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trictFirstAndLastChars="0" embedTrueTypeFonts="1" saveSubsetFonts="1" autoCompressPictures="0">
  <p:sldMasterIdLst>
    <p:sldMasterId id="2147483658" r:id="rId1"/>
  </p:sldMasterIdLst>
  <p:notesMasterIdLst>
    <p:notesMasterId r:id="rId43"/>
  </p:notesMasterIdLst>
  <p:sldIdLst>
    <p:sldId id="256" r:id="rId2"/>
    <p:sldId id="257" r:id="rId3"/>
    <p:sldId id="258" r:id="rId4"/>
    <p:sldId id="259" r:id="rId5"/>
    <p:sldId id="260" r:id="rId6"/>
    <p:sldId id="261" r:id="rId7"/>
    <p:sldId id="262" r:id="rId8"/>
    <p:sldId id="299" r:id="rId9"/>
    <p:sldId id="264" r:id="rId10"/>
    <p:sldId id="265" r:id="rId11"/>
    <p:sldId id="266" r:id="rId12"/>
    <p:sldId id="267" r:id="rId13"/>
    <p:sldId id="268" r:id="rId14"/>
    <p:sldId id="269" r:id="rId15"/>
    <p:sldId id="270" r:id="rId16"/>
    <p:sldId id="271" r:id="rId17"/>
    <p:sldId id="272" r:id="rId18"/>
    <p:sldId id="273" r:id="rId19"/>
    <p:sldId id="300" r:id="rId20"/>
    <p:sldId id="275" r:id="rId21"/>
    <p:sldId id="276" r:id="rId22"/>
    <p:sldId id="277" r:id="rId23"/>
    <p:sldId id="298" r:id="rId24"/>
    <p:sldId id="280" r:id="rId25"/>
    <p:sldId id="281" r:id="rId26"/>
    <p:sldId id="282" r:id="rId27"/>
    <p:sldId id="283" r:id="rId28"/>
    <p:sldId id="284" r:id="rId29"/>
    <p:sldId id="285" r:id="rId30"/>
    <p:sldId id="286" r:id="rId31"/>
    <p:sldId id="287" r:id="rId32"/>
    <p:sldId id="288" r:id="rId33"/>
    <p:sldId id="289" r:id="rId34"/>
    <p:sldId id="290" r:id="rId35"/>
    <p:sldId id="291" r:id="rId36"/>
    <p:sldId id="292" r:id="rId37"/>
    <p:sldId id="293" r:id="rId38"/>
    <p:sldId id="294" r:id="rId39"/>
    <p:sldId id="295" r:id="rId40"/>
    <p:sldId id="297" r:id="rId41"/>
    <p:sldId id="296" r:id="rId42"/>
  </p:sldIdLst>
  <p:sldSz cx="9144000" cy="5143500" type="screen16x9"/>
  <p:notesSz cx="6858000" cy="9144000"/>
  <p:embeddedFontLst>
    <p:embeddedFont>
      <p:font typeface="Calibri" panose="020F0502020204030204" pitchFamily="34" charset="0"/>
      <p:regular r:id="rId44"/>
      <p:bold r:id="rId45"/>
      <p:italic r:id="rId46"/>
      <p:boldItalic r:id="rId47"/>
    </p:embeddedFont>
    <p:embeddedFont>
      <p:font typeface="Georgia" panose="02040502050405020303" pitchFamily="18" charset="0"/>
      <p:regular r:id="rId48"/>
      <p:bold r:id="rId49"/>
      <p:italic r:id="rId50"/>
      <p:boldItalic r:id="rId51"/>
    </p:embeddedFont>
    <p:embeddedFont>
      <p:font typeface="Montserrat" pitchFamily="2" charset="77"/>
      <p:regular r:id="rId52"/>
      <p:bold r:id="rId53"/>
      <p:italic r:id="rId54"/>
      <p:boldItalic r:id="rId55"/>
    </p:embeddedFont>
    <p:embeddedFont>
      <p:font typeface="Montserrat Light" panose="020F0302020204030204" pitchFamily="34" charset="0"/>
      <p:regular r:id="rId56"/>
      <p:bold r:id="rId57"/>
      <p:italic r:id="rId58"/>
      <p:boldItalic r:id="rId57"/>
    </p:embeddedFont>
    <p:embeddedFont>
      <p:font typeface="Playfair Display" pitchFamily="2" charset="77"/>
      <p:regular r:id="rId59"/>
      <p:bold r:id="rId60"/>
      <p:italic r:id="rId61"/>
      <p:boldItalic r:id="rId6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9AA0A6"/>
          </p15:clr>
        </p15:guide>
        <p15:guide id="2" pos="2880">
          <p15:clr>
            <a:srgbClr val="9AA0A6"/>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1667"/>
  </p:normalViewPr>
  <p:slideViewPr>
    <p:cSldViewPr snapToGrid="0">
      <p:cViewPr varScale="1">
        <p:scale>
          <a:sx n="136" d="100"/>
          <a:sy n="136" d="100"/>
        </p:scale>
        <p:origin x="960" y="19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font" Target="fonts/font4.fntdata"/><Relationship Id="rId50" Type="http://schemas.openxmlformats.org/officeDocument/2006/relationships/font" Target="fonts/font7.fntdata"/><Relationship Id="rId55" Type="http://schemas.openxmlformats.org/officeDocument/2006/relationships/font" Target="fonts/font12.fntdata"/><Relationship Id="rId63"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font" Target="fonts/font2.fntdata"/><Relationship Id="rId53" Type="http://schemas.openxmlformats.org/officeDocument/2006/relationships/font" Target="fonts/font10.fntdata"/><Relationship Id="rId58" Type="http://schemas.openxmlformats.org/officeDocument/2006/relationships/font" Target="fonts/font14.fntdata"/><Relationship Id="rId66" Type="http://schemas.openxmlformats.org/officeDocument/2006/relationships/tableStyles" Target="tableStyles.xml"/><Relationship Id="rId5" Type="http://schemas.openxmlformats.org/officeDocument/2006/relationships/slide" Target="slides/slide4.xml"/><Relationship Id="rId61" Type="http://schemas.openxmlformats.org/officeDocument/2006/relationships/font" Target="fonts/font17.fntdata"/><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notesMaster" Target="notesMasters/notesMaster1.xml"/><Relationship Id="rId48" Type="http://schemas.openxmlformats.org/officeDocument/2006/relationships/font" Target="fonts/font5.fntdata"/><Relationship Id="rId56" Type="http://schemas.openxmlformats.org/officeDocument/2006/relationships/font" Target="fonts/font13.fntdata"/><Relationship Id="rId64" Type="http://schemas.openxmlformats.org/officeDocument/2006/relationships/viewProps" Target="viewProps.xml"/><Relationship Id="rId8" Type="http://schemas.openxmlformats.org/officeDocument/2006/relationships/slide" Target="slides/slide7.xml"/><Relationship Id="rId51" Type="http://schemas.openxmlformats.org/officeDocument/2006/relationships/font" Target="fonts/font8.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font" Target="fonts/font3.fntdata"/><Relationship Id="rId59" Type="http://schemas.openxmlformats.org/officeDocument/2006/relationships/font" Target="fonts/font15.fntdata"/><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font" Target="fonts/font11.fntdata"/><Relationship Id="rId62" Type="http://schemas.openxmlformats.org/officeDocument/2006/relationships/font" Target="fonts/font18.fntdata"/><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6.fntdata"/><Relationship Id="rId57" Type="http://schemas.openxmlformats.org/officeDocument/2006/relationships/font" Target="NUL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font" Target="fonts/font1.fntdata"/><Relationship Id="rId52" Type="http://schemas.openxmlformats.org/officeDocument/2006/relationships/font" Target="fonts/font9.fntdata"/><Relationship Id="rId60" Type="http://schemas.openxmlformats.org/officeDocument/2006/relationships/font" Target="fonts/font16.fntdata"/><Relationship Id="rId65"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317500">
              <a:spcBef>
                <a:spcPts val="0"/>
              </a:spcBef>
              <a:spcAft>
                <a:spcPts val="0"/>
              </a:spcAft>
              <a:buSzPts val="1400"/>
              <a:buChar char="●"/>
              <a:defRPr sz="1100"/>
            </a:lvl1pPr>
            <a:lvl2pPr marL="914400" lvl="1" indent="-317500">
              <a:spcBef>
                <a:spcPts val="0"/>
              </a:spcBef>
              <a:spcAft>
                <a:spcPts val="0"/>
              </a:spcAft>
              <a:buSzPts val="1400"/>
              <a:buChar char="○"/>
              <a:defRPr sz="1100"/>
            </a:lvl2pPr>
            <a:lvl3pPr marL="1371600" lvl="2" indent="-317500">
              <a:spcBef>
                <a:spcPts val="0"/>
              </a:spcBef>
              <a:spcAft>
                <a:spcPts val="0"/>
              </a:spcAft>
              <a:buSzPts val="1400"/>
              <a:buChar char="■"/>
              <a:defRPr sz="1100"/>
            </a:lvl3pPr>
            <a:lvl4pPr marL="1828800" lvl="3" indent="-317500">
              <a:spcBef>
                <a:spcPts val="0"/>
              </a:spcBef>
              <a:spcAft>
                <a:spcPts val="0"/>
              </a:spcAft>
              <a:buSzPts val="1400"/>
              <a:buChar char="●"/>
              <a:defRPr sz="1100"/>
            </a:lvl4pPr>
            <a:lvl5pPr marL="2286000" lvl="4" indent="-317500">
              <a:spcBef>
                <a:spcPts val="0"/>
              </a:spcBef>
              <a:spcAft>
                <a:spcPts val="0"/>
              </a:spcAft>
              <a:buSzPts val="1400"/>
              <a:buChar char="○"/>
              <a:defRPr sz="1100"/>
            </a:lvl5pPr>
            <a:lvl6pPr marL="2743200" lvl="5" indent="-317500">
              <a:spcBef>
                <a:spcPts val="0"/>
              </a:spcBef>
              <a:spcAft>
                <a:spcPts val="0"/>
              </a:spcAft>
              <a:buSzPts val="1400"/>
              <a:buChar char="■"/>
              <a:defRPr sz="1100"/>
            </a:lvl6pPr>
            <a:lvl7pPr marL="3200400" lvl="6" indent="-317500">
              <a:spcBef>
                <a:spcPts val="0"/>
              </a:spcBef>
              <a:spcAft>
                <a:spcPts val="0"/>
              </a:spcAft>
              <a:buSzPts val="1400"/>
              <a:buChar char="●"/>
              <a:defRPr sz="1100"/>
            </a:lvl7pPr>
            <a:lvl8pPr marL="3657600" lvl="7" indent="-317500">
              <a:spcBef>
                <a:spcPts val="0"/>
              </a:spcBef>
              <a:spcAft>
                <a:spcPts val="0"/>
              </a:spcAft>
              <a:buSzPts val="1400"/>
              <a:buChar char="○"/>
              <a:defRPr sz="1100"/>
            </a:lvl8pPr>
            <a:lvl9pPr marL="4114800" lvl="8" indent="-317500">
              <a:spcBef>
                <a:spcPts val="0"/>
              </a:spcBef>
              <a:spcAft>
                <a:spcPts val="0"/>
              </a:spcAft>
              <a:buSzPts val="14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
        <p:cNvGrpSpPr/>
        <p:nvPr/>
      </p:nvGrpSpPr>
      <p:grpSpPr>
        <a:xfrm>
          <a:off x="0" y="0"/>
          <a:ext cx="0" cy="0"/>
          <a:chOff x="0" y="0"/>
          <a:chExt cx="0" cy="0"/>
        </a:xfrm>
      </p:grpSpPr>
      <p:sp>
        <p:nvSpPr>
          <p:cNvPr id="84" name="Google Shape;84;g35f391192_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5" name="Google Shape;85;g35f391192_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04800" algn="l" rtl="0">
              <a:lnSpc>
                <a:spcPct val="115000"/>
              </a:lnSpc>
              <a:spcBef>
                <a:spcPts val="400"/>
              </a:spcBef>
              <a:spcAft>
                <a:spcPts val="0"/>
              </a:spcAft>
              <a:buClr>
                <a:schemeClr val="dk1"/>
              </a:buClr>
              <a:buSzPts val="1200"/>
              <a:buChar char="●"/>
            </a:pPr>
            <a:r>
              <a:rPr lang="en" sz="1200" dirty="0">
                <a:solidFill>
                  <a:schemeClr val="dk1"/>
                </a:solidFill>
              </a:rPr>
              <a:t>Play music to start while waiting for participants to join (plays the song “Say My Name” by Destiny’s Child).</a:t>
            </a:r>
            <a:endParaRPr sz="1200" dirty="0">
              <a:solidFill>
                <a:schemeClr val="dk1"/>
              </a:solidFill>
            </a:endParaRPr>
          </a:p>
          <a:p>
            <a:pPr marL="457200" lvl="0" indent="-304800" algn="l" rtl="0">
              <a:lnSpc>
                <a:spcPct val="115000"/>
              </a:lnSpc>
              <a:spcBef>
                <a:spcPts val="0"/>
              </a:spcBef>
              <a:spcAft>
                <a:spcPts val="0"/>
              </a:spcAft>
              <a:buClr>
                <a:schemeClr val="dk1"/>
              </a:buClr>
              <a:buSzPts val="1200"/>
              <a:buChar char="●"/>
            </a:pPr>
            <a:r>
              <a:rPr lang="en" sz="1200" dirty="0">
                <a:solidFill>
                  <a:schemeClr val="dk1"/>
                </a:solidFill>
              </a:rPr>
              <a:t>“This talk is titled “Say My Name: Understanding the power of names, correct pronunciation, and personal narratives ” and was created at Stanford University as part of the Leadership Education in Advancing Diversity (LEAD) program</a:t>
            </a:r>
            <a:endParaRPr sz="1200" dirty="0">
              <a:solidFill>
                <a:schemeClr val="dk1"/>
              </a:solidFill>
            </a:endParaRPr>
          </a:p>
          <a:p>
            <a:pPr marL="0" lvl="0" indent="0" algn="l" rtl="0">
              <a:lnSpc>
                <a:spcPct val="115000"/>
              </a:lnSpc>
              <a:spcBef>
                <a:spcPts val="400"/>
              </a:spcBef>
              <a:spcAft>
                <a:spcPts val="0"/>
              </a:spcAft>
              <a:buNone/>
            </a:pPr>
            <a:endParaRPr sz="1200" dirty="0">
              <a:solidFill>
                <a:schemeClr val="dk1"/>
              </a:solidFill>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gd762d32115_0_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5" name="Google Shape;185;gd762d32115_0_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Clr>
                <a:schemeClr val="dk1"/>
              </a:buClr>
              <a:buSzPts val="1400"/>
              <a:buChar char="●"/>
            </a:pPr>
            <a:r>
              <a:rPr lang="en" dirty="0">
                <a:solidFill>
                  <a:schemeClr val="dk1"/>
                </a:solidFill>
              </a:rPr>
              <a:t>“Again either using the zoom function ‘Raise Hand’ or manually raising your hand, this time please raise your hand if you have ever had your name mispronounced”</a:t>
            </a:r>
            <a:endParaRPr dirty="0">
              <a:solidFill>
                <a:schemeClr val="dk1"/>
              </a:solidFill>
            </a:endParaRPr>
          </a:p>
          <a:p>
            <a:pPr marL="457200" lvl="0" indent="-317500" algn="l" rtl="0">
              <a:spcBef>
                <a:spcPts val="0"/>
              </a:spcBef>
              <a:spcAft>
                <a:spcPts val="0"/>
              </a:spcAft>
              <a:buClr>
                <a:schemeClr val="dk1"/>
              </a:buClr>
              <a:buSzPts val="1400"/>
              <a:buChar char="●"/>
            </a:pPr>
            <a:r>
              <a:rPr lang="en" dirty="0">
                <a:solidFill>
                  <a:schemeClr val="dk1"/>
                </a:solidFill>
              </a:rPr>
              <a:t>Review poll results </a:t>
            </a:r>
            <a:endParaRPr dirty="0">
              <a:solidFill>
                <a:schemeClr val="dk1"/>
              </a:solidFill>
            </a:endParaRPr>
          </a:p>
          <a:p>
            <a:pPr marL="457200" lvl="0" indent="-317500" algn="l" rtl="0">
              <a:spcBef>
                <a:spcPts val="0"/>
              </a:spcBef>
              <a:spcAft>
                <a:spcPts val="0"/>
              </a:spcAft>
              <a:buClr>
                <a:schemeClr val="dk1"/>
              </a:buClr>
              <a:buSzPts val="1400"/>
              <a:buChar char="●"/>
            </a:pPr>
            <a:r>
              <a:rPr lang="en" dirty="0">
                <a:solidFill>
                  <a:schemeClr val="dk1"/>
                </a:solidFill>
              </a:rPr>
              <a:t>“Unsurprisingly, most of us have had experience with our name mispronounced as well”</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Google Shape;195;gd05611af3a_0_89: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6" name="Google Shape;196;gd05611af3a_0_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hat do we know about this”</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g35ed75ccf_0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1" name="Google Shape;201;g35ed75ccf_0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A 2012 article called ‘Teachers, please learn our names!: racial microagressions and the K-12 classroom’ highlights that the classroom is a pivotal place for children, and teachers often spend more time with children than their parents - they play such a large role in their student’s lives”</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6"/>
        <p:cNvGrpSpPr/>
        <p:nvPr/>
      </p:nvGrpSpPr>
      <p:grpSpPr>
        <a:xfrm>
          <a:off x="0" y="0"/>
          <a:ext cx="0" cy="0"/>
          <a:chOff x="0" y="0"/>
          <a:chExt cx="0" cy="0"/>
        </a:xfrm>
      </p:grpSpPr>
      <p:sp>
        <p:nvSpPr>
          <p:cNvPr id="207" name="Google Shape;207;gd05611af3a_0_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8" name="Google Shape;208;gd05611af3a_0_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In this study, … (read study results)”</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d05611af3a_0_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d05611af3a_0_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Clr>
                <a:schemeClr val="dk1"/>
              </a:buClr>
              <a:buSzPts val="1400"/>
              <a:buChar char="●"/>
            </a:pPr>
            <a:r>
              <a:rPr lang="en">
                <a:solidFill>
                  <a:schemeClr val="dk1"/>
                </a:solidFill>
              </a:rPr>
              <a:t>“In The New Yorker piece ‘America Ruined My Name for Me’ from 2021, author Beth Nguyen shares an intimate example of how mispronunciation of a cherished name degraded it to a common insult”</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gd05611af3a_0_1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3" name="Google Shape;223;gd05611af3a_0_1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a:t>“This piece is an autobiographical account by author Beth Nguyen, whose given name is B-I-C-H pronounced Bic. She recounts the complexity of living with a name that often draws commentary as well as the intricacies of changing one’s name”</a:t>
            </a:r>
            <a:endParaRPr/>
          </a:p>
          <a:p>
            <a:pPr marL="457200" lvl="0" indent="-317500" algn="l" rtl="0">
              <a:spcBef>
                <a:spcPts val="0"/>
              </a:spcBef>
              <a:spcAft>
                <a:spcPts val="0"/>
              </a:spcAft>
              <a:buSzPts val="1400"/>
              <a:buChar char="●"/>
            </a:pPr>
            <a:r>
              <a:rPr lang="en"/>
              <a:t>“She highlights this dichotomy by saying…(read quote)”</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d05611af3a_0_1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1" name="Google Shape;231;gd05611af3a_0_1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e’ll now discuss important historical context for racism and name pronunciation.”</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gd762d32115_0_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8" name="Google Shape;238;gd762d32115_0_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marR="0" lvl="0" indent="-317500" algn="l" defTabSz="914400" rtl="0" eaLnBrk="1" fontAlgn="auto" latinLnBrk="0" hangingPunct="1">
              <a:lnSpc>
                <a:spcPct val="100000"/>
              </a:lnSpc>
              <a:spcBef>
                <a:spcPts val="0"/>
              </a:spcBef>
              <a:spcAft>
                <a:spcPts val="0"/>
              </a:spcAft>
              <a:buClr>
                <a:srgbClr val="000000"/>
              </a:buClr>
              <a:buSzPts val="1400"/>
              <a:buFont typeface="Arial"/>
              <a:buChar char="●"/>
              <a:tabLst/>
              <a:defRPr/>
            </a:pPr>
            <a:r>
              <a:rPr lang="en" sz="1100" dirty="0"/>
              <a:t>Optional video. The video can be located by searching ‘Amber Ruffin name pronunciation’ in a search engine </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gdc22c9e443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3" name="Google Shape;243;gdc22c9e443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a:t>“As highlighted in the video, there is a complex history between racism and names. During the slave era, slaves were given European sounding names to replace their last names, and the new last name was often the name of the slave owner. After emancipation, many former slaves changed their names and incorporated African names and sounds.”</a:t>
            </a:r>
            <a:endParaRPr/>
          </a:p>
          <a:p>
            <a:pPr marL="457200" lvl="0" indent="-317500" algn="l" rtl="0">
              <a:spcBef>
                <a:spcPts val="0"/>
              </a:spcBef>
              <a:spcAft>
                <a:spcPts val="0"/>
              </a:spcAft>
              <a:buSzPts val="1400"/>
              <a:buChar char="●"/>
            </a:pPr>
            <a:r>
              <a:rPr lang="en"/>
              <a:t>“There is also complexity in westernizing names. Some may choose to Anglicize their names to ‘fit in’ or not draw commentary, while others view re-claiming their names as a way to re-claim identity. It is an individual preference and can be tricky.”</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gd83d7094f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0" name="Google Shape;250;gd83d7094f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dirty="0"/>
              <a:t>“There continue to be tangible effects of racism today, as evidenced in this 2003 study ‘</a:t>
            </a:r>
            <a:r>
              <a:rPr lang="en" sz="1200" dirty="0">
                <a:solidFill>
                  <a:schemeClr val="dk1"/>
                </a:solidFill>
              </a:rPr>
              <a:t>Are Emily and Greg More Employable than Lakisha and Jamal? A Field Experiment on Labor Market Discrimination.’ This study found that there was a 50% gap in callback rates for job applications between Western sounding names and racial/ethnic minority sounding names.” </a:t>
            </a:r>
            <a:endParaRPr sz="1200" dirty="0">
              <a:solidFill>
                <a:schemeClr val="dk1"/>
              </a:solidFill>
            </a:endParaRPr>
          </a:p>
          <a:p>
            <a:pPr marL="0" lvl="0" indent="0" algn="l" rtl="0">
              <a:spcBef>
                <a:spcPts val="0"/>
              </a:spcBef>
              <a:spcAft>
                <a:spcPts val="0"/>
              </a:spcAft>
              <a:buNone/>
            </a:pPr>
            <a:r>
              <a:rPr lang="en" sz="1200" dirty="0">
                <a:solidFill>
                  <a:schemeClr val="dk1"/>
                </a:solidFill>
              </a:rPr>
              <a:t>“Additionally, another study in 2016 by Kang et al, which showed that ‘Whitened’ names on resumes produced more call backs for jobs than ‘non-Whitened’ names.”</a:t>
            </a:r>
            <a:endParaRPr sz="1200" dirty="0"/>
          </a:p>
        </p:txBody>
      </p:sp>
    </p:spTree>
    <p:extLst>
      <p:ext uri="{BB962C8B-B14F-4D97-AF65-F5344CB8AC3E}">
        <p14:creationId xmlns:p14="http://schemas.microsoft.com/office/powerpoint/2010/main" val="51339291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gd5a01e8c30_2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6" name="Google Shape;96;gd5a01e8c30_2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04800" algn="l" rtl="0">
              <a:lnSpc>
                <a:spcPct val="115000"/>
              </a:lnSpc>
              <a:spcBef>
                <a:spcPts val="400"/>
              </a:spcBef>
              <a:spcAft>
                <a:spcPts val="0"/>
              </a:spcAft>
              <a:buClr>
                <a:schemeClr val="dk1"/>
              </a:buClr>
              <a:buSzPts val="1200"/>
              <a:buChar char="●"/>
            </a:pPr>
            <a:r>
              <a:rPr lang="en" sz="1200" dirty="0">
                <a:solidFill>
                  <a:schemeClr val="dk1"/>
                </a:solidFill>
              </a:rPr>
              <a:t>“The original scholars to present this work are listed here. It is being presented today by… (list presenters names).”</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gd394e66482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9" name="Google Shape;259;gd394e66482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2100" algn="l" rtl="0">
              <a:spcBef>
                <a:spcPts val="0"/>
              </a:spcBef>
              <a:spcAft>
                <a:spcPts val="0"/>
              </a:spcAft>
              <a:buSzPts val="1000"/>
              <a:buChar char="●"/>
            </a:pPr>
            <a:r>
              <a:rPr lang="en" sz="1000" dirty="0"/>
              <a:t>Optional video. The video can be located by searching ‘Key and Peele substitute teacher’ in a search engine </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2"/>
        <p:cNvGrpSpPr/>
        <p:nvPr/>
      </p:nvGrpSpPr>
      <p:grpSpPr>
        <a:xfrm>
          <a:off x="0" y="0"/>
          <a:ext cx="0" cy="0"/>
          <a:chOff x="0" y="0"/>
          <a:chExt cx="0" cy="0"/>
        </a:xfrm>
      </p:grpSpPr>
      <p:sp>
        <p:nvSpPr>
          <p:cNvPr id="263" name="Google Shape;263;gd5ba61f480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4" name="Google Shape;264;gd5ba61f480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Let’s discuss some tools for name pronunciation.”</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8"/>
        <p:cNvGrpSpPr/>
        <p:nvPr/>
      </p:nvGrpSpPr>
      <p:grpSpPr>
        <a:xfrm>
          <a:off x="0" y="0"/>
          <a:ext cx="0" cy="0"/>
          <a:chOff x="0" y="0"/>
          <a:chExt cx="0" cy="0"/>
        </a:xfrm>
      </p:grpSpPr>
      <p:sp>
        <p:nvSpPr>
          <p:cNvPr id="269" name="Google Shape;269;gd394e66482_1_1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0" name="Google Shape;270;gd394e66482_1_1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The best way to ask someone how to pronounce their name is just ask!”</a:t>
            </a:r>
            <a:endParaRPr dirty="0"/>
          </a:p>
          <a:p>
            <a:pPr marL="457200" lvl="0" indent="-317500" algn="l" rtl="0">
              <a:spcBef>
                <a:spcPts val="0"/>
              </a:spcBef>
              <a:spcAft>
                <a:spcPts val="0"/>
              </a:spcAft>
              <a:buSzPts val="1400"/>
              <a:buChar char="●"/>
            </a:pPr>
            <a:r>
              <a:rPr lang="en" dirty="0"/>
              <a:t>”Listen to which syllable is emphasized in a name. Repeat once or twice, but avoid dwelling as this can lead someone to feel othered.”</a:t>
            </a:r>
          </a:p>
          <a:p>
            <a:pPr marL="457200" lvl="0" indent="-317500" algn="l" rtl="0">
              <a:spcBef>
                <a:spcPts val="0"/>
              </a:spcBef>
              <a:spcAft>
                <a:spcPts val="0"/>
              </a:spcAft>
              <a:buSzPts val="1400"/>
              <a:buChar char="●"/>
            </a:pPr>
            <a:r>
              <a:rPr lang="en" dirty="0"/>
              <a:t>“Practice, practice, practice! It’s ok to clarify name pronunciation or ask for reminders. Remember to own your mistakes and correct them.”</a:t>
            </a:r>
          </a:p>
          <a:p>
            <a:pPr marL="457200" marR="0" lvl="0" indent="-317500" algn="l" defTabSz="914400" rtl="0" eaLnBrk="1" fontAlgn="auto" latinLnBrk="0" hangingPunct="1">
              <a:lnSpc>
                <a:spcPct val="100000"/>
              </a:lnSpc>
              <a:spcBef>
                <a:spcPts val="0"/>
              </a:spcBef>
              <a:spcAft>
                <a:spcPts val="0"/>
              </a:spcAft>
              <a:buClr>
                <a:srgbClr val="000000"/>
              </a:buClr>
              <a:buSzPts val="1400"/>
              <a:buFont typeface="Arial"/>
              <a:buChar char="●"/>
              <a:tabLst/>
              <a:defRPr/>
            </a:pPr>
            <a:r>
              <a:rPr lang="en-US" sz="1100" dirty="0">
                <a:solidFill>
                  <a:schemeClr val="dk1"/>
                </a:solidFill>
                <a:highlight>
                  <a:schemeClr val="lt1"/>
                </a:highlight>
              </a:rPr>
              <a:t>Some examples may be skipped if time does not allow</a:t>
            </a:r>
            <a:endParaRPr lang="en-US" sz="1100" dirty="0"/>
          </a:p>
          <a:p>
            <a:pPr marL="457200" lvl="0" indent="-317500" algn="l" rtl="0">
              <a:spcBef>
                <a:spcPts val="0"/>
              </a:spcBef>
              <a:spcAft>
                <a:spcPts val="0"/>
              </a:spcAft>
              <a:buSzPts val="1400"/>
              <a:buChar char="●"/>
            </a:pPr>
            <a:endParaRPr dirty="0"/>
          </a:p>
          <a:p>
            <a:pPr marL="0" lvl="0" indent="0" algn="l" rtl="0">
              <a:spcBef>
                <a:spcPts val="0"/>
              </a:spcBef>
              <a:spcAft>
                <a:spcPts val="0"/>
              </a:spcAft>
              <a:buNone/>
            </a:pP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lvl="0" indent="-317500" algn="l" rtl="0">
              <a:spcBef>
                <a:spcPts val="0"/>
              </a:spcBef>
              <a:spcAft>
                <a:spcPts val="0"/>
              </a:spcAft>
              <a:buSzPts val="1400"/>
              <a:buChar char="●"/>
            </a:pPr>
            <a:r>
              <a:rPr lang="en-US" dirty="0"/>
              <a:t>“</a:t>
            </a:r>
            <a:r>
              <a:rPr lang="en-US" dirty="0" err="1"/>
              <a:t>Pronouncenames.com</a:t>
            </a:r>
            <a:r>
              <a:rPr lang="en-US" dirty="0"/>
              <a:t> and </a:t>
            </a:r>
            <a:r>
              <a:rPr lang="en-US" dirty="0" err="1"/>
              <a:t>nameshouts.com</a:t>
            </a:r>
            <a:r>
              <a:rPr lang="en-US" dirty="0"/>
              <a:t> are examples of two websites that allow you to enter a person’s name and hear different pronunciations, and include examples in various languages.”</a:t>
            </a:r>
          </a:p>
          <a:p>
            <a:pPr marL="457200" lvl="0" indent="-317500" algn="l" rtl="0">
              <a:spcBef>
                <a:spcPts val="0"/>
              </a:spcBef>
              <a:spcAft>
                <a:spcPts val="0"/>
              </a:spcAft>
              <a:buSzPts val="1400"/>
              <a:buChar char="●"/>
            </a:pPr>
            <a:r>
              <a:rPr lang="en-US" dirty="0"/>
              <a:t>“This can be helpful when learning how to pronounce names that may have sounds you are not as familiar with saying.”</a:t>
            </a:r>
          </a:p>
          <a:p>
            <a:pPr marL="457200" lvl="0" indent="-317500" algn="l" rtl="0">
              <a:spcBef>
                <a:spcPts val="0"/>
              </a:spcBef>
              <a:spcAft>
                <a:spcPts val="0"/>
              </a:spcAft>
              <a:buSzPts val="1400"/>
              <a:buChar char="●"/>
            </a:pPr>
            <a:r>
              <a:rPr lang="en-US" dirty="0"/>
              <a:t>“Because there are many different pronunciations in even a single language and people have individual preferences, there are also resources that allow people to record the pronunciation of their own names, like </a:t>
            </a:r>
            <a:r>
              <a:rPr lang="en-US" dirty="0" err="1"/>
              <a:t>namecoach.com</a:t>
            </a:r>
            <a:r>
              <a:rPr lang="en-US" dirty="0"/>
              <a:t> and </a:t>
            </a:r>
            <a:r>
              <a:rPr lang="en-US" dirty="0" err="1"/>
              <a:t>namez.com</a:t>
            </a:r>
            <a:r>
              <a:rPr lang="en-US" dirty="0"/>
              <a:t>.”</a:t>
            </a:r>
          </a:p>
          <a:p>
            <a:pPr marL="457200" lvl="0" indent="-317500" algn="l" rtl="0">
              <a:spcBef>
                <a:spcPts val="0"/>
              </a:spcBef>
              <a:spcAft>
                <a:spcPts val="0"/>
              </a:spcAft>
              <a:buSzPts val="1400"/>
              <a:buChar char="●"/>
            </a:pPr>
            <a:r>
              <a:rPr lang="en-US" dirty="0"/>
              <a:t>“These can also be embedded into social media sites like twitter, or in email sign outs. </a:t>
            </a:r>
            <a:r>
              <a:rPr lang="en-US" dirty="0">
                <a:solidFill>
                  <a:schemeClr val="dk1"/>
                </a:solidFill>
              </a:rPr>
              <a:t>All of these resources will also be provided in the participant handout.</a:t>
            </a:r>
            <a:r>
              <a:rPr lang="en-US" dirty="0"/>
              <a:t>”</a:t>
            </a:r>
          </a:p>
          <a:p>
            <a:pPr marL="457200" lvl="0" indent="-317500" algn="l" rtl="0">
              <a:spcBef>
                <a:spcPts val="0"/>
              </a:spcBef>
              <a:spcAft>
                <a:spcPts val="0"/>
              </a:spcAft>
              <a:buSzPts val="1400"/>
              <a:buChar char="●"/>
            </a:pPr>
            <a:r>
              <a:rPr lang="en-US" dirty="0"/>
              <a:t>This slide may be skipped if time does not allow, and instead refer participants to Participant Handout (Appendix C) for resources </a:t>
            </a:r>
          </a:p>
          <a:p>
            <a:pPr marL="457200" lvl="0" indent="-317500" algn="l" rtl="0">
              <a:spcBef>
                <a:spcPts val="0"/>
              </a:spcBef>
              <a:spcAft>
                <a:spcPts val="0"/>
              </a:spcAft>
              <a:buSzPts val="1400"/>
              <a:buChar char="●"/>
            </a:pPr>
            <a:endParaRPr lang="en-US" dirty="0"/>
          </a:p>
          <a:p>
            <a:endParaRPr lang="en-US" dirty="0"/>
          </a:p>
        </p:txBody>
      </p:sp>
    </p:spTree>
    <p:extLst>
      <p:ext uri="{BB962C8B-B14F-4D97-AF65-F5344CB8AC3E}">
        <p14:creationId xmlns:p14="http://schemas.microsoft.com/office/powerpoint/2010/main" val="135807873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0"/>
        <p:cNvGrpSpPr/>
        <p:nvPr/>
      </p:nvGrpSpPr>
      <p:grpSpPr>
        <a:xfrm>
          <a:off x="0" y="0"/>
          <a:ext cx="0" cy="0"/>
          <a:chOff x="0" y="0"/>
          <a:chExt cx="0" cy="0"/>
        </a:xfrm>
      </p:grpSpPr>
      <p:sp>
        <p:nvSpPr>
          <p:cNvPr id="311" name="Google Shape;311;gd394e66482_1_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2" name="Google Shape;312;gd394e66482_1_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There are also tricks like ‘sounds-like’ for names, for example, Kim </a:t>
            </a:r>
            <a:r>
              <a:rPr lang="en" dirty="0" err="1"/>
              <a:t>Lamagna</a:t>
            </a:r>
            <a:r>
              <a:rPr lang="en" dirty="0"/>
              <a:t> sounds like lasagna.” </a:t>
            </a:r>
            <a:endParaRPr dirty="0"/>
          </a:p>
          <a:p>
            <a:pPr marL="457200" lvl="0" indent="-317500" algn="l" rtl="0">
              <a:spcBef>
                <a:spcPts val="0"/>
              </a:spcBef>
              <a:spcAft>
                <a:spcPts val="0"/>
              </a:spcAft>
              <a:buSzPts val="1400"/>
              <a:buChar char="●"/>
            </a:pPr>
            <a:r>
              <a:rPr lang="en" dirty="0"/>
              <a:t>“One tool for phonetically writing someone’s name is to break the name into syllables. Each syllable can be separated by a hyphen, and the syllable that is emphasized should be in capital letters. We will have a chance to practice shortly.”</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7"/>
        <p:cNvGrpSpPr/>
        <p:nvPr/>
      </p:nvGrpSpPr>
      <p:grpSpPr>
        <a:xfrm>
          <a:off x="0" y="0"/>
          <a:ext cx="0" cy="0"/>
          <a:chOff x="0" y="0"/>
          <a:chExt cx="0" cy="0"/>
        </a:xfrm>
      </p:grpSpPr>
      <p:sp>
        <p:nvSpPr>
          <p:cNvPr id="318" name="Google Shape;318;gd5ba61f480_0_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9" name="Google Shape;319;gd5ba61f480_0_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04800" algn="l" rtl="0">
              <a:spcBef>
                <a:spcPts val="0"/>
              </a:spcBef>
              <a:spcAft>
                <a:spcPts val="0"/>
              </a:spcAft>
              <a:buSzPts val="1200"/>
              <a:buChar char="●"/>
            </a:pPr>
            <a:r>
              <a:rPr lang="en" sz="1200" dirty="0"/>
              <a:t>“Here are some examples of how to correct someone when they mispronounce your name, from gentle to direct”</a:t>
            </a:r>
          </a:p>
          <a:p>
            <a:pPr marL="457200" lvl="0" indent="-304800" algn="l" rtl="0">
              <a:spcBef>
                <a:spcPts val="0"/>
              </a:spcBef>
              <a:spcAft>
                <a:spcPts val="0"/>
              </a:spcAft>
              <a:buSzPts val="1200"/>
              <a:buChar char="●"/>
            </a:pPr>
            <a:r>
              <a:rPr lang="en" sz="1200" dirty="0"/>
              <a:t>You can be direct by saying ‘it’s not a big deal but you’ve said my name wrong three times’ or more gentle by saying ‘I haven’t taken the time to tell you that my name is actually pronounced this way’”</a:t>
            </a:r>
            <a:endParaRPr sz="1200" dirty="0"/>
          </a:p>
          <a:p>
            <a:pPr marL="457200" lvl="0" indent="-304800" algn="l" rtl="0">
              <a:spcBef>
                <a:spcPts val="0"/>
              </a:spcBef>
              <a:spcAft>
                <a:spcPts val="0"/>
              </a:spcAft>
              <a:buSzPts val="1200"/>
              <a:buChar char="●"/>
            </a:pPr>
            <a:r>
              <a:rPr lang="en" sz="1200" dirty="0"/>
              <a:t>“You can also </a:t>
            </a:r>
            <a:r>
              <a:rPr lang="en" sz="1200" dirty="0">
                <a:solidFill>
                  <a:schemeClr val="dk1"/>
                </a:solidFill>
                <a:highlight>
                  <a:schemeClr val="lt1"/>
                </a:highlight>
              </a:rPr>
              <a:t>model for others! If you hear a mispronunciation, say ‘Oh, I think her name is pronounced Aniya like Tanya, but let’s ask her!’”</a:t>
            </a:r>
          </a:p>
          <a:p>
            <a:pPr marL="457200" lvl="0" indent="-304800" algn="l" rtl="0">
              <a:spcBef>
                <a:spcPts val="0"/>
              </a:spcBef>
              <a:spcAft>
                <a:spcPts val="0"/>
              </a:spcAft>
              <a:buSzPts val="1200"/>
              <a:buChar char="●"/>
            </a:pPr>
            <a:r>
              <a:rPr lang="en" sz="1200" dirty="0">
                <a:solidFill>
                  <a:schemeClr val="dk1"/>
                </a:solidFill>
                <a:highlight>
                  <a:schemeClr val="lt1"/>
                </a:highlight>
              </a:rPr>
              <a:t>Some examples may be skipped if time does not allow</a:t>
            </a:r>
            <a:endParaRPr sz="1200"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6"/>
        <p:cNvGrpSpPr/>
        <p:nvPr/>
      </p:nvGrpSpPr>
      <p:grpSpPr>
        <a:xfrm>
          <a:off x="0" y="0"/>
          <a:ext cx="0" cy="0"/>
          <a:chOff x="0" y="0"/>
          <a:chExt cx="0" cy="0"/>
        </a:xfrm>
      </p:grpSpPr>
      <p:sp>
        <p:nvSpPr>
          <p:cNvPr id="347" name="Google Shape;347;gd5ba61f480_0_13: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8" name="Google Shape;348;gd5ba61f480_0_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a:t>“Ok, now let’s practice this and change our name on Zoom to the phonetic pronunciation or ‘sounds-like’”</a:t>
            </a:r>
            <a:endParaRPr/>
          </a:p>
          <a:p>
            <a:pPr marL="457200" lvl="0" indent="-317500" algn="l" rtl="0">
              <a:spcBef>
                <a:spcPts val="0"/>
              </a:spcBef>
              <a:spcAft>
                <a:spcPts val="0"/>
              </a:spcAft>
              <a:buSzPts val="1400"/>
              <a:buChar char="●"/>
            </a:pPr>
            <a:r>
              <a:rPr lang="en"/>
              <a:t>“On the computer: Clinic on your picture &gt;&gt; Settings &gt;&gt; Profile &gt;&gt; Edit my profile&gt;&gt;Edit name”</a:t>
            </a:r>
            <a:endParaRPr/>
          </a:p>
          <a:p>
            <a:pPr marL="457200" lvl="0" indent="-317500" algn="l" rtl="0">
              <a:spcBef>
                <a:spcPts val="0"/>
              </a:spcBef>
              <a:spcAft>
                <a:spcPts val="0"/>
              </a:spcAft>
              <a:buSzPts val="1400"/>
              <a:buChar char="●"/>
            </a:pPr>
            <a:r>
              <a:rPr lang="en"/>
              <a:t>“On the phone: Setting &gt;&gt; Your name &gt;&gt; Display name&gt;&gt; Edit name”</a:t>
            </a:r>
            <a:endParaRPr/>
          </a:p>
          <a:p>
            <a:pPr marL="457200" lvl="0" indent="-317500" algn="l" rtl="0">
              <a:spcBef>
                <a:spcPts val="0"/>
              </a:spcBef>
              <a:spcAft>
                <a:spcPts val="0"/>
              </a:spcAft>
              <a:buSzPts val="1400"/>
              <a:buChar char="●"/>
            </a:pPr>
            <a:r>
              <a:rPr lang="en"/>
              <a:t>One facilitator should change their name first as an example</a:t>
            </a:r>
            <a:endParaRPr/>
          </a:p>
          <a:p>
            <a:pPr marL="457200" lvl="0" indent="-317500" algn="l" rtl="0">
              <a:spcBef>
                <a:spcPts val="0"/>
              </a:spcBef>
              <a:spcAft>
                <a:spcPts val="0"/>
              </a:spcAft>
              <a:buSzPts val="1400"/>
              <a:buChar char="●"/>
            </a:pPr>
            <a:r>
              <a:rPr lang="en"/>
              <a:t>“Change your name to phonetic pronunciation by separating syllables with a hyphen, and capitalizing the letters in the syllable that is emphasized. You can also give a ‘sounds-like example. You can reference the facilitator example”</a:t>
            </a: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gd5ba61f480_0_19: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4" name="Google Shape;354;gd5ba61f480_0_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Next we will talk about tools for application to healthcare as having tools to help with name pronunciation is important both when interacting with patients and colleagues.” </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8"/>
        <p:cNvGrpSpPr/>
        <p:nvPr/>
      </p:nvGrpSpPr>
      <p:grpSpPr>
        <a:xfrm>
          <a:off x="0" y="0"/>
          <a:ext cx="0" cy="0"/>
          <a:chOff x="0" y="0"/>
          <a:chExt cx="0" cy="0"/>
        </a:xfrm>
      </p:grpSpPr>
      <p:sp>
        <p:nvSpPr>
          <p:cNvPr id="359" name="Google Shape;359;gd394e66482_1_4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0" name="Google Shape;360;gd394e66482_1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a:t>“For those who are patient facing, one recommended approach, as mentioned earlier, is to ask  patients and their family members how they want to be addressed.” </a:t>
            </a:r>
            <a:endParaRPr/>
          </a:p>
          <a:p>
            <a:pPr marL="457200" lvl="0" indent="-317500" algn="l" rtl="0">
              <a:spcBef>
                <a:spcPts val="0"/>
              </a:spcBef>
              <a:spcAft>
                <a:spcPts val="0"/>
              </a:spcAft>
              <a:buSzPts val="1400"/>
              <a:buChar char="●"/>
            </a:pPr>
            <a:r>
              <a:rPr lang="en"/>
              <a:t>“In addition it’s important to ask colleagues how they would like to be addressed both in settings with patients and within the clinical team. For example, a physician may choose to go by their first name in front of colleagues but want to be addressed as Dr. Blank to patients.”</a:t>
            </a: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4"/>
        <p:cNvGrpSpPr/>
        <p:nvPr/>
      </p:nvGrpSpPr>
      <p:grpSpPr>
        <a:xfrm>
          <a:off x="0" y="0"/>
          <a:ext cx="0" cy="0"/>
          <a:chOff x="0" y="0"/>
          <a:chExt cx="0" cy="0"/>
        </a:xfrm>
      </p:grpSpPr>
      <p:sp>
        <p:nvSpPr>
          <p:cNvPr id="365" name="Google Shape;365;gd394e66482_1_19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6" name="Google Shape;366;gd394e66482_1_19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71450" lvl="0" indent="-171450" algn="l" rtl="0">
              <a:spcBef>
                <a:spcPts val="0"/>
              </a:spcBef>
              <a:spcAft>
                <a:spcPts val="0"/>
              </a:spcAft>
            </a:pPr>
            <a:r>
              <a:rPr lang="en" dirty="0"/>
              <a:t>“It is best to ask how a patient prefers to be addressed, but when in doubt, it is better to go formal if you know a patient’s pronouns, such as saying ‘Mr. Smith’ rather than using first name. </a:t>
            </a:r>
            <a:r>
              <a:rPr lang="en" dirty="0">
                <a:solidFill>
                  <a:schemeClr val="dk1"/>
                </a:solidFill>
              </a:rPr>
              <a:t>Some patients prefer to go by titles or roles, such as mom, Dr., or Sister so be sure to ask about these preferences.”</a:t>
            </a:r>
            <a:endParaRPr dirty="0">
              <a:solidFill>
                <a:schemeClr val="dk1"/>
              </a:solidFill>
            </a:endParaRPr>
          </a:p>
          <a:p>
            <a:pPr marL="171450" lvl="0" indent="-171450" algn="l" rtl="0">
              <a:spcBef>
                <a:spcPts val="0"/>
              </a:spcBef>
              <a:spcAft>
                <a:spcPts val="0"/>
              </a:spcAft>
            </a:pPr>
            <a:r>
              <a:rPr lang="en" dirty="0">
                <a:solidFill>
                  <a:schemeClr val="dk1"/>
                </a:solidFill>
              </a:rPr>
              <a:t>“We can also utilize the electronic medical record to help remember preferences. For example, you can add ‘nicknames’ to the patient’s chart under the demographic section, use the social history to document, and write the phonetic spelling in a note or EMR sticky note as a reminder to yourself.”</a:t>
            </a:r>
            <a:endParaRPr dirty="0">
              <a:solidFill>
                <a:schemeClr val="dk1"/>
              </a:solidFil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5" name="Google Shape;125;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Our learning objectives are…(read list of objectives)”</a:t>
            </a: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gd394e66482_1_4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2" name="Google Shape;372;gd394e66482_1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e can continue to highlight the importance of correct name pronunciation by having name badges with phonetic spelling. We can also promote one another by using formal titles, such as doctor.” </a:t>
            </a: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6"/>
        <p:cNvGrpSpPr/>
        <p:nvPr/>
      </p:nvGrpSpPr>
      <p:grpSpPr>
        <a:xfrm>
          <a:off x="0" y="0"/>
          <a:ext cx="0" cy="0"/>
          <a:chOff x="0" y="0"/>
          <a:chExt cx="0" cy="0"/>
        </a:xfrm>
      </p:grpSpPr>
      <p:sp>
        <p:nvSpPr>
          <p:cNvPr id="377" name="Google Shape;377;gd394e66482_1_178: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8" name="Google Shape;378;gd394e66482_1_1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Clr>
                <a:schemeClr val="dk1"/>
              </a:buClr>
              <a:buSzPts val="1400"/>
              <a:buChar char="●"/>
            </a:pPr>
            <a:r>
              <a:rPr lang="en"/>
              <a:t>“We’ll go back into breakout rooms to apply our knowledge to some cases. Pick one person from each group to report back in large group debrief.” </a:t>
            </a:r>
            <a:endParaRPr/>
          </a:p>
          <a:p>
            <a:pPr marL="457200" lvl="0" indent="-317500" algn="l" rtl="0">
              <a:spcBef>
                <a:spcPts val="0"/>
              </a:spcBef>
              <a:spcAft>
                <a:spcPts val="0"/>
              </a:spcAft>
              <a:buSzPts val="1400"/>
              <a:buChar char="●"/>
            </a:pPr>
            <a:r>
              <a:rPr lang="en">
                <a:solidFill>
                  <a:schemeClr val="dk1"/>
                </a:solidFill>
              </a:rPr>
              <a:t>Assign participants to the same zoom room that they were in for breakout room #1. If there have been significant changes in number of participants, rooms can be assigned to have about 6-8 participants per room. </a:t>
            </a:r>
            <a:endParaRPr>
              <a:solidFill>
                <a:schemeClr val="dk1"/>
              </a:solidFill>
            </a:endParaRPr>
          </a:p>
          <a:p>
            <a:pPr marL="457200" lvl="0" indent="-317500" algn="l" rtl="0">
              <a:spcBef>
                <a:spcPts val="0"/>
              </a:spcBef>
              <a:spcAft>
                <a:spcPts val="0"/>
              </a:spcAft>
              <a:buClr>
                <a:schemeClr val="dk1"/>
              </a:buClr>
              <a:buSzPts val="1400"/>
              <a:buChar char="●"/>
            </a:pPr>
            <a:r>
              <a:rPr lang="en">
                <a:solidFill>
                  <a:schemeClr val="dk1"/>
                </a:solidFill>
              </a:rPr>
              <a:t>Each small group should be pre-assigned either case 1 or case 2 so that both cases are discussed. If there is time, the small group may discuss both cases. </a:t>
            </a:r>
            <a:endParaRPr>
              <a:solidFill>
                <a:schemeClr val="dk1"/>
              </a:solidFill>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gd394e66482_1_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5" name="Google Shape;385;gd394e66482_1_6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Ask someone in the group to read the parts for Dr. Miller, Dr. Patel, and Ms. Jones</a:t>
            </a:r>
          </a:p>
          <a:p>
            <a:pPr marL="457200" lvl="0" indent="-317500" algn="l" rtl="0">
              <a:spcBef>
                <a:spcPts val="0"/>
              </a:spcBef>
              <a:spcAft>
                <a:spcPts val="0"/>
              </a:spcAft>
              <a:buSzPts val="1400"/>
              <a:buChar char="●"/>
            </a:pPr>
            <a:r>
              <a:rPr lang="en" dirty="0"/>
              <a:t>Please refer to the Facilitator Guide for discussion points (Appendix B)</a:t>
            </a:r>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9"/>
        <p:cNvGrpSpPr/>
        <p:nvPr/>
      </p:nvGrpSpPr>
      <p:grpSpPr>
        <a:xfrm>
          <a:off x="0" y="0"/>
          <a:ext cx="0" cy="0"/>
          <a:chOff x="0" y="0"/>
          <a:chExt cx="0" cy="0"/>
        </a:xfrm>
      </p:grpSpPr>
      <p:sp>
        <p:nvSpPr>
          <p:cNvPr id="390" name="Google Shape;390;gd7158b966c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1" name="Google Shape;391;gd7158b966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Option to read all of the questions at once or to go question by question</a:t>
            </a:r>
          </a:p>
          <a:p>
            <a:pPr marL="457200" marR="0" lvl="0" indent="-317500" algn="l" defTabSz="914400" rtl="0" eaLnBrk="1" fontAlgn="auto" latinLnBrk="0" hangingPunct="1">
              <a:lnSpc>
                <a:spcPct val="100000"/>
              </a:lnSpc>
              <a:spcBef>
                <a:spcPts val="0"/>
              </a:spcBef>
              <a:spcAft>
                <a:spcPts val="0"/>
              </a:spcAft>
              <a:buClr>
                <a:srgbClr val="000000"/>
              </a:buClr>
              <a:buSzPts val="1400"/>
              <a:buFont typeface="Arial"/>
              <a:buChar char="●"/>
              <a:tabLst/>
              <a:defRPr/>
            </a:pPr>
            <a:r>
              <a:rPr lang="en-US" dirty="0"/>
              <a:t>Please refer to the Facilitator Guide for discussion points (Appendix B)</a:t>
            </a:r>
          </a:p>
          <a:p>
            <a:pPr marL="457200" lvl="0" indent="-317500" algn="l" rtl="0">
              <a:spcBef>
                <a:spcPts val="0"/>
              </a:spcBef>
              <a:spcAft>
                <a:spcPts val="0"/>
              </a:spcAft>
              <a:buSzPts val="1400"/>
              <a:buChar char="●"/>
            </a:pPr>
            <a:endParaRPr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6"/>
        <p:cNvGrpSpPr/>
        <p:nvPr/>
      </p:nvGrpSpPr>
      <p:grpSpPr>
        <a:xfrm>
          <a:off x="0" y="0"/>
          <a:ext cx="0" cy="0"/>
          <a:chOff x="0" y="0"/>
          <a:chExt cx="0" cy="0"/>
        </a:xfrm>
      </p:grpSpPr>
      <p:sp>
        <p:nvSpPr>
          <p:cNvPr id="397" name="Google Shape;397;gd394e66482_1_6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8" name="Google Shape;398;gd394e66482_1_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Ask a participant to read out the case</a:t>
            </a:r>
          </a:p>
          <a:p>
            <a:pPr marL="457200" marR="0" lvl="0" indent="-317500" algn="l" defTabSz="914400" rtl="0" eaLnBrk="1" fontAlgn="auto" latinLnBrk="0" hangingPunct="1">
              <a:lnSpc>
                <a:spcPct val="100000"/>
              </a:lnSpc>
              <a:spcBef>
                <a:spcPts val="0"/>
              </a:spcBef>
              <a:spcAft>
                <a:spcPts val="0"/>
              </a:spcAft>
              <a:buClr>
                <a:srgbClr val="000000"/>
              </a:buClr>
              <a:buSzPts val="1400"/>
              <a:buFont typeface="Arial"/>
              <a:buChar char="●"/>
              <a:tabLst/>
              <a:defRPr/>
            </a:pPr>
            <a:r>
              <a:rPr lang="en-US" dirty="0"/>
              <a:t>Please refer to the Facilitator Guide for discussion points (Appendix B)</a:t>
            </a:r>
          </a:p>
          <a:p>
            <a:pPr marL="457200" lvl="0" indent="-317500" algn="l" rtl="0">
              <a:spcBef>
                <a:spcPts val="0"/>
              </a:spcBef>
              <a:spcAft>
                <a:spcPts val="0"/>
              </a:spcAft>
              <a:buSzPts val="1400"/>
              <a:buChar char="●"/>
            </a:pPr>
            <a:endParaRPr dirty="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2"/>
        <p:cNvGrpSpPr/>
        <p:nvPr/>
      </p:nvGrpSpPr>
      <p:grpSpPr>
        <a:xfrm>
          <a:off x="0" y="0"/>
          <a:ext cx="0" cy="0"/>
          <a:chOff x="0" y="0"/>
          <a:chExt cx="0" cy="0"/>
        </a:xfrm>
      </p:grpSpPr>
      <p:sp>
        <p:nvSpPr>
          <p:cNvPr id="403" name="Google Shape;403;gd394e66482_1_7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4" name="Google Shape;404;gd394e66482_1_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Clr>
                <a:schemeClr val="dk1"/>
              </a:buClr>
              <a:buSzPts val="1400"/>
              <a:buChar char="●"/>
            </a:pPr>
            <a:r>
              <a:rPr lang="en" dirty="0">
                <a:solidFill>
                  <a:schemeClr val="dk1"/>
                </a:solidFill>
              </a:rPr>
              <a:t>Option to read all of the questions at once or to go question by question</a:t>
            </a:r>
          </a:p>
          <a:p>
            <a:pPr marL="457200" marR="0" lvl="0" indent="-317500" algn="l" defTabSz="914400" rtl="0" eaLnBrk="1" fontAlgn="auto" latinLnBrk="0" hangingPunct="1">
              <a:lnSpc>
                <a:spcPct val="100000"/>
              </a:lnSpc>
              <a:spcBef>
                <a:spcPts val="0"/>
              </a:spcBef>
              <a:spcAft>
                <a:spcPts val="0"/>
              </a:spcAft>
              <a:buClr>
                <a:schemeClr val="dk1"/>
              </a:buClr>
              <a:buSzPts val="1400"/>
              <a:buFont typeface="Arial"/>
              <a:buChar char="●"/>
              <a:tabLst/>
              <a:defRPr/>
            </a:pPr>
            <a:r>
              <a:rPr lang="en-US" dirty="0"/>
              <a:t>Please refer to the Facilitator Guide for discussion points (Appendix B)</a:t>
            </a:r>
          </a:p>
          <a:p>
            <a:pPr marL="457200" lvl="0" indent="-317500" algn="l" rtl="0">
              <a:spcBef>
                <a:spcPts val="0"/>
              </a:spcBef>
              <a:spcAft>
                <a:spcPts val="0"/>
              </a:spcAft>
              <a:buClr>
                <a:schemeClr val="dk1"/>
              </a:buClr>
              <a:buSzPts val="1400"/>
              <a:buChar char="●"/>
            </a:pPr>
            <a:endParaRPr dirty="0"/>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8"/>
        <p:cNvGrpSpPr/>
        <p:nvPr/>
      </p:nvGrpSpPr>
      <p:grpSpPr>
        <a:xfrm>
          <a:off x="0" y="0"/>
          <a:ext cx="0" cy="0"/>
          <a:chOff x="0" y="0"/>
          <a:chExt cx="0" cy="0"/>
        </a:xfrm>
      </p:grpSpPr>
      <p:sp>
        <p:nvSpPr>
          <p:cNvPr id="409" name="Google Shape;409;gd394e66482_1_8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0" name="Google Shape;410;gd394e66482_1_8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Can someone who discussed case 1 share their main take-aways? How about for case 2?”</a:t>
            </a:r>
          </a:p>
          <a:p>
            <a:pPr marL="457200" lvl="0" indent="-317500" algn="l" rtl="0">
              <a:spcBef>
                <a:spcPts val="0"/>
              </a:spcBef>
              <a:spcAft>
                <a:spcPts val="0"/>
              </a:spcAft>
              <a:buSzPts val="1400"/>
              <a:buChar char="●"/>
            </a:pPr>
            <a:r>
              <a:rPr lang="en" dirty="0"/>
              <a:t>This slide may be skipped if time does not allow, and instead review slides 38 and 39 for main points</a:t>
            </a:r>
            <a:endParaRPr dirty="0"/>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gd5ba61f480_0_39: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6" name="Google Shape;416;gd5ba61f480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a:t>Ask participants to fill out anonymous post-workshop survey. Facilitator should copy and paste link into the chat for easier access. </a:t>
            </a: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3"/>
        <p:cNvGrpSpPr/>
        <p:nvPr/>
      </p:nvGrpSpPr>
      <p:grpSpPr>
        <a:xfrm>
          <a:off x="0" y="0"/>
          <a:ext cx="0" cy="0"/>
          <a:chOff x="0" y="0"/>
          <a:chExt cx="0" cy="0"/>
        </a:xfrm>
      </p:grpSpPr>
      <p:sp>
        <p:nvSpPr>
          <p:cNvPr id="424" name="Google Shape;424;gd5ba61f480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5" name="Google Shape;425;gd5ba61f480_0_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61950" algn="l" rtl="0">
              <a:lnSpc>
                <a:spcPct val="115000"/>
              </a:lnSpc>
              <a:spcBef>
                <a:spcPts val="1000"/>
              </a:spcBef>
              <a:spcAft>
                <a:spcPts val="0"/>
              </a:spcAft>
              <a:buSzPts val="2100"/>
              <a:buChar char="●"/>
            </a:pPr>
            <a:r>
              <a:rPr lang="en" b="0" dirty="0"/>
              <a:t>“Thank you for your participation. We hope that through this workshop you’ve been able to </a:t>
            </a:r>
            <a:r>
              <a:rPr lang="en-US" sz="1100" b="0" dirty="0">
                <a:solidFill>
                  <a:srgbClr val="000000"/>
                </a:solidFill>
                <a:latin typeface="Montserrat"/>
                <a:sym typeface="Montserrat"/>
              </a:rPr>
              <a:t>e</a:t>
            </a:r>
            <a:r>
              <a:rPr lang="en-US" sz="1100" b="0" dirty="0">
                <a:solidFill>
                  <a:srgbClr val="000000"/>
                </a:solidFill>
                <a:latin typeface="Montserrat"/>
                <a:ea typeface="Montserrat"/>
                <a:cs typeface="Montserrat"/>
                <a:sym typeface="Montserrat"/>
              </a:rPr>
              <a:t>xamine the importance of name pronunciation in identity affirmation, illustrate the historical instances of racism that contribute to name mispronunciation, employ tools to engage in productive conversation around name pronunciation, and apply name affirmation tools to case scenarios in a clinical and medical education setting.” </a:t>
            </a:r>
            <a:endParaRPr lang="en-US" b="0" dirty="0"/>
          </a:p>
          <a:p>
            <a:pPr marL="457200" lvl="0" indent="-317500" algn="l" rtl="0">
              <a:spcBef>
                <a:spcPts val="0"/>
              </a:spcBef>
              <a:spcAft>
                <a:spcPts val="0"/>
              </a:spcAft>
              <a:buSzPts val="1400"/>
              <a:buChar char="●"/>
            </a:pPr>
            <a:endParaRPr b="0" dirty="0"/>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0"/>
        <p:cNvGrpSpPr/>
        <p:nvPr/>
      </p:nvGrpSpPr>
      <p:grpSpPr>
        <a:xfrm>
          <a:off x="0" y="0"/>
          <a:ext cx="0" cy="0"/>
          <a:chOff x="0" y="0"/>
          <a:chExt cx="0" cy="0"/>
        </a:xfrm>
      </p:grpSpPr>
      <p:sp>
        <p:nvSpPr>
          <p:cNvPr id="431" name="Google Shape;431;gd62712f9b0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2" name="Google Shape;432;gd62712f9b0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There are a few take home points from this workshop.” </a:t>
            </a:r>
          </a:p>
          <a:p>
            <a:pPr marL="457200" marR="0" lvl="0" indent="-317500" algn="l" defTabSz="914400" rtl="0" eaLnBrk="1" fontAlgn="auto" latinLnBrk="0" hangingPunct="1">
              <a:lnSpc>
                <a:spcPct val="100000"/>
              </a:lnSpc>
              <a:spcBef>
                <a:spcPts val="0"/>
              </a:spcBef>
              <a:spcAft>
                <a:spcPts val="0"/>
              </a:spcAft>
              <a:buClr>
                <a:srgbClr val="000000"/>
              </a:buClr>
              <a:buSzPts val="1400"/>
              <a:buFont typeface="Arial"/>
              <a:buChar char="●"/>
              <a:tabLst/>
              <a:defRPr/>
            </a:pPr>
            <a:r>
              <a:rPr lang="en-US" dirty="0"/>
              <a:t>“Names are deeply personal and have complex ties to identity and racial microaggressions.”</a:t>
            </a:r>
          </a:p>
          <a:p>
            <a:pPr marL="457200" lvl="0" indent="-317500" algn="l" rtl="0">
              <a:spcBef>
                <a:spcPts val="0"/>
              </a:spcBef>
              <a:spcAft>
                <a:spcPts val="0"/>
              </a:spcAft>
              <a:buSzPts val="1400"/>
              <a:buChar char="●"/>
            </a:pPr>
            <a:r>
              <a:rPr lang="en" dirty="0"/>
              <a:t>“The key steps in name pronunciation are to just ask about preference, practice many times, and own your mistakes and correct them.”</a:t>
            </a:r>
          </a:p>
          <a:p>
            <a:pPr marL="457200" lvl="0" indent="-317500" algn="l" rtl="0">
              <a:spcBef>
                <a:spcPts val="0"/>
              </a:spcBef>
              <a:spcAft>
                <a:spcPts val="0"/>
              </a:spcAft>
              <a:buSzPts val="1400"/>
              <a:buChar char="●"/>
            </a:pPr>
            <a:r>
              <a:rPr lang="en" dirty="0"/>
              <a:t>“We hope you can incorporate some of the tools shared into the electronic health record, professional settings, and personal life.”</a:t>
            </a:r>
          </a:p>
          <a:p>
            <a:pPr marL="457200" lvl="0" indent="-317500" algn="l" rtl="0">
              <a:spcBef>
                <a:spcPts val="0"/>
              </a:spcBef>
              <a:spcAft>
                <a:spcPts val="0"/>
              </a:spcAft>
              <a:buSzPts val="1400"/>
              <a:buChar char="●"/>
            </a:pP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35f391192_0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35f391192_0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04800" algn="l" rtl="0">
              <a:spcBef>
                <a:spcPts val="0"/>
              </a:spcBef>
              <a:spcAft>
                <a:spcPts val="0"/>
              </a:spcAft>
              <a:buSzPts val="1200"/>
              <a:buChar char="●"/>
            </a:pPr>
            <a:r>
              <a:rPr lang="en" sz="1200" dirty="0"/>
              <a:t>“What’s in a name? At their core, names are a reflection of identity, and they often have meaning to an individual that </a:t>
            </a:r>
            <a:r>
              <a:rPr lang="en" sz="1200" dirty="0">
                <a:solidFill>
                  <a:schemeClr val="dk1"/>
                </a:solidFill>
              </a:rPr>
              <a:t>tie them to a racial, ethnic, cultural, or religious group.”</a:t>
            </a:r>
            <a:endParaRPr sz="1200" dirty="0"/>
          </a:p>
          <a:p>
            <a:pPr marL="457200" lvl="0" indent="-304800" algn="l" rtl="0">
              <a:spcBef>
                <a:spcPts val="0"/>
              </a:spcBef>
              <a:spcAft>
                <a:spcPts val="0"/>
              </a:spcAft>
              <a:buSzPts val="1200"/>
              <a:buChar char="●"/>
            </a:pPr>
            <a:r>
              <a:rPr lang="en" sz="1200" dirty="0"/>
              <a:t>“Author Beth Nguyen highlights the tension between the individual and societal roles of names in this quote that reads… (read quote)”</a:t>
            </a:r>
            <a:endParaRPr sz="1200" dirty="0"/>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7"/>
        <p:cNvGrpSpPr/>
        <p:nvPr/>
      </p:nvGrpSpPr>
      <p:grpSpPr>
        <a:xfrm>
          <a:off x="0" y="0"/>
          <a:ext cx="0" cy="0"/>
          <a:chOff x="0" y="0"/>
          <a:chExt cx="0" cy="0"/>
        </a:xfrm>
      </p:grpSpPr>
      <p:sp>
        <p:nvSpPr>
          <p:cNvPr id="438" name="Google Shape;438;gd7158b966c_0_6: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9" name="Google Shape;439;gd7158b966c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g35f391192_029:notes"/>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1" name="Google Shape;141;g35f391192_0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a:t>“We will dive in with a breakout room to think a little bit more about what all of our names mean to us”</a:t>
            </a:r>
            <a:endParaRPr/>
          </a:p>
          <a:p>
            <a:pPr marL="457200" lvl="0" indent="-317500" algn="l" rtl="0">
              <a:spcBef>
                <a:spcPts val="0"/>
              </a:spcBef>
              <a:spcAft>
                <a:spcPts val="0"/>
              </a:spcAft>
              <a:buSzPts val="1400"/>
              <a:buChar char="●"/>
            </a:pPr>
            <a:r>
              <a:rPr lang="en"/>
              <a:t>Randomly assign participants to zoom breakout rooms with about 6-8 participants per room. Participants will be assigned the same zoom room for breakout room #2.</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g35f391192_0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8" name="Google Shape;148;g35f391192_0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Names are essential to a person’s identity and a way to show respect. Chronic mispronunciation can lead an individual to feel marginalized and undervalued and may be experienced as a micro-</a:t>
            </a:r>
            <a:r>
              <a:rPr lang="en" dirty="0" err="1"/>
              <a:t>agression</a:t>
            </a:r>
            <a:r>
              <a:rPr lang="en" dirty="0"/>
              <a:t>, even if that is not intended.”</a:t>
            </a:r>
            <a:endParaRPr dirty="0"/>
          </a:p>
          <a:p>
            <a:pPr marL="457200" lvl="0" indent="-317500" algn="l" rtl="0">
              <a:spcBef>
                <a:spcPts val="0"/>
              </a:spcBef>
              <a:spcAft>
                <a:spcPts val="0"/>
              </a:spcAft>
              <a:buSzPts val="1400"/>
              <a:buChar char="●"/>
            </a:pPr>
            <a:r>
              <a:rPr lang="en" dirty="0"/>
              <a:t>“Using someone’s correct name, similar to their pronouns, is a way to validate their existence, which can be immensely useful in all situations from increasing trust and communication among coworkers, to providing support to patients or de-escalating tense situations.”</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35f391192_0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 name="Google Shape;156;g35f391192_0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We can see a lot of representations of the impact of name mispronunciation, such as this quote from </a:t>
            </a:r>
            <a:r>
              <a:rPr lang="en" dirty="0" err="1"/>
              <a:t>Yejin</a:t>
            </a:r>
            <a:r>
              <a:rPr lang="en" dirty="0"/>
              <a:t> Lee…(read quote)”</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lvl="0" indent="-317500" algn="l" rtl="0">
              <a:spcBef>
                <a:spcPts val="0"/>
              </a:spcBef>
              <a:spcAft>
                <a:spcPts val="0"/>
              </a:spcAft>
              <a:buSzPts val="1400"/>
              <a:buChar char="●"/>
            </a:pPr>
            <a:r>
              <a:rPr lang="en-US" dirty="0"/>
              <a:t>“We can also see many other examples of this throughout popular media and news highlight the importance of the issue and the impact it can have on individuals lives and that it remains an on going concern, like in ‘America Ruined My Name for Me,’ ‘Say My Name, Why Pronouncing Names Correctly is Important’ and ‘It’s Well Past Time White People Learn How to Say Everyone’s Names Correctly’”</a:t>
            </a:r>
          </a:p>
          <a:p>
            <a:pPr marL="457200" lvl="0" indent="-317500" algn="l" rtl="0">
              <a:spcBef>
                <a:spcPts val="0"/>
              </a:spcBef>
              <a:spcAft>
                <a:spcPts val="0"/>
              </a:spcAft>
              <a:buSzPts val="1400"/>
              <a:buChar char="●"/>
            </a:pPr>
            <a:r>
              <a:rPr lang="en-US" dirty="0"/>
              <a:t>“Students are negatively affected and can lead them to shy away from their own backgrounds, as highlighted by ‘Pronouncing Students’ Names Correctly Should Be a Big Deal’ and ‘The Lasting Impact of Mispronouncing Students’ Names’”</a:t>
            </a:r>
          </a:p>
          <a:p>
            <a:endParaRPr lang="en-US" dirty="0"/>
          </a:p>
        </p:txBody>
      </p:sp>
    </p:spTree>
    <p:extLst>
      <p:ext uri="{BB962C8B-B14F-4D97-AF65-F5344CB8AC3E}">
        <p14:creationId xmlns:p14="http://schemas.microsoft.com/office/powerpoint/2010/main" val="391630032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35ed75ccf_08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35ed75ccf_08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dirty="0"/>
              <a:t>“We are curious about what the experience of everyone here is in regards to pronouncing and mispronouncing names. By either using the zoom function ‘Raise Hand’ or manually raising your hand, please raise your hand if you have ever mispronounced someone’s name”</a:t>
            </a:r>
            <a:endParaRPr dirty="0"/>
          </a:p>
          <a:p>
            <a:pPr marL="457200" lvl="0" indent="-317500" algn="l" rtl="0">
              <a:spcBef>
                <a:spcPts val="0"/>
              </a:spcBef>
              <a:spcAft>
                <a:spcPts val="0"/>
              </a:spcAft>
              <a:buSzPts val="1400"/>
              <a:buChar char="●"/>
            </a:pPr>
            <a:r>
              <a:rPr lang="en" dirty="0"/>
              <a:t>Review poll results </a:t>
            </a:r>
            <a:endParaRPr dirty="0"/>
          </a:p>
          <a:p>
            <a:pPr marL="457200" lvl="0" indent="-317500" algn="l" rtl="0">
              <a:spcBef>
                <a:spcPts val="0"/>
              </a:spcBef>
              <a:spcAft>
                <a:spcPts val="0"/>
              </a:spcAft>
              <a:buSzPts val="1400"/>
              <a:buChar char="●"/>
            </a:pPr>
            <a:r>
              <a:rPr lang="en" dirty="0"/>
              <a:t>“It looks like most of us have in fact mispronounced someone else’s name”</a:t>
            </a:r>
            <a:endParaRPr dirty="0"/>
          </a:p>
          <a:p>
            <a:pPr marL="0" lvl="0" indent="0" algn="l" rtl="0">
              <a:spcBef>
                <a:spcPts val="0"/>
              </a:spcBef>
              <a:spcAft>
                <a:spcPts val="0"/>
              </a:spcAft>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type="title">
  <p:cSld name="TITLE">
    <p:bg>
      <p:bgPr>
        <a:gradFill>
          <a:gsLst>
            <a:gs pos="0">
              <a:schemeClr val="accent2"/>
            </a:gs>
            <a:gs pos="100000">
              <a:schemeClr val="accent1"/>
            </a:gs>
          </a:gsLst>
          <a:path path="circle">
            <a:fillToRect l="100000" t="100000"/>
          </a:path>
          <a:tileRect r="-100000" b="-100000"/>
        </a:gradFill>
        <a:effectLst/>
      </p:bgPr>
    </p:bg>
    <p:spTree>
      <p:nvGrpSpPr>
        <p:cNvPr id="1" name="Shape 9"/>
        <p:cNvGrpSpPr/>
        <p:nvPr/>
      </p:nvGrpSpPr>
      <p:grpSpPr>
        <a:xfrm>
          <a:off x="0" y="0"/>
          <a:ext cx="0" cy="0"/>
          <a:chOff x="0" y="0"/>
          <a:chExt cx="0" cy="0"/>
        </a:xfrm>
      </p:grpSpPr>
      <p:grpSp>
        <p:nvGrpSpPr>
          <p:cNvPr id="10" name="Google Shape;10;p2"/>
          <p:cNvGrpSpPr/>
          <p:nvPr/>
        </p:nvGrpSpPr>
        <p:grpSpPr>
          <a:xfrm>
            <a:off x="3078602" y="0"/>
            <a:ext cx="6065389" cy="5143642"/>
            <a:chOff x="2052402" y="0"/>
            <a:chExt cx="6065389" cy="5143642"/>
          </a:xfrm>
        </p:grpSpPr>
        <p:sp>
          <p:nvSpPr>
            <p:cNvPr id="11" name="Google Shape;11;p2"/>
            <p:cNvSpPr/>
            <p:nvPr/>
          </p:nvSpPr>
          <p:spPr>
            <a:xfrm>
              <a:off x="2052402" y="0"/>
              <a:ext cx="6065388" cy="5143500"/>
            </a:xfrm>
            <a:custGeom>
              <a:avLst/>
              <a:gdLst/>
              <a:ahLst/>
              <a:cxnLst/>
              <a:rect l="l" t="t" r="r" b="b"/>
              <a:pathLst>
                <a:path w="8087184" h="6858000" extrusionOk="0">
                  <a:moveTo>
                    <a:pt x="7505580" y="6858000"/>
                  </a:moveTo>
                  <a:lnTo>
                    <a:pt x="7696738" y="6858000"/>
                  </a:lnTo>
                  <a:cubicBezTo>
                    <a:pt x="7718274" y="6613807"/>
                    <a:pt x="7866550" y="6398978"/>
                    <a:pt x="8087184" y="6292327"/>
                  </a:cubicBezTo>
                  <a:lnTo>
                    <a:pt x="8087184" y="6085824"/>
                  </a:lnTo>
                  <a:cubicBezTo>
                    <a:pt x="7757916" y="6205690"/>
                    <a:pt x="7529976" y="6508299"/>
                    <a:pt x="7505580" y="6858000"/>
                  </a:cubicBezTo>
                  <a:close/>
                  <a:moveTo>
                    <a:pt x="7109988" y="6858000"/>
                  </a:moveTo>
                  <a:lnTo>
                    <a:pt x="7300574" y="6858000"/>
                  </a:lnTo>
                  <a:cubicBezTo>
                    <a:pt x="7326176" y="6394974"/>
                    <a:pt x="7641722" y="5998774"/>
                    <a:pt x="8087184" y="5870486"/>
                  </a:cubicBezTo>
                  <a:lnTo>
                    <a:pt x="8087184" y="5673454"/>
                  </a:lnTo>
                  <a:cubicBezTo>
                    <a:pt x="7534740" y="5807487"/>
                    <a:pt x="7136797" y="6289898"/>
                    <a:pt x="7109988" y="6858000"/>
                  </a:cubicBezTo>
                  <a:close/>
                  <a:moveTo>
                    <a:pt x="6319630" y="6858000"/>
                  </a:moveTo>
                  <a:lnTo>
                    <a:pt x="6510215" y="6858000"/>
                  </a:lnTo>
                  <a:cubicBezTo>
                    <a:pt x="6538485" y="5958928"/>
                    <a:pt x="7199691" y="5205998"/>
                    <a:pt x="8087184" y="5062145"/>
                  </a:cubicBezTo>
                  <a:lnTo>
                    <a:pt x="8087184" y="4869180"/>
                  </a:lnTo>
                  <a:cubicBezTo>
                    <a:pt x="7093725" y="5015188"/>
                    <a:pt x="6348402" y="5853783"/>
                    <a:pt x="6319630" y="6858000"/>
                  </a:cubicBezTo>
                  <a:close/>
                  <a:moveTo>
                    <a:pt x="6714777" y="6858000"/>
                  </a:moveTo>
                  <a:lnTo>
                    <a:pt x="6905363" y="6858000"/>
                  </a:lnTo>
                  <a:cubicBezTo>
                    <a:pt x="6932680" y="6177012"/>
                    <a:pt x="7419944" y="5602103"/>
                    <a:pt x="8086993" y="5463773"/>
                  </a:cubicBezTo>
                  <a:lnTo>
                    <a:pt x="8086993" y="5269538"/>
                  </a:lnTo>
                  <a:cubicBezTo>
                    <a:pt x="7313661" y="5411166"/>
                    <a:pt x="6742920" y="6071943"/>
                    <a:pt x="6714968" y="6858000"/>
                  </a:cubicBezTo>
                  <a:close/>
                  <a:moveTo>
                    <a:pt x="7902253" y="6858000"/>
                  </a:moveTo>
                  <a:lnTo>
                    <a:pt x="8087184" y="6858000"/>
                  </a:lnTo>
                  <a:lnTo>
                    <a:pt x="8087184" y="6532261"/>
                  </a:lnTo>
                  <a:cubicBezTo>
                    <a:pt x="7984903" y="6612091"/>
                    <a:pt x="7918389" y="6729230"/>
                    <a:pt x="7902253" y="6858000"/>
                  </a:cubicBezTo>
                  <a:close/>
                  <a:moveTo>
                    <a:pt x="1916910" y="2551824"/>
                  </a:moveTo>
                  <a:cubicBezTo>
                    <a:pt x="2641015" y="1478290"/>
                    <a:pt x="3620238" y="601442"/>
                    <a:pt x="4766674" y="0"/>
                  </a:cubicBezTo>
                  <a:lnTo>
                    <a:pt x="4372797" y="0"/>
                  </a:lnTo>
                  <a:cubicBezTo>
                    <a:pt x="4217787" y="90127"/>
                    <a:pt x="4065999" y="185317"/>
                    <a:pt x="3917425" y="285570"/>
                  </a:cubicBezTo>
                  <a:cubicBezTo>
                    <a:pt x="2632356" y="1153193"/>
                    <a:pt x="1626642" y="2375366"/>
                    <a:pt x="1022365" y="3803743"/>
                  </a:cubicBezTo>
                  <a:cubicBezTo>
                    <a:pt x="613622" y="4771490"/>
                    <a:pt x="402707" y="5798792"/>
                    <a:pt x="395021" y="6858000"/>
                  </a:cubicBezTo>
                  <a:lnTo>
                    <a:pt x="585606" y="6858000"/>
                  </a:lnTo>
                  <a:cubicBezTo>
                    <a:pt x="593293" y="5824406"/>
                    <a:pt x="799126" y="4822147"/>
                    <a:pt x="1197894" y="3877980"/>
                  </a:cubicBezTo>
                  <a:cubicBezTo>
                    <a:pt x="1394236" y="3413753"/>
                    <a:pt x="1635028" y="2969629"/>
                    <a:pt x="1916910" y="2551824"/>
                  </a:cubicBezTo>
                  <a:close/>
                  <a:moveTo>
                    <a:pt x="1589421" y="2330830"/>
                  </a:moveTo>
                  <a:cubicBezTo>
                    <a:pt x="2178972" y="1457633"/>
                    <a:pt x="2930502" y="705726"/>
                    <a:pt x="3803264" y="115868"/>
                  </a:cubicBezTo>
                  <a:cubicBezTo>
                    <a:pt x="3861583" y="76504"/>
                    <a:pt x="3920429" y="37881"/>
                    <a:pt x="3979810" y="0"/>
                  </a:cubicBezTo>
                  <a:lnTo>
                    <a:pt x="3635104" y="0"/>
                  </a:lnTo>
                  <a:cubicBezTo>
                    <a:pt x="2315489" y="907938"/>
                    <a:pt x="1282730" y="2174291"/>
                    <a:pt x="658473" y="3649867"/>
                  </a:cubicBezTo>
                  <a:cubicBezTo>
                    <a:pt x="229084" y="4666364"/>
                    <a:pt x="7814" y="5745720"/>
                    <a:pt x="0" y="6858000"/>
                  </a:cubicBezTo>
                  <a:lnTo>
                    <a:pt x="190586" y="6858000"/>
                  </a:lnTo>
                  <a:cubicBezTo>
                    <a:pt x="198336" y="5771144"/>
                    <a:pt x="414587" y="4716957"/>
                    <a:pt x="833939" y="3724104"/>
                  </a:cubicBezTo>
                  <a:cubicBezTo>
                    <a:pt x="1040191" y="3236353"/>
                    <a:pt x="1293200" y="2769749"/>
                    <a:pt x="1589421" y="2330830"/>
                  </a:cubicBezTo>
                  <a:close/>
                  <a:moveTo>
                    <a:pt x="2572017" y="2993622"/>
                  </a:moveTo>
                  <a:cubicBezTo>
                    <a:pt x="3332930" y="1865656"/>
                    <a:pt x="4404701" y="982881"/>
                    <a:pt x="5657281" y="452412"/>
                  </a:cubicBezTo>
                  <a:cubicBezTo>
                    <a:pt x="6154760" y="241841"/>
                    <a:pt x="6675072" y="90013"/>
                    <a:pt x="7207695" y="0"/>
                  </a:cubicBezTo>
                  <a:lnTo>
                    <a:pt x="6359208" y="0"/>
                  </a:lnTo>
                  <a:cubicBezTo>
                    <a:pt x="4284670" y="610249"/>
                    <a:pt x="2593089" y="2119237"/>
                    <a:pt x="1750212" y="4111495"/>
                  </a:cubicBezTo>
                  <a:cubicBezTo>
                    <a:pt x="1382635" y="4981807"/>
                    <a:pt x="1192558" y="5905571"/>
                    <a:pt x="1184807" y="6858000"/>
                  </a:cubicBezTo>
                  <a:lnTo>
                    <a:pt x="1375393" y="6858000"/>
                  </a:lnTo>
                  <a:cubicBezTo>
                    <a:pt x="1383080" y="5931185"/>
                    <a:pt x="1568075" y="5032463"/>
                    <a:pt x="1925741" y="4185732"/>
                  </a:cubicBezTo>
                  <a:cubicBezTo>
                    <a:pt x="2102147" y="3768398"/>
                    <a:pt x="2318583" y="3369160"/>
                    <a:pt x="2572017" y="2993622"/>
                  </a:cubicBezTo>
                  <a:close/>
                  <a:moveTo>
                    <a:pt x="2244464" y="2772819"/>
                  </a:moveTo>
                  <a:cubicBezTo>
                    <a:pt x="3048163" y="1581236"/>
                    <a:pt x="4180312" y="648682"/>
                    <a:pt x="5503478" y="88347"/>
                  </a:cubicBezTo>
                  <a:cubicBezTo>
                    <a:pt x="5576110" y="57669"/>
                    <a:pt x="5649085" y="28220"/>
                    <a:pt x="5722398" y="0"/>
                  </a:cubicBezTo>
                  <a:lnTo>
                    <a:pt x="5231195" y="0"/>
                  </a:lnTo>
                  <a:cubicBezTo>
                    <a:pt x="3500048" y="791829"/>
                    <a:pt x="2128257" y="2203840"/>
                    <a:pt x="1386320" y="3957619"/>
                  </a:cubicBezTo>
                  <a:cubicBezTo>
                    <a:pt x="998097" y="4876680"/>
                    <a:pt x="797664" y="5852181"/>
                    <a:pt x="789914" y="6858000"/>
                  </a:cubicBezTo>
                  <a:lnTo>
                    <a:pt x="980500" y="6858000"/>
                  </a:lnTo>
                  <a:cubicBezTo>
                    <a:pt x="988250" y="5877796"/>
                    <a:pt x="1183791" y="4927273"/>
                    <a:pt x="1561849" y="4031856"/>
                  </a:cubicBezTo>
                  <a:cubicBezTo>
                    <a:pt x="1748217" y="3591107"/>
                    <a:pt x="1976824" y="3169458"/>
                    <a:pt x="2244464" y="2772819"/>
                  </a:cubicBezTo>
                  <a:close/>
                  <a:moveTo>
                    <a:pt x="6645086" y="5174199"/>
                  </a:moveTo>
                  <a:cubicBezTo>
                    <a:pt x="6196994" y="5621603"/>
                    <a:pt x="5938846" y="6224801"/>
                    <a:pt x="5924482" y="6858000"/>
                  </a:cubicBezTo>
                  <a:lnTo>
                    <a:pt x="6115068" y="6858000"/>
                  </a:lnTo>
                  <a:cubicBezTo>
                    <a:pt x="6144113" y="5740903"/>
                    <a:pt x="6980009" y="4810427"/>
                    <a:pt x="8087184" y="4662805"/>
                  </a:cubicBezTo>
                  <a:lnTo>
                    <a:pt x="8087184" y="4470476"/>
                  </a:lnTo>
                  <a:cubicBezTo>
                    <a:pt x="7541283" y="4536958"/>
                    <a:pt x="7033500" y="4784755"/>
                    <a:pt x="6645086" y="5174199"/>
                  </a:cubicBezTo>
                  <a:close/>
                  <a:moveTo>
                    <a:pt x="5248665" y="3776858"/>
                  </a:moveTo>
                  <a:cubicBezTo>
                    <a:pt x="4429655" y="4594492"/>
                    <a:pt x="3963299" y="5700524"/>
                    <a:pt x="3949506" y="6858000"/>
                  </a:cubicBezTo>
                  <a:lnTo>
                    <a:pt x="4140092" y="6858000"/>
                  </a:lnTo>
                  <a:cubicBezTo>
                    <a:pt x="4168387" y="4649426"/>
                    <a:pt x="5884840" y="2831630"/>
                    <a:pt x="8087184" y="2677862"/>
                  </a:cubicBezTo>
                  <a:lnTo>
                    <a:pt x="8087184" y="2486740"/>
                  </a:lnTo>
                  <a:cubicBezTo>
                    <a:pt x="7015966" y="2558053"/>
                    <a:pt x="6007247" y="3016624"/>
                    <a:pt x="5248983" y="3776985"/>
                  </a:cubicBezTo>
                  <a:close/>
                  <a:moveTo>
                    <a:pt x="4410660" y="2938516"/>
                  </a:moveTo>
                  <a:cubicBezTo>
                    <a:pt x="3369116" y="3978263"/>
                    <a:pt x="2777913" y="5386016"/>
                    <a:pt x="2764635" y="6858000"/>
                  </a:cubicBezTo>
                  <a:lnTo>
                    <a:pt x="2955221" y="6858000"/>
                  </a:lnTo>
                  <a:cubicBezTo>
                    <a:pt x="2982996" y="3994566"/>
                    <a:pt x="5229175" y="1645170"/>
                    <a:pt x="8087184" y="1490201"/>
                  </a:cubicBezTo>
                  <a:lnTo>
                    <a:pt x="8087184" y="1299524"/>
                  </a:lnTo>
                  <a:cubicBezTo>
                    <a:pt x="6701118" y="1371556"/>
                    <a:pt x="5391045" y="1955579"/>
                    <a:pt x="4410660" y="2938516"/>
                  </a:cubicBezTo>
                  <a:close/>
                  <a:moveTo>
                    <a:pt x="4131135" y="2658858"/>
                  </a:moveTo>
                  <a:cubicBezTo>
                    <a:pt x="3581562" y="3207390"/>
                    <a:pt x="3143742" y="3857527"/>
                    <a:pt x="2842013" y="4573123"/>
                  </a:cubicBezTo>
                  <a:cubicBezTo>
                    <a:pt x="2536123" y="5297313"/>
                    <a:pt x="2377365" y="6065676"/>
                    <a:pt x="2369615" y="6858000"/>
                  </a:cubicBezTo>
                  <a:lnTo>
                    <a:pt x="2560201" y="6858000"/>
                  </a:lnTo>
                  <a:cubicBezTo>
                    <a:pt x="2567887" y="6091353"/>
                    <a:pt x="2721563" y="5347905"/>
                    <a:pt x="3017606" y="4647360"/>
                  </a:cubicBezTo>
                  <a:cubicBezTo>
                    <a:pt x="3885813" y="2587735"/>
                    <a:pt x="5855795" y="1207104"/>
                    <a:pt x="8087184" y="1094420"/>
                  </a:cubicBezTo>
                  <a:lnTo>
                    <a:pt x="8087184" y="903743"/>
                  </a:lnTo>
                  <a:cubicBezTo>
                    <a:pt x="6596296" y="976143"/>
                    <a:pt x="5185918" y="1602077"/>
                    <a:pt x="4131643" y="2659239"/>
                  </a:cubicBezTo>
                  <a:close/>
                  <a:moveTo>
                    <a:pt x="3851609" y="2379199"/>
                  </a:moveTo>
                  <a:cubicBezTo>
                    <a:pt x="3266022" y="2963794"/>
                    <a:pt x="2799525" y="3656649"/>
                    <a:pt x="2478058" y="4419247"/>
                  </a:cubicBezTo>
                  <a:cubicBezTo>
                    <a:pt x="2151585" y="5192123"/>
                    <a:pt x="1982535" y="6012350"/>
                    <a:pt x="1974721" y="6858000"/>
                  </a:cubicBezTo>
                  <a:lnTo>
                    <a:pt x="2165307" y="6858000"/>
                  </a:lnTo>
                  <a:cubicBezTo>
                    <a:pt x="2172994" y="6038091"/>
                    <a:pt x="2337152" y="5242779"/>
                    <a:pt x="2653651" y="4493611"/>
                  </a:cubicBezTo>
                  <a:cubicBezTo>
                    <a:pt x="3583550" y="2287642"/>
                    <a:pt x="5696853" y="811831"/>
                    <a:pt x="8087184" y="699147"/>
                  </a:cubicBezTo>
                  <a:lnTo>
                    <a:pt x="8087184" y="508471"/>
                  </a:lnTo>
                  <a:cubicBezTo>
                    <a:pt x="6491347" y="580803"/>
                    <a:pt x="4980435" y="1248328"/>
                    <a:pt x="3851990" y="2379580"/>
                  </a:cubicBezTo>
                  <a:close/>
                  <a:moveTo>
                    <a:pt x="6365561" y="4894350"/>
                  </a:moveTo>
                  <a:cubicBezTo>
                    <a:pt x="5843312" y="5415945"/>
                    <a:pt x="5543596" y="6119847"/>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689995" y="3217985"/>
                  </a:moveTo>
                  <a:cubicBezTo>
                    <a:pt x="3722659" y="4183711"/>
                    <a:pt x="3173060" y="5490862"/>
                    <a:pt x="3159529" y="6858000"/>
                  </a:cubicBezTo>
                  <a:lnTo>
                    <a:pt x="3350115" y="6858000"/>
                  </a:lnTo>
                  <a:cubicBezTo>
                    <a:pt x="3378080" y="4212840"/>
                    <a:pt x="5447656" y="2040614"/>
                    <a:pt x="8087184" y="1885982"/>
                  </a:cubicBezTo>
                  <a:lnTo>
                    <a:pt x="8087184" y="1694988"/>
                  </a:lnTo>
                  <a:cubicBezTo>
                    <a:pt x="6806004" y="1766892"/>
                    <a:pt x="5596357" y="2309182"/>
                    <a:pt x="4689995" y="3217985"/>
                  </a:cubicBezTo>
                  <a:close/>
                  <a:moveTo>
                    <a:pt x="5736946" y="640864"/>
                  </a:moveTo>
                  <a:cubicBezTo>
                    <a:pt x="4104688" y="1332467"/>
                    <a:pt x="2805440" y="2632335"/>
                    <a:pt x="2114167" y="4265371"/>
                  </a:cubicBezTo>
                  <a:cubicBezTo>
                    <a:pt x="1767110" y="5086996"/>
                    <a:pt x="1587515" y="5958960"/>
                    <a:pt x="1579828" y="6858000"/>
                  </a:cubicBezTo>
                  <a:lnTo>
                    <a:pt x="1770414" y="6858000"/>
                  </a:lnTo>
                  <a:cubicBezTo>
                    <a:pt x="1778101" y="5984575"/>
                    <a:pt x="1952613" y="5137589"/>
                    <a:pt x="2289696" y="4339608"/>
                  </a:cubicBezTo>
                  <a:cubicBezTo>
                    <a:pt x="3281262" y="1987231"/>
                    <a:pt x="5537892" y="416179"/>
                    <a:pt x="8087184" y="303430"/>
                  </a:cubicBezTo>
                  <a:lnTo>
                    <a:pt x="8087184" y="112753"/>
                  </a:lnTo>
                  <a:cubicBezTo>
                    <a:pt x="7278466" y="146573"/>
                    <a:pt x="6482453" y="325450"/>
                    <a:pt x="5736946" y="640864"/>
                  </a:cubicBezTo>
                  <a:close/>
                  <a:moveTo>
                    <a:pt x="4969330" y="3497453"/>
                  </a:moveTo>
                  <a:cubicBezTo>
                    <a:pt x="4076132" y="4389101"/>
                    <a:pt x="3568132" y="5595696"/>
                    <a:pt x="3554486" y="6858000"/>
                  </a:cubicBezTo>
                  <a:lnTo>
                    <a:pt x="3745072" y="6858000"/>
                  </a:lnTo>
                  <a:cubicBezTo>
                    <a:pt x="3773202" y="4431107"/>
                    <a:pt x="5666194" y="2436046"/>
                    <a:pt x="8087184" y="2281763"/>
                  </a:cubicBezTo>
                  <a:lnTo>
                    <a:pt x="8087184" y="2091086"/>
                  </a:lnTo>
                  <a:cubicBezTo>
                    <a:pt x="6910953" y="2162571"/>
                    <a:pt x="5801707" y="2662919"/>
                    <a:pt x="4969330" y="3497453"/>
                  </a:cubicBezTo>
                  <a:close/>
                  <a:moveTo>
                    <a:pt x="6086607" y="4615263"/>
                  </a:moveTo>
                  <a:cubicBezTo>
                    <a:pt x="5490118" y="5210739"/>
                    <a:pt x="5148633" y="6015070"/>
                    <a:pt x="5134441" y="6858000"/>
                  </a:cubicBezTo>
                  <a:lnTo>
                    <a:pt x="5325027" y="6858000"/>
                  </a:lnTo>
                  <a:cubicBezTo>
                    <a:pt x="5353570" y="5304190"/>
                    <a:pt x="6541217" y="4018292"/>
                    <a:pt x="8087184" y="3867302"/>
                  </a:cubicBezTo>
                  <a:lnTo>
                    <a:pt x="8087184" y="3675799"/>
                  </a:lnTo>
                  <a:cubicBezTo>
                    <a:pt x="7330940" y="3744977"/>
                    <a:pt x="6622978" y="4077447"/>
                    <a:pt x="6086607" y="4615263"/>
                  </a:cubicBezTo>
                  <a:close/>
                  <a:moveTo>
                    <a:pt x="5807081" y="4335604"/>
                  </a:moveTo>
                  <a:cubicBezTo>
                    <a:pt x="5136353" y="5005171"/>
                    <a:pt x="4753231" y="5910147"/>
                    <a:pt x="4739230" y="6858000"/>
                  </a:cubicBezTo>
                  <a:lnTo>
                    <a:pt x="4929815" y="6858000"/>
                  </a:lnTo>
                  <a:cubicBezTo>
                    <a:pt x="4958327" y="5085840"/>
                    <a:pt x="6322177" y="3622499"/>
                    <a:pt x="8087184" y="3470313"/>
                  </a:cubicBezTo>
                  <a:lnTo>
                    <a:pt x="8087184" y="3279192"/>
                  </a:lnTo>
                  <a:cubicBezTo>
                    <a:pt x="7225928" y="3349227"/>
                    <a:pt x="6417654" y="3723799"/>
                    <a:pt x="5807335" y="4335794"/>
                  </a:cubicBezTo>
                  <a:close/>
                  <a:moveTo>
                    <a:pt x="5527556" y="4055945"/>
                  </a:moveTo>
                  <a:cubicBezTo>
                    <a:pt x="4782753" y="4799672"/>
                    <a:pt x="4358160" y="5805294"/>
                    <a:pt x="4344463" y="6858000"/>
                  </a:cubicBezTo>
                  <a:lnTo>
                    <a:pt x="4535049" y="6858000"/>
                  </a:lnTo>
                  <a:cubicBezTo>
                    <a:pt x="4563415" y="4867661"/>
                    <a:pt x="6103486" y="3227074"/>
                    <a:pt x="8087184" y="3074024"/>
                  </a:cubicBezTo>
                  <a:lnTo>
                    <a:pt x="8087184" y="2882775"/>
                  </a:lnTo>
                  <a:cubicBezTo>
                    <a:pt x="7120852" y="2953516"/>
                    <a:pt x="6212355" y="3370126"/>
                    <a:pt x="5528000" y="4056326"/>
                  </a:cubicBezTo>
                  <a:close/>
                </a:path>
              </a:pathLst>
            </a:custGeom>
            <a:gradFill>
              <a:gsLst>
                <a:gs pos="0">
                  <a:srgbClr val="00D0FF">
                    <a:alpha val="11764"/>
                    <a:alpha val="11730"/>
                  </a:srgbClr>
                </a:gs>
                <a:gs pos="100000">
                  <a:srgbClr val="00D0FF">
                    <a:alpha val="0"/>
                    <a:alpha val="11730"/>
                  </a:srgbClr>
                </a:gs>
              </a:gsLst>
              <a:path path="circle">
                <a:fillToRect l="100000" t="100000"/>
              </a:path>
              <a:tileRect r="-100000" b="-100000"/>
            </a:gra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12" name="Google Shape;12;p2"/>
            <p:cNvSpPr/>
            <p:nvPr/>
          </p:nvSpPr>
          <p:spPr>
            <a:xfrm>
              <a:off x="2052402" y="0"/>
              <a:ext cx="6065388" cy="5143642"/>
            </a:xfrm>
            <a:custGeom>
              <a:avLst/>
              <a:gdLst/>
              <a:ahLst/>
              <a:cxnLst/>
              <a:rect l="l" t="t" r="r" b="b"/>
              <a:pathLst>
                <a:path w="8087184" h="6858190" extrusionOk="0">
                  <a:moveTo>
                    <a:pt x="6366259" y="1870219"/>
                  </a:moveTo>
                  <a:cubicBezTo>
                    <a:pt x="6414478" y="1849137"/>
                    <a:pt x="6436522" y="1792932"/>
                    <a:pt x="6415430" y="1744684"/>
                  </a:cubicBezTo>
                  <a:cubicBezTo>
                    <a:pt x="6395292" y="1698629"/>
                    <a:pt x="6342913" y="1676110"/>
                    <a:pt x="6295679" y="1693208"/>
                  </a:cubicBezTo>
                  <a:cubicBezTo>
                    <a:pt x="4468935" y="2426156"/>
                    <a:pt x="3157737" y="4060756"/>
                    <a:pt x="2838011" y="6003706"/>
                  </a:cubicBezTo>
                  <a:cubicBezTo>
                    <a:pt x="2829536" y="6055671"/>
                    <a:pt x="2864769" y="6104675"/>
                    <a:pt x="2916716" y="6113154"/>
                  </a:cubicBezTo>
                  <a:cubicBezTo>
                    <a:pt x="2916716" y="6113154"/>
                    <a:pt x="2916723" y="6113154"/>
                    <a:pt x="2916723" y="6113154"/>
                  </a:cubicBezTo>
                  <a:cubicBezTo>
                    <a:pt x="2921824" y="6114012"/>
                    <a:pt x="2926989" y="6114438"/>
                    <a:pt x="2932160" y="6114425"/>
                  </a:cubicBezTo>
                  <a:cubicBezTo>
                    <a:pt x="2978841" y="6114381"/>
                    <a:pt x="3018616" y="6080504"/>
                    <a:pt x="3026119" y="6034405"/>
                  </a:cubicBezTo>
                  <a:cubicBezTo>
                    <a:pt x="3335065" y="4157486"/>
                    <a:pt x="4601646" y="2578418"/>
                    <a:pt x="6366259" y="1870219"/>
                  </a:cubicBezTo>
                  <a:close/>
                  <a:moveTo>
                    <a:pt x="2680460" y="5322927"/>
                  </a:moveTo>
                  <a:cubicBezTo>
                    <a:pt x="2629555" y="5309637"/>
                    <a:pt x="2577512" y="5340139"/>
                    <a:pt x="2564203" y="5391062"/>
                  </a:cubicBezTo>
                  <a:cubicBezTo>
                    <a:pt x="2439623" y="5870239"/>
                    <a:pt x="2374272" y="6362877"/>
                    <a:pt x="2369615" y="6858000"/>
                  </a:cubicBezTo>
                  <a:lnTo>
                    <a:pt x="2560201" y="6858000"/>
                  </a:lnTo>
                  <a:cubicBezTo>
                    <a:pt x="2564794" y="6379148"/>
                    <a:pt x="2628055" y="5902679"/>
                    <a:pt x="2748563" y="5439240"/>
                  </a:cubicBezTo>
                  <a:cubicBezTo>
                    <a:pt x="2761847" y="5388310"/>
                    <a:pt x="2731365" y="5336243"/>
                    <a:pt x="2680460" y="5322927"/>
                  </a:cubicBezTo>
                  <a:close/>
                  <a:moveTo>
                    <a:pt x="2239000" y="4214715"/>
                  </a:moveTo>
                  <a:cubicBezTo>
                    <a:pt x="2190503" y="4194261"/>
                    <a:pt x="2134617" y="4217016"/>
                    <a:pt x="2114179" y="4265537"/>
                  </a:cubicBezTo>
                  <a:cubicBezTo>
                    <a:pt x="2114173" y="4265543"/>
                    <a:pt x="2114173" y="4265556"/>
                    <a:pt x="2114167" y="4265562"/>
                  </a:cubicBezTo>
                  <a:cubicBezTo>
                    <a:pt x="1767110" y="5087187"/>
                    <a:pt x="1587515" y="5959151"/>
                    <a:pt x="1579828" y="6858191"/>
                  </a:cubicBezTo>
                  <a:lnTo>
                    <a:pt x="1770414" y="6858191"/>
                  </a:lnTo>
                  <a:cubicBezTo>
                    <a:pt x="1778101" y="5984765"/>
                    <a:pt x="1952613" y="5137780"/>
                    <a:pt x="2289696" y="4339799"/>
                  </a:cubicBezTo>
                  <a:cubicBezTo>
                    <a:pt x="2310254" y="4291329"/>
                    <a:pt x="2287638" y="4235359"/>
                    <a:pt x="2239191" y="4214797"/>
                  </a:cubicBezTo>
                  <a:cubicBezTo>
                    <a:pt x="2239127" y="4214766"/>
                    <a:pt x="2239064" y="4214740"/>
                    <a:pt x="2239000" y="4214715"/>
                  </a:cubicBezTo>
                  <a:close/>
                  <a:moveTo>
                    <a:pt x="2087612" y="6428088"/>
                  </a:moveTo>
                  <a:cubicBezTo>
                    <a:pt x="2035093" y="6424847"/>
                    <a:pt x="1989898" y="6464825"/>
                    <a:pt x="1986665" y="6517389"/>
                  </a:cubicBezTo>
                  <a:cubicBezTo>
                    <a:pt x="1979740" y="6630078"/>
                    <a:pt x="1975738" y="6744357"/>
                    <a:pt x="1974658" y="6858000"/>
                  </a:cubicBezTo>
                  <a:lnTo>
                    <a:pt x="2165244" y="6858000"/>
                  </a:lnTo>
                  <a:cubicBezTo>
                    <a:pt x="2166260" y="6748234"/>
                    <a:pt x="2170135" y="6637896"/>
                    <a:pt x="2176806" y="6529083"/>
                  </a:cubicBezTo>
                  <a:cubicBezTo>
                    <a:pt x="2180027" y="6476584"/>
                    <a:pt x="2140105" y="6431330"/>
                    <a:pt x="2087612" y="6428088"/>
                  </a:cubicBezTo>
                  <a:close/>
                  <a:moveTo>
                    <a:pt x="3486447" y="3682663"/>
                  </a:moveTo>
                  <a:cubicBezTo>
                    <a:pt x="3518040" y="3682689"/>
                    <a:pt x="3547593" y="3667047"/>
                    <a:pt x="3565349" y="3640906"/>
                  </a:cubicBezTo>
                  <a:cubicBezTo>
                    <a:pt x="3898042" y="3151394"/>
                    <a:pt x="4303100" y="2715260"/>
                    <a:pt x="4766674" y="2347419"/>
                  </a:cubicBezTo>
                  <a:cubicBezTo>
                    <a:pt x="4807898" y="2314686"/>
                    <a:pt x="4814797" y="2254712"/>
                    <a:pt x="4782080" y="2213469"/>
                  </a:cubicBezTo>
                  <a:cubicBezTo>
                    <a:pt x="4749362" y="2172225"/>
                    <a:pt x="4689417" y="2165323"/>
                    <a:pt x="4648193" y="2198056"/>
                  </a:cubicBezTo>
                  <a:cubicBezTo>
                    <a:pt x="4169519" y="2577934"/>
                    <a:pt x="3751284" y="3028338"/>
                    <a:pt x="3407798" y="3533872"/>
                  </a:cubicBezTo>
                  <a:cubicBezTo>
                    <a:pt x="3378188" y="3577397"/>
                    <a:pt x="3389451" y="3636704"/>
                    <a:pt x="3432956" y="3666329"/>
                  </a:cubicBezTo>
                  <a:cubicBezTo>
                    <a:pt x="3448730" y="3677071"/>
                    <a:pt x="3467363" y="3682829"/>
                    <a:pt x="3486447" y="3682854"/>
                  </a:cubicBezTo>
                  <a:close/>
                  <a:moveTo>
                    <a:pt x="5285003" y="4471365"/>
                  </a:moveTo>
                  <a:cubicBezTo>
                    <a:pt x="5242903" y="4439770"/>
                    <a:pt x="5183174" y="4448313"/>
                    <a:pt x="5151593" y="4490433"/>
                  </a:cubicBezTo>
                  <a:cubicBezTo>
                    <a:pt x="4638429" y="5174034"/>
                    <a:pt x="4355873" y="6003210"/>
                    <a:pt x="4344781" y="6858064"/>
                  </a:cubicBezTo>
                  <a:lnTo>
                    <a:pt x="4535367" y="6858064"/>
                  </a:lnTo>
                  <a:cubicBezTo>
                    <a:pt x="4546427" y="6044479"/>
                    <a:pt x="4815610" y="5255459"/>
                    <a:pt x="5304062" y="4604903"/>
                  </a:cubicBezTo>
                  <a:cubicBezTo>
                    <a:pt x="5335661" y="4562795"/>
                    <a:pt x="5327161" y="4503030"/>
                    <a:pt x="5285074" y="4471416"/>
                  </a:cubicBezTo>
                  <a:cubicBezTo>
                    <a:pt x="5285048" y="4471403"/>
                    <a:pt x="5285029" y="4471384"/>
                    <a:pt x="5285003" y="4471365"/>
                  </a:cubicBezTo>
                  <a:close/>
                  <a:moveTo>
                    <a:pt x="6701690" y="2808030"/>
                  </a:moveTo>
                  <a:cubicBezTo>
                    <a:pt x="5767433" y="3193508"/>
                    <a:pt x="4991743" y="3885022"/>
                    <a:pt x="4501697" y="4769266"/>
                  </a:cubicBezTo>
                  <a:cubicBezTo>
                    <a:pt x="4475720" y="4815060"/>
                    <a:pt x="4491773" y="4873248"/>
                    <a:pt x="4537546" y="4899237"/>
                  </a:cubicBezTo>
                  <a:cubicBezTo>
                    <a:pt x="4583318" y="4925227"/>
                    <a:pt x="4641478" y="4909165"/>
                    <a:pt x="4667455" y="4863371"/>
                  </a:cubicBezTo>
                  <a:cubicBezTo>
                    <a:pt x="4667792" y="4862767"/>
                    <a:pt x="4668129" y="4862164"/>
                    <a:pt x="4668459" y="4861553"/>
                  </a:cubicBezTo>
                  <a:cubicBezTo>
                    <a:pt x="5137446" y="4015222"/>
                    <a:pt x="5879860" y="3353378"/>
                    <a:pt x="6774050" y="2984470"/>
                  </a:cubicBezTo>
                  <a:cubicBezTo>
                    <a:pt x="6822775" y="2964480"/>
                    <a:pt x="6846027" y="2908777"/>
                    <a:pt x="6826079" y="2860053"/>
                  </a:cubicBezTo>
                  <a:cubicBezTo>
                    <a:pt x="6806067" y="2811329"/>
                    <a:pt x="6750416" y="2788041"/>
                    <a:pt x="6701690" y="2808030"/>
                  </a:cubicBezTo>
                  <a:close/>
                  <a:moveTo>
                    <a:pt x="4156864" y="5925783"/>
                  </a:moveTo>
                  <a:cubicBezTo>
                    <a:pt x="4105367" y="5914933"/>
                    <a:pt x="4054824" y="5947901"/>
                    <a:pt x="4043980" y="5999428"/>
                  </a:cubicBezTo>
                  <a:cubicBezTo>
                    <a:pt x="4043973" y="5999435"/>
                    <a:pt x="4043973" y="5999441"/>
                    <a:pt x="4043973" y="5999447"/>
                  </a:cubicBezTo>
                  <a:cubicBezTo>
                    <a:pt x="3984905" y="6281916"/>
                    <a:pt x="3953267" y="6569443"/>
                    <a:pt x="3949506" y="6858000"/>
                  </a:cubicBezTo>
                  <a:lnTo>
                    <a:pt x="4140092" y="6858000"/>
                  </a:lnTo>
                  <a:cubicBezTo>
                    <a:pt x="4143866" y="6582600"/>
                    <a:pt x="4174143" y="6308242"/>
                    <a:pt x="4230493" y="6038663"/>
                  </a:cubicBezTo>
                  <a:cubicBezTo>
                    <a:pt x="4241299" y="5987155"/>
                    <a:pt x="4208341" y="5936626"/>
                    <a:pt x="4156864" y="5925783"/>
                  </a:cubicBezTo>
                  <a:close/>
                  <a:moveTo>
                    <a:pt x="5530160" y="2764810"/>
                  </a:moveTo>
                  <a:cubicBezTo>
                    <a:pt x="5974498" y="2457948"/>
                    <a:pt x="6465491" y="2225005"/>
                    <a:pt x="6984202" y="2075006"/>
                  </a:cubicBezTo>
                  <a:cubicBezTo>
                    <a:pt x="7034770" y="2060368"/>
                    <a:pt x="7063867" y="2007494"/>
                    <a:pt x="7049255" y="1956914"/>
                  </a:cubicBezTo>
                  <a:cubicBezTo>
                    <a:pt x="7034643" y="1906333"/>
                    <a:pt x="6981788" y="1877192"/>
                    <a:pt x="6931219" y="1891829"/>
                  </a:cubicBezTo>
                  <a:cubicBezTo>
                    <a:pt x="4715915" y="2532477"/>
                    <a:pt x="3182876" y="4551024"/>
                    <a:pt x="3159529" y="6858000"/>
                  </a:cubicBezTo>
                  <a:lnTo>
                    <a:pt x="3350115" y="6858000"/>
                  </a:lnTo>
                  <a:cubicBezTo>
                    <a:pt x="3368665" y="5220209"/>
                    <a:pt x="4181729" y="3693627"/>
                    <a:pt x="5530160" y="2764810"/>
                  </a:cubicBezTo>
                  <a:close/>
                  <a:moveTo>
                    <a:pt x="3857517" y="1312554"/>
                  </a:moveTo>
                  <a:cubicBezTo>
                    <a:pt x="2821278" y="2150298"/>
                    <a:pt x="2037615" y="3259196"/>
                    <a:pt x="1593677" y="4515920"/>
                  </a:cubicBezTo>
                  <a:cubicBezTo>
                    <a:pt x="1576137" y="4565572"/>
                    <a:pt x="1602146" y="4620055"/>
                    <a:pt x="1651774" y="4637604"/>
                  </a:cubicBezTo>
                  <a:cubicBezTo>
                    <a:pt x="1701402" y="4655152"/>
                    <a:pt x="1755859" y="4629131"/>
                    <a:pt x="1773399" y="4579479"/>
                  </a:cubicBezTo>
                  <a:cubicBezTo>
                    <a:pt x="2205610" y="3355958"/>
                    <a:pt x="2968581" y="2276360"/>
                    <a:pt x="3977459" y="1460773"/>
                  </a:cubicBezTo>
                  <a:cubicBezTo>
                    <a:pt x="4018371" y="1427634"/>
                    <a:pt x="4024686" y="1367596"/>
                    <a:pt x="3991562" y="1326664"/>
                  </a:cubicBezTo>
                  <a:cubicBezTo>
                    <a:pt x="3958439" y="1285732"/>
                    <a:pt x="3898430" y="1279414"/>
                    <a:pt x="3857517" y="1312554"/>
                  </a:cubicBezTo>
                  <a:close/>
                  <a:moveTo>
                    <a:pt x="2248403" y="2598095"/>
                  </a:moveTo>
                  <a:cubicBezTo>
                    <a:pt x="2204981" y="2568350"/>
                    <a:pt x="2145683" y="2579447"/>
                    <a:pt x="2115945" y="2622883"/>
                  </a:cubicBezTo>
                  <a:cubicBezTo>
                    <a:pt x="1635860" y="3322742"/>
                    <a:pt x="1277191" y="4098599"/>
                    <a:pt x="1055019" y="4917803"/>
                  </a:cubicBezTo>
                  <a:cubicBezTo>
                    <a:pt x="1039321" y="4968059"/>
                    <a:pt x="1067311" y="5021531"/>
                    <a:pt x="1117543" y="5037242"/>
                  </a:cubicBezTo>
                  <a:cubicBezTo>
                    <a:pt x="1167775" y="5052948"/>
                    <a:pt x="1221222" y="5024944"/>
                    <a:pt x="1236926" y="4974688"/>
                  </a:cubicBezTo>
                  <a:cubicBezTo>
                    <a:pt x="1237638" y="4972400"/>
                    <a:pt x="1238267" y="4970093"/>
                    <a:pt x="1238807" y="4967760"/>
                  </a:cubicBezTo>
                  <a:cubicBezTo>
                    <a:pt x="1455452" y="4169149"/>
                    <a:pt x="1805119" y="3412786"/>
                    <a:pt x="2273115" y="2730488"/>
                  </a:cubicBezTo>
                  <a:cubicBezTo>
                    <a:pt x="2302770" y="2687090"/>
                    <a:pt x="2291716" y="2627860"/>
                    <a:pt x="2248403" y="2598095"/>
                  </a:cubicBezTo>
                  <a:close/>
                  <a:moveTo>
                    <a:pt x="3182082" y="972450"/>
                  </a:moveTo>
                  <a:cubicBezTo>
                    <a:pt x="3216304" y="1012264"/>
                    <a:pt x="3276263" y="1016897"/>
                    <a:pt x="3316190" y="982811"/>
                  </a:cubicBezTo>
                  <a:cubicBezTo>
                    <a:pt x="3760979" y="601738"/>
                    <a:pt x="4247290" y="272053"/>
                    <a:pt x="4765912" y="0"/>
                  </a:cubicBezTo>
                  <a:lnTo>
                    <a:pt x="4372035" y="0"/>
                  </a:lnTo>
                  <a:cubicBezTo>
                    <a:pt x="3954366" y="243105"/>
                    <a:pt x="3559574" y="523572"/>
                    <a:pt x="3192500" y="837960"/>
                  </a:cubicBezTo>
                  <a:cubicBezTo>
                    <a:pt x="3152503" y="872186"/>
                    <a:pt x="3147814" y="932364"/>
                    <a:pt x="3182024" y="972381"/>
                  </a:cubicBezTo>
                  <a:cubicBezTo>
                    <a:pt x="3182043" y="972406"/>
                    <a:pt x="3182062" y="972425"/>
                    <a:pt x="3182082" y="972450"/>
                  </a:cubicBezTo>
                  <a:close/>
                  <a:moveTo>
                    <a:pt x="4503476" y="959103"/>
                  </a:moveTo>
                  <a:cubicBezTo>
                    <a:pt x="4531669" y="1003556"/>
                    <a:pt x="4590541" y="1016732"/>
                    <a:pt x="4634980" y="988531"/>
                  </a:cubicBezTo>
                  <a:cubicBezTo>
                    <a:pt x="5419589" y="490690"/>
                    <a:pt x="6295666" y="154609"/>
                    <a:pt x="7211824" y="0"/>
                  </a:cubicBezTo>
                  <a:lnTo>
                    <a:pt x="6361749" y="0"/>
                  </a:lnTo>
                  <a:cubicBezTo>
                    <a:pt x="5716216" y="188538"/>
                    <a:pt x="5100440" y="467098"/>
                    <a:pt x="4532571" y="827473"/>
                  </a:cubicBezTo>
                  <a:cubicBezTo>
                    <a:pt x="4488140" y="855680"/>
                    <a:pt x="4474970" y="914580"/>
                    <a:pt x="4503158" y="959040"/>
                  </a:cubicBezTo>
                  <a:close/>
                  <a:moveTo>
                    <a:pt x="4619923" y="423048"/>
                  </a:moveTo>
                  <a:cubicBezTo>
                    <a:pt x="4645786" y="468905"/>
                    <a:pt x="4703908" y="485105"/>
                    <a:pt x="4749744" y="459231"/>
                  </a:cubicBezTo>
                  <a:cubicBezTo>
                    <a:pt x="4749756" y="459225"/>
                    <a:pt x="4749763" y="459218"/>
                    <a:pt x="4749775" y="459213"/>
                  </a:cubicBezTo>
                  <a:cubicBezTo>
                    <a:pt x="5062406" y="282668"/>
                    <a:pt x="5387494" y="129190"/>
                    <a:pt x="5722461" y="0"/>
                  </a:cubicBezTo>
                  <a:lnTo>
                    <a:pt x="5231004" y="0"/>
                  </a:lnTo>
                  <a:cubicBezTo>
                    <a:pt x="5035419" y="89448"/>
                    <a:pt x="4843690" y="187160"/>
                    <a:pt x="4655817" y="293133"/>
                  </a:cubicBezTo>
                  <a:cubicBezTo>
                    <a:pt x="4609981" y="318991"/>
                    <a:pt x="4593775" y="377121"/>
                    <a:pt x="4619605" y="422984"/>
                  </a:cubicBezTo>
                  <a:close/>
                  <a:moveTo>
                    <a:pt x="1208440" y="3617579"/>
                  </a:moveTo>
                  <a:cubicBezTo>
                    <a:pt x="1160368" y="3596141"/>
                    <a:pt x="1104031" y="3617751"/>
                    <a:pt x="1082609" y="3665846"/>
                  </a:cubicBezTo>
                  <a:cubicBezTo>
                    <a:pt x="1082603" y="3665858"/>
                    <a:pt x="1082596" y="3665871"/>
                    <a:pt x="1082590" y="3665884"/>
                  </a:cubicBezTo>
                  <a:cubicBezTo>
                    <a:pt x="859205" y="4168380"/>
                    <a:pt x="688459" y="4692677"/>
                    <a:pt x="573091" y="5230385"/>
                  </a:cubicBezTo>
                  <a:cubicBezTo>
                    <a:pt x="458720" y="5765494"/>
                    <a:pt x="399119" y="6310867"/>
                    <a:pt x="395211" y="6858064"/>
                  </a:cubicBezTo>
                  <a:lnTo>
                    <a:pt x="585797" y="6858064"/>
                  </a:lnTo>
                  <a:cubicBezTo>
                    <a:pt x="589636" y="6324322"/>
                    <a:pt x="647724" y="5792347"/>
                    <a:pt x="759166" y="5270364"/>
                  </a:cubicBezTo>
                  <a:cubicBezTo>
                    <a:pt x="871732" y="4745641"/>
                    <a:pt x="1038323" y="4233992"/>
                    <a:pt x="1256277" y="3743616"/>
                  </a:cubicBezTo>
                  <a:cubicBezTo>
                    <a:pt x="1277788" y="3695566"/>
                    <a:pt x="1256296" y="3639157"/>
                    <a:pt x="1208262" y="3617637"/>
                  </a:cubicBezTo>
                  <a:cubicBezTo>
                    <a:pt x="1208173" y="3617598"/>
                    <a:pt x="1208084" y="3617554"/>
                    <a:pt x="1207995" y="3617516"/>
                  </a:cubicBezTo>
                  <a:close/>
                  <a:moveTo>
                    <a:pt x="942891" y="5974532"/>
                  </a:moveTo>
                  <a:cubicBezTo>
                    <a:pt x="890594" y="5968659"/>
                    <a:pt x="843443" y="6006305"/>
                    <a:pt x="837560" y="6058620"/>
                  </a:cubicBezTo>
                  <a:cubicBezTo>
                    <a:pt x="807861" y="6324074"/>
                    <a:pt x="791934" y="6590926"/>
                    <a:pt x="789850" y="6858000"/>
                  </a:cubicBezTo>
                  <a:lnTo>
                    <a:pt x="980436" y="6858000"/>
                  </a:lnTo>
                  <a:cubicBezTo>
                    <a:pt x="982494" y="6597917"/>
                    <a:pt x="998014" y="6338127"/>
                    <a:pt x="1026939" y="6079658"/>
                  </a:cubicBezTo>
                  <a:cubicBezTo>
                    <a:pt x="1032663" y="6027432"/>
                    <a:pt x="995073" y="5980418"/>
                    <a:pt x="942891" y="5974532"/>
                  </a:cubicBezTo>
                  <a:close/>
                  <a:moveTo>
                    <a:pt x="2329973" y="1389587"/>
                  </a:moveTo>
                  <a:cubicBezTo>
                    <a:pt x="2705198" y="978292"/>
                    <a:pt x="3121081" y="606057"/>
                    <a:pt x="3571258" y="278578"/>
                  </a:cubicBezTo>
                  <a:cubicBezTo>
                    <a:pt x="3704623" y="181588"/>
                    <a:pt x="3840892" y="88728"/>
                    <a:pt x="3980064" y="0"/>
                  </a:cubicBezTo>
                  <a:lnTo>
                    <a:pt x="3634913" y="0"/>
                  </a:lnTo>
                  <a:cubicBezTo>
                    <a:pt x="3575622" y="40678"/>
                    <a:pt x="3517049" y="82118"/>
                    <a:pt x="3459193" y="124321"/>
                  </a:cubicBezTo>
                  <a:cubicBezTo>
                    <a:pt x="2998611" y="459401"/>
                    <a:pt x="2573110" y="840261"/>
                    <a:pt x="2189194" y="1261071"/>
                  </a:cubicBezTo>
                  <a:cubicBezTo>
                    <a:pt x="2154101" y="1300312"/>
                    <a:pt x="2157449" y="1360585"/>
                    <a:pt x="2196671" y="1395695"/>
                  </a:cubicBezTo>
                  <a:cubicBezTo>
                    <a:pt x="2235354" y="1430316"/>
                    <a:pt x="2294613" y="1427602"/>
                    <a:pt x="2329973" y="1389587"/>
                  </a:cubicBezTo>
                  <a:close/>
                  <a:moveTo>
                    <a:pt x="557844" y="4174100"/>
                  </a:moveTo>
                  <a:cubicBezTo>
                    <a:pt x="507970" y="4157308"/>
                    <a:pt x="453932" y="4184143"/>
                    <a:pt x="437140" y="4234036"/>
                  </a:cubicBezTo>
                  <a:cubicBezTo>
                    <a:pt x="152879" y="5079865"/>
                    <a:pt x="5311" y="5965653"/>
                    <a:pt x="0" y="6858000"/>
                  </a:cubicBezTo>
                  <a:lnTo>
                    <a:pt x="190586" y="6858000"/>
                  </a:lnTo>
                  <a:cubicBezTo>
                    <a:pt x="195867" y="5986354"/>
                    <a:pt x="340068" y="5121127"/>
                    <a:pt x="617752" y="4294926"/>
                  </a:cubicBezTo>
                  <a:cubicBezTo>
                    <a:pt x="634569" y="4245032"/>
                    <a:pt x="607775" y="4190944"/>
                    <a:pt x="557905" y="4174119"/>
                  </a:cubicBezTo>
                  <a:cubicBezTo>
                    <a:pt x="557885" y="4174113"/>
                    <a:pt x="557865" y="4174107"/>
                    <a:pt x="557844" y="4174100"/>
                  </a:cubicBezTo>
                  <a:close/>
                  <a:moveTo>
                    <a:pt x="6996336" y="3748828"/>
                  </a:moveTo>
                  <a:cubicBezTo>
                    <a:pt x="7044554" y="3727644"/>
                    <a:pt x="7066407" y="3671388"/>
                    <a:pt x="7045253" y="3623172"/>
                  </a:cubicBezTo>
                  <a:cubicBezTo>
                    <a:pt x="7024098" y="3574957"/>
                    <a:pt x="6967875" y="3553048"/>
                    <a:pt x="6919656" y="3574232"/>
                  </a:cubicBezTo>
                  <a:cubicBezTo>
                    <a:pt x="5972433" y="3991121"/>
                    <a:pt x="5246340" y="4790323"/>
                    <a:pt x="4921684" y="5773368"/>
                  </a:cubicBezTo>
                  <a:cubicBezTo>
                    <a:pt x="4904569" y="5823161"/>
                    <a:pt x="4931042" y="5877408"/>
                    <a:pt x="4980810" y="5894524"/>
                  </a:cubicBezTo>
                  <a:cubicBezTo>
                    <a:pt x="5030578" y="5911647"/>
                    <a:pt x="5084800" y="5885162"/>
                    <a:pt x="5101914" y="5835370"/>
                  </a:cubicBezTo>
                  <a:cubicBezTo>
                    <a:pt x="5102175" y="5834601"/>
                    <a:pt x="5102429" y="5833826"/>
                    <a:pt x="5102677" y="5833050"/>
                  </a:cubicBezTo>
                  <a:cubicBezTo>
                    <a:pt x="5410415" y="4901366"/>
                    <a:pt x="6098595" y="4143936"/>
                    <a:pt x="6996336" y="3748828"/>
                  </a:cubicBezTo>
                  <a:close/>
                  <a:moveTo>
                    <a:pt x="6881984" y="5085281"/>
                  </a:moveTo>
                  <a:cubicBezTo>
                    <a:pt x="6913749" y="5127178"/>
                    <a:pt x="6973465" y="5135396"/>
                    <a:pt x="7015394" y="5103649"/>
                  </a:cubicBezTo>
                  <a:cubicBezTo>
                    <a:pt x="7328018" y="4865545"/>
                    <a:pt x="7697564" y="4713512"/>
                    <a:pt x="8087184" y="4662677"/>
                  </a:cubicBezTo>
                  <a:lnTo>
                    <a:pt x="8087184" y="4470349"/>
                  </a:lnTo>
                  <a:cubicBezTo>
                    <a:pt x="7655889" y="4522225"/>
                    <a:pt x="7246321" y="4688393"/>
                    <a:pt x="6900725" y="4951680"/>
                  </a:cubicBezTo>
                  <a:cubicBezTo>
                    <a:pt x="6858669" y="4983370"/>
                    <a:pt x="6850284" y="5043153"/>
                    <a:pt x="6881984" y="5085198"/>
                  </a:cubicBezTo>
                  <a:cubicBezTo>
                    <a:pt x="6881984" y="5085223"/>
                    <a:pt x="6882048" y="5085255"/>
                    <a:pt x="6882048" y="5085281"/>
                  </a:cubicBezTo>
                  <a:close/>
                  <a:moveTo>
                    <a:pt x="7499037" y="2661908"/>
                  </a:moveTo>
                  <a:cubicBezTo>
                    <a:pt x="7508693" y="2713633"/>
                    <a:pt x="7558373" y="2747770"/>
                    <a:pt x="7610085" y="2738179"/>
                  </a:cubicBezTo>
                  <a:cubicBezTo>
                    <a:pt x="7767635" y="2709126"/>
                    <a:pt x="7926711" y="2688972"/>
                    <a:pt x="8086549" y="2677798"/>
                  </a:cubicBezTo>
                  <a:lnTo>
                    <a:pt x="8086549" y="2486804"/>
                  </a:lnTo>
                  <a:cubicBezTo>
                    <a:pt x="7915022" y="2498295"/>
                    <a:pt x="7744257" y="2519689"/>
                    <a:pt x="7575208" y="2550871"/>
                  </a:cubicBezTo>
                  <a:cubicBezTo>
                    <a:pt x="7523559" y="2560577"/>
                    <a:pt x="7489572" y="2610235"/>
                    <a:pt x="7499101" y="2661908"/>
                  </a:cubicBezTo>
                  <a:close/>
                  <a:moveTo>
                    <a:pt x="7131080" y="4015712"/>
                  </a:moveTo>
                  <a:cubicBezTo>
                    <a:pt x="7150520" y="4064646"/>
                    <a:pt x="7205916" y="4088550"/>
                    <a:pt x="7254833" y="4069101"/>
                  </a:cubicBezTo>
                  <a:cubicBezTo>
                    <a:pt x="7254833" y="4069101"/>
                    <a:pt x="7254833" y="4069101"/>
                    <a:pt x="7254833" y="4069101"/>
                  </a:cubicBezTo>
                  <a:cubicBezTo>
                    <a:pt x="7521336" y="3962939"/>
                    <a:pt x="7801560" y="3895064"/>
                    <a:pt x="8087057" y="3867493"/>
                  </a:cubicBezTo>
                  <a:lnTo>
                    <a:pt x="8087057" y="3675799"/>
                  </a:lnTo>
                  <a:cubicBezTo>
                    <a:pt x="7777546" y="3704051"/>
                    <a:pt x="7473689" y="3776832"/>
                    <a:pt x="7184952" y="3891899"/>
                  </a:cubicBezTo>
                  <a:cubicBezTo>
                    <a:pt x="7135971" y="3911157"/>
                    <a:pt x="7111894" y="3966492"/>
                    <a:pt x="7131080" y="4015502"/>
                  </a:cubicBezTo>
                  <a:cubicBezTo>
                    <a:pt x="7131143" y="4015528"/>
                    <a:pt x="7131143" y="4015559"/>
                    <a:pt x="7131143" y="4015585"/>
                  </a:cubicBezTo>
                  <a:close/>
                  <a:moveTo>
                    <a:pt x="6365942" y="4894731"/>
                  </a:moveTo>
                  <a:cubicBezTo>
                    <a:pt x="5843642" y="5416174"/>
                    <a:pt x="5543800" y="6119929"/>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557220" y="3966771"/>
                  </a:moveTo>
                  <a:cubicBezTo>
                    <a:pt x="4259850" y="4352269"/>
                    <a:pt x="4022589" y="4780624"/>
                    <a:pt x="3853515" y="5237250"/>
                  </a:cubicBezTo>
                  <a:cubicBezTo>
                    <a:pt x="3835238" y="5286641"/>
                    <a:pt x="3860433" y="5341505"/>
                    <a:pt x="3909801" y="5359791"/>
                  </a:cubicBezTo>
                  <a:cubicBezTo>
                    <a:pt x="3959169" y="5378077"/>
                    <a:pt x="4014007" y="5352869"/>
                    <a:pt x="4032284" y="5303478"/>
                  </a:cubicBezTo>
                  <a:cubicBezTo>
                    <a:pt x="4669044" y="3583607"/>
                    <a:pt x="6257778" y="2399677"/>
                    <a:pt x="8087184" y="2281763"/>
                  </a:cubicBezTo>
                  <a:lnTo>
                    <a:pt x="8087184" y="2091086"/>
                  </a:lnTo>
                  <a:cubicBezTo>
                    <a:pt x="7191432" y="2144743"/>
                    <a:pt x="6328670" y="2448611"/>
                    <a:pt x="5596865" y="2968198"/>
                  </a:cubicBezTo>
                  <a:cubicBezTo>
                    <a:pt x="5202550" y="3247304"/>
                    <a:pt x="4852133" y="3583791"/>
                    <a:pt x="4557220" y="3966517"/>
                  </a:cubicBezTo>
                  <a:close/>
                  <a:moveTo>
                    <a:pt x="6932489" y="261735"/>
                  </a:moveTo>
                  <a:cubicBezTo>
                    <a:pt x="6468922" y="362681"/>
                    <a:pt x="6017234" y="512059"/>
                    <a:pt x="5584858" y="707410"/>
                  </a:cubicBezTo>
                  <a:cubicBezTo>
                    <a:pt x="5536862" y="729014"/>
                    <a:pt x="5515466" y="785454"/>
                    <a:pt x="5537059" y="833473"/>
                  </a:cubicBezTo>
                  <a:cubicBezTo>
                    <a:pt x="5558659" y="881491"/>
                    <a:pt x="5615073" y="902898"/>
                    <a:pt x="5663062" y="881294"/>
                  </a:cubicBezTo>
                  <a:cubicBezTo>
                    <a:pt x="5663151" y="881256"/>
                    <a:pt x="5663234" y="881218"/>
                    <a:pt x="5663316" y="881180"/>
                  </a:cubicBezTo>
                  <a:cubicBezTo>
                    <a:pt x="6083519" y="691317"/>
                    <a:pt x="6522476" y="546157"/>
                    <a:pt x="6973021" y="448090"/>
                  </a:cubicBezTo>
                  <a:cubicBezTo>
                    <a:pt x="7339644" y="368564"/>
                    <a:pt x="7712366" y="320214"/>
                    <a:pt x="8087184" y="303557"/>
                  </a:cubicBezTo>
                  <a:lnTo>
                    <a:pt x="8087184" y="112881"/>
                  </a:lnTo>
                  <a:cubicBezTo>
                    <a:pt x="7698771" y="129641"/>
                    <a:pt x="7312454" y="179439"/>
                    <a:pt x="6932489" y="261735"/>
                  </a:cubicBezTo>
                  <a:close/>
                  <a:moveTo>
                    <a:pt x="7678505" y="1431218"/>
                  </a:moveTo>
                  <a:cubicBezTo>
                    <a:pt x="7684286" y="1483553"/>
                    <a:pt x="7731361" y="1521288"/>
                    <a:pt x="7783708" y="1515497"/>
                  </a:cubicBezTo>
                  <a:cubicBezTo>
                    <a:pt x="7783708" y="1515497"/>
                    <a:pt x="7783708" y="1515497"/>
                    <a:pt x="7783708" y="1515497"/>
                  </a:cubicBezTo>
                  <a:cubicBezTo>
                    <a:pt x="7883957" y="1504438"/>
                    <a:pt x="7985284" y="1496430"/>
                    <a:pt x="8086866" y="1490582"/>
                  </a:cubicBezTo>
                  <a:lnTo>
                    <a:pt x="8086866" y="1299906"/>
                  </a:lnTo>
                  <a:cubicBezTo>
                    <a:pt x="7978233" y="1305689"/>
                    <a:pt x="7869917" y="1314397"/>
                    <a:pt x="7762871" y="1326283"/>
                  </a:cubicBezTo>
                  <a:cubicBezTo>
                    <a:pt x="7710778" y="1332016"/>
                    <a:pt x="7673105" y="1378750"/>
                    <a:pt x="7678505" y="1430901"/>
                  </a:cubicBezTo>
                  <a:close/>
                  <a:moveTo>
                    <a:pt x="5303173" y="1289991"/>
                  </a:moveTo>
                  <a:cubicBezTo>
                    <a:pt x="4389549" y="1793110"/>
                    <a:pt x="3611369" y="2510187"/>
                    <a:pt x="3035203" y="3379869"/>
                  </a:cubicBezTo>
                  <a:cubicBezTo>
                    <a:pt x="3007435" y="3424596"/>
                    <a:pt x="3021164" y="3483375"/>
                    <a:pt x="3065869" y="3511163"/>
                  </a:cubicBezTo>
                  <a:cubicBezTo>
                    <a:pt x="3108738" y="3537807"/>
                    <a:pt x="3164935" y="3526385"/>
                    <a:pt x="3194025" y="3485123"/>
                  </a:cubicBezTo>
                  <a:cubicBezTo>
                    <a:pt x="3753101" y="2641067"/>
                    <a:pt x="4508272" y="1945117"/>
                    <a:pt x="5394908" y="1456833"/>
                  </a:cubicBezTo>
                  <a:cubicBezTo>
                    <a:pt x="6222818" y="1002126"/>
                    <a:pt x="7143722" y="742952"/>
                    <a:pt x="8087184" y="699147"/>
                  </a:cubicBezTo>
                  <a:lnTo>
                    <a:pt x="8087184" y="508471"/>
                  </a:lnTo>
                  <a:cubicBezTo>
                    <a:pt x="7111767" y="552630"/>
                    <a:pt x="6159410" y="820081"/>
                    <a:pt x="5303490" y="1290245"/>
                  </a:cubicBezTo>
                  <a:close/>
                  <a:moveTo>
                    <a:pt x="6957138" y="1164907"/>
                  </a:moveTo>
                  <a:cubicBezTo>
                    <a:pt x="6968955" y="1216211"/>
                    <a:pt x="7020159" y="1248207"/>
                    <a:pt x="7071426" y="1236366"/>
                  </a:cubicBezTo>
                  <a:cubicBezTo>
                    <a:pt x="7071426" y="1236360"/>
                    <a:pt x="7071490" y="1236353"/>
                    <a:pt x="7071490" y="1236347"/>
                  </a:cubicBezTo>
                  <a:cubicBezTo>
                    <a:pt x="7405269" y="1159485"/>
                    <a:pt x="7745147" y="1112083"/>
                    <a:pt x="8087184" y="1094674"/>
                  </a:cubicBezTo>
                  <a:lnTo>
                    <a:pt x="8087184" y="903998"/>
                  </a:lnTo>
                  <a:cubicBezTo>
                    <a:pt x="7730789" y="921355"/>
                    <a:pt x="7376618" y="970277"/>
                    <a:pt x="7028862" y="1050183"/>
                  </a:cubicBezTo>
                  <a:cubicBezTo>
                    <a:pt x="6977531" y="1061859"/>
                    <a:pt x="6945386" y="1112941"/>
                    <a:pt x="6957075" y="1164284"/>
                  </a:cubicBezTo>
                  <a:cubicBezTo>
                    <a:pt x="6957075" y="1164385"/>
                    <a:pt x="6957138" y="1164487"/>
                    <a:pt x="6957138" y="1164589"/>
                  </a:cubicBezTo>
                  <a:close/>
                  <a:moveTo>
                    <a:pt x="7810517" y="5550150"/>
                  </a:moveTo>
                  <a:cubicBezTo>
                    <a:pt x="7858989" y="5529652"/>
                    <a:pt x="7881733" y="5473708"/>
                    <a:pt x="7861214" y="5425193"/>
                  </a:cubicBezTo>
                  <a:cubicBezTo>
                    <a:pt x="7840693" y="5376679"/>
                    <a:pt x="7784789" y="5353975"/>
                    <a:pt x="7736316" y="5374473"/>
                  </a:cubicBezTo>
                  <a:cubicBezTo>
                    <a:pt x="7136099" y="5627692"/>
                    <a:pt x="6737457" y="6206655"/>
                    <a:pt x="6714968" y="6858000"/>
                  </a:cubicBezTo>
                  <a:lnTo>
                    <a:pt x="6905553" y="6858000"/>
                  </a:lnTo>
                  <a:cubicBezTo>
                    <a:pt x="6927979" y="6283212"/>
                    <a:pt x="7280753" y="5773292"/>
                    <a:pt x="7810517" y="5549832"/>
                  </a:cubicBezTo>
                  <a:close/>
                  <a:moveTo>
                    <a:pt x="6090863" y="6328301"/>
                  </a:moveTo>
                  <a:cubicBezTo>
                    <a:pt x="6039456" y="6317477"/>
                    <a:pt x="5988995" y="6350311"/>
                    <a:pt x="5978037" y="6401711"/>
                  </a:cubicBezTo>
                  <a:cubicBezTo>
                    <a:pt x="5946202" y="6551837"/>
                    <a:pt x="5928338" y="6704569"/>
                    <a:pt x="5924672" y="6858000"/>
                  </a:cubicBezTo>
                  <a:lnTo>
                    <a:pt x="6115258" y="6858000"/>
                  </a:lnTo>
                  <a:cubicBezTo>
                    <a:pt x="6118847" y="6717916"/>
                    <a:pt x="6135282" y="6578469"/>
                    <a:pt x="6164366" y="6441372"/>
                  </a:cubicBezTo>
                  <a:cubicBezTo>
                    <a:pt x="6175293" y="6389889"/>
                    <a:pt x="6142417" y="6339252"/>
                    <a:pt x="6090933" y="6328313"/>
                  </a:cubicBezTo>
                  <a:cubicBezTo>
                    <a:pt x="6090914" y="6328313"/>
                    <a:pt x="6090888" y="6328307"/>
                    <a:pt x="6090863" y="6328301"/>
                  </a:cubicBezTo>
                  <a:close/>
                  <a:moveTo>
                    <a:pt x="5637269" y="5359219"/>
                  </a:moveTo>
                  <a:cubicBezTo>
                    <a:pt x="5590722" y="5334641"/>
                    <a:pt x="5533083" y="5352469"/>
                    <a:pt x="5508516" y="5399039"/>
                  </a:cubicBezTo>
                  <a:cubicBezTo>
                    <a:pt x="5508510" y="5399045"/>
                    <a:pt x="5508503" y="5399058"/>
                    <a:pt x="5508497" y="5399071"/>
                  </a:cubicBezTo>
                  <a:cubicBezTo>
                    <a:pt x="5271929" y="5849588"/>
                    <a:pt x="5143862" y="6349180"/>
                    <a:pt x="5134504" y="6858000"/>
                  </a:cubicBezTo>
                  <a:lnTo>
                    <a:pt x="5325090" y="6858000"/>
                  </a:lnTo>
                  <a:cubicBezTo>
                    <a:pt x="5334410" y="6380165"/>
                    <a:pt x="5454936" y="5911126"/>
                    <a:pt x="5677102" y="5488053"/>
                  </a:cubicBezTo>
                  <a:cubicBezTo>
                    <a:pt x="5701668" y="5441483"/>
                    <a:pt x="5683849" y="5383816"/>
                    <a:pt x="5637301" y="5359238"/>
                  </a:cubicBezTo>
                  <a:cubicBezTo>
                    <a:pt x="5637295" y="5359232"/>
                    <a:pt x="5637282" y="5359225"/>
                    <a:pt x="5637269" y="5359219"/>
                  </a:cubicBezTo>
                  <a:close/>
                  <a:moveTo>
                    <a:pt x="6804289" y="5734216"/>
                  </a:moveTo>
                  <a:cubicBezTo>
                    <a:pt x="6760771" y="5704725"/>
                    <a:pt x="6701563" y="5716108"/>
                    <a:pt x="6672022" y="5759640"/>
                  </a:cubicBezTo>
                  <a:cubicBezTo>
                    <a:pt x="6452404" y="6084724"/>
                    <a:pt x="6330169" y="6465778"/>
                    <a:pt x="6319630" y="6858000"/>
                  </a:cubicBezTo>
                  <a:lnTo>
                    <a:pt x="6510215" y="6858000"/>
                  </a:lnTo>
                  <a:cubicBezTo>
                    <a:pt x="6520761" y="6503851"/>
                    <a:pt x="6631618" y="6160023"/>
                    <a:pt x="6829891" y="5866482"/>
                  </a:cubicBezTo>
                  <a:cubicBezTo>
                    <a:pt x="6859177" y="5822913"/>
                    <a:pt x="6847679" y="5763873"/>
                    <a:pt x="6804289" y="5734407"/>
                  </a:cubicBezTo>
                  <a:close/>
                  <a:moveTo>
                    <a:pt x="4904404" y="6204806"/>
                  </a:moveTo>
                  <a:cubicBezTo>
                    <a:pt x="4852571" y="6195698"/>
                    <a:pt x="4803171" y="6230357"/>
                    <a:pt x="4794068" y="6282220"/>
                  </a:cubicBezTo>
                  <a:cubicBezTo>
                    <a:pt x="4794061" y="6282240"/>
                    <a:pt x="4794061" y="6282265"/>
                    <a:pt x="4794055" y="6282284"/>
                  </a:cubicBezTo>
                  <a:cubicBezTo>
                    <a:pt x="4760766" y="6472452"/>
                    <a:pt x="4742432" y="6664972"/>
                    <a:pt x="4739230" y="6858000"/>
                  </a:cubicBezTo>
                  <a:lnTo>
                    <a:pt x="4929815" y="6858000"/>
                  </a:lnTo>
                  <a:cubicBezTo>
                    <a:pt x="4932922" y="6676031"/>
                    <a:pt x="4950189" y="6494507"/>
                    <a:pt x="4981464" y="6315208"/>
                  </a:cubicBezTo>
                  <a:cubicBezTo>
                    <a:pt x="4990587" y="6263445"/>
                    <a:pt x="4956116" y="6214067"/>
                    <a:pt x="4904404" y="6204806"/>
                  </a:cubicBezTo>
                  <a:close/>
                  <a:moveTo>
                    <a:pt x="7902253" y="6858000"/>
                  </a:moveTo>
                  <a:lnTo>
                    <a:pt x="8087184" y="6858000"/>
                  </a:lnTo>
                  <a:lnTo>
                    <a:pt x="8087184" y="6532261"/>
                  </a:lnTo>
                  <a:cubicBezTo>
                    <a:pt x="7984903" y="6612091"/>
                    <a:pt x="7918389" y="6729230"/>
                    <a:pt x="7902253" y="6858000"/>
                  </a:cubicBezTo>
                  <a:close/>
                  <a:moveTo>
                    <a:pt x="7565551" y="6591561"/>
                  </a:moveTo>
                  <a:cubicBezTo>
                    <a:pt x="7546175" y="6640502"/>
                    <a:pt x="7570062" y="6695925"/>
                    <a:pt x="7619043" y="6715311"/>
                  </a:cubicBezTo>
                  <a:cubicBezTo>
                    <a:pt x="7667959" y="6734760"/>
                    <a:pt x="7723356" y="6710798"/>
                    <a:pt x="7742733" y="6661858"/>
                  </a:cubicBezTo>
                  <a:cubicBezTo>
                    <a:pt x="7807341" y="6499910"/>
                    <a:pt x="7930205" y="6368089"/>
                    <a:pt x="8087184" y="6292326"/>
                  </a:cubicBezTo>
                  <a:lnTo>
                    <a:pt x="8087184" y="6085760"/>
                  </a:lnTo>
                  <a:cubicBezTo>
                    <a:pt x="7849270" y="6172245"/>
                    <a:pt x="7659700" y="6356394"/>
                    <a:pt x="7566250" y="6591752"/>
                  </a:cubicBezTo>
                  <a:close/>
                  <a:moveTo>
                    <a:pt x="7109989" y="6858000"/>
                  </a:moveTo>
                  <a:lnTo>
                    <a:pt x="7300574" y="6858000"/>
                  </a:lnTo>
                  <a:cubicBezTo>
                    <a:pt x="7326176" y="6394974"/>
                    <a:pt x="7641722" y="5998774"/>
                    <a:pt x="8087184" y="5870486"/>
                  </a:cubicBezTo>
                  <a:lnTo>
                    <a:pt x="8087184" y="5673454"/>
                  </a:lnTo>
                  <a:cubicBezTo>
                    <a:pt x="7534740" y="5807487"/>
                    <a:pt x="7136797" y="6289898"/>
                    <a:pt x="7109989" y="6858000"/>
                  </a:cubicBezTo>
                  <a:close/>
                  <a:moveTo>
                    <a:pt x="6578000" y="3403894"/>
                  </a:moveTo>
                  <a:cubicBezTo>
                    <a:pt x="6600998" y="3451093"/>
                    <a:pt x="6657792" y="3470809"/>
                    <a:pt x="6705057" y="3448004"/>
                  </a:cubicBezTo>
                  <a:cubicBezTo>
                    <a:pt x="7047794" y="3281442"/>
                    <a:pt x="7413527" y="3167030"/>
                    <a:pt x="7790061" y="3108536"/>
                  </a:cubicBezTo>
                  <a:cubicBezTo>
                    <a:pt x="7841964" y="3099632"/>
                    <a:pt x="7876778" y="3050348"/>
                    <a:pt x="7867884" y="2998453"/>
                  </a:cubicBezTo>
                  <a:cubicBezTo>
                    <a:pt x="7859180" y="2947694"/>
                    <a:pt x="7811725" y="2913029"/>
                    <a:pt x="7760775" y="2920148"/>
                  </a:cubicBezTo>
                  <a:cubicBezTo>
                    <a:pt x="7365500" y="2981527"/>
                    <a:pt x="6981597" y="3101621"/>
                    <a:pt x="6621771" y="3276459"/>
                  </a:cubicBezTo>
                  <a:cubicBezTo>
                    <a:pt x="6574506" y="3299582"/>
                    <a:pt x="6554940" y="3356607"/>
                    <a:pt x="6578000" y="3403894"/>
                  </a:cubicBezTo>
                  <a:close/>
                </a:path>
              </a:pathLst>
            </a:custGeom>
            <a:solidFill>
              <a:srgbClr val="00D0FF">
                <a:alpha val="1173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13" name="Google Shape;13;p2"/>
            <p:cNvSpPr/>
            <p:nvPr/>
          </p:nvSpPr>
          <p:spPr>
            <a:xfrm>
              <a:off x="2377837" y="210583"/>
              <a:ext cx="5576288" cy="4831090"/>
            </a:xfrm>
            <a:custGeom>
              <a:avLst/>
              <a:gdLst/>
              <a:ahLst/>
              <a:cxnLst/>
              <a:rect l="l" t="t" r="r" b="b"/>
              <a:pathLst>
                <a:path w="7435051" h="6441453" extrusionOk="0">
                  <a:moveTo>
                    <a:pt x="2213120" y="5039472"/>
                  </a:moveTo>
                  <a:cubicBezTo>
                    <a:pt x="2095083" y="5051103"/>
                    <a:pt x="2103850" y="5229704"/>
                    <a:pt x="2222458" y="5229704"/>
                  </a:cubicBezTo>
                  <a:cubicBezTo>
                    <a:pt x="2353073" y="5228178"/>
                    <a:pt x="2343290" y="5028222"/>
                    <a:pt x="2213120" y="5039472"/>
                  </a:cubicBezTo>
                  <a:close/>
                  <a:moveTo>
                    <a:pt x="1816257" y="949650"/>
                  </a:moveTo>
                  <a:cubicBezTo>
                    <a:pt x="1698221" y="961282"/>
                    <a:pt x="1706988" y="1139882"/>
                    <a:pt x="1825595" y="1139882"/>
                  </a:cubicBezTo>
                  <a:cubicBezTo>
                    <a:pt x="1956274" y="1138420"/>
                    <a:pt x="1946427" y="938337"/>
                    <a:pt x="1816257" y="949650"/>
                  </a:cubicBezTo>
                  <a:close/>
                  <a:moveTo>
                    <a:pt x="1657435" y="6147620"/>
                  </a:moveTo>
                  <a:cubicBezTo>
                    <a:pt x="1527329" y="6136180"/>
                    <a:pt x="1517673" y="6336390"/>
                    <a:pt x="1648097" y="6337788"/>
                  </a:cubicBezTo>
                  <a:cubicBezTo>
                    <a:pt x="1766514" y="6337916"/>
                    <a:pt x="1775281" y="6159125"/>
                    <a:pt x="1657181" y="6147620"/>
                  </a:cubicBezTo>
                  <a:close/>
                  <a:moveTo>
                    <a:pt x="1777377" y="3926811"/>
                  </a:moveTo>
                  <a:cubicBezTo>
                    <a:pt x="1647271" y="3915307"/>
                    <a:pt x="1637614" y="4115517"/>
                    <a:pt x="1767975" y="4116979"/>
                  </a:cubicBezTo>
                  <a:cubicBezTo>
                    <a:pt x="1886583" y="4117487"/>
                    <a:pt x="1895477" y="3938442"/>
                    <a:pt x="1777377" y="3926811"/>
                  </a:cubicBezTo>
                  <a:close/>
                  <a:moveTo>
                    <a:pt x="2671541" y="3056499"/>
                  </a:moveTo>
                  <a:cubicBezTo>
                    <a:pt x="2553506" y="3068131"/>
                    <a:pt x="2562336" y="3246731"/>
                    <a:pt x="2680944" y="3246731"/>
                  </a:cubicBezTo>
                  <a:cubicBezTo>
                    <a:pt x="2811558" y="3245206"/>
                    <a:pt x="2801712" y="3045186"/>
                    <a:pt x="2671541" y="3056499"/>
                  </a:cubicBezTo>
                  <a:close/>
                  <a:moveTo>
                    <a:pt x="3043247" y="3211646"/>
                  </a:moveTo>
                  <a:cubicBezTo>
                    <a:pt x="2925148" y="3223278"/>
                    <a:pt x="2933978" y="3401878"/>
                    <a:pt x="3052649" y="3401878"/>
                  </a:cubicBezTo>
                  <a:cubicBezTo>
                    <a:pt x="3183264" y="3400289"/>
                    <a:pt x="3173354" y="3200333"/>
                    <a:pt x="3043247" y="3211646"/>
                  </a:cubicBezTo>
                  <a:close/>
                  <a:moveTo>
                    <a:pt x="3483564" y="1201216"/>
                  </a:moveTo>
                  <a:cubicBezTo>
                    <a:pt x="3602171" y="1201216"/>
                    <a:pt x="3611002" y="1022616"/>
                    <a:pt x="3492902" y="1010985"/>
                  </a:cubicBezTo>
                  <a:cubicBezTo>
                    <a:pt x="3362796" y="999608"/>
                    <a:pt x="3352949" y="1199627"/>
                    <a:pt x="3483564" y="1201216"/>
                  </a:cubicBezTo>
                  <a:close/>
                  <a:moveTo>
                    <a:pt x="3518314" y="4894812"/>
                  </a:moveTo>
                  <a:cubicBezTo>
                    <a:pt x="3388207" y="4883499"/>
                    <a:pt x="3378551" y="5083518"/>
                    <a:pt x="3508975" y="5085044"/>
                  </a:cubicBezTo>
                  <a:cubicBezTo>
                    <a:pt x="3627646" y="5085044"/>
                    <a:pt x="3636413" y="4906507"/>
                    <a:pt x="3518314" y="4894812"/>
                  </a:cubicBezTo>
                  <a:close/>
                  <a:moveTo>
                    <a:pt x="2488770" y="5643408"/>
                  </a:moveTo>
                  <a:cubicBezTo>
                    <a:pt x="2370670" y="5655039"/>
                    <a:pt x="2379501" y="5833576"/>
                    <a:pt x="2498109" y="5833640"/>
                  </a:cubicBezTo>
                  <a:cubicBezTo>
                    <a:pt x="2628723" y="5832115"/>
                    <a:pt x="2619003" y="5632095"/>
                    <a:pt x="2488770" y="5643408"/>
                  </a:cubicBezTo>
                  <a:close/>
                  <a:moveTo>
                    <a:pt x="1258984" y="4171957"/>
                  </a:moveTo>
                  <a:cubicBezTo>
                    <a:pt x="1128878" y="4160580"/>
                    <a:pt x="1118904" y="4360664"/>
                    <a:pt x="1249582" y="4362189"/>
                  </a:cubicBezTo>
                  <a:cubicBezTo>
                    <a:pt x="1368253" y="4362253"/>
                    <a:pt x="1377084" y="4183652"/>
                    <a:pt x="1258984" y="4171957"/>
                  </a:cubicBezTo>
                  <a:close/>
                  <a:moveTo>
                    <a:pt x="4268713" y="190694"/>
                  </a:moveTo>
                  <a:cubicBezTo>
                    <a:pt x="4399327" y="189105"/>
                    <a:pt x="4389417" y="-10851"/>
                    <a:pt x="4259311" y="463"/>
                  </a:cubicBezTo>
                  <a:cubicBezTo>
                    <a:pt x="4141211" y="12157"/>
                    <a:pt x="4150041" y="190758"/>
                    <a:pt x="4268713" y="190694"/>
                  </a:cubicBezTo>
                  <a:close/>
                  <a:moveTo>
                    <a:pt x="6303786" y="2710803"/>
                  </a:moveTo>
                  <a:cubicBezTo>
                    <a:pt x="6422394" y="2710803"/>
                    <a:pt x="6431225" y="2532266"/>
                    <a:pt x="6313189" y="2520571"/>
                  </a:cubicBezTo>
                  <a:cubicBezTo>
                    <a:pt x="6183082" y="2509448"/>
                    <a:pt x="6173045" y="2709341"/>
                    <a:pt x="6303786" y="2710803"/>
                  </a:cubicBezTo>
                  <a:close/>
                  <a:moveTo>
                    <a:pt x="2820516" y="724970"/>
                  </a:moveTo>
                  <a:cubicBezTo>
                    <a:pt x="2951131" y="723445"/>
                    <a:pt x="2941220" y="523425"/>
                    <a:pt x="2811177" y="534738"/>
                  </a:cubicBezTo>
                  <a:cubicBezTo>
                    <a:pt x="2693141" y="546370"/>
                    <a:pt x="2701908" y="724906"/>
                    <a:pt x="2820516" y="724970"/>
                  </a:cubicBezTo>
                  <a:close/>
                  <a:moveTo>
                    <a:pt x="7332377" y="2638663"/>
                  </a:moveTo>
                  <a:cubicBezTo>
                    <a:pt x="7214341" y="2650358"/>
                    <a:pt x="7223172" y="2828959"/>
                    <a:pt x="7341779" y="2828895"/>
                  </a:cubicBezTo>
                  <a:cubicBezTo>
                    <a:pt x="7472394" y="2827243"/>
                    <a:pt x="7462674" y="2627414"/>
                    <a:pt x="7332377" y="2638663"/>
                  </a:cubicBezTo>
                  <a:close/>
                  <a:moveTo>
                    <a:pt x="7339301" y="1234966"/>
                  </a:moveTo>
                  <a:cubicBezTo>
                    <a:pt x="7469916" y="1233504"/>
                    <a:pt x="7460006" y="1033421"/>
                    <a:pt x="7329899" y="1044798"/>
                  </a:cubicBezTo>
                  <a:cubicBezTo>
                    <a:pt x="7211864" y="1056302"/>
                    <a:pt x="7220694" y="1235157"/>
                    <a:pt x="7339301" y="1234966"/>
                  </a:cubicBezTo>
                  <a:close/>
                  <a:moveTo>
                    <a:pt x="84087" y="3888675"/>
                  </a:moveTo>
                  <a:cubicBezTo>
                    <a:pt x="-33695" y="3900434"/>
                    <a:pt x="-25118" y="4079352"/>
                    <a:pt x="93362" y="4079352"/>
                  </a:cubicBezTo>
                  <a:cubicBezTo>
                    <a:pt x="224104" y="4077445"/>
                    <a:pt x="214067" y="3877425"/>
                    <a:pt x="84087" y="3888675"/>
                  </a:cubicBezTo>
                  <a:close/>
                  <a:moveTo>
                    <a:pt x="488955" y="5693238"/>
                  </a:moveTo>
                  <a:cubicBezTo>
                    <a:pt x="370919" y="5704679"/>
                    <a:pt x="379686" y="5883470"/>
                    <a:pt x="498293" y="5883407"/>
                  </a:cubicBezTo>
                  <a:cubicBezTo>
                    <a:pt x="628908" y="5882135"/>
                    <a:pt x="619125" y="5681925"/>
                    <a:pt x="488955" y="5693366"/>
                  </a:cubicBezTo>
                  <a:close/>
                  <a:moveTo>
                    <a:pt x="722295" y="4567103"/>
                  </a:moveTo>
                  <a:cubicBezTo>
                    <a:pt x="592125" y="4555789"/>
                    <a:pt x="582532" y="4755682"/>
                    <a:pt x="712893" y="4757334"/>
                  </a:cubicBezTo>
                  <a:cubicBezTo>
                    <a:pt x="831501" y="4757334"/>
                    <a:pt x="840458" y="4578734"/>
                    <a:pt x="722295" y="4567103"/>
                  </a:cubicBezTo>
                  <a:close/>
                  <a:moveTo>
                    <a:pt x="1760606" y="2491334"/>
                  </a:moveTo>
                  <a:cubicBezTo>
                    <a:pt x="1891220" y="2489745"/>
                    <a:pt x="1881310" y="2289725"/>
                    <a:pt x="1751203" y="2301102"/>
                  </a:cubicBezTo>
                  <a:cubicBezTo>
                    <a:pt x="1633104" y="2312734"/>
                    <a:pt x="1641998" y="2491334"/>
                    <a:pt x="1760606" y="2491334"/>
                  </a:cubicBezTo>
                  <a:close/>
                  <a:moveTo>
                    <a:pt x="744657" y="3328976"/>
                  </a:moveTo>
                  <a:cubicBezTo>
                    <a:pt x="614551" y="3317536"/>
                    <a:pt x="604894" y="3517682"/>
                    <a:pt x="735255" y="3519144"/>
                  </a:cubicBezTo>
                  <a:cubicBezTo>
                    <a:pt x="853926" y="3519335"/>
                    <a:pt x="862820" y="3340544"/>
                    <a:pt x="744657" y="3328976"/>
                  </a:cubicBezTo>
                  <a:close/>
                  <a:moveTo>
                    <a:pt x="4587626" y="5427499"/>
                  </a:moveTo>
                  <a:cubicBezTo>
                    <a:pt x="4457774" y="5416058"/>
                    <a:pt x="4447546" y="5616269"/>
                    <a:pt x="4578478" y="5617476"/>
                  </a:cubicBezTo>
                  <a:cubicBezTo>
                    <a:pt x="4696832" y="5617858"/>
                    <a:pt x="4705535" y="5439067"/>
                    <a:pt x="4587626" y="5427499"/>
                  </a:cubicBezTo>
                  <a:close/>
                  <a:moveTo>
                    <a:pt x="6524040" y="3476242"/>
                  </a:moveTo>
                  <a:cubicBezTo>
                    <a:pt x="6654718" y="3474844"/>
                    <a:pt x="6644744" y="3274633"/>
                    <a:pt x="6514638" y="3286074"/>
                  </a:cubicBezTo>
                  <a:cubicBezTo>
                    <a:pt x="6396601" y="3297578"/>
                    <a:pt x="6405432" y="3476242"/>
                    <a:pt x="6524040" y="3476051"/>
                  </a:cubicBezTo>
                  <a:close/>
                  <a:moveTo>
                    <a:pt x="6533125" y="1608057"/>
                  </a:moveTo>
                  <a:cubicBezTo>
                    <a:pt x="6403018" y="1596616"/>
                    <a:pt x="6393362" y="1796826"/>
                    <a:pt x="6523785" y="1798225"/>
                  </a:cubicBezTo>
                  <a:cubicBezTo>
                    <a:pt x="6642394" y="1798161"/>
                    <a:pt x="6651224" y="1619624"/>
                    <a:pt x="6533125" y="1607866"/>
                  </a:cubicBezTo>
                  <a:close/>
                  <a:moveTo>
                    <a:pt x="6625368" y="767682"/>
                  </a:moveTo>
                  <a:cubicBezTo>
                    <a:pt x="6495261" y="756304"/>
                    <a:pt x="6485605" y="956324"/>
                    <a:pt x="6616029" y="957913"/>
                  </a:cubicBezTo>
                  <a:cubicBezTo>
                    <a:pt x="6734701" y="957722"/>
                    <a:pt x="6743531" y="779122"/>
                    <a:pt x="6625368" y="767491"/>
                  </a:cubicBezTo>
                  <a:close/>
                  <a:moveTo>
                    <a:pt x="6239178" y="2986775"/>
                  </a:moveTo>
                  <a:cubicBezTo>
                    <a:pt x="6109072" y="2975398"/>
                    <a:pt x="6099097" y="3175418"/>
                    <a:pt x="6229776" y="3177007"/>
                  </a:cubicBezTo>
                  <a:cubicBezTo>
                    <a:pt x="6348383" y="3176816"/>
                    <a:pt x="6357277" y="2998279"/>
                    <a:pt x="6239178" y="2986585"/>
                  </a:cubicBezTo>
                  <a:close/>
                  <a:moveTo>
                    <a:pt x="6514638" y="4652017"/>
                  </a:moveTo>
                  <a:cubicBezTo>
                    <a:pt x="6396538" y="4663649"/>
                    <a:pt x="6405432" y="4842249"/>
                    <a:pt x="6524040" y="4842249"/>
                  </a:cubicBezTo>
                  <a:cubicBezTo>
                    <a:pt x="6654718" y="4840660"/>
                    <a:pt x="6644808" y="4640640"/>
                    <a:pt x="6514638" y="4652017"/>
                  </a:cubicBezTo>
                  <a:close/>
                  <a:moveTo>
                    <a:pt x="6326403" y="5437732"/>
                  </a:moveTo>
                  <a:cubicBezTo>
                    <a:pt x="6196296" y="5426355"/>
                    <a:pt x="6186640" y="5626375"/>
                    <a:pt x="6317001" y="5627964"/>
                  </a:cubicBezTo>
                  <a:cubicBezTo>
                    <a:pt x="6435671" y="5628027"/>
                    <a:pt x="6444502" y="5449363"/>
                    <a:pt x="6326403" y="5437732"/>
                  </a:cubicBezTo>
                  <a:close/>
                  <a:moveTo>
                    <a:pt x="7229651" y="6251285"/>
                  </a:moveTo>
                  <a:cubicBezTo>
                    <a:pt x="7099545" y="6239781"/>
                    <a:pt x="7089888" y="6440055"/>
                    <a:pt x="7220249" y="6441453"/>
                  </a:cubicBezTo>
                  <a:cubicBezTo>
                    <a:pt x="7338857" y="6441453"/>
                    <a:pt x="7347751" y="6262662"/>
                    <a:pt x="7229651" y="6251094"/>
                  </a:cubicBezTo>
                  <a:close/>
                  <a:moveTo>
                    <a:pt x="6776566" y="3604694"/>
                  </a:moveTo>
                  <a:cubicBezTo>
                    <a:pt x="6658530" y="3616389"/>
                    <a:pt x="6667297" y="3794926"/>
                    <a:pt x="6785968" y="3794926"/>
                  </a:cubicBezTo>
                  <a:cubicBezTo>
                    <a:pt x="6916329" y="3793337"/>
                    <a:pt x="6906481" y="3593381"/>
                    <a:pt x="6776566" y="3604694"/>
                  </a:cubicBezTo>
                  <a:close/>
                  <a:moveTo>
                    <a:pt x="7330281" y="5086315"/>
                  </a:moveTo>
                  <a:cubicBezTo>
                    <a:pt x="7212244" y="5097946"/>
                    <a:pt x="7221075" y="5276610"/>
                    <a:pt x="7339683" y="5276546"/>
                  </a:cubicBezTo>
                  <a:cubicBezTo>
                    <a:pt x="7470107" y="5275021"/>
                    <a:pt x="7460324" y="5074938"/>
                    <a:pt x="7330090" y="5086315"/>
                  </a:cubicBezTo>
                  <a:close/>
                  <a:moveTo>
                    <a:pt x="7149732" y="2268942"/>
                  </a:moveTo>
                  <a:cubicBezTo>
                    <a:pt x="7031697" y="2280573"/>
                    <a:pt x="7040464" y="2459173"/>
                    <a:pt x="7159071" y="2459173"/>
                  </a:cubicBezTo>
                  <a:cubicBezTo>
                    <a:pt x="7289495" y="2457711"/>
                    <a:pt x="7279775" y="2257628"/>
                    <a:pt x="7149542" y="2268942"/>
                  </a:cubicBezTo>
                  <a:close/>
                  <a:moveTo>
                    <a:pt x="4803179" y="4171957"/>
                  </a:moveTo>
                  <a:cubicBezTo>
                    <a:pt x="4673072" y="4160580"/>
                    <a:pt x="4663416" y="4360600"/>
                    <a:pt x="4793840" y="4362189"/>
                  </a:cubicBezTo>
                  <a:cubicBezTo>
                    <a:pt x="4912511" y="4362189"/>
                    <a:pt x="4921532" y="4183589"/>
                    <a:pt x="4803179" y="4171957"/>
                  </a:cubicBezTo>
                  <a:close/>
                  <a:moveTo>
                    <a:pt x="4264139" y="1897059"/>
                  </a:moveTo>
                  <a:cubicBezTo>
                    <a:pt x="4146039" y="1908626"/>
                    <a:pt x="4154870" y="2087227"/>
                    <a:pt x="4273477" y="2087290"/>
                  </a:cubicBezTo>
                  <a:cubicBezTo>
                    <a:pt x="4404092" y="2085765"/>
                    <a:pt x="4394245" y="1885682"/>
                    <a:pt x="4264139" y="1897059"/>
                  </a:cubicBezTo>
                  <a:close/>
                  <a:moveTo>
                    <a:pt x="4141592" y="4439731"/>
                  </a:moveTo>
                  <a:cubicBezTo>
                    <a:pt x="4023556" y="4451362"/>
                    <a:pt x="4032386" y="4629962"/>
                    <a:pt x="4150995" y="4629962"/>
                  </a:cubicBezTo>
                  <a:cubicBezTo>
                    <a:pt x="4281609" y="4628373"/>
                    <a:pt x="4271826" y="4428417"/>
                    <a:pt x="4141592" y="4439731"/>
                  </a:cubicBezTo>
                  <a:close/>
                  <a:moveTo>
                    <a:pt x="4444560" y="5923067"/>
                  </a:moveTo>
                  <a:cubicBezTo>
                    <a:pt x="4326460" y="5934698"/>
                    <a:pt x="4335354" y="6113363"/>
                    <a:pt x="4453962" y="6113299"/>
                  </a:cubicBezTo>
                  <a:cubicBezTo>
                    <a:pt x="4584831" y="6111774"/>
                    <a:pt x="4574730" y="5911754"/>
                    <a:pt x="4444560" y="5923067"/>
                  </a:cubicBezTo>
                  <a:close/>
                  <a:moveTo>
                    <a:pt x="4149660" y="722555"/>
                  </a:moveTo>
                  <a:cubicBezTo>
                    <a:pt x="4280339" y="721029"/>
                    <a:pt x="4270365" y="521010"/>
                    <a:pt x="4140322" y="532323"/>
                  </a:cubicBezTo>
                  <a:cubicBezTo>
                    <a:pt x="4022222" y="543954"/>
                    <a:pt x="4031053" y="722491"/>
                    <a:pt x="4149660" y="722555"/>
                  </a:cubicBezTo>
                  <a:close/>
                  <a:moveTo>
                    <a:pt x="5149473" y="5067883"/>
                  </a:moveTo>
                  <a:cubicBezTo>
                    <a:pt x="5031437" y="5079514"/>
                    <a:pt x="5040267" y="5258178"/>
                    <a:pt x="5158875" y="5258115"/>
                  </a:cubicBezTo>
                  <a:cubicBezTo>
                    <a:pt x="5289489" y="5256589"/>
                    <a:pt x="5279643" y="5056569"/>
                    <a:pt x="5149473" y="5067883"/>
                  </a:cubicBezTo>
                  <a:close/>
                  <a:moveTo>
                    <a:pt x="5180729" y="418362"/>
                  </a:moveTo>
                  <a:cubicBezTo>
                    <a:pt x="5062692" y="430057"/>
                    <a:pt x="5071523" y="608657"/>
                    <a:pt x="5190131" y="608594"/>
                  </a:cubicBezTo>
                  <a:cubicBezTo>
                    <a:pt x="5320746" y="607259"/>
                    <a:pt x="5310962" y="407303"/>
                    <a:pt x="5180729" y="418362"/>
                  </a:cubicBezTo>
                  <a:close/>
                  <a:moveTo>
                    <a:pt x="3703309" y="5642900"/>
                  </a:moveTo>
                  <a:cubicBezTo>
                    <a:pt x="3578793" y="5643599"/>
                    <a:pt x="3578793" y="5832877"/>
                    <a:pt x="3703309" y="5833576"/>
                  </a:cubicBezTo>
                  <a:cubicBezTo>
                    <a:pt x="3827825" y="5832941"/>
                    <a:pt x="3827888" y="5643662"/>
                    <a:pt x="3703309" y="5642900"/>
                  </a:cubicBezTo>
                  <a:close/>
                  <a:moveTo>
                    <a:pt x="5646456" y="6045926"/>
                  </a:moveTo>
                  <a:cubicBezTo>
                    <a:pt x="5516350" y="6034422"/>
                    <a:pt x="5506694" y="6234696"/>
                    <a:pt x="5637118" y="6236094"/>
                  </a:cubicBezTo>
                  <a:cubicBezTo>
                    <a:pt x="5755726" y="6236222"/>
                    <a:pt x="5764556" y="6057430"/>
                    <a:pt x="5646456" y="6045926"/>
                  </a:cubicBezTo>
                  <a:close/>
                  <a:moveTo>
                    <a:pt x="5906225" y="1406067"/>
                  </a:moveTo>
                  <a:cubicBezTo>
                    <a:pt x="5776118" y="1394689"/>
                    <a:pt x="5766462" y="1594773"/>
                    <a:pt x="5896886" y="1596298"/>
                  </a:cubicBezTo>
                  <a:cubicBezTo>
                    <a:pt x="6015494" y="1596298"/>
                    <a:pt x="6024324" y="1417698"/>
                    <a:pt x="5906225" y="1406067"/>
                  </a:cubicBezTo>
                  <a:close/>
                </a:path>
              </a:pathLst>
            </a:custGeom>
            <a:solidFill>
              <a:srgbClr val="00D0FF">
                <a:alpha val="1173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14" name="Google Shape;14;p2"/>
          <p:cNvSpPr txBox="1">
            <a:spLocks noGrp="1"/>
          </p:cNvSpPr>
          <p:nvPr>
            <p:ph type="ctrTitle"/>
          </p:nvPr>
        </p:nvSpPr>
        <p:spPr>
          <a:xfrm>
            <a:off x="685800" y="1771550"/>
            <a:ext cx="7772400" cy="1600500"/>
          </a:xfrm>
          <a:prstGeom prst="rect">
            <a:avLst/>
          </a:prstGeom>
        </p:spPr>
        <p:txBody>
          <a:bodyPr spcFirstLastPara="1" wrap="square" lIns="0" tIns="0" rIns="0" bIns="0" anchor="ctr" anchorCtr="0">
            <a:noAutofit/>
          </a:bodyPr>
          <a:lstStyle>
            <a:lvl1pPr lvl="0" rtl="0">
              <a:spcBef>
                <a:spcPts val="0"/>
              </a:spcBef>
              <a:spcAft>
                <a:spcPts val="0"/>
              </a:spcAft>
              <a:buClr>
                <a:schemeClr val="lt1"/>
              </a:buClr>
              <a:buSzPts val="6000"/>
              <a:buNone/>
              <a:defRPr sz="6000">
                <a:solidFill>
                  <a:schemeClr val="lt1"/>
                </a:solidFill>
              </a:defRPr>
            </a:lvl1pPr>
            <a:lvl2pPr lvl="1" rtl="0">
              <a:spcBef>
                <a:spcPts val="0"/>
              </a:spcBef>
              <a:spcAft>
                <a:spcPts val="0"/>
              </a:spcAft>
              <a:buClr>
                <a:schemeClr val="lt1"/>
              </a:buClr>
              <a:buSzPts val="6000"/>
              <a:buNone/>
              <a:defRPr sz="6000">
                <a:solidFill>
                  <a:schemeClr val="lt1"/>
                </a:solidFill>
              </a:defRPr>
            </a:lvl2pPr>
            <a:lvl3pPr lvl="2" rtl="0">
              <a:spcBef>
                <a:spcPts val="0"/>
              </a:spcBef>
              <a:spcAft>
                <a:spcPts val="0"/>
              </a:spcAft>
              <a:buClr>
                <a:schemeClr val="lt1"/>
              </a:buClr>
              <a:buSzPts val="6000"/>
              <a:buNone/>
              <a:defRPr sz="6000">
                <a:solidFill>
                  <a:schemeClr val="lt1"/>
                </a:solidFill>
              </a:defRPr>
            </a:lvl3pPr>
            <a:lvl4pPr lvl="3" rtl="0">
              <a:spcBef>
                <a:spcPts val="0"/>
              </a:spcBef>
              <a:spcAft>
                <a:spcPts val="0"/>
              </a:spcAft>
              <a:buClr>
                <a:schemeClr val="lt1"/>
              </a:buClr>
              <a:buSzPts val="6000"/>
              <a:buNone/>
              <a:defRPr sz="6000">
                <a:solidFill>
                  <a:schemeClr val="lt1"/>
                </a:solidFill>
              </a:defRPr>
            </a:lvl4pPr>
            <a:lvl5pPr lvl="4" rtl="0">
              <a:spcBef>
                <a:spcPts val="0"/>
              </a:spcBef>
              <a:spcAft>
                <a:spcPts val="0"/>
              </a:spcAft>
              <a:buClr>
                <a:schemeClr val="lt1"/>
              </a:buClr>
              <a:buSzPts val="6000"/>
              <a:buNone/>
              <a:defRPr sz="6000">
                <a:solidFill>
                  <a:schemeClr val="lt1"/>
                </a:solidFill>
              </a:defRPr>
            </a:lvl5pPr>
            <a:lvl6pPr lvl="5" rtl="0">
              <a:spcBef>
                <a:spcPts val="0"/>
              </a:spcBef>
              <a:spcAft>
                <a:spcPts val="0"/>
              </a:spcAft>
              <a:buClr>
                <a:schemeClr val="lt1"/>
              </a:buClr>
              <a:buSzPts val="6000"/>
              <a:buNone/>
              <a:defRPr sz="6000">
                <a:solidFill>
                  <a:schemeClr val="lt1"/>
                </a:solidFill>
              </a:defRPr>
            </a:lvl6pPr>
            <a:lvl7pPr lvl="6" rtl="0">
              <a:spcBef>
                <a:spcPts val="0"/>
              </a:spcBef>
              <a:spcAft>
                <a:spcPts val="0"/>
              </a:spcAft>
              <a:buClr>
                <a:schemeClr val="lt1"/>
              </a:buClr>
              <a:buSzPts val="6000"/>
              <a:buNone/>
              <a:defRPr sz="6000">
                <a:solidFill>
                  <a:schemeClr val="lt1"/>
                </a:solidFill>
              </a:defRPr>
            </a:lvl7pPr>
            <a:lvl8pPr lvl="7" rtl="0">
              <a:spcBef>
                <a:spcPts val="0"/>
              </a:spcBef>
              <a:spcAft>
                <a:spcPts val="0"/>
              </a:spcAft>
              <a:buClr>
                <a:schemeClr val="lt1"/>
              </a:buClr>
              <a:buSzPts val="6000"/>
              <a:buNone/>
              <a:defRPr sz="6000">
                <a:solidFill>
                  <a:schemeClr val="lt1"/>
                </a:solidFill>
              </a:defRPr>
            </a:lvl8pPr>
            <a:lvl9pPr lvl="8" rtl="0">
              <a:spcBef>
                <a:spcPts val="0"/>
              </a:spcBef>
              <a:spcAft>
                <a:spcPts val="0"/>
              </a:spcAft>
              <a:buClr>
                <a:schemeClr val="lt1"/>
              </a:buClr>
              <a:buSzPts val="6000"/>
              <a:buNone/>
              <a:defRPr sz="6000">
                <a:solidFill>
                  <a:schemeClr val="lt1"/>
                </a:solidFill>
              </a:defRPr>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dark">
  <p:cSld name="BLANK_1">
    <p:bg>
      <p:bgPr>
        <a:gradFill>
          <a:gsLst>
            <a:gs pos="0">
              <a:schemeClr val="accent2"/>
            </a:gs>
            <a:gs pos="100000">
              <a:schemeClr val="accent1"/>
            </a:gs>
          </a:gsLst>
          <a:path path="circle">
            <a:fillToRect l="100000" t="100000"/>
          </a:path>
          <a:tileRect r="-100000" b="-100000"/>
        </a:gradFill>
        <a:effectLst/>
      </p:bgPr>
    </p:bg>
    <p:spTree>
      <p:nvGrpSpPr>
        <p:cNvPr id="1" name="Shape 77"/>
        <p:cNvGrpSpPr/>
        <p:nvPr/>
      </p:nvGrpSpPr>
      <p:grpSpPr>
        <a:xfrm>
          <a:off x="0" y="0"/>
          <a:ext cx="0" cy="0"/>
          <a:chOff x="0" y="0"/>
          <a:chExt cx="0" cy="0"/>
        </a:xfrm>
      </p:grpSpPr>
      <p:grpSp>
        <p:nvGrpSpPr>
          <p:cNvPr id="78" name="Google Shape;78;p11"/>
          <p:cNvGrpSpPr/>
          <p:nvPr/>
        </p:nvGrpSpPr>
        <p:grpSpPr>
          <a:xfrm>
            <a:off x="3078602" y="0"/>
            <a:ext cx="6065389" cy="5143642"/>
            <a:chOff x="2052402" y="0"/>
            <a:chExt cx="6065389" cy="5143642"/>
          </a:xfrm>
        </p:grpSpPr>
        <p:sp>
          <p:nvSpPr>
            <p:cNvPr id="79" name="Google Shape;79;p11"/>
            <p:cNvSpPr/>
            <p:nvPr/>
          </p:nvSpPr>
          <p:spPr>
            <a:xfrm>
              <a:off x="2052402" y="0"/>
              <a:ext cx="6065388" cy="5143500"/>
            </a:xfrm>
            <a:custGeom>
              <a:avLst/>
              <a:gdLst/>
              <a:ahLst/>
              <a:cxnLst/>
              <a:rect l="l" t="t" r="r" b="b"/>
              <a:pathLst>
                <a:path w="8087184" h="6858000" extrusionOk="0">
                  <a:moveTo>
                    <a:pt x="7505580" y="6858000"/>
                  </a:moveTo>
                  <a:lnTo>
                    <a:pt x="7696738" y="6858000"/>
                  </a:lnTo>
                  <a:cubicBezTo>
                    <a:pt x="7718274" y="6613807"/>
                    <a:pt x="7866550" y="6398978"/>
                    <a:pt x="8087184" y="6292327"/>
                  </a:cubicBezTo>
                  <a:lnTo>
                    <a:pt x="8087184" y="6085824"/>
                  </a:lnTo>
                  <a:cubicBezTo>
                    <a:pt x="7757916" y="6205690"/>
                    <a:pt x="7529976" y="6508299"/>
                    <a:pt x="7505580" y="6858000"/>
                  </a:cubicBezTo>
                  <a:close/>
                  <a:moveTo>
                    <a:pt x="7109988" y="6858000"/>
                  </a:moveTo>
                  <a:lnTo>
                    <a:pt x="7300574" y="6858000"/>
                  </a:lnTo>
                  <a:cubicBezTo>
                    <a:pt x="7326176" y="6394974"/>
                    <a:pt x="7641722" y="5998774"/>
                    <a:pt x="8087184" y="5870486"/>
                  </a:cubicBezTo>
                  <a:lnTo>
                    <a:pt x="8087184" y="5673454"/>
                  </a:lnTo>
                  <a:cubicBezTo>
                    <a:pt x="7534740" y="5807487"/>
                    <a:pt x="7136797" y="6289898"/>
                    <a:pt x="7109988" y="6858000"/>
                  </a:cubicBezTo>
                  <a:close/>
                  <a:moveTo>
                    <a:pt x="6319630" y="6858000"/>
                  </a:moveTo>
                  <a:lnTo>
                    <a:pt x="6510215" y="6858000"/>
                  </a:lnTo>
                  <a:cubicBezTo>
                    <a:pt x="6538485" y="5958928"/>
                    <a:pt x="7199691" y="5205998"/>
                    <a:pt x="8087184" y="5062145"/>
                  </a:cubicBezTo>
                  <a:lnTo>
                    <a:pt x="8087184" y="4869180"/>
                  </a:lnTo>
                  <a:cubicBezTo>
                    <a:pt x="7093725" y="5015188"/>
                    <a:pt x="6348402" y="5853783"/>
                    <a:pt x="6319630" y="6858000"/>
                  </a:cubicBezTo>
                  <a:close/>
                  <a:moveTo>
                    <a:pt x="6714777" y="6858000"/>
                  </a:moveTo>
                  <a:lnTo>
                    <a:pt x="6905363" y="6858000"/>
                  </a:lnTo>
                  <a:cubicBezTo>
                    <a:pt x="6932680" y="6177012"/>
                    <a:pt x="7419944" y="5602103"/>
                    <a:pt x="8086993" y="5463773"/>
                  </a:cubicBezTo>
                  <a:lnTo>
                    <a:pt x="8086993" y="5269538"/>
                  </a:lnTo>
                  <a:cubicBezTo>
                    <a:pt x="7313661" y="5411166"/>
                    <a:pt x="6742920" y="6071943"/>
                    <a:pt x="6714968" y="6858000"/>
                  </a:cubicBezTo>
                  <a:close/>
                  <a:moveTo>
                    <a:pt x="7902253" y="6858000"/>
                  </a:moveTo>
                  <a:lnTo>
                    <a:pt x="8087184" y="6858000"/>
                  </a:lnTo>
                  <a:lnTo>
                    <a:pt x="8087184" y="6532261"/>
                  </a:lnTo>
                  <a:cubicBezTo>
                    <a:pt x="7984903" y="6612091"/>
                    <a:pt x="7918389" y="6729230"/>
                    <a:pt x="7902253" y="6858000"/>
                  </a:cubicBezTo>
                  <a:close/>
                  <a:moveTo>
                    <a:pt x="1916910" y="2551824"/>
                  </a:moveTo>
                  <a:cubicBezTo>
                    <a:pt x="2641015" y="1478290"/>
                    <a:pt x="3620238" y="601442"/>
                    <a:pt x="4766674" y="0"/>
                  </a:cubicBezTo>
                  <a:lnTo>
                    <a:pt x="4372797" y="0"/>
                  </a:lnTo>
                  <a:cubicBezTo>
                    <a:pt x="4217787" y="90127"/>
                    <a:pt x="4065999" y="185317"/>
                    <a:pt x="3917425" y="285570"/>
                  </a:cubicBezTo>
                  <a:cubicBezTo>
                    <a:pt x="2632356" y="1153193"/>
                    <a:pt x="1626642" y="2375366"/>
                    <a:pt x="1022365" y="3803743"/>
                  </a:cubicBezTo>
                  <a:cubicBezTo>
                    <a:pt x="613622" y="4771490"/>
                    <a:pt x="402707" y="5798792"/>
                    <a:pt x="395021" y="6858000"/>
                  </a:cubicBezTo>
                  <a:lnTo>
                    <a:pt x="585606" y="6858000"/>
                  </a:lnTo>
                  <a:cubicBezTo>
                    <a:pt x="593293" y="5824406"/>
                    <a:pt x="799126" y="4822147"/>
                    <a:pt x="1197894" y="3877980"/>
                  </a:cubicBezTo>
                  <a:cubicBezTo>
                    <a:pt x="1394236" y="3413753"/>
                    <a:pt x="1635028" y="2969629"/>
                    <a:pt x="1916910" y="2551824"/>
                  </a:cubicBezTo>
                  <a:close/>
                  <a:moveTo>
                    <a:pt x="1589421" y="2330830"/>
                  </a:moveTo>
                  <a:cubicBezTo>
                    <a:pt x="2178972" y="1457633"/>
                    <a:pt x="2930502" y="705726"/>
                    <a:pt x="3803264" y="115868"/>
                  </a:cubicBezTo>
                  <a:cubicBezTo>
                    <a:pt x="3861583" y="76504"/>
                    <a:pt x="3920429" y="37881"/>
                    <a:pt x="3979810" y="0"/>
                  </a:cubicBezTo>
                  <a:lnTo>
                    <a:pt x="3635104" y="0"/>
                  </a:lnTo>
                  <a:cubicBezTo>
                    <a:pt x="2315489" y="907938"/>
                    <a:pt x="1282730" y="2174291"/>
                    <a:pt x="658473" y="3649867"/>
                  </a:cubicBezTo>
                  <a:cubicBezTo>
                    <a:pt x="229084" y="4666364"/>
                    <a:pt x="7814" y="5745720"/>
                    <a:pt x="0" y="6858000"/>
                  </a:cubicBezTo>
                  <a:lnTo>
                    <a:pt x="190586" y="6858000"/>
                  </a:lnTo>
                  <a:cubicBezTo>
                    <a:pt x="198336" y="5771144"/>
                    <a:pt x="414587" y="4716957"/>
                    <a:pt x="833939" y="3724104"/>
                  </a:cubicBezTo>
                  <a:cubicBezTo>
                    <a:pt x="1040191" y="3236353"/>
                    <a:pt x="1293200" y="2769749"/>
                    <a:pt x="1589421" y="2330830"/>
                  </a:cubicBezTo>
                  <a:close/>
                  <a:moveTo>
                    <a:pt x="2572017" y="2993622"/>
                  </a:moveTo>
                  <a:cubicBezTo>
                    <a:pt x="3332930" y="1865656"/>
                    <a:pt x="4404701" y="982881"/>
                    <a:pt x="5657281" y="452412"/>
                  </a:cubicBezTo>
                  <a:cubicBezTo>
                    <a:pt x="6154760" y="241841"/>
                    <a:pt x="6675072" y="90013"/>
                    <a:pt x="7207695" y="0"/>
                  </a:cubicBezTo>
                  <a:lnTo>
                    <a:pt x="6359208" y="0"/>
                  </a:lnTo>
                  <a:cubicBezTo>
                    <a:pt x="4284670" y="610249"/>
                    <a:pt x="2593089" y="2119237"/>
                    <a:pt x="1750212" y="4111495"/>
                  </a:cubicBezTo>
                  <a:cubicBezTo>
                    <a:pt x="1382635" y="4981807"/>
                    <a:pt x="1192558" y="5905571"/>
                    <a:pt x="1184807" y="6858000"/>
                  </a:cubicBezTo>
                  <a:lnTo>
                    <a:pt x="1375393" y="6858000"/>
                  </a:lnTo>
                  <a:cubicBezTo>
                    <a:pt x="1383080" y="5931185"/>
                    <a:pt x="1568075" y="5032463"/>
                    <a:pt x="1925741" y="4185732"/>
                  </a:cubicBezTo>
                  <a:cubicBezTo>
                    <a:pt x="2102147" y="3768398"/>
                    <a:pt x="2318583" y="3369160"/>
                    <a:pt x="2572017" y="2993622"/>
                  </a:cubicBezTo>
                  <a:close/>
                  <a:moveTo>
                    <a:pt x="2244464" y="2772819"/>
                  </a:moveTo>
                  <a:cubicBezTo>
                    <a:pt x="3048163" y="1581236"/>
                    <a:pt x="4180312" y="648682"/>
                    <a:pt x="5503478" y="88347"/>
                  </a:cubicBezTo>
                  <a:cubicBezTo>
                    <a:pt x="5576110" y="57669"/>
                    <a:pt x="5649085" y="28220"/>
                    <a:pt x="5722398" y="0"/>
                  </a:cubicBezTo>
                  <a:lnTo>
                    <a:pt x="5231195" y="0"/>
                  </a:lnTo>
                  <a:cubicBezTo>
                    <a:pt x="3500048" y="791829"/>
                    <a:pt x="2128257" y="2203840"/>
                    <a:pt x="1386320" y="3957619"/>
                  </a:cubicBezTo>
                  <a:cubicBezTo>
                    <a:pt x="998097" y="4876680"/>
                    <a:pt x="797664" y="5852181"/>
                    <a:pt x="789914" y="6858000"/>
                  </a:cubicBezTo>
                  <a:lnTo>
                    <a:pt x="980500" y="6858000"/>
                  </a:lnTo>
                  <a:cubicBezTo>
                    <a:pt x="988250" y="5877796"/>
                    <a:pt x="1183791" y="4927273"/>
                    <a:pt x="1561849" y="4031856"/>
                  </a:cubicBezTo>
                  <a:cubicBezTo>
                    <a:pt x="1748217" y="3591107"/>
                    <a:pt x="1976824" y="3169458"/>
                    <a:pt x="2244464" y="2772819"/>
                  </a:cubicBezTo>
                  <a:close/>
                  <a:moveTo>
                    <a:pt x="6645086" y="5174199"/>
                  </a:moveTo>
                  <a:cubicBezTo>
                    <a:pt x="6196994" y="5621603"/>
                    <a:pt x="5938846" y="6224801"/>
                    <a:pt x="5924482" y="6858000"/>
                  </a:cubicBezTo>
                  <a:lnTo>
                    <a:pt x="6115068" y="6858000"/>
                  </a:lnTo>
                  <a:cubicBezTo>
                    <a:pt x="6144113" y="5740903"/>
                    <a:pt x="6980009" y="4810427"/>
                    <a:pt x="8087184" y="4662805"/>
                  </a:cubicBezTo>
                  <a:lnTo>
                    <a:pt x="8087184" y="4470476"/>
                  </a:lnTo>
                  <a:cubicBezTo>
                    <a:pt x="7541283" y="4536958"/>
                    <a:pt x="7033500" y="4784755"/>
                    <a:pt x="6645086" y="5174199"/>
                  </a:cubicBezTo>
                  <a:close/>
                  <a:moveTo>
                    <a:pt x="5248665" y="3776858"/>
                  </a:moveTo>
                  <a:cubicBezTo>
                    <a:pt x="4429655" y="4594492"/>
                    <a:pt x="3963299" y="5700524"/>
                    <a:pt x="3949506" y="6858000"/>
                  </a:cubicBezTo>
                  <a:lnTo>
                    <a:pt x="4140092" y="6858000"/>
                  </a:lnTo>
                  <a:cubicBezTo>
                    <a:pt x="4168387" y="4649426"/>
                    <a:pt x="5884840" y="2831630"/>
                    <a:pt x="8087184" y="2677862"/>
                  </a:cubicBezTo>
                  <a:lnTo>
                    <a:pt x="8087184" y="2486740"/>
                  </a:lnTo>
                  <a:cubicBezTo>
                    <a:pt x="7015966" y="2558053"/>
                    <a:pt x="6007247" y="3016624"/>
                    <a:pt x="5248983" y="3776985"/>
                  </a:cubicBezTo>
                  <a:close/>
                  <a:moveTo>
                    <a:pt x="4410660" y="2938516"/>
                  </a:moveTo>
                  <a:cubicBezTo>
                    <a:pt x="3369116" y="3978263"/>
                    <a:pt x="2777913" y="5386016"/>
                    <a:pt x="2764635" y="6858000"/>
                  </a:cubicBezTo>
                  <a:lnTo>
                    <a:pt x="2955221" y="6858000"/>
                  </a:lnTo>
                  <a:cubicBezTo>
                    <a:pt x="2982996" y="3994566"/>
                    <a:pt x="5229175" y="1645170"/>
                    <a:pt x="8087184" y="1490201"/>
                  </a:cubicBezTo>
                  <a:lnTo>
                    <a:pt x="8087184" y="1299524"/>
                  </a:lnTo>
                  <a:cubicBezTo>
                    <a:pt x="6701118" y="1371556"/>
                    <a:pt x="5391045" y="1955579"/>
                    <a:pt x="4410660" y="2938516"/>
                  </a:cubicBezTo>
                  <a:close/>
                  <a:moveTo>
                    <a:pt x="4131135" y="2658858"/>
                  </a:moveTo>
                  <a:cubicBezTo>
                    <a:pt x="3581562" y="3207390"/>
                    <a:pt x="3143742" y="3857527"/>
                    <a:pt x="2842013" y="4573123"/>
                  </a:cubicBezTo>
                  <a:cubicBezTo>
                    <a:pt x="2536123" y="5297313"/>
                    <a:pt x="2377365" y="6065676"/>
                    <a:pt x="2369615" y="6858000"/>
                  </a:cubicBezTo>
                  <a:lnTo>
                    <a:pt x="2560201" y="6858000"/>
                  </a:lnTo>
                  <a:cubicBezTo>
                    <a:pt x="2567887" y="6091353"/>
                    <a:pt x="2721563" y="5347905"/>
                    <a:pt x="3017606" y="4647360"/>
                  </a:cubicBezTo>
                  <a:cubicBezTo>
                    <a:pt x="3885813" y="2587735"/>
                    <a:pt x="5855795" y="1207104"/>
                    <a:pt x="8087184" y="1094420"/>
                  </a:cubicBezTo>
                  <a:lnTo>
                    <a:pt x="8087184" y="903743"/>
                  </a:lnTo>
                  <a:cubicBezTo>
                    <a:pt x="6596296" y="976143"/>
                    <a:pt x="5185918" y="1602077"/>
                    <a:pt x="4131643" y="2659239"/>
                  </a:cubicBezTo>
                  <a:close/>
                  <a:moveTo>
                    <a:pt x="3851609" y="2379199"/>
                  </a:moveTo>
                  <a:cubicBezTo>
                    <a:pt x="3266022" y="2963794"/>
                    <a:pt x="2799525" y="3656649"/>
                    <a:pt x="2478058" y="4419247"/>
                  </a:cubicBezTo>
                  <a:cubicBezTo>
                    <a:pt x="2151585" y="5192123"/>
                    <a:pt x="1982535" y="6012350"/>
                    <a:pt x="1974721" y="6858000"/>
                  </a:cubicBezTo>
                  <a:lnTo>
                    <a:pt x="2165307" y="6858000"/>
                  </a:lnTo>
                  <a:cubicBezTo>
                    <a:pt x="2172994" y="6038091"/>
                    <a:pt x="2337152" y="5242779"/>
                    <a:pt x="2653651" y="4493611"/>
                  </a:cubicBezTo>
                  <a:cubicBezTo>
                    <a:pt x="3583550" y="2287642"/>
                    <a:pt x="5696853" y="811831"/>
                    <a:pt x="8087184" y="699147"/>
                  </a:cubicBezTo>
                  <a:lnTo>
                    <a:pt x="8087184" y="508471"/>
                  </a:lnTo>
                  <a:cubicBezTo>
                    <a:pt x="6491347" y="580803"/>
                    <a:pt x="4980435" y="1248328"/>
                    <a:pt x="3851990" y="2379580"/>
                  </a:cubicBezTo>
                  <a:close/>
                  <a:moveTo>
                    <a:pt x="6365561" y="4894350"/>
                  </a:moveTo>
                  <a:cubicBezTo>
                    <a:pt x="5843312" y="5415945"/>
                    <a:pt x="5543596" y="6119847"/>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689995" y="3217985"/>
                  </a:moveTo>
                  <a:cubicBezTo>
                    <a:pt x="3722659" y="4183711"/>
                    <a:pt x="3173060" y="5490862"/>
                    <a:pt x="3159529" y="6858000"/>
                  </a:cubicBezTo>
                  <a:lnTo>
                    <a:pt x="3350115" y="6858000"/>
                  </a:lnTo>
                  <a:cubicBezTo>
                    <a:pt x="3378080" y="4212840"/>
                    <a:pt x="5447656" y="2040614"/>
                    <a:pt x="8087184" y="1885982"/>
                  </a:cubicBezTo>
                  <a:lnTo>
                    <a:pt x="8087184" y="1694988"/>
                  </a:lnTo>
                  <a:cubicBezTo>
                    <a:pt x="6806004" y="1766892"/>
                    <a:pt x="5596357" y="2309182"/>
                    <a:pt x="4689995" y="3217985"/>
                  </a:cubicBezTo>
                  <a:close/>
                  <a:moveTo>
                    <a:pt x="5736946" y="640864"/>
                  </a:moveTo>
                  <a:cubicBezTo>
                    <a:pt x="4104688" y="1332467"/>
                    <a:pt x="2805440" y="2632335"/>
                    <a:pt x="2114167" y="4265371"/>
                  </a:cubicBezTo>
                  <a:cubicBezTo>
                    <a:pt x="1767110" y="5086996"/>
                    <a:pt x="1587515" y="5958960"/>
                    <a:pt x="1579828" y="6858000"/>
                  </a:cubicBezTo>
                  <a:lnTo>
                    <a:pt x="1770414" y="6858000"/>
                  </a:lnTo>
                  <a:cubicBezTo>
                    <a:pt x="1778101" y="5984575"/>
                    <a:pt x="1952613" y="5137589"/>
                    <a:pt x="2289696" y="4339608"/>
                  </a:cubicBezTo>
                  <a:cubicBezTo>
                    <a:pt x="3281262" y="1987231"/>
                    <a:pt x="5537892" y="416179"/>
                    <a:pt x="8087184" y="303430"/>
                  </a:cubicBezTo>
                  <a:lnTo>
                    <a:pt x="8087184" y="112753"/>
                  </a:lnTo>
                  <a:cubicBezTo>
                    <a:pt x="7278466" y="146573"/>
                    <a:pt x="6482453" y="325450"/>
                    <a:pt x="5736946" y="640864"/>
                  </a:cubicBezTo>
                  <a:close/>
                  <a:moveTo>
                    <a:pt x="4969330" y="3497453"/>
                  </a:moveTo>
                  <a:cubicBezTo>
                    <a:pt x="4076132" y="4389101"/>
                    <a:pt x="3568132" y="5595696"/>
                    <a:pt x="3554486" y="6858000"/>
                  </a:cubicBezTo>
                  <a:lnTo>
                    <a:pt x="3745072" y="6858000"/>
                  </a:lnTo>
                  <a:cubicBezTo>
                    <a:pt x="3773202" y="4431107"/>
                    <a:pt x="5666194" y="2436046"/>
                    <a:pt x="8087184" y="2281763"/>
                  </a:cubicBezTo>
                  <a:lnTo>
                    <a:pt x="8087184" y="2091086"/>
                  </a:lnTo>
                  <a:cubicBezTo>
                    <a:pt x="6910953" y="2162571"/>
                    <a:pt x="5801707" y="2662919"/>
                    <a:pt x="4969330" y="3497453"/>
                  </a:cubicBezTo>
                  <a:close/>
                  <a:moveTo>
                    <a:pt x="6086607" y="4615263"/>
                  </a:moveTo>
                  <a:cubicBezTo>
                    <a:pt x="5490118" y="5210739"/>
                    <a:pt x="5148633" y="6015070"/>
                    <a:pt x="5134441" y="6858000"/>
                  </a:cubicBezTo>
                  <a:lnTo>
                    <a:pt x="5325027" y="6858000"/>
                  </a:lnTo>
                  <a:cubicBezTo>
                    <a:pt x="5353570" y="5304190"/>
                    <a:pt x="6541217" y="4018292"/>
                    <a:pt x="8087184" y="3867302"/>
                  </a:cubicBezTo>
                  <a:lnTo>
                    <a:pt x="8087184" y="3675799"/>
                  </a:lnTo>
                  <a:cubicBezTo>
                    <a:pt x="7330940" y="3744977"/>
                    <a:pt x="6622978" y="4077447"/>
                    <a:pt x="6086607" y="4615263"/>
                  </a:cubicBezTo>
                  <a:close/>
                  <a:moveTo>
                    <a:pt x="5807081" y="4335604"/>
                  </a:moveTo>
                  <a:cubicBezTo>
                    <a:pt x="5136353" y="5005171"/>
                    <a:pt x="4753231" y="5910147"/>
                    <a:pt x="4739230" y="6858000"/>
                  </a:cubicBezTo>
                  <a:lnTo>
                    <a:pt x="4929815" y="6858000"/>
                  </a:lnTo>
                  <a:cubicBezTo>
                    <a:pt x="4958327" y="5085840"/>
                    <a:pt x="6322177" y="3622499"/>
                    <a:pt x="8087184" y="3470313"/>
                  </a:cubicBezTo>
                  <a:lnTo>
                    <a:pt x="8087184" y="3279192"/>
                  </a:lnTo>
                  <a:cubicBezTo>
                    <a:pt x="7225928" y="3349227"/>
                    <a:pt x="6417654" y="3723799"/>
                    <a:pt x="5807335" y="4335794"/>
                  </a:cubicBezTo>
                  <a:close/>
                  <a:moveTo>
                    <a:pt x="5527556" y="4055945"/>
                  </a:moveTo>
                  <a:cubicBezTo>
                    <a:pt x="4782753" y="4799672"/>
                    <a:pt x="4358160" y="5805294"/>
                    <a:pt x="4344463" y="6858000"/>
                  </a:cubicBezTo>
                  <a:lnTo>
                    <a:pt x="4535049" y="6858000"/>
                  </a:lnTo>
                  <a:cubicBezTo>
                    <a:pt x="4563415" y="4867661"/>
                    <a:pt x="6103486" y="3227074"/>
                    <a:pt x="8087184" y="3074024"/>
                  </a:cubicBezTo>
                  <a:lnTo>
                    <a:pt x="8087184" y="2882775"/>
                  </a:lnTo>
                  <a:cubicBezTo>
                    <a:pt x="7120852" y="2953516"/>
                    <a:pt x="6212355" y="3370126"/>
                    <a:pt x="5528000" y="4056326"/>
                  </a:cubicBezTo>
                  <a:close/>
                </a:path>
              </a:pathLst>
            </a:custGeom>
            <a:solidFill>
              <a:srgbClr val="FFFFFF">
                <a:alpha val="503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80" name="Google Shape;80;p11"/>
            <p:cNvSpPr/>
            <p:nvPr/>
          </p:nvSpPr>
          <p:spPr>
            <a:xfrm>
              <a:off x="2052402" y="0"/>
              <a:ext cx="6065388" cy="5143642"/>
            </a:xfrm>
            <a:custGeom>
              <a:avLst/>
              <a:gdLst/>
              <a:ahLst/>
              <a:cxnLst/>
              <a:rect l="l" t="t" r="r" b="b"/>
              <a:pathLst>
                <a:path w="8087184" h="6858190" extrusionOk="0">
                  <a:moveTo>
                    <a:pt x="6366259" y="1870219"/>
                  </a:moveTo>
                  <a:cubicBezTo>
                    <a:pt x="6414478" y="1849137"/>
                    <a:pt x="6436522" y="1792932"/>
                    <a:pt x="6415430" y="1744684"/>
                  </a:cubicBezTo>
                  <a:cubicBezTo>
                    <a:pt x="6395292" y="1698629"/>
                    <a:pt x="6342913" y="1676110"/>
                    <a:pt x="6295679" y="1693208"/>
                  </a:cubicBezTo>
                  <a:cubicBezTo>
                    <a:pt x="4468935" y="2426156"/>
                    <a:pt x="3157737" y="4060756"/>
                    <a:pt x="2838011" y="6003706"/>
                  </a:cubicBezTo>
                  <a:cubicBezTo>
                    <a:pt x="2829536" y="6055671"/>
                    <a:pt x="2864769" y="6104675"/>
                    <a:pt x="2916716" y="6113154"/>
                  </a:cubicBezTo>
                  <a:cubicBezTo>
                    <a:pt x="2916716" y="6113154"/>
                    <a:pt x="2916723" y="6113154"/>
                    <a:pt x="2916723" y="6113154"/>
                  </a:cubicBezTo>
                  <a:cubicBezTo>
                    <a:pt x="2921824" y="6114012"/>
                    <a:pt x="2926989" y="6114438"/>
                    <a:pt x="2932160" y="6114425"/>
                  </a:cubicBezTo>
                  <a:cubicBezTo>
                    <a:pt x="2978841" y="6114381"/>
                    <a:pt x="3018616" y="6080504"/>
                    <a:pt x="3026119" y="6034405"/>
                  </a:cubicBezTo>
                  <a:cubicBezTo>
                    <a:pt x="3335065" y="4157486"/>
                    <a:pt x="4601646" y="2578418"/>
                    <a:pt x="6366259" y="1870219"/>
                  </a:cubicBezTo>
                  <a:close/>
                  <a:moveTo>
                    <a:pt x="2680460" y="5322927"/>
                  </a:moveTo>
                  <a:cubicBezTo>
                    <a:pt x="2629555" y="5309637"/>
                    <a:pt x="2577512" y="5340139"/>
                    <a:pt x="2564203" y="5391062"/>
                  </a:cubicBezTo>
                  <a:cubicBezTo>
                    <a:pt x="2439623" y="5870239"/>
                    <a:pt x="2374272" y="6362877"/>
                    <a:pt x="2369615" y="6858000"/>
                  </a:cubicBezTo>
                  <a:lnTo>
                    <a:pt x="2560201" y="6858000"/>
                  </a:lnTo>
                  <a:cubicBezTo>
                    <a:pt x="2564794" y="6379148"/>
                    <a:pt x="2628055" y="5902679"/>
                    <a:pt x="2748563" y="5439240"/>
                  </a:cubicBezTo>
                  <a:cubicBezTo>
                    <a:pt x="2761847" y="5388310"/>
                    <a:pt x="2731365" y="5336243"/>
                    <a:pt x="2680460" y="5322927"/>
                  </a:cubicBezTo>
                  <a:close/>
                  <a:moveTo>
                    <a:pt x="2239000" y="4214715"/>
                  </a:moveTo>
                  <a:cubicBezTo>
                    <a:pt x="2190503" y="4194261"/>
                    <a:pt x="2134617" y="4217016"/>
                    <a:pt x="2114179" y="4265537"/>
                  </a:cubicBezTo>
                  <a:cubicBezTo>
                    <a:pt x="2114173" y="4265543"/>
                    <a:pt x="2114173" y="4265556"/>
                    <a:pt x="2114167" y="4265562"/>
                  </a:cubicBezTo>
                  <a:cubicBezTo>
                    <a:pt x="1767110" y="5087187"/>
                    <a:pt x="1587515" y="5959151"/>
                    <a:pt x="1579828" y="6858191"/>
                  </a:cubicBezTo>
                  <a:lnTo>
                    <a:pt x="1770414" y="6858191"/>
                  </a:lnTo>
                  <a:cubicBezTo>
                    <a:pt x="1778101" y="5984765"/>
                    <a:pt x="1952613" y="5137780"/>
                    <a:pt x="2289696" y="4339799"/>
                  </a:cubicBezTo>
                  <a:cubicBezTo>
                    <a:pt x="2310254" y="4291329"/>
                    <a:pt x="2287638" y="4235359"/>
                    <a:pt x="2239191" y="4214797"/>
                  </a:cubicBezTo>
                  <a:cubicBezTo>
                    <a:pt x="2239127" y="4214766"/>
                    <a:pt x="2239064" y="4214740"/>
                    <a:pt x="2239000" y="4214715"/>
                  </a:cubicBezTo>
                  <a:close/>
                  <a:moveTo>
                    <a:pt x="2087612" y="6428088"/>
                  </a:moveTo>
                  <a:cubicBezTo>
                    <a:pt x="2035093" y="6424847"/>
                    <a:pt x="1989898" y="6464825"/>
                    <a:pt x="1986665" y="6517389"/>
                  </a:cubicBezTo>
                  <a:cubicBezTo>
                    <a:pt x="1979740" y="6630078"/>
                    <a:pt x="1975738" y="6744357"/>
                    <a:pt x="1974658" y="6858000"/>
                  </a:cubicBezTo>
                  <a:lnTo>
                    <a:pt x="2165244" y="6858000"/>
                  </a:lnTo>
                  <a:cubicBezTo>
                    <a:pt x="2166260" y="6748234"/>
                    <a:pt x="2170135" y="6637896"/>
                    <a:pt x="2176806" y="6529083"/>
                  </a:cubicBezTo>
                  <a:cubicBezTo>
                    <a:pt x="2180027" y="6476584"/>
                    <a:pt x="2140105" y="6431330"/>
                    <a:pt x="2087612" y="6428088"/>
                  </a:cubicBezTo>
                  <a:close/>
                  <a:moveTo>
                    <a:pt x="3486447" y="3682663"/>
                  </a:moveTo>
                  <a:cubicBezTo>
                    <a:pt x="3518040" y="3682689"/>
                    <a:pt x="3547593" y="3667047"/>
                    <a:pt x="3565349" y="3640906"/>
                  </a:cubicBezTo>
                  <a:cubicBezTo>
                    <a:pt x="3898042" y="3151394"/>
                    <a:pt x="4303100" y="2715260"/>
                    <a:pt x="4766674" y="2347419"/>
                  </a:cubicBezTo>
                  <a:cubicBezTo>
                    <a:pt x="4807898" y="2314686"/>
                    <a:pt x="4814797" y="2254712"/>
                    <a:pt x="4782080" y="2213469"/>
                  </a:cubicBezTo>
                  <a:cubicBezTo>
                    <a:pt x="4749362" y="2172225"/>
                    <a:pt x="4689417" y="2165323"/>
                    <a:pt x="4648193" y="2198056"/>
                  </a:cubicBezTo>
                  <a:cubicBezTo>
                    <a:pt x="4169519" y="2577934"/>
                    <a:pt x="3751284" y="3028338"/>
                    <a:pt x="3407798" y="3533872"/>
                  </a:cubicBezTo>
                  <a:cubicBezTo>
                    <a:pt x="3378188" y="3577397"/>
                    <a:pt x="3389451" y="3636704"/>
                    <a:pt x="3432956" y="3666329"/>
                  </a:cubicBezTo>
                  <a:cubicBezTo>
                    <a:pt x="3448730" y="3677071"/>
                    <a:pt x="3467363" y="3682829"/>
                    <a:pt x="3486447" y="3682854"/>
                  </a:cubicBezTo>
                  <a:close/>
                  <a:moveTo>
                    <a:pt x="5285003" y="4471365"/>
                  </a:moveTo>
                  <a:cubicBezTo>
                    <a:pt x="5242903" y="4439770"/>
                    <a:pt x="5183174" y="4448313"/>
                    <a:pt x="5151593" y="4490433"/>
                  </a:cubicBezTo>
                  <a:cubicBezTo>
                    <a:pt x="4638429" y="5174034"/>
                    <a:pt x="4355873" y="6003210"/>
                    <a:pt x="4344781" y="6858064"/>
                  </a:cubicBezTo>
                  <a:lnTo>
                    <a:pt x="4535367" y="6858064"/>
                  </a:lnTo>
                  <a:cubicBezTo>
                    <a:pt x="4546427" y="6044479"/>
                    <a:pt x="4815610" y="5255459"/>
                    <a:pt x="5304062" y="4604903"/>
                  </a:cubicBezTo>
                  <a:cubicBezTo>
                    <a:pt x="5335661" y="4562795"/>
                    <a:pt x="5327161" y="4503030"/>
                    <a:pt x="5285074" y="4471416"/>
                  </a:cubicBezTo>
                  <a:cubicBezTo>
                    <a:pt x="5285048" y="4471403"/>
                    <a:pt x="5285029" y="4471384"/>
                    <a:pt x="5285003" y="4471365"/>
                  </a:cubicBezTo>
                  <a:close/>
                  <a:moveTo>
                    <a:pt x="6701690" y="2808030"/>
                  </a:moveTo>
                  <a:cubicBezTo>
                    <a:pt x="5767433" y="3193508"/>
                    <a:pt x="4991743" y="3885022"/>
                    <a:pt x="4501697" y="4769266"/>
                  </a:cubicBezTo>
                  <a:cubicBezTo>
                    <a:pt x="4475720" y="4815060"/>
                    <a:pt x="4491773" y="4873248"/>
                    <a:pt x="4537546" y="4899237"/>
                  </a:cubicBezTo>
                  <a:cubicBezTo>
                    <a:pt x="4583318" y="4925227"/>
                    <a:pt x="4641478" y="4909165"/>
                    <a:pt x="4667455" y="4863371"/>
                  </a:cubicBezTo>
                  <a:cubicBezTo>
                    <a:pt x="4667792" y="4862767"/>
                    <a:pt x="4668129" y="4862164"/>
                    <a:pt x="4668459" y="4861553"/>
                  </a:cubicBezTo>
                  <a:cubicBezTo>
                    <a:pt x="5137446" y="4015222"/>
                    <a:pt x="5879860" y="3353378"/>
                    <a:pt x="6774050" y="2984470"/>
                  </a:cubicBezTo>
                  <a:cubicBezTo>
                    <a:pt x="6822775" y="2964480"/>
                    <a:pt x="6846027" y="2908777"/>
                    <a:pt x="6826079" y="2860053"/>
                  </a:cubicBezTo>
                  <a:cubicBezTo>
                    <a:pt x="6806067" y="2811329"/>
                    <a:pt x="6750416" y="2788041"/>
                    <a:pt x="6701690" y="2808030"/>
                  </a:cubicBezTo>
                  <a:close/>
                  <a:moveTo>
                    <a:pt x="4156864" y="5925783"/>
                  </a:moveTo>
                  <a:cubicBezTo>
                    <a:pt x="4105367" y="5914933"/>
                    <a:pt x="4054824" y="5947901"/>
                    <a:pt x="4043980" y="5999428"/>
                  </a:cubicBezTo>
                  <a:cubicBezTo>
                    <a:pt x="4043973" y="5999435"/>
                    <a:pt x="4043973" y="5999441"/>
                    <a:pt x="4043973" y="5999447"/>
                  </a:cubicBezTo>
                  <a:cubicBezTo>
                    <a:pt x="3984905" y="6281916"/>
                    <a:pt x="3953267" y="6569443"/>
                    <a:pt x="3949506" y="6858000"/>
                  </a:cubicBezTo>
                  <a:lnTo>
                    <a:pt x="4140092" y="6858000"/>
                  </a:lnTo>
                  <a:cubicBezTo>
                    <a:pt x="4143866" y="6582600"/>
                    <a:pt x="4174143" y="6308242"/>
                    <a:pt x="4230493" y="6038663"/>
                  </a:cubicBezTo>
                  <a:cubicBezTo>
                    <a:pt x="4241299" y="5987155"/>
                    <a:pt x="4208341" y="5936626"/>
                    <a:pt x="4156864" y="5925783"/>
                  </a:cubicBezTo>
                  <a:close/>
                  <a:moveTo>
                    <a:pt x="5530160" y="2764810"/>
                  </a:moveTo>
                  <a:cubicBezTo>
                    <a:pt x="5974498" y="2457948"/>
                    <a:pt x="6465491" y="2225005"/>
                    <a:pt x="6984202" y="2075006"/>
                  </a:cubicBezTo>
                  <a:cubicBezTo>
                    <a:pt x="7034770" y="2060368"/>
                    <a:pt x="7063867" y="2007494"/>
                    <a:pt x="7049255" y="1956914"/>
                  </a:cubicBezTo>
                  <a:cubicBezTo>
                    <a:pt x="7034643" y="1906333"/>
                    <a:pt x="6981788" y="1877192"/>
                    <a:pt x="6931219" y="1891829"/>
                  </a:cubicBezTo>
                  <a:cubicBezTo>
                    <a:pt x="4715915" y="2532477"/>
                    <a:pt x="3182876" y="4551024"/>
                    <a:pt x="3159529" y="6858000"/>
                  </a:cubicBezTo>
                  <a:lnTo>
                    <a:pt x="3350115" y="6858000"/>
                  </a:lnTo>
                  <a:cubicBezTo>
                    <a:pt x="3368665" y="5220209"/>
                    <a:pt x="4181729" y="3693627"/>
                    <a:pt x="5530160" y="2764810"/>
                  </a:cubicBezTo>
                  <a:close/>
                  <a:moveTo>
                    <a:pt x="3857517" y="1312554"/>
                  </a:moveTo>
                  <a:cubicBezTo>
                    <a:pt x="2821278" y="2150298"/>
                    <a:pt x="2037615" y="3259196"/>
                    <a:pt x="1593677" y="4515920"/>
                  </a:cubicBezTo>
                  <a:cubicBezTo>
                    <a:pt x="1576137" y="4565572"/>
                    <a:pt x="1602146" y="4620055"/>
                    <a:pt x="1651774" y="4637604"/>
                  </a:cubicBezTo>
                  <a:cubicBezTo>
                    <a:pt x="1701402" y="4655152"/>
                    <a:pt x="1755859" y="4629131"/>
                    <a:pt x="1773399" y="4579479"/>
                  </a:cubicBezTo>
                  <a:cubicBezTo>
                    <a:pt x="2205610" y="3355958"/>
                    <a:pt x="2968581" y="2276360"/>
                    <a:pt x="3977459" y="1460773"/>
                  </a:cubicBezTo>
                  <a:cubicBezTo>
                    <a:pt x="4018371" y="1427634"/>
                    <a:pt x="4024686" y="1367596"/>
                    <a:pt x="3991562" y="1326664"/>
                  </a:cubicBezTo>
                  <a:cubicBezTo>
                    <a:pt x="3958439" y="1285732"/>
                    <a:pt x="3898430" y="1279414"/>
                    <a:pt x="3857517" y="1312554"/>
                  </a:cubicBezTo>
                  <a:close/>
                  <a:moveTo>
                    <a:pt x="2248403" y="2598095"/>
                  </a:moveTo>
                  <a:cubicBezTo>
                    <a:pt x="2204981" y="2568350"/>
                    <a:pt x="2145683" y="2579447"/>
                    <a:pt x="2115945" y="2622883"/>
                  </a:cubicBezTo>
                  <a:cubicBezTo>
                    <a:pt x="1635860" y="3322742"/>
                    <a:pt x="1277191" y="4098599"/>
                    <a:pt x="1055019" y="4917803"/>
                  </a:cubicBezTo>
                  <a:cubicBezTo>
                    <a:pt x="1039321" y="4968059"/>
                    <a:pt x="1067311" y="5021531"/>
                    <a:pt x="1117543" y="5037242"/>
                  </a:cubicBezTo>
                  <a:cubicBezTo>
                    <a:pt x="1167775" y="5052948"/>
                    <a:pt x="1221222" y="5024944"/>
                    <a:pt x="1236926" y="4974688"/>
                  </a:cubicBezTo>
                  <a:cubicBezTo>
                    <a:pt x="1237638" y="4972400"/>
                    <a:pt x="1238267" y="4970093"/>
                    <a:pt x="1238807" y="4967760"/>
                  </a:cubicBezTo>
                  <a:cubicBezTo>
                    <a:pt x="1455452" y="4169149"/>
                    <a:pt x="1805119" y="3412786"/>
                    <a:pt x="2273115" y="2730488"/>
                  </a:cubicBezTo>
                  <a:cubicBezTo>
                    <a:pt x="2302770" y="2687090"/>
                    <a:pt x="2291716" y="2627860"/>
                    <a:pt x="2248403" y="2598095"/>
                  </a:cubicBezTo>
                  <a:close/>
                  <a:moveTo>
                    <a:pt x="3182082" y="972450"/>
                  </a:moveTo>
                  <a:cubicBezTo>
                    <a:pt x="3216304" y="1012264"/>
                    <a:pt x="3276263" y="1016897"/>
                    <a:pt x="3316190" y="982811"/>
                  </a:cubicBezTo>
                  <a:cubicBezTo>
                    <a:pt x="3760979" y="601738"/>
                    <a:pt x="4247290" y="272053"/>
                    <a:pt x="4765912" y="0"/>
                  </a:cubicBezTo>
                  <a:lnTo>
                    <a:pt x="4372035" y="0"/>
                  </a:lnTo>
                  <a:cubicBezTo>
                    <a:pt x="3954366" y="243105"/>
                    <a:pt x="3559574" y="523572"/>
                    <a:pt x="3192500" y="837960"/>
                  </a:cubicBezTo>
                  <a:cubicBezTo>
                    <a:pt x="3152503" y="872186"/>
                    <a:pt x="3147814" y="932364"/>
                    <a:pt x="3182024" y="972381"/>
                  </a:cubicBezTo>
                  <a:cubicBezTo>
                    <a:pt x="3182043" y="972406"/>
                    <a:pt x="3182062" y="972425"/>
                    <a:pt x="3182082" y="972450"/>
                  </a:cubicBezTo>
                  <a:close/>
                  <a:moveTo>
                    <a:pt x="4503476" y="959103"/>
                  </a:moveTo>
                  <a:cubicBezTo>
                    <a:pt x="4531669" y="1003556"/>
                    <a:pt x="4590541" y="1016732"/>
                    <a:pt x="4634980" y="988531"/>
                  </a:cubicBezTo>
                  <a:cubicBezTo>
                    <a:pt x="5419589" y="490690"/>
                    <a:pt x="6295666" y="154609"/>
                    <a:pt x="7211824" y="0"/>
                  </a:cubicBezTo>
                  <a:lnTo>
                    <a:pt x="6361749" y="0"/>
                  </a:lnTo>
                  <a:cubicBezTo>
                    <a:pt x="5716216" y="188538"/>
                    <a:pt x="5100440" y="467098"/>
                    <a:pt x="4532571" y="827473"/>
                  </a:cubicBezTo>
                  <a:cubicBezTo>
                    <a:pt x="4488140" y="855680"/>
                    <a:pt x="4474970" y="914580"/>
                    <a:pt x="4503158" y="959040"/>
                  </a:cubicBezTo>
                  <a:close/>
                  <a:moveTo>
                    <a:pt x="4619923" y="423048"/>
                  </a:moveTo>
                  <a:cubicBezTo>
                    <a:pt x="4645786" y="468905"/>
                    <a:pt x="4703908" y="485105"/>
                    <a:pt x="4749744" y="459231"/>
                  </a:cubicBezTo>
                  <a:cubicBezTo>
                    <a:pt x="4749756" y="459225"/>
                    <a:pt x="4749763" y="459218"/>
                    <a:pt x="4749775" y="459213"/>
                  </a:cubicBezTo>
                  <a:cubicBezTo>
                    <a:pt x="5062406" y="282668"/>
                    <a:pt x="5387494" y="129190"/>
                    <a:pt x="5722461" y="0"/>
                  </a:cubicBezTo>
                  <a:lnTo>
                    <a:pt x="5231004" y="0"/>
                  </a:lnTo>
                  <a:cubicBezTo>
                    <a:pt x="5035419" y="89448"/>
                    <a:pt x="4843690" y="187160"/>
                    <a:pt x="4655817" y="293133"/>
                  </a:cubicBezTo>
                  <a:cubicBezTo>
                    <a:pt x="4609981" y="318991"/>
                    <a:pt x="4593775" y="377121"/>
                    <a:pt x="4619605" y="422984"/>
                  </a:cubicBezTo>
                  <a:close/>
                  <a:moveTo>
                    <a:pt x="1208440" y="3617579"/>
                  </a:moveTo>
                  <a:cubicBezTo>
                    <a:pt x="1160368" y="3596141"/>
                    <a:pt x="1104031" y="3617751"/>
                    <a:pt x="1082609" y="3665846"/>
                  </a:cubicBezTo>
                  <a:cubicBezTo>
                    <a:pt x="1082603" y="3665858"/>
                    <a:pt x="1082596" y="3665871"/>
                    <a:pt x="1082590" y="3665884"/>
                  </a:cubicBezTo>
                  <a:cubicBezTo>
                    <a:pt x="859205" y="4168380"/>
                    <a:pt x="688459" y="4692677"/>
                    <a:pt x="573091" y="5230385"/>
                  </a:cubicBezTo>
                  <a:cubicBezTo>
                    <a:pt x="458720" y="5765494"/>
                    <a:pt x="399119" y="6310867"/>
                    <a:pt x="395211" y="6858064"/>
                  </a:cubicBezTo>
                  <a:lnTo>
                    <a:pt x="585797" y="6858064"/>
                  </a:lnTo>
                  <a:cubicBezTo>
                    <a:pt x="589636" y="6324322"/>
                    <a:pt x="647724" y="5792347"/>
                    <a:pt x="759166" y="5270364"/>
                  </a:cubicBezTo>
                  <a:cubicBezTo>
                    <a:pt x="871732" y="4745641"/>
                    <a:pt x="1038323" y="4233992"/>
                    <a:pt x="1256277" y="3743616"/>
                  </a:cubicBezTo>
                  <a:cubicBezTo>
                    <a:pt x="1277788" y="3695566"/>
                    <a:pt x="1256296" y="3639157"/>
                    <a:pt x="1208262" y="3617637"/>
                  </a:cubicBezTo>
                  <a:cubicBezTo>
                    <a:pt x="1208173" y="3617598"/>
                    <a:pt x="1208084" y="3617554"/>
                    <a:pt x="1207995" y="3617516"/>
                  </a:cubicBezTo>
                  <a:close/>
                  <a:moveTo>
                    <a:pt x="942891" y="5974532"/>
                  </a:moveTo>
                  <a:cubicBezTo>
                    <a:pt x="890594" y="5968659"/>
                    <a:pt x="843443" y="6006305"/>
                    <a:pt x="837560" y="6058620"/>
                  </a:cubicBezTo>
                  <a:cubicBezTo>
                    <a:pt x="807861" y="6324074"/>
                    <a:pt x="791934" y="6590926"/>
                    <a:pt x="789850" y="6858000"/>
                  </a:cubicBezTo>
                  <a:lnTo>
                    <a:pt x="980436" y="6858000"/>
                  </a:lnTo>
                  <a:cubicBezTo>
                    <a:pt x="982494" y="6597917"/>
                    <a:pt x="998014" y="6338127"/>
                    <a:pt x="1026939" y="6079658"/>
                  </a:cubicBezTo>
                  <a:cubicBezTo>
                    <a:pt x="1032663" y="6027432"/>
                    <a:pt x="995073" y="5980418"/>
                    <a:pt x="942891" y="5974532"/>
                  </a:cubicBezTo>
                  <a:close/>
                  <a:moveTo>
                    <a:pt x="2329973" y="1389587"/>
                  </a:moveTo>
                  <a:cubicBezTo>
                    <a:pt x="2705198" y="978292"/>
                    <a:pt x="3121081" y="606057"/>
                    <a:pt x="3571258" y="278578"/>
                  </a:cubicBezTo>
                  <a:cubicBezTo>
                    <a:pt x="3704623" y="181588"/>
                    <a:pt x="3840892" y="88728"/>
                    <a:pt x="3980064" y="0"/>
                  </a:cubicBezTo>
                  <a:lnTo>
                    <a:pt x="3634913" y="0"/>
                  </a:lnTo>
                  <a:cubicBezTo>
                    <a:pt x="3575622" y="40678"/>
                    <a:pt x="3517049" y="82118"/>
                    <a:pt x="3459193" y="124321"/>
                  </a:cubicBezTo>
                  <a:cubicBezTo>
                    <a:pt x="2998611" y="459401"/>
                    <a:pt x="2573110" y="840261"/>
                    <a:pt x="2189194" y="1261071"/>
                  </a:cubicBezTo>
                  <a:cubicBezTo>
                    <a:pt x="2154101" y="1300312"/>
                    <a:pt x="2157449" y="1360585"/>
                    <a:pt x="2196671" y="1395695"/>
                  </a:cubicBezTo>
                  <a:cubicBezTo>
                    <a:pt x="2235354" y="1430316"/>
                    <a:pt x="2294613" y="1427602"/>
                    <a:pt x="2329973" y="1389587"/>
                  </a:cubicBezTo>
                  <a:close/>
                  <a:moveTo>
                    <a:pt x="557844" y="4174100"/>
                  </a:moveTo>
                  <a:cubicBezTo>
                    <a:pt x="507970" y="4157308"/>
                    <a:pt x="453932" y="4184143"/>
                    <a:pt x="437140" y="4234036"/>
                  </a:cubicBezTo>
                  <a:cubicBezTo>
                    <a:pt x="152879" y="5079865"/>
                    <a:pt x="5311" y="5965653"/>
                    <a:pt x="0" y="6858000"/>
                  </a:cubicBezTo>
                  <a:lnTo>
                    <a:pt x="190586" y="6858000"/>
                  </a:lnTo>
                  <a:cubicBezTo>
                    <a:pt x="195867" y="5986354"/>
                    <a:pt x="340068" y="5121127"/>
                    <a:pt x="617752" y="4294926"/>
                  </a:cubicBezTo>
                  <a:cubicBezTo>
                    <a:pt x="634569" y="4245032"/>
                    <a:pt x="607775" y="4190944"/>
                    <a:pt x="557905" y="4174119"/>
                  </a:cubicBezTo>
                  <a:cubicBezTo>
                    <a:pt x="557885" y="4174113"/>
                    <a:pt x="557865" y="4174107"/>
                    <a:pt x="557844" y="4174100"/>
                  </a:cubicBezTo>
                  <a:close/>
                  <a:moveTo>
                    <a:pt x="6996336" y="3748828"/>
                  </a:moveTo>
                  <a:cubicBezTo>
                    <a:pt x="7044554" y="3727644"/>
                    <a:pt x="7066407" y="3671388"/>
                    <a:pt x="7045253" y="3623172"/>
                  </a:cubicBezTo>
                  <a:cubicBezTo>
                    <a:pt x="7024098" y="3574957"/>
                    <a:pt x="6967875" y="3553048"/>
                    <a:pt x="6919656" y="3574232"/>
                  </a:cubicBezTo>
                  <a:cubicBezTo>
                    <a:pt x="5972433" y="3991121"/>
                    <a:pt x="5246340" y="4790323"/>
                    <a:pt x="4921684" y="5773368"/>
                  </a:cubicBezTo>
                  <a:cubicBezTo>
                    <a:pt x="4904569" y="5823161"/>
                    <a:pt x="4931042" y="5877408"/>
                    <a:pt x="4980810" y="5894524"/>
                  </a:cubicBezTo>
                  <a:cubicBezTo>
                    <a:pt x="5030578" y="5911647"/>
                    <a:pt x="5084800" y="5885162"/>
                    <a:pt x="5101914" y="5835370"/>
                  </a:cubicBezTo>
                  <a:cubicBezTo>
                    <a:pt x="5102175" y="5834601"/>
                    <a:pt x="5102429" y="5833826"/>
                    <a:pt x="5102677" y="5833050"/>
                  </a:cubicBezTo>
                  <a:cubicBezTo>
                    <a:pt x="5410415" y="4901366"/>
                    <a:pt x="6098595" y="4143936"/>
                    <a:pt x="6996336" y="3748828"/>
                  </a:cubicBezTo>
                  <a:close/>
                  <a:moveTo>
                    <a:pt x="6881984" y="5085281"/>
                  </a:moveTo>
                  <a:cubicBezTo>
                    <a:pt x="6913749" y="5127178"/>
                    <a:pt x="6973465" y="5135396"/>
                    <a:pt x="7015394" y="5103649"/>
                  </a:cubicBezTo>
                  <a:cubicBezTo>
                    <a:pt x="7328018" y="4865545"/>
                    <a:pt x="7697564" y="4713512"/>
                    <a:pt x="8087184" y="4662677"/>
                  </a:cubicBezTo>
                  <a:lnTo>
                    <a:pt x="8087184" y="4470349"/>
                  </a:lnTo>
                  <a:cubicBezTo>
                    <a:pt x="7655889" y="4522225"/>
                    <a:pt x="7246321" y="4688393"/>
                    <a:pt x="6900725" y="4951680"/>
                  </a:cubicBezTo>
                  <a:cubicBezTo>
                    <a:pt x="6858669" y="4983370"/>
                    <a:pt x="6850284" y="5043153"/>
                    <a:pt x="6881984" y="5085198"/>
                  </a:cubicBezTo>
                  <a:cubicBezTo>
                    <a:pt x="6881984" y="5085223"/>
                    <a:pt x="6882048" y="5085255"/>
                    <a:pt x="6882048" y="5085281"/>
                  </a:cubicBezTo>
                  <a:close/>
                  <a:moveTo>
                    <a:pt x="7499037" y="2661908"/>
                  </a:moveTo>
                  <a:cubicBezTo>
                    <a:pt x="7508693" y="2713633"/>
                    <a:pt x="7558373" y="2747770"/>
                    <a:pt x="7610085" y="2738179"/>
                  </a:cubicBezTo>
                  <a:cubicBezTo>
                    <a:pt x="7767635" y="2709126"/>
                    <a:pt x="7926711" y="2688972"/>
                    <a:pt x="8086549" y="2677798"/>
                  </a:cubicBezTo>
                  <a:lnTo>
                    <a:pt x="8086549" y="2486804"/>
                  </a:lnTo>
                  <a:cubicBezTo>
                    <a:pt x="7915022" y="2498295"/>
                    <a:pt x="7744257" y="2519689"/>
                    <a:pt x="7575208" y="2550871"/>
                  </a:cubicBezTo>
                  <a:cubicBezTo>
                    <a:pt x="7523559" y="2560577"/>
                    <a:pt x="7489572" y="2610235"/>
                    <a:pt x="7499101" y="2661908"/>
                  </a:cubicBezTo>
                  <a:close/>
                  <a:moveTo>
                    <a:pt x="7131080" y="4015712"/>
                  </a:moveTo>
                  <a:cubicBezTo>
                    <a:pt x="7150520" y="4064646"/>
                    <a:pt x="7205916" y="4088550"/>
                    <a:pt x="7254833" y="4069101"/>
                  </a:cubicBezTo>
                  <a:cubicBezTo>
                    <a:pt x="7254833" y="4069101"/>
                    <a:pt x="7254833" y="4069101"/>
                    <a:pt x="7254833" y="4069101"/>
                  </a:cubicBezTo>
                  <a:cubicBezTo>
                    <a:pt x="7521336" y="3962939"/>
                    <a:pt x="7801560" y="3895064"/>
                    <a:pt x="8087057" y="3867493"/>
                  </a:cubicBezTo>
                  <a:lnTo>
                    <a:pt x="8087057" y="3675799"/>
                  </a:lnTo>
                  <a:cubicBezTo>
                    <a:pt x="7777546" y="3704051"/>
                    <a:pt x="7473689" y="3776832"/>
                    <a:pt x="7184952" y="3891899"/>
                  </a:cubicBezTo>
                  <a:cubicBezTo>
                    <a:pt x="7135971" y="3911157"/>
                    <a:pt x="7111894" y="3966492"/>
                    <a:pt x="7131080" y="4015502"/>
                  </a:cubicBezTo>
                  <a:cubicBezTo>
                    <a:pt x="7131143" y="4015528"/>
                    <a:pt x="7131143" y="4015559"/>
                    <a:pt x="7131143" y="4015585"/>
                  </a:cubicBezTo>
                  <a:close/>
                  <a:moveTo>
                    <a:pt x="6365942" y="4894731"/>
                  </a:moveTo>
                  <a:cubicBezTo>
                    <a:pt x="5843642" y="5416174"/>
                    <a:pt x="5543800" y="6119929"/>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557220" y="3966771"/>
                  </a:moveTo>
                  <a:cubicBezTo>
                    <a:pt x="4259850" y="4352269"/>
                    <a:pt x="4022589" y="4780624"/>
                    <a:pt x="3853515" y="5237250"/>
                  </a:cubicBezTo>
                  <a:cubicBezTo>
                    <a:pt x="3835238" y="5286641"/>
                    <a:pt x="3860433" y="5341505"/>
                    <a:pt x="3909801" y="5359791"/>
                  </a:cubicBezTo>
                  <a:cubicBezTo>
                    <a:pt x="3959169" y="5378077"/>
                    <a:pt x="4014007" y="5352869"/>
                    <a:pt x="4032284" y="5303478"/>
                  </a:cubicBezTo>
                  <a:cubicBezTo>
                    <a:pt x="4669044" y="3583607"/>
                    <a:pt x="6257778" y="2399677"/>
                    <a:pt x="8087184" y="2281763"/>
                  </a:cubicBezTo>
                  <a:lnTo>
                    <a:pt x="8087184" y="2091086"/>
                  </a:lnTo>
                  <a:cubicBezTo>
                    <a:pt x="7191432" y="2144743"/>
                    <a:pt x="6328670" y="2448611"/>
                    <a:pt x="5596865" y="2968198"/>
                  </a:cubicBezTo>
                  <a:cubicBezTo>
                    <a:pt x="5202550" y="3247304"/>
                    <a:pt x="4852133" y="3583791"/>
                    <a:pt x="4557220" y="3966517"/>
                  </a:cubicBezTo>
                  <a:close/>
                  <a:moveTo>
                    <a:pt x="6932489" y="261735"/>
                  </a:moveTo>
                  <a:cubicBezTo>
                    <a:pt x="6468922" y="362681"/>
                    <a:pt x="6017234" y="512059"/>
                    <a:pt x="5584858" y="707410"/>
                  </a:cubicBezTo>
                  <a:cubicBezTo>
                    <a:pt x="5536862" y="729014"/>
                    <a:pt x="5515466" y="785454"/>
                    <a:pt x="5537059" y="833473"/>
                  </a:cubicBezTo>
                  <a:cubicBezTo>
                    <a:pt x="5558659" y="881491"/>
                    <a:pt x="5615073" y="902898"/>
                    <a:pt x="5663062" y="881294"/>
                  </a:cubicBezTo>
                  <a:cubicBezTo>
                    <a:pt x="5663151" y="881256"/>
                    <a:pt x="5663234" y="881218"/>
                    <a:pt x="5663316" y="881180"/>
                  </a:cubicBezTo>
                  <a:cubicBezTo>
                    <a:pt x="6083519" y="691317"/>
                    <a:pt x="6522476" y="546157"/>
                    <a:pt x="6973021" y="448090"/>
                  </a:cubicBezTo>
                  <a:cubicBezTo>
                    <a:pt x="7339644" y="368564"/>
                    <a:pt x="7712366" y="320214"/>
                    <a:pt x="8087184" y="303557"/>
                  </a:cubicBezTo>
                  <a:lnTo>
                    <a:pt x="8087184" y="112881"/>
                  </a:lnTo>
                  <a:cubicBezTo>
                    <a:pt x="7698771" y="129641"/>
                    <a:pt x="7312454" y="179439"/>
                    <a:pt x="6932489" y="261735"/>
                  </a:cubicBezTo>
                  <a:close/>
                  <a:moveTo>
                    <a:pt x="7678505" y="1431218"/>
                  </a:moveTo>
                  <a:cubicBezTo>
                    <a:pt x="7684286" y="1483553"/>
                    <a:pt x="7731361" y="1521288"/>
                    <a:pt x="7783708" y="1515497"/>
                  </a:cubicBezTo>
                  <a:cubicBezTo>
                    <a:pt x="7783708" y="1515497"/>
                    <a:pt x="7783708" y="1515497"/>
                    <a:pt x="7783708" y="1515497"/>
                  </a:cubicBezTo>
                  <a:cubicBezTo>
                    <a:pt x="7883957" y="1504438"/>
                    <a:pt x="7985284" y="1496430"/>
                    <a:pt x="8086866" y="1490582"/>
                  </a:cubicBezTo>
                  <a:lnTo>
                    <a:pt x="8086866" y="1299906"/>
                  </a:lnTo>
                  <a:cubicBezTo>
                    <a:pt x="7978233" y="1305689"/>
                    <a:pt x="7869917" y="1314397"/>
                    <a:pt x="7762871" y="1326283"/>
                  </a:cubicBezTo>
                  <a:cubicBezTo>
                    <a:pt x="7710778" y="1332016"/>
                    <a:pt x="7673105" y="1378750"/>
                    <a:pt x="7678505" y="1430901"/>
                  </a:cubicBezTo>
                  <a:close/>
                  <a:moveTo>
                    <a:pt x="5303173" y="1289991"/>
                  </a:moveTo>
                  <a:cubicBezTo>
                    <a:pt x="4389549" y="1793110"/>
                    <a:pt x="3611369" y="2510187"/>
                    <a:pt x="3035203" y="3379869"/>
                  </a:cubicBezTo>
                  <a:cubicBezTo>
                    <a:pt x="3007435" y="3424596"/>
                    <a:pt x="3021164" y="3483375"/>
                    <a:pt x="3065869" y="3511163"/>
                  </a:cubicBezTo>
                  <a:cubicBezTo>
                    <a:pt x="3108738" y="3537807"/>
                    <a:pt x="3164935" y="3526385"/>
                    <a:pt x="3194025" y="3485123"/>
                  </a:cubicBezTo>
                  <a:cubicBezTo>
                    <a:pt x="3753101" y="2641067"/>
                    <a:pt x="4508272" y="1945117"/>
                    <a:pt x="5394908" y="1456833"/>
                  </a:cubicBezTo>
                  <a:cubicBezTo>
                    <a:pt x="6222818" y="1002126"/>
                    <a:pt x="7143722" y="742952"/>
                    <a:pt x="8087184" y="699147"/>
                  </a:cubicBezTo>
                  <a:lnTo>
                    <a:pt x="8087184" y="508471"/>
                  </a:lnTo>
                  <a:cubicBezTo>
                    <a:pt x="7111767" y="552630"/>
                    <a:pt x="6159410" y="820081"/>
                    <a:pt x="5303490" y="1290245"/>
                  </a:cubicBezTo>
                  <a:close/>
                  <a:moveTo>
                    <a:pt x="6957138" y="1164907"/>
                  </a:moveTo>
                  <a:cubicBezTo>
                    <a:pt x="6968955" y="1216211"/>
                    <a:pt x="7020159" y="1248207"/>
                    <a:pt x="7071426" y="1236366"/>
                  </a:cubicBezTo>
                  <a:cubicBezTo>
                    <a:pt x="7071426" y="1236360"/>
                    <a:pt x="7071490" y="1236353"/>
                    <a:pt x="7071490" y="1236347"/>
                  </a:cubicBezTo>
                  <a:cubicBezTo>
                    <a:pt x="7405269" y="1159485"/>
                    <a:pt x="7745147" y="1112083"/>
                    <a:pt x="8087184" y="1094674"/>
                  </a:cubicBezTo>
                  <a:lnTo>
                    <a:pt x="8087184" y="903998"/>
                  </a:lnTo>
                  <a:cubicBezTo>
                    <a:pt x="7730789" y="921355"/>
                    <a:pt x="7376618" y="970277"/>
                    <a:pt x="7028862" y="1050183"/>
                  </a:cubicBezTo>
                  <a:cubicBezTo>
                    <a:pt x="6977531" y="1061859"/>
                    <a:pt x="6945386" y="1112941"/>
                    <a:pt x="6957075" y="1164284"/>
                  </a:cubicBezTo>
                  <a:cubicBezTo>
                    <a:pt x="6957075" y="1164385"/>
                    <a:pt x="6957138" y="1164487"/>
                    <a:pt x="6957138" y="1164589"/>
                  </a:cubicBezTo>
                  <a:close/>
                  <a:moveTo>
                    <a:pt x="7810517" y="5550150"/>
                  </a:moveTo>
                  <a:cubicBezTo>
                    <a:pt x="7858989" y="5529652"/>
                    <a:pt x="7881733" y="5473708"/>
                    <a:pt x="7861214" y="5425193"/>
                  </a:cubicBezTo>
                  <a:cubicBezTo>
                    <a:pt x="7840693" y="5376679"/>
                    <a:pt x="7784789" y="5353975"/>
                    <a:pt x="7736316" y="5374473"/>
                  </a:cubicBezTo>
                  <a:cubicBezTo>
                    <a:pt x="7136099" y="5627692"/>
                    <a:pt x="6737457" y="6206655"/>
                    <a:pt x="6714968" y="6858000"/>
                  </a:cubicBezTo>
                  <a:lnTo>
                    <a:pt x="6905553" y="6858000"/>
                  </a:lnTo>
                  <a:cubicBezTo>
                    <a:pt x="6927979" y="6283212"/>
                    <a:pt x="7280753" y="5773292"/>
                    <a:pt x="7810517" y="5549832"/>
                  </a:cubicBezTo>
                  <a:close/>
                  <a:moveTo>
                    <a:pt x="6090863" y="6328301"/>
                  </a:moveTo>
                  <a:cubicBezTo>
                    <a:pt x="6039456" y="6317477"/>
                    <a:pt x="5988995" y="6350311"/>
                    <a:pt x="5978037" y="6401711"/>
                  </a:cubicBezTo>
                  <a:cubicBezTo>
                    <a:pt x="5946202" y="6551837"/>
                    <a:pt x="5928338" y="6704569"/>
                    <a:pt x="5924672" y="6858000"/>
                  </a:cubicBezTo>
                  <a:lnTo>
                    <a:pt x="6115258" y="6858000"/>
                  </a:lnTo>
                  <a:cubicBezTo>
                    <a:pt x="6118847" y="6717916"/>
                    <a:pt x="6135282" y="6578469"/>
                    <a:pt x="6164366" y="6441372"/>
                  </a:cubicBezTo>
                  <a:cubicBezTo>
                    <a:pt x="6175293" y="6389889"/>
                    <a:pt x="6142417" y="6339252"/>
                    <a:pt x="6090933" y="6328313"/>
                  </a:cubicBezTo>
                  <a:cubicBezTo>
                    <a:pt x="6090914" y="6328313"/>
                    <a:pt x="6090888" y="6328307"/>
                    <a:pt x="6090863" y="6328301"/>
                  </a:cubicBezTo>
                  <a:close/>
                  <a:moveTo>
                    <a:pt x="5637269" y="5359219"/>
                  </a:moveTo>
                  <a:cubicBezTo>
                    <a:pt x="5590722" y="5334641"/>
                    <a:pt x="5533083" y="5352469"/>
                    <a:pt x="5508516" y="5399039"/>
                  </a:cubicBezTo>
                  <a:cubicBezTo>
                    <a:pt x="5508510" y="5399045"/>
                    <a:pt x="5508503" y="5399058"/>
                    <a:pt x="5508497" y="5399071"/>
                  </a:cubicBezTo>
                  <a:cubicBezTo>
                    <a:pt x="5271929" y="5849588"/>
                    <a:pt x="5143862" y="6349180"/>
                    <a:pt x="5134504" y="6858000"/>
                  </a:cubicBezTo>
                  <a:lnTo>
                    <a:pt x="5325090" y="6858000"/>
                  </a:lnTo>
                  <a:cubicBezTo>
                    <a:pt x="5334410" y="6380165"/>
                    <a:pt x="5454936" y="5911126"/>
                    <a:pt x="5677102" y="5488053"/>
                  </a:cubicBezTo>
                  <a:cubicBezTo>
                    <a:pt x="5701668" y="5441483"/>
                    <a:pt x="5683849" y="5383816"/>
                    <a:pt x="5637301" y="5359238"/>
                  </a:cubicBezTo>
                  <a:cubicBezTo>
                    <a:pt x="5637295" y="5359232"/>
                    <a:pt x="5637282" y="5359225"/>
                    <a:pt x="5637269" y="5359219"/>
                  </a:cubicBezTo>
                  <a:close/>
                  <a:moveTo>
                    <a:pt x="6804289" y="5734216"/>
                  </a:moveTo>
                  <a:cubicBezTo>
                    <a:pt x="6760771" y="5704725"/>
                    <a:pt x="6701563" y="5716108"/>
                    <a:pt x="6672022" y="5759640"/>
                  </a:cubicBezTo>
                  <a:cubicBezTo>
                    <a:pt x="6452404" y="6084724"/>
                    <a:pt x="6330169" y="6465778"/>
                    <a:pt x="6319630" y="6858000"/>
                  </a:cubicBezTo>
                  <a:lnTo>
                    <a:pt x="6510215" y="6858000"/>
                  </a:lnTo>
                  <a:cubicBezTo>
                    <a:pt x="6520761" y="6503851"/>
                    <a:pt x="6631618" y="6160023"/>
                    <a:pt x="6829891" y="5866482"/>
                  </a:cubicBezTo>
                  <a:cubicBezTo>
                    <a:pt x="6859177" y="5822913"/>
                    <a:pt x="6847679" y="5763873"/>
                    <a:pt x="6804289" y="5734407"/>
                  </a:cubicBezTo>
                  <a:close/>
                  <a:moveTo>
                    <a:pt x="4904404" y="6204806"/>
                  </a:moveTo>
                  <a:cubicBezTo>
                    <a:pt x="4852571" y="6195698"/>
                    <a:pt x="4803171" y="6230357"/>
                    <a:pt x="4794068" y="6282220"/>
                  </a:cubicBezTo>
                  <a:cubicBezTo>
                    <a:pt x="4794061" y="6282240"/>
                    <a:pt x="4794061" y="6282265"/>
                    <a:pt x="4794055" y="6282284"/>
                  </a:cubicBezTo>
                  <a:cubicBezTo>
                    <a:pt x="4760766" y="6472452"/>
                    <a:pt x="4742432" y="6664972"/>
                    <a:pt x="4739230" y="6858000"/>
                  </a:cubicBezTo>
                  <a:lnTo>
                    <a:pt x="4929815" y="6858000"/>
                  </a:lnTo>
                  <a:cubicBezTo>
                    <a:pt x="4932922" y="6676031"/>
                    <a:pt x="4950189" y="6494507"/>
                    <a:pt x="4981464" y="6315208"/>
                  </a:cubicBezTo>
                  <a:cubicBezTo>
                    <a:pt x="4990587" y="6263445"/>
                    <a:pt x="4956116" y="6214067"/>
                    <a:pt x="4904404" y="6204806"/>
                  </a:cubicBezTo>
                  <a:close/>
                  <a:moveTo>
                    <a:pt x="7902253" y="6858000"/>
                  </a:moveTo>
                  <a:lnTo>
                    <a:pt x="8087184" y="6858000"/>
                  </a:lnTo>
                  <a:lnTo>
                    <a:pt x="8087184" y="6532261"/>
                  </a:lnTo>
                  <a:cubicBezTo>
                    <a:pt x="7984903" y="6612091"/>
                    <a:pt x="7918389" y="6729230"/>
                    <a:pt x="7902253" y="6858000"/>
                  </a:cubicBezTo>
                  <a:close/>
                  <a:moveTo>
                    <a:pt x="7565551" y="6591561"/>
                  </a:moveTo>
                  <a:cubicBezTo>
                    <a:pt x="7546175" y="6640502"/>
                    <a:pt x="7570062" y="6695925"/>
                    <a:pt x="7619043" y="6715311"/>
                  </a:cubicBezTo>
                  <a:cubicBezTo>
                    <a:pt x="7667959" y="6734760"/>
                    <a:pt x="7723356" y="6710798"/>
                    <a:pt x="7742733" y="6661858"/>
                  </a:cubicBezTo>
                  <a:cubicBezTo>
                    <a:pt x="7807341" y="6499910"/>
                    <a:pt x="7930205" y="6368089"/>
                    <a:pt x="8087184" y="6292326"/>
                  </a:cubicBezTo>
                  <a:lnTo>
                    <a:pt x="8087184" y="6085760"/>
                  </a:lnTo>
                  <a:cubicBezTo>
                    <a:pt x="7849270" y="6172245"/>
                    <a:pt x="7659700" y="6356394"/>
                    <a:pt x="7566250" y="6591752"/>
                  </a:cubicBezTo>
                  <a:close/>
                  <a:moveTo>
                    <a:pt x="7109989" y="6858000"/>
                  </a:moveTo>
                  <a:lnTo>
                    <a:pt x="7300574" y="6858000"/>
                  </a:lnTo>
                  <a:cubicBezTo>
                    <a:pt x="7326176" y="6394974"/>
                    <a:pt x="7641722" y="5998774"/>
                    <a:pt x="8087184" y="5870486"/>
                  </a:cubicBezTo>
                  <a:lnTo>
                    <a:pt x="8087184" y="5673454"/>
                  </a:lnTo>
                  <a:cubicBezTo>
                    <a:pt x="7534740" y="5807487"/>
                    <a:pt x="7136797" y="6289898"/>
                    <a:pt x="7109989" y="6858000"/>
                  </a:cubicBezTo>
                  <a:close/>
                  <a:moveTo>
                    <a:pt x="6578000" y="3403894"/>
                  </a:moveTo>
                  <a:cubicBezTo>
                    <a:pt x="6600998" y="3451093"/>
                    <a:pt x="6657792" y="3470809"/>
                    <a:pt x="6705057" y="3448004"/>
                  </a:cubicBezTo>
                  <a:cubicBezTo>
                    <a:pt x="7047794" y="3281442"/>
                    <a:pt x="7413527" y="3167030"/>
                    <a:pt x="7790061" y="3108536"/>
                  </a:cubicBezTo>
                  <a:cubicBezTo>
                    <a:pt x="7841964" y="3099632"/>
                    <a:pt x="7876778" y="3050348"/>
                    <a:pt x="7867884" y="2998453"/>
                  </a:cubicBezTo>
                  <a:cubicBezTo>
                    <a:pt x="7859180" y="2947694"/>
                    <a:pt x="7811725" y="2913029"/>
                    <a:pt x="7760775" y="2920148"/>
                  </a:cubicBezTo>
                  <a:cubicBezTo>
                    <a:pt x="7365500" y="2981527"/>
                    <a:pt x="6981597" y="3101621"/>
                    <a:pt x="6621771" y="3276459"/>
                  </a:cubicBezTo>
                  <a:cubicBezTo>
                    <a:pt x="6574506" y="3299582"/>
                    <a:pt x="6554940" y="3356607"/>
                    <a:pt x="6578000" y="3403894"/>
                  </a:cubicBezTo>
                  <a:close/>
                </a:path>
              </a:pathLst>
            </a:custGeom>
            <a:solidFill>
              <a:srgbClr val="FFFFFF">
                <a:alpha val="503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81" name="Google Shape;81;p11"/>
            <p:cNvSpPr/>
            <p:nvPr/>
          </p:nvSpPr>
          <p:spPr>
            <a:xfrm>
              <a:off x="2377837" y="210583"/>
              <a:ext cx="5576288" cy="4831090"/>
            </a:xfrm>
            <a:custGeom>
              <a:avLst/>
              <a:gdLst/>
              <a:ahLst/>
              <a:cxnLst/>
              <a:rect l="l" t="t" r="r" b="b"/>
              <a:pathLst>
                <a:path w="7435051" h="6441453" extrusionOk="0">
                  <a:moveTo>
                    <a:pt x="2213120" y="5039472"/>
                  </a:moveTo>
                  <a:cubicBezTo>
                    <a:pt x="2095083" y="5051103"/>
                    <a:pt x="2103850" y="5229704"/>
                    <a:pt x="2222458" y="5229704"/>
                  </a:cubicBezTo>
                  <a:cubicBezTo>
                    <a:pt x="2353073" y="5228178"/>
                    <a:pt x="2343290" y="5028222"/>
                    <a:pt x="2213120" y="5039472"/>
                  </a:cubicBezTo>
                  <a:close/>
                  <a:moveTo>
                    <a:pt x="1816257" y="949650"/>
                  </a:moveTo>
                  <a:cubicBezTo>
                    <a:pt x="1698221" y="961282"/>
                    <a:pt x="1706988" y="1139882"/>
                    <a:pt x="1825595" y="1139882"/>
                  </a:cubicBezTo>
                  <a:cubicBezTo>
                    <a:pt x="1956274" y="1138420"/>
                    <a:pt x="1946427" y="938337"/>
                    <a:pt x="1816257" y="949650"/>
                  </a:cubicBezTo>
                  <a:close/>
                  <a:moveTo>
                    <a:pt x="1657435" y="6147620"/>
                  </a:moveTo>
                  <a:cubicBezTo>
                    <a:pt x="1527329" y="6136180"/>
                    <a:pt x="1517673" y="6336390"/>
                    <a:pt x="1648097" y="6337788"/>
                  </a:cubicBezTo>
                  <a:cubicBezTo>
                    <a:pt x="1766514" y="6337916"/>
                    <a:pt x="1775281" y="6159125"/>
                    <a:pt x="1657181" y="6147620"/>
                  </a:cubicBezTo>
                  <a:close/>
                  <a:moveTo>
                    <a:pt x="1777377" y="3926811"/>
                  </a:moveTo>
                  <a:cubicBezTo>
                    <a:pt x="1647271" y="3915307"/>
                    <a:pt x="1637614" y="4115517"/>
                    <a:pt x="1767975" y="4116979"/>
                  </a:cubicBezTo>
                  <a:cubicBezTo>
                    <a:pt x="1886583" y="4117487"/>
                    <a:pt x="1895477" y="3938442"/>
                    <a:pt x="1777377" y="3926811"/>
                  </a:cubicBezTo>
                  <a:close/>
                  <a:moveTo>
                    <a:pt x="2671541" y="3056499"/>
                  </a:moveTo>
                  <a:cubicBezTo>
                    <a:pt x="2553506" y="3068131"/>
                    <a:pt x="2562336" y="3246731"/>
                    <a:pt x="2680944" y="3246731"/>
                  </a:cubicBezTo>
                  <a:cubicBezTo>
                    <a:pt x="2811558" y="3245206"/>
                    <a:pt x="2801712" y="3045186"/>
                    <a:pt x="2671541" y="3056499"/>
                  </a:cubicBezTo>
                  <a:close/>
                  <a:moveTo>
                    <a:pt x="3043247" y="3211646"/>
                  </a:moveTo>
                  <a:cubicBezTo>
                    <a:pt x="2925148" y="3223278"/>
                    <a:pt x="2933978" y="3401878"/>
                    <a:pt x="3052649" y="3401878"/>
                  </a:cubicBezTo>
                  <a:cubicBezTo>
                    <a:pt x="3183264" y="3400289"/>
                    <a:pt x="3173354" y="3200333"/>
                    <a:pt x="3043247" y="3211646"/>
                  </a:cubicBezTo>
                  <a:close/>
                  <a:moveTo>
                    <a:pt x="3483564" y="1201216"/>
                  </a:moveTo>
                  <a:cubicBezTo>
                    <a:pt x="3602171" y="1201216"/>
                    <a:pt x="3611002" y="1022616"/>
                    <a:pt x="3492902" y="1010985"/>
                  </a:cubicBezTo>
                  <a:cubicBezTo>
                    <a:pt x="3362796" y="999608"/>
                    <a:pt x="3352949" y="1199627"/>
                    <a:pt x="3483564" y="1201216"/>
                  </a:cubicBezTo>
                  <a:close/>
                  <a:moveTo>
                    <a:pt x="3518314" y="4894812"/>
                  </a:moveTo>
                  <a:cubicBezTo>
                    <a:pt x="3388207" y="4883499"/>
                    <a:pt x="3378551" y="5083518"/>
                    <a:pt x="3508975" y="5085044"/>
                  </a:cubicBezTo>
                  <a:cubicBezTo>
                    <a:pt x="3627646" y="5085044"/>
                    <a:pt x="3636413" y="4906507"/>
                    <a:pt x="3518314" y="4894812"/>
                  </a:cubicBezTo>
                  <a:close/>
                  <a:moveTo>
                    <a:pt x="2488770" y="5643408"/>
                  </a:moveTo>
                  <a:cubicBezTo>
                    <a:pt x="2370670" y="5655039"/>
                    <a:pt x="2379501" y="5833576"/>
                    <a:pt x="2498109" y="5833640"/>
                  </a:cubicBezTo>
                  <a:cubicBezTo>
                    <a:pt x="2628723" y="5832115"/>
                    <a:pt x="2619003" y="5632095"/>
                    <a:pt x="2488770" y="5643408"/>
                  </a:cubicBezTo>
                  <a:close/>
                  <a:moveTo>
                    <a:pt x="1258984" y="4171957"/>
                  </a:moveTo>
                  <a:cubicBezTo>
                    <a:pt x="1128878" y="4160580"/>
                    <a:pt x="1118904" y="4360664"/>
                    <a:pt x="1249582" y="4362189"/>
                  </a:cubicBezTo>
                  <a:cubicBezTo>
                    <a:pt x="1368253" y="4362253"/>
                    <a:pt x="1377084" y="4183652"/>
                    <a:pt x="1258984" y="4171957"/>
                  </a:cubicBezTo>
                  <a:close/>
                  <a:moveTo>
                    <a:pt x="4268713" y="190694"/>
                  </a:moveTo>
                  <a:cubicBezTo>
                    <a:pt x="4399327" y="189105"/>
                    <a:pt x="4389417" y="-10851"/>
                    <a:pt x="4259311" y="463"/>
                  </a:cubicBezTo>
                  <a:cubicBezTo>
                    <a:pt x="4141211" y="12157"/>
                    <a:pt x="4150041" y="190758"/>
                    <a:pt x="4268713" y="190694"/>
                  </a:cubicBezTo>
                  <a:close/>
                  <a:moveTo>
                    <a:pt x="6303786" y="2710803"/>
                  </a:moveTo>
                  <a:cubicBezTo>
                    <a:pt x="6422394" y="2710803"/>
                    <a:pt x="6431225" y="2532266"/>
                    <a:pt x="6313189" y="2520571"/>
                  </a:cubicBezTo>
                  <a:cubicBezTo>
                    <a:pt x="6183082" y="2509448"/>
                    <a:pt x="6173045" y="2709341"/>
                    <a:pt x="6303786" y="2710803"/>
                  </a:cubicBezTo>
                  <a:close/>
                  <a:moveTo>
                    <a:pt x="2820516" y="724970"/>
                  </a:moveTo>
                  <a:cubicBezTo>
                    <a:pt x="2951131" y="723445"/>
                    <a:pt x="2941220" y="523425"/>
                    <a:pt x="2811177" y="534738"/>
                  </a:cubicBezTo>
                  <a:cubicBezTo>
                    <a:pt x="2693141" y="546370"/>
                    <a:pt x="2701908" y="724906"/>
                    <a:pt x="2820516" y="724970"/>
                  </a:cubicBezTo>
                  <a:close/>
                  <a:moveTo>
                    <a:pt x="7332377" y="2638663"/>
                  </a:moveTo>
                  <a:cubicBezTo>
                    <a:pt x="7214341" y="2650358"/>
                    <a:pt x="7223172" y="2828959"/>
                    <a:pt x="7341779" y="2828895"/>
                  </a:cubicBezTo>
                  <a:cubicBezTo>
                    <a:pt x="7472394" y="2827243"/>
                    <a:pt x="7462674" y="2627414"/>
                    <a:pt x="7332377" y="2638663"/>
                  </a:cubicBezTo>
                  <a:close/>
                  <a:moveTo>
                    <a:pt x="7339301" y="1234966"/>
                  </a:moveTo>
                  <a:cubicBezTo>
                    <a:pt x="7469916" y="1233504"/>
                    <a:pt x="7460006" y="1033421"/>
                    <a:pt x="7329899" y="1044798"/>
                  </a:cubicBezTo>
                  <a:cubicBezTo>
                    <a:pt x="7211864" y="1056302"/>
                    <a:pt x="7220694" y="1235157"/>
                    <a:pt x="7339301" y="1234966"/>
                  </a:cubicBezTo>
                  <a:close/>
                  <a:moveTo>
                    <a:pt x="84087" y="3888675"/>
                  </a:moveTo>
                  <a:cubicBezTo>
                    <a:pt x="-33695" y="3900434"/>
                    <a:pt x="-25118" y="4079352"/>
                    <a:pt x="93362" y="4079352"/>
                  </a:cubicBezTo>
                  <a:cubicBezTo>
                    <a:pt x="224104" y="4077445"/>
                    <a:pt x="214067" y="3877425"/>
                    <a:pt x="84087" y="3888675"/>
                  </a:cubicBezTo>
                  <a:close/>
                  <a:moveTo>
                    <a:pt x="488955" y="5693238"/>
                  </a:moveTo>
                  <a:cubicBezTo>
                    <a:pt x="370919" y="5704679"/>
                    <a:pt x="379686" y="5883470"/>
                    <a:pt x="498293" y="5883407"/>
                  </a:cubicBezTo>
                  <a:cubicBezTo>
                    <a:pt x="628908" y="5882135"/>
                    <a:pt x="619125" y="5681925"/>
                    <a:pt x="488955" y="5693366"/>
                  </a:cubicBezTo>
                  <a:close/>
                  <a:moveTo>
                    <a:pt x="722295" y="4567103"/>
                  </a:moveTo>
                  <a:cubicBezTo>
                    <a:pt x="592125" y="4555789"/>
                    <a:pt x="582532" y="4755682"/>
                    <a:pt x="712893" y="4757334"/>
                  </a:cubicBezTo>
                  <a:cubicBezTo>
                    <a:pt x="831501" y="4757334"/>
                    <a:pt x="840458" y="4578734"/>
                    <a:pt x="722295" y="4567103"/>
                  </a:cubicBezTo>
                  <a:close/>
                  <a:moveTo>
                    <a:pt x="1760606" y="2491334"/>
                  </a:moveTo>
                  <a:cubicBezTo>
                    <a:pt x="1891220" y="2489745"/>
                    <a:pt x="1881310" y="2289725"/>
                    <a:pt x="1751203" y="2301102"/>
                  </a:cubicBezTo>
                  <a:cubicBezTo>
                    <a:pt x="1633104" y="2312734"/>
                    <a:pt x="1641998" y="2491334"/>
                    <a:pt x="1760606" y="2491334"/>
                  </a:cubicBezTo>
                  <a:close/>
                  <a:moveTo>
                    <a:pt x="744657" y="3328976"/>
                  </a:moveTo>
                  <a:cubicBezTo>
                    <a:pt x="614551" y="3317536"/>
                    <a:pt x="604894" y="3517682"/>
                    <a:pt x="735255" y="3519144"/>
                  </a:cubicBezTo>
                  <a:cubicBezTo>
                    <a:pt x="853926" y="3519335"/>
                    <a:pt x="862820" y="3340544"/>
                    <a:pt x="744657" y="3328976"/>
                  </a:cubicBezTo>
                  <a:close/>
                  <a:moveTo>
                    <a:pt x="4587626" y="5427499"/>
                  </a:moveTo>
                  <a:cubicBezTo>
                    <a:pt x="4457774" y="5416058"/>
                    <a:pt x="4447546" y="5616269"/>
                    <a:pt x="4578478" y="5617476"/>
                  </a:cubicBezTo>
                  <a:cubicBezTo>
                    <a:pt x="4696832" y="5617858"/>
                    <a:pt x="4705535" y="5439067"/>
                    <a:pt x="4587626" y="5427499"/>
                  </a:cubicBezTo>
                  <a:close/>
                  <a:moveTo>
                    <a:pt x="6524040" y="3476242"/>
                  </a:moveTo>
                  <a:cubicBezTo>
                    <a:pt x="6654718" y="3474844"/>
                    <a:pt x="6644744" y="3274633"/>
                    <a:pt x="6514638" y="3286074"/>
                  </a:cubicBezTo>
                  <a:cubicBezTo>
                    <a:pt x="6396601" y="3297578"/>
                    <a:pt x="6405432" y="3476242"/>
                    <a:pt x="6524040" y="3476051"/>
                  </a:cubicBezTo>
                  <a:close/>
                  <a:moveTo>
                    <a:pt x="6533125" y="1608057"/>
                  </a:moveTo>
                  <a:cubicBezTo>
                    <a:pt x="6403018" y="1596616"/>
                    <a:pt x="6393362" y="1796826"/>
                    <a:pt x="6523785" y="1798225"/>
                  </a:cubicBezTo>
                  <a:cubicBezTo>
                    <a:pt x="6642394" y="1798161"/>
                    <a:pt x="6651224" y="1619624"/>
                    <a:pt x="6533125" y="1607866"/>
                  </a:cubicBezTo>
                  <a:close/>
                  <a:moveTo>
                    <a:pt x="6625368" y="767682"/>
                  </a:moveTo>
                  <a:cubicBezTo>
                    <a:pt x="6495261" y="756304"/>
                    <a:pt x="6485605" y="956324"/>
                    <a:pt x="6616029" y="957913"/>
                  </a:cubicBezTo>
                  <a:cubicBezTo>
                    <a:pt x="6734701" y="957722"/>
                    <a:pt x="6743531" y="779122"/>
                    <a:pt x="6625368" y="767491"/>
                  </a:cubicBezTo>
                  <a:close/>
                  <a:moveTo>
                    <a:pt x="6239178" y="2986775"/>
                  </a:moveTo>
                  <a:cubicBezTo>
                    <a:pt x="6109072" y="2975398"/>
                    <a:pt x="6099097" y="3175418"/>
                    <a:pt x="6229776" y="3177007"/>
                  </a:cubicBezTo>
                  <a:cubicBezTo>
                    <a:pt x="6348383" y="3176816"/>
                    <a:pt x="6357277" y="2998279"/>
                    <a:pt x="6239178" y="2986585"/>
                  </a:cubicBezTo>
                  <a:close/>
                  <a:moveTo>
                    <a:pt x="6514638" y="4652017"/>
                  </a:moveTo>
                  <a:cubicBezTo>
                    <a:pt x="6396538" y="4663649"/>
                    <a:pt x="6405432" y="4842249"/>
                    <a:pt x="6524040" y="4842249"/>
                  </a:cubicBezTo>
                  <a:cubicBezTo>
                    <a:pt x="6654718" y="4840660"/>
                    <a:pt x="6644808" y="4640640"/>
                    <a:pt x="6514638" y="4652017"/>
                  </a:cubicBezTo>
                  <a:close/>
                  <a:moveTo>
                    <a:pt x="6326403" y="5437732"/>
                  </a:moveTo>
                  <a:cubicBezTo>
                    <a:pt x="6196296" y="5426355"/>
                    <a:pt x="6186640" y="5626375"/>
                    <a:pt x="6317001" y="5627964"/>
                  </a:cubicBezTo>
                  <a:cubicBezTo>
                    <a:pt x="6435671" y="5628027"/>
                    <a:pt x="6444502" y="5449363"/>
                    <a:pt x="6326403" y="5437732"/>
                  </a:cubicBezTo>
                  <a:close/>
                  <a:moveTo>
                    <a:pt x="7229651" y="6251285"/>
                  </a:moveTo>
                  <a:cubicBezTo>
                    <a:pt x="7099545" y="6239781"/>
                    <a:pt x="7089888" y="6440055"/>
                    <a:pt x="7220249" y="6441453"/>
                  </a:cubicBezTo>
                  <a:cubicBezTo>
                    <a:pt x="7338857" y="6441453"/>
                    <a:pt x="7347751" y="6262662"/>
                    <a:pt x="7229651" y="6251094"/>
                  </a:cubicBezTo>
                  <a:close/>
                  <a:moveTo>
                    <a:pt x="6776566" y="3604694"/>
                  </a:moveTo>
                  <a:cubicBezTo>
                    <a:pt x="6658530" y="3616389"/>
                    <a:pt x="6667297" y="3794926"/>
                    <a:pt x="6785968" y="3794926"/>
                  </a:cubicBezTo>
                  <a:cubicBezTo>
                    <a:pt x="6916329" y="3793337"/>
                    <a:pt x="6906481" y="3593381"/>
                    <a:pt x="6776566" y="3604694"/>
                  </a:cubicBezTo>
                  <a:close/>
                  <a:moveTo>
                    <a:pt x="7330281" y="5086315"/>
                  </a:moveTo>
                  <a:cubicBezTo>
                    <a:pt x="7212244" y="5097946"/>
                    <a:pt x="7221075" y="5276610"/>
                    <a:pt x="7339683" y="5276546"/>
                  </a:cubicBezTo>
                  <a:cubicBezTo>
                    <a:pt x="7470107" y="5275021"/>
                    <a:pt x="7460324" y="5074938"/>
                    <a:pt x="7330090" y="5086315"/>
                  </a:cubicBezTo>
                  <a:close/>
                  <a:moveTo>
                    <a:pt x="7149732" y="2268942"/>
                  </a:moveTo>
                  <a:cubicBezTo>
                    <a:pt x="7031697" y="2280573"/>
                    <a:pt x="7040464" y="2459173"/>
                    <a:pt x="7159071" y="2459173"/>
                  </a:cubicBezTo>
                  <a:cubicBezTo>
                    <a:pt x="7289495" y="2457711"/>
                    <a:pt x="7279775" y="2257628"/>
                    <a:pt x="7149542" y="2268942"/>
                  </a:cubicBezTo>
                  <a:close/>
                  <a:moveTo>
                    <a:pt x="4803179" y="4171957"/>
                  </a:moveTo>
                  <a:cubicBezTo>
                    <a:pt x="4673072" y="4160580"/>
                    <a:pt x="4663416" y="4360600"/>
                    <a:pt x="4793840" y="4362189"/>
                  </a:cubicBezTo>
                  <a:cubicBezTo>
                    <a:pt x="4912511" y="4362189"/>
                    <a:pt x="4921532" y="4183589"/>
                    <a:pt x="4803179" y="4171957"/>
                  </a:cubicBezTo>
                  <a:close/>
                  <a:moveTo>
                    <a:pt x="4264139" y="1897059"/>
                  </a:moveTo>
                  <a:cubicBezTo>
                    <a:pt x="4146039" y="1908626"/>
                    <a:pt x="4154870" y="2087227"/>
                    <a:pt x="4273477" y="2087290"/>
                  </a:cubicBezTo>
                  <a:cubicBezTo>
                    <a:pt x="4404092" y="2085765"/>
                    <a:pt x="4394245" y="1885682"/>
                    <a:pt x="4264139" y="1897059"/>
                  </a:cubicBezTo>
                  <a:close/>
                  <a:moveTo>
                    <a:pt x="4141592" y="4439731"/>
                  </a:moveTo>
                  <a:cubicBezTo>
                    <a:pt x="4023556" y="4451362"/>
                    <a:pt x="4032386" y="4629962"/>
                    <a:pt x="4150995" y="4629962"/>
                  </a:cubicBezTo>
                  <a:cubicBezTo>
                    <a:pt x="4281609" y="4628373"/>
                    <a:pt x="4271826" y="4428417"/>
                    <a:pt x="4141592" y="4439731"/>
                  </a:cubicBezTo>
                  <a:close/>
                  <a:moveTo>
                    <a:pt x="4444560" y="5923067"/>
                  </a:moveTo>
                  <a:cubicBezTo>
                    <a:pt x="4326460" y="5934698"/>
                    <a:pt x="4335354" y="6113363"/>
                    <a:pt x="4453962" y="6113299"/>
                  </a:cubicBezTo>
                  <a:cubicBezTo>
                    <a:pt x="4584831" y="6111774"/>
                    <a:pt x="4574730" y="5911754"/>
                    <a:pt x="4444560" y="5923067"/>
                  </a:cubicBezTo>
                  <a:close/>
                  <a:moveTo>
                    <a:pt x="4149660" y="722555"/>
                  </a:moveTo>
                  <a:cubicBezTo>
                    <a:pt x="4280339" y="721029"/>
                    <a:pt x="4270365" y="521010"/>
                    <a:pt x="4140322" y="532323"/>
                  </a:cubicBezTo>
                  <a:cubicBezTo>
                    <a:pt x="4022222" y="543954"/>
                    <a:pt x="4031053" y="722491"/>
                    <a:pt x="4149660" y="722555"/>
                  </a:cubicBezTo>
                  <a:close/>
                  <a:moveTo>
                    <a:pt x="5149473" y="5067883"/>
                  </a:moveTo>
                  <a:cubicBezTo>
                    <a:pt x="5031437" y="5079514"/>
                    <a:pt x="5040267" y="5258178"/>
                    <a:pt x="5158875" y="5258115"/>
                  </a:cubicBezTo>
                  <a:cubicBezTo>
                    <a:pt x="5289489" y="5256589"/>
                    <a:pt x="5279643" y="5056569"/>
                    <a:pt x="5149473" y="5067883"/>
                  </a:cubicBezTo>
                  <a:close/>
                  <a:moveTo>
                    <a:pt x="5180729" y="418362"/>
                  </a:moveTo>
                  <a:cubicBezTo>
                    <a:pt x="5062692" y="430057"/>
                    <a:pt x="5071523" y="608657"/>
                    <a:pt x="5190131" y="608594"/>
                  </a:cubicBezTo>
                  <a:cubicBezTo>
                    <a:pt x="5320746" y="607259"/>
                    <a:pt x="5310962" y="407303"/>
                    <a:pt x="5180729" y="418362"/>
                  </a:cubicBezTo>
                  <a:close/>
                  <a:moveTo>
                    <a:pt x="3703309" y="5642900"/>
                  </a:moveTo>
                  <a:cubicBezTo>
                    <a:pt x="3578793" y="5643599"/>
                    <a:pt x="3578793" y="5832877"/>
                    <a:pt x="3703309" y="5833576"/>
                  </a:cubicBezTo>
                  <a:cubicBezTo>
                    <a:pt x="3827825" y="5832941"/>
                    <a:pt x="3827888" y="5643662"/>
                    <a:pt x="3703309" y="5642900"/>
                  </a:cubicBezTo>
                  <a:close/>
                  <a:moveTo>
                    <a:pt x="5646456" y="6045926"/>
                  </a:moveTo>
                  <a:cubicBezTo>
                    <a:pt x="5516350" y="6034422"/>
                    <a:pt x="5506694" y="6234696"/>
                    <a:pt x="5637118" y="6236094"/>
                  </a:cubicBezTo>
                  <a:cubicBezTo>
                    <a:pt x="5755726" y="6236222"/>
                    <a:pt x="5764556" y="6057430"/>
                    <a:pt x="5646456" y="6045926"/>
                  </a:cubicBezTo>
                  <a:close/>
                  <a:moveTo>
                    <a:pt x="5906225" y="1406067"/>
                  </a:moveTo>
                  <a:cubicBezTo>
                    <a:pt x="5776118" y="1394689"/>
                    <a:pt x="5766462" y="1594773"/>
                    <a:pt x="5896886" y="1596298"/>
                  </a:cubicBezTo>
                  <a:cubicBezTo>
                    <a:pt x="6015494" y="1596298"/>
                    <a:pt x="6024324" y="1417698"/>
                    <a:pt x="5906225" y="1406067"/>
                  </a:cubicBezTo>
                  <a:close/>
                </a:path>
              </a:pathLst>
            </a:custGeom>
            <a:solidFill>
              <a:srgbClr val="FFFFFF">
                <a:alpha val="503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82" name="Google Shape;82;p11"/>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solidFill>
                  <a:schemeClr val="lt1"/>
                </a:solidFill>
              </a:defRPr>
            </a:lvl1pPr>
            <a:lvl2pPr lvl="1" rtl="0">
              <a:buNone/>
              <a:defRPr>
                <a:solidFill>
                  <a:schemeClr val="lt1"/>
                </a:solidFill>
              </a:defRPr>
            </a:lvl2pPr>
            <a:lvl3pPr lvl="2" rtl="0">
              <a:buNone/>
              <a:defRPr>
                <a:solidFill>
                  <a:schemeClr val="lt1"/>
                </a:solidFill>
              </a:defRPr>
            </a:lvl3pPr>
            <a:lvl4pPr lvl="3" rtl="0">
              <a:buNone/>
              <a:defRPr>
                <a:solidFill>
                  <a:schemeClr val="lt1"/>
                </a:solidFill>
              </a:defRPr>
            </a:lvl4pPr>
            <a:lvl5pPr lvl="4" rtl="0">
              <a:buNone/>
              <a:defRPr>
                <a:solidFill>
                  <a:schemeClr val="lt1"/>
                </a:solidFill>
              </a:defRPr>
            </a:lvl5pPr>
            <a:lvl6pPr lvl="5" rtl="0">
              <a:buNone/>
              <a:defRPr>
                <a:solidFill>
                  <a:schemeClr val="lt1"/>
                </a:solidFill>
              </a:defRPr>
            </a:lvl6pPr>
            <a:lvl7pPr lvl="6" rtl="0">
              <a:buNone/>
              <a:defRPr>
                <a:solidFill>
                  <a:schemeClr val="lt1"/>
                </a:solidFill>
              </a:defRPr>
            </a:lvl7pPr>
            <a:lvl8pPr lvl="7" rtl="0">
              <a:buNone/>
              <a:defRPr>
                <a:solidFill>
                  <a:schemeClr val="lt1"/>
                </a:solidFill>
              </a:defRPr>
            </a:lvl8pPr>
            <a:lvl9pPr lvl="8" rtl="0">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ubtitle">
  <p:cSld name="TITLE_1">
    <p:bg>
      <p:bgPr>
        <a:gradFill>
          <a:gsLst>
            <a:gs pos="0">
              <a:schemeClr val="accent1"/>
            </a:gs>
            <a:gs pos="100000">
              <a:srgbClr val="D1F6FF"/>
            </a:gs>
          </a:gsLst>
          <a:path path="circle">
            <a:fillToRect l="100000" t="100000"/>
          </a:path>
          <a:tileRect r="-100000" b="-100000"/>
        </a:gradFill>
        <a:effectLst/>
      </p:bgPr>
    </p:bg>
    <p:spTree>
      <p:nvGrpSpPr>
        <p:cNvPr id="1" name="Shape 15"/>
        <p:cNvGrpSpPr/>
        <p:nvPr/>
      </p:nvGrpSpPr>
      <p:grpSpPr>
        <a:xfrm>
          <a:off x="0" y="0"/>
          <a:ext cx="0" cy="0"/>
          <a:chOff x="0" y="0"/>
          <a:chExt cx="0" cy="0"/>
        </a:xfrm>
      </p:grpSpPr>
      <p:grpSp>
        <p:nvGrpSpPr>
          <p:cNvPr id="16" name="Google Shape;16;p3"/>
          <p:cNvGrpSpPr/>
          <p:nvPr/>
        </p:nvGrpSpPr>
        <p:grpSpPr>
          <a:xfrm>
            <a:off x="3078602" y="0"/>
            <a:ext cx="6065389" cy="5143642"/>
            <a:chOff x="2052402" y="0"/>
            <a:chExt cx="6065389" cy="5143642"/>
          </a:xfrm>
        </p:grpSpPr>
        <p:sp>
          <p:nvSpPr>
            <p:cNvPr id="17" name="Google Shape;17;p3"/>
            <p:cNvSpPr/>
            <p:nvPr/>
          </p:nvSpPr>
          <p:spPr>
            <a:xfrm>
              <a:off x="2052402" y="0"/>
              <a:ext cx="6065388" cy="5143500"/>
            </a:xfrm>
            <a:custGeom>
              <a:avLst/>
              <a:gdLst/>
              <a:ahLst/>
              <a:cxnLst/>
              <a:rect l="l" t="t" r="r" b="b"/>
              <a:pathLst>
                <a:path w="8087184" h="6858000" extrusionOk="0">
                  <a:moveTo>
                    <a:pt x="7505580" y="6858000"/>
                  </a:moveTo>
                  <a:lnTo>
                    <a:pt x="7696738" y="6858000"/>
                  </a:lnTo>
                  <a:cubicBezTo>
                    <a:pt x="7718274" y="6613807"/>
                    <a:pt x="7866550" y="6398978"/>
                    <a:pt x="8087184" y="6292327"/>
                  </a:cubicBezTo>
                  <a:lnTo>
                    <a:pt x="8087184" y="6085824"/>
                  </a:lnTo>
                  <a:cubicBezTo>
                    <a:pt x="7757916" y="6205690"/>
                    <a:pt x="7529976" y="6508299"/>
                    <a:pt x="7505580" y="6858000"/>
                  </a:cubicBezTo>
                  <a:close/>
                  <a:moveTo>
                    <a:pt x="7109988" y="6858000"/>
                  </a:moveTo>
                  <a:lnTo>
                    <a:pt x="7300574" y="6858000"/>
                  </a:lnTo>
                  <a:cubicBezTo>
                    <a:pt x="7326176" y="6394974"/>
                    <a:pt x="7641722" y="5998774"/>
                    <a:pt x="8087184" y="5870486"/>
                  </a:cubicBezTo>
                  <a:lnTo>
                    <a:pt x="8087184" y="5673454"/>
                  </a:lnTo>
                  <a:cubicBezTo>
                    <a:pt x="7534740" y="5807487"/>
                    <a:pt x="7136797" y="6289898"/>
                    <a:pt x="7109988" y="6858000"/>
                  </a:cubicBezTo>
                  <a:close/>
                  <a:moveTo>
                    <a:pt x="6319630" y="6858000"/>
                  </a:moveTo>
                  <a:lnTo>
                    <a:pt x="6510215" y="6858000"/>
                  </a:lnTo>
                  <a:cubicBezTo>
                    <a:pt x="6538485" y="5958928"/>
                    <a:pt x="7199691" y="5205998"/>
                    <a:pt x="8087184" y="5062145"/>
                  </a:cubicBezTo>
                  <a:lnTo>
                    <a:pt x="8087184" y="4869180"/>
                  </a:lnTo>
                  <a:cubicBezTo>
                    <a:pt x="7093725" y="5015188"/>
                    <a:pt x="6348402" y="5853783"/>
                    <a:pt x="6319630" y="6858000"/>
                  </a:cubicBezTo>
                  <a:close/>
                  <a:moveTo>
                    <a:pt x="6714777" y="6858000"/>
                  </a:moveTo>
                  <a:lnTo>
                    <a:pt x="6905363" y="6858000"/>
                  </a:lnTo>
                  <a:cubicBezTo>
                    <a:pt x="6932680" y="6177012"/>
                    <a:pt x="7419944" y="5602103"/>
                    <a:pt x="8086993" y="5463773"/>
                  </a:cubicBezTo>
                  <a:lnTo>
                    <a:pt x="8086993" y="5269538"/>
                  </a:lnTo>
                  <a:cubicBezTo>
                    <a:pt x="7313661" y="5411166"/>
                    <a:pt x="6742920" y="6071943"/>
                    <a:pt x="6714968" y="6858000"/>
                  </a:cubicBezTo>
                  <a:close/>
                  <a:moveTo>
                    <a:pt x="7902253" y="6858000"/>
                  </a:moveTo>
                  <a:lnTo>
                    <a:pt x="8087184" y="6858000"/>
                  </a:lnTo>
                  <a:lnTo>
                    <a:pt x="8087184" y="6532261"/>
                  </a:lnTo>
                  <a:cubicBezTo>
                    <a:pt x="7984903" y="6612091"/>
                    <a:pt x="7918389" y="6729230"/>
                    <a:pt x="7902253" y="6858000"/>
                  </a:cubicBezTo>
                  <a:close/>
                  <a:moveTo>
                    <a:pt x="1916910" y="2551824"/>
                  </a:moveTo>
                  <a:cubicBezTo>
                    <a:pt x="2641015" y="1478290"/>
                    <a:pt x="3620238" y="601442"/>
                    <a:pt x="4766674" y="0"/>
                  </a:cubicBezTo>
                  <a:lnTo>
                    <a:pt x="4372797" y="0"/>
                  </a:lnTo>
                  <a:cubicBezTo>
                    <a:pt x="4217787" y="90127"/>
                    <a:pt x="4065999" y="185317"/>
                    <a:pt x="3917425" y="285570"/>
                  </a:cubicBezTo>
                  <a:cubicBezTo>
                    <a:pt x="2632356" y="1153193"/>
                    <a:pt x="1626642" y="2375366"/>
                    <a:pt x="1022365" y="3803743"/>
                  </a:cubicBezTo>
                  <a:cubicBezTo>
                    <a:pt x="613622" y="4771490"/>
                    <a:pt x="402707" y="5798792"/>
                    <a:pt x="395021" y="6858000"/>
                  </a:cubicBezTo>
                  <a:lnTo>
                    <a:pt x="585606" y="6858000"/>
                  </a:lnTo>
                  <a:cubicBezTo>
                    <a:pt x="593293" y="5824406"/>
                    <a:pt x="799126" y="4822147"/>
                    <a:pt x="1197894" y="3877980"/>
                  </a:cubicBezTo>
                  <a:cubicBezTo>
                    <a:pt x="1394236" y="3413753"/>
                    <a:pt x="1635028" y="2969629"/>
                    <a:pt x="1916910" y="2551824"/>
                  </a:cubicBezTo>
                  <a:close/>
                  <a:moveTo>
                    <a:pt x="1589421" y="2330830"/>
                  </a:moveTo>
                  <a:cubicBezTo>
                    <a:pt x="2178972" y="1457633"/>
                    <a:pt x="2930502" y="705726"/>
                    <a:pt x="3803264" y="115868"/>
                  </a:cubicBezTo>
                  <a:cubicBezTo>
                    <a:pt x="3861583" y="76504"/>
                    <a:pt x="3920429" y="37881"/>
                    <a:pt x="3979810" y="0"/>
                  </a:cubicBezTo>
                  <a:lnTo>
                    <a:pt x="3635104" y="0"/>
                  </a:lnTo>
                  <a:cubicBezTo>
                    <a:pt x="2315489" y="907938"/>
                    <a:pt x="1282730" y="2174291"/>
                    <a:pt x="658473" y="3649867"/>
                  </a:cubicBezTo>
                  <a:cubicBezTo>
                    <a:pt x="229084" y="4666364"/>
                    <a:pt x="7814" y="5745720"/>
                    <a:pt x="0" y="6858000"/>
                  </a:cubicBezTo>
                  <a:lnTo>
                    <a:pt x="190586" y="6858000"/>
                  </a:lnTo>
                  <a:cubicBezTo>
                    <a:pt x="198336" y="5771144"/>
                    <a:pt x="414587" y="4716957"/>
                    <a:pt x="833939" y="3724104"/>
                  </a:cubicBezTo>
                  <a:cubicBezTo>
                    <a:pt x="1040191" y="3236353"/>
                    <a:pt x="1293200" y="2769749"/>
                    <a:pt x="1589421" y="2330830"/>
                  </a:cubicBezTo>
                  <a:close/>
                  <a:moveTo>
                    <a:pt x="2572017" y="2993622"/>
                  </a:moveTo>
                  <a:cubicBezTo>
                    <a:pt x="3332930" y="1865656"/>
                    <a:pt x="4404701" y="982881"/>
                    <a:pt x="5657281" y="452412"/>
                  </a:cubicBezTo>
                  <a:cubicBezTo>
                    <a:pt x="6154760" y="241841"/>
                    <a:pt x="6675072" y="90013"/>
                    <a:pt x="7207695" y="0"/>
                  </a:cubicBezTo>
                  <a:lnTo>
                    <a:pt x="6359208" y="0"/>
                  </a:lnTo>
                  <a:cubicBezTo>
                    <a:pt x="4284670" y="610249"/>
                    <a:pt x="2593089" y="2119237"/>
                    <a:pt x="1750212" y="4111495"/>
                  </a:cubicBezTo>
                  <a:cubicBezTo>
                    <a:pt x="1382635" y="4981807"/>
                    <a:pt x="1192558" y="5905571"/>
                    <a:pt x="1184807" y="6858000"/>
                  </a:cubicBezTo>
                  <a:lnTo>
                    <a:pt x="1375393" y="6858000"/>
                  </a:lnTo>
                  <a:cubicBezTo>
                    <a:pt x="1383080" y="5931185"/>
                    <a:pt x="1568075" y="5032463"/>
                    <a:pt x="1925741" y="4185732"/>
                  </a:cubicBezTo>
                  <a:cubicBezTo>
                    <a:pt x="2102147" y="3768398"/>
                    <a:pt x="2318583" y="3369160"/>
                    <a:pt x="2572017" y="2993622"/>
                  </a:cubicBezTo>
                  <a:close/>
                  <a:moveTo>
                    <a:pt x="2244464" y="2772819"/>
                  </a:moveTo>
                  <a:cubicBezTo>
                    <a:pt x="3048163" y="1581236"/>
                    <a:pt x="4180312" y="648682"/>
                    <a:pt x="5503478" y="88347"/>
                  </a:cubicBezTo>
                  <a:cubicBezTo>
                    <a:pt x="5576110" y="57669"/>
                    <a:pt x="5649085" y="28220"/>
                    <a:pt x="5722398" y="0"/>
                  </a:cubicBezTo>
                  <a:lnTo>
                    <a:pt x="5231195" y="0"/>
                  </a:lnTo>
                  <a:cubicBezTo>
                    <a:pt x="3500048" y="791829"/>
                    <a:pt x="2128257" y="2203840"/>
                    <a:pt x="1386320" y="3957619"/>
                  </a:cubicBezTo>
                  <a:cubicBezTo>
                    <a:pt x="998097" y="4876680"/>
                    <a:pt x="797664" y="5852181"/>
                    <a:pt x="789914" y="6858000"/>
                  </a:cubicBezTo>
                  <a:lnTo>
                    <a:pt x="980500" y="6858000"/>
                  </a:lnTo>
                  <a:cubicBezTo>
                    <a:pt x="988250" y="5877796"/>
                    <a:pt x="1183791" y="4927273"/>
                    <a:pt x="1561849" y="4031856"/>
                  </a:cubicBezTo>
                  <a:cubicBezTo>
                    <a:pt x="1748217" y="3591107"/>
                    <a:pt x="1976824" y="3169458"/>
                    <a:pt x="2244464" y="2772819"/>
                  </a:cubicBezTo>
                  <a:close/>
                  <a:moveTo>
                    <a:pt x="6645086" y="5174199"/>
                  </a:moveTo>
                  <a:cubicBezTo>
                    <a:pt x="6196994" y="5621603"/>
                    <a:pt x="5938846" y="6224801"/>
                    <a:pt x="5924482" y="6858000"/>
                  </a:cubicBezTo>
                  <a:lnTo>
                    <a:pt x="6115068" y="6858000"/>
                  </a:lnTo>
                  <a:cubicBezTo>
                    <a:pt x="6144113" y="5740903"/>
                    <a:pt x="6980009" y="4810427"/>
                    <a:pt x="8087184" y="4662805"/>
                  </a:cubicBezTo>
                  <a:lnTo>
                    <a:pt x="8087184" y="4470476"/>
                  </a:lnTo>
                  <a:cubicBezTo>
                    <a:pt x="7541283" y="4536958"/>
                    <a:pt x="7033500" y="4784755"/>
                    <a:pt x="6645086" y="5174199"/>
                  </a:cubicBezTo>
                  <a:close/>
                  <a:moveTo>
                    <a:pt x="5248665" y="3776858"/>
                  </a:moveTo>
                  <a:cubicBezTo>
                    <a:pt x="4429655" y="4594492"/>
                    <a:pt x="3963299" y="5700524"/>
                    <a:pt x="3949506" y="6858000"/>
                  </a:cubicBezTo>
                  <a:lnTo>
                    <a:pt x="4140092" y="6858000"/>
                  </a:lnTo>
                  <a:cubicBezTo>
                    <a:pt x="4168387" y="4649426"/>
                    <a:pt x="5884840" y="2831630"/>
                    <a:pt x="8087184" y="2677862"/>
                  </a:cubicBezTo>
                  <a:lnTo>
                    <a:pt x="8087184" y="2486740"/>
                  </a:lnTo>
                  <a:cubicBezTo>
                    <a:pt x="7015966" y="2558053"/>
                    <a:pt x="6007247" y="3016624"/>
                    <a:pt x="5248983" y="3776985"/>
                  </a:cubicBezTo>
                  <a:close/>
                  <a:moveTo>
                    <a:pt x="4410660" y="2938516"/>
                  </a:moveTo>
                  <a:cubicBezTo>
                    <a:pt x="3369116" y="3978263"/>
                    <a:pt x="2777913" y="5386016"/>
                    <a:pt x="2764635" y="6858000"/>
                  </a:cubicBezTo>
                  <a:lnTo>
                    <a:pt x="2955221" y="6858000"/>
                  </a:lnTo>
                  <a:cubicBezTo>
                    <a:pt x="2982996" y="3994566"/>
                    <a:pt x="5229175" y="1645170"/>
                    <a:pt x="8087184" y="1490201"/>
                  </a:cubicBezTo>
                  <a:lnTo>
                    <a:pt x="8087184" y="1299524"/>
                  </a:lnTo>
                  <a:cubicBezTo>
                    <a:pt x="6701118" y="1371556"/>
                    <a:pt x="5391045" y="1955579"/>
                    <a:pt x="4410660" y="2938516"/>
                  </a:cubicBezTo>
                  <a:close/>
                  <a:moveTo>
                    <a:pt x="4131135" y="2658858"/>
                  </a:moveTo>
                  <a:cubicBezTo>
                    <a:pt x="3581562" y="3207390"/>
                    <a:pt x="3143742" y="3857527"/>
                    <a:pt x="2842013" y="4573123"/>
                  </a:cubicBezTo>
                  <a:cubicBezTo>
                    <a:pt x="2536123" y="5297313"/>
                    <a:pt x="2377365" y="6065676"/>
                    <a:pt x="2369615" y="6858000"/>
                  </a:cubicBezTo>
                  <a:lnTo>
                    <a:pt x="2560201" y="6858000"/>
                  </a:lnTo>
                  <a:cubicBezTo>
                    <a:pt x="2567887" y="6091353"/>
                    <a:pt x="2721563" y="5347905"/>
                    <a:pt x="3017606" y="4647360"/>
                  </a:cubicBezTo>
                  <a:cubicBezTo>
                    <a:pt x="3885813" y="2587735"/>
                    <a:pt x="5855795" y="1207104"/>
                    <a:pt x="8087184" y="1094420"/>
                  </a:cubicBezTo>
                  <a:lnTo>
                    <a:pt x="8087184" y="903743"/>
                  </a:lnTo>
                  <a:cubicBezTo>
                    <a:pt x="6596296" y="976143"/>
                    <a:pt x="5185918" y="1602077"/>
                    <a:pt x="4131643" y="2659239"/>
                  </a:cubicBezTo>
                  <a:close/>
                  <a:moveTo>
                    <a:pt x="3851609" y="2379199"/>
                  </a:moveTo>
                  <a:cubicBezTo>
                    <a:pt x="3266022" y="2963794"/>
                    <a:pt x="2799525" y="3656649"/>
                    <a:pt x="2478058" y="4419247"/>
                  </a:cubicBezTo>
                  <a:cubicBezTo>
                    <a:pt x="2151585" y="5192123"/>
                    <a:pt x="1982535" y="6012350"/>
                    <a:pt x="1974721" y="6858000"/>
                  </a:cubicBezTo>
                  <a:lnTo>
                    <a:pt x="2165307" y="6858000"/>
                  </a:lnTo>
                  <a:cubicBezTo>
                    <a:pt x="2172994" y="6038091"/>
                    <a:pt x="2337152" y="5242779"/>
                    <a:pt x="2653651" y="4493611"/>
                  </a:cubicBezTo>
                  <a:cubicBezTo>
                    <a:pt x="3583550" y="2287642"/>
                    <a:pt x="5696853" y="811831"/>
                    <a:pt x="8087184" y="699147"/>
                  </a:cubicBezTo>
                  <a:lnTo>
                    <a:pt x="8087184" y="508471"/>
                  </a:lnTo>
                  <a:cubicBezTo>
                    <a:pt x="6491347" y="580803"/>
                    <a:pt x="4980435" y="1248328"/>
                    <a:pt x="3851990" y="2379580"/>
                  </a:cubicBezTo>
                  <a:close/>
                  <a:moveTo>
                    <a:pt x="6365561" y="4894350"/>
                  </a:moveTo>
                  <a:cubicBezTo>
                    <a:pt x="5843312" y="5415945"/>
                    <a:pt x="5543596" y="6119847"/>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689995" y="3217985"/>
                  </a:moveTo>
                  <a:cubicBezTo>
                    <a:pt x="3722659" y="4183711"/>
                    <a:pt x="3173060" y="5490862"/>
                    <a:pt x="3159529" y="6858000"/>
                  </a:cubicBezTo>
                  <a:lnTo>
                    <a:pt x="3350115" y="6858000"/>
                  </a:lnTo>
                  <a:cubicBezTo>
                    <a:pt x="3378080" y="4212840"/>
                    <a:pt x="5447656" y="2040614"/>
                    <a:pt x="8087184" y="1885982"/>
                  </a:cubicBezTo>
                  <a:lnTo>
                    <a:pt x="8087184" y="1694988"/>
                  </a:lnTo>
                  <a:cubicBezTo>
                    <a:pt x="6806004" y="1766892"/>
                    <a:pt x="5596357" y="2309182"/>
                    <a:pt x="4689995" y="3217985"/>
                  </a:cubicBezTo>
                  <a:close/>
                  <a:moveTo>
                    <a:pt x="5736946" y="640864"/>
                  </a:moveTo>
                  <a:cubicBezTo>
                    <a:pt x="4104688" y="1332467"/>
                    <a:pt x="2805440" y="2632335"/>
                    <a:pt x="2114167" y="4265371"/>
                  </a:cubicBezTo>
                  <a:cubicBezTo>
                    <a:pt x="1767110" y="5086996"/>
                    <a:pt x="1587515" y="5958960"/>
                    <a:pt x="1579828" y="6858000"/>
                  </a:cubicBezTo>
                  <a:lnTo>
                    <a:pt x="1770414" y="6858000"/>
                  </a:lnTo>
                  <a:cubicBezTo>
                    <a:pt x="1778101" y="5984575"/>
                    <a:pt x="1952613" y="5137589"/>
                    <a:pt x="2289696" y="4339608"/>
                  </a:cubicBezTo>
                  <a:cubicBezTo>
                    <a:pt x="3281262" y="1987231"/>
                    <a:pt x="5537892" y="416179"/>
                    <a:pt x="8087184" y="303430"/>
                  </a:cubicBezTo>
                  <a:lnTo>
                    <a:pt x="8087184" y="112753"/>
                  </a:lnTo>
                  <a:cubicBezTo>
                    <a:pt x="7278466" y="146573"/>
                    <a:pt x="6482453" y="325450"/>
                    <a:pt x="5736946" y="640864"/>
                  </a:cubicBezTo>
                  <a:close/>
                  <a:moveTo>
                    <a:pt x="4969330" y="3497453"/>
                  </a:moveTo>
                  <a:cubicBezTo>
                    <a:pt x="4076132" y="4389101"/>
                    <a:pt x="3568132" y="5595696"/>
                    <a:pt x="3554486" y="6858000"/>
                  </a:cubicBezTo>
                  <a:lnTo>
                    <a:pt x="3745072" y="6858000"/>
                  </a:lnTo>
                  <a:cubicBezTo>
                    <a:pt x="3773202" y="4431107"/>
                    <a:pt x="5666194" y="2436046"/>
                    <a:pt x="8087184" y="2281763"/>
                  </a:cubicBezTo>
                  <a:lnTo>
                    <a:pt x="8087184" y="2091086"/>
                  </a:lnTo>
                  <a:cubicBezTo>
                    <a:pt x="6910953" y="2162571"/>
                    <a:pt x="5801707" y="2662919"/>
                    <a:pt x="4969330" y="3497453"/>
                  </a:cubicBezTo>
                  <a:close/>
                  <a:moveTo>
                    <a:pt x="6086607" y="4615263"/>
                  </a:moveTo>
                  <a:cubicBezTo>
                    <a:pt x="5490118" y="5210739"/>
                    <a:pt x="5148633" y="6015070"/>
                    <a:pt x="5134441" y="6858000"/>
                  </a:cubicBezTo>
                  <a:lnTo>
                    <a:pt x="5325027" y="6858000"/>
                  </a:lnTo>
                  <a:cubicBezTo>
                    <a:pt x="5353570" y="5304190"/>
                    <a:pt x="6541217" y="4018292"/>
                    <a:pt x="8087184" y="3867302"/>
                  </a:cubicBezTo>
                  <a:lnTo>
                    <a:pt x="8087184" y="3675799"/>
                  </a:lnTo>
                  <a:cubicBezTo>
                    <a:pt x="7330940" y="3744977"/>
                    <a:pt x="6622978" y="4077447"/>
                    <a:pt x="6086607" y="4615263"/>
                  </a:cubicBezTo>
                  <a:close/>
                  <a:moveTo>
                    <a:pt x="5807081" y="4335604"/>
                  </a:moveTo>
                  <a:cubicBezTo>
                    <a:pt x="5136353" y="5005171"/>
                    <a:pt x="4753231" y="5910147"/>
                    <a:pt x="4739230" y="6858000"/>
                  </a:cubicBezTo>
                  <a:lnTo>
                    <a:pt x="4929815" y="6858000"/>
                  </a:lnTo>
                  <a:cubicBezTo>
                    <a:pt x="4958327" y="5085840"/>
                    <a:pt x="6322177" y="3622499"/>
                    <a:pt x="8087184" y="3470313"/>
                  </a:cubicBezTo>
                  <a:lnTo>
                    <a:pt x="8087184" y="3279192"/>
                  </a:lnTo>
                  <a:cubicBezTo>
                    <a:pt x="7225928" y="3349227"/>
                    <a:pt x="6417654" y="3723799"/>
                    <a:pt x="5807335" y="4335794"/>
                  </a:cubicBezTo>
                  <a:close/>
                  <a:moveTo>
                    <a:pt x="5527556" y="4055945"/>
                  </a:moveTo>
                  <a:cubicBezTo>
                    <a:pt x="4782753" y="4799672"/>
                    <a:pt x="4358160" y="5805294"/>
                    <a:pt x="4344463" y="6858000"/>
                  </a:cubicBezTo>
                  <a:lnTo>
                    <a:pt x="4535049" y="6858000"/>
                  </a:lnTo>
                  <a:cubicBezTo>
                    <a:pt x="4563415" y="4867661"/>
                    <a:pt x="6103486" y="3227074"/>
                    <a:pt x="8087184" y="3074024"/>
                  </a:cubicBezTo>
                  <a:lnTo>
                    <a:pt x="8087184" y="2882775"/>
                  </a:lnTo>
                  <a:cubicBezTo>
                    <a:pt x="7120852" y="2953516"/>
                    <a:pt x="6212355" y="3370126"/>
                    <a:pt x="5528000" y="4056326"/>
                  </a:cubicBezTo>
                  <a:close/>
                </a:path>
              </a:pathLst>
            </a:custGeom>
            <a:solidFill>
              <a:srgbClr val="005CC2">
                <a:alpha val="838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18" name="Google Shape;18;p3"/>
            <p:cNvSpPr/>
            <p:nvPr/>
          </p:nvSpPr>
          <p:spPr>
            <a:xfrm>
              <a:off x="2052402" y="0"/>
              <a:ext cx="6065388" cy="5143642"/>
            </a:xfrm>
            <a:custGeom>
              <a:avLst/>
              <a:gdLst/>
              <a:ahLst/>
              <a:cxnLst/>
              <a:rect l="l" t="t" r="r" b="b"/>
              <a:pathLst>
                <a:path w="8087184" h="6858190" extrusionOk="0">
                  <a:moveTo>
                    <a:pt x="6366259" y="1870219"/>
                  </a:moveTo>
                  <a:cubicBezTo>
                    <a:pt x="6414478" y="1849137"/>
                    <a:pt x="6436522" y="1792932"/>
                    <a:pt x="6415430" y="1744684"/>
                  </a:cubicBezTo>
                  <a:cubicBezTo>
                    <a:pt x="6395292" y="1698629"/>
                    <a:pt x="6342913" y="1676110"/>
                    <a:pt x="6295679" y="1693208"/>
                  </a:cubicBezTo>
                  <a:cubicBezTo>
                    <a:pt x="4468935" y="2426156"/>
                    <a:pt x="3157737" y="4060756"/>
                    <a:pt x="2838011" y="6003706"/>
                  </a:cubicBezTo>
                  <a:cubicBezTo>
                    <a:pt x="2829536" y="6055671"/>
                    <a:pt x="2864769" y="6104675"/>
                    <a:pt x="2916716" y="6113154"/>
                  </a:cubicBezTo>
                  <a:cubicBezTo>
                    <a:pt x="2916716" y="6113154"/>
                    <a:pt x="2916723" y="6113154"/>
                    <a:pt x="2916723" y="6113154"/>
                  </a:cubicBezTo>
                  <a:cubicBezTo>
                    <a:pt x="2921824" y="6114012"/>
                    <a:pt x="2926989" y="6114438"/>
                    <a:pt x="2932160" y="6114425"/>
                  </a:cubicBezTo>
                  <a:cubicBezTo>
                    <a:pt x="2978841" y="6114381"/>
                    <a:pt x="3018616" y="6080504"/>
                    <a:pt x="3026119" y="6034405"/>
                  </a:cubicBezTo>
                  <a:cubicBezTo>
                    <a:pt x="3335065" y="4157486"/>
                    <a:pt x="4601646" y="2578418"/>
                    <a:pt x="6366259" y="1870219"/>
                  </a:cubicBezTo>
                  <a:close/>
                  <a:moveTo>
                    <a:pt x="2680460" y="5322927"/>
                  </a:moveTo>
                  <a:cubicBezTo>
                    <a:pt x="2629555" y="5309637"/>
                    <a:pt x="2577512" y="5340139"/>
                    <a:pt x="2564203" y="5391062"/>
                  </a:cubicBezTo>
                  <a:cubicBezTo>
                    <a:pt x="2439623" y="5870239"/>
                    <a:pt x="2374272" y="6362877"/>
                    <a:pt x="2369615" y="6858000"/>
                  </a:cubicBezTo>
                  <a:lnTo>
                    <a:pt x="2560201" y="6858000"/>
                  </a:lnTo>
                  <a:cubicBezTo>
                    <a:pt x="2564794" y="6379148"/>
                    <a:pt x="2628055" y="5902679"/>
                    <a:pt x="2748563" y="5439240"/>
                  </a:cubicBezTo>
                  <a:cubicBezTo>
                    <a:pt x="2761847" y="5388310"/>
                    <a:pt x="2731365" y="5336243"/>
                    <a:pt x="2680460" y="5322927"/>
                  </a:cubicBezTo>
                  <a:close/>
                  <a:moveTo>
                    <a:pt x="2239000" y="4214715"/>
                  </a:moveTo>
                  <a:cubicBezTo>
                    <a:pt x="2190503" y="4194261"/>
                    <a:pt x="2134617" y="4217016"/>
                    <a:pt x="2114179" y="4265537"/>
                  </a:cubicBezTo>
                  <a:cubicBezTo>
                    <a:pt x="2114173" y="4265543"/>
                    <a:pt x="2114173" y="4265556"/>
                    <a:pt x="2114167" y="4265562"/>
                  </a:cubicBezTo>
                  <a:cubicBezTo>
                    <a:pt x="1767110" y="5087187"/>
                    <a:pt x="1587515" y="5959151"/>
                    <a:pt x="1579828" y="6858191"/>
                  </a:cubicBezTo>
                  <a:lnTo>
                    <a:pt x="1770414" y="6858191"/>
                  </a:lnTo>
                  <a:cubicBezTo>
                    <a:pt x="1778101" y="5984765"/>
                    <a:pt x="1952613" y="5137780"/>
                    <a:pt x="2289696" y="4339799"/>
                  </a:cubicBezTo>
                  <a:cubicBezTo>
                    <a:pt x="2310254" y="4291329"/>
                    <a:pt x="2287638" y="4235359"/>
                    <a:pt x="2239191" y="4214797"/>
                  </a:cubicBezTo>
                  <a:cubicBezTo>
                    <a:pt x="2239127" y="4214766"/>
                    <a:pt x="2239064" y="4214740"/>
                    <a:pt x="2239000" y="4214715"/>
                  </a:cubicBezTo>
                  <a:close/>
                  <a:moveTo>
                    <a:pt x="2087612" y="6428088"/>
                  </a:moveTo>
                  <a:cubicBezTo>
                    <a:pt x="2035093" y="6424847"/>
                    <a:pt x="1989898" y="6464825"/>
                    <a:pt x="1986665" y="6517389"/>
                  </a:cubicBezTo>
                  <a:cubicBezTo>
                    <a:pt x="1979740" y="6630078"/>
                    <a:pt x="1975738" y="6744357"/>
                    <a:pt x="1974658" y="6858000"/>
                  </a:cubicBezTo>
                  <a:lnTo>
                    <a:pt x="2165244" y="6858000"/>
                  </a:lnTo>
                  <a:cubicBezTo>
                    <a:pt x="2166260" y="6748234"/>
                    <a:pt x="2170135" y="6637896"/>
                    <a:pt x="2176806" y="6529083"/>
                  </a:cubicBezTo>
                  <a:cubicBezTo>
                    <a:pt x="2180027" y="6476584"/>
                    <a:pt x="2140105" y="6431330"/>
                    <a:pt x="2087612" y="6428088"/>
                  </a:cubicBezTo>
                  <a:close/>
                  <a:moveTo>
                    <a:pt x="3486447" y="3682663"/>
                  </a:moveTo>
                  <a:cubicBezTo>
                    <a:pt x="3518040" y="3682689"/>
                    <a:pt x="3547593" y="3667047"/>
                    <a:pt x="3565349" y="3640906"/>
                  </a:cubicBezTo>
                  <a:cubicBezTo>
                    <a:pt x="3898042" y="3151394"/>
                    <a:pt x="4303100" y="2715260"/>
                    <a:pt x="4766674" y="2347419"/>
                  </a:cubicBezTo>
                  <a:cubicBezTo>
                    <a:pt x="4807898" y="2314686"/>
                    <a:pt x="4814797" y="2254712"/>
                    <a:pt x="4782080" y="2213469"/>
                  </a:cubicBezTo>
                  <a:cubicBezTo>
                    <a:pt x="4749362" y="2172225"/>
                    <a:pt x="4689417" y="2165323"/>
                    <a:pt x="4648193" y="2198056"/>
                  </a:cubicBezTo>
                  <a:cubicBezTo>
                    <a:pt x="4169519" y="2577934"/>
                    <a:pt x="3751284" y="3028338"/>
                    <a:pt x="3407798" y="3533872"/>
                  </a:cubicBezTo>
                  <a:cubicBezTo>
                    <a:pt x="3378188" y="3577397"/>
                    <a:pt x="3389451" y="3636704"/>
                    <a:pt x="3432956" y="3666329"/>
                  </a:cubicBezTo>
                  <a:cubicBezTo>
                    <a:pt x="3448730" y="3677071"/>
                    <a:pt x="3467363" y="3682829"/>
                    <a:pt x="3486447" y="3682854"/>
                  </a:cubicBezTo>
                  <a:close/>
                  <a:moveTo>
                    <a:pt x="5285003" y="4471365"/>
                  </a:moveTo>
                  <a:cubicBezTo>
                    <a:pt x="5242903" y="4439770"/>
                    <a:pt x="5183174" y="4448313"/>
                    <a:pt x="5151593" y="4490433"/>
                  </a:cubicBezTo>
                  <a:cubicBezTo>
                    <a:pt x="4638429" y="5174034"/>
                    <a:pt x="4355873" y="6003210"/>
                    <a:pt x="4344781" y="6858064"/>
                  </a:cubicBezTo>
                  <a:lnTo>
                    <a:pt x="4535367" y="6858064"/>
                  </a:lnTo>
                  <a:cubicBezTo>
                    <a:pt x="4546427" y="6044479"/>
                    <a:pt x="4815610" y="5255459"/>
                    <a:pt x="5304062" y="4604903"/>
                  </a:cubicBezTo>
                  <a:cubicBezTo>
                    <a:pt x="5335661" y="4562795"/>
                    <a:pt x="5327161" y="4503030"/>
                    <a:pt x="5285074" y="4471416"/>
                  </a:cubicBezTo>
                  <a:cubicBezTo>
                    <a:pt x="5285048" y="4471403"/>
                    <a:pt x="5285029" y="4471384"/>
                    <a:pt x="5285003" y="4471365"/>
                  </a:cubicBezTo>
                  <a:close/>
                  <a:moveTo>
                    <a:pt x="6701690" y="2808030"/>
                  </a:moveTo>
                  <a:cubicBezTo>
                    <a:pt x="5767433" y="3193508"/>
                    <a:pt x="4991743" y="3885022"/>
                    <a:pt x="4501697" y="4769266"/>
                  </a:cubicBezTo>
                  <a:cubicBezTo>
                    <a:pt x="4475720" y="4815060"/>
                    <a:pt x="4491773" y="4873248"/>
                    <a:pt x="4537546" y="4899237"/>
                  </a:cubicBezTo>
                  <a:cubicBezTo>
                    <a:pt x="4583318" y="4925227"/>
                    <a:pt x="4641478" y="4909165"/>
                    <a:pt x="4667455" y="4863371"/>
                  </a:cubicBezTo>
                  <a:cubicBezTo>
                    <a:pt x="4667792" y="4862767"/>
                    <a:pt x="4668129" y="4862164"/>
                    <a:pt x="4668459" y="4861553"/>
                  </a:cubicBezTo>
                  <a:cubicBezTo>
                    <a:pt x="5137446" y="4015222"/>
                    <a:pt x="5879860" y="3353378"/>
                    <a:pt x="6774050" y="2984470"/>
                  </a:cubicBezTo>
                  <a:cubicBezTo>
                    <a:pt x="6822775" y="2964480"/>
                    <a:pt x="6846027" y="2908777"/>
                    <a:pt x="6826079" y="2860053"/>
                  </a:cubicBezTo>
                  <a:cubicBezTo>
                    <a:pt x="6806067" y="2811329"/>
                    <a:pt x="6750416" y="2788041"/>
                    <a:pt x="6701690" y="2808030"/>
                  </a:cubicBezTo>
                  <a:close/>
                  <a:moveTo>
                    <a:pt x="4156864" y="5925783"/>
                  </a:moveTo>
                  <a:cubicBezTo>
                    <a:pt x="4105367" y="5914933"/>
                    <a:pt x="4054824" y="5947901"/>
                    <a:pt x="4043980" y="5999428"/>
                  </a:cubicBezTo>
                  <a:cubicBezTo>
                    <a:pt x="4043973" y="5999435"/>
                    <a:pt x="4043973" y="5999441"/>
                    <a:pt x="4043973" y="5999447"/>
                  </a:cubicBezTo>
                  <a:cubicBezTo>
                    <a:pt x="3984905" y="6281916"/>
                    <a:pt x="3953267" y="6569443"/>
                    <a:pt x="3949506" y="6858000"/>
                  </a:cubicBezTo>
                  <a:lnTo>
                    <a:pt x="4140092" y="6858000"/>
                  </a:lnTo>
                  <a:cubicBezTo>
                    <a:pt x="4143866" y="6582600"/>
                    <a:pt x="4174143" y="6308242"/>
                    <a:pt x="4230493" y="6038663"/>
                  </a:cubicBezTo>
                  <a:cubicBezTo>
                    <a:pt x="4241299" y="5987155"/>
                    <a:pt x="4208341" y="5936626"/>
                    <a:pt x="4156864" y="5925783"/>
                  </a:cubicBezTo>
                  <a:close/>
                  <a:moveTo>
                    <a:pt x="5530160" y="2764810"/>
                  </a:moveTo>
                  <a:cubicBezTo>
                    <a:pt x="5974498" y="2457948"/>
                    <a:pt x="6465491" y="2225005"/>
                    <a:pt x="6984202" y="2075006"/>
                  </a:cubicBezTo>
                  <a:cubicBezTo>
                    <a:pt x="7034770" y="2060368"/>
                    <a:pt x="7063867" y="2007494"/>
                    <a:pt x="7049255" y="1956914"/>
                  </a:cubicBezTo>
                  <a:cubicBezTo>
                    <a:pt x="7034643" y="1906333"/>
                    <a:pt x="6981788" y="1877192"/>
                    <a:pt x="6931219" y="1891829"/>
                  </a:cubicBezTo>
                  <a:cubicBezTo>
                    <a:pt x="4715915" y="2532477"/>
                    <a:pt x="3182876" y="4551024"/>
                    <a:pt x="3159529" y="6858000"/>
                  </a:cubicBezTo>
                  <a:lnTo>
                    <a:pt x="3350115" y="6858000"/>
                  </a:lnTo>
                  <a:cubicBezTo>
                    <a:pt x="3368665" y="5220209"/>
                    <a:pt x="4181729" y="3693627"/>
                    <a:pt x="5530160" y="2764810"/>
                  </a:cubicBezTo>
                  <a:close/>
                  <a:moveTo>
                    <a:pt x="3857517" y="1312554"/>
                  </a:moveTo>
                  <a:cubicBezTo>
                    <a:pt x="2821278" y="2150298"/>
                    <a:pt x="2037615" y="3259196"/>
                    <a:pt x="1593677" y="4515920"/>
                  </a:cubicBezTo>
                  <a:cubicBezTo>
                    <a:pt x="1576137" y="4565572"/>
                    <a:pt x="1602146" y="4620055"/>
                    <a:pt x="1651774" y="4637604"/>
                  </a:cubicBezTo>
                  <a:cubicBezTo>
                    <a:pt x="1701402" y="4655152"/>
                    <a:pt x="1755859" y="4629131"/>
                    <a:pt x="1773399" y="4579479"/>
                  </a:cubicBezTo>
                  <a:cubicBezTo>
                    <a:pt x="2205610" y="3355958"/>
                    <a:pt x="2968581" y="2276360"/>
                    <a:pt x="3977459" y="1460773"/>
                  </a:cubicBezTo>
                  <a:cubicBezTo>
                    <a:pt x="4018371" y="1427634"/>
                    <a:pt x="4024686" y="1367596"/>
                    <a:pt x="3991562" y="1326664"/>
                  </a:cubicBezTo>
                  <a:cubicBezTo>
                    <a:pt x="3958439" y="1285732"/>
                    <a:pt x="3898430" y="1279414"/>
                    <a:pt x="3857517" y="1312554"/>
                  </a:cubicBezTo>
                  <a:close/>
                  <a:moveTo>
                    <a:pt x="2248403" y="2598095"/>
                  </a:moveTo>
                  <a:cubicBezTo>
                    <a:pt x="2204981" y="2568350"/>
                    <a:pt x="2145683" y="2579447"/>
                    <a:pt x="2115945" y="2622883"/>
                  </a:cubicBezTo>
                  <a:cubicBezTo>
                    <a:pt x="1635860" y="3322742"/>
                    <a:pt x="1277191" y="4098599"/>
                    <a:pt x="1055019" y="4917803"/>
                  </a:cubicBezTo>
                  <a:cubicBezTo>
                    <a:pt x="1039321" y="4968059"/>
                    <a:pt x="1067311" y="5021531"/>
                    <a:pt x="1117543" y="5037242"/>
                  </a:cubicBezTo>
                  <a:cubicBezTo>
                    <a:pt x="1167775" y="5052948"/>
                    <a:pt x="1221222" y="5024944"/>
                    <a:pt x="1236926" y="4974688"/>
                  </a:cubicBezTo>
                  <a:cubicBezTo>
                    <a:pt x="1237638" y="4972400"/>
                    <a:pt x="1238267" y="4970093"/>
                    <a:pt x="1238807" y="4967760"/>
                  </a:cubicBezTo>
                  <a:cubicBezTo>
                    <a:pt x="1455452" y="4169149"/>
                    <a:pt x="1805119" y="3412786"/>
                    <a:pt x="2273115" y="2730488"/>
                  </a:cubicBezTo>
                  <a:cubicBezTo>
                    <a:pt x="2302770" y="2687090"/>
                    <a:pt x="2291716" y="2627860"/>
                    <a:pt x="2248403" y="2598095"/>
                  </a:cubicBezTo>
                  <a:close/>
                  <a:moveTo>
                    <a:pt x="3182082" y="972450"/>
                  </a:moveTo>
                  <a:cubicBezTo>
                    <a:pt x="3216304" y="1012264"/>
                    <a:pt x="3276263" y="1016897"/>
                    <a:pt x="3316190" y="982811"/>
                  </a:cubicBezTo>
                  <a:cubicBezTo>
                    <a:pt x="3760979" y="601738"/>
                    <a:pt x="4247290" y="272053"/>
                    <a:pt x="4765912" y="0"/>
                  </a:cubicBezTo>
                  <a:lnTo>
                    <a:pt x="4372035" y="0"/>
                  </a:lnTo>
                  <a:cubicBezTo>
                    <a:pt x="3954366" y="243105"/>
                    <a:pt x="3559574" y="523572"/>
                    <a:pt x="3192500" y="837960"/>
                  </a:cubicBezTo>
                  <a:cubicBezTo>
                    <a:pt x="3152503" y="872186"/>
                    <a:pt x="3147814" y="932364"/>
                    <a:pt x="3182024" y="972381"/>
                  </a:cubicBezTo>
                  <a:cubicBezTo>
                    <a:pt x="3182043" y="972406"/>
                    <a:pt x="3182062" y="972425"/>
                    <a:pt x="3182082" y="972450"/>
                  </a:cubicBezTo>
                  <a:close/>
                  <a:moveTo>
                    <a:pt x="4503476" y="959103"/>
                  </a:moveTo>
                  <a:cubicBezTo>
                    <a:pt x="4531669" y="1003556"/>
                    <a:pt x="4590541" y="1016732"/>
                    <a:pt x="4634980" y="988531"/>
                  </a:cubicBezTo>
                  <a:cubicBezTo>
                    <a:pt x="5419589" y="490690"/>
                    <a:pt x="6295666" y="154609"/>
                    <a:pt x="7211824" y="0"/>
                  </a:cubicBezTo>
                  <a:lnTo>
                    <a:pt x="6361749" y="0"/>
                  </a:lnTo>
                  <a:cubicBezTo>
                    <a:pt x="5716216" y="188538"/>
                    <a:pt x="5100440" y="467098"/>
                    <a:pt x="4532571" y="827473"/>
                  </a:cubicBezTo>
                  <a:cubicBezTo>
                    <a:pt x="4488140" y="855680"/>
                    <a:pt x="4474970" y="914580"/>
                    <a:pt x="4503158" y="959040"/>
                  </a:cubicBezTo>
                  <a:close/>
                  <a:moveTo>
                    <a:pt x="4619923" y="423048"/>
                  </a:moveTo>
                  <a:cubicBezTo>
                    <a:pt x="4645786" y="468905"/>
                    <a:pt x="4703908" y="485105"/>
                    <a:pt x="4749744" y="459231"/>
                  </a:cubicBezTo>
                  <a:cubicBezTo>
                    <a:pt x="4749756" y="459225"/>
                    <a:pt x="4749763" y="459218"/>
                    <a:pt x="4749775" y="459213"/>
                  </a:cubicBezTo>
                  <a:cubicBezTo>
                    <a:pt x="5062406" y="282668"/>
                    <a:pt x="5387494" y="129190"/>
                    <a:pt x="5722461" y="0"/>
                  </a:cubicBezTo>
                  <a:lnTo>
                    <a:pt x="5231004" y="0"/>
                  </a:lnTo>
                  <a:cubicBezTo>
                    <a:pt x="5035419" y="89448"/>
                    <a:pt x="4843690" y="187160"/>
                    <a:pt x="4655817" y="293133"/>
                  </a:cubicBezTo>
                  <a:cubicBezTo>
                    <a:pt x="4609981" y="318991"/>
                    <a:pt x="4593775" y="377121"/>
                    <a:pt x="4619605" y="422984"/>
                  </a:cubicBezTo>
                  <a:close/>
                  <a:moveTo>
                    <a:pt x="1208440" y="3617579"/>
                  </a:moveTo>
                  <a:cubicBezTo>
                    <a:pt x="1160368" y="3596141"/>
                    <a:pt x="1104031" y="3617751"/>
                    <a:pt x="1082609" y="3665846"/>
                  </a:cubicBezTo>
                  <a:cubicBezTo>
                    <a:pt x="1082603" y="3665858"/>
                    <a:pt x="1082596" y="3665871"/>
                    <a:pt x="1082590" y="3665884"/>
                  </a:cubicBezTo>
                  <a:cubicBezTo>
                    <a:pt x="859205" y="4168380"/>
                    <a:pt x="688459" y="4692677"/>
                    <a:pt x="573091" y="5230385"/>
                  </a:cubicBezTo>
                  <a:cubicBezTo>
                    <a:pt x="458720" y="5765494"/>
                    <a:pt x="399119" y="6310867"/>
                    <a:pt x="395211" y="6858064"/>
                  </a:cubicBezTo>
                  <a:lnTo>
                    <a:pt x="585797" y="6858064"/>
                  </a:lnTo>
                  <a:cubicBezTo>
                    <a:pt x="589636" y="6324322"/>
                    <a:pt x="647724" y="5792347"/>
                    <a:pt x="759166" y="5270364"/>
                  </a:cubicBezTo>
                  <a:cubicBezTo>
                    <a:pt x="871732" y="4745641"/>
                    <a:pt x="1038323" y="4233992"/>
                    <a:pt x="1256277" y="3743616"/>
                  </a:cubicBezTo>
                  <a:cubicBezTo>
                    <a:pt x="1277788" y="3695566"/>
                    <a:pt x="1256296" y="3639157"/>
                    <a:pt x="1208262" y="3617637"/>
                  </a:cubicBezTo>
                  <a:cubicBezTo>
                    <a:pt x="1208173" y="3617598"/>
                    <a:pt x="1208084" y="3617554"/>
                    <a:pt x="1207995" y="3617516"/>
                  </a:cubicBezTo>
                  <a:close/>
                  <a:moveTo>
                    <a:pt x="942891" y="5974532"/>
                  </a:moveTo>
                  <a:cubicBezTo>
                    <a:pt x="890594" y="5968659"/>
                    <a:pt x="843443" y="6006305"/>
                    <a:pt x="837560" y="6058620"/>
                  </a:cubicBezTo>
                  <a:cubicBezTo>
                    <a:pt x="807861" y="6324074"/>
                    <a:pt x="791934" y="6590926"/>
                    <a:pt x="789850" y="6858000"/>
                  </a:cubicBezTo>
                  <a:lnTo>
                    <a:pt x="980436" y="6858000"/>
                  </a:lnTo>
                  <a:cubicBezTo>
                    <a:pt x="982494" y="6597917"/>
                    <a:pt x="998014" y="6338127"/>
                    <a:pt x="1026939" y="6079658"/>
                  </a:cubicBezTo>
                  <a:cubicBezTo>
                    <a:pt x="1032663" y="6027432"/>
                    <a:pt x="995073" y="5980418"/>
                    <a:pt x="942891" y="5974532"/>
                  </a:cubicBezTo>
                  <a:close/>
                  <a:moveTo>
                    <a:pt x="2329973" y="1389587"/>
                  </a:moveTo>
                  <a:cubicBezTo>
                    <a:pt x="2705198" y="978292"/>
                    <a:pt x="3121081" y="606057"/>
                    <a:pt x="3571258" y="278578"/>
                  </a:cubicBezTo>
                  <a:cubicBezTo>
                    <a:pt x="3704623" y="181588"/>
                    <a:pt x="3840892" y="88728"/>
                    <a:pt x="3980064" y="0"/>
                  </a:cubicBezTo>
                  <a:lnTo>
                    <a:pt x="3634913" y="0"/>
                  </a:lnTo>
                  <a:cubicBezTo>
                    <a:pt x="3575622" y="40678"/>
                    <a:pt x="3517049" y="82118"/>
                    <a:pt x="3459193" y="124321"/>
                  </a:cubicBezTo>
                  <a:cubicBezTo>
                    <a:pt x="2998611" y="459401"/>
                    <a:pt x="2573110" y="840261"/>
                    <a:pt x="2189194" y="1261071"/>
                  </a:cubicBezTo>
                  <a:cubicBezTo>
                    <a:pt x="2154101" y="1300312"/>
                    <a:pt x="2157449" y="1360585"/>
                    <a:pt x="2196671" y="1395695"/>
                  </a:cubicBezTo>
                  <a:cubicBezTo>
                    <a:pt x="2235354" y="1430316"/>
                    <a:pt x="2294613" y="1427602"/>
                    <a:pt x="2329973" y="1389587"/>
                  </a:cubicBezTo>
                  <a:close/>
                  <a:moveTo>
                    <a:pt x="557844" y="4174100"/>
                  </a:moveTo>
                  <a:cubicBezTo>
                    <a:pt x="507970" y="4157308"/>
                    <a:pt x="453932" y="4184143"/>
                    <a:pt x="437140" y="4234036"/>
                  </a:cubicBezTo>
                  <a:cubicBezTo>
                    <a:pt x="152879" y="5079865"/>
                    <a:pt x="5311" y="5965653"/>
                    <a:pt x="0" y="6858000"/>
                  </a:cubicBezTo>
                  <a:lnTo>
                    <a:pt x="190586" y="6858000"/>
                  </a:lnTo>
                  <a:cubicBezTo>
                    <a:pt x="195867" y="5986354"/>
                    <a:pt x="340068" y="5121127"/>
                    <a:pt x="617752" y="4294926"/>
                  </a:cubicBezTo>
                  <a:cubicBezTo>
                    <a:pt x="634569" y="4245032"/>
                    <a:pt x="607775" y="4190944"/>
                    <a:pt x="557905" y="4174119"/>
                  </a:cubicBezTo>
                  <a:cubicBezTo>
                    <a:pt x="557885" y="4174113"/>
                    <a:pt x="557865" y="4174107"/>
                    <a:pt x="557844" y="4174100"/>
                  </a:cubicBezTo>
                  <a:close/>
                  <a:moveTo>
                    <a:pt x="6996336" y="3748828"/>
                  </a:moveTo>
                  <a:cubicBezTo>
                    <a:pt x="7044554" y="3727644"/>
                    <a:pt x="7066407" y="3671388"/>
                    <a:pt x="7045253" y="3623172"/>
                  </a:cubicBezTo>
                  <a:cubicBezTo>
                    <a:pt x="7024098" y="3574957"/>
                    <a:pt x="6967875" y="3553048"/>
                    <a:pt x="6919656" y="3574232"/>
                  </a:cubicBezTo>
                  <a:cubicBezTo>
                    <a:pt x="5972433" y="3991121"/>
                    <a:pt x="5246340" y="4790323"/>
                    <a:pt x="4921684" y="5773368"/>
                  </a:cubicBezTo>
                  <a:cubicBezTo>
                    <a:pt x="4904569" y="5823161"/>
                    <a:pt x="4931042" y="5877408"/>
                    <a:pt x="4980810" y="5894524"/>
                  </a:cubicBezTo>
                  <a:cubicBezTo>
                    <a:pt x="5030578" y="5911647"/>
                    <a:pt x="5084800" y="5885162"/>
                    <a:pt x="5101914" y="5835370"/>
                  </a:cubicBezTo>
                  <a:cubicBezTo>
                    <a:pt x="5102175" y="5834601"/>
                    <a:pt x="5102429" y="5833826"/>
                    <a:pt x="5102677" y="5833050"/>
                  </a:cubicBezTo>
                  <a:cubicBezTo>
                    <a:pt x="5410415" y="4901366"/>
                    <a:pt x="6098595" y="4143936"/>
                    <a:pt x="6996336" y="3748828"/>
                  </a:cubicBezTo>
                  <a:close/>
                  <a:moveTo>
                    <a:pt x="6881984" y="5085281"/>
                  </a:moveTo>
                  <a:cubicBezTo>
                    <a:pt x="6913749" y="5127178"/>
                    <a:pt x="6973465" y="5135396"/>
                    <a:pt x="7015394" y="5103649"/>
                  </a:cubicBezTo>
                  <a:cubicBezTo>
                    <a:pt x="7328018" y="4865545"/>
                    <a:pt x="7697564" y="4713512"/>
                    <a:pt x="8087184" y="4662677"/>
                  </a:cubicBezTo>
                  <a:lnTo>
                    <a:pt x="8087184" y="4470349"/>
                  </a:lnTo>
                  <a:cubicBezTo>
                    <a:pt x="7655889" y="4522225"/>
                    <a:pt x="7246321" y="4688393"/>
                    <a:pt x="6900725" y="4951680"/>
                  </a:cubicBezTo>
                  <a:cubicBezTo>
                    <a:pt x="6858669" y="4983370"/>
                    <a:pt x="6850284" y="5043153"/>
                    <a:pt x="6881984" y="5085198"/>
                  </a:cubicBezTo>
                  <a:cubicBezTo>
                    <a:pt x="6881984" y="5085223"/>
                    <a:pt x="6882048" y="5085255"/>
                    <a:pt x="6882048" y="5085281"/>
                  </a:cubicBezTo>
                  <a:close/>
                  <a:moveTo>
                    <a:pt x="7499037" y="2661908"/>
                  </a:moveTo>
                  <a:cubicBezTo>
                    <a:pt x="7508693" y="2713633"/>
                    <a:pt x="7558373" y="2747770"/>
                    <a:pt x="7610085" y="2738179"/>
                  </a:cubicBezTo>
                  <a:cubicBezTo>
                    <a:pt x="7767635" y="2709126"/>
                    <a:pt x="7926711" y="2688972"/>
                    <a:pt x="8086549" y="2677798"/>
                  </a:cubicBezTo>
                  <a:lnTo>
                    <a:pt x="8086549" y="2486804"/>
                  </a:lnTo>
                  <a:cubicBezTo>
                    <a:pt x="7915022" y="2498295"/>
                    <a:pt x="7744257" y="2519689"/>
                    <a:pt x="7575208" y="2550871"/>
                  </a:cubicBezTo>
                  <a:cubicBezTo>
                    <a:pt x="7523559" y="2560577"/>
                    <a:pt x="7489572" y="2610235"/>
                    <a:pt x="7499101" y="2661908"/>
                  </a:cubicBezTo>
                  <a:close/>
                  <a:moveTo>
                    <a:pt x="7131080" y="4015712"/>
                  </a:moveTo>
                  <a:cubicBezTo>
                    <a:pt x="7150520" y="4064646"/>
                    <a:pt x="7205916" y="4088550"/>
                    <a:pt x="7254833" y="4069101"/>
                  </a:cubicBezTo>
                  <a:cubicBezTo>
                    <a:pt x="7254833" y="4069101"/>
                    <a:pt x="7254833" y="4069101"/>
                    <a:pt x="7254833" y="4069101"/>
                  </a:cubicBezTo>
                  <a:cubicBezTo>
                    <a:pt x="7521336" y="3962939"/>
                    <a:pt x="7801560" y="3895064"/>
                    <a:pt x="8087057" y="3867493"/>
                  </a:cubicBezTo>
                  <a:lnTo>
                    <a:pt x="8087057" y="3675799"/>
                  </a:lnTo>
                  <a:cubicBezTo>
                    <a:pt x="7777546" y="3704051"/>
                    <a:pt x="7473689" y="3776832"/>
                    <a:pt x="7184952" y="3891899"/>
                  </a:cubicBezTo>
                  <a:cubicBezTo>
                    <a:pt x="7135971" y="3911157"/>
                    <a:pt x="7111894" y="3966492"/>
                    <a:pt x="7131080" y="4015502"/>
                  </a:cubicBezTo>
                  <a:cubicBezTo>
                    <a:pt x="7131143" y="4015528"/>
                    <a:pt x="7131143" y="4015559"/>
                    <a:pt x="7131143" y="4015585"/>
                  </a:cubicBezTo>
                  <a:close/>
                  <a:moveTo>
                    <a:pt x="6365942" y="4894731"/>
                  </a:moveTo>
                  <a:cubicBezTo>
                    <a:pt x="5843642" y="5416174"/>
                    <a:pt x="5543800" y="6119929"/>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557220" y="3966771"/>
                  </a:moveTo>
                  <a:cubicBezTo>
                    <a:pt x="4259850" y="4352269"/>
                    <a:pt x="4022589" y="4780624"/>
                    <a:pt x="3853515" y="5237250"/>
                  </a:cubicBezTo>
                  <a:cubicBezTo>
                    <a:pt x="3835238" y="5286641"/>
                    <a:pt x="3860433" y="5341505"/>
                    <a:pt x="3909801" y="5359791"/>
                  </a:cubicBezTo>
                  <a:cubicBezTo>
                    <a:pt x="3959169" y="5378077"/>
                    <a:pt x="4014007" y="5352869"/>
                    <a:pt x="4032284" y="5303478"/>
                  </a:cubicBezTo>
                  <a:cubicBezTo>
                    <a:pt x="4669044" y="3583607"/>
                    <a:pt x="6257778" y="2399677"/>
                    <a:pt x="8087184" y="2281763"/>
                  </a:cubicBezTo>
                  <a:lnTo>
                    <a:pt x="8087184" y="2091086"/>
                  </a:lnTo>
                  <a:cubicBezTo>
                    <a:pt x="7191432" y="2144743"/>
                    <a:pt x="6328670" y="2448611"/>
                    <a:pt x="5596865" y="2968198"/>
                  </a:cubicBezTo>
                  <a:cubicBezTo>
                    <a:pt x="5202550" y="3247304"/>
                    <a:pt x="4852133" y="3583791"/>
                    <a:pt x="4557220" y="3966517"/>
                  </a:cubicBezTo>
                  <a:close/>
                  <a:moveTo>
                    <a:pt x="6932489" y="261735"/>
                  </a:moveTo>
                  <a:cubicBezTo>
                    <a:pt x="6468922" y="362681"/>
                    <a:pt x="6017234" y="512059"/>
                    <a:pt x="5584858" y="707410"/>
                  </a:cubicBezTo>
                  <a:cubicBezTo>
                    <a:pt x="5536862" y="729014"/>
                    <a:pt x="5515466" y="785454"/>
                    <a:pt x="5537059" y="833473"/>
                  </a:cubicBezTo>
                  <a:cubicBezTo>
                    <a:pt x="5558659" y="881491"/>
                    <a:pt x="5615073" y="902898"/>
                    <a:pt x="5663062" y="881294"/>
                  </a:cubicBezTo>
                  <a:cubicBezTo>
                    <a:pt x="5663151" y="881256"/>
                    <a:pt x="5663234" y="881218"/>
                    <a:pt x="5663316" y="881180"/>
                  </a:cubicBezTo>
                  <a:cubicBezTo>
                    <a:pt x="6083519" y="691317"/>
                    <a:pt x="6522476" y="546157"/>
                    <a:pt x="6973021" y="448090"/>
                  </a:cubicBezTo>
                  <a:cubicBezTo>
                    <a:pt x="7339644" y="368564"/>
                    <a:pt x="7712366" y="320214"/>
                    <a:pt x="8087184" y="303557"/>
                  </a:cubicBezTo>
                  <a:lnTo>
                    <a:pt x="8087184" y="112881"/>
                  </a:lnTo>
                  <a:cubicBezTo>
                    <a:pt x="7698771" y="129641"/>
                    <a:pt x="7312454" y="179439"/>
                    <a:pt x="6932489" y="261735"/>
                  </a:cubicBezTo>
                  <a:close/>
                  <a:moveTo>
                    <a:pt x="7678505" y="1431218"/>
                  </a:moveTo>
                  <a:cubicBezTo>
                    <a:pt x="7684286" y="1483553"/>
                    <a:pt x="7731361" y="1521288"/>
                    <a:pt x="7783708" y="1515497"/>
                  </a:cubicBezTo>
                  <a:cubicBezTo>
                    <a:pt x="7783708" y="1515497"/>
                    <a:pt x="7783708" y="1515497"/>
                    <a:pt x="7783708" y="1515497"/>
                  </a:cubicBezTo>
                  <a:cubicBezTo>
                    <a:pt x="7883957" y="1504438"/>
                    <a:pt x="7985284" y="1496430"/>
                    <a:pt x="8086866" y="1490582"/>
                  </a:cubicBezTo>
                  <a:lnTo>
                    <a:pt x="8086866" y="1299906"/>
                  </a:lnTo>
                  <a:cubicBezTo>
                    <a:pt x="7978233" y="1305689"/>
                    <a:pt x="7869917" y="1314397"/>
                    <a:pt x="7762871" y="1326283"/>
                  </a:cubicBezTo>
                  <a:cubicBezTo>
                    <a:pt x="7710778" y="1332016"/>
                    <a:pt x="7673105" y="1378750"/>
                    <a:pt x="7678505" y="1430901"/>
                  </a:cubicBezTo>
                  <a:close/>
                  <a:moveTo>
                    <a:pt x="5303173" y="1289991"/>
                  </a:moveTo>
                  <a:cubicBezTo>
                    <a:pt x="4389549" y="1793110"/>
                    <a:pt x="3611369" y="2510187"/>
                    <a:pt x="3035203" y="3379869"/>
                  </a:cubicBezTo>
                  <a:cubicBezTo>
                    <a:pt x="3007435" y="3424596"/>
                    <a:pt x="3021164" y="3483375"/>
                    <a:pt x="3065869" y="3511163"/>
                  </a:cubicBezTo>
                  <a:cubicBezTo>
                    <a:pt x="3108738" y="3537807"/>
                    <a:pt x="3164935" y="3526385"/>
                    <a:pt x="3194025" y="3485123"/>
                  </a:cubicBezTo>
                  <a:cubicBezTo>
                    <a:pt x="3753101" y="2641067"/>
                    <a:pt x="4508272" y="1945117"/>
                    <a:pt x="5394908" y="1456833"/>
                  </a:cubicBezTo>
                  <a:cubicBezTo>
                    <a:pt x="6222818" y="1002126"/>
                    <a:pt x="7143722" y="742952"/>
                    <a:pt x="8087184" y="699147"/>
                  </a:cubicBezTo>
                  <a:lnTo>
                    <a:pt x="8087184" y="508471"/>
                  </a:lnTo>
                  <a:cubicBezTo>
                    <a:pt x="7111767" y="552630"/>
                    <a:pt x="6159410" y="820081"/>
                    <a:pt x="5303490" y="1290245"/>
                  </a:cubicBezTo>
                  <a:close/>
                  <a:moveTo>
                    <a:pt x="6957138" y="1164907"/>
                  </a:moveTo>
                  <a:cubicBezTo>
                    <a:pt x="6968955" y="1216211"/>
                    <a:pt x="7020159" y="1248207"/>
                    <a:pt x="7071426" y="1236366"/>
                  </a:cubicBezTo>
                  <a:cubicBezTo>
                    <a:pt x="7071426" y="1236360"/>
                    <a:pt x="7071490" y="1236353"/>
                    <a:pt x="7071490" y="1236347"/>
                  </a:cubicBezTo>
                  <a:cubicBezTo>
                    <a:pt x="7405269" y="1159485"/>
                    <a:pt x="7745147" y="1112083"/>
                    <a:pt x="8087184" y="1094674"/>
                  </a:cubicBezTo>
                  <a:lnTo>
                    <a:pt x="8087184" y="903998"/>
                  </a:lnTo>
                  <a:cubicBezTo>
                    <a:pt x="7730789" y="921355"/>
                    <a:pt x="7376618" y="970277"/>
                    <a:pt x="7028862" y="1050183"/>
                  </a:cubicBezTo>
                  <a:cubicBezTo>
                    <a:pt x="6977531" y="1061859"/>
                    <a:pt x="6945386" y="1112941"/>
                    <a:pt x="6957075" y="1164284"/>
                  </a:cubicBezTo>
                  <a:cubicBezTo>
                    <a:pt x="6957075" y="1164385"/>
                    <a:pt x="6957138" y="1164487"/>
                    <a:pt x="6957138" y="1164589"/>
                  </a:cubicBezTo>
                  <a:close/>
                  <a:moveTo>
                    <a:pt x="7810517" y="5550150"/>
                  </a:moveTo>
                  <a:cubicBezTo>
                    <a:pt x="7858989" y="5529652"/>
                    <a:pt x="7881733" y="5473708"/>
                    <a:pt x="7861214" y="5425193"/>
                  </a:cubicBezTo>
                  <a:cubicBezTo>
                    <a:pt x="7840693" y="5376679"/>
                    <a:pt x="7784789" y="5353975"/>
                    <a:pt x="7736316" y="5374473"/>
                  </a:cubicBezTo>
                  <a:cubicBezTo>
                    <a:pt x="7136099" y="5627692"/>
                    <a:pt x="6737457" y="6206655"/>
                    <a:pt x="6714968" y="6858000"/>
                  </a:cubicBezTo>
                  <a:lnTo>
                    <a:pt x="6905553" y="6858000"/>
                  </a:lnTo>
                  <a:cubicBezTo>
                    <a:pt x="6927979" y="6283212"/>
                    <a:pt x="7280753" y="5773292"/>
                    <a:pt x="7810517" y="5549832"/>
                  </a:cubicBezTo>
                  <a:close/>
                  <a:moveTo>
                    <a:pt x="6090863" y="6328301"/>
                  </a:moveTo>
                  <a:cubicBezTo>
                    <a:pt x="6039456" y="6317477"/>
                    <a:pt x="5988995" y="6350311"/>
                    <a:pt x="5978037" y="6401711"/>
                  </a:cubicBezTo>
                  <a:cubicBezTo>
                    <a:pt x="5946202" y="6551837"/>
                    <a:pt x="5928338" y="6704569"/>
                    <a:pt x="5924672" y="6858000"/>
                  </a:cubicBezTo>
                  <a:lnTo>
                    <a:pt x="6115258" y="6858000"/>
                  </a:lnTo>
                  <a:cubicBezTo>
                    <a:pt x="6118847" y="6717916"/>
                    <a:pt x="6135282" y="6578469"/>
                    <a:pt x="6164366" y="6441372"/>
                  </a:cubicBezTo>
                  <a:cubicBezTo>
                    <a:pt x="6175293" y="6389889"/>
                    <a:pt x="6142417" y="6339252"/>
                    <a:pt x="6090933" y="6328313"/>
                  </a:cubicBezTo>
                  <a:cubicBezTo>
                    <a:pt x="6090914" y="6328313"/>
                    <a:pt x="6090888" y="6328307"/>
                    <a:pt x="6090863" y="6328301"/>
                  </a:cubicBezTo>
                  <a:close/>
                  <a:moveTo>
                    <a:pt x="5637269" y="5359219"/>
                  </a:moveTo>
                  <a:cubicBezTo>
                    <a:pt x="5590722" y="5334641"/>
                    <a:pt x="5533083" y="5352469"/>
                    <a:pt x="5508516" y="5399039"/>
                  </a:cubicBezTo>
                  <a:cubicBezTo>
                    <a:pt x="5508510" y="5399045"/>
                    <a:pt x="5508503" y="5399058"/>
                    <a:pt x="5508497" y="5399071"/>
                  </a:cubicBezTo>
                  <a:cubicBezTo>
                    <a:pt x="5271929" y="5849588"/>
                    <a:pt x="5143862" y="6349180"/>
                    <a:pt x="5134504" y="6858000"/>
                  </a:cubicBezTo>
                  <a:lnTo>
                    <a:pt x="5325090" y="6858000"/>
                  </a:lnTo>
                  <a:cubicBezTo>
                    <a:pt x="5334410" y="6380165"/>
                    <a:pt x="5454936" y="5911126"/>
                    <a:pt x="5677102" y="5488053"/>
                  </a:cubicBezTo>
                  <a:cubicBezTo>
                    <a:pt x="5701668" y="5441483"/>
                    <a:pt x="5683849" y="5383816"/>
                    <a:pt x="5637301" y="5359238"/>
                  </a:cubicBezTo>
                  <a:cubicBezTo>
                    <a:pt x="5637295" y="5359232"/>
                    <a:pt x="5637282" y="5359225"/>
                    <a:pt x="5637269" y="5359219"/>
                  </a:cubicBezTo>
                  <a:close/>
                  <a:moveTo>
                    <a:pt x="6804289" y="5734216"/>
                  </a:moveTo>
                  <a:cubicBezTo>
                    <a:pt x="6760771" y="5704725"/>
                    <a:pt x="6701563" y="5716108"/>
                    <a:pt x="6672022" y="5759640"/>
                  </a:cubicBezTo>
                  <a:cubicBezTo>
                    <a:pt x="6452404" y="6084724"/>
                    <a:pt x="6330169" y="6465778"/>
                    <a:pt x="6319630" y="6858000"/>
                  </a:cubicBezTo>
                  <a:lnTo>
                    <a:pt x="6510215" y="6858000"/>
                  </a:lnTo>
                  <a:cubicBezTo>
                    <a:pt x="6520761" y="6503851"/>
                    <a:pt x="6631618" y="6160023"/>
                    <a:pt x="6829891" y="5866482"/>
                  </a:cubicBezTo>
                  <a:cubicBezTo>
                    <a:pt x="6859177" y="5822913"/>
                    <a:pt x="6847679" y="5763873"/>
                    <a:pt x="6804289" y="5734407"/>
                  </a:cubicBezTo>
                  <a:close/>
                  <a:moveTo>
                    <a:pt x="4904404" y="6204806"/>
                  </a:moveTo>
                  <a:cubicBezTo>
                    <a:pt x="4852571" y="6195698"/>
                    <a:pt x="4803171" y="6230357"/>
                    <a:pt x="4794068" y="6282220"/>
                  </a:cubicBezTo>
                  <a:cubicBezTo>
                    <a:pt x="4794061" y="6282240"/>
                    <a:pt x="4794061" y="6282265"/>
                    <a:pt x="4794055" y="6282284"/>
                  </a:cubicBezTo>
                  <a:cubicBezTo>
                    <a:pt x="4760766" y="6472452"/>
                    <a:pt x="4742432" y="6664972"/>
                    <a:pt x="4739230" y="6858000"/>
                  </a:cubicBezTo>
                  <a:lnTo>
                    <a:pt x="4929815" y="6858000"/>
                  </a:lnTo>
                  <a:cubicBezTo>
                    <a:pt x="4932922" y="6676031"/>
                    <a:pt x="4950189" y="6494507"/>
                    <a:pt x="4981464" y="6315208"/>
                  </a:cubicBezTo>
                  <a:cubicBezTo>
                    <a:pt x="4990587" y="6263445"/>
                    <a:pt x="4956116" y="6214067"/>
                    <a:pt x="4904404" y="6204806"/>
                  </a:cubicBezTo>
                  <a:close/>
                  <a:moveTo>
                    <a:pt x="7902253" y="6858000"/>
                  </a:moveTo>
                  <a:lnTo>
                    <a:pt x="8087184" y="6858000"/>
                  </a:lnTo>
                  <a:lnTo>
                    <a:pt x="8087184" y="6532261"/>
                  </a:lnTo>
                  <a:cubicBezTo>
                    <a:pt x="7984903" y="6612091"/>
                    <a:pt x="7918389" y="6729230"/>
                    <a:pt x="7902253" y="6858000"/>
                  </a:cubicBezTo>
                  <a:close/>
                  <a:moveTo>
                    <a:pt x="7565551" y="6591561"/>
                  </a:moveTo>
                  <a:cubicBezTo>
                    <a:pt x="7546175" y="6640502"/>
                    <a:pt x="7570062" y="6695925"/>
                    <a:pt x="7619043" y="6715311"/>
                  </a:cubicBezTo>
                  <a:cubicBezTo>
                    <a:pt x="7667959" y="6734760"/>
                    <a:pt x="7723356" y="6710798"/>
                    <a:pt x="7742733" y="6661858"/>
                  </a:cubicBezTo>
                  <a:cubicBezTo>
                    <a:pt x="7807341" y="6499910"/>
                    <a:pt x="7930205" y="6368089"/>
                    <a:pt x="8087184" y="6292326"/>
                  </a:cubicBezTo>
                  <a:lnTo>
                    <a:pt x="8087184" y="6085760"/>
                  </a:lnTo>
                  <a:cubicBezTo>
                    <a:pt x="7849270" y="6172245"/>
                    <a:pt x="7659700" y="6356394"/>
                    <a:pt x="7566250" y="6591752"/>
                  </a:cubicBezTo>
                  <a:close/>
                  <a:moveTo>
                    <a:pt x="7109989" y="6858000"/>
                  </a:moveTo>
                  <a:lnTo>
                    <a:pt x="7300574" y="6858000"/>
                  </a:lnTo>
                  <a:cubicBezTo>
                    <a:pt x="7326176" y="6394974"/>
                    <a:pt x="7641722" y="5998774"/>
                    <a:pt x="8087184" y="5870486"/>
                  </a:cubicBezTo>
                  <a:lnTo>
                    <a:pt x="8087184" y="5673454"/>
                  </a:lnTo>
                  <a:cubicBezTo>
                    <a:pt x="7534740" y="5807487"/>
                    <a:pt x="7136797" y="6289898"/>
                    <a:pt x="7109989" y="6858000"/>
                  </a:cubicBezTo>
                  <a:close/>
                  <a:moveTo>
                    <a:pt x="6578000" y="3403894"/>
                  </a:moveTo>
                  <a:cubicBezTo>
                    <a:pt x="6600998" y="3451093"/>
                    <a:pt x="6657792" y="3470809"/>
                    <a:pt x="6705057" y="3448004"/>
                  </a:cubicBezTo>
                  <a:cubicBezTo>
                    <a:pt x="7047794" y="3281442"/>
                    <a:pt x="7413527" y="3167030"/>
                    <a:pt x="7790061" y="3108536"/>
                  </a:cubicBezTo>
                  <a:cubicBezTo>
                    <a:pt x="7841964" y="3099632"/>
                    <a:pt x="7876778" y="3050348"/>
                    <a:pt x="7867884" y="2998453"/>
                  </a:cubicBezTo>
                  <a:cubicBezTo>
                    <a:pt x="7859180" y="2947694"/>
                    <a:pt x="7811725" y="2913029"/>
                    <a:pt x="7760775" y="2920148"/>
                  </a:cubicBezTo>
                  <a:cubicBezTo>
                    <a:pt x="7365500" y="2981527"/>
                    <a:pt x="6981597" y="3101621"/>
                    <a:pt x="6621771" y="3276459"/>
                  </a:cubicBezTo>
                  <a:cubicBezTo>
                    <a:pt x="6574506" y="3299582"/>
                    <a:pt x="6554940" y="3356607"/>
                    <a:pt x="6578000" y="3403894"/>
                  </a:cubicBezTo>
                  <a:close/>
                </a:path>
              </a:pathLst>
            </a:custGeom>
            <a:solidFill>
              <a:srgbClr val="005CC2">
                <a:alpha val="838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19" name="Google Shape;19;p3"/>
            <p:cNvSpPr/>
            <p:nvPr/>
          </p:nvSpPr>
          <p:spPr>
            <a:xfrm>
              <a:off x="2377837" y="210583"/>
              <a:ext cx="5576288" cy="4831090"/>
            </a:xfrm>
            <a:custGeom>
              <a:avLst/>
              <a:gdLst/>
              <a:ahLst/>
              <a:cxnLst/>
              <a:rect l="l" t="t" r="r" b="b"/>
              <a:pathLst>
                <a:path w="7435051" h="6441453" extrusionOk="0">
                  <a:moveTo>
                    <a:pt x="2213120" y="5039472"/>
                  </a:moveTo>
                  <a:cubicBezTo>
                    <a:pt x="2095083" y="5051103"/>
                    <a:pt x="2103850" y="5229704"/>
                    <a:pt x="2222458" y="5229704"/>
                  </a:cubicBezTo>
                  <a:cubicBezTo>
                    <a:pt x="2353073" y="5228178"/>
                    <a:pt x="2343290" y="5028222"/>
                    <a:pt x="2213120" y="5039472"/>
                  </a:cubicBezTo>
                  <a:close/>
                  <a:moveTo>
                    <a:pt x="1816257" y="949650"/>
                  </a:moveTo>
                  <a:cubicBezTo>
                    <a:pt x="1698221" y="961282"/>
                    <a:pt x="1706988" y="1139882"/>
                    <a:pt x="1825595" y="1139882"/>
                  </a:cubicBezTo>
                  <a:cubicBezTo>
                    <a:pt x="1956274" y="1138420"/>
                    <a:pt x="1946427" y="938337"/>
                    <a:pt x="1816257" y="949650"/>
                  </a:cubicBezTo>
                  <a:close/>
                  <a:moveTo>
                    <a:pt x="1657435" y="6147620"/>
                  </a:moveTo>
                  <a:cubicBezTo>
                    <a:pt x="1527329" y="6136180"/>
                    <a:pt x="1517673" y="6336390"/>
                    <a:pt x="1648097" y="6337788"/>
                  </a:cubicBezTo>
                  <a:cubicBezTo>
                    <a:pt x="1766514" y="6337916"/>
                    <a:pt x="1775281" y="6159125"/>
                    <a:pt x="1657181" y="6147620"/>
                  </a:cubicBezTo>
                  <a:close/>
                  <a:moveTo>
                    <a:pt x="1777377" y="3926811"/>
                  </a:moveTo>
                  <a:cubicBezTo>
                    <a:pt x="1647271" y="3915307"/>
                    <a:pt x="1637614" y="4115517"/>
                    <a:pt x="1767975" y="4116979"/>
                  </a:cubicBezTo>
                  <a:cubicBezTo>
                    <a:pt x="1886583" y="4117487"/>
                    <a:pt x="1895477" y="3938442"/>
                    <a:pt x="1777377" y="3926811"/>
                  </a:cubicBezTo>
                  <a:close/>
                  <a:moveTo>
                    <a:pt x="2671541" y="3056499"/>
                  </a:moveTo>
                  <a:cubicBezTo>
                    <a:pt x="2553506" y="3068131"/>
                    <a:pt x="2562336" y="3246731"/>
                    <a:pt x="2680944" y="3246731"/>
                  </a:cubicBezTo>
                  <a:cubicBezTo>
                    <a:pt x="2811558" y="3245206"/>
                    <a:pt x="2801712" y="3045186"/>
                    <a:pt x="2671541" y="3056499"/>
                  </a:cubicBezTo>
                  <a:close/>
                  <a:moveTo>
                    <a:pt x="3043247" y="3211646"/>
                  </a:moveTo>
                  <a:cubicBezTo>
                    <a:pt x="2925148" y="3223278"/>
                    <a:pt x="2933978" y="3401878"/>
                    <a:pt x="3052649" y="3401878"/>
                  </a:cubicBezTo>
                  <a:cubicBezTo>
                    <a:pt x="3183264" y="3400289"/>
                    <a:pt x="3173354" y="3200333"/>
                    <a:pt x="3043247" y="3211646"/>
                  </a:cubicBezTo>
                  <a:close/>
                  <a:moveTo>
                    <a:pt x="3483564" y="1201216"/>
                  </a:moveTo>
                  <a:cubicBezTo>
                    <a:pt x="3602171" y="1201216"/>
                    <a:pt x="3611002" y="1022616"/>
                    <a:pt x="3492902" y="1010985"/>
                  </a:cubicBezTo>
                  <a:cubicBezTo>
                    <a:pt x="3362796" y="999608"/>
                    <a:pt x="3352949" y="1199627"/>
                    <a:pt x="3483564" y="1201216"/>
                  </a:cubicBezTo>
                  <a:close/>
                  <a:moveTo>
                    <a:pt x="3518314" y="4894812"/>
                  </a:moveTo>
                  <a:cubicBezTo>
                    <a:pt x="3388207" y="4883499"/>
                    <a:pt x="3378551" y="5083518"/>
                    <a:pt x="3508975" y="5085044"/>
                  </a:cubicBezTo>
                  <a:cubicBezTo>
                    <a:pt x="3627646" y="5085044"/>
                    <a:pt x="3636413" y="4906507"/>
                    <a:pt x="3518314" y="4894812"/>
                  </a:cubicBezTo>
                  <a:close/>
                  <a:moveTo>
                    <a:pt x="2488770" y="5643408"/>
                  </a:moveTo>
                  <a:cubicBezTo>
                    <a:pt x="2370670" y="5655039"/>
                    <a:pt x="2379501" y="5833576"/>
                    <a:pt x="2498109" y="5833640"/>
                  </a:cubicBezTo>
                  <a:cubicBezTo>
                    <a:pt x="2628723" y="5832115"/>
                    <a:pt x="2619003" y="5632095"/>
                    <a:pt x="2488770" y="5643408"/>
                  </a:cubicBezTo>
                  <a:close/>
                  <a:moveTo>
                    <a:pt x="1258984" y="4171957"/>
                  </a:moveTo>
                  <a:cubicBezTo>
                    <a:pt x="1128878" y="4160580"/>
                    <a:pt x="1118904" y="4360664"/>
                    <a:pt x="1249582" y="4362189"/>
                  </a:cubicBezTo>
                  <a:cubicBezTo>
                    <a:pt x="1368253" y="4362253"/>
                    <a:pt x="1377084" y="4183652"/>
                    <a:pt x="1258984" y="4171957"/>
                  </a:cubicBezTo>
                  <a:close/>
                  <a:moveTo>
                    <a:pt x="4268713" y="190694"/>
                  </a:moveTo>
                  <a:cubicBezTo>
                    <a:pt x="4399327" y="189105"/>
                    <a:pt x="4389417" y="-10851"/>
                    <a:pt x="4259311" y="463"/>
                  </a:cubicBezTo>
                  <a:cubicBezTo>
                    <a:pt x="4141211" y="12157"/>
                    <a:pt x="4150041" y="190758"/>
                    <a:pt x="4268713" y="190694"/>
                  </a:cubicBezTo>
                  <a:close/>
                  <a:moveTo>
                    <a:pt x="6303786" y="2710803"/>
                  </a:moveTo>
                  <a:cubicBezTo>
                    <a:pt x="6422394" y="2710803"/>
                    <a:pt x="6431225" y="2532266"/>
                    <a:pt x="6313189" y="2520571"/>
                  </a:cubicBezTo>
                  <a:cubicBezTo>
                    <a:pt x="6183082" y="2509448"/>
                    <a:pt x="6173045" y="2709341"/>
                    <a:pt x="6303786" y="2710803"/>
                  </a:cubicBezTo>
                  <a:close/>
                  <a:moveTo>
                    <a:pt x="2820516" y="724970"/>
                  </a:moveTo>
                  <a:cubicBezTo>
                    <a:pt x="2951131" y="723445"/>
                    <a:pt x="2941220" y="523425"/>
                    <a:pt x="2811177" y="534738"/>
                  </a:cubicBezTo>
                  <a:cubicBezTo>
                    <a:pt x="2693141" y="546370"/>
                    <a:pt x="2701908" y="724906"/>
                    <a:pt x="2820516" y="724970"/>
                  </a:cubicBezTo>
                  <a:close/>
                  <a:moveTo>
                    <a:pt x="7332377" y="2638663"/>
                  </a:moveTo>
                  <a:cubicBezTo>
                    <a:pt x="7214341" y="2650358"/>
                    <a:pt x="7223172" y="2828959"/>
                    <a:pt x="7341779" y="2828895"/>
                  </a:cubicBezTo>
                  <a:cubicBezTo>
                    <a:pt x="7472394" y="2827243"/>
                    <a:pt x="7462674" y="2627414"/>
                    <a:pt x="7332377" y="2638663"/>
                  </a:cubicBezTo>
                  <a:close/>
                  <a:moveTo>
                    <a:pt x="7339301" y="1234966"/>
                  </a:moveTo>
                  <a:cubicBezTo>
                    <a:pt x="7469916" y="1233504"/>
                    <a:pt x="7460006" y="1033421"/>
                    <a:pt x="7329899" y="1044798"/>
                  </a:cubicBezTo>
                  <a:cubicBezTo>
                    <a:pt x="7211864" y="1056302"/>
                    <a:pt x="7220694" y="1235157"/>
                    <a:pt x="7339301" y="1234966"/>
                  </a:cubicBezTo>
                  <a:close/>
                  <a:moveTo>
                    <a:pt x="84087" y="3888675"/>
                  </a:moveTo>
                  <a:cubicBezTo>
                    <a:pt x="-33695" y="3900434"/>
                    <a:pt x="-25118" y="4079352"/>
                    <a:pt x="93362" y="4079352"/>
                  </a:cubicBezTo>
                  <a:cubicBezTo>
                    <a:pt x="224104" y="4077445"/>
                    <a:pt x="214067" y="3877425"/>
                    <a:pt x="84087" y="3888675"/>
                  </a:cubicBezTo>
                  <a:close/>
                  <a:moveTo>
                    <a:pt x="488955" y="5693238"/>
                  </a:moveTo>
                  <a:cubicBezTo>
                    <a:pt x="370919" y="5704679"/>
                    <a:pt x="379686" y="5883470"/>
                    <a:pt x="498293" y="5883407"/>
                  </a:cubicBezTo>
                  <a:cubicBezTo>
                    <a:pt x="628908" y="5882135"/>
                    <a:pt x="619125" y="5681925"/>
                    <a:pt x="488955" y="5693366"/>
                  </a:cubicBezTo>
                  <a:close/>
                  <a:moveTo>
                    <a:pt x="722295" y="4567103"/>
                  </a:moveTo>
                  <a:cubicBezTo>
                    <a:pt x="592125" y="4555789"/>
                    <a:pt x="582532" y="4755682"/>
                    <a:pt x="712893" y="4757334"/>
                  </a:cubicBezTo>
                  <a:cubicBezTo>
                    <a:pt x="831501" y="4757334"/>
                    <a:pt x="840458" y="4578734"/>
                    <a:pt x="722295" y="4567103"/>
                  </a:cubicBezTo>
                  <a:close/>
                  <a:moveTo>
                    <a:pt x="1760606" y="2491334"/>
                  </a:moveTo>
                  <a:cubicBezTo>
                    <a:pt x="1891220" y="2489745"/>
                    <a:pt x="1881310" y="2289725"/>
                    <a:pt x="1751203" y="2301102"/>
                  </a:cubicBezTo>
                  <a:cubicBezTo>
                    <a:pt x="1633104" y="2312734"/>
                    <a:pt x="1641998" y="2491334"/>
                    <a:pt x="1760606" y="2491334"/>
                  </a:cubicBezTo>
                  <a:close/>
                  <a:moveTo>
                    <a:pt x="744657" y="3328976"/>
                  </a:moveTo>
                  <a:cubicBezTo>
                    <a:pt x="614551" y="3317536"/>
                    <a:pt x="604894" y="3517682"/>
                    <a:pt x="735255" y="3519144"/>
                  </a:cubicBezTo>
                  <a:cubicBezTo>
                    <a:pt x="853926" y="3519335"/>
                    <a:pt x="862820" y="3340544"/>
                    <a:pt x="744657" y="3328976"/>
                  </a:cubicBezTo>
                  <a:close/>
                  <a:moveTo>
                    <a:pt x="4587626" y="5427499"/>
                  </a:moveTo>
                  <a:cubicBezTo>
                    <a:pt x="4457774" y="5416058"/>
                    <a:pt x="4447546" y="5616269"/>
                    <a:pt x="4578478" y="5617476"/>
                  </a:cubicBezTo>
                  <a:cubicBezTo>
                    <a:pt x="4696832" y="5617858"/>
                    <a:pt x="4705535" y="5439067"/>
                    <a:pt x="4587626" y="5427499"/>
                  </a:cubicBezTo>
                  <a:close/>
                  <a:moveTo>
                    <a:pt x="6524040" y="3476242"/>
                  </a:moveTo>
                  <a:cubicBezTo>
                    <a:pt x="6654718" y="3474844"/>
                    <a:pt x="6644744" y="3274633"/>
                    <a:pt x="6514638" y="3286074"/>
                  </a:cubicBezTo>
                  <a:cubicBezTo>
                    <a:pt x="6396601" y="3297578"/>
                    <a:pt x="6405432" y="3476242"/>
                    <a:pt x="6524040" y="3476051"/>
                  </a:cubicBezTo>
                  <a:close/>
                  <a:moveTo>
                    <a:pt x="6533125" y="1608057"/>
                  </a:moveTo>
                  <a:cubicBezTo>
                    <a:pt x="6403018" y="1596616"/>
                    <a:pt x="6393362" y="1796826"/>
                    <a:pt x="6523785" y="1798225"/>
                  </a:cubicBezTo>
                  <a:cubicBezTo>
                    <a:pt x="6642394" y="1798161"/>
                    <a:pt x="6651224" y="1619624"/>
                    <a:pt x="6533125" y="1607866"/>
                  </a:cubicBezTo>
                  <a:close/>
                  <a:moveTo>
                    <a:pt x="6625368" y="767682"/>
                  </a:moveTo>
                  <a:cubicBezTo>
                    <a:pt x="6495261" y="756304"/>
                    <a:pt x="6485605" y="956324"/>
                    <a:pt x="6616029" y="957913"/>
                  </a:cubicBezTo>
                  <a:cubicBezTo>
                    <a:pt x="6734701" y="957722"/>
                    <a:pt x="6743531" y="779122"/>
                    <a:pt x="6625368" y="767491"/>
                  </a:cubicBezTo>
                  <a:close/>
                  <a:moveTo>
                    <a:pt x="6239178" y="2986775"/>
                  </a:moveTo>
                  <a:cubicBezTo>
                    <a:pt x="6109072" y="2975398"/>
                    <a:pt x="6099097" y="3175418"/>
                    <a:pt x="6229776" y="3177007"/>
                  </a:cubicBezTo>
                  <a:cubicBezTo>
                    <a:pt x="6348383" y="3176816"/>
                    <a:pt x="6357277" y="2998279"/>
                    <a:pt x="6239178" y="2986585"/>
                  </a:cubicBezTo>
                  <a:close/>
                  <a:moveTo>
                    <a:pt x="6514638" y="4652017"/>
                  </a:moveTo>
                  <a:cubicBezTo>
                    <a:pt x="6396538" y="4663649"/>
                    <a:pt x="6405432" y="4842249"/>
                    <a:pt x="6524040" y="4842249"/>
                  </a:cubicBezTo>
                  <a:cubicBezTo>
                    <a:pt x="6654718" y="4840660"/>
                    <a:pt x="6644808" y="4640640"/>
                    <a:pt x="6514638" y="4652017"/>
                  </a:cubicBezTo>
                  <a:close/>
                  <a:moveTo>
                    <a:pt x="6326403" y="5437732"/>
                  </a:moveTo>
                  <a:cubicBezTo>
                    <a:pt x="6196296" y="5426355"/>
                    <a:pt x="6186640" y="5626375"/>
                    <a:pt x="6317001" y="5627964"/>
                  </a:cubicBezTo>
                  <a:cubicBezTo>
                    <a:pt x="6435671" y="5628027"/>
                    <a:pt x="6444502" y="5449363"/>
                    <a:pt x="6326403" y="5437732"/>
                  </a:cubicBezTo>
                  <a:close/>
                  <a:moveTo>
                    <a:pt x="7229651" y="6251285"/>
                  </a:moveTo>
                  <a:cubicBezTo>
                    <a:pt x="7099545" y="6239781"/>
                    <a:pt x="7089888" y="6440055"/>
                    <a:pt x="7220249" y="6441453"/>
                  </a:cubicBezTo>
                  <a:cubicBezTo>
                    <a:pt x="7338857" y="6441453"/>
                    <a:pt x="7347751" y="6262662"/>
                    <a:pt x="7229651" y="6251094"/>
                  </a:cubicBezTo>
                  <a:close/>
                  <a:moveTo>
                    <a:pt x="6776566" y="3604694"/>
                  </a:moveTo>
                  <a:cubicBezTo>
                    <a:pt x="6658530" y="3616389"/>
                    <a:pt x="6667297" y="3794926"/>
                    <a:pt x="6785968" y="3794926"/>
                  </a:cubicBezTo>
                  <a:cubicBezTo>
                    <a:pt x="6916329" y="3793337"/>
                    <a:pt x="6906481" y="3593381"/>
                    <a:pt x="6776566" y="3604694"/>
                  </a:cubicBezTo>
                  <a:close/>
                  <a:moveTo>
                    <a:pt x="7330281" y="5086315"/>
                  </a:moveTo>
                  <a:cubicBezTo>
                    <a:pt x="7212244" y="5097946"/>
                    <a:pt x="7221075" y="5276610"/>
                    <a:pt x="7339683" y="5276546"/>
                  </a:cubicBezTo>
                  <a:cubicBezTo>
                    <a:pt x="7470107" y="5275021"/>
                    <a:pt x="7460324" y="5074938"/>
                    <a:pt x="7330090" y="5086315"/>
                  </a:cubicBezTo>
                  <a:close/>
                  <a:moveTo>
                    <a:pt x="7149732" y="2268942"/>
                  </a:moveTo>
                  <a:cubicBezTo>
                    <a:pt x="7031697" y="2280573"/>
                    <a:pt x="7040464" y="2459173"/>
                    <a:pt x="7159071" y="2459173"/>
                  </a:cubicBezTo>
                  <a:cubicBezTo>
                    <a:pt x="7289495" y="2457711"/>
                    <a:pt x="7279775" y="2257628"/>
                    <a:pt x="7149542" y="2268942"/>
                  </a:cubicBezTo>
                  <a:close/>
                  <a:moveTo>
                    <a:pt x="4803179" y="4171957"/>
                  </a:moveTo>
                  <a:cubicBezTo>
                    <a:pt x="4673072" y="4160580"/>
                    <a:pt x="4663416" y="4360600"/>
                    <a:pt x="4793840" y="4362189"/>
                  </a:cubicBezTo>
                  <a:cubicBezTo>
                    <a:pt x="4912511" y="4362189"/>
                    <a:pt x="4921532" y="4183589"/>
                    <a:pt x="4803179" y="4171957"/>
                  </a:cubicBezTo>
                  <a:close/>
                  <a:moveTo>
                    <a:pt x="4264139" y="1897059"/>
                  </a:moveTo>
                  <a:cubicBezTo>
                    <a:pt x="4146039" y="1908626"/>
                    <a:pt x="4154870" y="2087227"/>
                    <a:pt x="4273477" y="2087290"/>
                  </a:cubicBezTo>
                  <a:cubicBezTo>
                    <a:pt x="4404092" y="2085765"/>
                    <a:pt x="4394245" y="1885682"/>
                    <a:pt x="4264139" y="1897059"/>
                  </a:cubicBezTo>
                  <a:close/>
                  <a:moveTo>
                    <a:pt x="4141592" y="4439731"/>
                  </a:moveTo>
                  <a:cubicBezTo>
                    <a:pt x="4023556" y="4451362"/>
                    <a:pt x="4032386" y="4629962"/>
                    <a:pt x="4150995" y="4629962"/>
                  </a:cubicBezTo>
                  <a:cubicBezTo>
                    <a:pt x="4281609" y="4628373"/>
                    <a:pt x="4271826" y="4428417"/>
                    <a:pt x="4141592" y="4439731"/>
                  </a:cubicBezTo>
                  <a:close/>
                  <a:moveTo>
                    <a:pt x="4444560" y="5923067"/>
                  </a:moveTo>
                  <a:cubicBezTo>
                    <a:pt x="4326460" y="5934698"/>
                    <a:pt x="4335354" y="6113363"/>
                    <a:pt x="4453962" y="6113299"/>
                  </a:cubicBezTo>
                  <a:cubicBezTo>
                    <a:pt x="4584831" y="6111774"/>
                    <a:pt x="4574730" y="5911754"/>
                    <a:pt x="4444560" y="5923067"/>
                  </a:cubicBezTo>
                  <a:close/>
                  <a:moveTo>
                    <a:pt x="4149660" y="722555"/>
                  </a:moveTo>
                  <a:cubicBezTo>
                    <a:pt x="4280339" y="721029"/>
                    <a:pt x="4270365" y="521010"/>
                    <a:pt x="4140322" y="532323"/>
                  </a:cubicBezTo>
                  <a:cubicBezTo>
                    <a:pt x="4022222" y="543954"/>
                    <a:pt x="4031053" y="722491"/>
                    <a:pt x="4149660" y="722555"/>
                  </a:cubicBezTo>
                  <a:close/>
                  <a:moveTo>
                    <a:pt x="5149473" y="5067883"/>
                  </a:moveTo>
                  <a:cubicBezTo>
                    <a:pt x="5031437" y="5079514"/>
                    <a:pt x="5040267" y="5258178"/>
                    <a:pt x="5158875" y="5258115"/>
                  </a:cubicBezTo>
                  <a:cubicBezTo>
                    <a:pt x="5289489" y="5256589"/>
                    <a:pt x="5279643" y="5056569"/>
                    <a:pt x="5149473" y="5067883"/>
                  </a:cubicBezTo>
                  <a:close/>
                  <a:moveTo>
                    <a:pt x="5180729" y="418362"/>
                  </a:moveTo>
                  <a:cubicBezTo>
                    <a:pt x="5062692" y="430057"/>
                    <a:pt x="5071523" y="608657"/>
                    <a:pt x="5190131" y="608594"/>
                  </a:cubicBezTo>
                  <a:cubicBezTo>
                    <a:pt x="5320746" y="607259"/>
                    <a:pt x="5310962" y="407303"/>
                    <a:pt x="5180729" y="418362"/>
                  </a:cubicBezTo>
                  <a:close/>
                  <a:moveTo>
                    <a:pt x="3703309" y="5642900"/>
                  </a:moveTo>
                  <a:cubicBezTo>
                    <a:pt x="3578793" y="5643599"/>
                    <a:pt x="3578793" y="5832877"/>
                    <a:pt x="3703309" y="5833576"/>
                  </a:cubicBezTo>
                  <a:cubicBezTo>
                    <a:pt x="3827825" y="5832941"/>
                    <a:pt x="3827888" y="5643662"/>
                    <a:pt x="3703309" y="5642900"/>
                  </a:cubicBezTo>
                  <a:close/>
                  <a:moveTo>
                    <a:pt x="5646456" y="6045926"/>
                  </a:moveTo>
                  <a:cubicBezTo>
                    <a:pt x="5516350" y="6034422"/>
                    <a:pt x="5506694" y="6234696"/>
                    <a:pt x="5637118" y="6236094"/>
                  </a:cubicBezTo>
                  <a:cubicBezTo>
                    <a:pt x="5755726" y="6236222"/>
                    <a:pt x="5764556" y="6057430"/>
                    <a:pt x="5646456" y="6045926"/>
                  </a:cubicBezTo>
                  <a:close/>
                  <a:moveTo>
                    <a:pt x="5906225" y="1406067"/>
                  </a:moveTo>
                  <a:cubicBezTo>
                    <a:pt x="5776118" y="1394689"/>
                    <a:pt x="5766462" y="1594773"/>
                    <a:pt x="5896886" y="1596298"/>
                  </a:cubicBezTo>
                  <a:cubicBezTo>
                    <a:pt x="6015494" y="1596298"/>
                    <a:pt x="6024324" y="1417698"/>
                    <a:pt x="5906225" y="1406067"/>
                  </a:cubicBezTo>
                  <a:close/>
                </a:path>
              </a:pathLst>
            </a:custGeom>
            <a:solidFill>
              <a:srgbClr val="005CC2">
                <a:alpha val="838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20" name="Google Shape;20;p3"/>
          <p:cNvSpPr txBox="1">
            <a:spLocks noGrp="1"/>
          </p:cNvSpPr>
          <p:nvPr>
            <p:ph type="ctrTitle"/>
          </p:nvPr>
        </p:nvSpPr>
        <p:spPr>
          <a:xfrm>
            <a:off x="685800" y="1668151"/>
            <a:ext cx="7772400" cy="1311600"/>
          </a:xfrm>
          <a:prstGeom prst="rect">
            <a:avLst/>
          </a:prstGeom>
        </p:spPr>
        <p:txBody>
          <a:bodyPr spcFirstLastPara="1" wrap="square" lIns="0" tIns="0" rIns="0" bIns="0" anchor="b" anchorCtr="0">
            <a:noAutofit/>
          </a:bodyPr>
          <a:lstStyle>
            <a:lvl1pPr lvl="0" rtl="0">
              <a:spcBef>
                <a:spcPts val="0"/>
              </a:spcBef>
              <a:spcAft>
                <a:spcPts val="0"/>
              </a:spcAft>
              <a:buClr>
                <a:schemeClr val="accent2"/>
              </a:buClr>
              <a:buSzPts val="4800"/>
              <a:buNone/>
              <a:defRPr sz="4800">
                <a:solidFill>
                  <a:schemeClr val="accent2"/>
                </a:solidFill>
              </a:defRPr>
            </a:lvl1pPr>
            <a:lvl2pPr lvl="1" rtl="0">
              <a:spcBef>
                <a:spcPts val="0"/>
              </a:spcBef>
              <a:spcAft>
                <a:spcPts val="0"/>
              </a:spcAft>
              <a:buClr>
                <a:schemeClr val="accent2"/>
              </a:buClr>
              <a:buSzPts val="4800"/>
              <a:buNone/>
              <a:defRPr sz="4800">
                <a:solidFill>
                  <a:schemeClr val="accent2"/>
                </a:solidFill>
              </a:defRPr>
            </a:lvl2pPr>
            <a:lvl3pPr lvl="2" rtl="0">
              <a:spcBef>
                <a:spcPts val="0"/>
              </a:spcBef>
              <a:spcAft>
                <a:spcPts val="0"/>
              </a:spcAft>
              <a:buClr>
                <a:schemeClr val="accent2"/>
              </a:buClr>
              <a:buSzPts val="4800"/>
              <a:buNone/>
              <a:defRPr sz="4800">
                <a:solidFill>
                  <a:schemeClr val="accent2"/>
                </a:solidFill>
              </a:defRPr>
            </a:lvl3pPr>
            <a:lvl4pPr lvl="3" rtl="0">
              <a:spcBef>
                <a:spcPts val="0"/>
              </a:spcBef>
              <a:spcAft>
                <a:spcPts val="0"/>
              </a:spcAft>
              <a:buClr>
                <a:schemeClr val="accent2"/>
              </a:buClr>
              <a:buSzPts val="4800"/>
              <a:buNone/>
              <a:defRPr sz="4800">
                <a:solidFill>
                  <a:schemeClr val="accent2"/>
                </a:solidFill>
              </a:defRPr>
            </a:lvl4pPr>
            <a:lvl5pPr lvl="4" rtl="0">
              <a:spcBef>
                <a:spcPts val="0"/>
              </a:spcBef>
              <a:spcAft>
                <a:spcPts val="0"/>
              </a:spcAft>
              <a:buClr>
                <a:schemeClr val="accent2"/>
              </a:buClr>
              <a:buSzPts val="4800"/>
              <a:buNone/>
              <a:defRPr sz="4800">
                <a:solidFill>
                  <a:schemeClr val="accent2"/>
                </a:solidFill>
              </a:defRPr>
            </a:lvl5pPr>
            <a:lvl6pPr lvl="5" rtl="0">
              <a:spcBef>
                <a:spcPts val="0"/>
              </a:spcBef>
              <a:spcAft>
                <a:spcPts val="0"/>
              </a:spcAft>
              <a:buClr>
                <a:schemeClr val="accent2"/>
              </a:buClr>
              <a:buSzPts val="4800"/>
              <a:buNone/>
              <a:defRPr sz="4800">
                <a:solidFill>
                  <a:schemeClr val="accent2"/>
                </a:solidFill>
              </a:defRPr>
            </a:lvl6pPr>
            <a:lvl7pPr lvl="6" rtl="0">
              <a:spcBef>
                <a:spcPts val="0"/>
              </a:spcBef>
              <a:spcAft>
                <a:spcPts val="0"/>
              </a:spcAft>
              <a:buClr>
                <a:schemeClr val="accent2"/>
              </a:buClr>
              <a:buSzPts val="4800"/>
              <a:buNone/>
              <a:defRPr sz="4800">
                <a:solidFill>
                  <a:schemeClr val="accent2"/>
                </a:solidFill>
              </a:defRPr>
            </a:lvl7pPr>
            <a:lvl8pPr lvl="7" rtl="0">
              <a:spcBef>
                <a:spcPts val="0"/>
              </a:spcBef>
              <a:spcAft>
                <a:spcPts val="0"/>
              </a:spcAft>
              <a:buClr>
                <a:schemeClr val="accent2"/>
              </a:buClr>
              <a:buSzPts val="4800"/>
              <a:buNone/>
              <a:defRPr sz="4800">
                <a:solidFill>
                  <a:schemeClr val="accent2"/>
                </a:solidFill>
              </a:defRPr>
            </a:lvl8pPr>
            <a:lvl9pPr lvl="8" rtl="0">
              <a:spcBef>
                <a:spcPts val="0"/>
              </a:spcBef>
              <a:spcAft>
                <a:spcPts val="0"/>
              </a:spcAft>
              <a:buClr>
                <a:schemeClr val="accent2"/>
              </a:buClr>
              <a:buSzPts val="4800"/>
              <a:buNone/>
              <a:defRPr sz="4800">
                <a:solidFill>
                  <a:schemeClr val="accent2"/>
                </a:solidFill>
              </a:defRPr>
            </a:lvl9pPr>
          </a:lstStyle>
          <a:p>
            <a:endParaRPr/>
          </a:p>
        </p:txBody>
      </p:sp>
      <p:sp>
        <p:nvSpPr>
          <p:cNvPr id="21" name="Google Shape;21;p3"/>
          <p:cNvSpPr txBox="1">
            <a:spLocks noGrp="1"/>
          </p:cNvSpPr>
          <p:nvPr>
            <p:ph type="subTitle" idx="1"/>
          </p:nvPr>
        </p:nvSpPr>
        <p:spPr>
          <a:xfrm>
            <a:off x="685800" y="3076652"/>
            <a:ext cx="7772400" cy="398700"/>
          </a:xfrm>
          <a:prstGeom prst="rect">
            <a:avLst/>
          </a:prstGeom>
        </p:spPr>
        <p:txBody>
          <a:bodyPr spcFirstLastPara="1" wrap="square" lIns="0" tIns="0" rIns="0" bIns="0" anchor="t" anchorCtr="0">
            <a:noAutofit/>
          </a:bodyPr>
          <a:lstStyle>
            <a:lvl1pPr lvl="0" rtl="0">
              <a:spcBef>
                <a:spcPts val="0"/>
              </a:spcBef>
              <a:spcAft>
                <a:spcPts val="0"/>
              </a:spcAft>
              <a:buClr>
                <a:schemeClr val="dk1"/>
              </a:buClr>
              <a:buSzPts val="2400"/>
              <a:buNone/>
              <a:defRPr/>
            </a:lvl1pPr>
            <a:lvl2pPr lvl="1" rtl="0">
              <a:spcBef>
                <a:spcPts val="600"/>
              </a:spcBef>
              <a:spcAft>
                <a:spcPts val="0"/>
              </a:spcAft>
              <a:buClr>
                <a:schemeClr val="dk1"/>
              </a:buClr>
              <a:buSzPts val="3000"/>
              <a:buNone/>
              <a:defRPr sz="3000"/>
            </a:lvl2pPr>
            <a:lvl3pPr lvl="2" rtl="0">
              <a:spcBef>
                <a:spcPts val="600"/>
              </a:spcBef>
              <a:spcAft>
                <a:spcPts val="0"/>
              </a:spcAft>
              <a:buSzPts val="3000"/>
              <a:buNone/>
              <a:defRPr sz="3000"/>
            </a:lvl3pPr>
            <a:lvl4pPr lvl="3" rtl="0">
              <a:spcBef>
                <a:spcPts val="600"/>
              </a:spcBef>
              <a:spcAft>
                <a:spcPts val="0"/>
              </a:spcAft>
              <a:buSzPts val="3000"/>
              <a:buNone/>
              <a:defRPr sz="3000"/>
            </a:lvl4pPr>
            <a:lvl5pPr lvl="4" rtl="0">
              <a:spcBef>
                <a:spcPts val="600"/>
              </a:spcBef>
              <a:spcAft>
                <a:spcPts val="0"/>
              </a:spcAft>
              <a:buSzPts val="3000"/>
              <a:buNone/>
              <a:defRPr sz="3000"/>
            </a:lvl5pPr>
            <a:lvl6pPr lvl="5" rtl="0">
              <a:spcBef>
                <a:spcPts val="600"/>
              </a:spcBef>
              <a:spcAft>
                <a:spcPts val="0"/>
              </a:spcAft>
              <a:buSzPts val="3000"/>
              <a:buNone/>
              <a:defRPr sz="3000"/>
            </a:lvl6pPr>
            <a:lvl7pPr lvl="6" rtl="0">
              <a:spcBef>
                <a:spcPts val="600"/>
              </a:spcBef>
              <a:spcAft>
                <a:spcPts val="0"/>
              </a:spcAft>
              <a:buSzPts val="3000"/>
              <a:buNone/>
              <a:defRPr sz="3000"/>
            </a:lvl7pPr>
            <a:lvl8pPr lvl="7" rtl="0">
              <a:spcBef>
                <a:spcPts val="600"/>
              </a:spcBef>
              <a:spcAft>
                <a:spcPts val="0"/>
              </a:spcAft>
              <a:buSzPts val="3000"/>
              <a:buNone/>
              <a:defRPr sz="3000"/>
            </a:lvl8pPr>
            <a:lvl9pPr lvl="8" rtl="0">
              <a:spcBef>
                <a:spcPts val="600"/>
              </a:spcBef>
              <a:spcAft>
                <a:spcPts val="600"/>
              </a:spcAft>
              <a:buSzPts val="3000"/>
              <a:buNone/>
              <a:defRPr sz="3000"/>
            </a:lvl9pPr>
          </a:lstStyle>
          <a:p>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Quote">
  <p:cSld name="TITLE_1_1">
    <p:bg>
      <p:bgPr>
        <a:gradFill>
          <a:gsLst>
            <a:gs pos="0">
              <a:schemeClr val="dk1"/>
            </a:gs>
            <a:gs pos="100000">
              <a:schemeClr val="accent2"/>
            </a:gs>
          </a:gsLst>
          <a:path path="circle">
            <a:fillToRect l="100000" t="100000"/>
          </a:path>
          <a:tileRect r="-100000" b="-100000"/>
        </a:gradFill>
        <a:effectLst/>
      </p:bgPr>
    </p:bg>
    <p:spTree>
      <p:nvGrpSpPr>
        <p:cNvPr id="1" name="Shape 22"/>
        <p:cNvGrpSpPr/>
        <p:nvPr/>
      </p:nvGrpSpPr>
      <p:grpSpPr>
        <a:xfrm>
          <a:off x="0" y="0"/>
          <a:ext cx="0" cy="0"/>
          <a:chOff x="0" y="0"/>
          <a:chExt cx="0" cy="0"/>
        </a:xfrm>
      </p:grpSpPr>
      <p:grpSp>
        <p:nvGrpSpPr>
          <p:cNvPr id="23" name="Google Shape;23;p4"/>
          <p:cNvGrpSpPr/>
          <p:nvPr/>
        </p:nvGrpSpPr>
        <p:grpSpPr>
          <a:xfrm>
            <a:off x="3078602" y="0"/>
            <a:ext cx="6065389" cy="5143642"/>
            <a:chOff x="2052402" y="0"/>
            <a:chExt cx="6065389" cy="5143642"/>
          </a:xfrm>
        </p:grpSpPr>
        <p:sp>
          <p:nvSpPr>
            <p:cNvPr id="24" name="Google Shape;24;p4"/>
            <p:cNvSpPr/>
            <p:nvPr/>
          </p:nvSpPr>
          <p:spPr>
            <a:xfrm>
              <a:off x="2052402" y="0"/>
              <a:ext cx="6065388" cy="5143500"/>
            </a:xfrm>
            <a:custGeom>
              <a:avLst/>
              <a:gdLst/>
              <a:ahLst/>
              <a:cxnLst/>
              <a:rect l="l" t="t" r="r" b="b"/>
              <a:pathLst>
                <a:path w="8087184" h="6858000" extrusionOk="0">
                  <a:moveTo>
                    <a:pt x="7505580" y="6858000"/>
                  </a:moveTo>
                  <a:lnTo>
                    <a:pt x="7696738" y="6858000"/>
                  </a:lnTo>
                  <a:cubicBezTo>
                    <a:pt x="7718274" y="6613807"/>
                    <a:pt x="7866550" y="6398978"/>
                    <a:pt x="8087184" y="6292327"/>
                  </a:cubicBezTo>
                  <a:lnTo>
                    <a:pt x="8087184" y="6085824"/>
                  </a:lnTo>
                  <a:cubicBezTo>
                    <a:pt x="7757916" y="6205690"/>
                    <a:pt x="7529976" y="6508299"/>
                    <a:pt x="7505580" y="6858000"/>
                  </a:cubicBezTo>
                  <a:close/>
                  <a:moveTo>
                    <a:pt x="7109988" y="6858000"/>
                  </a:moveTo>
                  <a:lnTo>
                    <a:pt x="7300574" y="6858000"/>
                  </a:lnTo>
                  <a:cubicBezTo>
                    <a:pt x="7326176" y="6394974"/>
                    <a:pt x="7641722" y="5998774"/>
                    <a:pt x="8087184" y="5870486"/>
                  </a:cubicBezTo>
                  <a:lnTo>
                    <a:pt x="8087184" y="5673454"/>
                  </a:lnTo>
                  <a:cubicBezTo>
                    <a:pt x="7534740" y="5807487"/>
                    <a:pt x="7136797" y="6289898"/>
                    <a:pt x="7109988" y="6858000"/>
                  </a:cubicBezTo>
                  <a:close/>
                  <a:moveTo>
                    <a:pt x="6319630" y="6858000"/>
                  </a:moveTo>
                  <a:lnTo>
                    <a:pt x="6510215" y="6858000"/>
                  </a:lnTo>
                  <a:cubicBezTo>
                    <a:pt x="6538485" y="5958928"/>
                    <a:pt x="7199691" y="5205998"/>
                    <a:pt x="8087184" y="5062145"/>
                  </a:cubicBezTo>
                  <a:lnTo>
                    <a:pt x="8087184" y="4869180"/>
                  </a:lnTo>
                  <a:cubicBezTo>
                    <a:pt x="7093725" y="5015188"/>
                    <a:pt x="6348402" y="5853783"/>
                    <a:pt x="6319630" y="6858000"/>
                  </a:cubicBezTo>
                  <a:close/>
                  <a:moveTo>
                    <a:pt x="6714777" y="6858000"/>
                  </a:moveTo>
                  <a:lnTo>
                    <a:pt x="6905363" y="6858000"/>
                  </a:lnTo>
                  <a:cubicBezTo>
                    <a:pt x="6932680" y="6177012"/>
                    <a:pt x="7419944" y="5602103"/>
                    <a:pt x="8086993" y="5463773"/>
                  </a:cubicBezTo>
                  <a:lnTo>
                    <a:pt x="8086993" y="5269538"/>
                  </a:lnTo>
                  <a:cubicBezTo>
                    <a:pt x="7313661" y="5411166"/>
                    <a:pt x="6742920" y="6071943"/>
                    <a:pt x="6714968" y="6858000"/>
                  </a:cubicBezTo>
                  <a:close/>
                  <a:moveTo>
                    <a:pt x="7902253" y="6858000"/>
                  </a:moveTo>
                  <a:lnTo>
                    <a:pt x="8087184" y="6858000"/>
                  </a:lnTo>
                  <a:lnTo>
                    <a:pt x="8087184" y="6532261"/>
                  </a:lnTo>
                  <a:cubicBezTo>
                    <a:pt x="7984903" y="6612091"/>
                    <a:pt x="7918389" y="6729230"/>
                    <a:pt x="7902253" y="6858000"/>
                  </a:cubicBezTo>
                  <a:close/>
                  <a:moveTo>
                    <a:pt x="1916910" y="2551824"/>
                  </a:moveTo>
                  <a:cubicBezTo>
                    <a:pt x="2641015" y="1478290"/>
                    <a:pt x="3620238" y="601442"/>
                    <a:pt x="4766674" y="0"/>
                  </a:cubicBezTo>
                  <a:lnTo>
                    <a:pt x="4372797" y="0"/>
                  </a:lnTo>
                  <a:cubicBezTo>
                    <a:pt x="4217787" y="90127"/>
                    <a:pt x="4065999" y="185317"/>
                    <a:pt x="3917425" y="285570"/>
                  </a:cubicBezTo>
                  <a:cubicBezTo>
                    <a:pt x="2632356" y="1153193"/>
                    <a:pt x="1626642" y="2375366"/>
                    <a:pt x="1022365" y="3803743"/>
                  </a:cubicBezTo>
                  <a:cubicBezTo>
                    <a:pt x="613622" y="4771490"/>
                    <a:pt x="402707" y="5798792"/>
                    <a:pt x="395021" y="6858000"/>
                  </a:cubicBezTo>
                  <a:lnTo>
                    <a:pt x="585606" y="6858000"/>
                  </a:lnTo>
                  <a:cubicBezTo>
                    <a:pt x="593293" y="5824406"/>
                    <a:pt x="799126" y="4822147"/>
                    <a:pt x="1197894" y="3877980"/>
                  </a:cubicBezTo>
                  <a:cubicBezTo>
                    <a:pt x="1394236" y="3413753"/>
                    <a:pt x="1635028" y="2969629"/>
                    <a:pt x="1916910" y="2551824"/>
                  </a:cubicBezTo>
                  <a:close/>
                  <a:moveTo>
                    <a:pt x="1589421" y="2330830"/>
                  </a:moveTo>
                  <a:cubicBezTo>
                    <a:pt x="2178972" y="1457633"/>
                    <a:pt x="2930502" y="705726"/>
                    <a:pt x="3803264" y="115868"/>
                  </a:cubicBezTo>
                  <a:cubicBezTo>
                    <a:pt x="3861583" y="76504"/>
                    <a:pt x="3920429" y="37881"/>
                    <a:pt x="3979810" y="0"/>
                  </a:cubicBezTo>
                  <a:lnTo>
                    <a:pt x="3635104" y="0"/>
                  </a:lnTo>
                  <a:cubicBezTo>
                    <a:pt x="2315489" y="907938"/>
                    <a:pt x="1282730" y="2174291"/>
                    <a:pt x="658473" y="3649867"/>
                  </a:cubicBezTo>
                  <a:cubicBezTo>
                    <a:pt x="229084" y="4666364"/>
                    <a:pt x="7814" y="5745720"/>
                    <a:pt x="0" y="6858000"/>
                  </a:cubicBezTo>
                  <a:lnTo>
                    <a:pt x="190586" y="6858000"/>
                  </a:lnTo>
                  <a:cubicBezTo>
                    <a:pt x="198336" y="5771144"/>
                    <a:pt x="414587" y="4716957"/>
                    <a:pt x="833939" y="3724104"/>
                  </a:cubicBezTo>
                  <a:cubicBezTo>
                    <a:pt x="1040191" y="3236353"/>
                    <a:pt x="1293200" y="2769749"/>
                    <a:pt x="1589421" y="2330830"/>
                  </a:cubicBezTo>
                  <a:close/>
                  <a:moveTo>
                    <a:pt x="2572017" y="2993622"/>
                  </a:moveTo>
                  <a:cubicBezTo>
                    <a:pt x="3332930" y="1865656"/>
                    <a:pt x="4404701" y="982881"/>
                    <a:pt x="5657281" y="452412"/>
                  </a:cubicBezTo>
                  <a:cubicBezTo>
                    <a:pt x="6154760" y="241841"/>
                    <a:pt x="6675072" y="90013"/>
                    <a:pt x="7207695" y="0"/>
                  </a:cubicBezTo>
                  <a:lnTo>
                    <a:pt x="6359208" y="0"/>
                  </a:lnTo>
                  <a:cubicBezTo>
                    <a:pt x="4284670" y="610249"/>
                    <a:pt x="2593089" y="2119237"/>
                    <a:pt x="1750212" y="4111495"/>
                  </a:cubicBezTo>
                  <a:cubicBezTo>
                    <a:pt x="1382635" y="4981807"/>
                    <a:pt x="1192558" y="5905571"/>
                    <a:pt x="1184807" y="6858000"/>
                  </a:cubicBezTo>
                  <a:lnTo>
                    <a:pt x="1375393" y="6858000"/>
                  </a:lnTo>
                  <a:cubicBezTo>
                    <a:pt x="1383080" y="5931185"/>
                    <a:pt x="1568075" y="5032463"/>
                    <a:pt x="1925741" y="4185732"/>
                  </a:cubicBezTo>
                  <a:cubicBezTo>
                    <a:pt x="2102147" y="3768398"/>
                    <a:pt x="2318583" y="3369160"/>
                    <a:pt x="2572017" y="2993622"/>
                  </a:cubicBezTo>
                  <a:close/>
                  <a:moveTo>
                    <a:pt x="2244464" y="2772819"/>
                  </a:moveTo>
                  <a:cubicBezTo>
                    <a:pt x="3048163" y="1581236"/>
                    <a:pt x="4180312" y="648682"/>
                    <a:pt x="5503478" y="88347"/>
                  </a:cubicBezTo>
                  <a:cubicBezTo>
                    <a:pt x="5576110" y="57669"/>
                    <a:pt x="5649085" y="28220"/>
                    <a:pt x="5722398" y="0"/>
                  </a:cubicBezTo>
                  <a:lnTo>
                    <a:pt x="5231195" y="0"/>
                  </a:lnTo>
                  <a:cubicBezTo>
                    <a:pt x="3500048" y="791829"/>
                    <a:pt x="2128257" y="2203840"/>
                    <a:pt x="1386320" y="3957619"/>
                  </a:cubicBezTo>
                  <a:cubicBezTo>
                    <a:pt x="998097" y="4876680"/>
                    <a:pt x="797664" y="5852181"/>
                    <a:pt x="789914" y="6858000"/>
                  </a:cubicBezTo>
                  <a:lnTo>
                    <a:pt x="980500" y="6858000"/>
                  </a:lnTo>
                  <a:cubicBezTo>
                    <a:pt x="988250" y="5877796"/>
                    <a:pt x="1183791" y="4927273"/>
                    <a:pt x="1561849" y="4031856"/>
                  </a:cubicBezTo>
                  <a:cubicBezTo>
                    <a:pt x="1748217" y="3591107"/>
                    <a:pt x="1976824" y="3169458"/>
                    <a:pt x="2244464" y="2772819"/>
                  </a:cubicBezTo>
                  <a:close/>
                  <a:moveTo>
                    <a:pt x="6645086" y="5174199"/>
                  </a:moveTo>
                  <a:cubicBezTo>
                    <a:pt x="6196994" y="5621603"/>
                    <a:pt x="5938846" y="6224801"/>
                    <a:pt x="5924482" y="6858000"/>
                  </a:cubicBezTo>
                  <a:lnTo>
                    <a:pt x="6115068" y="6858000"/>
                  </a:lnTo>
                  <a:cubicBezTo>
                    <a:pt x="6144113" y="5740903"/>
                    <a:pt x="6980009" y="4810427"/>
                    <a:pt x="8087184" y="4662805"/>
                  </a:cubicBezTo>
                  <a:lnTo>
                    <a:pt x="8087184" y="4470476"/>
                  </a:lnTo>
                  <a:cubicBezTo>
                    <a:pt x="7541283" y="4536958"/>
                    <a:pt x="7033500" y="4784755"/>
                    <a:pt x="6645086" y="5174199"/>
                  </a:cubicBezTo>
                  <a:close/>
                  <a:moveTo>
                    <a:pt x="5248665" y="3776858"/>
                  </a:moveTo>
                  <a:cubicBezTo>
                    <a:pt x="4429655" y="4594492"/>
                    <a:pt x="3963299" y="5700524"/>
                    <a:pt x="3949506" y="6858000"/>
                  </a:cubicBezTo>
                  <a:lnTo>
                    <a:pt x="4140092" y="6858000"/>
                  </a:lnTo>
                  <a:cubicBezTo>
                    <a:pt x="4168387" y="4649426"/>
                    <a:pt x="5884840" y="2831630"/>
                    <a:pt x="8087184" y="2677862"/>
                  </a:cubicBezTo>
                  <a:lnTo>
                    <a:pt x="8087184" y="2486740"/>
                  </a:lnTo>
                  <a:cubicBezTo>
                    <a:pt x="7015966" y="2558053"/>
                    <a:pt x="6007247" y="3016624"/>
                    <a:pt x="5248983" y="3776985"/>
                  </a:cubicBezTo>
                  <a:close/>
                  <a:moveTo>
                    <a:pt x="4410660" y="2938516"/>
                  </a:moveTo>
                  <a:cubicBezTo>
                    <a:pt x="3369116" y="3978263"/>
                    <a:pt x="2777913" y="5386016"/>
                    <a:pt x="2764635" y="6858000"/>
                  </a:cubicBezTo>
                  <a:lnTo>
                    <a:pt x="2955221" y="6858000"/>
                  </a:lnTo>
                  <a:cubicBezTo>
                    <a:pt x="2982996" y="3994566"/>
                    <a:pt x="5229175" y="1645170"/>
                    <a:pt x="8087184" y="1490201"/>
                  </a:cubicBezTo>
                  <a:lnTo>
                    <a:pt x="8087184" y="1299524"/>
                  </a:lnTo>
                  <a:cubicBezTo>
                    <a:pt x="6701118" y="1371556"/>
                    <a:pt x="5391045" y="1955579"/>
                    <a:pt x="4410660" y="2938516"/>
                  </a:cubicBezTo>
                  <a:close/>
                  <a:moveTo>
                    <a:pt x="4131135" y="2658858"/>
                  </a:moveTo>
                  <a:cubicBezTo>
                    <a:pt x="3581562" y="3207390"/>
                    <a:pt x="3143742" y="3857527"/>
                    <a:pt x="2842013" y="4573123"/>
                  </a:cubicBezTo>
                  <a:cubicBezTo>
                    <a:pt x="2536123" y="5297313"/>
                    <a:pt x="2377365" y="6065676"/>
                    <a:pt x="2369615" y="6858000"/>
                  </a:cubicBezTo>
                  <a:lnTo>
                    <a:pt x="2560201" y="6858000"/>
                  </a:lnTo>
                  <a:cubicBezTo>
                    <a:pt x="2567887" y="6091353"/>
                    <a:pt x="2721563" y="5347905"/>
                    <a:pt x="3017606" y="4647360"/>
                  </a:cubicBezTo>
                  <a:cubicBezTo>
                    <a:pt x="3885813" y="2587735"/>
                    <a:pt x="5855795" y="1207104"/>
                    <a:pt x="8087184" y="1094420"/>
                  </a:cubicBezTo>
                  <a:lnTo>
                    <a:pt x="8087184" y="903743"/>
                  </a:lnTo>
                  <a:cubicBezTo>
                    <a:pt x="6596296" y="976143"/>
                    <a:pt x="5185918" y="1602077"/>
                    <a:pt x="4131643" y="2659239"/>
                  </a:cubicBezTo>
                  <a:close/>
                  <a:moveTo>
                    <a:pt x="3851609" y="2379199"/>
                  </a:moveTo>
                  <a:cubicBezTo>
                    <a:pt x="3266022" y="2963794"/>
                    <a:pt x="2799525" y="3656649"/>
                    <a:pt x="2478058" y="4419247"/>
                  </a:cubicBezTo>
                  <a:cubicBezTo>
                    <a:pt x="2151585" y="5192123"/>
                    <a:pt x="1982535" y="6012350"/>
                    <a:pt x="1974721" y="6858000"/>
                  </a:cubicBezTo>
                  <a:lnTo>
                    <a:pt x="2165307" y="6858000"/>
                  </a:lnTo>
                  <a:cubicBezTo>
                    <a:pt x="2172994" y="6038091"/>
                    <a:pt x="2337152" y="5242779"/>
                    <a:pt x="2653651" y="4493611"/>
                  </a:cubicBezTo>
                  <a:cubicBezTo>
                    <a:pt x="3583550" y="2287642"/>
                    <a:pt x="5696853" y="811831"/>
                    <a:pt x="8087184" y="699147"/>
                  </a:cubicBezTo>
                  <a:lnTo>
                    <a:pt x="8087184" y="508471"/>
                  </a:lnTo>
                  <a:cubicBezTo>
                    <a:pt x="6491347" y="580803"/>
                    <a:pt x="4980435" y="1248328"/>
                    <a:pt x="3851990" y="2379580"/>
                  </a:cubicBezTo>
                  <a:close/>
                  <a:moveTo>
                    <a:pt x="6365561" y="4894350"/>
                  </a:moveTo>
                  <a:cubicBezTo>
                    <a:pt x="5843312" y="5415945"/>
                    <a:pt x="5543596" y="6119847"/>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689995" y="3217985"/>
                  </a:moveTo>
                  <a:cubicBezTo>
                    <a:pt x="3722659" y="4183711"/>
                    <a:pt x="3173060" y="5490862"/>
                    <a:pt x="3159529" y="6858000"/>
                  </a:cubicBezTo>
                  <a:lnTo>
                    <a:pt x="3350115" y="6858000"/>
                  </a:lnTo>
                  <a:cubicBezTo>
                    <a:pt x="3378080" y="4212840"/>
                    <a:pt x="5447656" y="2040614"/>
                    <a:pt x="8087184" y="1885982"/>
                  </a:cubicBezTo>
                  <a:lnTo>
                    <a:pt x="8087184" y="1694988"/>
                  </a:lnTo>
                  <a:cubicBezTo>
                    <a:pt x="6806004" y="1766892"/>
                    <a:pt x="5596357" y="2309182"/>
                    <a:pt x="4689995" y="3217985"/>
                  </a:cubicBezTo>
                  <a:close/>
                  <a:moveTo>
                    <a:pt x="5736946" y="640864"/>
                  </a:moveTo>
                  <a:cubicBezTo>
                    <a:pt x="4104688" y="1332467"/>
                    <a:pt x="2805440" y="2632335"/>
                    <a:pt x="2114167" y="4265371"/>
                  </a:cubicBezTo>
                  <a:cubicBezTo>
                    <a:pt x="1767110" y="5086996"/>
                    <a:pt x="1587515" y="5958960"/>
                    <a:pt x="1579828" y="6858000"/>
                  </a:cubicBezTo>
                  <a:lnTo>
                    <a:pt x="1770414" y="6858000"/>
                  </a:lnTo>
                  <a:cubicBezTo>
                    <a:pt x="1778101" y="5984575"/>
                    <a:pt x="1952613" y="5137589"/>
                    <a:pt x="2289696" y="4339608"/>
                  </a:cubicBezTo>
                  <a:cubicBezTo>
                    <a:pt x="3281262" y="1987231"/>
                    <a:pt x="5537892" y="416179"/>
                    <a:pt x="8087184" y="303430"/>
                  </a:cubicBezTo>
                  <a:lnTo>
                    <a:pt x="8087184" y="112753"/>
                  </a:lnTo>
                  <a:cubicBezTo>
                    <a:pt x="7278466" y="146573"/>
                    <a:pt x="6482453" y="325450"/>
                    <a:pt x="5736946" y="640864"/>
                  </a:cubicBezTo>
                  <a:close/>
                  <a:moveTo>
                    <a:pt x="4969330" y="3497453"/>
                  </a:moveTo>
                  <a:cubicBezTo>
                    <a:pt x="4076132" y="4389101"/>
                    <a:pt x="3568132" y="5595696"/>
                    <a:pt x="3554486" y="6858000"/>
                  </a:cubicBezTo>
                  <a:lnTo>
                    <a:pt x="3745072" y="6858000"/>
                  </a:lnTo>
                  <a:cubicBezTo>
                    <a:pt x="3773202" y="4431107"/>
                    <a:pt x="5666194" y="2436046"/>
                    <a:pt x="8087184" y="2281763"/>
                  </a:cubicBezTo>
                  <a:lnTo>
                    <a:pt x="8087184" y="2091086"/>
                  </a:lnTo>
                  <a:cubicBezTo>
                    <a:pt x="6910953" y="2162571"/>
                    <a:pt x="5801707" y="2662919"/>
                    <a:pt x="4969330" y="3497453"/>
                  </a:cubicBezTo>
                  <a:close/>
                  <a:moveTo>
                    <a:pt x="6086607" y="4615263"/>
                  </a:moveTo>
                  <a:cubicBezTo>
                    <a:pt x="5490118" y="5210739"/>
                    <a:pt x="5148633" y="6015070"/>
                    <a:pt x="5134441" y="6858000"/>
                  </a:cubicBezTo>
                  <a:lnTo>
                    <a:pt x="5325027" y="6858000"/>
                  </a:lnTo>
                  <a:cubicBezTo>
                    <a:pt x="5353570" y="5304190"/>
                    <a:pt x="6541217" y="4018292"/>
                    <a:pt x="8087184" y="3867302"/>
                  </a:cubicBezTo>
                  <a:lnTo>
                    <a:pt x="8087184" y="3675799"/>
                  </a:lnTo>
                  <a:cubicBezTo>
                    <a:pt x="7330940" y="3744977"/>
                    <a:pt x="6622978" y="4077447"/>
                    <a:pt x="6086607" y="4615263"/>
                  </a:cubicBezTo>
                  <a:close/>
                  <a:moveTo>
                    <a:pt x="5807081" y="4335604"/>
                  </a:moveTo>
                  <a:cubicBezTo>
                    <a:pt x="5136353" y="5005171"/>
                    <a:pt x="4753231" y="5910147"/>
                    <a:pt x="4739230" y="6858000"/>
                  </a:cubicBezTo>
                  <a:lnTo>
                    <a:pt x="4929815" y="6858000"/>
                  </a:lnTo>
                  <a:cubicBezTo>
                    <a:pt x="4958327" y="5085840"/>
                    <a:pt x="6322177" y="3622499"/>
                    <a:pt x="8087184" y="3470313"/>
                  </a:cubicBezTo>
                  <a:lnTo>
                    <a:pt x="8087184" y="3279192"/>
                  </a:lnTo>
                  <a:cubicBezTo>
                    <a:pt x="7225928" y="3349227"/>
                    <a:pt x="6417654" y="3723799"/>
                    <a:pt x="5807335" y="4335794"/>
                  </a:cubicBezTo>
                  <a:close/>
                  <a:moveTo>
                    <a:pt x="5527556" y="4055945"/>
                  </a:moveTo>
                  <a:cubicBezTo>
                    <a:pt x="4782753" y="4799672"/>
                    <a:pt x="4358160" y="5805294"/>
                    <a:pt x="4344463" y="6858000"/>
                  </a:cubicBezTo>
                  <a:lnTo>
                    <a:pt x="4535049" y="6858000"/>
                  </a:lnTo>
                  <a:cubicBezTo>
                    <a:pt x="4563415" y="4867661"/>
                    <a:pt x="6103486" y="3227074"/>
                    <a:pt x="8087184" y="3074024"/>
                  </a:cubicBezTo>
                  <a:lnTo>
                    <a:pt x="8087184" y="2882775"/>
                  </a:lnTo>
                  <a:cubicBezTo>
                    <a:pt x="7120852" y="2953516"/>
                    <a:pt x="6212355" y="3370126"/>
                    <a:pt x="5528000" y="4056326"/>
                  </a:cubicBezTo>
                  <a:close/>
                </a:path>
              </a:pathLst>
            </a:custGeom>
            <a:solidFill>
              <a:srgbClr val="005CC2">
                <a:alpha val="838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25" name="Google Shape;25;p4"/>
            <p:cNvSpPr/>
            <p:nvPr/>
          </p:nvSpPr>
          <p:spPr>
            <a:xfrm>
              <a:off x="2052402" y="0"/>
              <a:ext cx="6065388" cy="5143642"/>
            </a:xfrm>
            <a:custGeom>
              <a:avLst/>
              <a:gdLst/>
              <a:ahLst/>
              <a:cxnLst/>
              <a:rect l="l" t="t" r="r" b="b"/>
              <a:pathLst>
                <a:path w="8087184" h="6858190" extrusionOk="0">
                  <a:moveTo>
                    <a:pt x="6366259" y="1870219"/>
                  </a:moveTo>
                  <a:cubicBezTo>
                    <a:pt x="6414478" y="1849137"/>
                    <a:pt x="6436522" y="1792932"/>
                    <a:pt x="6415430" y="1744684"/>
                  </a:cubicBezTo>
                  <a:cubicBezTo>
                    <a:pt x="6395292" y="1698629"/>
                    <a:pt x="6342913" y="1676110"/>
                    <a:pt x="6295679" y="1693208"/>
                  </a:cubicBezTo>
                  <a:cubicBezTo>
                    <a:pt x="4468935" y="2426156"/>
                    <a:pt x="3157737" y="4060756"/>
                    <a:pt x="2838011" y="6003706"/>
                  </a:cubicBezTo>
                  <a:cubicBezTo>
                    <a:pt x="2829536" y="6055671"/>
                    <a:pt x="2864769" y="6104675"/>
                    <a:pt x="2916716" y="6113154"/>
                  </a:cubicBezTo>
                  <a:cubicBezTo>
                    <a:pt x="2916716" y="6113154"/>
                    <a:pt x="2916723" y="6113154"/>
                    <a:pt x="2916723" y="6113154"/>
                  </a:cubicBezTo>
                  <a:cubicBezTo>
                    <a:pt x="2921824" y="6114012"/>
                    <a:pt x="2926989" y="6114438"/>
                    <a:pt x="2932160" y="6114425"/>
                  </a:cubicBezTo>
                  <a:cubicBezTo>
                    <a:pt x="2978841" y="6114381"/>
                    <a:pt x="3018616" y="6080504"/>
                    <a:pt x="3026119" y="6034405"/>
                  </a:cubicBezTo>
                  <a:cubicBezTo>
                    <a:pt x="3335065" y="4157486"/>
                    <a:pt x="4601646" y="2578418"/>
                    <a:pt x="6366259" y="1870219"/>
                  </a:cubicBezTo>
                  <a:close/>
                  <a:moveTo>
                    <a:pt x="2680460" y="5322927"/>
                  </a:moveTo>
                  <a:cubicBezTo>
                    <a:pt x="2629555" y="5309637"/>
                    <a:pt x="2577512" y="5340139"/>
                    <a:pt x="2564203" y="5391062"/>
                  </a:cubicBezTo>
                  <a:cubicBezTo>
                    <a:pt x="2439623" y="5870239"/>
                    <a:pt x="2374272" y="6362877"/>
                    <a:pt x="2369615" y="6858000"/>
                  </a:cubicBezTo>
                  <a:lnTo>
                    <a:pt x="2560201" y="6858000"/>
                  </a:lnTo>
                  <a:cubicBezTo>
                    <a:pt x="2564794" y="6379148"/>
                    <a:pt x="2628055" y="5902679"/>
                    <a:pt x="2748563" y="5439240"/>
                  </a:cubicBezTo>
                  <a:cubicBezTo>
                    <a:pt x="2761847" y="5388310"/>
                    <a:pt x="2731365" y="5336243"/>
                    <a:pt x="2680460" y="5322927"/>
                  </a:cubicBezTo>
                  <a:close/>
                  <a:moveTo>
                    <a:pt x="2239000" y="4214715"/>
                  </a:moveTo>
                  <a:cubicBezTo>
                    <a:pt x="2190503" y="4194261"/>
                    <a:pt x="2134617" y="4217016"/>
                    <a:pt x="2114179" y="4265537"/>
                  </a:cubicBezTo>
                  <a:cubicBezTo>
                    <a:pt x="2114173" y="4265543"/>
                    <a:pt x="2114173" y="4265556"/>
                    <a:pt x="2114167" y="4265562"/>
                  </a:cubicBezTo>
                  <a:cubicBezTo>
                    <a:pt x="1767110" y="5087187"/>
                    <a:pt x="1587515" y="5959151"/>
                    <a:pt x="1579828" y="6858191"/>
                  </a:cubicBezTo>
                  <a:lnTo>
                    <a:pt x="1770414" y="6858191"/>
                  </a:lnTo>
                  <a:cubicBezTo>
                    <a:pt x="1778101" y="5984765"/>
                    <a:pt x="1952613" y="5137780"/>
                    <a:pt x="2289696" y="4339799"/>
                  </a:cubicBezTo>
                  <a:cubicBezTo>
                    <a:pt x="2310254" y="4291329"/>
                    <a:pt x="2287638" y="4235359"/>
                    <a:pt x="2239191" y="4214797"/>
                  </a:cubicBezTo>
                  <a:cubicBezTo>
                    <a:pt x="2239127" y="4214766"/>
                    <a:pt x="2239064" y="4214740"/>
                    <a:pt x="2239000" y="4214715"/>
                  </a:cubicBezTo>
                  <a:close/>
                  <a:moveTo>
                    <a:pt x="2087612" y="6428088"/>
                  </a:moveTo>
                  <a:cubicBezTo>
                    <a:pt x="2035093" y="6424847"/>
                    <a:pt x="1989898" y="6464825"/>
                    <a:pt x="1986665" y="6517389"/>
                  </a:cubicBezTo>
                  <a:cubicBezTo>
                    <a:pt x="1979740" y="6630078"/>
                    <a:pt x="1975738" y="6744357"/>
                    <a:pt x="1974658" y="6858000"/>
                  </a:cubicBezTo>
                  <a:lnTo>
                    <a:pt x="2165244" y="6858000"/>
                  </a:lnTo>
                  <a:cubicBezTo>
                    <a:pt x="2166260" y="6748234"/>
                    <a:pt x="2170135" y="6637896"/>
                    <a:pt x="2176806" y="6529083"/>
                  </a:cubicBezTo>
                  <a:cubicBezTo>
                    <a:pt x="2180027" y="6476584"/>
                    <a:pt x="2140105" y="6431330"/>
                    <a:pt x="2087612" y="6428088"/>
                  </a:cubicBezTo>
                  <a:close/>
                  <a:moveTo>
                    <a:pt x="3486447" y="3682663"/>
                  </a:moveTo>
                  <a:cubicBezTo>
                    <a:pt x="3518040" y="3682689"/>
                    <a:pt x="3547593" y="3667047"/>
                    <a:pt x="3565349" y="3640906"/>
                  </a:cubicBezTo>
                  <a:cubicBezTo>
                    <a:pt x="3898042" y="3151394"/>
                    <a:pt x="4303100" y="2715260"/>
                    <a:pt x="4766674" y="2347419"/>
                  </a:cubicBezTo>
                  <a:cubicBezTo>
                    <a:pt x="4807898" y="2314686"/>
                    <a:pt x="4814797" y="2254712"/>
                    <a:pt x="4782080" y="2213469"/>
                  </a:cubicBezTo>
                  <a:cubicBezTo>
                    <a:pt x="4749362" y="2172225"/>
                    <a:pt x="4689417" y="2165323"/>
                    <a:pt x="4648193" y="2198056"/>
                  </a:cubicBezTo>
                  <a:cubicBezTo>
                    <a:pt x="4169519" y="2577934"/>
                    <a:pt x="3751284" y="3028338"/>
                    <a:pt x="3407798" y="3533872"/>
                  </a:cubicBezTo>
                  <a:cubicBezTo>
                    <a:pt x="3378188" y="3577397"/>
                    <a:pt x="3389451" y="3636704"/>
                    <a:pt x="3432956" y="3666329"/>
                  </a:cubicBezTo>
                  <a:cubicBezTo>
                    <a:pt x="3448730" y="3677071"/>
                    <a:pt x="3467363" y="3682829"/>
                    <a:pt x="3486447" y="3682854"/>
                  </a:cubicBezTo>
                  <a:close/>
                  <a:moveTo>
                    <a:pt x="5285003" y="4471365"/>
                  </a:moveTo>
                  <a:cubicBezTo>
                    <a:pt x="5242903" y="4439770"/>
                    <a:pt x="5183174" y="4448313"/>
                    <a:pt x="5151593" y="4490433"/>
                  </a:cubicBezTo>
                  <a:cubicBezTo>
                    <a:pt x="4638429" y="5174034"/>
                    <a:pt x="4355873" y="6003210"/>
                    <a:pt x="4344781" y="6858064"/>
                  </a:cubicBezTo>
                  <a:lnTo>
                    <a:pt x="4535367" y="6858064"/>
                  </a:lnTo>
                  <a:cubicBezTo>
                    <a:pt x="4546427" y="6044479"/>
                    <a:pt x="4815610" y="5255459"/>
                    <a:pt x="5304062" y="4604903"/>
                  </a:cubicBezTo>
                  <a:cubicBezTo>
                    <a:pt x="5335661" y="4562795"/>
                    <a:pt x="5327161" y="4503030"/>
                    <a:pt x="5285074" y="4471416"/>
                  </a:cubicBezTo>
                  <a:cubicBezTo>
                    <a:pt x="5285048" y="4471403"/>
                    <a:pt x="5285029" y="4471384"/>
                    <a:pt x="5285003" y="4471365"/>
                  </a:cubicBezTo>
                  <a:close/>
                  <a:moveTo>
                    <a:pt x="6701690" y="2808030"/>
                  </a:moveTo>
                  <a:cubicBezTo>
                    <a:pt x="5767433" y="3193508"/>
                    <a:pt x="4991743" y="3885022"/>
                    <a:pt x="4501697" y="4769266"/>
                  </a:cubicBezTo>
                  <a:cubicBezTo>
                    <a:pt x="4475720" y="4815060"/>
                    <a:pt x="4491773" y="4873248"/>
                    <a:pt x="4537546" y="4899237"/>
                  </a:cubicBezTo>
                  <a:cubicBezTo>
                    <a:pt x="4583318" y="4925227"/>
                    <a:pt x="4641478" y="4909165"/>
                    <a:pt x="4667455" y="4863371"/>
                  </a:cubicBezTo>
                  <a:cubicBezTo>
                    <a:pt x="4667792" y="4862767"/>
                    <a:pt x="4668129" y="4862164"/>
                    <a:pt x="4668459" y="4861553"/>
                  </a:cubicBezTo>
                  <a:cubicBezTo>
                    <a:pt x="5137446" y="4015222"/>
                    <a:pt x="5879860" y="3353378"/>
                    <a:pt x="6774050" y="2984470"/>
                  </a:cubicBezTo>
                  <a:cubicBezTo>
                    <a:pt x="6822775" y="2964480"/>
                    <a:pt x="6846027" y="2908777"/>
                    <a:pt x="6826079" y="2860053"/>
                  </a:cubicBezTo>
                  <a:cubicBezTo>
                    <a:pt x="6806067" y="2811329"/>
                    <a:pt x="6750416" y="2788041"/>
                    <a:pt x="6701690" y="2808030"/>
                  </a:cubicBezTo>
                  <a:close/>
                  <a:moveTo>
                    <a:pt x="4156864" y="5925783"/>
                  </a:moveTo>
                  <a:cubicBezTo>
                    <a:pt x="4105367" y="5914933"/>
                    <a:pt x="4054824" y="5947901"/>
                    <a:pt x="4043980" y="5999428"/>
                  </a:cubicBezTo>
                  <a:cubicBezTo>
                    <a:pt x="4043973" y="5999435"/>
                    <a:pt x="4043973" y="5999441"/>
                    <a:pt x="4043973" y="5999447"/>
                  </a:cubicBezTo>
                  <a:cubicBezTo>
                    <a:pt x="3984905" y="6281916"/>
                    <a:pt x="3953267" y="6569443"/>
                    <a:pt x="3949506" y="6858000"/>
                  </a:cubicBezTo>
                  <a:lnTo>
                    <a:pt x="4140092" y="6858000"/>
                  </a:lnTo>
                  <a:cubicBezTo>
                    <a:pt x="4143866" y="6582600"/>
                    <a:pt x="4174143" y="6308242"/>
                    <a:pt x="4230493" y="6038663"/>
                  </a:cubicBezTo>
                  <a:cubicBezTo>
                    <a:pt x="4241299" y="5987155"/>
                    <a:pt x="4208341" y="5936626"/>
                    <a:pt x="4156864" y="5925783"/>
                  </a:cubicBezTo>
                  <a:close/>
                  <a:moveTo>
                    <a:pt x="5530160" y="2764810"/>
                  </a:moveTo>
                  <a:cubicBezTo>
                    <a:pt x="5974498" y="2457948"/>
                    <a:pt x="6465491" y="2225005"/>
                    <a:pt x="6984202" y="2075006"/>
                  </a:cubicBezTo>
                  <a:cubicBezTo>
                    <a:pt x="7034770" y="2060368"/>
                    <a:pt x="7063867" y="2007494"/>
                    <a:pt x="7049255" y="1956914"/>
                  </a:cubicBezTo>
                  <a:cubicBezTo>
                    <a:pt x="7034643" y="1906333"/>
                    <a:pt x="6981788" y="1877192"/>
                    <a:pt x="6931219" y="1891829"/>
                  </a:cubicBezTo>
                  <a:cubicBezTo>
                    <a:pt x="4715915" y="2532477"/>
                    <a:pt x="3182876" y="4551024"/>
                    <a:pt x="3159529" y="6858000"/>
                  </a:cubicBezTo>
                  <a:lnTo>
                    <a:pt x="3350115" y="6858000"/>
                  </a:lnTo>
                  <a:cubicBezTo>
                    <a:pt x="3368665" y="5220209"/>
                    <a:pt x="4181729" y="3693627"/>
                    <a:pt x="5530160" y="2764810"/>
                  </a:cubicBezTo>
                  <a:close/>
                  <a:moveTo>
                    <a:pt x="3857517" y="1312554"/>
                  </a:moveTo>
                  <a:cubicBezTo>
                    <a:pt x="2821278" y="2150298"/>
                    <a:pt x="2037615" y="3259196"/>
                    <a:pt x="1593677" y="4515920"/>
                  </a:cubicBezTo>
                  <a:cubicBezTo>
                    <a:pt x="1576137" y="4565572"/>
                    <a:pt x="1602146" y="4620055"/>
                    <a:pt x="1651774" y="4637604"/>
                  </a:cubicBezTo>
                  <a:cubicBezTo>
                    <a:pt x="1701402" y="4655152"/>
                    <a:pt x="1755859" y="4629131"/>
                    <a:pt x="1773399" y="4579479"/>
                  </a:cubicBezTo>
                  <a:cubicBezTo>
                    <a:pt x="2205610" y="3355958"/>
                    <a:pt x="2968581" y="2276360"/>
                    <a:pt x="3977459" y="1460773"/>
                  </a:cubicBezTo>
                  <a:cubicBezTo>
                    <a:pt x="4018371" y="1427634"/>
                    <a:pt x="4024686" y="1367596"/>
                    <a:pt x="3991562" y="1326664"/>
                  </a:cubicBezTo>
                  <a:cubicBezTo>
                    <a:pt x="3958439" y="1285732"/>
                    <a:pt x="3898430" y="1279414"/>
                    <a:pt x="3857517" y="1312554"/>
                  </a:cubicBezTo>
                  <a:close/>
                  <a:moveTo>
                    <a:pt x="2248403" y="2598095"/>
                  </a:moveTo>
                  <a:cubicBezTo>
                    <a:pt x="2204981" y="2568350"/>
                    <a:pt x="2145683" y="2579447"/>
                    <a:pt x="2115945" y="2622883"/>
                  </a:cubicBezTo>
                  <a:cubicBezTo>
                    <a:pt x="1635860" y="3322742"/>
                    <a:pt x="1277191" y="4098599"/>
                    <a:pt x="1055019" y="4917803"/>
                  </a:cubicBezTo>
                  <a:cubicBezTo>
                    <a:pt x="1039321" y="4968059"/>
                    <a:pt x="1067311" y="5021531"/>
                    <a:pt x="1117543" y="5037242"/>
                  </a:cubicBezTo>
                  <a:cubicBezTo>
                    <a:pt x="1167775" y="5052948"/>
                    <a:pt x="1221222" y="5024944"/>
                    <a:pt x="1236926" y="4974688"/>
                  </a:cubicBezTo>
                  <a:cubicBezTo>
                    <a:pt x="1237638" y="4972400"/>
                    <a:pt x="1238267" y="4970093"/>
                    <a:pt x="1238807" y="4967760"/>
                  </a:cubicBezTo>
                  <a:cubicBezTo>
                    <a:pt x="1455452" y="4169149"/>
                    <a:pt x="1805119" y="3412786"/>
                    <a:pt x="2273115" y="2730488"/>
                  </a:cubicBezTo>
                  <a:cubicBezTo>
                    <a:pt x="2302770" y="2687090"/>
                    <a:pt x="2291716" y="2627860"/>
                    <a:pt x="2248403" y="2598095"/>
                  </a:cubicBezTo>
                  <a:close/>
                  <a:moveTo>
                    <a:pt x="3182082" y="972450"/>
                  </a:moveTo>
                  <a:cubicBezTo>
                    <a:pt x="3216304" y="1012264"/>
                    <a:pt x="3276263" y="1016897"/>
                    <a:pt x="3316190" y="982811"/>
                  </a:cubicBezTo>
                  <a:cubicBezTo>
                    <a:pt x="3760979" y="601738"/>
                    <a:pt x="4247290" y="272053"/>
                    <a:pt x="4765912" y="0"/>
                  </a:cubicBezTo>
                  <a:lnTo>
                    <a:pt x="4372035" y="0"/>
                  </a:lnTo>
                  <a:cubicBezTo>
                    <a:pt x="3954366" y="243105"/>
                    <a:pt x="3559574" y="523572"/>
                    <a:pt x="3192500" y="837960"/>
                  </a:cubicBezTo>
                  <a:cubicBezTo>
                    <a:pt x="3152503" y="872186"/>
                    <a:pt x="3147814" y="932364"/>
                    <a:pt x="3182024" y="972381"/>
                  </a:cubicBezTo>
                  <a:cubicBezTo>
                    <a:pt x="3182043" y="972406"/>
                    <a:pt x="3182062" y="972425"/>
                    <a:pt x="3182082" y="972450"/>
                  </a:cubicBezTo>
                  <a:close/>
                  <a:moveTo>
                    <a:pt x="4503476" y="959103"/>
                  </a:moveTo>
                  <a:cubicBezTo>
                    <a:pt x="4531669" y="1003556"/>
                    <a:pt x="4590541" y="1016732"/>
                    <a:pt x="4634980" y="988531"/>
                  </a:cubicBezTo>
                  <a:cubicBezTo>
                    <a:pt x="5419589" y="490690"/>
                    <a:pt x="6295666" y="154609"/>
                    <a:pt x="7211824" y="0"/>
                  </a:cubicBezTo>
                  <a:lnTo>
                    <a:pt x="6361749" y="0"/>
                  </a:lnTo>
                  <a:cubicBezTo>
                    <a:pt x="5716216" y="188538"/>
                    <a:pt x="5100440" y="467098"/>
                    <a:pt x="4532571" y="827473"/>
                  </a:cubicBezTo>
                  <a:cubicBezTo>
                    <a:pt x="4488140" y="855680"/>
                    <a:pt x="4474970" y="914580"/>
                    <a:pt x="4503158" y="959040"/>
                  </a:cubicBezTo>
                  <a:close/>
                  <a:moveTo>
                    <a:pt x="4619923" y="423048"/>
                  </a:moveTo>
                  <a:cubicBezTo>
                    <a:pt x="4645786" y="468905"/>
                    <a:pt x="4703908" y="485105"/>
                    <a:pt x="4749744" y="459231"/>
                  </a:cubicBezTo>
                  <a:cubicBezTo>
                    <a:pt x="4749756" y="459225"/>
                    <a:pt x="4749763" y="459218"/>
                    <a:pt x="4749775" y="459213"/>
                  </a:cubicBezTo>
                  <a:cubicBezTo>
                    <a:pt x="5062406" y="282668"/>
                    <a:pt x="5387494" y="129190"/>
                    <a:pt x="5722461" y="0"/>
                  </a:cubicBezTo>
                  <a:lnTo>
                    <a:pt x="5231004" y="0"/>
                  </a:lnTo>
                  <a:cubicBezTo>
                    <a:pt x="5035419" y="89448"/>
                    <a:pt x="4843690" y="187160"/>
                    <a:pt x="4655817" y="293133"/>
                  </a:cubicBezTo>
                  <a:cubicBezTo>
                    <a:pt x="4609981" y="318991"/>
                    <a:pt x="4593775" y="377121"/>
                    <a:pt x="4619605" y="422984"/>
                  </a:cubicBezTo>
                  <a:close/>
                  <a:moveTo>
                    <a:pt x="1208440" y="3617579"/>
                  </a:moveTo>
                  <a:cubicBezTo>
                    <a:pt x="1160368" y="3596141"/>
                    <a:pt x="1104031" y="3617751"/>
                    <a:pt x="1082609" y="3665846"/>
                  </a:cubicBezTo>
                  <a:cubicBezTo>
                    <a:pt x="1082603" y="3665858"/>
                    <a:pt x="1082596" y="3665871"/>
                    <a:pt x="1082590" y="3665884"/>
                  </a:cubicBezTo>
                  <a:cubicBezTo>
                    <a:pt x="859205" y="4168380"/>
                    <a:pt x="688459" y="4692677"/>
                    <a:pt x="573091" y="5230385"/>
                  </a:cubicBezTo>
                  <a:cubicBezTo>
                    <a:pt x="458720" y="5765494"/>
                    <a:pt x="399119" y="6310867"/>
                    <a:pt x="395211" y="6858064"/>
                  </a:cubicBezTo>
                  <a:lnTo>
                    <a:pt x="585797" y="6858064"/>
                  </a:lnTo>
                  <a:cubicBezTo>
                    <a:pt x="589636" y="6324322"/>
                    <a:pt x="647724" y="5792347"/>
                    <a:pt x="759166" y="5270364"/>
                  </a:cubicBezTo>
                  <a:cubicBezTo>
                    <a:pt x="871732" y="4745641"/>
                    <a:pt x="1038323" y="4233992"/>
                    <a:pt x="1256277" y="3743616"/>
                  </a:cubicBezTo>
                  <a:cubicBezTo>
                    <a:pt x="1277788" y="3695566"/>
                    <a:pt x="1256296" y="3639157"/>
                    <a:pt x="1208262" y="3617637"/>
                  </a:cubicBezTo>
                  <a:cubicBezTo>
                    <a:pt x="1208173" y="3617598"/>
                    <a:pt x="1208084" y="3617554"/>
                    <a:pt x="1207995" y="3617516"/>
                  </a:cubicBezTo>
                  <a:close/>
                  <a:moveTo>
                    <a:pt x="942891" y="5974532"/>
                  </a:moveTo>
                  <a:cubicBezTo>
                    <a:pt x="890594" y="5968659"/>
                    <a:pt x="843443" y="6006305"/>
                    <a:pt x="837560" y="6058620"/>
                  </a:cubicBezTo>
                  <a:cubicBezTo>
                    <a:pt x="807861" y="6324074"/>
                    <a:pt x="791934" y="6590926"/>
                    <a:pt x="789850" y="6858000"/>
                  </a:cubicBezTo>
                  <a:lnTo>
                    <a:pt x="980436" y="6858000"/>
                  </a:lnTo>
                  <a:cubicBezTo>
                    <a:pt x="982494" y="6597917"/>
                    <a:pt x="998014" y="6338127"/>
                    <a:pt x="1026939" y="6079658"/>
                  </a:cubicBezTo>
                  <a:cubicBezTo>
                    <a:pt x="1032663" y="6027432"/>
                    <a:pt x="995073" y="5980418"/>
                    <a:pt x="942891" y="5974532"/>
                  </a:cubicBezTo>
                  <a:close/>
                  <a:moveTo>
                    <a:pt x="2329973" y="1389587"/>
                  </a:moveTo>
                  <a:cubicBezTo>
                    <a:pt x="2705198" y="978292"/>
                    <a:pt x="3121081" y="606057"/>
                    <a:pt x="3571258" y="278578"/>
                  </a:cubicBezTo>
                  <a:cubicBezTo>
                    <a:pt x="3704623" y="181588"/>
                    <a:pt x="3840892" y="88728"/>
                    <a:pt x="3980064" y="0"/>
                  </a:cubicBezTo>
                  <a:lnTo>
                    <a:pt x="3634913" y="0"/>
                  </a:lnTo>
                  <a:cubicBezTo>
                    <a:pt x="3575622" y="40678"/>
                    <a:pt x="3517049" y="82118"/>
                    <a:pt x="3459193" y="124321"/>
                  </a:cubicBezTo>
                  <a:cubicBezTo>
                    <a:pt x="2998611" y="459401"/>
                    <a:pt x="2573110" y="840261"/>
                    <a:pt x="2189194" y="1261071"/>
                  </a:cubicBezTo>
                  <a:cubicBezTo>
                    <a:pt x="2154101" y="1300312"/>
                    <a:pt x="2157449" y="1360585"/>
                    <a:pt x="2196671" y="1395695"/>
                  </a:cubicBezTo>
                  <a:cubicBezTo>
                    <a:pt x="2235354" y="1430316"/>
                    <a:pt x="2294613" y="1427602"/>
                    <a:pt x="2329973" y="1389587"/>
                  </a:cubicBezTo>
                  <a:close/>
                  <a:moveTo>
                    <a:pt x="557844" y="4174100"/>
                  </a:moveTo>
                  <a:cubicBezTo>
                    <a:pt x="507970" y="4157308"/>
                    <a:pt x="453932" y="4184143"/>
                    <a:pt x="437140" y="4234036"/>
                  </a:cubicBezTo>
                  <a:cubicBezTo>
                    <a:pt x="152879" y="5079865"/>
                    <a:pt x="5311" y="5965653"/>
                    <a:pt x="0" y="6858000"/>
                  </a:cubicBezTo>
                  <a:lnTo>
                    <a:pt x="190586" y="6858000"/>
                  </a:lnTo>
                  <a:cubicBezTo>
                    <a:pt x="195867" y="5986354"/>
                    <a:pt x="340068" y="5121127"/>
                    <a:pt x="617752" y="4294926"/>
                  </a:cubicBezTo>
                  <a:cubicBezTo>
                    <a:pt x="634569" y="4245032"/>
                    <a:pt x="607775" y="4190944"/>
                    <a:pt x="557905" y="4174119"/>
                  </a:cubicBezTo>
                  <a:cubicBezTo>
                    <a:pt x="557885" y="4174113"/>
                    <a:pt x="557865" y="4174107"/>
                    <a:pt x="557844" y="4174100"/>
                  </a:cubicBezTo>
                  <a:close/>
                  <a:moveTo>
                    <a:pt x="6996336" y="3748828"/>
                  </a:moveTo>
                  <a:cubicBezTo>
                    <a:pt x="7044554" y="3727644"/>
                    <a:pt x="7066407" y="3671388"/>
                    <a:pt x="7045253" y="3623172"/>
                  </a:cubicBezTo>
                  <a:cubicBezTo>
                    <a:pt x="7024098" y="3574957"/>
                    <a:pt x="6967875" y="3553048"/>
                    <a:pt x="6919656" y="3574232"/>
                  </a:cubicBezTo>
                  <a:cubicBezTo>
                    <a:pt x="5972433" y="3991121"/>
                    <a:pt x="5246340" y="4790323"/>
                    <a:pt x="4921684" y="5773368"/>
                  </a:cubicBezTo>
                  <a:cubicBezTo>
                    <a:pt x="4904569" y="5823161"/>
                    <a:pt x="4931042" y="5877408"/>
                    <a:pt x="4980810" y="5894524"/>
                  </a:cubicBezTo>
                  <a:cubicBezTo>
                    <a:pt x="5030578" y="5911647"/>
                    <a:pt x="5084800" y="5885162"/>
                    <a:pt x="5101914" y="5835370"/>
                  </a:cubicBezTo>
                  <a:cubicBezTo>
                    <a:pt x="5102175" y="5834601"/>
                    <a:pt x="5102429" y="5833826"/>
                    <a:pt x="5102677" y="5833050"/>
                  </a:cubicBezTo>
                  <a:cubicBezTo>
                    <a:pt x="5410415" y="4901366"/>
                    <a:pt x="6098595" y="4143936"/>
                    <a:pt x="6996336" y="3748828"/>
                  </a:cubicBezTo>
                  <a:close/>
                  <a:moveTo>
                    <a:pt x="6881984" y="5085281"/>
                  </a:moveTo>
                  <a:cubicBezTo>
                    <a:pt x="6913749" y="5127178"/>
                    <a:pt x="6973465" y="5135396"/>
                    <a:pt x="7015394" y="5103649"/>
                  </a:cubicBezTo>
                  <a:cubicBezTo>
                    <a:pt x="7328018" y="4865545"/>
                    <a:pt x="7697564" y="4713512"/>
                    <a:pt x="8087184" y="4662677"/>
                  </a:cubicBezTo>
                  <a:lnTo>
                    <a:pt x="8087184" y="4470349"/>
                  </a:lnTo>
                  <a:cubicBezTo>
                    <a:pt x="7655889" y="4522225"/>
                    <a:pt x="7246321" y="4688393"/>
                    <a:pt x="6900725" y="4951680"/>
                  </a:cubicBezTo>
                  <a:cubicBezTo>
                    <a:pt x="6858669" y="4983370"/>
                    <a:pt x="6850284" y="5043153"/>
                    <a:pt x="6881984" y="5085198"/>
                  </a:cubicBezTo>
                  <a:cubicBezTo>
                    <a:pt x="6881984" y="5085223"/>
                    <a:pt x="6882048" y="5085255"/>
                    <a:pt x="6882048" y="5085281"/>
                  </a:cubicBezTo>
                  <a:close/>
                  <a:moveTo>
                    <a:pt x="7499037" y="2661908"/>
                  </a:moveTo>
                  <a:cubicBezTo>
                    <a:pt x="7508693" y="2713633"/>
                    <a:pt x="7558373" y="2747770"/>
                    <a:pt x="7610085" y="2738179"/>
                  </a:cubicBezTo>
                  <a:cubicBezTo>
                    <a:pt x="7767635" y="2709126"/>
                    <a:pt x="7926711" y="2688972"/>
                    <a:pt x="8086549" y="2677798"/>
                  </a:cubicBezTo>
                  <a:lnTo>
                    <a:pt x="8086549" y="2486804"/>
                  </a:lnTo>
                  <a:cubicBezTo>
                    <a:pt x="7915022" y="2498295"/>
                    <a:pt x="7744257" y="2519689"/>
                    <a:pt x="7575208" y="2550871"/>
                  </a:cubicBezTo>
                  <a:cubicBezTo>
                    <a:pt x="7523559" y="2560577"/>
                    <a:pt x="7489572" y="2610235"/>
                    <a:pt x="7499101" y="2661908"/>
                  </a:cubicBezTo>
                  <a:close/>
                  <a:moveTo>
                    <a:pt x="7131080" y="4015712"/>
                  </a:moveTo>
                  <a:cubicBezTo>
                    <a:pt x="7150520" y="4064646"/>
                    <a:pt x="7205916" y="4088550"/>
                    <a:pt x="7254833" y="4069101"/>
                  </a:cubicBezTo>
                  <a:cubicBezTo>
                    <a:pt x="7254833" y="4069101"/>
                    <a:pt x="7254833" y="4069101"/>
                    <a:pt x="7254833" y="4069101"/>
                  </a:cubicBezTo>
                  <a:cubicBezTo>
                    <a:pt x="7521336" y="3962939"/>
                    <a:pt x="7801560" y="3895064"/>
                    <a:pt x="8087057" y="3867493"/>
                  </a:cubicBezTo>
                  <a:lnTo>
                    <a:pt x="8087057" y="3675799"/>
                  </a:lnTo>
                  <a:cubicBezTo>
                    <a:pt x="7777546" y="3704051"/>
                    <a:pt x="7473689" y="3776832"/>
                    <a:pt x="7184952" y="3891899"/>
                  </a:cubicBezTo>
                  <a:cubicBezTo>
                    <a:pt x="7135971" y="3911157"/>
                    <a:pt x="7111894" y="3966492"/>
                    <a:pt x="7131080" y="4015502"/>
                  </a:cubicBezTo>
                  <a:cubicBezTo>
                    <a:pt x="7131143" y="4015528"/>
                    <a:pt x="7131143" y="4015559"/>
                    <a:pt x="7131143" y="4015585"/>
                  </a:cubicBezTo>
                  <a:close/>
                  <a:moveTo>
                    <a:pt x="6365942" y="4894731"/>
                  </a:moveTo>
                  <a:cubicBezTo>
                    <a:pt x="5843642" y="5416174"/>
                    <a:pt x="5543800" y="6119929"/>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557220" y="3966771"/>
                  </a:moveTo>
                  <a:cubicBezTo>
                    <a:pt x="4259850" y="4352269"/>
                    <a:pt x="4022589" y="4780624"/>
                    <a:pt x="3853515" y="5237250"/>
                  </a:cubicBezTo>
                  <a:cubicBezTo>
                    <a:pt x="3835238" y="5286641"/>
                    <a:pt x="3860433" y="5341505"/>
                    <a:pt x="3909801" y="5359791"/>
                  </a:cubicBezTo>
                  <a:cubicBezTo>
                    <a:pt x="3959169" y="5378077"/>
                    <a:pt x="4014007" y="5352869"/>
                    <a:pt x="4032284" y="5303478"/>
                  </a:cubicBezTo>
                  <a:cubicBezTo>
                    <a:pt x="4669044" y="3583607"/>
                    <a:pt x="6257778" y="2399677"/>
                    <a:pt x="8087184" y="2281763"/>
                  </a:cubicBezTo>
                  <a:lnTo>
                    <a:pt x="8087184" y="2091086"/>
                  </a:lnTo>
                  <a:cubicBezTo>
                    <a:pt x="7191432" y="2144743"/>
                    <a:pt x="6328670" y="2448611"/>
                    <a:pt x="5596865" y="2968198"/>
                  </a:cubicBezTo>
                  <a:cubicBezTo>
                    <a:pt x="5202550" y="3247304"/>
                    <a:pt x="4852133" y="3583791"/>
                    <a:pt x="4557220" y="3966517"/>
                  </a:cubicBezTo>
                  <a:close/>
                  <a:moveTo>
                    <a:pt x="6932489" y="261735"/>
                  </a:moveTo>
                  <a:cubicBezTo>
                    <a:pt x="6468922" y="362681"/>
                    <a:pt x="6017234" y="512059"/>
                    <a:pt x="5584858" y="707410"/>
                  </a:cubicBezTo>
                  <a:cubicBezTo>
                    <a:pt x="5536862" y="729014"/>
                    <a:pt x="5515466" y="785454"/>
                    <a:pt x="5537059" y="833473"/>
                  </a:cubicBezTo>
                  <a:cubicBezTo>
                    <a:pt x="5558659" y="881491"/>
                    <a:pt x="5615073" y="902898"/>
                    <a:pt x="5663062" y="881294"/>
                  </a:cubicBezTo>
                  <a:cubicBezTo>
                    <a:pt x="5663151" y="881256"/>
                    <a:pt x="5663234" y="881218"/>
                    <a:pt x="5663316" y="881180"/>
                  </a:cubicBezTo>
                  <a:cubicBezTo>
                    <a:pt x="6083519" y="691317"/>
                    <a:pt x="6522476" y="546157"/>
                    <a:pt x="6973021" y="448090"/>
                  </a:cubicBezTo>
                  <a:cubicBezTo>
                    <a:pt x="7339644" y="368564"/>
                    <a:pt x="7712366" y="320214"/>
                    <a:pt x="8087184" y="303557"/>
                  </a:cubicBezTo>
                  <a:lnTo>
                    <a:pt x="8087184" y="112881"/>
                  </a:lnTo>
                  <a:cubicBezTo>
                    <a:pt x="7698771" y="129641"/>
                    <a:pt x="7312454" y="179439"/>
                    <a:pt x="6932489" y="261735"/>
                  </a:cubicBezTo>
                  <a:close/>
                  <a:moveTo>
                    <a:pt x="7678505" y="1431218"/>
                  </a:moveTo>
                  <a:cubicBezTo>
                    <a:pt x="7684286" y="1483553"/>
                    <a:pt x="7731361" y="1521288"/>
                    <a:pt x="7783708" y="1515497"/>
                  </a:cubicBezTo>
                  <a:cubicBezTo>
                    <a:pt x="7783708" y="1515497"/>
                    <a:pt x="7783708" y="1515497"/>
                    <a:pt x="7783708" y="1515497"/>
                  </a:cubicBezTo>
                  <a:cubicBezTo>
                    <a:pt x="7883957" y="1504438"/>
                    <a:pt x="7985284" y="1496430"/>
                    <a:pt x="8086866" y="1490582"/>
                  </a:cubicBezTo>
                  <a:lnTo>
                    <a:pt x="8086866" y="1299906"/>
                  </a:lnTo>
                  <a:cubicBezTo>
                    <a:pt x="7978233" y="1305689"/>
                    <a:pt x="7869917" y="1314397"/>
                    <a:pt x="7762871" y="1326283"/>
                  </a:cubicBezTo>
                  <a:cubicBezTo>
                    <a:pt x="7710778" y="1332016"/>
                    <a:pt x="7673105" y="1378750"/>
                    <a:pt x="7678505" y="1430901"/>
                  </a:cubicBezTo>
                  <a:close/>
                  <a:moveTo>
                    <a:pt x="5303173" y="1289991"/>
                  </a:moveTo>
                  <a:cubicBezTo>
                    <a:pt x="4389549" y="1793110"/>
                    <a:pt x="3611369" y="2510187"/>
                    <a:pt x="3035203" y="3379869"/>
                  </a:cubicBezTo>
                  <a:cubicBezTo>
                    <a:pt x="3007435" y="3424596"/>
                    <a:pt x="3021164" y="3483375"/>
                    <a:pt x="3065869" y="3511163"/>
                  </a:cubicBezTo>
                  <a:cubicBezTo>
                    <a:pt x="3108738" y="3537807"/>
                    <a:pt x="3164935" y="3526385"/>
                    <a:pt x="3194025" y="3485123"/>
                  </a:cubicBezTo>
                  <a:cubicBezTo>
                    <a:pt x="3753101" y="2641067"/>
                    <a:pt x="4508272" y="1945117"/>
                    <a:pt x="5394908" y="1456833"/>
                  </a:cubicBezTo>
                  <a:cubicBezTo>
                    <a:pt x="6222818" y="1002126"/>
                    <a:pt x="7143722" y="742952"/>
                    <a:pt x="8087184" y="699147"/>
                  </a:cubicBezTo>
                  <a:lnTo>
                    <a:pt x="8087184" y="508471"/>
                  </a:lnTo>
                  <a:cubicBezTo>
                    <a:pt x="7111767" y="552630"/>
                    <a:pt x="6159410" y="820081"/>
                    <a:pt x="5303490" y="1290245"/>
                  </a:cubicBezTo>
                  <a:close/>
                  <a:moveTo>
                    <a:pt x="6957138" y="1164907"/>
                  </a:moveTo>
                  <a:cubicBezTo>
                    <a:pt x="6968955" y="1216211"/>
                    <a:pt x="7020159" y="1248207"/>
                    <a:pt x="7071426" y="1236366"/>
                  </a:cubicBezTo>
                  <a:cubicBezTo>
                    <a:pt x="7071426" y="1236360"/>
                    <a:pt x="7071490" y="1236353"/>
                    <a:pt x="7071490" y="1236347"/>
                  </a:cubicBezTo>
                  <a:cubicBezTo>
                    <a:pt x="7405269" y="1159485"/>
                    <a:pt x="7745147" y="1112083"/>
                    <a:pt x="8087184" y="1094674"/>
                  </a:cubicBezTo>
                  <a:lnTo>
                    <a:pt x="8087184" y="903998"/>
                  </a:lnTo>
                  <a:cubicBezTo>
                    <a:pt x="7730789" y="921355"/>
                    <a:pt x="7376618" y="970277"/>
                    <a:pt x="7028862" y="1050183"/>
                  </a:cubicBezTo>
                  <a:cubicBezTo>
                    <a:pt x="6977531" y="1061859"/>
                    <a:pt x="6945386" y="1112941"/>
                    <a:pt x="6957075" y="1164284"/>
                  </a:cubicBezTo>
                  <a:cubicBezTo>
                    <a:pt x="6957075" y="1164385"/>
                    <a:pt x="6957138" y="1164487"/>
                    <a:pt x="6957138" y="1164589"/>
                  </a:cubicBezTo>
                  <a:close/>
                  <a:moveTo>
                    <a:pt x="7810517" y="5550150"/>
                  </a:moveTo>
                  <a:cubicBezTo>
                    <a:pt x="7858989" y="5529652"/>
                    <a:pt x="7881733" y="5473708"/>
                    <a:pt x="7861214" y="5425193"/>
                  </a:cubicBezTo>
                  <a:cubicBezTo>
                    <a:pt x="7840693" y="5376679"/>
                    <a:pt x="7784789" y="5353975"/>
                    <a:pt x="7736316" y="5374473"/>
                  </a:cubicBezTo>
                  <a:cubicBezTo>
                    <a:pt x="7136099" y="5627692"/>
                    <a:pt x="6737457" y="6206655"/>
                    <a:pt x="6714968" y="6858000"/>
                  </a:cubicBezTo>
                  <a:lnTo>
                    <a:pt x="6905553" y="6858000"/>
                  </a:lnTo>
                  <a:cubicBezTo>
                    <a:pt x="6927979" y="6283212"/>
                    <a:pt x="7280753" y="5773292"/>
                    <a:pt x="7810517" y="5549832"/>
                  </a:cubicBezTo>
                  <a:close/>
                  <a:moveTo>
                    <a:pt x="6090863" y="6328301"/>
                  </a:moveTo>
                  <a:cubicBezTo>
                    <a:pt x="6039456" y="6317477"/>
                    <a:pt x="5988995" y="6350311"/>
                    <a:pt x="5978037" y="6401711"/>
                  </a:cubicBezTo>
                  <a:cubicBezTo>
                    <a:pt x="5946202" y="6551837"/>
                    <a:pt x="5928338" y="6704569"/>
                    <a:pt x="5924672" y="6858000"/>
                  </a:cubicBezTo>
                  <a:lnTo>
                    <a:pt x="6115258" y="6858000"/>
                  </a:lnTo>
                  <a:cubicBezTo>
                    <a:pt x="6118847" y="6717916"/>
                    <a:pt x="6135282" y="6578469"/>
                    <a:pt x="6164366" y="6441372"/>
                  </a:cubicBezTo>
                  <a:cubicBezTo>
                    <a:pt x="6175293" y="6389889"/>
                    <a:pt x="6142417" y="6339252"/>
                    <a:pt x="6090933" y="6328313"/>
                  </a:cubicBezTo>
                  <a:cubicBezTo>
                    <a:pt x="6090914" y="6328313"/>
                    <a:pt x="6090888" y="6328307"/>
                    <a:pt x="6090863" y="6328301"/>
                  </a:cubicBezTo>
                  <a:close/>
                  <a:moveTo>
                    <a:pt x="5637269" y="5359219"/>
                  </a:moveTo>
                  <a:cubicBezTo>
                    <a:pt x="5590722" y="5334641"/>
                    <a:pt x="5533083" y="5352469"/>
                    <a:pt x="5508516" y="5399039"/>
                  </a:cubicBezTo>
                  <a:cubicBezTo>
                    <a:pt x="5508510" y="5399045"/>
                    <a:pt x="5508503" y="5399058"/>
                    <a:pt x="5508497" y="5399071"/>
                  </a:cubicBezTo>
                  <a:cubicBezTo>
                    <a:pt x="5271929" y="5849588"/>
                    <a:pt x="5143862" y="6349180"/>
                    <a:pt x="5134504" y="6858000"/>
                  </a:cubicBezTo>
                  <a:lnTo>
                    <a:pt x="5325090" y="6858000"/>
                  </a:lnTo>
                  <a:cubicBezTo>
                    <a:pt x="5334410" y="6380165"/>
                    <a:pt x="5454936" y="5911126"/>
                    <a:pt x="5677102" y="5488053"/>
                  </a:cubicBezTo>
                  <a:cubicBezTo>
                    <a:pt x="5701668" y="5441483"/>
                    <a:pt x="5683849" y="5383816"/>
                    <a:pt x="5637301" y="5359238"/>
                  </a:cubicBezTo>
                  <a:cubicBezTo>
                    <a:pt x="5637295" y="5359232"/>
                    <a:pt x="5637282" y="5359225"/>
                    <a:pt x="5637269" y="5359219"/>
                  </a:cubicBezTo>
                  <a:close/>
                  <a:moveTo>
                    <a:pt x="6804289" y="5734216"/>
                  </a:moveTo>
                  <a:cubicBezTo>
                    <a:pt x="6760771" y="5704725"/>
                    <a:pt x="6701563" y="5716108"/>
                    <a:pt x="6672022" y="5759640"/>
                  </a:cubicBezTo>
                  <a:cubicBezTo>
                    <a:pt x="6452404" y="6084724"/>
                    <a:pt x="6330169" y="6465778"/>
                    <a:pt x="6319630" y="6858000"/>
                  </a:cubicBezTo>
                  <a:lnTo>
                    <a:pt x="6510215" y="6858000"/>
                  </a:lnTo>
                  <a:cubicBezTo>
                    <a:pt x="6520761" y="6503851"/>
                    <a:pt x="6631618" y="6160023"/>
                    <a:pt x="6829891" y="5866482"/>
                  </a:cubicBezTo>
                  <a:cubicBezTo>
                    <a:pt x="6859177" y="5822913"/>
                    <a:pt x="6847679" y="5763873"/>
                    <a:pt x="6804289" y="5734407"/>
                  </a:cubicBezTo>
                  <a:close/>
                  <a:moveTo>
                    <a:pt x="4904404" y="6204806"/>
                  </a:moveTo>
                  <a:cubicBezTo>
                    <a:pt x="4852571" y="6195698"/>
                    <a:pt x="4803171" y="6230357"/>
                    <a:pt x="4794068" y="6282220"/>
                  </a:cubicBezTo>
                  <a:cubicBezTo>
                    <a:pt x="4794061" y="6282240"/>
                    <a:pt x="4794061" y="6282265"/>
                    <a:pt x="4794055" y="6282284"/>
                  </a:cubicBezTo>
                  <a:cubicBezTo>
                    <a:pt x="4760766" y="6472452"/>
                    <a:pt x="4742432" y="6664972"/>
                    <a:pt x="4739230" y="6858000"/>
                  </a:cubicBezTo>
                  <a:lnTo>
                    <a:pt x="4929815" y="6858000"/>
                  </a:lnTo>
                  <a:cubicBezTo>
                    <a:pt x="4932922" y="6676031"/>
                    <a:pt x="4950189" y="6494507"/>
                    <a:pt x="4981464" y="6315208"/>
                  </a:cubicBezTo>
                  <a:cubicBezTo>
                    <a:pt x="4990587" y="6263445"/>
                    <a:pt x="4956116" y="6214067"/>
                    <a:pt x="4904404" y="6204806"/>
                  </a:cubicBezTo>
                  <a:close/>
                  <a:moveTo>
                    <a:pt x="7902253" y="6858000"/>
                  </a:moveTo>
                  <a:lnTo>
                    <a:pt x="8087184" y="6858000"/>
                  </a:lnTo>
                  <a:lnTo>
                    <a:pt x="8087184" y="6532261"/>
                  </a:lnTo>
                  <a:cubicBezTo>
                    <a:pt x="7984903" y="6612091"/>
                    <a:pt x="7918389" y="6729230"/>
                    <a:pt x="7902253" y="6858000"/>
                  </a:cubicBezTo>
                  <a:close/>
                  <a:moveTo>
                    <a:pt x="7565551" y="6591561"/>
                  </a:moveTo>
                  <a:cubicBezTo>
                    <a:pt x="7546175" y="6640502"/>
                    <a:pt x="7570062" y="6695925"/>
                    <a:pt x="7619043" y="6715311"/>
                  </a:cubicBezTo>
                  <a:cubicBezTo>
                    <a:pt x="7667959" y="6734760"/>
                    <a:pt x="7723356" y="6710798"/>
                    <a:pt x="7742733" y="6661858"/>
                  </a:cubicBezTo>
                  <a:cubicBezTo>
                    <a:pt x="7807341" y="6499910"/>
                    <a:pt x="7930205" y="6368089"/>
                    <a:pt x="8087184" y="6292326"/>
                  </a:cubicBezTo>
                  <a:lnTo>
                    <a:pt x="8087184" y="6085760"/>
                  </a:lnTo>
                  <a:cubicBezTo>
                    <a:pt x="7849270" y="6172245"/>
                    <a:pt x="7659700" y="6356394"/>
                    <a:pt x="7566250" y="6591752"/>
                  </a:cubicBezTo>
                  <a:close/>
                  <a:moveTo>
                    <a:pt x="7109989" y="6858000"/>
                  </a:moveTo>
                  <a:lnTo>
                    <a:pt x="7300574" y="6858000"/>
                  </a:lnTo>
                  <a:cubicBezTo>
                    <a:pt x="7326176" y="6394974"/>
                    <a:pt x="7641722" y="5998774"/>
                    <a:pt x="8087184" y="5870486"/>
                  </a:cubicBezTo>
                  <a:lnTo>
                    <a:pt x="8087184" y="5673454"/>
                  </a:lnTo>
                  <a:cubicBezTo>
                    <a:pt x="7534740" y="5807487"/>
                    <a:pt x="7136797" y="6289898"/>
                    <a:pt x="7109989" y="6858000"/>
                  </a:cubicBezTo>
                  <a:close/>
                  <a:moveTo>
                    <a:pt x="6578000" y="3403894"/>
                  </a:moveTo>
                  <a:cubicBezTo>
                    <a:pt x="6600998" y="3451093"/>
                    <a:pt x="6657792" y="3470809"/>
                    <a:pt x="6705057" y="3448004"/>
                  </a:cubicBezTo>
                  <a:cubicBezTo>
                    <a:pt x="7047794" y="3281442"/>
                    <a:pt x="7413527" y="3167030"/>
                    <a:pt x="7790061" y="3108536"/>
                  </a:cubicBezTo>
                  <a:cubicBezTo>
                    <a:pt x="7841964" y="3099632"/>
                    <a:pt x="7876778" y="3050348"/>
                    <a:pt x="7867884" y="2998453"/>
                  </a:cubicBezTo>
                  <a:cubicBezTo>
                    <a:pt x="7859180" y="2947694"/>
                    <a:pt x="7811725" y="2913029"/>
                    <a:pt x="7760775" y="2920148"/>
                  </a:cubicBezTo>
                  <a:cubicBezTo>
                    <a:pt x="7365500" y="2981527"/>
                    <a:pt x="6981597" y="3101621"/>
                    <a:pt x="6621771" y="3276459"/>
                  </a:cubicBezTo>
                  <a:cubicBezTo>
                    <a:pt x="6574506" y="3299582"/>
                    <a:pt x="6554940" y="3356607"/>
                    <a:pt x="6578000" y="3403894"/>
                  </a:cubicBezTo>
                  <a:close/>
                </a:path>
              </a:pathLst>
            </a:custGeom>
            <a:solidFill>
              <a:srgbClr val="005CC2">
                <a:alpha val="838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26" name="Google Shape;26;p4"/>
            <p:cNvSpPr/>
            <p:nvPr/>
          </p:nvSpPr>
          <p:spPr>
            <a:xfrm>
              <a:off x="2377837" y="210583"/>
              <a:ext cx="5576288" cy="4831090"/>
            </a:xfrm>
            <a:custGeom>
              <a:avLst/>
              <a:gdLst/>
              <a:ahLst/>
              <a:cxnLst/>
              <a:rect l="l" t="t" r="r" b="b"/>
              <a:pathLst>
                <a:path w="7435051" h="6441453" extrusionOk="0">
                  <a:moveTo>
                    <a:pt x="2213120" y="5039472"/>
                  </a:moveTo>
                  <a:cubicBezTo>
                    <a:pt x="2095083" y="5051103"/>
                    <a:pt x="2103850" y="5229704"/>
                    <a:pt x="2222458" y="5229704"/>
                  </a:cubicBezTo>
                  <a:cubicBezTo>
                    <a:pt x="2353073" y="5228178"/>
                    <a:pt x="2343290" y="5028222"/>
                    <a:pt x="2213120" y="5039472"/>
                  </a:cubicBezTo>
                  <a:close/>
                  <a:moveTo>
                    <a:pt x="1816257" y="949650"/>
                  </a:moveTo>
                  <a:cubicBezTo>
                    <a:pt x="1698221" y="961282"/>
                    <a:pt x="1706988" y="1139882"/>
                    <a:pt x="1825595" y="1139882"/>
                  </a:cubicBezTo>
                  <a:cubicBezTo>
                    <a:pt x="1956274" y="1138420"/>
                    <a:pt x="1946427" y="938337"/>
                    <a:pt x="1816257" y="949650"/>
                  </a:cubicBezTo>
                  <a:close/>
                  <a:moveTo>
                    <a:pt x="1657435" y="6147620"/>
                  </a:moveTo>
                  <a:cubicBezTo>
                    <a:pt x="1527329" y="6136180"/>
                    <a:pt x="1517673" y="6336390"/>
                    <a:pt x="1648097" y="6337788"/>
                  </a:cubicBezTo>
                  <a:cubicBezTo>
                    <a:pt x="1766514" y="6337916"/>
                    <a:pt x="1775281" y="6159125"/>
                    <a:pt x="1657181" y="6147620"/>
                  </a:cubicBezTo>
                  <a:close/>
                  <a:moveTo>
                    <a:pt x="1777377" y="3926811"/>
                  </a:moveTo>
                  <a:cubicBezTo>
                    <a:pt x="1647271" y="3915307"/>
                    <a:pt x="1637614" y="4115517"/>
                    <a:pt x="1767975" y="4116979"/>
                  </a:cubicBezTo>
                  <a:cubicBezTo>
                    <a:pt x="1886583" y="4117487"/>
                    <a:pt x="1895477" y="3938442"/>
                    <a:pt x="1777377" y="3926811"/>
                  </a:cubicBezTo>
                  <a:close/>
                  <a:moveTo>
                    <a:pt x="2671541" y="3056499"/>
                  </a:moveTo>
                  <a:cubicBezTo>
                    <a:pt x="2553506" y="3068131"/>
                    <a:pt x="2562336" y="3246731"/>
                    <a:pt x="2680944" y="3246731"/>
                  </a:cubicBezTo>
                  <a:cubicBezTo>
                    <a:pt x="2811558" y="3245206"/>
                    <a:pt x="2801712" y="3045186"/>
                    <a:pt x="2671541" y="3056499"/>
                  </a:cubicBezTo>
                  <a:close/>
                  <a:moveTo>
                    <a:pt x="3043247" y="3211646"/>
                  </a:moveTo>
                  <a:cubicBezTo>
                    <a:pt x="2925148" y="3223278"/>
                    <a:pt x="2933978" y="3401878"/>
                    <a:pt x="3052649" y="3401878"/>
                  </a:cubicBezTo>
                  <a:cubicBezTo>
                    <a:pt x="3183264" y="3400289"/>
                    <a:pt x="3173354" y="3200333"/>
                    <a:pt x="3043247" y="3211646"/>
                  </a:cubicBezTo>
                  <a:close/>
                  <a:moveTo>
                    <a:pt x="3483564" y="1201216"/>
                  </a:moveTo>
                  <a:cubicBezTo>
                    <a:pt x="3602171" y="1201216"/>
                    <a:pt x="3611002" y="1022616"/>
                    <a:pt x="3492902" y="1010985"/>
                  </a:cubicBezTo>
                  <a:cubicBezTo>
                    <a:pt x="3362796" y="999608"/>
                    <a:pt x="3352949" y="1199627"/>
                    <a:pt x="3483564" y="1201216"/>
                  </a:cubicBezTo>
                  <a:close/>
                  <a:moveTo>
                    <a:pt x="3518314" y="4894812"/>
                  </a:moveTo>
                  <a:cubicBezTo>
                    <a:pt x="3388207" y="4883499"/>
                    <a:pt x="3378551" y="5083518"/>
                    <a:pt x="3508975" y="5085044"/>
                  </a:cubicBezTo>
                  <a:cubicBezTo>
                    <a:pt x="3627646" y="5085044"/>
                    <a:pt x="3636413" y="4906507"/>
                    <a:pt x="3518314" y="4894812"/>
                  </a:cubicBezTo>
                  <a:close/>
                  <a:moveTo>
                    <a:pt x="2488770" y="5643408"/>
                  </a:moveTo>
                  <a:cubicBezTo>
                    <a:pt x="2370670" y="5655039"/>
                    <a:pt x="2379501" y="5833576"/>
                    <a:pt x="2498109" y="5833640"/>
                  </a:cubicBezTo>
                  <a:cubicBezTo>
                    <a:pt x="2628723" y="5832115"/>
                    <a:pt x="2619003" y="5632095"/>
                    <a:pt x="2488770" y="5643408"/>
                  </a:cubicBezTo>
                  <a:close/>
                  <a:moveTo>
                    <a:pt x="1258984" y="4171957"/>
                  </a:moveTo>
                  <a:cubicBezTo>
                    <a:pt x="1128878" y="4160580"/>
                    <a:pt x="1118904" y="4360664"/>
                    <a:pt x="1249582" y="4362189"/>
                  </a:cubicBezTo>
                  <a:cubicBezTo>
                    <a:pt x="1368253" y="4362253"/>
                    <a:pt x="1377084" y="4183652"/>
                    <a:pt x="1258984" y="4171957"/>
                  </a:cubicBezTo>
                  <a:close/>
                  <a:moveTo>
                    <a:pt x="4268713" y="190694"/>
                  </a:moveTo>
                  <a:cubicBezTo>
                    <a:pt x="4399327" y="189105"/>
                    <a:pt x="4389417" y="-10851"/>
                    <a:pt x="4259311" y="463"/>
                  </a:cubicBezTo>
                  <a:cubicBezTo>
                    <a:pt x="4141211" y="12157"/>
                    <a:pt x="4150041" y="190758"/>
                    <a:pt x="4268713" y="190694"/>
                  </a:cubicBezTo>
                  <a:close/>
                  <a:moveTo>
                    <a:pt x="6303786" y="2710803"/>
                  </a:moveTo>
                  <a:cubicBezTo>
                    <a:pt x="6422394" y="2710803"/>
                    <a:pt x="6431225" y="2532266"/>
                    <a:pt x="6313189" y="2520571"/>
                  </a:cubicBezTo>
                  <a:cubicBezTo>
                    <a:pt x="6183082" y="2509448"/>
                    <a:pt x="6173045" y="2709341"/>
                    <a:pt x="6303786" y="2710803"/>
                  </a:cubicBezTo>
                  <a:close/>
                  <a:moveTo>
                    <a:pt x="2820516" y="724970"/>
                  </a:moveTo>
                  <a:cubicBezTo>
                    <a:pt x="2951131" y="723445"/>
                    <a:pt x="2941220" y="523425"/>
                    <a:pt x="2811177" y="534738"/>
                  </a:cubicBezTo>
                  <a:cubicBezTo>
                    <a:pt x="2693141" y="546370"/>
                    <a:pt x="2701908" y="724906"/>
                    <a:pt x="2820516" y="724970"/>
                  </a:cubicBezTo>
                  <a:close/>
                  <a:moveTo>
                    <a:pt x="7332377" y="2638663"/>
                  </a:moveTo>
                  <a:cubicBezTo>
                    <a:pt x="7214341" y="2650358"/>
                    <a:pt x="7223172" y="2828959"/>
                    <a:pt x="7341779" y="2828895"/>
                  </a:cubicBezTo>
                  <a:cubicBezTo>
                    <a:pt x="7472394" y="2827243"/>
                    <a:pt x="7462674" y="2627414"/>
                    <a:pt x="7332377" y="2638663"/>
                  </a:cubicBezTo>
                  <a:close/>
                  <a:moveTo>
                    <a:pt x="7339301" y="1234966"/>
                  </a:moveTo>
                  <a:cubicBezTo>
                    <a:pt x="7469916" y="1233504"/>
                    <a:pt x="7460006" y="1033421"/>
                    <a:pt x="7329899" y="1044798"/>
                  </a:cubicBezTo>
                  <a:cubicBezTo>
                    <a:pt x="7211864" y="1056302"/>
                    <a:pt x="7220694" y="1235157"/>
                    <a:pt x="7339301" y="1234966"/>
                  </a:cubicBezTo>
                  <a:close/>
                  <a:moveTo>
                    <a:pt x="84087" y="3888675"/>
                  </a:moveTo>
                  <a:cubicBezTo>
                    <a:pt x="-33695" y="3900434"/>
                    <a:pt x="-25118" y="4079352"/>
                    <a:pt x="93362" y="4079352"/>
                  </a:cubicBezTo>
                  <a:cubicBezTo>
                    <a:pt x="224104" y="4077445"/>
                    <a:pt x="214067" y="3877425"/>
                    <a:pt x="84087" y="3888675"/>
                  </a:cubicBezTo>
                  <a:close/>
                  <a:moveTo>
                    <a:pt x="488955" y="5693238"/>
                  </a:moveTo>
                  <a:cubicBezTo>
                    <a:pt x="370919" y="5704679"/>
                    <a:pt x="379686" y="5883470"/>
                    <a:pt x="498293" y="5883407"/>
                  </a:cubicBezTo>
                  <a:cubicBezTo>
                    <a:pt x="628908" y="5882135"/>
                    <a:pt x="619125" y="5681925"/>
                    <a:pt x="488955" y="5693366"/>
                  </a:cubicBezTo>
                  <a:close/>
                  <a:moveTo>
                    <a:pt x="722295" y="4567103"/>
                  </a:moveTo>
                  <a:cubicBezTo>
                    <a:pt x="592125" y="4555789"/>
                    <a:pt x="582532" y="4755682"/>
                    <a:pt x="712893" y="4757334"/>
                  </a:cubicBezTo>
                  <a:cubicBezTo>
                    <a:pt x="831501" y="4757334"/>
                    <a:pt x="840458" y="4578734"/>
                    <a:pt x="722295" y="4567103"/>
                  </a:cubicBezTo>
                  <a:close/>
                  <a:moveTo>
                    <a:pt x="1760606" y="2491334"/>
                  </a:moveTo>
                  <a:cubicBezTo>
                    <a:pt x="1891220" y="2489745"/>
                    <a:pt x="1881310" y="2289725"/>
                    <a:pt x="1751203" y="2301102"/>
                  </a:cubicBezTo>
                  <a:cubicBezTo>
                    <a:pt x="1633104" y="2312734"/>
                    <a:pt x="1641998" y="2491334"/>
                    <a:pt x="1760606" y="2491334"/>
                  </a:cubicBezTo>
                  <a:close/>
                  <a:moveTo>
                    <a:pt x="744657" y="3328976"/>
                  </a:moveTo>
                  <a:cubicBezTo>
                    <a:pt x="614551" y="3317536"/>
                    <a:pt x="604894" y="3517682"/>
                    <a:pt x="735255" y="3519144"/>
                  </a:cubicBezTo>
                  <a:cubicBezTo>
                    <a:pt x="853926" y="3519335"/>
                    <a:pt x="862820" y="3340544"/>
                    <a:pt x="744657" y="3328976"/>
                  </a:cubicBezTo>
                  <a:close/>
                  <a:moveTo>
                    <a:pt x="4587626" y="5427499"/>
                  </a:moveTo>
                  <a:cubicBezTo>
                    <a:pt x="4457774" y="5416058"/>
                    <a:pt x="4447546" y="5616269"/>
                    <a:pt x="4578478" y="5617476"/>
                  </a:cubicBezTo>
                  <a:cubicBezTo>
                    <a:pt x="4696832" y="5617858"/>
                    <a:pt x="4705535" y="5439067"/>
                    <a:pt x="4587626" y="5427499"/>
                  </a:cubicBezTo>
                  <a:close/>
                  <a:moveTo>
                    <a:pt x="6524040" y="3476242"/>
                  </a:moveTo>
                  <a:cubicBezTo>
                    <a:pt x="6654718" y="3474844"/>
                    <a:pt x="6644744" y="3274633"/>
                    <a:pt x="6514638" y="3286074"/>
                  </a:cubicBezTo>
                  <a:cubicBezTo>
                    <a:pt x="6396601" y="3297578"/>
                    <a:pt x="6405432" y="3476242"/>
                    <a:pt x="6524040" y="3476051"/>
                  </a:cubicBezTo>
                  <a:close/>
                  <a:moveTo>
                    <a:pt x="6533125" y="1608057"/>
                  </a:moveTo>
                  <a:cubicBezTo>
                    <a:pt x="6403018" y="1596616"/>
                    <a:pt x="6393362" y="1796826"/>
                    <a:pt x="6523785" y="1798225"/>
                  </a:cubicBezTo>
                  <a:cubicBezTo>
                    <a:pt x="6642394" y="1798161"/>
                    <a:pt x="6651224" y="1619624"/>
                    <a:pt x="6533125" y="1607866"/>
                  </a:cubicBezTo>
                  <a:close/>
                  <a:moveTo>
                    <a:pt x="6625368" y="767682"/>
                  </a:moveTo>
                  <a:cubicBezTo>
                    <a:pt x="6495261" y="756304"/>
                    <a:pt x="6485605" y="956324"/>
                    <a:pt x="6616029" y="957913"/>
                  </a:cubicBezTo>
                  <a:cubicBezTo>
                    <a:pt x="6734701" y="957722"/>
                    <a:pt x="6743531" y="779122"/>
                    <a:pt x="6625368" y="767491"/>
                  </a:cubicBezTo>
                  <a:close/>
                  <a:moveTo>
                    <a:pt x="6239178" y="2986775"/>
                  </a:moveTo>
                  <a:cubicBezTo>
                    <a:pt x="6109072" y="2975398"/>
                    <a:pt x="6099097" y="3175418"/>
                    <a:pt x="6229776" y="3177007"/>
                  </a:cubicBezTo>
                  <a:cubicBezTo>
                    <a:pt x="6348383" y="3176816"/>
                    <a:pt x="6357277" y="2998279"/>
                    <a:pt x="6239178" y="2986585"/>
                  </a:cubicBezTo>
                  <a:close/>
                  <a:moveTo>
                    <a:pt x="6514638" y="4652017"/>
                  </a:moveTo>
                  <a:cubicBezTo>
                    <a:pt x="6396538" y="4663649"/>
                    <a:pt x="6405432" y="4842249"/>
                    <a:pt x="6524040" y="4842249"/>
                  </a:cubicBezTo>
                  <a:cubicBezTo>
                    <a:pt x="6654718" y="4840660"/>
                    <a:pt x="6644808" y="4640640"/>
                    <a:pt x="6514638" y="4652017"/>
                  </a:cubicBezTo>
                  <a:close/>
                  <a:moveTo>
                    <a:pt x="6326403" y="5437732"/>
                  </a:moveTo>
                  <a:cubicBezTo>
                    <a:pt x="6196296" y="5426355"/>
                    <a:pt x="6186640" y="5626375"/>
                    <a:pt x="6317001" y="5627964"/>
                  </a:cubicBezTo>
                  <a:cubicBezTo>
                    <a:pt x="6435671" y="5628027"/>
                    <a:pt x="6444502" y="5449363"/>
                    <a:pt x="6326403" y="5437732"/>
                  </a:cubicBezTo>
                  <a:close/>
                  <a:moveTo>
                    <a:pt x="7229651" y="6251285"/>
                  </a:moveTo>
                  <a:cubicBezTo>
                    <a:pt x="7099545" y="6239781"/>
                    <a:pt x="7089888" y="6440055"/>
                    <a:pt x="7220249" y="6441453"/>
                  </a:cubicBezTo>
                  <a:cubicBezTo>
                    <a:pt x="7338857" y="6441453"/>
                    <a:pt x="7347751" y="6262662"/>
                    <a:pt x="7229651" y="6251094"/>
                  </a:cubicBezTo>
                  <a:close/>
                  <a:moveTo>
                    <a:pt x="6776566" y="3604694"/>
                  </a:moveTo>
                  <a:cubicBezTo>
                    <a:pt x="6658530" y="3616389"/>
                    <a:pt x="6667297" y="3794926"/>
                    <a:pt x="6785968" y="3794926"/>
                  </a:cubicBezTo>
                  <a:cubicBezTo>
                    <a:pt x="6916329" y="3793337"/>
                    <a:pt x="6906481" y="3593381"/>
                    <a:pt x="6776566" y="3604694"/>
                  </a:cubicBezTo>
                  <a:close/>
                  <a:moveTo>
                    <a:pt x="7330281" y="5086315"/>
                  </a:moveTo>
                  <a:cubicBezTo>
                    <a:pt x="7212244" y="5097946"/>
                    <a:pt x="7221075" y="5276610"/>
                    <a:pt x="7339683" y="5276546"/>
                  </a:cubicBezTo>
                  <a:cubicBezTo>
                    <a:pt x="7470107" y="5275021"/>
                    <a:pt x="7460324" y="5074938"/>
                    <a:pt x="7330090" y="5086315"/>
                  </a:cubicBezTo>
                  <a:close/>
                  <a:moveTo>
                    <a:pt x="7149732" y="2268942"/>
                  </a:moveTo>
                  <a:cubicBezTo>
                    <a:pt x="7031697" y="2280573"/>
                    <a:pt x="7040464" y="2459173"/>
                    <a:pt x="7159071" y="2459173"/>
                  </a:cubicBezTo>
                  <a:cubicBezTo>
                    <a:pt x="7289495" y="2457711"/>
                    <a:pt x="7279775" y="2257628"/>
                    <a:pt x="7149542" y="2268942"/>
                  </a:cubicBezTo>
                  <a:close/>
                  <a:moveTo>
                    <a:pt x="4803179" y="4171957"/>
                  </a:moveTo>
                  <a:cubicBezTo>
                    <a:pt x="4673072" y="4160580"/>
                    <a:pt x="4663416" y="4360600"/>
                    <a:pt x="4793840" y="4362189"/>
                  </a:cubicBezTo>
                  <a:cubicBezTo>
                    <a:pt x="4912511" y="4362189"/>
                    <a:pt x="4921532" y="4183589"/>
                    <a:pt x="4803179" y="4171957"/>
                  </a:cubicBezTo>
                  <a:close/>
                  <a:moveTo>
                    <a:pt x="4264139" y="1897059"/>
                  </a:moveTo>
                  <a:cubicBezTo>
                    <a:pt x="4146039" y="1908626"/>
                    <a:pt x="4154870" y="2087227"/>
                    <a:pt x="4273477" y="2087290"/>
                  </a:cubicBezTo>
                  <a:cubicBezTo>
                    <a:pt x="4404092" y="2085765"/>
                    <a:pt x="4394245" y="1885682"/>
                    <a:pt x="4264139" y="1897059"/>
                  </a:cubicBezTo>
                  <a:close/>
                  <a:moveTo>
                    <a:pt x="4141592" y="4439731"/>
                  </a:moveTo>
                  <a:cubicBezTo>
                    <a:pt x="4023556" y="4451362"/>
                    <a:pt x="4032386" y="4629962"/>
                    <a:pt x="4150995" y="4629962"/>
                  </a:cubicBezTo>
                  <a:cubicBezTo>
                    <a:pt x="4281609" y="4628373"/>
                    <a:pt x="4271826" y="4428417"/>
                    <a:pt x="4141592" y="4439731"/>
                  </a:cubicBezTo>
                  <a:close/>
                  <a:moveTo>
                    <a:pt x="4444560" y="5923067"/>
                  </a:moveTo>
                  <a:cubicBezTo>
                    <a:pt x="4326460" y="5934698"/>
                    <a:pt x="4335354" y="6113363"/>
                    <a:pt x="4453962" y="6113299"/>
                  </a:cubicBezTo>
                  <a:cubicBezTo>
                    <a:pt x="4584831" y="6111774"/>
                    <a:pt x="4574730" y="5911754"/>
                    <a:pt x="4444560" y="5923067"/>
                  </a:cubicBezTo>
                  <a:close/>
                  <a:moveTo>
                    <a:pt x="4149660" y="722555"/>
                  </a:moveTo>
                  <a:cubicBezTo>
                    <a:pt x="4280339" y="721029"/>
                    <a:pt x="4270365" y="521010"/>
                    <a:pt x="4140322" y="532323"/>
                  </a:cubicBezTo>
                  <a:cubicBezTo>
                    <a:pt x="4022222" y="543954"/>
                    <a:pt x="4031053" y="722491"/>
                    <a:pt x="4149660" y="722555"/>
                  </a:cubicBezTo>
                  <a:close/>
                  <a:moveTo>
                    <a:pt x="5149473" y="5067883"/>
                  </a:moveTo>
                  <a:cubicBezTo>
                    <a:pt x="5031437" y="5079514"/>
                    <a:pt x="5040267" y="5258178"/>
                    <a:pt x="5158875" y="5258115"/>
                  </a:cubicBezTo>
                  <a:cubicBezTo>
                    <a:pt x="5289489" y="5256589"/>
                    <a:pt x="5279643" y="5056569"/>
                    <a:pt x="5149473" y="5067883"/>
                  </a:cubicBezTo>
                  <a:close/>
                  <a:moveTo>
                    <a:pt x="5180729" y="418362"/>
                  </a:moveTo>
                  <a:cubicBezTo>
                    <a:pt x="5062692" y="430057"/>
                    <a:pt x="5071523" y="608657"/>
                    <a:pt x="5190131" y="608594"/>
                  </a:cubicBezTo>
                  <a:cubicBezTo>
                    <a:pt x="5320746" y="607259"/>
                    <a:pt x="5310962" y="407303"/>
                    <a:pt x="5180729" y="418362"/>
                  </a:cubicBezTo>
                  <a:close/>
                  <a:moveTo>
                    <a:pt x="3703309" y="5642900"/>
                  </a:moveTo>
                  <a:cubicBezTo>
                    <a:pt x="3578793" y="5643599"/>
                    <a:pt x="3578793" y="5832877"/>
                    <a:pt x="3703309" y="5833576"/>
                  </a:cubicBezTo>
                  <a:cubicBezTo>
                    <a:pt x="3827825" y="5832941"/>
                    <a:pt x="3827888" y="5643662"/>
                    <a:pt x="3703309" y="5642900"/>
                  </a:cubicBezTo>
                  <a:close/>
                  <a:moveTo>
                    <a:pt x="5646456" y="6045926"/>
                  </a:moveTo>
                  <a:cubicBezTo>
                    <a:pt x="5516350" y="6034422"/>
                    <a:pt x="5506694" y="6234696"/>
                    <a:pt x="5637118" y="6236094"/>
                  </a:cubicBezTo>
                  <a:cubicBezTo>
                    <a:pt x="5755726" y="6236222"/>
                    <a:pt x="5764556" y="6057430"/>
                    <a:pt x="5646456" y="6045926"/>
                  </a:cubicBezTo>
                  <a:close/>
                  <a:moveTo>
                    <a:pt x="5906225" y="1406067"/>
                  </a:moveTo>
                  <a:cubicBezTo>
                    <a:pt x="5776118" y="1394689"/>
                    <a:pt x="5766462" y="1594773"/>
                    <a:pt x="5896886" y="1596298"/>
                  </a:cubicBezTo>
                  <a:cubicBezTo>
                    <a:pt x="6015494" y="1596298"/>
                    <a:pt x="6024324" y="1417698"/>
                    <a:pt x="5906225" y="1406067"/>
                  </a:cubicBezTo>
                  <a:close/>
                </a:path>
              </a:pathLst>
            </a:custGeom>
            <a:solidFill>
              <a:srgbClr val="005CC2">
                <a:alpha val="838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27" name="Google Shape;27;p4"/>
          <p:cNvSpPr txBox="1">
            <a:spLocks noGrp="1"/>
          </p:cNvSpPr>
          <p:nvPr>
            <p:ph type="body" idx="1"/>
          </p:nvPr>
        </p:nvSpPr>
        <p:spPr>
          <a:xfrm>
            <a:off x="810450" y="1593500"/>
            <a:ext cx="5783700" cy="2736900"/>
          </a:xfrm>
          <a:prstGeom prst="rect">
            <a:avLst/>
          </a:prstGeom>
        </p:spPr>
        <p:txBody>
          <a:bodyPr spcFirstLastPara="1" wrap="square" lIns="0" tIns="0" rIns="0" bIns="0" anchor="t" anchorCtr="0">
            <a:noAutofit/>
          </a:bodyPr>
          <a:lstStyle>
            <a:lvl1pPr marL="457200" lvl="0" indent="-431800" rtl="0">
              <a:spcBef>
                <a:spcPts val="0"/>
              </a:spcBef>
              <a:spcAft>
                <a:spcPts val="0"/>
              </a:spcAft>
              <a:buClr>
                <a:schemeClr val="lt1"/>
              </a:buClr>
              <a:buSzPts val="3200"/>
              <a:buChar char="●"/>
              <a:defRPr sz="3200">
                <a:solidFill>
                  <a:schemeClr val="lt1"/>
                </a:solidFill>
              </a:defRPr>
            </a:lvl1pPr>
            <a:lvl2pPr marL="914400" lvl="1" indent="-431800" rtl="0">
              <a:spcBef>
                <a:spcPts val="600"/>
              </a:spcBef>
              <a:spcAft>
                <a:spcPts val="0"/>
              </a:spcAft>
              <a:buClr>
                <a:schemeClr val="lt1"/>
              </a:buClr>
              <a:buSzPts val="3200"/>
              <a:buChar char="○"/>
              <a:defRPr sz="3200">
                <a:solidFill>
                  <a:schemeClr val="lt1"/>
                </a:solidFill>
              </a:defRPr>
            </a:lvl2pPr>
            <a:lvl3pPr marL="1371600" lvl="2" indent="-431800" rtl="0">
              <a:spcBef>
                <a:spcPts val="600"/>
              </a:spcBef>
              <a:spcAft>
                <a:spcPts val="0"/>
              </a:spcAft>
              <a:buClr>
                <a:schemeClr val="lt1"/>
              </a:buClr>
              <a:buSzPts val="3200"/>
              <a:buChar char="■"/>
              <a:defRPr sz="3200">
                <a:solidFill>
                  <a:schemeClr val="lt1"/>
                </a:solidFill>
              </a:defRPr>
            </a:lvl3pPr>
            <a:lvl4pPr marL="1828800" lvl="3" indent="-431800" rtl="0">
              <a:spcBef>
                <a:spcPts val="600"/>
              </a:spcBef>
              <a:spcAft>
                <a:spcPts val="0"/>
              </a:spcAft>
              <a:buClr>
                <a:schemeClr val="lt1"/>
              </a:buClr>
              <a:buSzPts val="3200"/>
              <a:buChar char="●"/>
              <a:defRPr sz="3200">
                <a:solidFill>
                  <a:schemeClr val="lt1"/>
                </a:solidFill>
              </a:defRPr>
            </a:lvl4pPr>
            <a:lvl5pPr marL="2286000" lvl="4" indent="-431800" rtl="0">
              <a:spcBef>
                <a:spcPts val="600"/>
              </a:spcBef>
              <a:spcAft>
                <a:spcPts val="0"/>
              </a:spcAft>
              <a:buClr>
                <a:schemeClr val="lt1"/>
              </a:buClr>
              <a:buSzPts val="3200"/>
              <a:buChar char="○"/>
              <a:defRPr sz="3200">
                <a:solidFill>
                  <a:schemeClr val="lt1"/>
                </a:solidFill>
              </a:defRPr>
            </a:lvl5pPr>
            <a:lvl6pPr marL="2743200" lvl="5" indent="-431800" rtl="0">
              <a:spcBef>
                <a:spcPts val="600"/>
              </a:spcBef>
              <a:spcAft>
                <a:spcPts val="0"/>
              </a:spcAft>
              <a:buClr>
                <a:schemeClr val="lt1"/>
              </a:buClr>
              <a:buSzPts val="3200"/>
              <a:buChar char="■"/>
              <a:defRPr sz="3200">
                <a:solidFill>
                  <a:schemeClr val="lt1"/>
                </a:solidFill>
              </a:defRPr>
            </a:lvl6pPr>
            <a:lvl7pPr marL="3200400" lvl="6" indent="-431800" rtl="0">
              <a:spcBef>
                <a:spcPts val="600"/>
              </a:spcBef>
              <a:spcAft>
                <a:spcPts val="0"/>
              </a:spcAft>
              <a:buClr>
                <a:schemeClr val="lt1"/>
              </a:buClr>
              <a:buSzPts val="3200"/>
              <a:buChar char="●"/>
              <a:defRPr sz="3200">
                <a:solidFill>
                  <a:schemeClr val="lt1"/>
                </a:solidFill>
              </a:defRPr>
            </a:lvl7pPr>
            <a:lvl8pPr marL="3657600" lvl="7" indent="-431800" rtl="0">
              <a:spcBef>
                <a:spcPts val="600"/>
              </a:spcBef>
              <a:spcAft>
                <a:spcPts val="0"/>
              </a:spcAft>
              <a:buClr>
                <a:schemeClr val="lt1"/>
              </a:buClr>
              <a:buSzPts val="3200"/>
              <a:buChar char="○"/>
              <a:defRPr sz="3200">
                <a:solidFill>
                  <a:schemeClr val="lt1"/>
                </a:solidFill>
              </a:defRPr>
            </a:lvl8pPr>
            <a:lvl9pPr marL="4114800" lvl="8" indent="-431800" rtl="0">
              <a:spcBef>
                <a:spcPts val="600"/>
              </a:spcBef>
              <a:spcAft>
                <a:spcPts val="600"/>
              </a:spcAft>
              <a:buClr>
                <a:schemeClr val="lt1"/>
              </a:buClr>
              <a:buSzPts val="3200"/>
              <a:buChar char="■"/>
              <a:defRPr sz="3200">
                <a:solidFill>
                  <a:schemeClr val="lt1"/>
                </a:solidFill>
              </a:defRPr>
            </a:lvl9pPr>
          </a:lstStyle>
          <a:p>
            <a:endParaRPr/>
          </a:p>
        </p:txBody>
      </p:sp>
      <p:sp>
        <p:nvSpPr>
          <p:cNvPr id="28" name="Google Shape;28;p4"/>
          <p:cNvSpPr txBox="1"/>
          <p:nvPr/>
        </p:nvSpPr>
        <p:spPr>
          <a:xfrm>
            <a:off x="810450" y="670269"/>
            <a:ext cx="1957200" cy="653700"/>
          </a:xfrm>
          <a:prstGeom prst="rect">
            <a:avLst/>
          </a:prstGeom>
          <a:noFill/>
          <a:ln>
            <a:noFill/>
          </a:ln>
        </p:spPr>
        <p:txBody>
          <a:bodyPr spcFirstLastPara="1" wrap="square" lIns="0" tIns="0" rIns="0" bIns="0" anchor="t" anchorCtr="0">
            <a:noAutofit/>
          </a:bodyPr>
          <a:lstStyle/>
          <a:p>
            <a:pPr marL="0" lvl="0" indent="0" algn="l" rtl="0">
              <a:spcBef>
                <a:spcPts val="0"/>
              </a:spcBef>
              <a:spcAft>
                <a:spcPts val="0"/>
              </a:spcAft>
              <a:buNone/>
            </a:pPr>
            <a:r>
              <a:rPr lang="en" sz="9600" b="1">
                <a:solidFill>
                  <a:schemeClr val="lt1"/>
                </a:solidFill>
                <a:latin typeface="Montserrat"/>
                <a:ea typeface="Montserrat"/>
                <a:cs typeface="Montserrat"/>
                <a:sym typeface="Montserrat"/>
              </a:rPr>
              <a:t>“</a:t>
            </a:r>
            <a:endParaRPr sz="9600" b="1">
              <a:solidFill>
                <a:schemeClr val="lt1"/>
              </a:solidFill>
              <a:latin typeface="Montserrat"/>
              <a:ea typeface="Montserrat"/>
              <a:cs typeface="Montserrat"/>
              <a:sym typeface="Montserrat"/>
            </a:endParaRPr>
          </a:p>
        </p:txBody>
      </p:sp>
      <p:sp>
        <p:nvSpPr>
          <p:cNvPr id="29" name="Google Shape;29;p4"/>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solidFill>
                  <a:schemeClr val="lt1"/>
                </a:solidFill>
              </a:defRPr>
            </a:lvl1pPr>
            <a:lvl2pPr lvl="1" rtl="0">
              <a:buNone/>
              <a:defRPr>
                <a:solidFill>
                  <a:schemeClr val="lt1"/>
                </a:solidFill>
              </a:defRPr>
            </a:lvl2pPr>
            <a:lvl3pPr lvl="2" rtl="0">
              <a:buNone/>
              <a:defRPr>
                <a:solidFill>
                  <a:schemeClr val="lt1"/>
                </a:solidFill>
              </a:defRPr>
            </a:lvl3pPr>
            <a:lvl4pPr lvl="3" rtl="0">
              <a:buNone/>
              <a:defRPr>
                <a:solidFill>
                  <a:schemeClr val="lt1"/>
                </a:solidFill>
              </a:defRPr>
            </a:lvl4pPr>
            <a:lvl5pPr lvl="4" rtl="0">
              <a:buNone/>
              <a:defRPr>
                <a:solidFill>
                  <a:schemeClr val="lt1"/>
                </a:solidFill>
              </a:defRPr>
            </a:lvl5pPr>
            <a:lvl6pPr lvl="5" rtl="0">
              <a:buNone/>
              <a:defRPr>
                <a:solidFill>
                  <a:schemeClr val="lt1"/>
                </a:solidFill>
              </a:defRPr>
            </a:lvl6pPr>
            <a:lvl7pPr lvl="6" rtl="0">
              <a:buNone/>
              <a:defRPr>
                <a:solidFill>
                  <a:schemeClr val="lt1"/>
                </a:solidFill>
              </a:defRPr>
            </a:lvl7pPr>
            <a:lvl8pPr lvl="7" rtl="0">
              <a:buNone/>
              <a:defRPr>
                <a:solidFill>
                  <a:schemeClr val="lt1"/>
                </a:solidFill>
              </a:defRPr>
            </a:lvl8pPr>
            <a:lvl9pPr lvl="8" rtl="0">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 1 column" type="tx">
  <p:cSld name="TITLE_AND_BODY">
    <p:spTree>
      <p:nvGrpSpPr>
        <p:cNvPr id="1" name="Shape 30"/>
        <p:cNvGrpSpPr/>
        <p:nvPr/>
      </p:nvGrpSpPr>
      <p:grpSpPr>
        <a:xfrm>
          <a:off x="0" y="0"/>
          <a:ext cx="0" cy="0"/>
          <a:chOff x="0" y="0"/>
          <a:chExt cx="0" cy="0"/>
        </a:xfrm>
      </p:grpSpPr>
      <p:grpSp>
        <p:nvGrpSpPr>
          <p:cNvPr id="31" name="Google Shape;31;p5"/>
          <p:cNvGrpSpPr/>
          <p:nvPr/>
        </p:nvGrpSpPr>
        <p:grpSpPr>
          <a:xfrm>
            <a:off x="5005048" y="0"/>
            <a:ext cx="4138960" cy="5143642"/>
            <a:chOff x="5005048" y="0"/>
            <a:chExt cx="4138960" cy="5143642"/>
          </a:xfrm>
        </p:grpSpPr>
        <p:sp>
          <p:nvSpPr>
            <p:cNvPr id="32" name="Google Shape;32;p5"/>
            <p:cNvSpPr/>
            <p:nvPr/>
          </p:nvSpPr>
          <p:spPr>
            <a:xfrm>
              <a:off x="5005049" y="0"/>
              <a:ext cx="4138960" cy="5143500"/>
            </a:xfrm>
            <a:custGeom>
              <a:avLst/>
              <a:gdLst/>
              <a:ahLst/>
              <a:cxnLst/>
              <a:rect l="l" t="t" r="r" b="b"/>
              <a:pathLst>
                <a:path w="5518613" h="6858000" extrusionOk="0">
                  <a:moveTo>
                    <a:pt x="4347879" y="6858000"/>
                  </a:moveTo>
                  <a:lnTo>
                    <a:pt x="4538614" y="6858000"/>
                  </a:lnTo>
                  <a:cubicBezTo>
                    <a:pt x="4551534" y="5930683"/>
                    <a:pt x="4899626" y="5039346"/>
                    <a:pt x="5518613" y="4348570"/>
                  </a:cubicBezTo>
                  <a:lnTo>
                    <a:pt x="5518613" y="4070500"/>
                  </a:lnTo>
                  <a:cubicBezTo>
                    <a:pt x="4781548" y="4812740"/>
                    <a:pt x="4361771" y="5812222"/>
                    <a:pt x="4347879" y="6858000"/>
                  </a:cubicBezTo>
                  <a:close/>
                  <a:moveTo>
                    <a:pt x="4301085" y="5188627"/>
                  </a:moveTo>
                  <a:cubicBezTo>
                    <a:pt x="4077511" y="5717157"/>
                    <a:pt x="3959147" y="6284191"/>
                    <a:pt x="3952611" y="6858000"/>
                  </a:cubicBezTo>
                  <a:lnTo>
                    <a:pt x="4143347" y="6858000"/>
                  </a:lnTo>
                  <a:cubicBezTo>
                    <a:pt x="4157130" y="5751110"/>
                    <a:pt x="4603757" y="4693586"/>
                    <a:pt x="5387642" y="3911730"/>
                  </a:cubicBezTo>
                  <a:cubicBezTo>
                    <a:pt x="5430449" y="3868935"/>
                    <a:pt x="5474000" y="3827197"/>
                    <a:pt x="5518295" y="3786519"/>
                  </a:cubicBezTo>
                  <a:lnTo>
                    <a:pt x="5518295" y="3532283"/>
                  </a:lnTo>
                  <a:cubicBezTo>
                    <a:pt x="5426952" y="3609615"/>
                    <a:pt x="5338451" y="3691136"/>
                    <a:pt x="5252792" y="3776858"/>
                  </a:cubicBezTo>
                  <a:cubicBezTo>
                    <a:pt x="4847103" y="4181397"/>
                    <a:pt x="4523877" y="4660866"/>
                    <a:pt x="4301085" y="5188627"/>
                  </a:cubicBezTo>
                  <a:close/>
                  <a:moveTo>
                    <a:pt x="4742956" y="6858000"/>
                  </a:moveTo>
                  <a:lnTo>
                    <a:pt x="4933691" y="6858000"/>
                  </a:lnTo>
                  <a:cubicBezTo>
                    <a:pt x="4944296" y="6192253"/>
                    <a:pt x="5147442" y="5543813"/>
                    <a:pt x="5518613" y="4990959"/>
                  </a:cubicBezTo>
                  <a:lnTo>
                    <a:pt x="5518613" y="4666809"/>
                  </a:lnTo>
                  <a:cubicBezTo>
                    <a:pt x="5027419" y="5292807"/>
                    <a:pt x="4754965" y="6062479"/>
                    <a:pt x="4742956" y="6858000"/>
                  </a:cubicBezTo>
                  <a:close/>
                  <a:moveTo>
                    <a:pt x="3936844" y="5034751"/>
                  </a:moveTo>
                  <a:cubicBezTo>
                    <a:pt x="3692690" y="5611967"/>
                    <a:pt x="3563753" y="6231329"/>
                    <a:pt x="3557280" y="6858000"/>
                  </a:cubicBezTo>
                  <a:lnTo>
                    <a:pt x="3748016" y="6858000"/>
                  </a:lnTo>
                  <a:cubicBezTo>
                    <a:pt x="3761742" y="5646276"/>
                    <a:pt x="4250019" y="4488202"/>
                    <a:pt x="5108087" y="3632261"/>
                  </a:cubicBezTo>
                  <a:cubicBezTo>
                    <a:pt x="5237705" y="3502760"/>
                    <a:pt x="5374780" y="3380944"/>
                    <a:pt x="5518613" y="3267434"/>
                  </a:cubicBezTo>
                  <a:lnTo>
                    <a:pt x="5518613" y="3027435"/>
                  </a:lnTo>
                  <a:cubicBezTo>
                    <a:pt x="4821685" y="3543508"/>
                    <a:pt x="4275552" y="4236573"/>
                    <a:pt x="3936844" y="5034751"/>
                  </a:cubicBezTo>
                  <a:close/>
                  <a:moveTo>
                    <a:pt x="1590798" y="2330830"/>
                  </a:moveTo>
                  <a:cubicBezTo>
                    <a:pt x="2180774" y="1457646"/>
                    <a:pt x="2932850" y="705739"/>
                    <a:pt x="3806254" y="115868"/>
                  </a:cubicBezTo>
                  <a:cubicBezTo>
                    <a:pt x="3864619" y="76504"/>
                    <a:pt x="3923511" y="37881"/>
                    <a:pt x="3982938" y="0"/>
                  </a:cubicBezTo>
                  <a:lnTo>
                    <a:pt x="3637961" y="0"/>
                  </a:lnTo>
                  <a:cubicBezTo>
                    <a:pt x="2317309" y="907938"/>
                    <a:pt x="1283739" y="2174291"/>
                    <a:pt x="658991" y="3649867"/>
                  </a:cubicBezTo>
                  <a:cubicBezTo>
                    <a:pt x="229264" y="4666364"/>
                    <a:pt x="7820" y="5745720"/>
                    <a:pt x="0" y="6858000"/>
                  </a:cubicBezTo>
                  <a:lnTo>
                    <a:pt x="190735" y="6858000"/>
                  </a:lnTo>
                  <a:cubicBezTo>
                    <a:pt x="198492" y="5771144"/>
                    <a:pt x="414913" y="4716957"/>
                    <a:pt x="834595" y="3724104"/>
                  </a:cubicBezTo>
                  <a:cubicBezTo>
                    <a:pt x="1041009" y="3236353"/>
                    <a:pt x="1294217" y="2769749"/>
                    <a:pt x="1590670" y="2330830"/>
                  </a:cubicBezTo>
                  <a:close/>
                  <a:moveTo>
                    <a:pt x="5138478" y="6858000"/>
                  </a:moveTo>
                  <a:lnTo>
                    <a:pt x="5329213" y="6858000"/>
                  </a:lnTo>
                  <a:cubicBezTo>
                    <a:pt x="5335393" y="6514973"/>
                    <a:pt x="5399423" y="6175480"/>
                    <a:pt x="5518613" y="5853770"/>
                  </a:cubicBezTo>
                  <a:lnTo>
                    <a:pt x="5518613" y="5388583"/>
                  </a:lnTo>
                  <a:cubicBezTo>
                    <a:pt x="5473428" y="5473625"/>
                    <a:pt x="5431892" y="5560847"/>
                    <a:pt x="5394000" y="5650255"/>
                  </a:cubicBezTo>
                  <a:cubicBezTo>
                    <a:pt x="5232135" y="6032727"/>
                    <a:pt x="5145382" y="6442770"/>
                    <a:pt x="5138478" y="6858000"/>
                  </a:cubicBezTo>
                  <a:close/>
                  <a:moveTo>
                    <a:pt x="1918417" y="2551824"/>
                  </a:moveTo>
                  <a:cubicBezTo>
                    <a:pt x="2643092" y="1478290"/>
                    <a:pt x="3623084" y="601442"/>
                    <a:pt x="4770422" y="0"/>
                  </a:cubicBezTo>
                  <a:lnTo>
                    <a:pt x="4376235" y="0"/>
                  </a:lnTo>
                  <a:cubicBezTo>
                    <a:pt x="4221103" y="90127"/>
                    <a:pt x="4069195" y="185317"/>
                    <a:pt x="3920504" y="285570"/>
                  </a:cubicBezTo>
                  <a:cubicBezTo>
                    <a:pt x="2634426" y="1153193"/>
                    <a:pt x="1627921" y="2375366"/>
                    <a:pt x="1023169" y="3803743"/>
                  </a:cubicBezTo>
                  <a:cubicBezTo>
                    <a:pt x="614105" y="4771490"/>
                    <a:pt x="403024" y="5798792"/>
                    <a:pt x="395331" y="6858000"/>
                  </a:cubicBezTo>
                  <a:lnTo>
                    <a:pt x="586067" y="6858000"/>
                  </a:lnTo>
                  <a:cubicBezTo>
                    <a:pt x="593760" y="5824406"/>
                    <a:pt x="799754" y="4822147"/>
                    <a:pt x="1198836" y="3877980"/>
                  </a:cubicBezTo>
                  <a:cubicBezTo>
                    <a:pt x="1395332" y="3413753"/>
                    <a:pt x="1636313" y="2969629"/>
                    <a:pt x="1918417" y="2551824"/>
                  </a:cubicBezTo>
                  <a:close/>
                  <a:moveTo>
                    <a:pt x="3295909" y="1820898"/>
                  </a:moveTo>
                  <a:cubicBezTo>
                    <a:pt x="2638349" y="2477855"/>
                    <a:pt x="2113960" y="3255643"/>
                    <a:pt x="1751587" y="4111495"/>
                  </a:cubicBezTo>
                  <a:cubicBezTo>
                    <a:pt x="1383722" y="4981807"/>
                    <a:pt x="1193495" y="5905571"/>
                    <a:pt x="1185739" y="6858000"/>
                  </a:cubicBezTo>
                  <a:lnTo>
                    <a:pt x="1376474" y="6858000"/>
                  </a:lnTo>
                  <a:cubicBezTo>
                    <a:pt x="1384167" y="5931185"/>
                    <a:pt x="1569308" y="5032463"/>
                    <a:pt x="1927255" y="4185732"/>
                  </a:cubicBezTo>
                  <a:cubicBezTo>
                    <a:pt x="2618518" y="2553159"/>
                    <a:pt x="3901291" y="1241972"/>
                    <a:pt x="5518613" y="514827"/>
                  </a:cubicBezTo>
                  <a:lnTo>
                    <a:pt x="5518613" y="306544"/>
                  </a:lnTo>
                  <a:cubicBezTo>
                    <a:pt x="4689289" y="667432"/>
                    <a:pt x="3935274" y="1181063"/>
                    <a:pt x="3295909" y="1820643"/>
                  </a:cubicBezTo>
                  <a:close/>
                  <a:moveTo>
                    <a:pt x="3572666" y="4881129"/>
                  </a:moveTo>
                  <a:cubicBezTo>
                    <a:pt x="3307970" y="5506962"/>
                    <a:pt x="3168460" y="6178556"/>
                    <a:pt x="3162013" y="6858000"/>
                  </a:cubicBezTo>
                  <a:lnTo>
                    <a:pt x="3352748" y="6858000"/>
                  </a:lnTo>
                  <a:cubicBezTo>
                    <a:pt x="3372565" y="5227315"/>
                    <a:pt x="4179313" y="3706695"/>
                    <a:pt x="5518613" y="2775615"/>
                  </a:cubicBezTo>
                  <a:lnTo>
                    <a:pt x="5518613" y="2545341"/>
                  </a:lnTo>
                  <a:cubicBezTo>
                    <a:pt x="4654149" y="3115286"/>
                    <a:pt x="3977337" y="3927785"/>
                    <a:pt x="3573111" y="4880875"/>
                  </a:cubicBezTo>
                  <a:close/>
                  <a:moveTo>
                    <a:pt x="5235308" y="0"/>
                  </a:moveTo>
                  <a:cubicBezTo>
                    <a:pt x="3502800" y="791829"/>
                    <a:pt x="2129930" y="2203840"/>
                    <a:pt x="1387410" y="3957619"/>
                  </a:cubicBezTo>
                  <a:cubicBezTo>
                    <a:pt x="998882" y="4876680"/>
                    <a:pt x="798292" y="5852181"/>
                    <a:pt x="790535" y="6858000"/>
                  </a:cubicBezTo>
                  <a:lnTo>
                    <a:pt x="981270" y="6858000"/>
                  </a:lnTo>
                  <a:cubicBezTo>
                    <a:pt x="989027" y="5877796"/>
                    <a:pt x="1184722" y="4927273"/>
                    <a:pt x="1563077" y="4031856"/>
                  </a:cubicBezTo>
                  <a:cubicBezTo>
                    <a:pt x="2315465" y="2254877"/>
                    <a:pt x="3730277" y="840502"/>
                    <a:pt x="5507805" y="88347"/>
                  </a:cubicBezTo>
                  <a:lnTo>
                    <a:pt x="5518295" y="83961"/>
                  </a:lnTo>
                  <a:lnTo>
                    <a:pt x="5518295" y="0"/>
                  </a:lnTo>
                  <a:close/>
                  <a:moveTo>
                    <a:pt x="2115829" y="4265371"/>
                  </a:moveTo>
                  <a:cubicBezTo>
                    <a:pt x="1768499" y="5086996"/>
                    <a:pt x="1588763" y="5958960"/>
                    <a:pt x="1581070" y="6858000"/>
                  </a:cubicBezTo>
                  <a:lnTo>
                    <a:pt x="1771805" y="6858000"/>
                  </a:lnTo>
                  <a:cubicBezTo>
                    <a:pt x="1779499" y="5984575"/>
                    <a:pt x="1954148" y="5137589"/>
                    <a:pt x="2291496" y="4339608"/>
                  </a:cubicBezTo>
                  <a:cubicBezTo>
                    <a:pt x="2920256" y="2855992"/>
                    <a:pt x="4067231" y="1651564"/>
                    <a:pt x="5518613" y="950841"/>
                  </a:cubicBezTo>
                  <a:lnTo>
                    <a:pt x="5518613" y="739889"/>
                  </a:lnTo>
                  <a:cubicBezTo>
                    <a:pt x="3987230" y="1453890"/>
                    <a:pt x="2774896" y="2709940"/>
                    <a:pt x="2115829" y="4265371"/>
                  </a:cubicBezTo>
                  <a:close/>
                  <a:moveTo>
                    <a:pt x="3208425" y="4726999"/>
                  </a:moveTo>
                  <a:cubicBezTo>
                    <a:pt x="2923104" y="5401587"/>
                    <a:pt x="2773059" y="6125618"/>
                    <a:pt x="2766809" y="6858000"/>
                  </a:cubicBezTo>
                  <a:lnTo>
                    <a:pt x="2957544" y="6858000"/>
                  </a:lnTo>
                  <a:cubicBezTo>
                    <a:pt x="2978335" y="5002228"/>
                    <a:pt x="3943723" y="3284988"/>
                    <a:pt x="5518613" y="2302356"/>
                  </a:cubicBezTo>
                  <a:lnTo>
                    <a:pt x="5518613" y="2079201"/>
                  </a:lnTo>
                  <a:cubicBezTo>
                    <a:pt x="4486524" y="2693796"/>
                    <a:pt x="3677291" y="3621298"/>
                    <a:pt x="3208425" y="4726999"/>
                  </a:cubicBezTo>
                  <a:close/>
                  <a:moveTo>
                    <a:pt x="2844247" y="4573123"/>
                  </a:moveTo>
                  <a:cubicBezTo>
                    <a:pt x="2538117" y="5297313"/>
                    <a:pt x="2379234" y="6065676"/>
                    <a:pt x="2371478" y="6858000"/>
                  </a:cubicBezTo>
                  <a:lnTo>
                    <a:pt x="2562213" y="6858000"/>
                  </a:lnTo>
                  <a:cubicBezTo>
                    <a:pt x="2569906" y="6091353"/>
                    <a:pt x="2723703" y="5347905"/>
                    <a:pt x="3019978" y="4647360"/>
                  </a:cubicBezTo>
                  <a:cubicBezTo>
                    <a:pt x="3521924" y="3463366"/>
                    <a:pt x="4400064" y="2477658"/>
                    <a:pt x="5518613" y="1842635"/>
                  </a:cubicBezTo>
                  <a:lnTo>
                    <a:pt x="5518613" y="1624564"/>
                  </a:lnTo>
                  <a:cubicBezTo>
                    <a:pt x="4319580" y="2277199"/>
                    <a:pt x="3376933" y="3316482"/>
                    <a:pt x="2844247" y="4573123"/>
                  </a:cubicBezTo>
                  <a:close/>
                  <a:moveTo>
                    <a:pt x="2480006" y="4419247"/>
                  </a:moveTo>
                  <a:cubicBezTo>
                    <a:pt x="2153276" y="5192123"/>
                    <a:pt x="1984094" y="6012350"/>
                    <a:pt x="1976274" y="6858000"/>
                  </a:cubicBezTo>
                  <a:lnTo>
                    <a:pt x="2167009" y="6858000"/>
                  </a:lnTo>
                  <a:cubicBezTo>
                    <a:pt x="2174702" y="6038091"/>
                    <a:pt x="2338989" y="5242779"/>
                    <a:pt x="2655737" y="4493611"/>
                  </a:cubicBezTo>
                  <a:cubicBezTo>
                    <a:pt x="3221262" y="3159288"/>
                    <a:pt x="4233361" y="2063108"/>
                    <a:pt x="5518613" y="1392892"/>
                  </a:cubicBezTo>
                  <a:lnTo>
                    <a:pt x="5518613" y="1178826"/>
                  </a:lnTo>
                  <a:cubicBezTo>
                    <a:pt x="4153132" y="1864200"/>
                    <a:pt x="3076061" y="3012811"/>
                    <a:pt x="2480006" y="441924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33" name="Google Shape;33;p5"/>
            <p:cNvSpPr/>
            <p:nvPr/>
          </p:nvSpPr>
          <p:spPr>
            <a:xfrm>
              <a:off x="5005048" y="0"/>
              <a:ext cx="4138960" cy="5143642"/>
            </a:xfrm>
            <a:custGeom>
              <a:avLst/>
              <a:gdLst/>
              <a:ahLst/>
              <a:cxnLst/>
              <a:rect l="l" t="t" r="r" b="b"/>
              <a:pathLst>
                <a:path w="5518613" h="6858190" extrusionOk="0">
                  <a:moveTo>
                    <a:pt x="2240760" y="4214715"/>
                  </a:moveTo>
                  <a:cubicBezTo>
                    <a:pt x="2192225" y="4194261"/>
                    <a:pt x="2136295" y="4217016"/>
                    <a:pt x="2115841" y="4265537"/>
                  </a:cubicBezTo>
                  <a:cubicBezTo>
                    <a:pt x="2115835" y="4265543"/>
                    <a:pt x="2115835" y="4265556"/>
                    <a:pt x="2115829" y="4265562"/>
                  </a:cubicBezTo>
                  <a:cubicBezTo>
                    <a:pt x="1768499" y="5087187"/>
                    <a:pt x="1588763" y="5959151"/>
                    <a:pt x="1581070" y="6858191"/>
                  </a:cubicBezTo>
                  <a:lnTo>
                    <a:pt x="1771805" y="6858191"/>
                  </a:lnTo>
                  <a:cubicBezTo>
                    <a:pt x="1779499" y="5984765"/>
                    <a:pt x="1954148" y="5137780"/>
                    <a:pt x="2291496" y="4339799"/>
                  </a:cubicBezTo>
                  <a:cubicBezTo>
                    <a:pt x="2312070" y="4291329"/>
                    <a:pt x="2289436" y="4235359"/>
                    <a:pt x="2240951" y="4214797"/>
                  </a:cubicBezTo>
                  <a:cubicBezTo>
                    <a:pt x="2240888" y="4214766"/>
                    <a:pt x="2240824" y="4214740"/>
                    <a:pt x="2240760" y="4214715"/>
                  </a:cubicBezTo>
                  <a:close/>
                  <a:moveTo>
                    <a:pt x="2250170" y="2598095"/>
                  </a:moveTo>
                  <a:cubicBezTo>
                    <a:pt x="2206714" y="2568350"/>
                    <a:pt x="2147370" y="2579447"/>
                    <a:pt x="2117609" y="2622883"/>
                  </a:cubicBezTo>
                  <a:cubicBezTo>
                    <a:pt x="1637146" y="3322742"/>
                    <a:pt x="1278195" y="4098599"/>
                    <a:pt x="1055848" y="4917803"/>
                  </a:cubicBezTo>
                  <a:cubicBezTo>
                    <a:pt x="1040138" y="4968059"/>
                    <a:pt x="1068151" y="5021531"/>
                    <a:pt x="1118422" y="5037242"/>
                  </a:cubicBezTo>
                  <a:cubicBezTo>
                    <a:pt x="1168694" y="5052948"/>
                    <a:pt x="1222182" y="5024944"/>
                    <a:pt x="1237899" y="4974688"/>
                  </a:cubicBezTo>
                  <a:cubicBezTo>
                    <a:pt x="1238611" y="4972400"/>
                    <a:pt x="1239240" y="4970093"/>
                    <a:pt x="1239781" y="4967760"/>
                  </a:cubicBezTo>
                  <a:cubicBezTo>
                    <a:pt x="1456596" y="4169149"/>
                    <a:pt x="1806538" y="3412786"/>
                    <a:pt x="2274902" y="2730488"/>
                  </a:cubicBezTo>
                  <a:cubicBezTo>
                    <a:pt x="2304581" y="2687090"/>
                    <a:pt x="2293518" y="2627860"/>
                    <a:pt x="2250170" y="2598095"/>
                  </a:cubicBezTo>
                  <a:close/>
                  <a:moveTo>
                    <a:pt x="5289222" y="4471365"/>
                  </a:moveTo>
                  <a:cubicBezTo>
                    <a:pt x="5247089" y="4439770"/>
                    <a:pt x="5187312" y="4448313"/>
                    <a:pt x="5155707" y="4490433"/>
                  </a:cubicBezTo>
                  <a:cubicBezTo>
                    <a:pt x="4642139" y="5174034"/>
                    <a:pt x="4359361" y="6003210"/>
                    <a:pt x="4348260" y="6858064"/>
                  </a:cubicBezTo>
                  <a:lnTo>
                    <a:pt x="4538996" y="6858064"/>
                  </a:lnTo>
                  <a:cubicBezTo>
                    <a:pt x="4550065" y="6044479"/>
                    <a:pt x="4819460" y="5255459"/>
                    <a:pt x="5308296" y="4604903"/>
                  </a:cubicBezTo>
                  <a:cubicBezTo>
                    <a:pt x="5339900" y="4562782"/>
                    <a:pt x="5331375" y="4503024"/>
                    <a:pt x="5289241" y="4471429"/>
                  </a:cubicBezTo>
                  <a:cubicBezTo>
                    <a:pt x="5289216" y="4471403"/>
                    <a:pt x="5289184" y="4471384"/>
                    <a:pt x="5289158" y="4471365"/>
                  </a:cubicBezTo>
                  <a:close/>
                  <a:moveTo>
                    <a:pt x="2682504" y="5323054"/>
                  </a:moveTo>
                  <a:cubicBezTo>
                    <a:pt x="2631558" y="5309764"/>
                    <a:pt x="2579475" y="5340266"/>
                    <a:pt x="2566155" y="5391189"/>
                  </a:cubicBezTo>
                  <a:cubicBezTo>
                    <a:pt x="2441510" y="5870327"/>
                    <a:pt x="2376125" y="6362940"/>
                    <a:pt x="2371478" y="6858000"/>
                  </a:cubicBezTo>
                  <a:lnTo>
                    <a:pt x="2562213" y="6858000"/>
                  </a:lnTo>
                  <a:cubicBezTo>
                    <a:pt x="2566810" y="6379148"/>
                    <a:pt x="2630122" y="5902679"/>
                    <a:pt x="2750724" y="5439240"/>
                  </a:cubicBezTo>
                  <a:cubicBezTo>
                    <a:pt x="2764018" y="5388310"/>
                    <a:pt x="2733513" y="5336243"/>
                    <a:pt x="2682567" y="5322927"/>
                  </a:cubicBezTo>
                  <a:close/>
                  <a:moveTo>
                    <a:pt x="4160068" y="5925910"/>
                  </a:moveTo>
                  <a:cubicBezTo>
                    <a:pt x="4108531" y="5915060"/>
                    <a:pt x="4057948" y="5948028"/>
                    <a:pt x="4047095" y="5999555"/>
                  </a:cubicBezTo>
                  <a:cubicBezTo>
                    <a:pt x="4047089" y="5999562"/>
                    <a:pt x="4047089" y="5999568"/>
                    <a:pt x="4047089" y="5999574"/>
                  </a:cubicBezTo>
                  <a:cubicBezTo>
                    <a:pt x="3988006" y="6282004"/>
                    <a:pt x="3956363" y="6569507"/>
                    <a:pt x="3952611" y="6858000"/>
                  </a:cubicBezTo>
                  <a:lnTo>
                    <a:pt x="4143347" y="6858000"/>
                  </a:lnTo>
                  <a:cubicBezTo>
                    <a:pt x="4147123" y="6582600"/>
                    <a:pt x="4177425" y="6308242"/>
                    <a:pt x="4233819" y="6038663"/>
                  </a:cubicBezTo>
                  <a:cubicBezTo>
                    <a:pt x="4244634" y="5987155"/>
                    <a:pt x="4211649" y="5936626"/>
                    <a:pt x="4160132" y="5925783"/>
                  </a:cubicBezTo>
                  <a:close/>
                  <a:moveTo>
                    <a:pt x="2089189" y="6428024"/>
                  </a:moveTo>
                  <a:cubicBezTo>
                    <a:pt x="2036629" y="6424783"/>
                    <a:pt x="1991399" y="6464762"/>
                    <a:pt x="1988163" y="6517325"/>
                  </a:cubicBezTo>
                  <a:cubicBezTo>
                    <a:pt x="1981233" y="6630015"/>
                    <a:pt x="1977228" y="6744293"/>
                    <a:pt x="1976147" y="6857937"/>
                  </a:cubicBezTo>
                  <a:lnTo>
                    <a:pt x="2166882" y="6857937"/>
                  </a:lnTo>
                  <a:cubicBezTo>
                    <a:pt x="2167900" y="6748170"/>
                    <a:pt x="2171778" y="6637832"/>
                    <a:pt x="2178454" y="6529020"/>
                  </a:cubicBezTo>
                  <a:cubicBezTo>
                    <a:pt x="2181645" y="6476520"/>
                    <a:pt x="2141737" y="6431393"/>
                    <a:pt x="2089253" y="6428088"/>
                  </a:cubicBezTo>
                  <a:close/>
                  <a:moveTo>
                    <a:pt x="3184583" y="972450"/>
                  </a:moveTo>
                  <a:cubicBezTo>
                    <a:pt x="3218833" y="1012264"/>
                    <a:pt x="3278838" y="1016897"/>
                    <a:pt x="3318797" y="982811"/>
                  </a:cubicBezTo>
                  <a:cubicBezTo>
                    <a:pt x="3763936" y="601738"/>
                    <a:pt x="4250629" y="272053"/>
                    <a:pt x="4769659" y="0"/>
                  </a:cubicBezTo>
                  <a:lnTo>
                    <a:pt x="4375472" y="0"/>
                  </a:lnTo>
                  <a:cubicBezTo>
                    <a:pt x="3957475" y="243105"/>
                    <a:pt x="3562373" y="523572"/>
                    <a:pt x="3195010" y="837960"/>
                  </a:cubicBezTo>
                  <a:cubicBezTo>
                    <a:pt x="3154981" y="872186"/>
                    <a:pt x="3150289" y="932364"/>
                    <a:pt x="3184526" y="972381"/>
                  </a:cubicBezTo>
                  <a:cubicBezTo>
                    <a:pt x="3184545" y="972406"/>
                    <a:pt x="3184564" y="972425"/>
                    <a:pt x="3184583" y="972450"/>
                  </a:cubicBezTo>
                  <a:close/>
                  <a:moveTo>
                    <a:pt x="3860550" y="1312617"/>
                  </a:moveTo>
                  <a:cubicBezTo>
                    <a:pt x="2823496" y="2150361"/>
                    <a:pt x="2039217" y="3259260"/>
                    <a:pt x="1594930" y="4515984"/>
                  </a:cubicBezTo>
                  <a:cubicBezTo>
                    <a:pt x="1577376" y="4565636"/>
                    <a:pt x="1603405" y="4620118"/>
                    <a:pt x="1653073" y="4637667"/>
                  </a:cubicBezTo>
                  <a:cubicBezTo>
                    <a:pt x="1702740" y="4655216"/>
                    <a:pt x="1757240" y="4629195"/>
                    <a:pt x="1774794" y="4579543"/>
                  </a:cubicBezTo>
                  <a:cubicBezTo>
                    <a:pt x="2207331" y="3355996"/>
                    <a:pt x="2970909" y="2276380"/>
                    <a:pt x="3980586" y="1460773"/>
                  </a:cubicBezTo>
                  <a:cubicBezTo>
                    <a:pt x="4021531" y="1427634"/>
                    <a:pt x="4027850" y="1367596"/>
                    <a:pt x="3994700" y="1326664"/>
                  </a:cubicBezTo>
                  <a:cubicBezTo>
                    <a:pt x="3961551" y="1285732"/>
                    <a:pt x="3901494" y="1279414"/>
                    <a:pt x="3860550" y="1312554"/>
                  </a:cubicBezTo>
                  <a:close/>
                  <a:moveTo>
                    <a:pt x="1208945" y="3617516"/>
                  </a:moveTo>
                  <a:cubicBezTo>
                    <a:pt x="1160835" y="3596077"/>
                    <a:pt x="1104454" y="3617687"/>
                    <a:pt x="1083015" y="3665782"/>
                  </a:cubicBezTo>
                  <a:cubicBezTo>
                    <a:pt x="1083009" y="3665795"/>
                    <a:pt x="1083002" y="3665808"/>
                    <a:pt x="1082996" y="3665820"/>
                  </a:cubicBezTo>
                  <a:cubicBezTo>
                    <a:pt x="859435" y="4168317"/>
                    <a:pt x="688555" y="4692614"/>
                    <a:pt x="573097" y="5230321"/>
                  </a:cubicBezTo>
                  <a:cubicBezTo>
                    <a:pt x="458636" y="5765430"/>
                    <a:pt x="398987" y="6310803"/>
                    <a:pt x="395077" y="6858000"/>
                  </a:cubicBezTo>
                  <a:lnTo>
                    <a:pt x="585812" y="6858000"/>
                  </a:lnTo>
                  <a:cubicBezTo>
                    <a:pt x="589655" y="6324252"/>
                    <a:pt x="647789" y="5792284"/>
                    <a:pt x="759318" y="5270300"/>
                  </a:cubicBezTo>
                  <a:cubicBezTo>
                    <a:pt x="872119" y="4745584"/>
                    <a:pt x="1038993" y="4233954"/>
                    <a:pt x="1257265" y="3743616"/>
                  </a:cubicBezTo>
                  <a:cubicBezTo>
                    <a:pt x="1278792" y="3695566"/>
                    <a:pt x="1257284" y="3639157"/>
                    <a:pt x="1209212" y="3617637"/>
                  </a:cubicBezTo>
                  <a:cubicBezTo>
                    <a:pt x="1209123" y="3617598"/>
                    <a:pt x="1209034" y="3617554"/>
                    <a:pt x="1208945" y="3617516"/>
                  </a:cubicBezTo>
                  <a:close/>
                  <a:moveTo>
                    <a:pt x="943632" y="5974532"/>
                  </a:moveTo>
                  <a:cubicBezTo>
                    <a:pt x="891294" y="5968659"/>
                    <a:pt x="844106" y="6006305"/>
                    <a:pt x="838219" y="6058620"/>
                  </a:cubicBezTo>
                  <a:cubicBezTo>
                    <a:pt x="808496" y="6324074"/>
                    <a:pt x="792557" y="6590926"/>
                    <a:pt x="790471" y="6858000"/>
                  </a:cubicBezTo>
                  <a:lnTo>
                    <a:pt x="981207" y="6858000"/>
                  </a:lnTo>
                  <a:cubicBezTo>
                    <a:pt x="983267" y="6597917"/>
                    <a:pt x="998799" y="6338127"/>
                    <a:pt x="1027746" y="6079658"/>
                  </a:cubicBezTo>
                  <a:cubicBezTo>
                    <a:pt x="1033475" y="6027432"/>
                    <a:pt x="995855" y="5980418"/>
                    <a:pt x="943632" y="5974532"/>
                  </a:cubicBezTo>
                  <a:close/>
                  <a:moveTo>
                    <a:pt x="2331805" y="1389587"/>
                  </a:moveTo>
                  <a:cubicBezTo>
                    <a:pt x="2707325" y="978292"/>
                    <a:pt x="3123535" y="606057"/>
                    <a:pt x="3574065" y="278578"/>
                  </a:cubicBezTo>
                  <a:cubicBezTo>
                    <a:pt x="3707535" y="181588"/>
                    <a:pt x="3843911" y="88728"/>
                    <a:pt x="3983193" y="0"/>
                  </a:cubicBezTo>
                  <a:lnTo>
                    <a:pt x="3637771" y="0"/>
                  </a:lnTo>
                  <a:cubicBezTo>
                    <a:pt x="3578433" y="40678"/>
                    <a:pt x="3519814" y="82118"/>
                    <a:pt x="3461913" y="124321"/>
                  </a:cubicBezTo>
                  <a:cubicBezTo>
                    <a:pt x="3000969" y="459401"/>
                    <a:pt x="2575133" y="840261"/>
                    <a:pt x="2190915" y="1261071"/>
                  </a:cubicBezTo>
                  <a:cubicBezTo>
                    <a:pt x="2155794" y="1300312"/>
                    <a:pt x="2159145" y="1360585"/>
                    <a:pt x="2198398" y="1395695"/>
                  </a:cubicBezTo>
                  <a:cubicBezTo>
                    <a:pt x="2237111" y="1430316"/>
                    <a:pt x="2296417" y="1427602"/>
                    <a:pt x="2331805" y="1389587"/>
                  </a:cubicBezTo>
                  <a:close/>
                  <a:moveTo>
                    <a:pt x="558283" y="4174100"/>
                  </a:moveTo>
                  <a:cubicBezTo>
                    <a:pt x="508369" y="4157308"/>
                    <a:pt x="454289" y="4184143"/>
                    <a:pt x="437484" y="4234036"/>
                  </a:cubicBezTo>
                  <a:cubicBezTo>
                    <a:pt x="152999" y="5079865"/>
                    <a:pt x="5315" y="5965653"/>
                    <a:pt x="0" y="6858000"/>
                  </a:cubicBezTo>
                  <a:lnTo>
                    <a:pt x="190735" y="6858000"/>
                  </a:lnTo>
                  <a:cubicBezTo>
                    <a:pt x="196021" y="5986354"/>
                    <a:pt x="340335" y="5121127"/>
                    <a:pt x="618237" y="4294926"/>
                  </a:cubicBezTo>
                  <a:cubicBezTo>
                    <a:pt x="635068" y="4245032"/>
                    <a:pt x="608253" y="4190944"/>
                    <a:pt x="558344" y="4174119"/>
                  </a:cubicBezTo>
                  <a:cubicBezTo>
                    <a:pt x="558323" y="4174113"/>
                    <a:pt x="558303" y="4174107"/>
                    <a:pt x="558283" y="4174100"/>
                  </a:cubicBezTo>
                  <a:close/>
                  <a:moveTo>
                    <a:pt x="3037844" y="3379615"/>
                  </a:moveTo>
                  <a:cubicBezTo>
                    <a:pt x="3010054" y="3424341"/>
                    <a:pt x="3023793" y="3483121"/>
                    <a:pt x="3068533" y="3510909"/>
                  </a:cubicBezTo>
                  <a:cubicBezTo>
                    <a:pt x="3111436" y="3537552"/>
                    <a:pt x="3167678" y="3526131"/>
                    <a:pt x="3196790" y="3484868"/>
                  </a:cubicBezTo>
                  <a:cubicBezTo>
                    <a:pt x="3756262" y="2640934"/>
                    <a:pt x="4511937" y="1945073"/>
                    <a:pt x="5399149" y="1456833"/>
                  </a:cubicBezTo>
                  <a:cubicBezTo>
                    <a:pt x="5438612" y="1435178"/>
                    <a:pt x="5478324" y="1413994"/>
                    <a:pt x="5518295" y="1393274"/>
                  </a:cubicBezTo>
                  <a:lnTo>
                    <a:pt x="5518295" y="1179080"/>
                  </a:lnTo>
                  <a:cubicBezTo>
                    <a:pt x="5447342" y="1214673"/>
                    <a:pt x="5377024" y="1251582"/>
                    <a:pt x="5307342" y="1289800"/>
                  </a:cubicBezTo>
                  <a:cubicBezTo>
                    <a:pt x="4393090" y="1792906"/>
                    <a:pt x="3614361" y="2509939"/>
                    <a:pt x="3037780" y="3379551"/>
                  </a:cubicBezTo>
                  <a:close/>
                  <a:moveTo>
                    <a:pt x="4015808" y="3381140"/>
                  </a:moveTo>
                  <a:cubicBezTo>
                    <a:pt x="3403115" y="4138641"/>
                    <a:pt x="2998006" y="5042404"/>
                    <a:pt x="2840242" y="6003706"/>
                  </a:cubicBezTo>
                  <a:cubicBezTo>
                    <a:pt x="2831761" y="6055671"/>
                    <a:pt x="2867028" y="6104675"/>
                    <a:pt x="2919009" y="6113154"/>
                  </a:cubicBezTo>
                  <a:cubicBezTo>
                    <a:pt x="2919009" y="6113154"/>
                    <a:pt x="2919016" y="6113154"/>
                    <a:pt x="2919016" y="6113154"/>
                  </a:cubicBezTo>
                  <a:cubicBezTo>
                    <a:pt x="2924121" y="6114012"/>
                    <a:pt x="2929290" y="6114438"/>
                    <a:pt x="2934465" y="6114425"/>
                  </a:cubicBezTo>
                  <a:cubicBezTo>
                    <a:pt x="2981183" y="6114381"/>
                    <a:pt x="3020989" y="6080504"/>
                    <a:pt x="3028498" y="6034405"/>
                  </a:cubicBezTo>
                  <a:cubicBezTo>
                    <a:pt x="3282755" y="4490388"/>
                    <a:pt x="4190147" y="3130744"/>
                    <a:pt x="5518613" y="2303182"/>
                  </a:cubicBezTo>
                  <a:lnTo>
                    <a:pt x="5518613" y="2080027"/>
                  </a:lnTo>
                  <a:cubicBezTo>
                    <a:pt x="4944729" y="2421681"/>
                    <a:pt x="4435910" y="2862252"/>
                    <a:pt x="4015745" y="3381331"/>
                  </a:cubicBezTo>
                  <a:close/>
                  <a:moveTo>
                    <a:pt x="3489188" y="3682663"/>
                  </a:moveTo>
                  <a:cubicBezTo>
                    <a:pt x="3520805" y="3682689"/>
                    <a:pt x="3550382" y="3667047"/>
                    <a:pt x="3568152" y="3640906"/>
                  </a:cubicBezTo>
                  <a:cubicBezTo>
                    <a:pt x="3901106" y="3151394"/>
                    <a:pt x="4306483" y="2715260"/>
                    <a:pt x="4770422" y="2347419"/>
                  </a:cubicBezTo>
                  <a:cubicBezTo>
                    <a:pt x="4811678" y="2314686"/>
                    <a:pt x="4818582" y="2254712"/>
                    <a:pt x="4785839" y="2213469"/>
                  </a:cubicBezTo>
                  <a:cubicBezTo>
                    <a:pt x="4753096" y="2172225"/>
                    <a:pt x="4693104" y="2165323"/>
                    <a:pt x="4651848" y="2198056"/>
                  </a:cubicBezTo>
                  <a:cubicBezTo>
                    <a:pt x="4172796" y="2577934"/>
                    <a:pt x="3754234" y="3028338"/>
                    <a:pt x="3410477" y="3533872"/>
                  </a:cubicBezTo>
                  <a:cubicBezTo>
                    <a:pt x="3380843" y="3577397"/>
                    <a:pt x="3392116" y="3636704"/>
                    <a:pt x="3435655" y="3666329"/>
                  </a:cubicBezTo>
                  <a:cubicBezTo>
                    <a:pt x="3451441" y="3677071"/>
                    <a:pt x="3470089" y="3682829"/>
                    <a:pt x="3489188" y="3682854"/>
                  </a:cubicBezTo>
                  <a:close/>
                  <a:moveTo>
                    <a:pt x="5235117" y="0"/>
                  </a:moveTo>
                  <a:cubicBezTo>
                    <a:pt x="5039295" y="89448"/>
                    <a:pt x="4847415" y="187160"/>
                    <a:pt x="4659477" y="293133"/>
                  </a:cubicBezTo>
                  <a:cubicBezTo>
                    <a:pt x="4613020" y="317947"/>
                    <a:pt x="4595485" y="375710"/>
                    <a:pt x="4620306" y="422150"/>
                  </a:cubicBezTo>
                  <a:cubicBezTo>
                    <a:pt x="4645127" y="468591"/>
                    <a:pt x="4702908" y="486122"/>
                    <a:pt x="4749364" y="461309"/>
                  </a:cubicBezTo>
                  <a:cubicBezTo>
                    <a:pt x="4750655" y="460619"/>
                    <a:pt x="4751933" y="459899"/>
                    <a:pt x="4753192" y="459149"/>
                  </a:cubicBezTo>
                  <a:cubicBezTo>
                    <a:pt x="5000906" y="319499"/>
                    <a:pt x="5256473" y="194249"/>
                    <a:pt x="5518613" y="84025"/>
                  </a:cubicBezTo>
                  <a:lnTo>
                    <a:pt x="5518613" y="0"/>
                  </a:lnTo>
                  <a:close/>
                  <a:moveTo>
                    <a:pt x="4506698" y="959040"/>
                  </a:moveTo>
                  <a:cubicBezTo>
                    <a:pt x="4534914" y="1003493"/>
                    <a:pt x="4593832" y="1016668"/>
                    <a:pt x="4638305" y="988467"/>
                  </a:cubicBezTo>
                  <a:cubicBezTo>
                    <a:pt x="4920053" y="809892"/>
                    <a:pt x="5214244" y="651732"/>
                    <a:pt x="5518613" y="515208"/>
                  </a:cubicBezTo>
                  <a:lnTo>
                    <a:pt x="5518613" y="306799"/>
                  </a:lnTo>
                  <a:cubicBezTo>
                    <a:pt x="5178233" y="454670"/>
                    <a:pt x="4849857" y="628751"/>
                    <a:pt x="4536453" y="827473"/>
                  </a:cubicBezTo>
                  <a:cubicBezTo>
                    <a:pt x="4491903" y="855559"/>
                    <a:pt x="4478558" y="914434"/>
                    <a:pt x="4506654" y="958970"/>
                  </a:cubicBezTo>
                  <a:cubicBezTo>
                    <a:pt x="4506666" y="958995"/>
                    <a:pt x="4506685" y="959014"/>
                    <a:pt x="4506698" y="959040"/>
                  </a:cubicBezTo>
                  <a:close/>
                  <a:moveTo>
                    <a:pt x="4505109" y="4769266"/>
                  </a:moveTo>
                  <a:cubicBezTo>
                    <a:pt x="4479111" y="4815060"/>
                    <a:pt x="4495178" y="4873248"/>
                    <a:pt x="4540986" y="4899237"/>
                  </a:cubicBezTo>
                  <a:cubicBezTo>
                    <a:pt x="4586794" y="4925227"/>
                    <a:pt x="4645000" y="4909165"/>
                    <a:pt x="4670998" y="4863371"/>
                  </a:cubicBezTo>
                  <a:cubicBezTo>
                    <a:pt x="4671334" y="4862767"/>
                    <a:pt x="4671672" y="4862163"/>
                    <a:pt x="4672002" y="4861553"/>
                  </a:cubicBezTo>
                  <a:cubicBezTo>
                    <a:pt x="4894546" y="4460236"/>
                    <a:pt x="5180426" y="4097461"/>
                    <a:pt x="5518613" y="3787218"/>
                  </a:cubicBezTo>
                  <a:lnTo>
                    <a:pt x="5518613" y="3532982"/>
                  </a:lnTo>
                  <a:cubicBezTo>
                    <a:pt x="5109015" y="3880656"/>
                    <a:pt x="4765659" y="4299483"/>
                    <a:pt x="4505109" y="4769266"/>
                  </a:cubicBezTo>
                  <a:close/>
                  <a:moveTo>
                    <a:pt x="5138541" y="6858000"/>
                  </a:moveTo>
                  <a:lnTo>
                    <a:pt x="5329276" y="6858000"/>
                  </a:lnTo>
                  <a:cubicBezTo>
                    <a:pt x="5336270" y="6515418"/>
                    <a:pt x="5400255" y="6176332"/>
                    <a:pt x="5518613" y="5854724"/>
                  </a:cubicBezTo>
                  <a:lnTo>
                    <a:pt x="5518613" y="5389791"/>
                  </a:lnTo>
                  <a:cubicBezTo>
                    <a:pt x="5516706" y="5392651"/>
                    <a:pt x="5514862" y="5395638"/>
                    <a:pt x="5513146" y="5398816"/>
                  </a:cubicBezTo>
                  <a:cubicBezTo>
                    <a:pt x="5276239" y="5849385"/>
                    <a:pt x="5147964" y="6349072"/>
                    <a:pt x="5138541" y="6858000"/>
                  </a:cubicBezTo>
                  <a:close/>
                  <a:moveTo>
                    <a:pt x="4985952" y="5893686"/>
                  </a:moveTo>
                  <a:cubicBezTo>
                    <a:pt x="5035970" y="5910160"/>
                    <a:pt x="5089878" y="5882988"/>
                    <a:pt x="5106370" y="5832987"/>
                  </a:cubicBezTo>
                  <a:cubicBezTo>
                    <a:pt x="5204847" y="5534978"/>
                    <a:pt x="5343543" y="5251798"/>
                    <a:pt x="5518613" y="4991277"/>
                  </a:cubicBezTo>
                  <a:lnTo>
                    <a:pt x="5518613" y="4667127"/>
                  </a:lnTo>
                  <a:cubicBezTo>
                    <a:pt x="5258469" y="4998866"/>
                    <a:pt x="5057911" y="5373234"/>
                    <a:pt x="4925871" y="5773559"/>
                  </a:cubicBezTo>
                  <a:cubicBezTo>
                    <a:pt x="4909525" y="5823396"/>
                    <a:pt x="4936514" y="5877065"/>
                    <a:pt x="4986271" y="5893686"/>
                  </a:cubicBezTo>
                  <a:close/>
                  <a:moveTo>
                    <a:pt x="4231022" y="3746922"/>
                  </a:moveTo>
                  <a:cubicBezTo>
                    <a:pt x="3547960" y="4641328"/>
                    <a:pt x="3172923" y="5732780"/>
                    <a:pt x="3162013" y="6858000"/>
                  </a:cubicBezTo>
                  <a:lnTo>
                    <a:pt x="3352748" y="6858000"/>
                  </a:lnTo>
                  <a:cubicBezTo>
                    <a:pt x="3371256" y="5227137"/>
                    <a:pt x="4178328" y="3706129"/>
                    <a:pt x="5518613" y="2776187"/>
                  </a:cubicBezTo>
                  <a:lnTo>
                    <a:pt x="5518613" y="2545913"/>
                  </a:lnTo>
                  <a:cubicBezTo>
                    <a:pt x="5487758" y="2566252"/>
                    <a:pt x="5457088" y="2586909"/>
                    <a:pt x="5426615" y="2607883"/>
                  </a:cubicBezTo>
                  <a:cubicBezTo>
                    <a:pt x="4970414" y="2922055"/>
                    <a:pt x="4566875" y="3306503"/>
                    <a:pt x="4231022" y="3746922"/>
                  </a:cubicBezTo>
                  <a:close/>
                  <a:moveTo>
                    <a:pt x="4908260" y="6204806"/>
                  </a:moveTo>
                  <a:cubicBezTo>
                    <a:pt x="4856386" y="6195698"/>
                    <a:pt x="4806947" y="6230357"/>
                    <a:pt x="4797837" y="6282220"/>
                  </a:cubicBezTo>
                  <a:cubicBezTo>
                    <a:pt x="4797830" y="6282240"/>
                    <a:pt x="4797830" y="6282265"/>
                    <a:pt x="4797824" y="6282284"/>
                  </a:cubicBezTo>
                  <a:cubicBezTo>
                    <a:pt x="4764509" y="6472452"/>
                    <a:pt x="4746160" y="6664972"/>
                    <a:pt x="4742956" y="6858000"/>
                  </a:cubicBezTo>
                  <a:lnTo>
                    <a:pt x="4933691" y="6858000"/>
                  </a:lnTo>
                  <a:cubicBezTo>
                    <a:pt x="4936800" y="6676031"/>
                    <a:pt x="4954081" y="6494507"/>
                    <a:pt x="4985380" y="6315208"/>
                  </a:cubicBezTo>
                  <a:cubicBezTo>
                    <a:pt x="4994510" y="6263445"/>
                    <a:pt x="4960013" y="6214067"/>
                    <a:pt x="4908260" y="6204806"/>
                  </a:cubicBezTo>
                  <a:close/>
                  <a:moveTo>
                    <a:pt x="4560803" y="3966517"/>
                  </a:moveTo>
                  <a:cubicBezTo>
                    <a:pt x="4263180" y="4352091"/>
                    <a:pt x="4025727" y="4780535"/>
                    <a:pt x="3856544" y="5237250"/>
                  </a:cubicBezTo>
                  <a:cubicBezTo>
                    <a:pt x="3838253" y="5286641"/>
                    <a:pt x="3863468" y="5341505"/>
                    <a:pt x="3912875" y="5359791"/>
                  </a:cubicBezTo>
                  <a:cubicBezTo>
                    <a:pt x="3962282" y="5378077"/>
                    <a:pt x="4017163" y="5352869"/>
                    <a:pt x="4035454" y="5303478"/>
                  </a:cubicBezTo>
                  <a:cubicBezTo>
                    <a:pt x="4333199" y="4501537"/>
                    <a:pt x="4846398" y="3797203"/>
                    <a:pt x="5518613" y="3267942"/>
                  </a:cubicBezTo>
                  <a:lnTo>
                    <a:pt x="5518613" y="3027944"/>
                  </a:lnTo>
                  <a:cubicBezTo>
                    <a:pt x="5157405" y="3294948"/>
                    <a:pt x="4835056" y="3610823"/>
                    <a:pt x="4560803" y="396651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34" name="Google Shape;34;p5"/>
            <p:cNvSpPr/>
            <p:nvPr/>
          </p:nvSpPr>
          <p:spPr>
            <a:xfrm>
              <a:off x="5330737" y="210583"/>
              <a:ext cx="3668526" cy="4753341"/>
            </a:xfrm>
            <a:custGeom>
              <a:avLst/>
              <a:gdLst/>
              <a:ahLst/>
              <a:cxnLst/>
              <a:rect l="l" t="t" r="r" b="b"/>
              <a:pathLst>
                <a:path w="4891368" h="6337788" extrusionOk="0">
                  <a:moveTo>
                    <a:pt x="745243" y="3328976"/>
                  </a:moveTo>
                  <a:cubicBezTo>
                    <a:pt x="615034" y="3317536"/>
                    <a:pt x="605370" y="3517682"/>
                    <a:pt x="735833" y="3519144"/>
                  </a:cubicBezTo>
                  <a:cubicBezTo>
                    <a:pt x="854598" y="3519335"/>
                    <a:pt x="863499" y="3340544"/>
                    <a:pt x="745243" y="3328976"/>
                  </a:cubicBezTo>
                  <a:close/>
                  <a:moveTo>
                    <a:pt x="1658484" y="6147620"/>
                  </a:moveTo>
                  <a:cubicBezTo>
                    <a:pt x="1528275" y="6136180"/>
                    <a:pt x="1518611" y="6336390"/>
                    <a:pt x="1649138" y="6337788"/>
                  </a:cubicBezTo>
                  <a:cubicBezTo>
                    <a:pt x="1767903" y="6337916"/>
                    <a:pt x="1776676" y="6159125"/>
                    <a:pt x="1658484" y="6147620"/>
                  </a:cubicBezTo>
                  <a:close/>
                  <a:moveTo>
                    <a:pt x="1259974" y="4171957"/>
                  </a:moveTo>
                  <a:cubicBezTo>
                    <a:pt x="1129765" y="4160580"/>
                    <a:pt x="1119783" y="4360664"/>
                    <a:pt x="1250564" y="4362189"/>
                  </a:cubicBezTo>
                  <a:cubicBezTo>
                    <a:pt x="1369329" y="4362253"/>
                    <a:pt x="1378166" y="4183652"/>
                    <a:pt x="1259974" y="4171957"/>
                  </a:cubicBezTo>
                  <a:close/>
                  <a:moveTo>
                    <a:pt x="1778774" y="3926811"/>
                  </a:moveTo>
                  <a:cubicBezTo>
                    <a:pt x="1648566" y="3915307"/>
                    <a:pt x="1638902" y="4115517"/>
                    <a:pt x="1769365" y="4116979"/>
                  </a:cubicBezTo>
                  <a:cubicBezTo>
                    <a:pt x="1888066" y="4117487"/>
                    <a:pt x="1896967" y="3938442"/>
                    <a:pt x="1778774" y="3926811"/>
                  </a:cubicBezTo>
                  <a:close/>
                  <a:moveTo>
                    <a:pt x="2490854" y="5643345"/>
                  </a:moveTo>
                  <a:cubicBezTo>
                    <a:pt x="2372661" y="5654976"/>
                    <a:pt x="2381499" y="5833513"/>
                    <a:pt x="2500200" y="5833576"/>
                  </a:cubicBezTo>
                  <a:cubicBezTo>
                    <a:pt x="2630790" y="5832115"/>
                    <a:pt x="2621062" y="5632095"/>
                    <a:pt x="2490727" y="5643408"/>
                  </a:cubicBezTo>
                  <a:close/>
                  <a:moveTo>
                    <a:pt x="1817685" y="949650"/>
                  </a:moveTo>
                  <a:cubicBezTo>
                    <a:pt x="1699556" y="961282"/>
                    <a:pt x="1708330" y="1139882"/>
                    <a:pt x="1827031" y="1139882"/>
                  </a:cubicBezTo>
                  <a:cubicBezTo>
                    <a:pt x="1957811" y="1138420"/>
                    <a:pt x="1947957" y="938337"/>
                    <a:pt x="1817685" y="949650"/>
                  </a:cubicBezTo>
                  <a:close/>
                  <a:moveTo>
                    <a:pt x="1761990" y="2491334"/>
                  </a:moveTo>
                  <a:cubicBezTo>
                    <a:pt x="1892707" y="2489745"/>
                    <a:pt x="1882789" y="2289725"/>
                    <a:pt x="1752580" y="2301102"/>
                  </a:cubicBezTo>
                  <a:cubicBezTo>
                    <a:pt x="1634388" y="2312734"/>
                    <a:pt x="1643289" y="2491334"/>
                    <a:pt x="1761990" y="2491334"/>
                  </a:cubicBezTo>
                  <a:close/>
                  <a:moveTo>
                    <a:pt x="722863" y="4567103"/>
                  </a:moveTo>
                  <a:cubicBezTo>
                    <a:pt x="592591" y="4555789"/>
                    <a:pt x="582990" y="4755682"/>
                    <a:pt x="713453" y="4757334"/>
                  </a:cubicBezTo>
                  <a:cubicBezTo>
                    <a:pt x="832154" y="4757334"/>
                    <a:pt x="841119" y="4578734"/>
                    <a:pt x="722863" y="4567103"/>
                  </a:cubicBezTo>
                  <a:close/>
                  <a:moveTo>
                    <a:pt x="4272069" y="190694"/>
                  </a:moveTo>
                  <a:cubicBezTo>
                    <a:pt x="4402786" y="189105"/>
                    <a:pt x="4392868" y="-10851"/>
                    <a:pt x="4262659" y="463"/>
                  </a:cubicBezTo>
                  <a:cubicBezTo>
                    <a:pt x="4144467" y="12157"/>
                    <a:pt x="4153304" y="190758"/>
                    <a:pt x="4272069" y="190694"/>
                  </a:cubicBezTo>
                  <a:close/>
                  <a:moveTo>
                    <a:pt x="84153" y="3888675"/>
                  </a:moveTo>
                  <a:cubicBezTo>
                    <a:pt x="-33721" y="3900434"/>
                    <a:pt x="-25138" y="4079352"/>
                    <a:pt x="93436" y="4079352"/>
                  </a:cubicBezTo>
                  <a:cubicBezTo>
                    <a:pt x="224280" y="4077445"/>
                    <a:pt x="214235" y="3877425"/>
                    <a:pt x="84153" y="3888675"/>
                  </a:cubicBezTo>
                  <a:close/>
                  <a:moveTo>
                    <a:pt x="489339" y="5693238"/>
                  </a:moveTo>
                  <a:cubicBezTo>
                    <a:pt x="371210" y="5704679"/>
                    <a:pt x="379984" y="5883470"/>
                    <a:pt x="498685" y="5883407"/>
                  </a:cubicBezTo>
                  <a:cubicBezTo>
                    <a:pt x="629403" y="5882135"/>
                    <a:pt x="619611" y="5681925"/>
                    <a:pt x="489339" y="5693366"/>
                  </a:cubicBezTo>
                  <a:close/>
                  <a:moveTo>
                    <a:pt x="2214860" y="5039345"/>
                  </a:moveTo>
                  <a:cubicBezTo>
                    <a:pt x="2096731" y="5050976"/>
                    <a:pt x="2105504" y="5229576"/>
                    <a:pt x="2224206" y="5229576"/>
                  </a:cubicBezTo>
                  <a:cubicBezTo>
                    <a:pt x="2354923" y="5228178"/>
                    <a:pt x="2345132" y="5028222"/>
                    <a:pt x="2214860" y="5039472"/>
                  </a:cubicBezTo>
                  <a:close/>
                  <a:moveTo>
                    <a:pt x="4448054" y="5922813"/>
                  </a:moveTo>
                  <a:cubicBezTo>
                    <a:pt x="4329862" y="5934444"/>
                    <a:pt x="4338763" y="6113108"/>
                    <a:pt x="4457464" y="6113044"/>
                  </a:cubicBezTo>
                  <a:cubicBezTo>
                    <a:pt x="4588435" y="6111774"/>
                    <a:pt x="4578326" y="5911754"/>
                    <a:pt x="4448054" y="5923067"/>
                  </a:cubicBezTo>
                  <a:close/>
                  <a:moveTo>
                    <a:pt x="4267491" y="1896804"/>
                  </a:moveTo>
                  <a:cubicBezTo>
                    <a:pt x="4149299" y="1908372"/>
                    <a:pt x="4158136" y="2086973"/>
                    <a:pt x="4276837" y="2087036"/>
                  </a:cubicBezTo>
                  <a:cubicBezTo>
                    <a:pt x="4407554" y="2085765"/>
                    <a:pt x="4397700" y="1885682"/>
                    <a:pt x="4267491" y="1897059"/>
                  </a:cubicBezTo>
                  <a:close/>
                  <a:moveTo>
                    <a:pt x="4153050" y="722301"/>
                  </a:moveTo>
                  <a:cubicBezTo>
                    <a:pt x="4283831" y="720775"/>
                    <a:pt x="4273849" y="520755"/>
                    <a:pt x="4143704" y="532069"/>
                  </a:cubicBezTo>
                  <a:cubicBezTo>
                    <a:pt x="4025384" y="543954"/>
                    <a:pt x="4034222" y="722491"/>
                    <a:pt x="4152923" y="722555"/>
                  </a:cubicBezTo>
                  <a:close/>
                  <a:moveTo>
                    <a:pt x="4144848" y="4439731"/>
                  </a:moveTo>
                  <a:cubicBezTo>
                    <a:pt x="4026719" y="4451362"/>
                    <a:pt x="4035557" y="4629962"/>
                    <a:pt x="4154258" y="4629962"/>
                  </a:cubicBezTo>
                  <a:cubicBezTo>
                    <a:pt x="4284975" y="4628373"/>
                    <a:pt x="4275184" y="4428417"/>
                    <a:pt x="4144848" y="4439731"/>
                  </a:cubicBezTo>
                  <a:close/>
                  <a:moveTo>
                    <a:pt x="4591233" y="5427499"/>
                  </a:moveTo>
                  <a:cubicBezTo>
                    <a:pt x="4461278" y="5416058"/>
                    <a:pt x="4451042" y="5616269"/>
                    <a:pt x="4582078" y="5617476"/>
                  </a:cubicBezTo>
                  <a:cubicBezTo>
                    <a:pt x="4700524" y="5617858"/>
                    <a:pt x="4709235" y="5439067"/>
                    <a:pt x="4591233" y="5427499"/>
                  </a:cubicBezTo>
                  <a:close/>
                  <a:moveTo>
                    <a:pt x="4806955" y="4171957"/>
                  </a:moveTo>
                  <a:cubicBezTo>
                    <a:pt x="4676746" y="4160580"/>
                    <a:pt x="4667082" y="4360600"/>
                    <a:pt x="4797609" y="4362189"/>
                  </a:cubicBezTo>
                  <a:cubicBezTo>
                    <a:pt x="4916373" y="4362189"/>
                    <a:pt x="4925401" y="4183589"/>
                    <a:pt x="4806955" y="4171957"/>
                  </a:cubicBezTo>
                  <a:close/>
                  <a:moveTo>
                    <a:pt x="3486302" y="1201216"/>
                  </a:moveTo>
                  <a:cubicBezTo>
                    <a:pt x="3605003" y="1201216"/>
                    <a:pt x="3613841" y="1022616"/>
                    <a:pt x="3495648" y="1010985"/>
                  </a:cubicBezTo>
                  <a:cubicBezTo>
                    <a:pt x="3365439" y="999608"/>
                    <a:pt x="3355585" y="1199627"/>
                    <a:pt x="3486302" y="1201216"/>
                  </a:cubicBezTo>
                  <a:close/>
                  <a:moveTo>
                    <a:pt x="2813387" y="534738"/>
                  </a:moveTo>
                  <a:cubicBezTo>
                    <a:pt x="2695259" y="546370"/>
                    <a:pt x="2704032" y="724906"/>
                    <a:pt x="2822734" y="724970"/>
                  </a:cubicBezTo>
                  <a:cubicBezTo>
                    <a:pt x="2953451" y="723445"/>
                    <a:pt x="2943660" y="523425"/>
                    <a:pt x="2813387" y="534738"/>
                  </a:cubicBezTo>
                  <a:close/>
                  <a:moveTo>
                    <a:pt x="3045640" y="3211646"/>
                  </a:moveTo>
                  <a:cubicBezTo>
                    <a:pt x="2927447" y="3223278"/>
                    <a:pt x="2936285" y="3401878"/>
                    <a:pt x="3055049" y="3401878"/>
                  </a:cubicBezTo>
                  <a:cubicBezTo>
                    <a:pt x="3185767" y="3400289"/>
                    <a:pt x="3175848" y="3200333"/>
                    <a:pt x="3045640" y="3211646"/>
                  </a:cubicBezTo>
                  <a:close/>
                  <a:moveTo>
                    <a:pt x="3521080" y="4894812"/>
                  </a:moveTo>
                  <a:cubicBezTo>
                    <a:pt x="3390871" y="4883499"/>
                    <a:pt x="3381207" y="5083518"/>
                    <a:pt x="3511734" y="5085044"/>
                  </a:cubicBezTo>
                  <a:cubicBezTo>
                    <a:pt x="3630498" y="5085044"/>
                    <a:pt x="3639272" y="4906507"/>
                    <a:pt x="3521080" y="4894812"/>
                  </a:cubicBezTo>
                  <a:close/>
                  <a:moveTo>
                    <a:pt x="3706220" y="5642900"/>
                  </a:moveTo>
                  <a:cubicBezTo>
                    <a:pt x="3581606" y="5643599"/>
                    <a:pt x="3581606" y="5832877"/>
                    <a:pt x="3706220" y="5833576"/>
                  </a:cubicBezTo>
                  <a:cubicBezTo>
                    <a:pt x="3830834" y="5832941"/>
                    <a:pt x="3830897" y="5643662"/>
                    <a:pt x="3706220" y="5642900"/>
                  </a:cubicBezTo>
                  <a:close/>
                  <a:moveTo>
                    <a:pt x="2673642" y="3056499"/>
                  </a:moveTo>
                  <a:cubicBezTo>
                    <a:pt x="2555513" y="3068131"/>
                    <a:pt x="2564351" y="3246731"/>
                    <a:pt x="2683051" y="3246731"/>
                  </a:cubicBezTo>
                  <a:cubicBezTo>
                    <a:pt x="2813769" y="3245206"/>
                    <a:pt x="2803914" y="3045186"/>
                    <a:pt x="2673642" y="3056499"/>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35" name="Google Shape;35;p5"/>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36" name="Google Shape;36;p5"/>
          <p:cNvSpPr txBox="1">
            <a:spLocks noGrp="1"/>
          </p:cNvSpPr>
          <p:nvPr>
            <p:ph type="body" idx="1"/>
          </p:nvPr>
        </p:nvSpPr>
        <p:spPr>
          <a:xfrm>
            <a:off x="855300" y="1430147"/>
            <a:ext cx="7433400" cy="3033900"/>
          </a:xfrm>
          <a:prstGeom prst="rect">
            <a:avLst/>
          </a:prstGeom>
        </p:spPr>
        <p:txBody>
          <a:bodyPr spcFirstLastPara="1" wrap="square" lIns="0" tIns="0" rIns="0" bIns="0" anchor="t" anchorCtr="0">
            <a:noAutofit/>
          </a:bodyPr>
          <a:lstStyle>
            <a:lvl1pPr marL="457200" lvl="0" indent="-381000" rtl="0">
              <a:spcBef>
                <a:spcPts val="0"/>
              </a:spcBef>
              <a:spcAft>
                <a:spcPts val="0"/>
              </a:spcAft>
              <a:buSzPts val="2400"/>
              <a:buChar char="●"/>
              <a:defRPr/>
            </a:lvl1pPr>
            <a:lvl2pPr marL="914400" lvl="1" indent="-381000" rtl="0">
              <a:spcBef>
                <a:spcPts val="600"/>
              </a:spcBef>
              <a:spcAft>
                <a:spcPts val="0"/>
              </a:spcAft>
              <a:buSzPts val="2400"/>
              <a:buChar char="○"/>
              <a:defRPr/>
            </a:lvl2pPr>
            <a:lvl3pPr marL="1371600" lvl="2" indent="-381000" rtl="0">
              <a:spcBef>
                <a:spcPts val="600"/>
              </a:spcBef>
              <a:spcAft>
                <a:spcPts val="0"/>
              </a:spcAft>
              <a:buSzPts val="2400"/>
              <a:buChar char="■"/>
              <a:defRPr/>
            </a:lvl3pPr>
            <a:lvl4pPr marL="1828800" lvl="3" indent="-381000" rtl="0">
              <a:spcBef>
                <a:spcPts val="600"/>
              </a:spcBef>
              <a:spcAft>
                <a:spcPts val="0"/>
              </a:spcAft>
              <a:buSzPts val="2400"/>
              <a:buChar char="●"/>
              <a:defRPr/>
            </a:lvl4pPr>
            <a:lvl5pPr marL="2286000" lvl="4" indent="-381000" rtl="0">
              <a:spcBef>
                <a:spcPts val="600"/>
              </a:spcBef>
              <a:spcAft>
                <a:spcPts val="0"/>
              </a:spcAft>
              <a:buSzPts val="2400"/>
              <a:buChar char="○"/>
              <a:defRPr/>
            </a:lvl5pPr>
            <a:lvl6pPr marL="2743200" lvl="5" indent="-381000" rtl="0">
              <a:spcBef>
                <a:spcPts val="600"/>
              </a:spcBef>
              <a:spcAft>
                <a:spcPts val="0"/>
              </a:spcAft>
              <a:buSzPts val="2400"/>
              <a:buChar char="■"/>
              <a:defRPr/>
            </a:lvl6pPr>
            <a:lvl7pPr marL="3200400" lvl="6" indent="-381000" rtl="0">
              <a:spcBef>
                <a:spcPts val="600"/>
              </a:spcBef>
              <a:spcAft>
                <a:spcPts val="0"/>
              </a:spcAft>
              <a:buSzPts val="2400"/>
              <a:buChar char="●"/>
              <a:defRPr/>
            </a:lvl7pPr>
            <a:lvl8pPr marL="3657600" lvl="7" indent="-381000" rtl="0">
              <a:spcBef>
                <a:spcPts val="600"/>
              </a:spcBef>
              <a:spcAft>
                <a:spcPts val="0"/>
              </a:spcAft>
              <a:buSzPts val="2400"/>
              <a:buChar char="○"/>
              <a:defRPr/>
            </a:lvl8pPr>
            <a:lvl9pPr marL="4114800" lvl="8" indent="-381000" rtl="0">
              <a:spcBef>
                <a:spcPts val="600"/>
              </a:spcBef>
              <a:spcAft>
                <a:spcPts val="600"/>
              </a:spcAft>
              <a:buSzPts val="2400"/>
              <a:buChar char="■"/>
              <a:defRPr/>
            </a:lvl9pPr>
          </a:lstStyle>
          <a:p>
            <a:endParaRPr/>
          </a:p>
        </p:txBody>
      </p:sp>
      <p:sp>
        <p:nvSpPr>
          <p:cNvPr id="37" name="Google Shape;37;p5"/>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 2 columns" type="twoColTx">
  <p:cSld name="TITLE_AND_TWO_COLUMNS">
    <p:spTree>
      <p:nvGrpSpPr>
        <p:cNvPr id="1" name="Shape 38"/>
        <p:cNvGrpSpPr/>
        <p:nvPr/>
      </p:nvGrpSpPr>
      <p:grpSpPr>
        <a:xfrm>
          <a:off x="0" y="0"/>
          <a:ext cx="0" cy="0"/>
          <a:chOff x="0" y="0"/>
          <a:chExt cx="0" cy="0"/>
        </a:xfrm>
      </p:grpSpPr>
      <p:grpSp>
        <p:nvGrpSpPr>
          <p:cNvPr id="39" name="Google Shape;39;p6"/>
          <p:cNvGrpSpPr/>
          <p:nvPr/>
        </p:nvGrpSpPr>
        <p:grpSpPr>
          <a:xfrm>
            <a:off x="5005048" y="0"/>
            <a:ext cx="4138960" cy="5143642"/>
            <a:chOff x="5005048" y="0"/>
            <a:chExt cx="4138960" cy="5143642"/>
          </a:xfrm>
        </p:grpSpPr>
        <p:sp>
          <p:nvSpPr>
            <p:cNvPr id="40" name="Google Shape;40;p6"/>
            <p:cNvSpPr/>
            <p:nvPr/>
          </p:nvSpPr>
          <p:spPr>
            <a:xfrm>
              <a:off x="5005049" y="0"/>
              <a:ext cx="4138960" cy="5143500"/>
            </a:xfrm>
            <a:custGeom>
              <a:avLst/>
              <a:gdLst/>
              <a:ahLst/>
              <a:cxnLst/>
              <a:rect l="l" t="t" r="r" b="b"/>
              <a:pathLst>
                <a:path w="5518613" h="6858000" extrusionOk="0">
                  <a:moveTo>
                    <a:pt x="4347879" y="6858000"/>
                  </a:moveTo>
                  <a:lnTo>
                    <a:pt x="4538614" y="6858000"/>
                  </a:lnTo>
                  <a:cubicBezTo>
                    <a:pt x="4551534" y="5930683"/>
                    <a:pt x="4899626" y="5039346"/>
                    <a:pt x="5518613" y="4348570"/>
                  </a:cubicBezTo>
                  <a:lnTo>
                    <a:pt x="5518613" y="4070500"/>
                  </a:lnTo>
                  <a:cubicBezTo>
                    <a:pt x="4781548" y="4812740"/>
                    <a:pt x="4361771" y="5812222"/>
                    <a:pt x="4347879" y="6858000"/>
                  </a:cubicBezTo>
                  <a:close/>
                  <a:moveTo>
                    <a:pt x="4301085" y="5188627"/>
                  </a:moveTo>
                  <a:cubicBezTo>
                    <a:pt x="4077511" y="5717157"/>
                    <a:pt x="3959147" y="6284191"/>
                    <a:pt x="3952611" y="6858000"/>
                  </a:cubicBezTo>
                  <a:lnTo>
                    <a:pt x="4143347" y="6858000"/>
                  </a:lnTo>
                  <a:cubicBezTo>
                    <a:pt x="4157130" y="5751110"/>
                    <a:pt x="4603757" y="4693586"/>
                    <a:pt x="5387642" y="3911730"/>
                  </a:cubicBezTo>
                  <a:cubicBezTo>
                    <a:pt x="5430449" y="3868935"/>
                    <a:pt x="5474000" y="3827197"/>
                    <a:pt x="5518295" y="3786519"/>
                  </a:cubicBezTo>
                  <a:lnTo>
                    <a:pt x="5518295" y="3532283"/>
                  </a:lnTo>
                  <a:cubicBezTo>
                    <a:pt x="5426952" y="3609615"/>
                    <a:pt x="5338451" y="3691136"/>
                    <a:pt x="5252792" y="3776858"/>
                  </a:cubicBezTo>
                  <a:cubicBezTo>
                    <a:pt x="4847103" y="4181397"/>
                    <a:pt x="4523877" y="4660866"/>
                    <a:pt x="4301085" y="5188627"/>
                  </a:cubicBezTo>
                  <a:close/>
                  <a:moveTo>
                    <a:pt x="4742956" y="6858000"/>
                  </a:moveTo>
                  <a:lnTo>
                    <a:pt x="4933691" y="6858000"/>
                  </a:lnTo>
                  <a:cubicBezTo>
                    <a:pt x="4944296" y="6192253"/>
                    <a:pt x="5147442" y="5543813"/>
                    <a:pt x="5518613" y="4990959"/>
                  </a:cubicBezTo>
                  <a:lnTo>
                    <a:pt x="5518613" y="4666809"/>
                  </a:lnTo>
                  <a:cubicBezTo>
                    <a:pt x="5027419" y="5292807"/>
                    <a:pt x="4754965" y="6062479"/>
                    <a:pt x="4742956" y="6858000"/>
                  </a:cubicBezTo>
                  <a:close/>
                  <a:moveTo>
                    <a:pt x="3936844" y="5034751"/>
                  </a:moveTo>
                  <a:cubicBezTo>
                    <a:pt x="3692690" y="5611967"/>
                    <a:pt x="3563753" y="6231329"/>
                    <a:pt x="3557280" y="6858000"/>
                  </a:cubicBezTo>
                  <a:lnTo>
                    <a:pt x="3748016" y="6858000"/>
                  </a:lnTo>
                  <a:cubicBezTo>
                    <a:pt x="3761742" y="5646276"/>
                    <a:pt x="4250019" y="4488202"/>
                    <a:pt x="5108087" y="3632261"/>
                  </a:cubicBezTo>
                  <a:cubicBezTo>
                    <a:pt x="5237705" y="3502760"/>
                    <a:pt x="5374780" y="3380944"/>
                    <a:pt x="5518613" y="3267434"/>
                  </a:cubicBezTo>
                  <a:lnTo>
                    <a:pt x="5518613" y="3027435"/>
                  </a:lnTo>
                  <a:cubicBezTo>
                    <a:pt x="4821685" y="3543508"/>
                    <a:pt x="4275552" y="4236573"/>
                    <a:pt x="3936844" y="5034751"/>
                  </a:cubicBezTo>
                  <a:close/>
                  <a:moveTo>
                    <a:pt x="1590798" y="2330830"/>
                  </a:moveTo>
                  <a:cubicBezTo>
                    <a:pt x="2180774" y="1457646"/>
                    <a:pt x="2932850" y="705739"/>
                    <a:pt x="3806254" y="115868"/>
                  </a:cubicBezTo>
                  <a:cubicBezTo>
                    <a:pt x="3864619" y="76504"/>
                    <a:pt x="3923511" y="37881"/>
                    <a:pt x="3982938" y="0"/>
                  </a:cubicBezTo>
                  <a:lnTo>
                    <a:pt x="3637961" y="0"/>
                  </a:lnTo>
                  <a:cubicBezTo>
                    <a:pt x="2317309" y="907938"/>
                    <a:pt x="1283739" y="2174291"/>
                    <a:pt x="658991" y="3649867"/>
                  </a:cubicBezTo>
                  <a:cubicBezTo>
                    <a:pt x="229264" y="4666364"/>
                    <a:pt x="7820" y="5745720"/>
                    <a:pt x="0" y="6858000"/>
                  </a:cubicBezTo>
                  <a:lnTo>
                    <a:pt x="190735" y="6858000"/>
                  </a:lnTo>
                  <a:cubicBezTo>
                    <a:pt x="198492" y="5771144"/>
                    <a:pt x="414913" y="4716957"/>
                    <a:pt x="834595" y="3724104"/>
                  </a:cubicBezTo>
                  <a:cubicBezTo>
                    <a:pt x="1041009" y="3236353"/>
                    <a:pt x="1294217" y="2769749"/>
                    <a:pt x="1590670" y="2330830"/>
                  </a:cubicBezTo>
                  <a:close/>
                  <a:moveTo>
                    <a:pt x="5138478" y="6858000"/>
                  </a:moveTo>
                  <a:lnTo>
                    <a:pt x="5329213" y="6858000"/>
                  </a:lnTo>
                  <a:cubicBezTo>
                    <a:pt x="5335393" y="6514973"/>
                    <a:pt x="5399423" y="6175480"/>
                    <a:pt x="5518613" y="5853770"/>
                  </a:cubicBezTo>
                  <a:lnTo>
                    <a:pt x="5518613" y="5388583"/>
                  </a:lnTo>
                  <a:cubicBezTo>
                    <a:pt x="5473428" y="5473625"/>
                    <a:pt x="5431892" y="5560847"/>
                    <a:pt x="5394000" y="5650255"/>
                  </a:cubicBezTo>
                  <a:cubicBezTo>
                    <a:pt x="5232135" y="6032727"/>
                    <a:pt x="5145382" y="6442770"/>
                    <a:pt x="5138478" y="6858000"/>
                  </a:cubicBezTo>
                  <a:close/>
                  <a:moveTo>
                    <a:pt x="1918417" y="2551824"/>
                  </a:moveTo>
                  <a:cubicBezTo>
                    <a:pt x="2643092" y="1478290"/>
                    <a:pt x="3623084" y="601442"/>
                    <a:pt x="4770422" y="0"/>
                  </a:cubicBezTo>
                  <a:lnTo>
                    <a:pt x="4376235" y="0"/>
                  </a:lnTo>
                  <a:cubicBezTo>
                    <a:pt x="4221103" y="90127"/>
                    <a:pt x="4069195" y="185317"/>
                    <a:pt x="3920504" y="285570"/>
                  </a:cubicBezTo>
                  <a:cubicBezTo>
                    <a:pt x="2634426" y="1153193"/>
                    <a:pt x="1627921" y="2375366"/>
                    <a:pt x="1023169" y="3803743"/>
                  </a:cubicBezTo>
                  <a:cubicBezTo>
                    <a:pt x="614105" y="4771490"/>
                    <a:pt x="403024" y="5798792"/>
                    <a:pt x="395331" y="6858000"/>
                  </a:cubicBezTo>
                  <a:lnTo>
                    <a:pt x="586067" y="6858000"/>
                  </a:lnTo>
                  <a:cubicBezTo>
                    <a:pt x="593760" y="5824406"/>
                    <a:pt x="799754" y="4822147"/>
                    <a:pt x="1198836" y="3877980"/>
                  </a:cubicBezTo>
                  <a:cubicBezTo>
                    <a:pt x="1395332" y="3413753"/>
                    <a:pt x="1636313" y="2969629"/>
                    <a:pt x="1918417" y="2551824"/>
                  </a:cubicBezTo>
                  <a:close/>
                  <a:moveTo>
                    <a:pt x="3295909" y="1820898"/>
                  </a:moveTo>
                  <a:cubicBezTo>
                    <a:pt x="2638349" y="2477855"/>
                    <a:pt x="2113960" y="3255643"/>
                    <a:pt x="1751587" y="4111495"/>
                  </a:cubicBezTo>
                  <a:cubicBezTo>
                    <a:pt x="1383722" y="4981807"/>
                    <a:pt x="1193495" y="5905571"/>
                    <a:pt x="1185739" y="6858000"/>
                  </a:cubicBezTo>
                  <a:lnTo>
                    <a:pt x="1376474" y="6858000"/>
                  </a:lnTo>
                  <a:cubicBezTo>
                    <a:pt x="1384167" y="5931185"/>
                    <a:pt x="1569308" y="5032463"/>
                    <a:pt x="1927255" y="4185732"/>
                  </a:cubicBezTo>
                  <a:cubicBezTo>
                    <a:pt x="2618518" y="2553159"/>
                    <a:pt x="3901291" y="1241972"/>
                    <a:pt x="5518613" y="514827"/>
                  </a:cubicBezTo>
                  <a:lnTo>
                    <a:pt x="5518613" y="306544"/>
                  </a:lnTo>
                  <a:cubicBezTo>
                    <a:pt x="4689289" y="667432"/>
                    <a:pt x="3935274" y="1181063"/>
                    <a:pt x="3295909" y="1820643"/>
                  </a:cubicBezTo>
                  <a:close/>
                  <a:moveTo>
                    <a:pt x="3572666" y="4881129"/>
                  </a:moveTo>
                  <a:cubicBezTo>
                    <a:pt x="3307970" y="5506962"/>
                    <a:pt x="3168460" y="6178556"/>
                    <a:pt x="3162013" y="6858000"/>
                  </a:cubicBezTo>
                  <a:lnTo>
                    <a:pt x="3352748" y="6858000"/>
                  </a:lnTo>
                  <a:cubicBezTo>
                    <a:pt x="3372565" y="5227315"/>
                    <a:pt x="4179313" y="3706695"/>
                    <a:pt x="5518613" y="2775615"/>
                  </a:cubicBezTo>
                  <a:lnTo>
                    <a:pt x="5518613" y="2545341"/>
                  </a:lnTo>
                  <a:cubicBezTo>
                    <a:pt x="4654149" y="3115286"/>
                    <a:pt x="3977337" y="3927785"/>
                    <a:pt x="3573111" y="4880875"/>
                  </a:cubicBezTo>
                  <a:close/>
                  <a:moveTo>
                    <a:pt x="5235308" y="0"/>
                  </a:moveTo>
                  <a:cubicBezTo>
                    <a:pt x="3502800" y="791829"/>
                    <a:pt x="2129930" y="2203840"/>
                    <a:pt x="1387410" y="3957619"/>
                  </a:cubicBezTo>
                  <a:cubicBezTo>
                    <a:pt x="998882" y="4876680"/>
                    <a:pt x="798292" y="5852181"/>
                    <a:pt x="790535" y="6858000"/>
                  </a:cubicBezTo>
                  <a:lnTo>
                    <a:pt x="981270" y="6858000"/>
                  </a:lnTo>
                  <a:cubicBezTo>
                    <a:pt x="989027" y="5877796"/>
                    <a:pt x="1184722" y="4927273"/>
                    <a:pt x="1563077" y="4031856"/>
                  </a:cubicBezTo>
                  <a:cubicBezTo>
                    <a:pt x="2315465" y="2254877"/>
                    <a:pt x="3730277" y="840502"/>
                    <a:pt x="5507805" y="88347"/>
                  </a:cubicBezTo>
                  <a:lnTo>
                    <a:pt x="5518295" y="83961"/>
                  </a:lnTo>
                  <a:lnTo>
                    <a:pt x="5518295" y="0"/>
                  </a:lnTo>
                  <a:close/>
                  <a:moveTo>
                    <a:pt x="2115829" y="4265371"/>
                  </a:moveTo>
                  <a:cubicBezTo>
                    <a:pt x="1768499" y="5086996"/>
                    <a:pt x="1588763" y="5958960"/>
                    <a:pt x="1581070" y="6858000"/>
                  </a:cubicBezTo>
                  <a:lnTo>
                    <a:pt x="1771805" y="6858000"/>
                  </a:lnTo>
                  <a:cubicBezTo>
                    <a:pt x="1779499" y="5984575"/>
                    <a:pt x="1954148" y="5137589"/>
                    <a:pt x="2291496" y="4339608"/>
                  </a:cubicBezTo>
                  <a:cubicBezTo>
                    <a:pt x="2920256" y="2855992"/>
                    <a:pt x="4067231" y="1651564"/>
                    <a:pt x="5518613" y="950841"/>
                  </a:cubicBezTo>
                  <a:lnTo>
                    <a:pt x="5518613" y="739889"/>
                  </a:lnTo>
                  <a:cubicBezTo>
                    <a:pt x="3987230" y="1453890"/>
                    <a:pt x="2774896" y="2709940"/>
                    <a:pt x="2115829" y="4265371"/>
                  </a:cubicBezTo>
                  <a:close/>
                  <a:moveTo>
                    <a:pt x="3208425" y="4726999"/>
                  </a:moveTo>
                  <a:cubicBezTo>
                    <a:pt x="2923104" y="5401587"/>
                    <a:pt x="2773059" y="6125618"/>
                    <a:pt x="2766809" y="6858000"/>
                  </a:cubicBezTo>
                  <a:lnTo>
                    <a:pt x="2957544" y="6858000"/>
                  </a:lnTo>
                  <a:cubicBezTo>
                    <a:pt x="2978335" y="5002228"/>
                    <a:pt x="3943723" y="3284988"/>
                    <a:pt x="5518613" y="2302356"/>
                  </a:cubicBezTo>
                  <a:lnTo>
                    <a:pt x="5518613" y="2079201"/>
                  </a:lnTo>
                  <a:cubicBezTo>
                    <a:pt x="4486524" y="2693796"/>
                    <a:pt x="3677291" y="3621298"/>
                    <a:pt x="3208425" y="4726999"/>
                  </a:cubicBezTo>
                  <a:close/>
                  <a:moveTo>
                    <a:pt x="2844247" y="4573123"/>
                  </a:moveTo>
                  <a:cubicBezTo>
                    <a:pt x="2538117" y="5297313"/>
                    <a:pt x="2379234" y="6065676"/>
                    <a:pt x="2371478" y="6858000"/>
                  </a:cubicBezTo>
                  <a:lnTo>
                    <a:pt x="2562213" y="6858000"/>
                  </a:lnTo>
                  <a:cubicBezTo>
                    <a:pt x="2569906" y="6091353"/>
                    <a:pt x="2723703" y="5347905"/>
                    <a:pt x="3019978" y="4647360"/>
                  </a:cubicBezTo>
                  <a:cubicBezTo>
                    <a:pt x="3521924" y="3463366"/>
                    <a:pt x="4400064" y="2477658"/>
                    <a:pt x="5518613" y="1842635"/>
                  </a:cubicBezTo>
                  <a:lnTo>
                    <a:pt x="5518613" y="1624564"/>
                  </a:lnTo>
                  <a:cubicBezTo>
                    <a:pt x="4319580" y="2277199"/>
                    <a:pt x="3376933" y="3316482"/>
                    <a:pt x="2844247" y="4573123"/>
                  </a:cubicBezTo>
                  <a:close/>
                  <a:moveTo>
                    <a:pt x="2480006" y="4419247"/>
                  </a:moveTo>
                  <a:cubicBezTo>
                    <a:pt x="2153276" y="5192123"/>
                    <a:pt x="1984094" y="6012350"/>
                    <a:pt x="1976274" y="6858000"/>
                  </a:cubicBezTo>
                  <a:lnTo>
                    <a:pt x="2167009" y="6858000"/>
                  </a:lnTo>
                  <a:cubicBezTo>
                    <a:pt x="2174702" y="6038091"/>
                    <a:pt x="2338989" y="5242779"/>
                    <a:pt x="2655737" y="4493611"/>
                  </a:cubicBezTo>
                  <a:cubicBezTo>
                    <a:pt x="3221262" y="3159288"/>
                    <a:pt x="4233361" y="2063108"/>
                    <a:pt x="5518613" y="1392892"/>
                  </a:cubicBezTo>
                  <a:lnTo>
                    <a:pt x="5518613" y="1178826"/>
                  </a:lnTo>
                  <a:cubicBezTo>
                    <a:pt x="4153132" y="1864200"/>
                    <a:pt x="3076061" y="3012811"/>
                    <a:pt x="2480006" y="441924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41" name="Google Shape;41;p6"/>
            <p:cNvSpPr/>
            <p:nvPr/>
          </p:nvSpPr>
          <p:spPr>
            <a:xfrm>
              <a:off x="5005048" y="0"/>
              <a:ext cx="4138960" cy="5143642"/>
            </a:xfrm>
            <a:custGeom>
              <a:avLst/>
              <a:gdLst/>
              <a:ahLst/>
              <a:cxnLst/>
              <a:rect l="l" t="t" r="r" b="b"/>
              <a:pathLst>
                <a:path w="5518613" h="6858190" extrusionOk="0">
                  <a:moveTo>
                    <a:pt x="2240760" y="4214715"/>
                  </a:moveTo>
                  <a:cubicBezTo>
                    <a:pt x="2192225" y="4194261"/>
                    <a:pt x="2136295" y="4217016"/>
                    <a:pt x="2115841" y="4265537"/>
                  </a:cubicBezTo>
                  <a:cubicBezTo>
                    <a:pt x="2115835" y="4265543"/>
                    <a:pt x="2115835" y="4265556"/>
                    <a:pt x="2115829" y="4265562"/>
                  </a:cubicBezTo>
                  <a:cubicBezTo>
                    <a:pt x="1768499" y="5087187"/>
                    <a:pt x="1588763" y="5959151"/>
                    <a:pt x="1581070" y="6858191"/>
                  </a:cubicBezTo>
                  <a:lnTo>
                    <a:pt x="1771805" y="6858191"/>
                  </a:lnTo>
                  <a:cubicBezTo>
                    <a:pt x="1779499" y="5984765"/>
                    <a:pt x="1954148" y="5137780"/>
                    <a:pt x="2291496" y="4339799"/>
                  </a:cubicBezTo>
                  <a:cubicBezTo>
                    <a:pt x="2312070" y="4291329"/>
                    <a:pt x="2289436" y="4235359"/>
                    <a:pt x="2240951" y="4214797"/>
                  </a:cubicBezTo>
                  <a:cubicBezTo>
                    <a:pt x="2240888" y="4214766"/>
                    <a:pt x="2240824" y="4214740"/>
                    <a:pt x="2240760" y="4214715"/>
                  </a:cubicBezTo>
                  <a:close/>
                  <a:moveTo>
                    <a:pt x="2250170" y="2598095"/>
                  </a:moveTo>
                  <a:cubicBezTo>
                    <a:pt x="2206714" y="2568350"/>
                    <a:pt x="2147370" y="2579447"/>
                    <a:pt x="2117609" y="2622883"/>
                  </a:cubicBezTo>
                  <a:cubicBezTo>
                    <a:pt x="1637146" y="3322742"/>
                    <a:pt x="1278195" y="4098599"/>
                    <a:pt x="1055848" y="4917803"/>
                  </a:cubicBezTo>
                  <a:cubicBezTo>
                    <a:pt x="1040138" y="4968059"/>
                    <a:pt x="1068151" y="5021531"/>
                    <a:pt x="1118422" y="5037242"/>
                  </a:cubicBezTo>
                  <a:cubicBezTo>
                    <a:pt x="1168694" y="5052948"/>
                    <a:pt x="1222182" y="5024944"/>
                    <a:pt x="1237899" y="4974688"/>
                  </a:cubicBezTo>
                  <a:cubicBezTo>
                    <a:pt x="1238611" y="4972400"/>
                    <a:pt x="1239240" y="4970093"/>
                    <a:pt x="1239781" y="4967760"/>
                  </a:cubicBezTo>
                  <a:cubicBezTo>
                    <a:pt x="1456596" y="4169149"/>
                    <a:pt x="1806538" y="3412786"/>
                    <a:pt x="2274902" y="2730488"/>
                  </a:cubicBezTo>
                  <a:cubicBezTo>
                    <a:pt x="2304581" y="2687090"/>
                    <a:pt x="2293518" y="2627860"/>
                    <a:pt x="2250170" y="2598095"/>
                  </a:cubicBezTo>
                  <a:close/>
                  <a:moveTo>
                    <a:pt x="5289222" y="4471365"/>
                  </a:moveTo>
                  <a:cubicBezTo>
                    <a:pt x="5247089" y="4439770"/>
                    <a:pt x="5187312" y="4448313"/>
                    <a:pt x="5155707" y="4490433"/>
                  </a:cubicBezTo>
                  <a:cubicBezTo>
                    <a:pt x="4642139" y="5174034"/>
                    <a:pt x="4359361" y="6003210"/>
                    <a:pt x="4348260" y="6858064"/>
                  </a:cubicBezTo>
                  <a:lnTo>
                    <a:pt x="4538996" y="6858064"/>
                  </a:lnTo>
                  <a:cubicBezTo>
                    <a:pt x="4550065" y="6044479"/>
                    <a:pt x="4819460" y="5255459"/>
                    <a:pt x="5308296" y="4604903"/>
                  </a:cubicBezTo>
                  <a:cubicBezTo>
                    <a:pt x="5339900" y="4562782"/>
                    <a:pt x="5331375" y="4503024"/>
                    <a:pt x="5289241" y="4471429"/>
                  </a:cubicBezTo>
                  <a:cubicBezTo>
                    <a:pt x="5289216" y="4471403"/>
                    <a:pt x="5289184" y="4471384"/>
                    <a:pt x="5289158" y="4471365"/>
                  </a:cubicBezTo>
                  <a:close/>
                  <a:moveTo>
                    <a:pt x="2682504" y="5323054"/>
                  </a:moveTo>
                  <a:cubicBezTo>
                    <a:pt x="2631558" y="5309764"/>
                    <a:pt x="2579475" y="5340266"/>
                    <a:pt x="2566155" y="5391189"/>
                  </a:cubicBezTo>
                  <a:cubicBezTo>
                    <a:pt x="2441510" y="5870327"/>
                    <a:pt x="2376125" y="6362940"/>
                    <a:pt x="2371478" y="6858000"/>
                  </a:cubicBezTo>
                  <a:lnTo>
                    <a:pt x="2562213" y="6858000"/>
                  </a:lnTo>
                  <a:cubicBezTo>
                    <a:pt x="2566810" y="6379148"/>
                    <a:pt x="2630122" y="5902679"/>
                    <a:pt x="2750724" y="5439240"/>
                  </a:cubicBezTo>
                  <a:cubicBezTo>
                    <a:pt x="2764018" y="5388310"/>
                    <a:pt x="2733513" y="5336243"/>
                    <a:pt x="2682567" y="5322927"/>
                  </a:cubicBezTo>
                  <a:close/>
                  <a:moveTo>
                    <a:pt x="4160068" y="5925910"/>
                  </a:moveTo>
                  <a:cubicBezTo>
                    <a:pt x="4108531" y="5915060"/>
                    <a:pt x="4057948" y="5948028"/>
                    <a:pt x="4047095" y="5999555"/>
                  </a:cubicBezTo>
                  <a:cubicBezTo>
                    <a:pt x="4047089" y="5999562"/>
                    <a:pt x="4047089" y="5999568"/>
                    <a:pt x="4047089" y="5999574"/>
                  </a:cubicBezTo>
                  <a:cubicBezTo>
                    <a:pt x="3988006" y="6282004"/>
                    <a:pt x="3956363" y="6569507"/>
                    <a:pt x="3952611" y="6858000"/>
                  </a:cubicBezTo>
                  <a:lnTo>
                    <a:pt x="4143347" y="6858000"/>
                  </a:lnTo>
                  <a:cubicBezTo>
                    <a:pt x="4147123" y="6582600"/>
                    <a:pt x="4177425" y="6308242"/>
                    <a:pt x="4233819" y="6038663"/>
                  </a:cubicBezTo>
                  <a:cubicBezTo>
                    <a:pt x="4244634" y="5987155"/>
                    <a:pt x="4211649" y="5936626"/>
                    <a:pt x="4160132" y="5925783"/>
                  </a:cubicBezTo>
                  <a:close/>
                  <a:moveTo>
                    <a:pt x="2089189" y="6428024"/>
                  </a:moveTo>
                  <a:cubicBezTo>
                    <a:pt x="2036629" y="6424783"/>
                    <a:pt x="1991399" y="6464762"/>
                    <a:pt x="1988163" y="6517325"/>
                  </a:cubicBezTo>
                  <a:cubicBezTo>
                    <a:pt x="1981233" y="6630015"/>
                    <a:pt x="1977228" y="6744293"/>
                    <a:pt x="1976147" y="6857937"/>
                  </a:cubicBezTo>
                  <a:lnTo>
                    <a:pt x="2166882" y="6857937"/>
                  </a:lnTo>
                  <a:cubicBezTo>
                    <a:pt x="2167900" y="6748170"/>
                    <a:pt x="2171778" y="6637832"/>
                    <a:pt x="2178454" y="6529020"/>
                  </a:cubicBezTo>
                  <a:cubicBezTo>
                    <a:pt x="2181645" y="6476520"/>
                    <a:pt x="2141737" y="6431393"/>
                    <a:pt x="2089253" y="6428088"/>
                  </a:cubicBezTo>
                  <a:close/>
                  <a:moveTo>
                    <a:pt x="3184583" y="972450"/>
                  </a:moveTo>
                  <a:cubicBezTo>
                    <a:pt x="3218833" y="1012264"/>
                    <a:pt x="3278838" y="1016897"/>
                    <a:pt x="3318797" y="982811"/>
                  </a:cubicBezTo>
                  <a:cubicBezTo>
                    <a:pt x="3763936" y="601738"/>
                    <a:pt x="4250629" y="272053"/>
                    <a:pt x="4769659" y="0"/>
                  </a:cubicBezTo>
                  <a:lnTo>
                    <a:pt x="4375472" y="0"/>
                  </a:lnTo>
                  <a:cubicBezTo>
                    <a:pt x="3957475" y="243105"/>
                    <a:pt x="3562373" y="523572"/>
                    <a:pt x="3195010" y="837960"/>
                  </a:cubicBezTo>
                  <a:cubicBezTo>
                    <a:pt x="3154981" y="872186"/>
                    <a:pt x="3150289" y="932364"/>
                    <a:pt x="3184526" y="972381"/>
                  </a:cubicBezTo>
                  <a:cubicBezTo>
                    <a:pt x="3184545" y="972406"/>
                    <a:pt x="3184564" y="972425"/>
                    <a:pt x="3184583" y="972450"/>
                  </a:cubicBezTo>
                  <a:close/>
                  <a:moveTo>
                    <a:pt x="3860550" y="1312617"/>
                  </a:moveTo>
                  <a:cubicBezTo>
                    <a:pt x="2823496" y="2150361"/>
                    <a:pt x="2039217" y="3259260"/>
                    <a:pt x="1594930" y="4515984"/>
                  </a:cubicBezTo>
                  <a:cubicBezTo>
                    <a:pt x="1577376" y="4565636"/>
                    <a:pt x="1603405" y="4620118"/>
                    <a:pt x="1653073" y="4637667"/>
                  </a:cubicBezTo>
                  <a:cubicBezTo>
                    <a:pt x="1702740" y="4655216"/>
                    <a:pt x="1757240" y="4629195"/>
                    <a:pt x="1774794" y="4579543"/>
                  </a:cubicBezTo>
                  <a:cubicBezTo>
                    <a:pt x="2207331" y="3355996"/>
                    <a:pt x="2970909" y="2276380"/>
                    <a:pt x="3980586" y="1460773"/>
                  </a:cubicBezTo>
                  <a:cubicBezTo>
                    <a:pt x="4021531" y="1427634"/>
                    <a:pt x="4027850" y="1367596"/>
                    <a:pt x="3994700" y="1326664"/>
                  </a:cubicBezTo>
                  <a:cubicBezTo>
                    <a:pt x="3961551" y="1285732"/>
                    <a:pt x="3901494" y="1279414"/>
                    <a:pt x="3860550" y="1312554"/>
                  </a:cubicBezTo>
                  <a:close/>
                  <a:moveTo>
                    <a:pt x="1208945" y="3617516"/>
                  </a:moveTo>
                  <a:cubicBezTo>
                    <a:pt x="1160835" y="3596077"/>
                    <a:pt x="1104454" y="3617687"/>
                    <a:pt x="1083015" y="3665782"/>
                  </a:cubicBezTo>
                  <a:cubicBezTo>
                    <a:pt x="1083009" y="3665795"/>
                    <a:pt x="1083002" y="3665808"/>
                    <a:pt x="1082996" y="3665820"/>
                  </a:cubicBezTo>
                  <a:cubicBezTo>
                    <a:pt x="859435" y="4168317"/>
                    <a:pt x="688555" y="4692614"/>
                    <a:pt x="573097" y="5230321"/>
                  </a:cubicBezTo>
                  <a:cubicBezTo>
                    <a:pt x="458636" y="5765430"/>
                    <a:pt x="398987" y="6310803"/>
                    <a:pt x="395077" y="6858000"/>
                  </a:cubicBezTo>
                  <a:lnTo>
                    <a:pt x="585812" y="6858000"/>
                  </a:lnTo>
                  <a:cubicBezTo>
                    <a:pt x="589655" y="6324252"/>
                    <a:pt x="647789" y="5792284"/>
                    <a:pt x="759318" y="5270300"/>
                  </a:cubicBezTo>
                  <a:cubicBezTo>
                    <a:pt x="872119" y="4745584"/>
                    <a:pt x="1038993" y="4233954"/>
                    <a:pt x="1257265" y="3743616"/>
                  </a:cubicBezTo>
                  <a:cubicBezTo>
                    <a:pt x="1278792" y="3695566"/>
                    <a:pt x="1257284" y="3639157"/>
                    <a:pt x="1209212" y="3617637"/>
                  </a:cubicBezTo>
                  <a:cubicBezTo>
                    <a:pt x="1209123" y="3617598"/>
                    <a:pt x="1209034" y="3617554"/>
                    <a:pt x="1208945" y="3617516"/>
                  </a:cubicBezTo>
                  <a:close/>
                  <a:moveTo>
                    <a:pt x="943632" y="5974532"/>
                  </a:moveTo>
                  <a:cubicBezTo>
                    <a:pt x="891294" y="5968659"/>
                    <a:pt x="844106" y="6006305"/>
                    <a:pt x="838219" y="6058620"/>
                  </a:cubicBezTo>
                  <a:cubicBezTo>
                    <a:pt x="808496" y="6324074"/>
                    <a:pt x="792557" y="6590926"/>
                    <a:pt x="790471" y="6858000"/>
                  </a:cubicBezTo>
                  <a:lnTo>
                    <a:pt x="981207" y="6858000"/>
                  </a:lnTo>
                  <a:cubicBezTo>
                    <a:pt x="983267" y="6597917"/>
                    <a:pt x="998799" y="6338127"/>
                    <a:pt x="1027746" y="6079658"/>
                  </a:cubicBezTo>
                  <a:cubicBezTo>
                    <a:pt x="1033475" y="6027432"/>
                    <a:pt x="995855" y="5980418"/>
                    <a:pt x="943632" y="5974532"/>
                  </a:cubicBezTo>
                  <a:close/>
                  <a:moveTo>
                    <a:pt x="2331805" y="1389587"/>
                  </a:moveTo>
                  <a:cubicBezTo>
                    <a:pt x="2707325" y="978292"/>
                    <a:pt x="3123535" y="606057"/>
                    <a:pt x="3574065" y="278578"/>
                  </a:cubicBezTo>
                  <a:cubicBezTo>
                    <a:pt x="3707535" y="181588"/>
                    <a:pt x="3843911" y="88728"/>
                    <a:pt x="3983193" y="0"/>
                  </a:cubicBezTo>
                  <a:lnTo>
                    <a:pt x="3637771" y="0"/>
                  </a:lnTo>
                  <a:cubicBezTo>
                    <a:pt x="3578433" y="40678"/>
                    <a:pt x="3519814" y="82118"/>
                    <a:pt x="3461913" y="124321"/>
                  </a:cubicBezTo>
                  <a:cubicBezTo>
                    <a:pt x="3000969" y="459401"/>
                    <a:pt x="2575133" y="840261"/>
                    <a:pt x="2190915" y="1261071"/>
                  </a:cubicBezTo>
                  <a:cubicBezTo>
                    <a:pt x="2155794" y="1300312"/>
                    <a:pt x="2159145" y="1360585"/>
                    <a:pt x="2198398" y="1395695"/>
                  </a:cubicBezTo>
                  <a:cubicBezTo>
                    <a:pt x="2237111" y="1430316"/>
                    <a:pt x="2296417" y="1427602"/>
                    <a:pt x="2331805" y="1389587"/>
                  </a:cubicBezTo>
                  <a:close/>
                  <a:moveTo>
                    <a:pt x="558283" y="4174100"/>
                  </a:moveTo>
                  <a:cubicBezTo>
                    <a:pt x="508369" y="4157308"/>
                    <a:pt x="454289" y="4184143"/>
                    <a:pt x="437484" y="4234036"/>
                  </a:cubicBezTo>
                  <a:cubicBezTo>
                    <a:pt x="152999" y="5079865"/>
                    <a:pt x="5315" y="5965653"/>
                    <a:pt x="0" y="6858000"/>
                  </a:cubicBezTo>
                  <a:lnTo>
                    <a:pt x="190735" y="6858000"/>
                  </a:lnTo>
                  <a:cubicBezTo>
                    <a:pt x="196021" y="5986354"/>
                    <a:pt x="340335" y="5121127"/>
                    <a:pt x="618237" y="4294926"/>
                  </a:cubicBezTo>
                  <a:cubicBezTo>
                    <a:pt x="635068" y="4245032"/>
                    <a:pt x="608253" y="4190944"/>
                    <a:pt x="558344" y="4174119"/>
                  </a:cubicBezTo>
                  <a:cubicBezTo>
                    <a:pt x="558323" y="4174113"/>
                    <a:pt x="558303" y="4174107"/>
                    <a:pt x="558283" y="4174100"/>
                  </a:cubicBezTo>
                  <a:close/>
                  <a:moveTo>
                    <a:pt x="3037844" y="3379615"/>
                  </a:moveTo>
                  <a:cubicBezTo>
                    <a:pt x="3010054" y="3424341"/>
                    <a:pt x="3023793" y="3483121"/>
                    <a:pt x="3068533" y="3510909"/>
                  </a:cubicBezTo>
                  <a:cubicBezTo>
                    <a:pt x="3111436" y="3537552"/>
                    <a:pt x="3167678" y="3526131"/>
                    <a:pt x="3196790" y="3484868"/>
                  </a:cubicBezTo>
                  <a:cubicBezTo>
                    <a:pt x="3756262" y="2640934"/>
                    <a:pt x="4511937" y="1945073"/>
                    <a:pt x="5399149" y="1456833"/>
                  </a:cubicBezTo>
                  <a:cubicBezTo>
                    <a:pt x="5438612" y="1435178"/>
                    <a:pt x="5478324" y="1413994"/>
                    <a:pt x="5518295" y="1393274"/>
                  </a:cubicBezTo>
                  <a:lnTo>
                    <a:pt x="5518295" y="1179080"/>
                  </a:lnTo>
                  <a:cubicBezTo>
                    <a:pt x="5447342" y="1214673"/>
                    <a:pt x="5377024" y="1251582"/>
                    <a:pt x="5307342" y="1289800"/>
                  </a:cubicBezTo>
                  <a:cubicBezTo>
                    <a:pt x="4393090" y="1792906"/>
                    <a:pt x="3614361" y="2509939"/>
                    <a:pt x="3037780" y="3379551"/>
                  </a:cubicBezTo>
                  <a:close/>
                  <a:moveTo>
                    <a:pt x="4015808" y="3381140"/>
                  </a:moveTo>
                  <a:cubicBezTo>
                    <a:pt x="3403115" y="4138641"/>
                    <a:pt x="2998006" y="5042404"/>
                    <a:pt x="2840242" y="6003706"/>
                  </a:cubicBezTo>
                  <a:cubicBezTo>
                    <a:pt x="2831761" y="6055671"/>
                    <a:pt x="2867028" y="6104675"/>
                    <a:pt x="2919009" y="6113154"/>
                  </a:cubicBezTo>
                  <a:cubicBezTo>
                    <a:pt x="2919009" y="6113154"/>
                    <a:pt x="2919016" y="6113154"/>
                    <a:pt x="2919016" y="6113154"/>
                  </a:cubicBezTo>
                  <a:cubicBezTo>
                    <a:pt x="2924121" y="6114012"/>
                    <a:pt x="2929290" y="6114438"/>
                    <a:pt x="2934465" y="6114425"/>
                  </a:cubicBezTo>
                  <a:cubicBezTo>
                    <a:pt x="2981183" y="6114381"/>
                    <a:pt x="3020989" y="6080504"/>
                    <a:pt x="3028498" y="6034405"/>
                  </a:cubicBezTo>
                  <a:cubicBezTo>
                    <a:pt x="3282755" y="4490388"/>
                    <a:pt x="4190147" y="3130744"/>
                    <a:pt x="5518613" y="2303182"/>
                  </a:cubicBezTo>
                  <a:lnTo>
                    <a:pt x="5518613" y="2080027"/>
                  </a:lnTo>
                  <a:cubicBezTo>
                    <a:pt x="4944729" y="2421681"/>
                    <a:pt x="4435910" y="2862252"/>
                    <a:pt x="4015745" y="3381331"/>
                  </a:cubicBezTo>
                  <a:close/>
                  <a:moveTo>
                    <a:pt x="3489188" y="3682663"/>
                  </a:moveTo>
                  <a:cubicBezTo>
                    <a:pt x="3520805" y="3682689"/>
                    <a:pt x="3550382" y="3667047"/>
                    <a:pt x="3568152" y="3640906"/>
                  </a:cubicBezTo>
                  <a:cubicBezTo>
                    <a:pt x="3901106" y="3151394"/>
                    <a:pt x="4306483" y="2715260"/>
                    <a:pt x="4770422" y="2347419"/>
                  </a:cubicBezTo>
                  <a:cubicBezTo>
                    <a:pt x="4811678" y="2314686"/>
                    <a:pt x="4818582" y="2254712"/>
                    <a:pt x="4785839" y="2213469"/>
                  </a:cubicBezTo>
                  <a:cubicBezTo>
                    <a:pt x="4753096" y="2172225"/>
                    <a:pt x="4693104" y="2165323"/>
                    <a:pt x="4651848" y="2198056"/>
                  </a:cubicBezTo>
                  <a:cubicBezTo>
                    <a:pt x="4172796" y="2577934"/>
                    <a:pt x="3754234" y="3028338"/>
                    <a:pt x="3410477" y="3533872"/>
                  </a:cubicBezTo>
                  <a:cubicBezTo>
                    <a:pt x="3380843" y="3577397"/>
                    <a:pt x="3392116" y="3636704"/>
                    <a:pt x="3435655" y="3666329"/>
                  </a:cubicBezTo>
                  <a:cubicBezTo>
                    <a:pt x="3451441" y="3677071"/>
                    <a:pt x="3470089" y="3682829"/>
                    <a:pt x="3489188" y="3682854"/>
                  </a:cubicBezTo>
                  <a:close/>
                  <a:moveTo>
                    <a:pt x="5235117" y="0"/>
                  </a:moveTo>
                  <a:cubicBezTo>
                    <a:pt x="5039295" y="89448"/>
                    <a:pt x="4847415" y="187160"/>
                    <a:pt x="4659477" y="293133"/>
                  </a:cubicBezTo>
                  <a:cubicBezTo>
                    <a:pt x="4613020" y="317947"/>
                    <a:pt x="4595485" y="375710"/>
                    <a:pt x="4620306" y="422150"/>
                  </a:cubicBezTo>
                  <a:cubicBezTo>
                    <a:pt x="4645127" y="468591"/>
                    <a:pt x="4702908" y="486122"/>
                    <a:pt x="4749364" y="461309"/>
                  </a:cubicBezTo>
                  <a:cubicBezTo>
                    <a:pt x="4750655" y="460619"/>
                    <a:pt x="4751933" y="459899"/>
                    <a:pt x="4753192" y="459149"/>
                  </a:cubicBezTo>
                  <a:cubicBezTo>
                    <a:pt x="5000906" y="319499"/>
                    <a:pt x="5256473" y="194249"/>
                    <a:pt x="5518613" y="84025"/>
                  </a:cubicBezTo>
                  <a:lnTo>
                    <a:pt x="5518613" y="0"/>
                  </a:lnTo>
                  <a:close/>
                  <a:moveTo>
                    <a:pt x="4506698" y="959040"/>
                  </a:moveTo>
                  <a:cubicBezTo>
                    <a:pt x="4534914" y="1003493"/>
                    <a:pt x="4593832" y="1016668"/>
                    <a:pt x="4638305" y="988467"/>
                  </a:cubicBezTo>
                  <a:cubicBezTo>
                    <a:pt x="4920053" y="809892"/>
                    <a:pt x="5214244" y="651732"/>
                    <a:pt x="5518613" y="515208"/>
                  </a:cubicBezTo>
                  <a:lnTo>
                    <a:pt x="5518613" y="306799"/>
                  </a:lnTo>
                  <a:cubicBezTo>
                    <a:pt x="5178233" y="454670"/>
                    <a:pt x="4849857" y="628751"/>
                    <a:pt x="4536453" y="827473"/>
                  </a:cubicBezTo>
                  <a:cubicBezTo>
                    <a:pt x="4491903" y="855559"/>
                    <a:pt x="4478558" y="914434"/>
                    <a:pt x="4506654" y="958970"/>
                  </a:cubicBezTo>
                  <a:cubicBezTo>
                    <a:pt x="4506666" y="958995"/>
                    <a:pt x="4506685" y="959014"/>
                    <a:pt x="4506698" y="959040"/>
                  </a:cubicBezTo>
                  <a:close/>
                  <a:moveTo>
                    <a:pt x="4505109" y="4769266"/>
                  </a:moveTo>
                  <a:cubicBezTo>
                    <a:pt x="4479111" y="4815060"/>
                    <a:pt x="4495178" y="4873248"/>
                    <a:pt x="4540986" y="4899237"/>
                  </a:cubicBezTo>
                  <a:cubicBezTo>
                    <a:pt x="4586794" y="4925227"/>
                    <a:pt x="4645000" y="4909165"/>
                    <a:pt x="4670998" y="4863371"/>
                  </a:cubicBezTo>
                  <a:cubicBezTo>
                    <a:pt x="4671334" y="4862767"/>
                    <a:pt x="4671672" y="4862163"/>
                    <a:pt x="4672002" y="4861553"/>
                  </a:cubicBezTo>
                  <a:cubicBezTo>
                    <a:pt x="4894546" y="4460236"/>
                    <a:pt x="5180426" y="4097461"/>
                    <a:pt x="5518613" y="3787218"/>
                  </a:cubicBezTo>
                  <a:lnTo>
                    <a:pt x="5518613" y="3532982"/>
                  </a:lnTo>
                  <a:cubicBezTo>
                    <a:pt x="5109015" y="3880656"/>
                    <a:pt x="4765659" y="4299483"/>
                    <a:pt x="4505109" y="4769266"/>
                  </a:cubicBezTo>
                  <a:close/>
                  <a:moveTo>
                    <a:pt x="5138541" y="6858000"/>
                  </a:moveTo>
                  <a:lnTo>
                    <a:pt x="5329276" y="6858000"/>
                  </a:lnTo>
                  <a:cubicBezTo>
                    <a:pt x="5336270" y="6515418"/>
                    <a:pt x="5400255" y="6176332"/>
                    <a:pt x="5518613" y="5854724"/>
                  </a:cubicBezTo>
                  <a:lnTo>
                    <a:pt x="5518613" y="5389791"/>
                  </a:lnTo>
                  <a:cubicBezTo>
                    <a:pt x="5516706" y="5392651"/>
                    <a:pt x="5514862" y="5395638"/>
                    <a:pt x="5513146" y="5398816"/>
                  </a:cubicBezTo>
                  <a:cubicBezTo>
                    <a:pt x="5276239" y="5849385"/>
                    <a:pt x="5147964" y="6349072"/>
                    <a:pt x="5138541" y="6858000"/>
                  </a:cubicBezTo>
                  <a:close/>
                  <a:moveTo>
                    <a:pt x="4985952" y="5893686"/>
                  </a:moveTo>
                  <a:cubicBezTo>
                    <a:pt x="5035970" y="5910160"/>
                    <a:pt x="5089878" y="5882988"/>
                    <a:pt x="5106370" y="5832987"/>
                  </a:cubicBezTo>
                  <a:cubicBezTo>
                    <a:pt x="5204847" y="5534978"/>
                    <a:pt x="5343543" y="5251798"/>
                    <a:pt x="5518613" y="4991277"/>
                  </a:cubicBezTo>
                  <a:lnTo>
                    <a:pt x="5518613" y="4667127"/>
                  </a:lnTo>
                  <a:cubicBezTo>
                    <a:pt x="5258469" y="4998866"/>
                    <a:pt x="5057911" y="5373234"/>
                    <a:pt x="4925871" y="5773559"/>
                  </a:cubicBezTo>
                  <a:cubicBezTo>
                    <a:pt x="4909525" y="5823396"/>
                    <a:pt x="4936514" y="5877065"/>
                    <a:pt x="4986271" y="5893686"/>
                  </a:cubicBezTo>
                  <a:close/>
                  <a:moveTo>
                    <a:pt x="4231022" y="3746922"/>
                  </a:moveTo>
                  <a:cubicBezTo>
                    <a:pt x="3547960" y="4641328"/>
                    <a:pt x="3172923" y="5732780"/>
                    <a:pt x="3162013" y="6858000"/>
                  </a:cubicBezTo>
                  <a:lnTo>
                    <a:pt x="3352748" y="6858000"/>
                  </a:lnTo>
                  <a:cubicBezTo>
                    <a:pt x="3371256" y="5227137"/>
                    <a:pt x="4178328" y="3706129"/>
                    <a:pt x="5518613" y="2776187"/>
                  </a:cubicBezTo>
                  <a:lnTo>
                    <a:pt x="5518613" y="2545913"/>
                  </a:lnTo>
                  <a:cubicBezTo>
                    <a:pt x="5487758" y="2566252"/>
                    <a:pt x="5457088" y="2586909"/>
                    <a:pt x="5426615" y="2607883"/>
                  </a:cubicBezTo>
                  <a:cubicBezTo>
                    <a:pt x="4970414" y="2922055"/>
                    <a:pt x="4566875" y="3306503"/>
                    <a:pt x="4231022" y="3746922"/>
                  </a:cubicBezTo>
                  <a:close/>
                  <a:moveTo>
                    <a:pt x="4908260" y="6204806"/>
                  </a:moveTo>
                  <a:cubicBezTo>
                    <a:pt x="4856386" y="6195698"/>
                    <a:pt x="4806947" y="6230357"/>
                    <a:pt x="4797837" y="6282220"/>
                  </a:cubicBezTo>
                  <a:cubicBezTo>
                    <a:pt x="4797830" y="6282240"/>
                    <a:pt x="4797830" y="6282265"/>
                    <a:pt x="4797824" y="6282284"/>
                  </a:cubicBezTo>
                  <a:cubicBezTo>
                    <a:pt x="4764509" y="6472452"/>
                    <a:pt x="4746160" y="6664972"/>
                    <a:pt x="4742956" y="6858000"/>
                  </a:cubicBezTo>
                  <a:lnTo>
                    <a:pt x="4933691" y="6858000"/>
                  </a:lnTo>
                  <a:cubicBezTo>
                    <a:pt x="4936800" y="6676031"/>
                    <a:pt x="4954081" y="6494507"/>
                    <a:pt x="4985380" y="6315208"/>
                  </a:cubicBezTo>
                  <a:cubicBezTo>
                    <a:pt x="4994510" y="6263445"/>
                    <a:pt x="4960013" y="6214067"/>
                    <a:pt x="4908260" y="6204806"/>
                  </a:cubicBezTo>
                  <a:close/>
                  <a:moveTo>
                    <a:pt x="4560803" y="3966517"/>
                  </a:moveTo>
                  <a:cubicBezTo>
                    <a:pt x="4263180" y="4352091"/>
                    <a:pt x="4025727" y="4780535"/>
                    <a:pt x="3856544" y="5237250"/>
                  </a:cubicBezTo>
                  <a:cubicBezTo>
                    <a:pt x="3838253" y="5286641"/>
                    <a:pt x="3863468" y="5341505"/>
                    <a:pt x="3912875" y="5359791"/>
                  </a:cubicBezTo>
                  <a:cubicBezTo>
                    <a:pt x="3962282" y="5378077"/>
                    <a:pt x="4017163" y="5352869"/>
                    <a:pt x="4035454" y="5303478"/>
                  </a:cubicBezTo>
                  <a:cubicBezTo>
                    <a:pt x="4333199" y="4501537"/>
                    <a:pt x="4846398" y="3797203"/>
                    <a:pt x="5518613" y="3267942"/>
                  </a:cubicBezTo>
                  <a:lnTo>
                    <a:pt x="5518613" y="3027944"/>
                  </a:lnTo>
                  <a:cubicBezTo>
                    <a:pt x="5157405" y="3294948"/>
                    <a:pt x="4835056" y="3610823"/>
                    <a:pt x="4560803" y="396651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42" name="Google Shape;42;p6"/>
            <p:cNvSpPr/>
            <p:nvPr/>
          </p:nvSpPr>
          <p:spPr>
            <a:xfrm>
              <a:off x="5330737" y="210583"/>
              <a:ext cx="3668526" cy="4753341"/>
            </a:xfrm>
            <a:custGeom>
              <a:avLst/>
              <a:gdLst/>
              <a:ahLst/>
              <a:cxnLst/>
              <a:rect l="l" t="t" r="r" b="b"/>
              <a:pathLst>
                <a:path w="4891368" h="6337788" extrusionOk="0">
                  <a:moveTo>
                    <a:pt x="745243" y="3328976"/>
                  </a:moveTo>
                  <a:cubicBezTo>
                    <a:pt x="615034" y="3317536"/>
                    <a:pt x="605370" y="3517682"/>
                    <a:pt x="735833" y="3519144"/>
                  </a:cubicBezTo>
                  <a:cubicBezTo>
                    <a:pt x="854598" y="3519335"/>
                    <a:pt x="863499" y="3340544"/>
                    <a:pt x="745243" y="3328976"/>
                  </a:cubicBezTo>
                  <a:close/>
                  <a:moveTo>
                    <a:pt x="1658484" y="6147620"/>
                  </a:moveTo>
                  <a:cubicBezTo>
                    <a:pt x="1528275" y="6136180"/>
                    <a:pt x="1518611" y="6336390"/>
                    <a:pt x="1649138" y="6337788"/>
                  </a:cubicBezTo>
                  <a:cubicBezTo>
                    <a:pt x="1767903" y="6337916"/>
                    <a:pt x="1776676" y="6159125"/>
                    <a:pt x="1658484" y="6147620"/>
                  </a:cubicBezTo>
                  <a:close/>
                  <a:moveTo>
                    <a:pt x="1259974" y="4171957"/>
                  </a:moveTo>
                  <a:cubicBezTo>
                    <a:pt x="1129765" y="4160580"/>
                    <a:pt x="1119783" y="4360664"/>
                    <a:pt x="1250564" y="4362189"/>
                  </a:cubicBezTo>
                  <a:cubicBezTo>
                    <a:pt x="1369329" y="4362253"/>
                    <a:pt x="1378166" y="4183652"/>
                    <a:pt x="1259974" y="4171957"/>
                  </a:cubicBezTo>
                  <a:close/>
                  <a:moveTo>
                    <a:pt x="1778774" y="3926811"/>
                  </a:moveTo>
                  <a:cubicBezTo>
                    <a:pt x="1648566" y="3915307"/>
                    <a:pt x="1638902" y="4115517"/>
                    <a:pt x="1769365" y="4116979"/>
                  </a:cubicBezTo>
                  <a:cubicBezTo>
                    <a:pt x="1888066" y="4117487"/>
                    <a:pt x="1896967" y="3938442"/>
                    <a:pt x="1778774" y="3926811"/>
                  </a:cubicBezTo>
                  <a:close/>
                  <a:moveTo>
                    <a:pt x="2490854" y="5643345"/>
                  </a:moveTo>
                  <a:cubicBezTo>
                    <a:pt x="2372661" y="5654976"/>
                    <a:pt x="2381499" y="5833513"/>
                    <a:pt x="2500200" y="5833576"/>
                  </a:cubicBezTo>
                  <a:cubicBezTo>
                    <a:pt x="2630790" y="5832115"/>
                    <a:pt x="2621062" y="5632095"/>
                    <a:pt x="2490727" y="5643408"/>
                  </a:cubicBezTo>
                  <a:close/>
                  <a:moveTo>
                    <a:pt x="1817685" y="949650"/>
                  </a:moveTo>
                  <a:cubicBezTo>
                    <a:pt x="1699556" y="961282"/>
                    <a:pt x="1708330" y="1139882"/>
                    <a:pt x="1827031" y="1139882"/>
                  </a:cubicBezTo>
                  <a:cubicBezTo>
                    <a:pt x="1957811" y="1138420"/>
                    <a:pt x="1947957" y="938337"/>
                    <a:pt x="1817685" y="949650"/>
                  </a:cubicBezTo>
                  <a:close/>
                  <a:moveTo>
                    <a:pt x="1761990" y="2491334"/>
                  </a:moveTo>
                  <a:cubicBezTo>
                    <a:pt x="1892707" y="2489745"/>
                    <a:pt x="1882789" y="2289725"/>
                    <a:pt x="1752580" y="2301102"/>
                  </a:cubicBezTo>
                  <a:cubicBezTo>
                    <a:pt x="1634388" y="2312734"/>
                    <a:pt x="1643289" y="2491334"/>
                    <a:pt x="1761990" y="2491334"/>
                  </a:cubicBezTo>
                  <a:close/>
                  <a:moveTo>
                    <a:pt x="722863" y="4567103"/>
                  </a:moveTo>
                  <a:cubicBezTo>
                    <a:pt x="592591" y="4555789"/>
                    <a:pt x="582990" y="4755682"/>
                    <a:pt x="713453" y="4757334"/>
                  </a:cubicBezTo>
                  <a:cubicBezTo>
                    <a:pt x="832154" y="4757334"/>
                    <a:pt x="841119" y="4578734"/>
                    <a:pt x="722863" y="4567103"/>
                  </a:cubicBezTo>
                  <a:close/>
                  <a:moveTo>
                    <a:pt x="4272069" y="190694"/>
                  </a:moveTo>
                  <a:cubicBezTo>
                    <a:pt x="4402786" y="189105"/>
                    <a:pt x="4392868" y="-10851"/>
                    <a:pt x="4262659" y="463"/>
                  </a:cubicBezTo>
                  <a:cubicBezTo>
                    <a:pt x="4144467" y="12157"/>
                    <a:pt x="4153304" y="190758"/>
                    <a:pt x="4272069" y="190694"/>
                  </a:cubicBezTo>
                  <a:close/>
                  <a:moveTo>
                    <a:pt x="84153" y="3888675"/>
                  </a:moveTo>
                  <a:cubicBezTo>
                    <a:pt x="-33721" y="3900434"/>
                    <a:pt x="-25138" y="4079352"/>
                    <a:pt x="93436" y="4079352"/>
                  </a:cubicBezTo>
                  <a:cubicBezTo>
                    <a:pt x="224280" y="4077445"/>
                    <a:pt x="214235" y="3877425"/>
                    <a:pt x="84153" y="3888675"/>
                  </a:cubicBezTo>
                  <a:close/>
                  <a:moveTo>
                    <a:pt x="489339" y="5693238"/>
                  </a:moveTo>
                  <a:cubicBezTo>
                    <a:pt x="371210" y="5704679"/>
                    <a:pt x="379984" y="5883470"/>
                    <a:pt x="498685" y="5883407"/>
                  </a:cubicBezTo>
                  <a:cubicBezTo>
                    <a:pt x="629403" y="5882135"/>
                    <a:pt x="619611" y="5681925"/>
                    <a:pt x="489339" y="5693366"/>
                  </a:cubicBezTo>
                  <a:close/>
                  <a:moveTo>
                    <a:pt x="2214860" y="5039345"/>
                  </a:moveTo>
                  <a:cubicBezTo>
                    <a:pt x="2096731" y="5050976"/>
                    <a:pt x="2105504" y="5229576"/>
                    <a:pt x="2224206" y="5229576"/>
                  </a:cubicBezTo>
                  <a:cubicBezTo>
                    <a:pt x="2354923" y="5228178"/>
                    <a:pt x="2345132" y="5028222"/>
                    <a:pt x="2214860" y="5039472"/>
                  </a:cubicBezTo>
                  <a:close/>
                  <a:moveTo>
                    <a:pt x="4448054" y="5922813"/>
                  </a:moveTo>
                  <a:cubicBezTo>
                    <a:pt x="4329862" y="5934444"/>
                    <a:pt x="4338763" y="6113108"/>
                    <a:pt x="4457464" y="6113044"/>
                  </a:cubicBezTo>
                  <a:cubicBezTo>
                    <a:pt x="4588435" y="6111774"/>
                    <a:pt x="4578326" y="5911754"/>
                    <a:pt x="4448054" y="5923067"/>
                  </a:cubicBezTo>
                  <a:close/>
                  <a:moveTo>
                    <a:pt x="4267491" y="1896804"/>
                  </a:moveTo>
                  <a:cubicBezTo>
                    <a:pt x="4149299" y="1908372"/>
                    <a:pt x="4158136" y="2086973"/>
                    <a:pt x="4276837" y="2087036"/>
                  </a:cubicBezTo>
                  <a:cubicBezTo>
                    <a:pt x="4407554" y="2085765"/>
                    <a:pt x="4397700" y="1885682"/>
                    <a:pt x="4267491" y="1897059"/>
                  </a:cubicBezTo>
                  <a:close/>
                  <a:moveTo>
                    <a:pt x="4153050" y="722301"/>
                  </a:moveTo>
                  <a:cubicBezTo>
                    <a:pt x="4283831" y="720775"/>
                    <a:pt x="4273849" y="520755"/>
                    <a:pt x="4143704" y="532069"/>
                  </a:cubicBezTo>
                  <a:cubicBezTo>
                    <a:pt x="4025384" y="543954"/>
                    <a:pt x="4034222" y="722491"/>
                    <a:pt x="4152923" y="722555"/>
                  </a:cubicBezTo>
                  <a:close/>
                  <a:moveTo>
                    <a:pt x="4144848" y="4439731"/>
                  </a:moveTo>
                  <a:cubicBezTo>
                    <a:pt x="4026719" y="4451362"/>
                    <a:pt x="4035557" y="4629962"/>
                    <a:pt x="4154258" y="4629962"/>
                  </a:cubicBezTo>
                  <a:cubicBezTo>
                    <a:pt x="4284975" y="4628373"/>
                    <a:pt x="4275184" y="4428417"/>
                    <a:pt x="4144848" y="4439731"/>
                  </a:cubicBezTo>
                  <a:close/>
                  <a:moveTo>
                    <a:pt x="4591233" y="5427499"/>
                  </a:moveTo>
                  <a:cubicBezTo>
                    <a:pt x="4461278" y="5416058"/>
                    <a:pt x="4451042" y="5616269"/>
                    <a:pt x="4582078" y="5617476"/>
                  </a:cubicBezTo>
                  <a:cubicBezTo>
                    <a:pt x="4700524" y="5617858"/>
                    <a:pt x="4709235" y="5439067"/>
                    <a:pt x="4591233" y="5427499"/>
                  </a:cubicBezTo>
                  <a:close/>
                  <a:moveTo>
                    <a:pt x="4806955" y="4171957"/>
                  </a:moveTo>
                  <a:cubicBezTo>
                    <a:pt x="4676746" y="4160580"/>
                    <a:pt x="4667082" y="4360600"/>
                    <a:pt x="4797609" y="4362189"/>
                  </a:cubicBezTo>
                  <a:cubicBezTo>
                    <a:pt x="4916373" y="4362189"/>
                    <a:pt x="4925401" y="4183589"/>
                    <a:pt x="4806955" y="4171957"/>
                  </a:cubicBezTo>
                  <a:close/>
                  <a:moveTo>
                    <a:pt x="3486302" y="1201216"/>
                  </a:moveTo>
                  <a:cubicBezTo>
                    <a:pt x="3605003" y="1201216"/>
                    <a:pt x="3613841" y="1022616"/>
                    <a:pt x="3495648" y="1010985"/>
                  </a:cubicBezTo>
                  <a:cubicBezTo>
                    <a:pt x="3365439" y="999608"/>
                    <a:pt x="3355585" y="1199627"/>
                    <a:pt x="3486302" y="1201216"/>
                  </a:cubicBezTo>
                  <a:close/>
                  <a:moveTo>
                    <a:pt x="2813387" y="534738"/>
                  </a:moveTo>
                  <a:cubicBezTo>
                    <a:pt x="2695259" y="546370"/>
                    <a:pt x="2704032" y="724906"/>
                    <a:pt x="2822734" y="724970"/>
                  </a:cubicBezTo>
                  <a:cubicBezTo>
                    <a:pt x="2953451" y="723445"/>
                    <a:pt x="2943660" y="523425"/>
                    <a:pt x="2813387" y="534738"/>
                  </a:cubicBezTo>
                  <a:close/>
                  <a:moveTo>
                    <a:pt x="3045640" y="3211646"/>
                  </a:moveTo>
                  <a:cubicBezTo>
                    <a:pt x="2927447" y="3223278"/>
                    <a:pt x="2936285" y="3401878"/>
                    <a:pt x="3055049" y="3401878"/>
                  </a:cubicBezTo>
                  <a:cubicBezTo>
                    <a:pt x="3185767" y="3400289"/>
                    <a:pt x="3175848" y="3200333"/>
                    <a:pt x="3045640" y="3211646"/>
                  </a:cubicBezTo>
                  <a:close/>
                  <a:moveTo>
                    <a:pt x="3521080" y="4894812"/>
                  </a:moveTo>
                  <a:cubicBezTo>
                    <a:pt x="3390871" y="4883499"/>
                    <a:pt x="3381207" y="5083518"/>
                    <a:pt x="3511734" y="5085044"/>
                  </a:cubicBezTo>
                  <a:cubicBezTo>
                    <a:pt x="3630498" y="5085044"/>
                    <a:pt x="3639272" y="4906507"/>
                    <a:pt x="3521080" y="4894812"/>
                  </a:cubicBezTo>
                  <a:close/>
                  <a:moveTo>
                    <a:pt x="3706220" y="5642900"/>
                  </a:moveTo>
                  <a:cubicBezTo>
                    <a:pt x="3581606" y="5643599"/>
                    <a:pt x="3581606" y="5832877"/>
                    <a:pt x="3706220" y="5833576"/>
                  </a:cubicBezTo>
                  <a:cubicBezTo>
                    <a:pt x="3830834" y="5832941"/>
                    <a:pt x="3830897" y="5643662"/>
                    <a:pt x="3706220" y="5642900"/>
                  </a:cubicBezTo>
                  <a:close/>
                  <a:moveTo>
                    <a:pt x="2673642" y="3056499"/>
                  </a:moveTo>
                  <a:cubicBezTo>
                    <a:pt x="2555513" y="3068131"/>
                    <a:pt x="2564351" y="3246731"/>
                    <a:pt x="2683051" y="3246731"/>
                  </a:cubicBezTo>
                  <a:cubicBezTo>
                    <a:pt x="2813769" y="3245206"/>
                    <a:pt x="2803914" y="3045186"/>
                    <a:pt x="2673642" y="3056499"/>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43" name="Google Shape;43;p6"/>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44" name="Google Shape;44;p6"/>
          <p:cNvSpPr txBox="1">
            <a:spLocks noGrp="1"/>
          </p:cNvSpPr>
          <p:nvPr>
            <p:ph type="body" idx="1"/>
          </p:nvPr>
        </p:nvSpPr>
        <p:spPr>
          <a:xfrm>
            <a:off x="855300" y="1430150"/>
            <a:ext cx="3473100" cy="3319800"/>
          </a:xfrm>
          <a:prstGeom prst="rect">
            <a:avLst/>
          </a:prstGeom>
        </p:spPr>
        <p:txBody>
          <a:bodyPr spcFirstLastPara="1" wrap="square" lIns="0" tIns="0" rIns="0" bIns="0" anchor="t" anchorCtr="0">
            <a:noAutofit/>
          </a:bodyPr>
          <a:lstStyle>
            <a:lvl1pPr marL="457200" lvl="0" indent="-355600" rtl="0">
              <a:spcBef>
                <a:spcPts val="0"/>
              </a:spcBef>
              <a:spcAft>
                <a:spcPts val="0"/>
              </a:spcAft>
              <a:buSzPts val="2000"/>
              <a:buChar char="●"/>
              <a:defRPr sz="2000"/>
            </a:lvl1pPr>
            <a:lvl2pPr marL="914400" lvl="1" indent="-355600" rtl="0">
              <a:spcBef>
                <a:spcPts val="600"/>
              </a:spcBef>
              <a:spcAft>
                <a:spcPts val="0"/>
              </a:spcAft>
              <a:buSzPts val="2000"/>
              <a:buChar char="○"/>
              <a:defRPr sz="2000"/>
            </a:lvl2pPr>
            <a:lvl3pPr marL="1371600" lvl="2" indent="-355600" rtl="0">
              <a:spcBef>
                <a:spcPts val="600"/>
              </a:spcBef>
              <a:spcAft>
                <a:spcPts val="0"/>
              </a:spcAft>
              <a:buSzPts val="2000"/>
              <a:buChar char="■"/>
              <a:defRPr sz="2000"/>
            </a:lvl3pPr>
            <a:lvl4pPr marL="1828800" lvl="3" indent="-355600" rtl="0">
              <a:spcBef>
                <a:spcPts val="600"/>
              </a:spcBef>
              <a:spcAft>
                <a:spcPts val="0"/>
              </a:spcAft>
              <a:buSzPts val="2000"/>
              <a:buChar char="●"/>
              <a:defRPr sz="2000"/>
            </a:lvl4pPr>
            <a:lvl5pPr marL="2286000" lvl="4" indent="-355600" rtl="0">
              <a:spcBef>
                <a:spcPts val="600"/>
              </a:spcBef>
              <a:spcAft>
                <a:spcPts val="0"/>
              </a:spcAft>
              <a:buSzPts val="2000"/>
              <a:buChar char="○"/>
              <a:defRPr sz="2000"/>
            </a:lvl5pPr>
            <a:lvl6pPr marL="2743200" lvl="5" indent="-355600" rtl="0">
              <a:spcBef>
                <a:spcPts val="600"/>
              </a:spcBef>
              <a:spcAft>
                <a:spcPts val="0"/>
              </a:spcAft>
              <a:buSzPts val="2000"/>
              <a:buChar char="■"/>
              <a:defRPr sz="2000"/>
            </a:lvl6pPr>
            <a:lvl7pPr marL="3200400" lvl="6" indent="-355600" rtl="0">
              <a:spcBef>
                <a:spcPts val="600"/>
              </a:spcBef>
              <a:spcAft>
                <a:spcPts val="0"/>
              </a:spcAft>
              <a:buSzPts val="2000"/>
              <a:buChar char="●"/>
              <a:defRPr sz="2000"/>
            </a:lvl7pPr>
            <a:lvl8pPr marL="3657600" lvl="7" indent="-355600" rtl="0">
              <a:spcBef>
                <a:spcPts val="600"/>
              </a:spcBef>
              <a:spcAft>
                <a:spcPts val="0"/>
              </a:spcAft>
              <a:buSzPts val="2000"/>
              <a:buChar char="○"/>
              <a:defRPr sz="2000"/>
            </a:lvl8pPr>
            <a:lvl9pPr marL="4114800" lvl="8" indent="-355600" rtl="0">
              <a:spcBef>
                <a:spcPts val="600"/>
              </a:spcBef>
              <a:spcAft>
                <a:spcPts val="600"/>
              </a:spcAft>
              <a:buSzPts val="2000"/>
              <a:buChar char="■"/>
              <a:defRPr sz="2000"/>
            </a:lvl9pPr>
          </a:lstStyle>
          <a:p>
            <a:endParaRPr/>
          </a:p>
        </p:txBody>
      </p:sp>
      <p:sp>
        <p:nvSpPr>
          <p:cNvPr id="45" name="Google Shape;45;p6"/>
          <p:cNvSpPr txBox="1">
            <a:spLocks noGrp="1"/>
          </p:cNvSpPr>
          <p:nvPr>
            <p:ph type="body" idx="2"/>
          </p:nvPr>
        </p:nvSpPr>
        <p:spPr>
          <a:xfrm>
            <a:off x="4815605" y="1430150"/>
            <a:ext cx="3473100" cy="3319800"/>
          </a:xfrm>
          <a:prstGeom prst="rect">
            <a:avLst/>
          </a:prstGeom>
        </p:spPr>
        <p:txBody>
          <a:bodyPr spcFirstLastPara="1" wrap="square" lIns="0" tIns="0" rIns="0" bIns="0" anchor="t" anchorCtr="0">
            <a:noAutofit/>
          </a:bodyPr>
          <a:lstStyle>
            <a:lvl1pPr marL="457200" lvl="0" indent="-355600" rtl="0">
              <a:spcBef>
                <a:spcPts val="0"/>
              </a:spcBef>
              <a:spcAft>
                <a:spcPts val="0"/>
              </a:spcAft>
              <a:buSzPts val="2000"/>
              <a:buChar char="●"/>
              <a:defRPr sz="2000"/>
            </a:lvl1pPr>
            <a:lvl2pPr marL="914400" lvl="1" indent="-355600" rtl="0">
              <a:spcBef>
                <a:spcPts val="600"/>
              </a:spcBef>
              <a:spcAft>
                <a:spcPts val="0"/>
              </a:spcAft>
              <a:buSzPts val="2000"/>
              <a:buChar char="○"/>
              <a:defRPr sz="2000"/>
            </a:lvl2pPr>
            <a:lvl3pPr marL="1371600" lvl="2" indent="-355600" rtl="0">
              <a:spcBef>
                <a:spcPts val="600"/>
              </a:spcBef>
              <a:spcAft>
                <a:spcPts val="0"/>
              </a:spcAft>
              <a:buSzPts val="2000"/>
              <a:buChar char="■"/>
              <a:defRPr sz="2000"/>
            </a:lvl3pPr>
            <a:lvl4pPr marL="1828800" lvl="3" indent="-355600" rtl="0">
              <a:spcBef>
                <a:spcPts val="600"/>
              </a:spcBef>
              <a:spcAft>
                <a:spcPts val="0"/>
              </a:spcAft>
              <a:buSzPts val="2000"/>
              <a:buChar char="●"/>
              <a:defRPr sz="2000"/>
            </a:lvl4pPr>
            <a:lvl5pPr marL="2286000" lvl="4" indent="-355600" rtl="0">
              <a:spcBef>
                <a:spcPts val="600"/>
              </a:spcBef>
              <a:spcAft>
                <a:spcPts val="0"/>
              </a:spcAft>
              <a:buSzPts val="2000"/>
              <a:buChar char="○"/>
              <a:defRPr sz="2000"/>
            </a:lvl5pPr>
            <a:lvl6pPr marL="2743200" lvl="5" indent="-355600" rtl="0">
              <a:spcBef>
                <a:spcPts val="600"/>
              </a:spcBef>
              <a:spcAft>
                <a:spcPts val="0"/>
              </a:spcAft>
              <a:buSzPts val="2000"/>
              <a:buChar char="■"/>
              <a:defRPr sz="2000"/>
            </a:lvl6pPr>
            <a:lvl7pPr marL="3200400" lvl="6" indent="-355600" rtl="0">
              <a:spcBef>
                <a:spcPts val="600"/>
              </a:spcBef>
              <a:spcAft>
                <a:spcPts val="0"/>
              </a:spcAft>
              <a:buSzPts val="2000"/>
              <a:buChar char="●"/>
              <a:defRPr sz="2000"/>
            </a:lvl7pPr>
            <a:lvl8pPr marL="3657600" lvl="7" indent="-355600" rtl="0">
              <a:spcBef>
                <a:spcPts val="600"/>
              </a:spcBef>
              <a:spcAft>
                <a:spcPts val="0"/>
              </a:spcAft>
              <a:buSzPts val="2000"/>
              <a:buChar char="○"/>
              <a:defRPr sz="2000"/>
            </a:lvl8pPr>
            <a:lvl9pPr marL="4114800" lvl="8" indent="-355600" rtl="0">
              <a:spcBef>
                <a:spcPts val="600"/>
              </a:spcBef>
              <a:spcAft>
                <a:spcPts val="600"/>
              </a:spcAft>
              <a:buSzPts val="2000"/>
              <a:buChar char="■"/>
              <a:defRPr sz="2000"/>
            </a:lvl9pPr>
          </a:lstStyle>
          <a:p>
            <a:endParaRPr/>
          </a:p>
        </p:txBody>
      </p:sp>
      <p:sp>
        <p:nvSpPr>
          <p:cNvPr id="46" name="Google Shape;46;p6"/>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 3 columns">
  <p:cSld name="TITLE_AND_TWO_COLUMNS_1">
    <p:spTree>
      <p:nvGrpSpPr>
        <p:cNvPr id="1" name="Shape 47"/>
        <p:cNvGrpSpPr/>
        <p:nvPr/>
      </p:nvGrpSpPr>
      <p:grpSpPr>
        <a:xfrm>
          <a:off x="0" y="0"/>
          <a:ext cx="0" cy="0"/>
          <a:chOff x="0" y="0"/>
          <a:chExt cx="0" cy="0"/>
        </a:xfrm>
      </p:grpSpPr>
      <p:grpSp>
        <p:nvGrpSpPr>
          <p:cNvPr id="48" name="Google Shape;48;p7"/>
          <p:cNvGrpSpPr/>
          <p:nvPr/>
        </p:nvGrpSpPr>
        <p:grpSpPr>
          <a:xfrm>
            <a:off x="5005048" y="0"/>
            <a:ext cx="4138960" cy="5143642"/>
            <a:chOff x="5005048" y="0"/>
            <a:chExt cx="4138960" cy="5143642"/>
          </a:xfrm>
        </p:grpSpPr>
        <p:sp>
          <p:nvSpPr>
            <p:cNvPr id="49" name="Google Shape;49;p7"/>
            <p:cNvSpPr/>
            <p:nvPr/>
          </p:nvSpPr>
          <p:spPr>
            <a:xfrm>
              <a:off x="5005049" y="0"/>
              <a:ext cx="4138960" cy="5143500"/>
            </a:xfrm>
            <a:custGeom>
              <a:avLst/>
              <a:gdLst/>
              <a:ahLst/>
              <a:cxnLst/>
              <a:rect l="l" t="t" r="r" b="b"/>
              <a:pathLst>
                <a:path w="5518613" h="6858000" extrusionOk="0">
                  <a:moveTo>
                    <a:pt x="4347879" y="6858000"/>
                  </a:moveTo>
                  <a:lnTo>
                    <a:pt x="4538614" y="6858000"/>
                  </a:lnTo>
                  <a:cubicBezTo>
                    <a:pt x="4551534" y="5930683"/>
                    <a:pt x="4899626" y="5039346"/>
                    <a:pt x="5518613" y="4348570"/>
                  </a:cubicBezTo>
                  <a:lnTo>
                    <a:pt x="5518613" y="4070500"/>
                  </a:lnTo>
                  <a:cubicBezTo>
                    <a:pt x="4781548" y="4812740"/>
                    <a:pt x="4361771" y="5812222"/>
                    <a:pt x="4347879" y="6858000"/>
                  </a:cubicBezTo>
                  <a:close/>
                  <a:moveTo>
                    <a:pt x="4301085" y="5188627"/>
                  </a:moveTo>
                  <a:cubicBezTo>
                    <a:pt x="4077511" y="5717157"/>
                    <a:pt x="3959147" y="6284191"/>
                    <a:pt x="3952611" y="6858000"/>
                  </a:cubicBezTo>
                  <a:lnTo>
                    <a:pt x="4143347" y="6858000"/>
                  </a:lnTo>
                  <a:cubicBezTo>
                    <a:pt x="4157130" y="5751110"/>
                    <a:pt x="4603757" y="4693586"/>
                    <a:pt x="5387642" y="3911730"/>
                  </a:cubicBezTo>
                  <a:cubicBezTo>
                    <a:pt x="5430449" y="3868935"/>
                    <a:pt x="5474000" y="3827197"/>
                    <a:pt x="5518295" y="3786519"/>
                  </a:cubicBezTo>
                  <a:lnTo>
                    <a:pt x="5518295" y="3532283"/>
                  </a:lnTo>
                  <a:cubicBezTo>
                    <a:pt x="5426952" y="3609615"/>
                    <a:pt x="5338451" y="3691136"/>
                    <a:pt x="5252792" y="3776858"/>
                  </a:cubicBezTo>
                  <a:cubicBezTo>
                    <a:pt x="4847103" y="4181397"/>
                    <a:pt x="4523877" y="4660866"/>
                    <a:pt x="4301085" y="5188627"/>
                  </a:cubicBezTo>
                  <a:close/>
                  <a:moveTo>
                    <a:pt x="4742956" y="6858000"/>
                  </a:moveTo>
                  <a:lnTo>
                    <a:pt x="4933691" y="6858000"/>
                  </a:lnTo>
                  <a:cubicBezTo>
                    <a:pt x="4944296" y="6192253"/>
                    <a:pt x="5147442" y="5543813"/>
                    <a:pt x="5518613" y="4990959"/>
                  </a:cubicBezTo>
                  <a:lnTo>
                    <a:pt x="5518613" y="4666809"/>
                  </a:lnTo>
                  <a:cubicBezTo>
                    <a:pt x="5027419" y="5292807"/>
                    <a:pt x="4754965" y="6062479"/>
                    <a:pt x="4742956" y="6858000"/>
                  </a:cubicBezTo>
                  <a:close/>
                  <a:moveTo>
                    <a:pt x="3936844" y="5034751"/>
                  </a:moveTo>
                  <a:cubicBezTo>
                    <a:pt x="3692690" y="5611967"/>
                    <a:pt x="3563753" y="6231329"/>
                    <a:pt x="3557280" y="6858000"/>
                  </a:cubicBezTo>
                  <a:lnTo>
                    <a:pt x="3748016" y="6858000"/>
                  </a:lnTo>
                  <a:cubicBezTo>
                    <a:pt x="3761742" y="5646276"/>
                    <a:pt x="4250019" y="4488202"/>
                    <a:pt x="5108087" y="3632261"/>
                  </a:cubicBezTo>
                  <a:cubicBezTo>
                    <a:pt x="5237705" y="3502760"/>
                    <a:pt x="5374780" y="3380944"/>
                    <a:pt x="5518613" y="3267434"/>
                  </a:cubicBezTo>
                  <a:lnTo>
                    <a:pt x="5518613" y="3027435"/>
                  </a:lnTo>
                  <a:cubicBezTo>
                    <a:pt x="4821685" y="3543508"/>
                    <a:pt x="4275552" y="4236573"/>
                    <a:pt x="3936844" y="5034751"/>
                  </a:cubicBezTo>
                  <a:close/>
                  <a:moveTo>
                    <a:pt x="1590798" y="2330830"/>
                  </a:moveTo>
                  <a:cubicBezTo>
                    <a:pt x="2180774" y="1457646"/>
                    <a:pt x="2932850" y="705739"/>
                    <a:pt x="3806254" y="115868"/>
                  </a:cubicBezTo>
                  <a:cubicBezTo>
                    <a:pt x="3864619" y="76504"/>
                    <a:pt x="3923511" y="37881"/>
                    <a:pt x="3982938" y="0"/>
                  </a:cubicBezTo>
                  <a:lnTo>
                    <a:pt x="3637961" y="0"/>
                  </a:lnTo>
                  <a:cubicBezTo>
                    <a:pt x="2317309" y="907938"/>
                    <a:pt x="1283739" y="2174291"/>
                    <a:pt x="658991" y="3649867"/>
                  </a:cubicBezTo>
                  <a:cubicBezTo>
                    <a:pt x="229264" y="4666364"/>
                    <a:pt x="7820" y="5745720"/>
                    <a:pt x="0" y="6858000"/>
                  </a:cubicBezTo>
                  <a:lnTo>
                    <a:pt x="190735" y="6858000"/>
                  </a:lnTo>
                  <a:cubicBezTo>
                    <a:pt x="198492" y="5771144"/>
                    <a:pt x="414913" y="4716957"/>
                    <a:pt x="834595" y="3724104"/>
                  </a:cubicBezTo>
                  <a:cubicBezTo>
                    <a:pt x="1041009" y="3236353"/>
                    <a:pt x="1294217" y="2769749"/>
                    <a:pt x="1590670" y="2330830"/>
                  </a:cubicBezTo>
                  <a:close/>
                  <a:moveTo>
                    <a:pt x="5138478" y="6858000"/>
                  </a:moveTo>
                  <a:lnTo>
                    <a:pt x="5329213" y="6858000"/>
                  </a:lnTo>
                  <a:cubicBezTo>
                    <a:pt x="5335393" y="6514973"/>
                    <a:pt x="5399423" y="6175480"/>
                    <a:pt x="5518613" y="5853770"/>
                  </a:cubicBezTo>
                  <a:lnTo>
                    <a:pt x="5518613" y="5388583"/>
                  </a:lnTo>
                  <a:cubicBezTo>
                    <a:pt x="5473428" y="5473625"/>
                    <a:pt x="5431892" y="5560847"/>
                    <a:pt x="5394000" y="5650255"/>
                  </a:cubicBezTo>
                  <a:cubicBezTo>
                    <a:pt x="5232135" y="6032727"/>
                    <a:pt x="5145382" y="6442770"/>
                    <a:pt x="5138478" y="6858000"/>
                  </a:cubicBezTo>
                  <a:close/>
                  <a:moveTo>
                    <a:pt x="1918417" y="2551824"/>
                  </a:moveTo>
                  <a:cubicBezTo>
                    <a:pt x="2643092" y="1478290"/>
                    <a:pt x="3623084" y="601442"/>
                    <a:pt x="4770422" y="0"/>
                  </a:cubicBezTo>
                  <a:lnTo>
                    <a:pt x="4376235" y="0"/>
                  </a:lnTo>
                  <a:cubicBezTo>
                    <a:pt x="4221103" y="90127"/>
                    <a:pt x="4069195" y="185317"/>
                    <a:pt x="3920504" y="285570"/>
                  </a:cubicBezTo>
                  <a:cubicBezTo>
                    <a:pt x="2634426" y="1153193"/>
                    <a:pt x="1627921" y="2375366"/>
                    <a:pt x="1023169" y="3803743"/>
                  </a:cubicBezTo>
                  <a:cubicBezTo>
                    <a:pt x="614105" y="4771490"/>
                    <a:pt x="403024" y="5798792"/>
                    <a:pt x="395331" y="6858000"/>
                  </a:cubicBezTo>
                  <a:lnTo>
                    <a:pt x="586067" y="6858000"/>
                  </a:lnTo>
                  <a:cubicBezTo>
                    <a:pt x="593760" y="5824406"/>
                    <a:pt x="799754" y="4822147"/>
                    <a:pt x="1198836" y="3877980"/>
                  </a:cubicBezTo>
                  <a:cubicBezTo>
                    <a:pt x="1395332" y="3413753"/>
                    <a:pt x="1636313" y="2969629"/>
                    <a:pt x="1918417" y="2551824"/>
                  </a:cubicBezTo>
                  <a:close/>
                  <a:moveTo>
                    <a:pt x="3295909" y="1820898"/>
                  </a:moveTo>
                  <a:cubicBezTo>
                    <a:pt x="2638349" y="2477855"/>
                    <a:pt x="2113960" y="3255643"/>
                    <a:pt x="1751587" y="4111495"/>
                  </a:cubicBezTo>
                  <a:cubicBezTo>
                    <a:pt x="1383722" y="4981807"/>
                    <a:pt x="1193495" y="5905571"/>
                    <a:pt x="1185739" y="6858000"/>
                  </a:cubicBezTo>
                  <a:lnTo>
                    <a:pt x="1376474" y="6858000"/>
                  </a:lnTo>
                  <a:cubicBezTo>
                    <a:pt x="1384167" y="5931185"/>
                    <a:pt x="1569308" y="5032463"/>
                    <a:pt x="1927255" y="4185732"/>
                  </a:cubicBezTo>
                  <a:cubicBezTo>
                    <a:pt x="2618518" y="2553159"/>
                    <a:pt x="3901291" y="1241972"/>
                    <a:pt x="5518613" y="514827"/>
                  </a:cubicBezTo>
                  <a:lnTo>
                    <a:pt x="5518613" y="306544"/>
                  </a:lnTo>
                  <a:cubicBezTo>
                    <a:pt x="4689289" y="667432"/>
                    <a:pt x="3935274" y="1181063"/>
                    <a:pt x="3295909" y="1820643"/>
                  </a:cubicBezTo>
                  <a:close/>
                  <a:moveTo>
                    <a:pt x="3572666" y="4881129"/>
                  </a:moveTo>
                  <a:cubicBezTo>
                    <a:pt x="3307970" y="5506962"/>
                    <a:pt x="3168460" y="6178556"/>
                    <a:pt x="3162013" y="6858000"/>
                  </a:cubicBezTo>
                  <a:lnTo>
                    <a:pt x="3352748" y="6858000"/>
                  </a:lnTo>
                  <a:cubicBezTo>
                    <a:pt x="3372565" y="5227315"/>
                    <a:pt x="4179313" y="3706695"/>
                    <a:pt x="5518613" y="2775615"/>
                  </a:cubicBezTo>
                  <a:lnTo>
                    <a:pt x="5518613" y="2545341"/>
                  </a:lnTo>
                  <a:cubicBezTo>
                    <a:pt x="4654149" y="3115286"/>
                    <a:pt x="3977337" y="3927785"/>
                    <a:pt x="3573111" y="4880875"/>
                  </a:cubicBezTo>
                  <a:close/>
                  <a:moveTo>
                    <a:pt x="5235308" y="0"/>
                  </a:moveTo>
                  <a:cubicBezTo>
                    <a:pt x="3502800" y="791829"/>
                    <a:pt x="2129930" y="2203840"/>
                    <a:pt x="1387410" y="3957619"/>
                  </a:cubicBezTo>
                  <a:cubicBezTo>
                    <a:pt x="998882" y="4876680"/>
                    <a:pt x="798292" y="5852181"/>
                    <a:pt x="790535" y="6858000"/>
                  </a:cubicBezTo>
                  <a:lnTo>
                    <a:pt x="981270" y="6858000"/>
                  </a:lnTo>
                  <a:cubicBezTo>
                    <a:pt x="989027" y="5877796"/>
                    <a:pt x="1184722" y="4927273"/>
                    <a:pt x="1563077" y="4031856"/>
                  </a:cubicBezTo>
                  <a:cubicBezTo>
                    <a:pt x="2315465" y="2254877"/>
                    <a:pt x="3730277" y="840502"/>
                    <a:pt x="5507805" y="88347"/>
                  </a:cubicBezTo>
                  <a:lnTo>
                    <a:pt x="5518295" y="83961"/>
                  </a:lnTo>
                  <a:lnTo>
                    <a:pt x="5518295" y="0"/>
                  </a:lnTo>
                  <a:close/>
                  <a:moveTo>
                    <a:pt x="2115829" y="4265371"/>
                  </a:moveTo>
                  <a:cubicBezTo>
                    <a:pt x="1768499" y="5086996"/>
                    <a:pt x="1588763" y="5958960"/>
                    <a:pt x="1581070" y="6858000"/>
                  </a:cubicBezTo>
                  <a:lnTo>
                    <a:pt x="1771805" y="6858000"/>
                  </a:lnTo>
                  <a:cubicBezTo>
                    <a:pt x="1779499" y="5984575"/>
                    <a:pt x="1954148" y="5137589"/>
                    <a:pt x="2291496" y="4339608"/>
                  </a:cubicBezTo>
                  <a:cubicBezTo>
                    <a:pt x="2920256" y="2855992"/>
                    <a:pt x="4067231" y="1651564"/>
                    <a:pt x="5518613" y="950841"/>
                  </a:cubicBezTo>
                  <a:lnTo>
                    <a:pt x="5518613" y="739889"/>
                  </a:lnTo>
                  <a:cubicBezTo>
                    <a:pt x="3987230" y="1453890"/>
                    <a:pt x="2774896" y="2709940"/>
                    <a:pt x="2115829" y="4265371"/>
                  </a:cubicBezTo>
                  <a:close/>
                  <a:moveTo>
                    <a:pt x="3208425" y="4726999"/>
                  </a:moveTo>
                  <a:cubicBezTo>
                    <a:pt x="2923104" y="5401587"/>
                    <a:pt x="2773059" y="6125618"/>
                    <a:pt x="2766809" y="6858000"/>
                  </a:cubicBezTo>
                  <a:lnTo>
                    <a:pt x="2957544" y="6858000"/>
                  </a:lnTo>
                  <a:cubicBezTo>
                    <a:pt x="2978335" y="5002228"/>
                    <a:pt x="3943723" y="3284988"/>
                    <a:pt x="5518613" y="2302356"/>
                  </a:cubicBezTo>
                  <a:lnTo>
                    <a:pt x="5518613" y="2079201"/>
                  </a:lnTo>
                  <a:cubicBezTo>
                    <a:pt x="4486524" y="2693796"/>
                    <a:pt x="3677291" y="3621298"/>
                    <a:pt x="3208425" y="4726999"/>
                  </a:cubicBezTo>
                  <a:close/>
                  <a:moveTo>
                    <a:pt x="2844247" y="4573123"/>
                  </a:moveTo>
                  <a:cubicBezTo>
                    <a:pt x="2538117" y="5297313"/>
                    <a:pt x="2379234" y="6065676"/>
                    <a:pt x="2371478" y="6858000"/>
                  </a:cubicBezTo>
                  <a:lnTo>
                    <a:pt x="2562213" y="6858000"/>
                  </a:lnTo>
                  <a:cubicBezTo>
                    <a:pt x="2569906" y="6091353"/>
                    <a:pt x="2723703" y="5347905"/>
                    <a:pt x="3019978" y="4647360"/>
                  </a:cubicBezTo>
                  <a:cubicBezTo>
                    <a:pt x="3521924" y="3463366"/>
                    <a:pt x="4400064" y="2477658"/>
                    <a:pt x="5518613" y="1842635"/>
                  </a:cubicBezTo>
                  <a:lnTo>
                    <a:pt x="5518613" y="1624564"/>
                  </a:lnTo>
                  <a:cubicBezTo>
                    <a:pt x="4319580" y="2277199"/>
                    <a:pt x="3376933" y="3316482"/>
                    <a:pt x="2844247" y="4573123"/>
                  </a:cubicBezTo>
                  <a:close/>
                  <a:moveTo>
                    <a:pt x="2480006" y="4419247"/>
                  </a:moveTo>
                  <a:cubicBezTo>
                    <a:pt x="2153276" y="5192123"/>
                    <a:pt x="1984094" y="6012350"/>
                    <a:pt x="1976274" y="6858000"/>
                  </a:cubicBezTo>
                  <a:lnTo>
                    <a:pt x="2167009" y="6858000"/>
                  </a:lnTo>
                  <a:cubicBezTo>
                    <a:pt x="2174702" y="6038091"/>
                    <a:pt x="2338989" y="5242779"/>
                    <a:pt x="2655737" y="4493611"/>
                  </a:cubicBezTo>
                  <a:cubicBezTo>
                    <a:pt x="3221262" y="3159288"/>
                    <a:pt x="4233361" y="2063108"/>
                    <a:pt x="5518613" y="1392892"/>
                  </a:cubicBezTo>
                  <a:lnTo>
                    <a:pt x="5518613" y="1178826"/>
                  </a:lnTo>
                  <a:cubicBezTo>
                    <a:pt x="4153132" y="1864200"/>
                    <a:pt x="3076061" y="3012811"/>
                    <a:pt x="2480006" y="441924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50" name="Google Shape;50;p7"/>
            <p:cNvSpPr/>
            <p:nvPr/>
          </p:nvSpPr>
          <p:spPr>
            <a:xfrm>
              <a:off x="5005048" y="0"/>
              <a:ext cx="4138960" cy="5143642"/>
            </a:xfrm>
            <a:custGeom>
              <a:avLst/>
              <a:gdLst/>
              <a:ahLst/>
              <a:cxnLst/>
              <a:rect l="l" t="t" r="r" b="b"/>
              <a:pathLst>
                <a:path w="5518613" h="6858190" extrusionOk="0">
                  <a:moveTo>
                    <a:pt x="2240760" y="4214715"/>
                  </a:moveTo>
                  <a:cubicBezTo>
                    <a:pt x="2192225" y="4194261"/>
                    <a:pt x="2136295" y="4217016"/>
                    <a:pt x="2115841" y="4265537"/>
                  </a:cubicBezTo>
                  <a:cubicBezTo>
                    <a:pt x="2115835" y="4265543"/>
                    <a:pt x="2115835" y="4265556"/>
                    <a:pt x="2115829" y="4265562"/>
                  </a:cubicBezTo>
                  <a:cubicBezTo>
                    <a:pt x="1768499" y="5087187"/>
                    <a:pt x="1588763" y="5959151"/>
                    <a:pt x="1581070" y="6858191"/>
                  </a:cubicBezTo>
                  <a:lnTo>
                    <a:pt x="1771805" y="6858191"/>
                  </a:lnTo>
                  <a:cubicBezTo>
                    <a:pt x="1779499" y="5984765"/>
                    <a:pt x="1954148" y="5137780"/>
                    <a:pt x="2291496" y="4339799"/>
                  </a:cubicBezTo>
                  <a:cubicBezTo>
                    <a:pt x="2312070" y="4291329"/>
                    <a:pt x="2289436" y="4235359"/>
                    <a:pt x="2240951" y="4214797"/>
                  </a:cubicBezTo>
                  <a:cubicBezTo>
                    <a:pt x="2240888" y="4214766"/>
                    <a:pt x="2240824" y="4214740"/>
                    <a:pt x="2240760" y="4214715"/>
                  </a:cubicBezTo>
                  <a:close/>
                  <a:moveTo>
                    <a:pt x="2250170" y="2598095"/>
                  </a:moveTo>
                  <a:cubicBezTo>
                    <a:pt x="2206714" y="2568350"/>
                    <a:pt x="2147370" y="2579447"/>
                    <a:pt x="2117609" y="2622883"/>
                  </a:cubicBezTo>
                  <a:cubicBezTo>
                    <a:pt x="1637146" y="3322742"/>
                    <a:pt x="1278195" y="4098599"/>
                    <a:pt x="1055848" y="4917803"/>
                  </a:cubicBezTo>
                  <a:cubicBezTo>
                    <a:pt x="1040138" y="4968059"/>
                    <a:pt x="1068151" y="5021531"/>
                    <a:pt x="1118422" y="5037242"/>
                  </a:cubicBezTo>
                  <a:cubicBezTo>
                    <a:pt x="1168694" y="5052948"/>
                    <a:pt x="1222182" y="5024944"/>
                    <a:pt x="1237899" y="4974688"/>
                  </a:cubicBezTo>
                  <a:cubicBezTo>
                    <a:pt x="1238611" y="4972400"/>
                    <a:pt x="1239240" y="4970093"/>
                    <a:pt x="1239781" y="4967760"/>
                  </a:cubicBezTo>
                  <a:cubicBezTo>
                    <a:pt x="1456596" y="4169149"/>
                    <a:pt x="1806538" y="3412786"/>
                    <a:pt x="2274902" y="2730488"/>
                  </a:cubicBezTo>
                  <a:cubicBezTo>
                    <a:pt x="2304581" y="2687090"/>
                    <a:pt x="2293518" y="2627860"/>
                    <a:pt x="2250170" y="2598095"/>
                  </a:cubicBezTo>
                  <a:close/>
                  <a:moveTo>
                    <a:pt x="5289222" y="4471365"/>
                  </a:moveTo>
                  <a:cubicBezTo>
                    <a:pt x="5247089" y="4439770"/>
                    <a:pt x="5187312" y="4448313"/>
                    <a:pt x="5155707" y="4490433"/>
                  </a:cubicBezTo>
                  <a:cubicBezTo>
                    <a:pt x="4642139" y="5174034"/>
                    <a:pt x="4359361" y="6003210"/>
                    <a:pt x="4348260" y="6858064"/>
                  </a:cubicBezTo>
                  <a:lnTo>
                    <a:pt x="4538996" y="6858064"/>
                  </a:lnTo>
                  <a:cubicBezTo>
                    <a:pt x="4550065" y="6044479"/>
                    <a:pt x="4819460" y="5255459"/>
                    <a:pt x="5308296" y="4604903"/>
                  </a:cubicBezTo>
                  <a:cubicBezTo>
                    <a:pt x="5339900" y="4562782"/>
                    <a:pt x="5331375" y="4503024"/>
                    <a:pt x="5289241" y="4471429"/>
                  </a:cubicBezTo>
                  <a:cubicBezTo>
                    <a:pt x="5289216" y="4471403"/>
                    <a:pt x="5289184" y="4471384"/>
                    <a:pt x="5289158" y="4471365"/>
                  </a:cubicBezTo>
                  <a:close/>
                  <a:moveTo>
                    <a:pt x="2682504" y="5323054"/>
                  </a:moveTo>
                  <a:cubicBezTo>
                    <a:pt x="2631558" y="5309764"/>
                    <a:pt x="2579475" y="5340266"/>
                    <a:pt x="2566155" y="5391189"/>
                  </a:cubicBezTo>
                  <a:cubicBezTo>
                    <a:pt x="2441510" y="5870327"/>
                    <a:pt x="2376125" y="6362940"/>
                    <a:pt x="2371478" y="6858000"/>
                  </a:cubicBezTo>
                  <a:lnTo>
                    <a:pt x="2562213" y="6858000"/>
                  </a:lnTo>
                  <a:cubicBezTo>
                    <a:pt x="2566810" y="6379148"/>
                    <a:pt x="2630122" y="5902679"/>
                    <a:pt x="2750724" y="5439240"/>
                  </a:cubicBezTo>
                  <a:cubicBezTo>
                    <a:pt x="2764018" y="5388310"/>
                    <a:pt x="2733513" y="5336243"/>
                    <a:pt x="2682567" y="5322927"/>
                  </a:cubicBezTo>
                  <a:close/>
                  <a:moveTo>
                    <a:pt x="4160068" y="5925910"/>
                  </a:moveTo>
                  <a:cubicBezTo>
                    <a:pt x="4108531" y="5915060"/>
                    <a:pt x="4057948" y="5948028"/>
                    <a:pt x="4047095" y="5999555"/>
                  </a:cubicBezTo>
                  <a:cubicBezTo>
                    <a:pt x="4047089" y="5999562"/>
                    <a:pt x="4047089" y="5999568"/>
                    <a:pt x="4047089" y="5999574"/>
                  </a:cubicBezTo>
                  <a:cubicBezTo>
                    <a:pt x="3988006" y="6282004"/>
                    <a:pt x="3956363" y="6569507"/>
                    <a:pt x="3952611" y="6858000"/>
                  </a:cubicBezTo>
                  <a:lnTo>
                    <a:pt x="4143347" y="6858000"/>
                  </a:lnTo>
                  <a:cubicBezTo>
                    <a:pt x="4147123" y="6582600"/>
                    <a:pt x="4177425" y="6308242"/>
                    <a:pt x="4233819" y="6038663"/>
                  </a:cubicBezTo>
                  <a:cubicBezTo>
                    <a:pt x="4244634" y="5987155"/>
                    <a:pt x="4211649" y="5936626"/>
                    <a:pt x="4160132" y="5925783"/>
                  </a:cubicBezTo>
                  <a:close/>
                  <a:moveTo>
                    <a:pt x="2089189" y="6428024"/>
                  </a:moveTo>
                  <a:cubicBezTo>
                    <a:pt x="2036629" y="6424783"/>
                    <a:pt x="1991399" y="6464762"/>
                    <a:pt x="1988163" y="6517325"/>
                  </a:cubicBezTo>
                  <a:cubicBezTo>
                    <a:pt x="1981233" y="6630015"/>
                    <a:pt x="1977228" y="6744293"/>
                    <a:pt x="1976147" y="6857937"/>
                  </a:cubicBezTo>
                  <a:lnTo>
                    <a:pt x="2166882" y="6857937"/>
                  </a:lnTo>
                  <a:cubicBezTo>
                    <a:pt x="2167900" y="6748170"/>
                    <a:pt x="2171778" y="6637832"/>
                    <a:pt x="2178454" y="6529020"/>
                  </a:cubicBezTo>
                  <a:cubicBezTo>
                    <a:pt x="2181645" y="6476520"/>
                    <a:pt x="2141737" y="6431393"/>
                    <a:pt x="2089253" y="6428088"/>
                  </a:cubicBezTo>
                  <a:close/>
                  <a:moveTo>
                    <a:pt x="3184583" y="972450"/>
                  </a:moveTo>
                  <a:cubicBezTo>
                    <a:pt x="3218833" y="1012264"/>
                    <a:pt x="3278838" y="1016897"/>
                    <a:pt x="3318797" y="982811"/>
                  </a:cubicBezTo>
                  <a:cubicBezTo>
                    <a:pt x="3763936" y="601738"/>
                    <a:pt x="4250629" y="272053"/>
                    <a:pt x="4769659" y="0"/>
                  </a:cubicBezTo>
                  <a:lnTo>
                    <a:pt x="4375472" y="0"/>
                  </a:lnTo>
                  <a:cubicBezTo>
                    <a:pt x="3957475" y="243105"/>
                    <a:pt x="3562373" y="523572"/>
                    <a:pt x="3195010" y="837960"/>
                  </a:cubicBezTo>
                  <a:cubicBezTo>
                    <a:pt x="3154981" y="872186"/>
                    <a:pt x="3150289" y="932364"/>
                    <a:pt x="3184526" y="972381"/>
                  </a:cubicBezTo>
                  <a:cubicBezTo>
                    <a:pt x="3184545" y="972406"/>
                    <a:pt x="3184564" y="972425"/>
                    <a:pt x="3184583" y="972450"/>
                  </a:cubicBezTo>
                  <a:close/>
                  <a:moveTo>
                    <a:pt x="3860550" y="1312617"/>
                  </a:moveTo>
                  <a:cubicBezTo>
                    <a:pt x="2823496" y="2150361"/>
                    <a:pt x="2039217" y="3259260"/>
                    <a:pt x="1594930" y="4515984"/>
                  </a:cubicBezTo>
                  <a:cubicBezTo>
                    <a:pt x="1577376" y="4565636"/>
                    <a:pt x="1603405" y="4620118"/>
                    <a:pt x="1653073" y="4637667"/>
                  </a:cubicBezTo>
                  <a:cubicBezTo>
                    <a:pt x="1702740" y="4655216"/>
                    <a:pt x="1757240" y="4629195"/>
                    <a:pt x="1774794" y="4579543"/>
                  </a:cubicBezTo>
                  <a:cubicBezTo>
                    <a:pt x="2207331" y="3355996"/>
                    <a:pt x="2970909" y="2276380"/>
                    <a:pt x="3980586" y="1460773"/>
                  </a:cubicBezTo>
                  <a:cubicBezTo>
                    <a:pt x="4021531" y="1427634"/>
                    <a:pt x="4027850" y="1367596"/>
                    <a:pt x="3994700" y="1326664"/>
                  </a:cubicBezTo>
                  <a:cubicBezTo>
                    <a:pt x="3961551" y="1285732"/>
                    <a:pt x="3901494" y="1279414"/>
                    <a:pt x="3860550" y="1312554"/>
                  </a:cubicBezTo>
                  <a:close/>
                  <a:moveTo>
                    <a:pt x="1208945" y="3617516"/>
                  </a:moveTo>
                  <a:cubicBezTo>
                    <a:pt x="1160835" y="3596077"/>
                    <a:pt x="1104454" y="3617687"/>
                    <a:pt x="1083015" y="3665782"/>
                  </a:cubicBezTo>
                  <a:cubicBezTo>
                    <a:pt x="1083009" y="3665795"/>
                    <a:pt x="1083002" y="3665808"/>
                    <a:pt x="1082996" y="3665820"/>
                  </a:cubicBezTo>
                  <a:cubicBezTo>
                    <a:pt x="859435" y="4168317"/>
                    <a:pt x="688555" y="4692614"/>
                    <a:pt x="573097" y="5230321"/>
                  </a:cubicBezTo>
                  <a:cubicBezTo>
                    <a:pt x="458636" y="5765430"/>
                    <a:pt x="398987" y="6310803"/>
                    <a:pt x="395077" y="6858000"/>
                  </a:cubicBezTo>
                  <a:lnTo>
                    <a:pt x="585812" y="6858000"/>
                  </a:lnTo>
                  <a:cubicBezTo>
                    <a:pt x="589655" y="6324252"/>
                    <a:pt x="647789" y="5792284"/>
                    <a:pt x="759318" y="5270300"/>
                  </a:cubicBezTo>
                  <a:cubicBezTo>
                    <a:pt x="872119" y="4745584"/>
                    <a:pt x="1038993" y="4233954"/>
                    <a:pt x="1257265" y="3743616"/>
                  </a:cubicBezTo>
                  <a:cubicBezTo>
                    <a:pt x="1278792" y="3695566"/>
                    <a:pt x="1257284" y="3639157"/>
                    <a:pt x="1209212" y="3617637"/>
                  </a:cubicBezTo>
                  <a:cubicBezTo>
                    <a:pt x="1209123" y="3617598"/>
                    <a:pt x="1209034" y="3617554"/>
                    <a:pt x="1208945" y="3617516"/>
                  </a:cubicBezTo>
                  <a:close/>
                  <a:moveTo>
                    <a:pt x="943632" y="5974532"/>
                  </a:moveTo>
                  <a:cubicBezTo>
                    <a:pt x="891294" y="5968659"/>
                    <a:pt x="844106" y="6006305"/>
                    <a:pt x="838219" y="6058620"/>
                  </a:cubicBezTo>
                  <a:cubicBezTo>
                    <a:pt x="808496" y="6324074"/>
                    <a:pt x="792557" y="6590926"/>
                    <a:pt x="790471" y="6858000"/>
                  </a:cubicBezTo>
                  <a:lnTo>
                    <a:pt x="981207" y="6858000"/>
                  </a:lnTo>
                  <a:cubicBezTo>
                    <a:pt x="983267" y="6597917"/>
                    <a:pt x="998799" y="6338127"/>
                    <a:pt x="1027746" y="6079658"/>
                  </a:cubicBezTo>
                  <a:cubicBezTo>
                    <a:pt x="1033475" y="6027432"/>
                    <a:pt x="995855" y="5980418"/>
                    <a:pt x="943632" y="5974532"/>
                  </a:cubicBezTo>
                  <a:close/>
                  <a:moveTo>
                    <a:pt x="2331805" y="1389587"/>
                  </a:moveTo>
                  <a:cubicBezTo>
                    <a:pt x="2707325" y="978292"/>
                    <a:pt x="3123535" y="606057"/>
                    <a:pt x="3574065" y="278578"/>
                  </a:cubicBezTo>
                  <a:cubicBezTo>
                    <a:pt x="3707535" y="181588"/>
                    <a:pt x="3843911" y="88728"/>
                    <a:pt x="3983193" y="0"/>
                  </a:cubicBezTo>
                  <a:lnTo>
                    <a:pt x="3637771" y="0"/>
                  </a:lnTo>
                  <a:cubicBezTo>
                    <a:pt x="3578433" y="40678"/>
                    <a:pt x="3519814" y="82118"/>
                    <a:pt x="3461913" y="124321"/>
                  </a:cubicBezTo>
                  <a:cubicBezTo>
                    <a:pt x="3000969" y="459401"/>
                    <a:pt x="2575133" y="840261"/>
                    <a:pt x="2190915" y="1261071"/>
                  </a:cubicBezTo>
                  <a:cubicBezTo>
                    <a:pt x="2155794" y="1300312"/>
                    <a:pt x="2159145" y="1360585"/>
                    <a:pt x="2198398" y="1395695"/>
                  </a:cubicBezTo>
                  <a:cubicBezTo>
                    <a:pt x="2237111" y="1430316"/>
                    <a:pt x="2296417" y="1427602"/>
                    <a:pt x="2331805" y="1389587"/>
                  </a:cubicBezTo>
                  <a:close/>
                  <a:moveTo>
                    <a:pt x="558283" y="4174100"/>
                  </a:moveTo>
                  <a:cubicBezTo>
                    <a:pt x="508369" y="4157308"/>
                    <a:pt x="454289" y="4184143"/>
                    <a:pt x="437484" y="4234036"/>
                  </a:cubicBezTo>
                  <a:cubicBezTo>
                    <a:pt x="152999" y="5079865"/>
                    <a:pt x="5315" y="5965653"/>
                    <a:pt x="0" y="6858000"/>
                  </a:cubicBezTo>
                  <a:lnTo>
                    <a:pt x="190735" y="6858000"/>
                  </a:lnTo>
                  <a:cubicBezTo>
                    <a:pt x="196021" y="5986354"/>
                    <a:pt x="340335" y="5121127"/>
                    <a:pt x="618237" y="4294926"/>
                  </a:cubicBezTo>
                  <a:cubicBezTo>
                    <a:pt x="635068" y="4245032"/>
                    <a:pt x="608253" y="4190944"/>
                    <a:pt x="558344" y="4174119"/>
                  </a:cubicBezTo>
                  <a:cubicBezTo>
                    <a:pt x="558323" y="4174113"/>
                    <a:pt x="558303" y="4174107"/>
                    <a:pt x="558283" y="4174100"/>
                  </a:cubicBezTo>
                  <a:close/>
                  <a:moveTo>
                    <a:pt x="3037844" y="3379615"/>
                  </a:moveTo>
                  <a:cubicBezTo>
                    <a:pt x="3010054" y="3424341"/>
                    <a:pt x="3023793" y="3483121"/>
                    <a:pt x="3068533" y="3510909"/>
                  </a:cubicBezTo>
                  <a:cubicBezTo>
                    <a:pt x="3111436" y="3537552"/>
                    <a:pt x="3167678" y="3526131"/>
                    <a:pt x="3196790" y="3484868"/>
                  </a:cubicBezTo>
                  <a:cubicBezTo>
                    <a:pt x="3756262" y="2640934"/>
                    <a:pt x="4511937" y="1945073"/>
                    <a:pt x="5399149" y="1456833"/>
                  </a:cubicBezTo>
                  <a:cubicBezTo>
                    <a:pt x="5438612" y="1435178"/>
                    <a:pt x="5478324" y="1413994"/>
                    <a:pt x="5518295" y="1393274"/>
                  </a:cubicBezTo>
                  <a:lnTo>
                    <a:pt x="5518295" y="1179080"/>
                  </a:lnTo>
                  <a:cubicBezTo>
                    <a:pt x="5447342" y="1214673"/>
                    <a:pt x="5377024" y="1251582"/>
                    <a:pt x="5307342" y="1289800"/>
                  </a:cubicBezTo>
                  <a:cubicBezTo>
                    <a:pt x="4393090" y="1792906"/>
                    <a:pt x="3614361" y="2509939"/>
                    <a:pt x="3037780" y="3379551"/>
                  </a:cubicBezTo>
                  <a:close/>
                  <a:moveTo>
                    <a:pt x="4015808" y="3381140"/>
                  </a:moveTo>
                  <a:cubicBezTo>
                    <a:pt x="3403115" y="4138641"/>
                    <a:pt x="2998006" y="5042404"/>
                    <a:pt x="2840242" y="6003706"/>
                  </a:cubicBezTo>
                  <a:cubicBezTo>
                    <a:pt x="2831761" y="6055671"/>
                    <a:pt x="2867028" y="6104675"/>
                    <a:pt x="2919009" y="6113154"/>
                  </a:cubicBezTo>
                  <a:cubicBezTo>
                    <a:pt x="2919009" y="6113154"/>
                    <a:pt x="2919016" y="6113154"/>
                    <a:pt x="2919016" y="6113154"/>
                  </a:cubicBezTo>
                  <a:cubicBezTo>
                    <a:pt x="2924121" y="6114012"/>
                    <a:pt x="2929290" y="6114438"/>
                    <a:pt x="2934465" y="6114425"/>
                  </a:cubicBezTo>
                  <a:cubicBezTo>
                    <a:pt x="2981183" y="6114381"/>
                    <a:pt x="3020989" y="6080504"/>
                    <a:pt x="3028498" y="6034405"/>
                  </a:cubicBezTo>
                  <a:cubicBezTo>
                    <a:pt x="3282755" y="4490388"/>
                    <a:pt x="4190147" y="3130744"/>
                    <a:pt x="5518613" y="2303182"/>
                  </a:cubicBezTo>
                  <a:lnTo>
                    <a:pt x="5518613" y="2080027"/>
                  </a:lnTo>
                  <a:cubicBezTo>
                    <a:pt x="4944729" y="2421681"/>
                    <a:pt x="4435910" y="2862252"/>
                    <a:pt x="4015745" y="3381331"/>
                  </a:cubicBezTo>
                  <a:close/>
                  <a:moveTo>
                    <a:pt x="3489188" y="3682663"/>
                  </a:moveTo>
                  <a:cubicBezTo>
                    <a:pt x="3520805" y="3682689"/>
                    <a:pt x="3550382" y="3667047"/>
                    <a:pt x="3568152" y="3640906"/>
                  </a:cubicBezTo>
                  <a:cubicBezTo>
                    <a:pt x="3901106" y="3151394"/>
                    <a:pt x="4306483" y="2715260"/>
                    <a:pt x="4770422" y="2347419"/>
                  </a:cubicBezTo>
                  <a:cubicBezTo>
                    <a:pt x="4811678" y="2314686"/>
                    <a:pt x="4818582" y="2254712"/>
                    <a:pt x="4785839" y="2213469"/>
                  </a:cubicBezTo>
                  <a:cubicBezTo>
                    <a:pt x="4753096" y="2172225"/>
                    <a:pt x="4693104" y="2165323"/>
                    <a:pt x="4651848" y="2198056"/>
                  </a:cubicBezTo>
                  <a:cubicBezTo>
                    <a:pt x="4172796" y="2577934"/>
                    <a:pt x="3754234" y="3028338"/>
                    <a:pt x="3410477" y="3533872"/>
                  </a:cubicBezTo>
                  <a:cubicBezTo>
                    <a:pt x="3380843" y="3577397"/>
                    <a:pt x="3392116" y="3636704"/>
                    <a:pt x="3435655" y="3666329"/>
                  </a:cubicBezTo>
                  <a:cubicBezTo>
                    <a:pt x="3451441" y="3677071"/>
                    <a:pt x="3470089" y="3682829"/>
                    <a:pt x="3489188" y="3682854"/>
                  </a:cubicBezTo>
                  <a:close/>
                  <a:moveTo>
                    <a:pt x="5235117" y="0"/>
                  </a:moveTo>
                  <a:cubicBezTo>
                    <a:pt x="5039295" y="89448"/>
                    <a:pt x="4847415" y="187160"/>
                    <a:pt x="4659477" y="293133"/>
                  </a:cubicBezTo>
                  <a:cubicBezTo>
                    <a:pt x="4613020" y="317947"/>
                    <a:pt x="4595485" y="375710"/>
                    <a:pt x="4620306" y="422150"/>
                  </a:cubicBezTo>
                  <a:cubicBezTo>
                    <a:pt x="4645127" y="468591"/>
                    <a:pt x="4702908" y="486122"/>
                    <a:pt x="4749364" y="461309"/>
                  </a:cubicBezTo>
                  <a:cubicBezTo>
                    <a:pt x="4750655" y="460619"/>
                    <a:pt x="4751933" y="459899"/>
                    <a:pt x="4753192" y="459149"/>
                  </a:cubicBezTo>
                  <a:cubicBezTo>
                    <a:pt x="5000906" y="319499"/>
                    <a:pt x="5256473" y="194249"/>
                    <a:pt x="5518613" y="84025"/>
                  </a:cubicBezTo>
                  <a:lnTo>
                    <a:pt x="5518613" y="0"/>
                  </a:lnTo>
                  <a:close/>
                  <a:moveTo>
                    <a:pt x="4506698" y="959040"/>
                  </a:moveTo>
                  <a:cubicBezTo>
                    <a:pt x="4534914" y="1003493"/>
                    <a:pt x="4593832" y="1016668"/>
                    <a:pt x="4638305" y="988467"/>
                  </a:cubicBezTo>
                  <a:cubicBezTo>
                    <a:pt x="4920053" y="809892"/>
                    <a:pt x="5214244" y="651732"/>
                    <a:pt x="5518613" y="515208"/>
                  </a:cubicBezTo>
                  <a:lnTo>
                    <a:pt x="5518613" y="306799"/>
                  </a:lnTo>
                  <a:cubicBezTo>
                    <a:pt x="5178233" y="454670"/>
                    <a:pt x="4849857" y="628751"/>
                    <a:pt x="4536453" y="827473"/>
                  </a:cubicBezTo>
                  <a:cubicBezTo>
                    <a:pt x="4491903" y="855559"/>
                    <a:pt x="4478558" y="914434"/>
                    <a:pt x="4506654" y="958970"/>
                  </a:cubicBezTo>
                  <a:cubicBezTo>
                    <a:pt x="4506666" y="958995"/>
                    <a:pt x="4506685" y="959014"/>
                    <a:pt x="4506698" y="959040"/>
                  </a:cubicBezTo>
                  <a:close/>
                  <a:moveTo>
                    <a:pt x="4505109" y="4769266"/>
                  </a:moveTo>
                  <a:cubicBezTo>
                    <a:pt x="4479111" y="4815060"/>
                    <a:pt x="4495178" y="4873248"/>
                    <a:pt x="4540986" y="4899237"/>
                  </a:cubicBezTo>
                  <a:cubicBezTo>
                    <a:pt x="4586794" y="4925227"/>
                    <a:pt x="4645000" y="4909165"/>
                    <a:pt x="4670998" y="4863371"/>
                  </a:cubicBezTo>
                  <a:cubicBezTo>
                    <a:pt x="4671334" y="4862767"/>
                    <a:pt x="4671672" y="4862163"/>
                    <a:pt x="4672002" y="4861553"/>
                  </a:cubicBezTo>
                  <a:cubicBezTo>
                    <a:pt x="4894546" y="4460236"/>
                    <a:pt x="5180426" y="4097461"/>
                    <a:pt x="5518613" y="3787218"/>
                  </a:cubicBezTo>
                  <a:lnTo>
                    <a:pt x="5518613" y="3532982"/>
                  </a:lnTo>
                  <a:cubicBezTo>
                    <a:pt x="5109015" y="3880656"/>
                    <a:pt x="4765659" y="4299483"/>
                    <a:pt x="4505109" y="4769266"/>
                  </a:cubicBezTo>
                  <a:close/>
                  <a:moveTo>
                    <a:pt x="5138541" y="6858000"/>
                  </a:moveTo>
                  <a:lnTo>
                    <a:pt x="5329276" y="6858000"/>
                  </a:lnTo>
                  <a:cubicBezTo>
                    <a:pt x="5336270" y="6515418"/>
                    <a:pt x="5400255" y="6176332"/>
                    <a:pt x="5518613" y="5854724"/>
                  </a:cubicBezTo>
                  <a:lnTo>
                    <a:pt x="5518613" y="5389791"/>
                  </a:lnTo>
                  <a:cubicBezTo>
                    <a:pt x="5516706" y="5392651"/>
                    <a:pt x="5514862" y="5395638"/>
                    <a:pt x="5513146" y="5398816"/>
                  </a:cubicBezTo>
                  <a:cubicBezTo>
                    <a:pt x="5276239" y="5849385"/>
                    <a:pt x="5147964" y="6349072"/>
                    <a:pt x="5138541" y="6858000"/>
                  </a:cubicBezTo>
                  <a:close/>
                  <a:moveTo>
                    <a:pt x="4985952" y="5893686"/>
                  </a:moveTo>
                  <a:cubicBezTo>
                    <a:pt x="5035970" y="5910160"/>
                    <a:pt x="5089878" y="5882988"/>
                    <a:pt x="5106370" y="5832987"/>
                  </a:cubicBezTo>
                  <a:cubicBezTo>
                    <a:pt x="5204847" y="5534978"/>
                    <a:pt x="5343543" y="5251798"/>
                    <a:pt x="5518613" y="4991277"/>
                  </a:cubicBezTo>
                  <a:lnTo>
                    <a:pt x="5518613" y="4667127"/>
                  </a:lnTo>
                  <a:cubicBezTo>
                    <a:pt x="5258469" y="4998866"/>
                    <a:pt x="5057911" y="5373234"/>
                    <a:pt x="4925871" y="5773559"/>
                  </a:cubicBezTo>
                  <a:cubicBezTo>
                    <a:pt x="4909525" y="5823396"/>
                    <a:pt x="4936514" y="5877065"/>
                    <a:pt x="4986271" y="5893686"/>
                  </a:cubicBezTo>
                  <a:close/>
                  <a:moveTo>
                    <a:pt x="4231022" y="3746922"/>
                  </a:moveTo>
                  <a:cubicBezTo>
                    <a:pt x="3547960" y="4641328"/>
                    <a:pt x="3172923" y="5732780"/>
                    <a:pt x="3162013" y="6858000"/>
                  </a:cubicBezTo>
                  <a:lnTo>
                    <a:pt x="3352748" y="6858000"/>
                  </a:lnTo>
                  <a:cubicBezTo>
                    <a:pt x="3371256" y="5227137"/>
                    <a:pt x="4178328" y="3706129"/>
                    <a:pt x="5518613" y="2776187"/>
                  </a:cubicBezTo>
                  <a:lnTo>
                    <a:pt x="5518613" y="2545913"/>
                  </a:lnTo>
                  <a:cubicBezTo>
                    <a:pt x="5487758" y="2566252"/>
                    <a:pt x="5457088" y="2586909"/>
                    <a:pt x="5426615" y="2607883"/>
                  </a:cubicBezTo>
                  <a:cubicBezTo>
                    <a:pt x="4970414" y="2922055"/>
                    <a:pt x="4566875" y="3306503"/>
                    <a:pt x="4231022" y="3746922"/>
                  </a:cubicBezTo>
                  <a:close/>
                  <a:moveTo>
                    <a:pt x="4908260" y="6204806"/>
                  </a:moveTo>
                  <a:cubicBezTo>
                    <a:pt x="4856386" y="6195698"/>
                    <a:pt x="4806947" y="6230357"/>
                    <a:pt x="4797837" y="6282220"/>
                  </a:cubicBezTo>
                  <a:cubicBezTo>
                    <a:pt x="4797830" y="6282240"/>
                    <a:pt x="4797830" y="6282265"/>
                    <a:pt x="4797824" y="6282284"/>
                  </a:cubicBezTo>
                  <a:cubicBezTo>
                    <a:pt x="4764509" y="6472452"/>
                    <a:pt x="4746160" y="6664972"/>
                    <a:pt x="4742956" y="6858000"/>
                  </a:cubicBezTo>
                  <a:lnTo>
                    <a:pt x="4933691" y="6858000"/>
                  </a:lnTo>
                  <a:cubicBezTo>
                    <a:pt x="4936800" y="6676031"/>
                    <a:pt x="4954081" y="6494507"/>
                    <a:pt x="4985380" y="6315208"/>
                  </a:cubicBezTo>
                  <a:cubicBezTo>
                    <a:pt x="4994510" y="6263445"/>
                    <a:pt x="4960013" y="6214067"/>
                    <a:pt x="4908260" y="6204806"/>
                  </a:cubicBezTo>
                  <a:close/>
                  <a:moveTo>
                    <a:pt x="4560803" y="3966517"/>
                  </a:moveTo>
                  <a:cubicBezTo>
                    <a:pt x="4263180" y="4352091"/>
                    <a:pt x="4025727" y="4780535"/>
                    <a:pt x="3856544" y="5237250"/>
                  </a:cubicBezTo>
                  <a:cubicBezTo>
                    <a:pt x="3838253" y="5286641"/>
                    <a:pt x="3863468" y="5341505"/>
                    <a:pt x="3912875" y="5359791"/>
                  </a:cubicBezTo>
                  <a:cubicBezTo>
                    <a:pt x="3962282" y="5378077"/>
                    <a:pt x="4017163" y="5352869"/>
                    <a:pt x="4035454" y="5303478"/>
                  </a:cubicBezTo>
                  <a:cubicBezTo>
                    <a:pt x="4333199" y="4501537"/>
                    <a:pt x="4846398" y="3797203"/>
                    <a:pt x="5518613" y="3267942"/>
                  </a:cubicBezTo>
                  <a:lnTo>
                    <a:pt x="5518613" y="3027944"/>
                  </a:lnTo>
                  <a:cubicBezTo>
                    <a:pt x="5157405" y="3294948"/>
                    <a:pt x="4835056" y="3610823"/>
                    <a:pt x="4560803" y="396651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51" name="Google Shape;51;p7"/>
            <p:cNvSpPr/>
            <p:nvPr/>
          </p:nvSpPr>
          <p:spPr>
            <a:xfrm>
              <a:off x="5330737" y="210583"/>
              <a:ext cx="3668526" cy="4753341"/>
            </a:xfrm>
            <a:custGeom>
              <a:avLst/>
              <a:gdLst/>
              <a:ahLst/>
              <a:cxnLst/>
              <a:rect l="l" t="t" r="r" b="b"/>
              <a:pathLst>
                <a:path w="4891368" h="6337788" extrusionOk="0">
                  <a:moveTo>
                    <a:pt x="745243" y="3328976"/>
                  </a:moveTo>
                  <a:cubicBezTo>
                    <a:pt x="615034" y="3317536"/>
                    <a:pt x="605370" y="3517682"/>
                    <a:pt x="735833" y="3519144"/>
                  </a:cubicBezTo>
                  <a:cubicBezTo>
                    <a:pt x="854598" y="3519335"/>
                    <a:pt x="863499" y="3340544"/>
                    <a:pt x="745243" y="3328976"/>
                  </a:cubicBezTo>
                  <a:close/>
                  <a:moveTo>
                    <a:pt x="1658484" y="6147620"/>
                  </a:moveTo>
                  <a:cubicBezTo>
                    <a:pt x="1528275" y="6136180"/>
                    <a:pt x="1518611" y="6336390"/>
                    <a:pt x="1649138" y="6337788"/>
                  </a:cubicBezTo>
                  <a:cubicBezTo>
                    <a:pt x="1767903" y="6337916"/>
                    <a:pt x="1776676" y="6159125"/>
                    <a:pt x="1658484" y="6147620"/>
                  </a:cubicBezTo>
                  <a:close/>
                  <a:moveTo>
                    <a:pt x="1259974" y="4171957"/>
                  </a:moveTo>
                  <a:cubicBezTo>
                    <a:pt x="1129765" y="4160580"/>
                    <a:pt x="1119783" y="4360664"/>
                    <a:pt x="1250564" y="4362189"/>
                  </a:cubicBezTo>
                  <a:cubicBezTo>
                    <a:pt x="1369329" y="4362253"/>
                    <a:pt x="1378166" y="4183652"/>
                    <a:pt x="1259974" y="4171957"/>
                  </a:cubicBezTo>
                  <a:close/>
                  <a:moveTo>
                    <a:pt x="1778774" y="3926811"/>
                  </a:moveTo>
                  <a:cubicBezTo>
                    <a:pt x="1648566" y="3915307"/>
                    <a:pt x="1638902" y="4115517"/>
                    <a:pt x="1769365" y="4116979"/>
                  </a:cubicBezTo>
                  <a:cubicBezTo>
                    <a:pt x="1888066" y="4117487"/>
                    <a:pt x="1896967" y="3938442"/>
                    <a:pt x="1778774" y="3926811"/>
                  </a:cubicBezTo>
                  <a:close/>
                  <a:moveTo>
                    <a:pt x="2490854" y="5643345"/>
                  </a:moveTo>
                  <a:cubicBezTo>
                    <a:pt x="2372661" y="5654976"/>
                    <a:pt x="2381499" y="5833513"/>
                    <a:pt x="2500200" y="5833576"/>
                  </a:cubicBezTo>
                  <a:cubicBezTo>
                    <a:pt x="2630790" y="5832115"/>
                    <a:pt x="2621062" y="5632095"/>
                    <a:pt x="2490727" y="5643408"/>
                  </a:cubicBezTo>
                  <a:close/>
                  <a:moveTo>
                    <a:pt x="1817685" y="949650"/>
                  </a:moveTo>
                  <a:cubicBezTo>
                    <a:pt x="1699556" y="961282"/>
                    <a:pt x="1708330" y="1139882"/>
                    <a:pt x="1827031" y="1139882"/>
                  </a:cubicBezTo>
                  <a:cubicBezTo>
                    <a:pt x="1957811" y="1138420"/>
                    <a:pt x="1947957" y="938337"/>
                    <a:pt x="1817685" y="949650"/>
                  </a:cubicBezTo>
                  <a:close/>
                  <a:moveTo>
                    <a:pt x="1761990" y="2491334"/>
                  </a:moveTo>
                  <a:cubicBezTo>
                    <a:pt x="1892707" y="2489745"/>
                    <a:pt x="1882789" y="2289725"/>
                    <a:pt x="1752580" y="2301102"/>
                  </a:cubicBezTo>
                  <a:cubicBezTo>
                    <a:pt x="1634388" y="2312734"/>
                    <a:pt x="1643289" y="2491334"/>
                    <a:pt x="1761990" y="2491334"/>
                  </a:cubicBezTo>
                  <a:close/>
                  <a:moveTo>
                    <a:pt x="722863" y="4567103"/>
                  </a:moveTo>
                  <a:cubicBezTo>
                    <a:pt x="592591" y="4555789"/>
                    <a:pt x="582990" y="4755682"/>
                    <a:pt x="713453" y="4757334"/>
                  </a:cubicBezTo>
                  <a:cubicBezTo>
                    <a:pt x="832154" y="4757334"/>
                    <a:pt x="841119" y="4578734"/>
                    <a:pt x="722863" y="4567103"/>
                  </a:cubicBezTo>
                  <a:close/>
                  <a:moveTo>
                    <a:pt x="4272069" y="190694"/>
                  </a:moveTo>
                  <a:cubicBezTo>
                    <a:pt x="4402786" y="189105"/>
                    <a:pt x="4392868" y="-10851"/>
                    <a:pt x="4262659" y="463"/>
                  </a:cubicBezTo>
                  <a:cubicBezTo>
                    <a:pt x="4144467" y="12157"/>
                    <a:pt x="4153304" y="190758"/>
                    <a:pt x="4272069" y="190694"/>
                  </a:cubicBezTo>
                  <a:close/>
                  <a:moveTo>
                    <a:pt x="84153" y="3888675"/>
                  </a:moveTo>
                  <a:cubicBezTo>
                    <a:pt x="-33721" y="3900434"/>
                    <a:pt x="-25138" y="4079352"/>
                    <a:pt x="93436" y="4079352"/>
                  </a:cubicBezTo>
                  <a:cubicBezTo>
                    <a:pt x="224280" y="4077445"/>
                    <a:pt x="214235" y="3877425"/>
                    <a:pt x="84153" y="3888675"/>
                  </a:cubicBezTo>
                  <a:close/>
                  <a:moveTo>
                    <a:pt x="489339" y="5693238"/>
                  </a:moveTo>
                  <a:cubicBezTo>
                    <a:pt x="371210" y="5704679"/>
                    <a:pt x="379984" y="5883470"/>
                    <a:pt x="498685" y="5883407"/>
                  </a:cubicBezTo>
                  <a:cubicBezTo>
                    <a:pt x="629403" y="5882135"/>
                    <a:pt x="619611" y="5681925"/>
                    <a:pt x="489339" y="5693366"/>
                  </a:cubicBezTo>
                  <a:close/>
                  <a:moveTo>
                    <a:pt x="2214860" y="5039345"/>
                  </a:moveTo>
                  <a:cubicBezTo>
                    <a:pt x="2096731" y="5050976"/>
                    <a:pt x="2105504" y="5229576"/>
                    <a:pt x="2224206" y="5229576"/>
                  </a:cubicBezTo>
                  <a:cubicBezTo>
                    <a:pt x="2354923" y="5228178"/>
                    <a:pt x="2345132" y="5028222"/>
                    <a:pt x="2214860" y="5039472"/>
                  </a:cubicBezTo>
                  <a:close/>
                  <a:moveTo>
                    <a:pt x="4448054" y="5922813"/>
                  </a:moveTo>
                  <a:cubicBezTo>
                    <a:pt x="4329862" y="5934444"/>
                    <a:pt x="4338763" y="6113108"/>
                    <a:pt x="4457464" y="6113044"/>
                  </a:cubicBezTo>
                  <a:cubicBezTo>
                    <a:pt x="4588435" y="6111774"/>
                    <a:pt x="4578326" y="5911754"/>
                    <a:pt x="4448054" y="5923067"/>
                  </a:cubicBezTo>
                  <a:close/>
                  <a:moveTo>
                    <a:pt x="4267491" y="1896804"/>
                  </a:moveTo>
                  <a:cubicBezTo>
                    <a:pt x="4149299" y="1908372"/>
                    <a:pt x="4158136" y="2086973"/>
                    <a:pt x="4276837" y="2087036"/>
                  </a:cubicBezTo>
                  <a:cubicBezTo>
                    <a:pt x="4407554" y="2085765"/>
                    <a:pt x="4397700" y="1885682"/>
                    <a:pt x="4267491" y="1897059"/>
                  </a:cubicBezTo>
                  <a:close/>
                  <a:moveTo>
                    <a:pt x="4153050" y="722301"/>
                  </a:moveTo>
                  <a:cubicBezTo>
                    <a:pt x="4283831" y="720775"/>
                    <a:pt x="4273849" y="520755"/>
                    <a:pt x="4143704" y="532069"/>
                  </a:cubicBezTo>
                  <a:cubicBezTo>
                    <a:pt x="4025384" y="543954"/>
                    <a:pt x="4034222" y="722491"/>
                    <a:pt x="4152923" y="722555"/>
                  </a:cubicBezTo>
                  <a:close/>
                  <a:moveTo>
                    <a:pt x="4144848" y="4439731"/>
                  </a:moveTo>
                  <a:cubicBezTo>
                    <a:pt x="4026719" y="4451362"/>
                    <a:pt x="4035557" y="4629962"/>
                    <a:pt x="4154258" y="4629962"/>
                  </a:cubicBezTo>
                  <a:cubicBezTo>
                    <a:pt x="4284975" y="4628373"/>
                    <a:pt x="4275184" y="4428417"/>
                    <a:pt x="4144848" y="4439731"/>
                  </a:cubicBezTo>
                  <a:close/>
                  <a:moveTo>
                    <a:pt x="4591233" y="5427499"/>
                  </a:moveTo>
                  <a:cubicBezTo>
                    <a:pt x="4461278" y="5416058"/>
                    <a:pt x="4451042" y="5616269"/>
                    <a:pt x="4582078" y="5617476"/>
                  </a:cubicBezTo>
                  <a:cubicBezTo>
                    <a:pt x="4700524" y="5617858"/>
                    <a:pt x="4709235" y="5439067"/>
                    <a:pt x="4591233" y="5427499"/>
                  </a:cubicBezTo>
                  <a:close/>
                  <a:moveTo>
                    <a:pt x="4806955" y="4171957"/>
                  </a:moveTo>
                  <a:cubicBezTo>
                    <a:pt x="4676746" y="4160580"/>
                    <a:pt x="4667082" y="4360600"/>
                    <a:pt x="4797609" y="4362189"/>
                  </a:cubicBezTo>
                  <a:cubicBezTo>
                    <a:pt x="4916373" y="4362189"/>
                    <a:pt x="4925401" y="4183589"/>
                    <a:pt x="4806955" y="4171957"/>
                  </a:cubicBezTo>
                  <a:close/>
                  <a:moveTo>
                    <a:pt x="3486302" y="1201216"/>
                  </a:moveTo>
                  <a:cubicBezTo>
                    <a:pt x="3605003" y="1201216"/>
                    <a:pt x="3613841" y="1022616"/>
                    <a:pt x="3495648" y="1010985"/>
                  </a:cubicBezTo>
                  <a:cubicBezTo>
                    <a:pt x="3365439" y="999608"/>
                    <a:pt x="3355585" y="1199627"/>
                    <a:pt x="3486302" y="1201216"/>
                  </a:cubicBezTo>
                  <a:close/>
                  <a:moveTo>
                    <a:pt x="2813387" y="534738"/>
                  </a:moveTo>
                  <a:cubicBezTo>
                    <a:pt x="2695259" y="546370"/>
                    <a:pt x="2704032" y="724906"/>
                    <a:pt x="2822734" y="724970"/>
                  </a:cubicBezTo>
                  <a:cubicBezTo>
                    <a:pt x="2953451" y="723445"/>
                    <a:pt x="2943660" y="523425"/>
                    <a:pt x="2813387" y="534738"/>
                  </a:cubicBezTo>
                  <a:close/>
                  <a:moveTo>
                    <a:pt x="3045640" y="3211646"/>
                  </a:moveTo>
                  <a:cubicBezTo>
                    <a:pt x="2927447" y="3223278"/>
                    <a:pt x="2936285" y="3401878"/>
                    <a:pt x="3055049" y="3401878"/>
                  </a:cubicBezTo>
                  <a:cubicBezTo>
                    <a:pt x="3185767" y="3400289"/>
                    <a:pt x="3175848" y="3200333"/>
                    <a:pt x="3045640" y="3211646"/>
                  </a:cubicBezTo>
                  <a:close/>
                  <a:moveTo>
                    <a:pt x="3521080" y="4894812"/>
                  </a:moveTo>
                  <a:cubicBezTo>
                    <a:pt x="3390871" y="4883499"/>
                    <a:pt x="3381207" y="5083518"/>
                    <a:pt x="3511734" y="5085044"/>
                  </a:cubicBezTo>
                  <a:cubicBezTo>
                    <a:pt x="3630498" y="5085044"/>
                    <a:pt x="3639272" y="4906507"/>
                    <a:pt x="3521080" y="4894812"/>
                  </a:cubicBezTo>
                  <a:close/>
                  <a:moveTo>
                    <a:pt x="3706220" y="5642900"/>
                  </a:moveTo>
                  <a:cubicBezTo>
                    <a:pt x="3581606" y="5643599"/>
                    <a:pt x="3581606" y="5832877"/>
                    <a:pt x="3706220" y="5833576"/>
                  </a:cubicBezTo>
                  <a:cubicBezTo>
                    <a:pt x="3830834" y="5832941"/>
                    <a:pt x="3830897" y="5643662"/>
                    <a:pt x="3706220" y="5642900"/>
                  </a:cubicBezTo>
                  <a:close/>
                  <a:moveTo>
                    <a:pt x="2673642" y="3056499"/>
                  </a:moveTo>
                  <a:cubicBezTo>
                    <a:pt x="2555513" y="3068131"/>
                    <a:pt x="2564351" y="3246731"/>
                    <a:pt x="2683051" y="3246731"/>
                  </a:cubicBezTo>
                  <a:cubicBezTo>
                    <a:pt x="2813769" y="3245206"/>
                    <a:pt x="2803914" y="3045186"/>
                    <a:pt x="2673642" y="3056499"/>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52" name="Google Shape;52;p7"/>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53" name="Google Shape;53;p7"/>
          <p:cNvSpPr txBox="1">
            <a:spLocks noGrp="1"/>
          </p:cNvSpPr>
          <p:nvPr>
            <p:ph type="body" idx="1"/>
          </p:nvPr>
        </p:nvSpPr>
        <p:spPr>
          <a:xfrm>
            <a:off x="855300" y="1430150"/>
            <a:ext cx="2315700" cy="3319800"/>
          </a:xfrm>
          <a:prstGeom prst="rect">
            <a:avLst/>
          </a:prstGeom>
        </p:spPr>
        <p:txBody>
          <a:bodyPr spcFirstLastPara="1" wrap="square" lIns="0" tIns="0" rIns="0" bIns="0" anchor="t" anchorCtr="0">
            <a:noAutofit/>
          </a:bodyPr>
          <a:lstStyle>
            <a:lvl1pPr marL="457200" lvl="0" indent="-342900" rtl="0">
              <a:spcBef>
                <a:spcPts val="0"/>
              </a:spcBef>
              <a:spcAft>
                <a:spcPts val="0"/>
              </a:spcAft>
              <a:buSzPts val="1800"/>
              <a:buChar char="●"/>
              <a:defRPr sz="1800"/>
            </a:lvl1pPr>
            <a:lvl2pPr marL="914400" lvl="1" indent="-342900" rtl="0">
              <a:spcBef>
                <a:spcPts val="600"/>
              </a:spcBef>
              <a:spcAft>
                <a:spcPts val="0"/>
              </a:spcAft>
              <a:buSzPts val="1800"/>
              <a:buChar char="○"/>
              <a:defRPr sz="1800"/>
            </a:lvl2pPr>
            <a:lvl3pPr marL="1371600" lvl="2" indent="-342900" rtl="0">
              <a:spcBef>
                <a:spcPts val="600"/>
              </a:spcBef>
              <a:spcAft>
                <a:spcPts val="0"/>
              </a:spcAft>
              <a:buSzPts val="1800"/>
              <a:buChar char="■"/>
              <a:defRPr sz="1800"/>
            </a:lvl3pPr>
            <a:lvl4pPr marL="1828800" lvl="3" indent="-342900" rtl="0">
              <a:spcBef>
                <a:spcPts val="600"/>
              </a:spcBef>
              <a:spcAft>
                <a:spcPts val="0"/>
              </a:spcAft>
              <a:buSzPts val="1800"/>
              <a:buChar char="●"/>
              <a:defRPr sz="1800"/>
            </a:lvl4pPr>
            <a:lvl5pPr marL="2286000" lvl="4" indent="-342900" rtl="0">
              <a:spcBef>
                <a:spcPts val="600"/>
              </a:spcBef>
              <a:spcAft>
                <a:spcPts val="0"/>
              </a:spcAft>
              <a:buSzPts val="1800"/>
              <a:buChar char="○"/>
              <a:defRPr sz="1800"/>
            </a:lvl5pPr>
            <a:lvl6pPr marL="2743200" lvl="5" indent="-342900" rtl="0">
              <a:spcBef>
                <a:spcPts val="600"/>
              </a:spcBef>
              <a:spcAft>
                <a:spcPts val="0"/>
              </a:spcAft>
              <a:buSzPts val="1800"/>
              <a:buChar char="■"/>
              <a:defRPr sz="1800"/>
            </a:lvl6pPr>
            <a:lvl7pPr marL="3200400" lvl="6" indent="-342900" rtl="0">
              <a:spcBef>
                <a:spcPts val="600"/>
              </a:spcBef>
              <a:spcAft>
                <a:spcPts val="0"/>
              </a:spcAft>
              <a:buSzPts val="1800"/>
              <a:buChar char="●"/>
              <a:defRPr sz="1800"/>
            </a:lvl7pPr>
            <a:lvl8pPr marL="3657600" lvl="7" indent="-342900" rtl="0">
              <a:spcBef>
                <a:spcPts val="600"/>
              </a:spcBef>
              <a:spcAft>
                <a:spcPts val="0"/>
              </a:spcAft>
              <a:buSzPts val="1800"/>
              <a:buChar char="○"/>
              <a:defRPr sz="1800"/>
            </a:lvl8pPr>
            <a:lvl9pPr marL="4114800" lvl="8" indent="-342900" rtl="0">
              <a:spcBef>
                <a:spcPts val="600"/>
              </a:spcBef>
              <a:spcAft>
                <a:spcPts val="600"/>
              </a:spcAft>
              <a:buSzPts val="1800"/>
              <a:buChar char="■"/>
              <a:defRPr sz="1800"/>
            </a:lvl9pPr>
          </a:lstStyle>
          <a:p>
            <a:endParaRPr/>
          </a:p>
        </p:txBody>
      </p:sp>
      <p:sp>
        <p:nvSpPr>
          <p:cNvPr id="54" name="Google Shape;54;p7"/>
          <p:cNvSpPr txBox="1">
            <a:spLocks noGrp="1"/>
          </p:cNvSpPr>
          <p:nvPr>
            <p:ph type="body" idx="2"/>
          </p:nvPr>
        </p:nvSpPr>
        <p:spPr>
          <a:xfrm>
            <a:off x="3414211" y="1430150"/>
            <a:ext cx="2315700" cy="3319800"/>
          </a:xfrm>
          <a:prstGeom prst="rect">
            <a:avLst/>
          </a:prstGeom>
        </p:spPr>
        <p:txBody>
          <a:bodyPr spcFirstLastPara="1" wrap="square" lIns="0" tIns="0" rIns="0" bIns="0" anchor="t" anchorCtr="0">
            <a:noAutofit/>
          </a:bodyPr>
          <a:lstStyle>
            <a:lvl1pPr marL="457200" lvl="0" indent="-342900" rtl="0">
              <a:spcBef>
                <a:spcPts val="0"/>
              </a:spcBef>
              <a:spcAft>
                <a:spcPts val="0"/>
              </a:spcAft>
              <a:buSzPts val="1800"/>
              <a:buChar char="●"/>
              <a:defRPr sz="1800"/>
            </a:lvl1pPr>
            <a:lvl2pPr marL="914400" lvl="1" indent="-342900" rtl="0">
              <a:spcBef>
                <a:spcPts val="600"/>
              </a:spcBef>
              <a:spcAft>
                <a:spcPts val="0"/>
              </a:spcAft>
              <a:buSzPts val="1800"/>
              <a:buChar char="○"/>
              <a:defRPr sz="1800"/>
            </a:lvl2pPr>
            <a:lvl3pPr marL="1371600" lvl="2" indent="-342900" rtl="0">
              <a:spcBef>
                <a:spcPts val="600"/>
              </a:spcBef>
              <a:spcAft>
                <a:spcPts val="0"/>
              </a:spcAft>
              <a:buSzPts val="1800"/>
              <a:buChar char="■"/>
              <a:defRPr sz="1800"/>
            </a:lvl3pPr>
            <a:lvl4pPr marL="1828800" lvl="3" indent="-342900" rtl="0">
              <a:spcBef>
                <a:spcPts val="600"/>
              </a:spcBef>
              <a:spcAft>
                <a:spcPts val="0"/>
              </a:spcAft>
              <a:buSzPts val="1800"/>
              <a:buChar char="●"/>
              <a:defRPr sz="1800"/>
            </a:lvl4pPr>
            <a:lvl5pPr marL="2286000" lvl="4" indent="-342900" rtl="0">
              <a:spcBef>
                <a:spcPts val="600"/>
              </a:spcBef>
              <a:spcAft>
                <a:spcPts val="0"/>
              </a:spcAft>
              <a:buSzPts val="1800"/>
              <a:buChar char="○"/>
              <a:defRPr sz="1800"/>
            </a:lvl5pPr>
            <a:lvl6pPr marL="2743200" lvl="5" indent="-342900" rtl="0">
              <a:spcBef>
                <a:spcPts val="600"/>
              </a:spcBef>
              <a:spcAft>
                <a:spcPts val="0"/>
              </a:spcAft>
              <a:buSzPts val="1800"/>
              <a:buChar char="■"/>
              <a:defRPr sz="1800"/>
            </a:lvl6pPr>
            <a:lvl7pPr marL="3200400" lvl="6" indent="-342900" rtl="0">
              <a:spcBef>
                <a:spcPts val="600"/>
              </a:spcBef>
              <a:spcAft>
                <a:spcPts val="0"/>
              </a:spcAft>
              <a:buSzPts val="1800"/>
              <a:buChar char="●"/>
              <a:defRPr sz="1800"/>
            </a:lvl7pPr>
            <a:lvl8pPr marL="3657600" lvl="7" indent="-342900" rtl="0">
              <a:spcBef>
                <a:spcPts val="600"/>
              </a:spcBef>
              <a:spcAft>
                <a:spcPts val="0"/>
              </a:spcAft>
              <a:buSzPts val="1800"/>
              <a:buChar char="○"/>
              <a:defRPr sz="1800"/>
            </a:lvl8pPr>
            <a:lvl9pPr marL="4114800" lvl="8" indent="-342900" rtl="0">
              <a:spcBef>
                <a:spcPts val="600"/>
              </a:spcBef>
              <a:spcAft>
                <a:spcPts val="600"/>
              </a:spcAft>
              <a:buSzPts val="1800"/>
              <a:buChar char="■"/>
              <a:defRPr sz="1800"/>
            </a:lvl9pPr>
          </a:lstStyle>
          <a:p>
            <a:endParaRPr/>
          </a:p>
        </p:txBody>
      </p:sp>
      <p:sp>
        <p:nvSpPr>
          <p:cNvPr id="55" name="Google Shape;55;p7"/>
          <p:cNvSpPr txBox="1">
            <a:spLocks noGrp="1"/>
          </p:cNvSpPr>
          <p:nvPr>
            <p:ph type="body" idx="3"/>
          </p:nvPr>
        </p:nvSpPr>
        <p:spPr>
          <a:xfrm>
            <a:off x="5973122" y="1430150"/>
            <a:ext cx="2315700" cy="3319800"/>
          </a:xfrm>
          <a:prstGeom prst="rect">
            <a:avLst/>
          </a:prstGeom>
        </p:spPr>
        <p:txBody>
          <a:bodyPr spcFirstLastPara="1" wrap="square" lIns="0" tIns="0" rIns="0" bIns="0" anchor="t" anchorCtr="0">
            <a:noAutofit/>
          </a:bodyPr>
          <a:lstStyle>
            <a:lvl1pPr marL="457200" lvl="0" indent="-342900" rtl="0">
              <a:spcBef>
                <a:spcPts val="0"/>
              </a:spcBef>
              <a:spcAft>
                <a:spcPts val="0"/>
              </a:spcAft>
              <a:buSzPts val="1800"/>
              <a:buChar char="●"/>
              <a:defRPr sz="1800"/>
            </a:lvl1pPr>
            <a:lvl2pPr marL="914400" lvl="1" indent="-342900" rtl="0">
              <a:spcBef>
                <a:spcPts val="600"/>
              </a:spcBef>
              <a:spcAft>
                <a:spcPts val="0"/>
              </a:spcAft>
              <a:buSzPts val="1800"/>
              <a:buChar char="○"/>
              <a:defRPr sz="1800"/>
            </a:lvl2pPr>
            <a:lvl3pPr marL="1371600" lvl="2" indent="-342900" rtl="0">
              <a:spcBef>
                <a:spcPts val="600"/>
              </a:spcBef>
              <a:spcAft>
                <a:spcPts val="0"/>
              </a:spcAft>
              <a:buSzPts val="1800"/>
              <a:buChar char="■"/>
              <a:defRPr sz="1800"/>
            </a:lvl3pPr>
            <a:lvl4pPr marL="1828800" lvl="3" indent="-342900" rtl="0">
              <a:spcBef>
                <a:spcPts val="600"/>
              </a:spcBef>
              <a:spcAft>
                <a:spcPts val="0"/>
              </a:spcAft>
              <a:buSzPts val="1800"/>
              <a:buChar char="●"/>
              <a:defRPr sz="1800"/>
            </a:lvl4pPr>
            <a:lvl5pPr marL="2286000" lvl="4" indent="-342900" rtl="0">
              <a:spcBef>
                <a:spcPts val="600"/>
              </a:spcBef>
              <a:spcAft>
                <a:spcPts val="0"/>
              </a:spcAft>
              <a:buSzPts val="1800"/>
              <a:buChar char="○"/>
              <a:defRPr sz="1800"/>
            </a:lvl5pPr>
            <a:lvl6pPr marL="2743200" lvl="5" indent="-342900" rtl="0">
              <a:spcBef>
                <a:spcPts val="600"/>
              </a:spcBef>
              <a:spcAft>
                <a:spcPts val="0"/>
              </a:spcAft>
              <a:buSzPts val="1800"/>
              <a:buChar char="■"/>
              <a:defRPr sz="1800"/>
            </a:lvl6pPr>
            <a:lvl7pPr marL="3200400" lvl="6" indent="-342900" rtl="0">
              <a:spcBef>
                <a:spcPts val="600"/>
              </a:spcBef>
              <a:spcAft>
                <a:spcPts val="0"/>
              </a:spcAft>
              <a:buSzPts val="1800"/>
              <a:buChar char="●"/>
              <a:defRPr sz="1800"/>
            </a:lvl7pPr>
            <a:lvl8pPr marL="3657600" lvl="7" indent="-342900" rtl="0">
              <a:spcBef>
                <a:spcPts val="600"/>
              </a:spcBef>
              <a:spcAft>
                <a:spcPts val="0"/>
              </a:spcAft>
              <a:buSzPts val="1800"/>
              <a:buChar char="○"/>
              <a:defRPr sz="1800"/>
            </a:lvl8pPr>
            <a:lvl9pPr marL="4114800" lvl="8" indent="-342900" rtl="0">
              <a:spcBef>
                <a:spcPts val="600"/>
              </a:spcBef>
              <a:spcAft>
                <a:spcPts val="600"/>
              </a:spcAft>
              <a:buSzPts val="1800"/>
              <a:buChar char="■"/>
              <a:defRPr sz="1800"/>
            </a:lvl9pPr>
          </a:lstStyle>
          <a:p>
            <a:endParaRPr/>
          </a:p>
        </p:txBody>
      </p:sp>
      <p:sp>
        <p:nvSpPr>
          <p:cNvPr id="56" name="Google Shape;56;p7"/>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7"/>
        <p:cNvGrpSpPr/>
        <p:nvPr/>
      </p:nvGrpSpPr>
      <p:grpSpPr>
        <a:xfrm>
          <a:off x="0" y="0"/>
          <a:ext cx="0" cy="0"/>
          <a:chOff x="0" y="0"/>
          <a:chExt cx="0" cy="0"/>
        </a:xfrm>
      </p:grpSpPr>
      <p:grpSp>
        <p:nvGrpSpPr>
          <p:cNvPr id="58" name="Google Shape;58;p8"/>
          <p:cNvGrpSpPr/>
          <p:nvPr/>
        </p:nvGrpSpPr>
        <p:grpSpPr>
          <a:xfrm>
            <a:off x="5005048" y="0"/>
            <a:ext cx="4138960" cy="5143642"/>
            <a:chOff x="5005048" y="0"/>
            <a:chExt cx="4138960" cy="5143642"/>
          </a:xfrm>
        </p:grpSpPr>
        <p:sp>
          <p:nvSpPr>
            <p:cNvPr id="59" name="Google Shape;59;p8"/>
            <p:cNvSpPr/>
            <p:nvPr/>
          </p:nvSpPr>
          <p:spPr>
            <a:xfrm>
              <a:off x="5005049" y="0"/>
              <a:ext cx="4138960" cy="5143500"/>
            </a:xfrm>
            <a:custGeom>
              <a:avLst/>
              <a:gdLst/>
              <a:ahLst/>
              <a:cxnLst/>
              <a:rect l="l" t="t" r="r" b="b"/>
              <a:pathLst>
                <a:path w="5518613" h="6858000" extrusionOk="0">
                  <a:moveTo>
                    <a:pt x="4347879" y="6858000"/>
                  </a:moveTo>
                  <a:lnTo>
                    <a:pt x="4538614" y="6858000"/>
                  </a:lnTo>
                  <a:cubicBezTo>
                    <a:pt x="4551534" y="5930683"/>
                    <a:pt x="4899626" y="5039346"/>
                    <a:pt x="5518613" y="4348570"/>
                  </a:cubicBezTo>
                  <a:lnTo>
                    <a:pt x="5518613" y="4070500"/>
                  </a:lnTo>
                  <a:cubicBezTo>
                    <a:pt x="4781548" y="4812740"/>
                    <a:pt x="4361771" y="5812222"/>
                    <a:pt x="4347879" y="6858000"/>
                  </a:cubicBezTo>
                  <a:close/>
                  <a:moveTo>
                    <a:pt x="4301085" y="5188627"/>
                  </a:moveTo>
                  <a:cubicBezTo>
                    <a:pt x="4077511" y="5717157"/>
                    <a:pt x="3959147" y="6284191"/>
                    <a:pt x="3952611" y="6858000"/>
                  </a:cubicBezTo>
                  <a:lnTo>
                    <a:pt x="4143347" y="6858000"/>
                  </a:lnTo>
                  <a:cubicBezTo>
                    <a:pt x="4157130" y="5751110"/>
                    <a:pt x="4603757" y="4693586"/>
                    <a:pt x="5387642" y="3911730"/>
                  </a:cubicBezTo>
                  <a:cubicBezTo>
                    <a:pt x="5430449" y="3868935"/>
                    <a:pt x="5474000" y="3827197"/>
                    <a:pt x="5518295" y="3786519"/>
                  </a:cubicBezTo>
                  <a:lnTo>
                    <a:pt x="5518295" y="3532283"/>
                  </a:lnTo>
                  <a:cubicBezTo>
                    <a:pt x="5426952" y="3609615"/>
                    <a:pt x="5338451" y="3691136"/>
                    <a:pt x="5252792" y="3776858"/>
                  </a:cubicBezTo>
                  <a:cubicBezTo>
                    <a:pt x="4847103" y="4181397"/>
                    <a:pt x="4523877" y="4660866"/>
                    <a:pt x="4301085" y="5188627"/>
                  </a:cubicBezTo>
                  <a:close/>
                  <a:moveTo>
                    <a:pt x="4742956" y="6858000"/>
                  </a:moveTo>
                  <a:lnTo>
                    <a:pt x="4933691" y="6858000"/>
                  </a:lnTo>
                  <a:cubicBezTo>
                    <a:pt x="4944296" y="6192253"/>
                    <a:pt x="5147442" y="5543813"/>
                    <a:pt x="5518613" y="4990959"/>
                  </a:cubicBezTo>
                  <a:lnTo>
                    <a:pt x="5518613" y="4666809"/>
                  </a:lnTo>
                  <a:cubicBezTo>
                    <a:pt x="5027419" y="5292807"/>
                    <a:pt x="4754965" y="6062479"/>
                    <a:pt x="4742956" y="6858000"/>
                  </a:cubicBezTo>
                  <a:close/>
                  <a:moveTo>
                    <a:pt x="3936844" y="5034751"/>
                  </a:moveTo>
                  <a:cubicBezTo>
                    <a:pt x="3692690" y="5611967"/>
                    <a:pt x="3563753" y="6231329"/>
                    <a:pt x="3557280" y="6858000"/>
                  </a:cubicBezTo>
                  <a:lnTo>
                    <a:pt x="3748016" y="6858000"/>
                  </a:lnTo>
                  <a:cubicBezTo>
                    <a:pt x="3761742" y="5646276"/>
                    <a:pt x="4250019" y="4488202"/>
                    <a:pt x="5108087" y="3632261"/>
                  </a:cubicBezTo>
                  <a:cubicBezTo>
                    <a:pt x="5237705" y="3502760"/>
                    <a:pt x="5374780" y="3380944"/>
                    <a:pt x="5518613" y="3267434"/>
                  </a:cubicBezTo>
                  <a:lnTo>
                    <a:pt x="5518613" y="3027435"/>
                  </a:lnTo>
                  <a:cubicBezTo>
                    <a:pt x="4821685" y="3543508"/>
                    <a:pt x="4275552" y="4236573"/>
                    <a:pt x="3936844" y="5034751"/>
                  </a:cubicBezTo>
                  <a:close/>
                  <a:moveTo>
                    <a:pt x="1590798" y="2330830"/>
                  </a:moveTo>
                  <a:cubicBezTo>
                    <a:pt x="2180774" y="1457646"/>
                    <a:pt x="2932850" y="705739"/>
                    <a:pt x="3806254" y="115868"/>
                  </a:cubicBezTo>
                  <a:cubicBezTo>
                    <a:pt x="3864619" y="76504"/>
                    <a:pt x="3923511" y="37881"/>
                    <a:pt x="3982938" y="0"/>
                  </a:cubicBezTo>
                  <a:lnTo>
                    <a:pt x="3637961" y="0"/>
                  </a:lnTo>
                  <a:cubicBezTo>
                    <a:pt x="2317309" y="907938"/>
                    <a:pt x="1283739" y="2174291"/>
                    <a:pt x="658991" y="3649867"/>
                  </a:cubicBezTo>
                  <a:cubicBezTo>
                    <a:pt x="229264" y="4666364"/>
                    <a:pt x="7820" y="5745720"/>
                    <a:pt x="0" y="6858000"/>
                  </a:cubicBezTo>
                  <a:lnTo>
                    <a:pt x="190735" y="6858000"/>
                  </a:lnTo>
                  <a:cubicBezTo>
                    <a:pt x="198492" y="5771144"/>
                    <a:pt x="414913" y="4716957"/>
                    <a:pt x="834595" y="3724104"/>
                  </a:cubicBezTo>
                  <a:cubicBezTo>
                    <a:pt x="1041009" y="3236353"/>
                    <a:pt x="1294217" y="2769749"/>
                    <a:pt x="1590670" y="2330830"/>
                  </a:cubicBezTo>
                  <a:close/>
                  <a:moveTo>
                    <a:pt x="5138478" y="6858000"/>
                  </a:moveTo>
                  <a:lnTo>
                    <a:pt x="5329213" y="6858000"/>
                  </a:lnTo>
                  <a:cubicBezTo>
                    <a:pt x="5335393" y="6514973"/>
                    <a:pt x="5399423" y="6175480"/>
                    <a:pt x="5518613" y="5853770"/>
                  </a:cubicBezTo>
                  <a:lnTo>
                    <a:pt x="5518613" y="5388583"/>
                  </a:lnTo>
                  <a:cubicBezTo>
                    <a:pt x="5473428" y="5473625"/>
                    <a:pt x="5431892" y="5560847"/>
                    <a:pt x="5394000" y="5650255"/>
                  </a:cubicBezTo>
                  <a:cubicBezTo>
                    <a:pt x="5232135" y="6032727"/>
                    <a:pt x="5145382" y="6442770"/>
                    <a:pt x="5138478" y="6858000"/>
                  </a:cubicBezTo>
                  <a:close/>
                  <a:moveTo>
                    <a:pt x="1918417" y="2551824"/>
                  </a:moveTo>
                  <a:cubicBezTo>
                    <a:pt x="2643092" y="1478290"/>
                    <a:pt x="3623084" y="601442"/>
                    <a:pt x="4770422" y="0"/>
                  </a:cubicBezTo>
                  <a:lnTo>
                    <a:pt x="4376235" y="0"/>
                  </a:lnTo>
                  <a:cubicBezTo>
                    <a:pt x="4221103" y="90127"/>
                    <a:pt x="4069195" y="185317"/>
                    <a:pt x="3920504" y="285570"/>
                  </a:cubicBezTo>
                  <a:cubicBezTo>
                    <a:pt x="2634426" y="1153193"/>
                    <a:pt x="1627921" y="2375366"/>
                    <a:pt x="1023169" y="3803743"/>
                  </a:cubicBezTo>
                  <a:cubicBezTo>
                    <a:pt x="614105" y="4771490"/>
                    <a:pt x="403024" y="5798792"/>
                    <a:pt x="395331" y="6858000"/>
                  </a:cubicBezTo>
                  <a:lnTo>
                    <a:pt x="586067" y="6858000"/>
                  </a:lnTo>
                  <a:cubicBezTo>
                    <a:pt x="593760" y="5824406"/>
                    <a:pt x="799754" y="4822147"/>
                    <a:pt x="1198836" y="3877980"/>
                  </a:cubicBezTo>
                  <a:cubicBezTo>
                    <a:pt x="1395332" y="3413753"/>
                    <a:pt x="1636313" y="2969629"/>
                    <a:pt x="1918417" y="2551824"/>
                  </a:cubicBezTo>
                  <a:close/>
                  <a:moveTo>
                    <a:pt x="3295909" y="1820898"/>
                  </a:moveTo>
                  <a:cubicBezTo>
                    <a:pt x="2638349" y="2477855"/>
                    <a:pt x="2113960" y="3255643"/>
                    <a:pt x="1751587" y="4111495"/>
                  </a:cubicBezTo>
                  <a:cubicBezTo>
                    <a:pt x="1383722" y="4981807"/>
                    <a:pt x="1193495" y="5905571"/>
                    <a:pt x="1185739" y="6858000"/>
                  </a:cubicBezTo>
                  <a:lnTo>
                    <a:pt x="1376474" y="6858000"/>
                  </a:lnTo>
                  <a:cubicBezTo>
                    <a:pt x="1384167" y="5931185"/>
                    <a:pt x="1569308" y="5032463"/>
                    <a:pt x="1927255" y="4185732"/>
                  </a:cubicBezTo>
                  <a:cubicBezTo>
                    <a:pt x="2618518" y="2553159"/>
                    <a:pt x="3901291" y="1241972"/>
                    <a:pt x="5518613" y="514827"/>
                  </a:cubicBezTo>
                  <a:lnTo>
                    <a:pt x="5518613" y="306544"/>
                  </a:lnTo>
                  <a:cubicBezTo>
                    <a:pt x="4689289" y="667432"/>
                    <a:pt x="3935274" y="1181063"/>
                    <a:pt x="3295909" y="1820643"/>
                  </a:cubicBezTo>
                  <a:close/>
                  <a:moveTo>
                    <a:pt x="3572666" y="4881129"/>
                  </a:moveTo>
                  <a:cubicBezTo>
                    <a:pt x="3307970" y="5506962"/>
                    <a:pt x="3168460" y="6178556"/>
                    <a:pt x="3162013" y="6858000"/>
                  </a:cubicBezTo>
                  <a:lnTo>
                    <a:pt x="3352748" y="6858000"/>
                  </a:lnTo>
                  <a:cubicBezTo>
                    <a:pt x="3372565" y="5227315"/>
                    <a:pt x="4179313" y="3706695"/>
                    <a:pt x="5518613" y="2775615"/>
                  </a:cubicBezTo>
                  <a:lnTo>
                    <a:pt x="5518613" y="2545341"/>
                  </a:lnTo>
                  <a:cubicBezTo>
                    <a:pt x="4654149" y="3115286"/>
                    <a:pt x="3977337" y="3927785"/>
                    <a:pt x="3573111" y="4880875"/>
                  </a:cubicBezTo>
                  <a:close/>
                  <a:moveTo>
                    <a:pt x="5235308" y="0"/>
                  </a:moveTo>
                  <a:cubicBezTo>
                    <a:pt x="3502800" y="791829"/>
                    <a:pt x="2129930" y="2203840"/>
                    <a:pt x="1387410" y="3957619"/>
                  </a:cubicBezTo>
                  <a:cubicBezTo>
                    <a:pt x="998882" y="4876680"/>
                    <a:pt x="798292" y="5852181"/>
                    <a:pt x="790535" y="6858000"/>
                  </a:cubicBezTo>
                  <a:lnTo>
                    <a:pt x="981270" y="6858000"/>
                  </a:lnTo>
                  <a:cubicBezTo>
                    <a:pt x="989027" y="5877796"/>
                    <a:pt x="1184722" y="4927273"/>
                    <a:pt x="1563077" y="4031856"/>
                  </a:cubicBezTo>
                  <a:cubicBezTo>
                    <a:pt x="2315465" y="2254877"/>
                    <a:pt x="3730277" y="840502"/>
                    <a:pt x="5507805" y="88347"/>
                  </a:cubicBezTo>
                  <a:lnTo>
                    <a:pt x="5518295" y="83961"/>
                  </a:lnTo>
                  <a:lnTo>
                    <a:pt x="5518295" y="0"/>
                  </a:lnTo>
                  <a:close/>
                  <a:moveTo>
                    <a:pt x="2115829" y="4265371"/>
                  </a:moveTo>
                  <a:cubicBezTo>
                    <a:pt x="1768499" y="5086996"/>
                    <a:pt x="1588763" y="5958960"/>
                    <a:pt x="1581070" y="6858000"/>
                  </a:cubicBezTo>
                  <a:lnTo>
                    <a:pt x="1771805" y="6858000"/>
                  </a:lnTo>
                  <a:cubicBezTo>
                    <a:pt x="1779499" y="5984575"/>
                    <a:pt x="1954148" y="5137589"/>
                    <a:pt x="2291496" y="4339608"/>
                  </a:cubicBezTo>
                  <a:cubicBezTo>
                    <a:pt x="2920256" y="2855992"/>
                    <a:pt x="4067231" y="1651564"/>
                    <a:pt x="5518613" y="950841"/>
                  </a:cubicBezTo>
                  <a:lnTo>
                    <a:pt x="5518613" y="739889"/>
                  </a:lnTo>
                  <a:cubicBezTo>
                    <a:pt x="3987230" y="1453890"/>
                    <a:pt x="2774896" y="2709940"/>
                    <a:pt x="2115829" y="4265371"/>
                  </a:cubicBezTo>
                  <a:close/>
                  <a:moveTo>
                    <a:pt x="3208425" y="4726999"/>
                  </a:moveTo>
                  <a:cubicBezTo>
                    <a:pt x="2923104" y="5401587"/>
                    <a:pt x="2773059" y="6125618"/>
                    <a:pt x="2766809" y="6858000"/>
                  </a:cubicBezTo>
                  <a:lnTo>
                    <a:pt x="2957544" y="6858000"/>
                  </a:lnTo>
                  <a:cubicBezTo>
                    <a:pt x="2978335" y="5002228"/>
                    <a:pt x="3943723" y="3284988"/>
                    <a:pt x="5518613" y="2302356"/>
                  </a:cubicBezTo>
                  <a:lnTo>
                    <a:pt x="5518613" y="2079201"/>
                  </a:lnTo>
                  <a:cubicBezTo>
                    <a:pt x="4486524" y="2693796"/>
                    <a:pt x="3677291" y="3621298"/>
                    <a:pt x="3208425" y="4726999"/>
                  </a:cubicBezTo>
                  <a:close/>
                  <a:moveTo>
                    <a:pt x="2844247" y="4573123"/>
                  </a:moveTo>
                  <a:cubicBezTo>
                    <a:pt x="2538117" y="5297313"/>
                    <a:pt x="2379234" y="6065676"/>
                    <a:pt x="2371478" y="6858000"/>
                  </a:cubicBezTo>
                  <a:lnTo>
                    <a:pt x="2562213" y="6858000"/>
                  </a:lnTo>
                  <a:cubicBezTo>
                    <a:pt x="2569906" y="6091353"/>
                    <a:pt x="2723703" y="5347905"/>
                    <a:pt x="3019978" y="4647360"/>
                  </a:cubicBezTo>
                  <a:cubicBezTo>
                    <a:pt x="3521924" y="3463366"/>
                    <a:pt x="4400064" y="2477658"/>
                    <a:pt x="5518613" y="1842635"/>
                  </a:cubicBezTo>
                  <a:lnTo>
                    <a:pt x="5518613" y="1624564"/>
                  </a:lnTo>
                  <a:cubicBezTo>
                    <a:pt x="4319580" y="2277199"/>
                    <a:pt x="3376933" y="3316482"/>
                    <a:pt x="2844247" y="4573123"/>
                  </a:cubicBezTo>
                  <a:close/>
                  <a:moveTo>
                    <a:pt x="2480006" y="4419247"/>
                  </a:moveTo>
                  <a:cubicBezTo>
                    <a:pt x="2153276" y="5192123"/>
                    <a:pt x="1984094" y="6012350"/>
                    <a:pt x="1976274" y="6858000"/>
                  </a:cubicBezTo>
                  <a:lnTo>
                    <a:pt x="2167009" y="6858000"/>
                  </a:lnTo>
                  <a:cubicBezTo>
                    <a:pt x="2174702" y="6038091"/>
                    <a:pt x="2338989" y="5242779"/>
                    <a:pt x="2655737" y="4493611"/>
                  </a:cubicBezTo>
                  <a:cubicBezTo>
                    <a:pt x="3221262" y="3159288"/>
                    <a:pt x="4233361" y="2063108"/>
                    <a:pt x="5518613" y="1392892"/>
                  </a:cubicBezTo>
                  <a:lnTo>
                    <a:pt x="5518613" y="1178826"/>
                  </a:lnTo>
                  <a:cubicBezTo>
                    <a:pt x="4153132" y="1864200"/>
                    <a:pt x="3076061" y="3012811"/>
                    <a:pt x="2480006" y="441924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60" name="Google Shape;60;p8"/>
            <p:cNvSpPr/>
            <p:nvPr/>
          </p:nvSpPr>
          <p:spPr>
            <a:xfrm>
              <a:off x="5005048" y="0"/>
              <a:ext cx="4138960" cy="5143642"/>
            </a:xfrm>
            <a:custGeom>
              <a:avLst/>
              <a:gdLst/>
              <a:ahLst/>
              <a:cxnLst/>
              <a:rect l="l" t="t" r="r" b="b"/>
              <a:pathLst>
                <a:path w="5518613" h="6858190" extrusionOk="0">
                  <a:moveTo>
                    <a:pt x="2240760" y="4214715"/>
                  </a:moveTo>
                  <a:cubicBezTo>
                    <a:pt x="2192225" y="4194261"/>
                    <a:pt x="2136295" y="4217016"/>
                    <a:pt x="2115841" y="4265537"/>
                  </a:cubicBezTo>
                  <a:cubicBezTo>
                    <a:pt x="2115835" y="4265543"/>
                    <a:pt x="2115835" y="4265556"/>
                    <a:pt x="2115829" y="4265562"/>
                  </a:cubicBezTo>
                  <a:cubicBezTo>
                    <a:pt x="1768499" y="5087187"/>
                    <a:pt x="1588763" y="5959151"/>
                    <a:pt x="1581070" y="6858191"/>
                  </a:cubicBezTo>
                  <a:lnTo>
                    <a:pt x="1771805" y="6858191"/>
                  </a:lnTo>
                  <a:cubicBezTo>
                    <a:pt x="1779499" y="5984765"/>
                    <a:pt x="1954148" y="5137780"/>
                    <a:pt x="2291496" y="4339799"/>
                  </a:cubicBezTo>
                  <a:cubicBezTo>
                    <a:pt x="2312070" y="4291329"/>
                    <a:pt x="2289436" y="4235359"/>
                    <a:pt x="2240951" y="4214797"/>
                  </a:cubicBezTo>
                  <a:cubicBezTo>
                    <a:pt x="2240888" y="4214766"/>
                    <a:pt x="2240824" y="4214740"/>
                    <a:pt x="2240760" y="4214715"/>
                  </a:cubicBezTo>
                  <a:close/>
                  <a:moveTo>
                    <a:pt x="2250170" y="2598095"/>
                  </a:moveTo>
                  <a:cubicBezTo>
                    <a:pt x="2206714" y="2568350"/>
                    <a:pt x="2147370" y="2579447"/>
                    <a:pt x="2117609" y="2622883"/>
                  </a:cubicBezTo>
                  <a:cubicBezTo>
                    <a:pt x="1637146" y="3322742"/>
                    <a:pt x="1278195" y="4098599"/>
                    <a:pt x="1055848" y="4917803"/>
                  </a:cubicBezTo>
                  <a:cubicBezTo>
                    <a:pt x="1040138" y="4968059"/>
                    <a:pt x="1068151" y="5021531"/>
                    <a:pt x="1118422" y="5037242"/>
                  </a:cubicBezTo>
                  <a:cubicBezTo>
                    <a:pt x="1168694" y="5052948"/>
                    <a:pt x="1222182" y="5024944"/>
                    <a:pt x="1237899" y="4974688"/>
                  </a:cubicBezTo>
                  <a:cubicBezTo>
                    <a:pt x="1238611" y="4972400"/>
                    <a:pt x="1239240" y="4970093"/>
                    <a:pt x="1239781" y="4967760"/>
                  </a:cubicBezTo>
                  <a:cubicBezTo>
                    <a:pt x="1456596" y="4169149"/>
                    <a:pt x="1806538" y="3412786"/>
                    <a:pt x="2274902" y="2730488"/>
                  </a:cubicBezTo>
                  <a:cubicBezTo>
                    <a:pt x="2304581" y="2687090"/>
                    <a:pt x="2293518" y="2627860"/>
                    <a:pt x="2250170" y="2598095"/>
                  </a:cubicBezTo>
                  <a:close/>
                  <a:moveTo>
                    <a:pt x="5289222" y="4471365"/>
                  </a:moveTo>
                  <a:cubicBezTo>
                    <a:pt x="5247089" y="4439770"/>
                    <a:pt x="5187312" y="4448313"/>
                    <a:pt x="5155707" y="4490433"/>
                  </a:cubicBezTo>
                  <a:cubicBezTo>
                    <a:pt x="4642139" y="5174034"/>
                    <a:pt x="4359361" y="6003210"/>
                    <a:pt x="4348260" y="6858064"/>
                  </a:cubicBezTo>
                  <a:lnTo>
                    <a:pt x="4538996" y="6858064"/>
                  </a:lnTo>
                  <a:cubicBezTo>
                    <a:pt x="4550065" y="6044479"/>
                    <a:pt x="4819460" y="5255459"/>
                    <a:pt x="5308296" y="4604903"/>
                  </a:cubicBezTo>
                  <a:cubicBezTo>
                    <a:pt x="5339900" y="4562782"/>
                    <a:pt x="5331375" y="4503024"/>
                    <a:pt x="5289241" y="4471429"/>
                  </a:cubicBezTo>
                  <a:cubicBezTo>
                    <a:pt x="5289216" y="4471403"/>
                    <a:pt x="5289184" y="4471384"/>
                    <a:pt x="5289158" y="4471365"/>
                  </a:cubicBezTo>
                  <a:close/>
                  <a:moveTo>
                    <a:pt x="2682504" y="5323054"/>
                  </a:moveTo>
                  <a:cubicBezTo>
                    <a:pt x="2631558" y="5309764"/>
                    <a:pt x="2579475" y="5340266"/>
                    <a:pt x="2566155" y="5391189"/>
                  </a:cubicBezTo>
                  <a:cubicBezTo>
                    <a:pt x="2441510" y="5870327"/>
                    <a:pt x="2376125" y="6362940"/>
                    <a:pt x="2371478" y="6858000"/>
                  </a:cubicBezTo>
                  <a:lnTo>
                    <a:pt x="2562213" y="6858000"/>
                  </a:lnTo>
                  <a:cubicBezTo>
                    <a:pt x="2566810" y="6379148"/>
                    <a:pt x="2630122" y="5902679"/>
                    <a:pt x="2750724" y="5439240"/>
                  </a:cubicBezTo>
                  <a:cubicBezTo>
                    <a:pt x="2764018" y="5388310"/>
                    <a:pt x="2733513" y="5336243"/>
                    <a:pt x="2682567" y="5322927"/>
                  </a:cubicBezTo>
                  <a:close/>
                  <a:moveTo>
                    <a:pt x="4160068" y="5925910"/>
                  </a:moveTo>
                  <a:cubicBezTo>
                    <a:pt x="4108531" y="5915060"/>
                    <a:pt x="4057948" y="5948028"/>
                    <a:pt x="4047095" y="5999555"/>
                  </a:cubicBezTo>
                  <a:cubicBezTo>
                    <a:pt x="4047089" y="5999562"/>
                    <a:pt x="4047089" y="5999568"/>
                    <a:pt x="4047089" y="5999574"/>
                  </a:cubicBezTo>
                  <a:cubicBezTo>
                    <a:pt x="3988006" y="6282004"/>
                    <a:pt x="3956363" y="6569507"/>
                    <a:pt x="3952611" y="6858000"/>
                  </a:cubicBezTo>
                  <a:lnTo>
                    <a:pt x="4143347" y="6858000"/>
                  </a:lnTo>
                  <a:cubicBezTo>
                    <a:pt x="4147123" y="6582600"/>
                    <a:pt x="4177425" y="6308242"/>
                    <a:pt x="4233819" y="6038663"/>
                  </a:cubicBezTo>
                  <a:cubicBezTo>
                    <a:pt x="4244634" y="5987155"/>
                    <a:pt x="4211649" y="5936626"/>
                    <a:pt x="4160132" y="5925783"/>
                  </a:cubicBezTo>
                  <a:close/>
                  <a:moveTo>
                    <a:pt x="2089189" y="6428024"/>
                  </a:moveTo>
                  <a:cubicBezTo>
                    <a:pt x="2036629" y="6424783"/>
                    <a:pt x="1991399" y="6464762"/>
                    <a:pt x="1988163" y="6517325"/>
                  </a:cubicBezTo>
                  <a:cubicBezTo>
                    <a:pt x="1981233" y="6630015"/>
                    <a:pt x="1977228" y="6744293"/>
                    <a:pt x="1976147" y="6857937"/>
                  </a:cubicBezTo>
                  <a:lnTo>
                    <a:pt x="2166882" y="6857937"/>
                  </a:lnTo>
                  <a:cubicBezTo>
                    <a:pt x="2167900" y="6748170"/>
                    <a:pt x="2171778" y="6637832"/>
                    <a:pt x="2178454" y="6529020"/>
                  </a:cubicBezTo>
                  <a:cubicBezTo>
                    <a:pt x="2181645" y="6476520"/>
                    <a:pt x="2141737" y="6431393"/>
                    <a:pt x="2089253" y="6428088"/>
                  </a:cubicBezTo>
                  <a:close/>
                  <a:moveTo>
                    <a:pt x="3184583" y="972450"/>
                  </a:moveTo>
                  <a:cubicBezTo>
                    <a:pt x="3218833" y="1012264"/>
                    <a:pt x="3278838" y="1016897"/>
                    <a:pt x="3318797" y="982811"/>
                  </a:cubicBezTo>
                  <a:cubicBezTo>
                    <a:pt x="3763936" y="601738"/>
                    <a:pt x="4250629" y="272053"/>
                    <a:pt x="4769659" y="0"/>
                  </a:cubicBezTo>
                  <a:lnTo>
                    <a:pt x="4375472" y="0"/>
                  </a:lnTo>
                  <a:cubicBezTo>
                    <a:pt x="3957475" y="243105"/>
                    <a:pt x="3562373" y="523572"/>
                    <a:pt x="3195010" y="837960"/>
                  </a:cubicBezTo>
                  <a:cubicBezTo>
                    <a:pt x="3154981" y="872186"/>
                    <a:pt x="3150289" y="932364"/>
                    <a:pt x="3184526" y="972381"/>
                  </a:cubicBezTo>
                  <a:cubicBezTo>
                    <a:pt x="3184545" y="972406"/>
                    <a:pt x="3184564" y="972425"/>
                    <a:pt x="3184583" y="972450"/>
                  </a:cubicBezTo>
                  <a:close/>
                  <a:moveTo>
                    <a:pt x="3860550" y="1312617"/>
                  </a:moveTo>
                  <a:cubicBezTo>
                    <a:pt x="2823496" y="2150361"/>
                    <a:pt x="2039217" y="3259260"/>
                    <a:pt x="1594930" y="4515984"/>
                  </a:cubicBezTo>
                  <a:cubicBezTo>
                    <a:pt x="1577376" y="4565636"/>
                    <a:pt x="1603405" y="4620118"/>
                    <a:pt x="1653073" y="4637667"/>
                  </a:cubicBezTo>
                  <a:cubicBezTo>
                    <a:pt x="1702740" y="4655216"/>
                    <a:pt x="1757240" y="4629195"/>
                    <a:pt x="1774794" y="4579543"/>
                  </a:cubicBezTo>
                  <a:cubicBezTo>
                    <a:pt x="2207331" y="3355996"/>
                    <a:pt x="2970909" y="2276380"/>
                    <a:pt x="3980586" y="1460773"/>
                  </a:cubicBezTo>
                  <a:cubicBezTo>
                    <a:pt x="4021531" y="1427634"/>
                    <a:pt x="4027850" y="1367596"/>
                    <a:pt x="3994700" y="1326664"/>
                  </a:cubicBezTo>
                  <a:cubicBezTo>
                    <a:pt x="3961551" y="1285732"/>
                    <a:pt x="3901494" y="1279414"/>
                    <a:pt x="3860550" y="1312554"/>
                  </a:cubicBezTo>
                  <a:close/>
                  <a:moveTo>
                    <a:pt x="1208945" y="3617516"/>
                  </a:moveTo>
                  <a:cubicBezTo>
                    <a:pt x="1160835" y="3596077"/>
                    <a:pt x="1104454" y="3617687"/>
                    <a:pt x="1083015" y="3665782"/>
                  </a:cubicBezTo>
                  <a:cubicBezTo>
                    <a:pt x="1083009" y="3665795"/>
                    <a:pt x="1083002" y="3665808"/>
                    <a:pt x="1082996" y="3665820"/>
                  </a:cubicBezTo>
                  <a:cubicBezTo>
                    <a:pt x="859435" y="4168317"/>
                    <a:pt x="688555" y="4692614"/>
                    <a:pt x="573097" y="5230321"/>
                  </a:cubicBezTo>
                  <a:cubicBezTo>
                    <a:pt x="458636" y="5765430"/>
                    <a:pt x="398987" y="6310803"/>
                    <a:pt x="395077" y="6858000"/>
                  </a:cubicBezTo>
                  <a:lnTo>
                    <a:pt x="585812" y="6858000"/>
                  </a:lnTo>
                  <a:cubicBezTo>
                    <a:pt x="589655" y="6324252"/>
                    <a:pt x="647789" y="5792284"/>
                    <a:pt x="759318" y="5270300"/>
                  </a:cubicBezTo>
                  <a:cubicBezTo>
                    <a:pt x="872119" y="4745584"/>
                    <a:pt x="1038993" y="4233954"/>
                    <a:pt x="1257265" y="3743616"/>
                  </a:cubicBezTo>
                  <a:cubicBezTo>
                    <a:pt x="1278792" y="3695566"/>
                    <a:pt x="1257284" y="3639157"/>
                    <a:pt x="1209212" y="3617637"/>
                  </a:cubicBezTo>
                  <a:cubicBezTo>
                    <a:pt x="1209123" y="3617598"/>
                    <a:pt x="1209034" y="3617554"/>
                    <a:pt x="1208945" y="3617516"/>
                  </a:cubicBezTo>
                  <a:close/>
                  <a:moveTo>
                    <a:pt x="943632" y="5974532"/>
                  </a:moveTo>
                  <a:cubicBezTo>
                    <a:pt x="891294" y="5968659"/>
                    <a:pt x="844106" y="6006305"/>
                    <a:pt x="838219" y="6058620"/>
                  </a:cubicBezTo>
                  <a:cubicBezTo>
                    <a:pt x="808496" y="6324074"/>
                    <a:pt x="792557" y="6590926"/>
                    <a:pt x="790471" y="6858000"/>
                  </a:cubicBezTo>
                  <a:lnTo>
                    <a:pt x="981207" y="6858000"/>
                  </a:lnTo>
                  <a:cubicBezTo>
                    <a:pt x="983267" y="6597917"/>
                    <a:pt x="998799" y="6338127"/>
                    <a:pt x="1027746" y="6079658"/>
                  </a:cubicBezTo>
                  <a:cubicBezTo>
                    <a:pt x="1033475" y="6027432"/>
                    <a:pt x="995855" y="5980418"/>
                    <a:pt x="943632" y="5974532"/>
                  </a:cubicBezTo>
                  <a:close/>
                  <a:moveTo>
                    <a:pt x="2331805" y="1389587"/>
                  </a:moveTo>
                  <a:cubicBezTo>
                    <a:pt x="2707325" y="978292"/>
                    <a:pt x="3123535" y="606057"/>
                    <a:pt x="3574065" y="278578"/>
                  </a:cubicBezTo>
                  <a:cubicBezTo>
                    <a:pt x="3707535" y="181588"/>
                    <a:pt x="3843911" y="88728"/>
                    <a:pt x="3983193" y="0"/>
                  </a:cubicBezTo>
                  <a:lnTo>
                    <a:pt x="3637771" y="0"/>
                  </a:lnTo>
                  <a:cubicBezTo>
                    <a:pt x="3578433" y="40678"/>
                    <a:pt x="3519814" y="82118"/>
                    <a:pt x="3461913" y="124321"/>
                  </a:cubicBezTo>
                  <a:cubicBezTo>
                    <a:pt x="3000969" y="459401"/>
                    <a:pt x="2575133" y="840261"/>
                    <a:pt x="2190915" y="1261071"/>
                  </a:cubicBezTo>
                  <a:cubicBezTo>
                    <a:pt x="2155794" y="1300312"/>
                    <a:pt x="2159145" y="1360585"/>
                    <a:pt x="2198398" y="1395695"/>
                  </a:cubicBezTo>
                  <a:cubicBezTo>
                    <a:pt x="2237111" y="1430316"/>
                    <a:pt x="2296417" y="1427602"/>
                    <a:pt x="2331805" y="1389587"/>
                  </a:cubicBezTo>
                  <a:close/>
                  <a:moveTo>
                    <a:pt x="558283" y="4174100"/>
                  </a:moveTo>
                  <a:cubicBezTo>
                    <a:pt x="508369" y="4157308"/>
                    <a:pt x="454289" y="4184143"/>
                    <a:pt x="437484" y="4234036"/>
                  </a:cubicBezTo>
                  <a:cubicBezTo>
                    <a:pt x="152999" y="5079865"/>
                    <a:pt x="5315" y="5965653"/>
                    <a:pt x="0" y="6858000"/>
                  </a:cubicBezTo>
                  <a:lnTo>
                    <a:pt x="190735" y="6858000"/>
                  </a:lnTo>
                  <a:cubicBezTo>
                    <a:pt x="196021" y="5986354"/>
                    <a:pt x="340335" y="5121127"/>
                    <a:pt x="618237" y="4294926"/>
                  </a:cubicBezTo>
                  <a:cubicBezTo>
                    <a:pt x="635068" y="4245032"/>
                    <a:pt x="608253" y="4190944"/>
                    <a:pt x="558344" y="4174119"/>
                  </a:cubicBezTo>
                  <a:cubicBezTo>
                    <a:pt x="558323" y="4174113"/>
                    <a:pt x="558303" y="4174107"/>
                    <a:pt x="558283" y="4174100"/>
                  </a:cubicBezTo>
                  <a:close/>
                  <a:moveTo>
                    <a:pt x="3037844" y="3379615"/>
                  </a:moveTo>
                  <a:cubicBezTo>
                    <a:pt x="3010054" y="3424341"/>
                    <a:pt x="3023793" y="3483121"/>
                    <a:pt x="3068533" y="3510909"/>
                  </a:cubicBezTo>
                  <a:cubicBezTo>
                    <a:pt x="3111436" y="3537552"/>
                    <a:pt x="3167678" y="3526131"/>
                    <a:pt x="3196790" y="3484868"/>
                  </a:cubicBezTo>
                  <a:cubicBezTo>
                    <a:pt x="3756262" y="2640934"/>
                    <a:pt x="4511937" y="1945073"/>
                    <a:pt x="5399149" y="1456833"/>
                  </a:cubicBezTo>
                  <a:cubicBezTo>
                    <a:pt x="5438612" y="1435178"/>
                    <a:pt x="5478324" y="1413994"/>
                    <a:pt x="5518295" y="1393274"/>
                  </a:cubicBezTo>
                  <a:lnTo>
                    <a:pt x="5518295" y="1179080"/>
                  </a:lnTo>
                  <a:cubicBezTo>
                    <a:pt x="5447342" y="1214673"/>
                    <a:pt x="5377024" y="1251582"/>
                    <a:pt x="5307342" y="1289800"/>
                  </a:cubicBezTo>
                  <a:cubicBezTo>
                    <a:pt x="4393090" y="1792906"/>
                    <a:pt x="3614361" y="2509939"/>
                    <a:pt x="3037780" y="3379551"/>
                  </a:cubicBezTo>
                  <a:close/>
                  <a:moveTo>
                    <a:pt x="4015808" y="3381140"/>
                  </a:moveTo>
                  <a:cubicBezTo>
                    <a:pt x="3403115" y="4138641"/>
                    <a:pt x="2998006" y="5042404"/>
                    <a:pt x="2840242" y="6003706"/>
                  </a:cubicBezTo>
                  <a:cubicBezTo>
                    <a:pt x="2831761" y="6055671"/>
                    <a:pt x="2867028" y="6104675"/>
                    <a:pt x="2919009" y="6113154"/>
                  </a:cubicBezTo>
                  <a:cubicBezTo>
                    <a:pt x="2919009" y="6113154"/>
                    <a:pt x="2919016" y="6113154"/>
                    <a:pt x="2919016" y="6113154"/>
                  </a:cubicBezTo>
                  <a:cubicBezTo>
                    <a:pt x="2924121" y="6114012"/>
                    <a:pt x="2929290" y="6114438"/>
                    <a:pt x="2934465" y="6114425"/>
                  </a:cubicBezTo>
                  <a:cubicBezTo>
                    <a:pt x="2981183" y="6114381"/>
                    <a:pt x="3020989" y="6080504"/>
                    <a:pt x="3028498" y="6034405"/>
                  </a:cubicBezTo>
                  <a:cubicBezTo>
                    <a:pt x="3282755" y="4490388"/>
                    <a:pt x="4190147" y="3130744"/>
                    <a:pt x="5518613" y="2303182"/>
                  </a:cubicBezTo>
                  <a:lnTo>
                    <a:pt x="5518613" y="2080027"/>
                  </a:lnTo>
                  <a:cubicBezTo>
                    <a:pt x="4944729" y="2421681"/>
                    <a:pt x="4435910" y="2862252"/>
                    <a:pt x="4015745" y="3381331"/>
                  </a:cubicBezTo>
                  <a:close/>
                  <a:moveTo>
                    <a:pt x="3489188" y="3682663"/>
                  </a:moveTo>
                  <a:cubicBezTo>
                    <a:pt x="3520805" y="3682689"/>
                    <a:pt x="3550382" y="3667047"/>
                    <a:pt x="3568152" y="3640906"/>
                  </a:cubicBezTo>
                  <a:cubicBezTo>
                    <a:pt x="3901106" y="3151394"/>
                    <a:pt x="4306483" y="2715260"/>
                    <a:pt x="4770422" y="2347419"/>
                  </a:cubicBezTo>
                  <a:cubicBezTo>
                    <a:pt x="4811678" y="2314686"/>
                    <a:pt x="4818582" y="2254712"/>
                    <a:pt x="4785839" y="2213469"/>
                  </a:cubicBezTo>
                  <a:cubicBezTo>
                    <a:pt x="4753096" y="2172225"/>
                    <a:pt x="4693104" y="2165323"/>
                    <a:pt x="4651848" y="2198056"/>
                  </a:cubicBezTo>
                  <a:cubicBezTo>
                    <a:pt x="4172796" y="2577934"/>
                    <a:pt x="3754234" y="3028338"/>
                    <a:pt x="3410477" y="3533872"/>
                  </a:cubicBezTo>
                  <a:cubicBezTo>
                    <a:pt x="3380843" y="3577397"/>
                    <a:pt x="3392116" y="3636704"/>
                    <a:pt x="3435655" y="3666329"/>
                  </a:cubicBezTo>
                  <a:cubicBezTo>
                    <a:pt x="3451441" y="3677071"/>
                    <a:pt x="3470089" y="3682829"/>
                    <a:pt x="3489188" y="3682854"/>
                  </a:cubicBezTo>
                  <a:close/>
                  <a:moveTo>
                    <a:pt x="5235117" y="0"/>
                  </a:moveTo>
                  <a:cubicBezTo>
                    <a:pt x="5039295" y="89448"/>
                    <a:pt x="4847415" y="187160"/>
                    <a:pt x="4659477" y="293133"/>
                  </a:cubicBezTo>
                  <a:cubicBezTo>
                    <a:pt x="4613020" y="317947"/>
                    <a:pt x="4595485" y="375710"/>
                    <a:pt x="4620306" y="422150"/>
                  </a:cubicBezTo>
                  <a:cubicBezTo>
                    <a:pt x="4645127" y="468591"/>
                    <a:pt x="4702908" y="486122"/>
                    <a:pt x="4749364" y="461309"/>
                  </a:cubicBezTo>
                  <a:cubicBezTo>
                    <a:pt x="4750655" y="460619"/>
                    <a:pt x="4751933" y="459899"/>
                    <a:pt x="4753192" y="459149"/>
                  </a:cubicBezTo>
                  <a:cubicBezTo>
                    <a:pt x="5000906" y="319499"/>
                    <a:pt x="5256473" y="194249"/>
                    <a:pt x="5518613" y="84025"/>
                  </a:cubicBezTo>
                  <a:lnTo>
                    <a:pt x="5518613" y="0"/>
                  </a:lnTo>
                  <a:close/>
                  <a:moveTo>
                    <a:pt x="4506698" y="959040"/>
                  </a:moveTo>
                  <a:cubicBezTo>
                    <a:pt x="4534914" y="1003493"/>
                    <a:pt x="4593832" y="1016668"/>
                    <a:pt x="4638305" y="988467"/>
                  </a:cubicBezTo>
                  <a:cubicBezTo>
                    <a:pt x="4920053" y="809892"/>
                    <a:pt x="5214244" y="651732"/>
                    <a:pt x="5518613" y="515208"/>
                  </a:cubicBezTo>
                  <a:lnTo>
                    <a:pt x="5518613" y="306799"/>
                  </a:lnTo>
                  <a:cubicBezTo>
                    <a:pt x="5178233" y="454670"/>
                    <a:pt x="4849857" y="628751"/>
                    <a:pt x="4536453" y="827473"/>
                  </a:cubicBezTo>
                  <a:cubicBezTo>
                    <a:pt x="4491903" y="855559"/>
                    <a:pt x="4478558" y="914434"/>
                    <a:pt x="4506654" y="958970"/>
                  </a:cubicBezTo>
                  <a:cubicBezTo>
                    <a:pt x="4506666" y="958995"/>
                    <a:pt x="4506685" y="959014"/>
                    <a:pt x="4506698" y="959040"/>
                  </a:cubicBezTo>
                  <a:close/>
                  <a:moveTo>
                    <a:pt x="4505109" y="4769266"/>
                  </a:moveTo>
                  <a:cubicBezTo>
                    <a:pt x="4479111" y="4815060"/>
                    <a:pt x="4495178" y="4873248"/>
                    <a:pt x="4540986" y="4899237"/>
                  </a:cubicBezTo>
                  <a:cubicBezTo>
                    <a:pt x="4586794" y="4925227"/>
                    <a:pt x="4645000" y="4909165"/>
                    <a:pt x="4670998" y="4863371"/>
                  </a:cubicBezTo>
                  <a:cubicBezTo>
                    <a:pt x="4671334" y="4862767"/>
                    <a:pt x="4671672" y="4862163"/>
                    <a:pt x="4672002" y="4861553"/>
                  </a:cubicBezTo>
                  <a:cubicBezTo>
                    <a:pt x="4894546" y="4460236"/>
                    <a:pt x="5180426" y="4097461"/>
                    <a:pt x="5518613" y="3787218"/>
                  </a:cubicBezTo>
                  <a:lnTo>
                    <a:pt x="5518613" y="3532982"/>
                  </a:lnTo>
                  <a:cubicBezTo>
                    <a:pt x="5109015" y="3880656"/>
                    <a:pt x="4765659" y="4299483"/>
                    <a:pt x="4505109" y="4769266"/>
                  </a:cubicBezTo>
                  <a:close/>
                  <a:moveTo>
                    <a:pt x="5138541" y="6858000"/>
                  </a:moveTo>
                  <a:lnTo>
                    <a:pt x="5329276" y="6858000"/>
                  </a:lnTo>
                  <a:cubicBezTo>
                    <a:pt x="5336270" y="6515418"/>
                    <a:pt x="5400255" y="6176332"/>
                    <a:pt x="5518613" y="5854724"/>
                  </a:cubicBezTo>
                  <a:lnTo>
                    <a:pt x="5518613" y="5389791"/>
                  </a:lnTo>
                  <a:cubicBezTo>
                    <a:pt x="5516706" y="5392651"/>
                    <a:pt x="5514862" y="5395638"/>
                    <a:pt x="5513146" y="5398816"/>
                  </a:cubicBezTo>
                  <a:cubicBezTo>
                    <a:pt x="5276239" y="5849385"/>
                    <a:pt x="5147964" y="6349072"/>
                    <a:pt x="5138541" y="6858000"/>
                  </a:cubicBezTo>
                  <a:close/>
                  <a:moveTo>
                    <a:pt x="4985952" y="5893686"/>
                  </a:moveTo>
                  <a:cubicBezTo>
                    <a:pt x="5035970" y="5910160"/>
                    <a:pt x="5089878" y="5882988"/>
                    <a:pt x="5106370" y="5832987"/>
                  </a:cubicBezTo>
                  <a:cubicBezTo>
                    <a:pt x="5204847" y="5534978"/>
                    <a:pt x="5343543" y="5251798"/>
                    <a:pt x="5518613" y="4991277"/>
                  </a:cubicBezTo>
                  <a:lnTo>
                    <a:pt x="5518613" y="4667127"/>
                  </a:lnTo>
                  <a:cubicBezTo>
                    <a:pt x="5258469" y="4998866"/>
                    <a:pt x="5057911" y="5373234"/>
                    <a:pt x="4925871" y="5773559"/>
                  </a:cubicBezTo>
                  <a:cubicBezTo>
                    <a:pt x="4909525" y="5823396"/>
                    <a:pt x="4936514" y="5877065"/>
                    <a:pt x="4986271" y="5893686"/>
                  </a:cubicBezTo>
                  <a:close/>
                  <a:moveTo>
                    <a:pt x="4231022" y="3746922"/>
                  </a:moveTo>
                  <a:cubicBezTo>
                    <a:pt x="3547960" y="4641328"/>
                    <a:pt x="3172923" y="5732780"/>
                    <a:pt x="3162013" y="6858000"/>
                  </a:cubicBezTo>
                  <a:lnTo>
                    <a:pt x="3352748" y="6858000"/>
                  </a:lnTo>
                  <a:cubicBezTo>
                    <a:pt x="3371256" y="5227137"/>
                    <a:pt x="4178328" y="3706129"/>
                    <a:pt x="5518613" y="2776187"/>
                  </a:cubicBezTo>
                  <a:lnTo>
                    <a:pt x="5518613" y="2545913"/>
                  </a:lnTo>
                  <a:cubicBezTo>
                    <a:pt x="5487758" y="2566252"/>
                    <a:pt x="5457088" y="2586909"/>
                    <a:pt x="5426615" y="2607883"/>
                  </a:cubicBezTo>
                  <a:cubicBezTo>
                    <a:pt x="4970414" y="2922055"/>
                    <a:pt x="4566875" y="3306503"/>
                    <a:pt x="4231022" y="3746922"/>
                  </a:cubicBezTo>
                  <a:close/>
                  <a:moveTo>
                    <a:pt x="4908260" y="6204806"/>
                  </a:moveTo>
                  <a:cubicBezTo>
                    <a:pt x="4856386" y="6195698"/>
                    <a:pt x="4806947" y="6230357"/>
                    <a:pt x="4797837" y="6282220"/>
                  </a:cubicBezTo>
                  <a:cubicBezTo>
                    <a:pt x="4797830" y="6282240"/>
                    <a:pt x="4797830" y="6282265"/>
                    <a:pt x="4797824" y="6282284"/>
                  </a:cubicBezTo>
                  <a:cubicBezTo>
                    <a:pt x="4764509" y="6472452"/>
                    <a:pt x="4746160" y="6664972"/>
                    <a:pt x="4742956" y="6858000"/>
                  </a:cubicBezTo>
                  <a:lnTo>
                    <a:pt x="4933691" y="6858000"/>
                  </a:lnTo>
                  <a:cubicBezTo>
                    <a:pt x="4936800" y="6676031"/>
                    <a:pt x="4954081" y="6494507"/>
                    <a:pt x="4985380" y="6315208"/>
                  </a:cubicBezTo>
                  <a:cubicBezTo>
                    <a:pt x="4994510" y="6263445"/>
                    <a:pt x="4960013" y="6214067"/>
                    <a:pt x="4908260" y="6204806"/>
                  </a:cubicBezTo>
                  <a:close/>
                  <a:moveTo>
                    <a:pt x="4560803" y="3966517"/>
                  </a:moveTo>
                  <a:cubicBezTo>
                    <a:pt x="4263180" y="4352091"/>
                    <a:pt x="4025727" y="4780535"/>
                    <a:pt x="3856544" y="5237250"/>
                  </a:cubicBezTo>
                  <a:cubicBezTo>
                    <a:pt x="3838253" y="5286641"/>
                    <a:pt x="3863468" y="5341505"/>
                    <a:pt x="3912875" y="5359791"/>
                  </a:cubicBezTo>
                  <a:cubicBezTo>
                    <a:pt x="3962282" y="5378077"/>
                    <a:pt x="4017163" y="5352869"/>
                    <a:pt x="4035454" y="5303478"/>
                  </a:cubicBezTo>
                  <a:cubicBezTo>
                    <a:pt x="4333199" y="4501537"/>
                    <a:pt x="4846398" y="3797203"/>
                    <a:pt x="5518613" y="3267942"/>
                  </a:cubicBezTo>
                  <a:lnTo>
                    <a:pt x="5518613" y="3027944"/>
                  </a:lnTo>
                  <a:cubicBezTo>
                    <a:pt x="5157405" y="3294948"/>
                    <a:pt x="4835056" y="3610823"/>
                    <a:pt x="4560803" y="396651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61" name="Google Shape;61;p8"/>
            <p:cNvSpPr/>
            <p:nvPr/>
          </p:nvSpPr>
          <p:spPr>
            <a:xfrm>
              <a:off x="5330737" y="210583"/>
              <a:ext cx="3668526" cy="4753341"/>
            </a:xfrm>
            <a:custGeom>
              <a:avLst/>
              <a:gdLst/>
              <a:ahLst/>
              <a:cxnLst/>
              <a:rect l="l" t="t" r="r" b="b"/>
              <a:pathLst>
                <a:path w="4891368" h="6337788" extrusionOk="0">
                  <a:moveTo>
                    <a:pt x="745243" y="3328976"/>
                  </a:moveTo>
                  <a:cubicBezTo>
                    <a:pt x="615034" y="3317536"/>
                    <a:pt x="605370" y="3517682"/>
                    <a:pt x="735833" y="3519144"/>
                  </a:cubicBezTo>
                  <a:cubicBezTo>
                    <a:pt x="854598" y="3519335"/>
                    <a:pt x="863499" y="3340544"/>
                    <a:pt x="745243" y="3328976"/>
                  </a:cubicBezTo>
                  <a:close/>
                  <a:moveTo>
                    <a:pt x="1658484" y="6147620"/>
                  </a:moveTo>
                  <a:cubicBezTo>
                    <a:pt x="1528275" y="6136180"/>
                    <a:pt x="1518611" y="6336390"/>
                    <a:pt x="1649138" y="6337788"/>
                  </a:cubicBezTo>
                  <a:cubicBezTo>
                    <a:pt x="1767903" y="6337916"/>
                    <a:pt x="1776676" y="6159125"/>
                    <a:pt x="1658484" y="6147620"/>
                  </a:cubicBezTo>
                  <a:close/>
                  <a:moveTo>
                    <a:pt x="1259974" y="4171957"/>
                  </a:moveTo>
                  <a:cubicBezTo>
                    <a:pt x="1129765" y="4160580"/>
                    <a:pt x="1119783" y="4360664"/>
                    <a:pt x="1250564" y="4362189"/>
                  </a:cubicBezTo>
                  <a:cubicBezTo>
                    <a:pt x="1369329" y="4362253"/>
                    <a:pt x="1378166" y="4183652"/>
                    <a:pt x="1259974" y="4171957"/>
                  </a:cubicBezTo>
                  <a:close/>
                  <a:moveTo>
                    <a:pt x="1778774" y="3926811"/>
                  </a:moveTo>
                  <a:cubicBezTo>
                    <a:pt x="1648566" y="3915307"/>
                    <a:pt x="1638902" y="4115517"/>
                    <a:pt x="1769365" y="4116979"/>
                  </a:cubicBezTo>
                  <a:cubicBezTo>
                    <a:pt x="1888066" y="4117487"/>
                    <a:pt x="1896967" y="3938442"/>
                    <a:pt x="1778774" y="3926811"/>
                  </a:cubicBezTo>
                  <a:close/>
                  <a:moveTo>
                    <a:pt x="2490854" y="5643345"/>
                  </a:moveTo>
                  <a:cubicBezTo>
                    <a:pt x="2372661" y="5654976"/>
                    <a:pt x="2381499" y="5833513"/>
                    <a:pt x="2500200" y="5833576"/>
                  </a:cubicBezTo>
                  <a:cubicBezTo>
                    <a:pt x="2630790" y="5832115"/>
                    <a:pt x="2621062" y="5632095"/>
                    <a:pt x="2490727" y="5643408"/>
                  </a:cubicBezTo>
                  <a:close/>
                  <a:moveTo>
                    <a:pt x="1817685" y="949650"/>
                  </a:moveTo>
                  <a:cubicBezTo>
                    <a:pt x="1699556" y="961282"/>
                    <a:pt x="1708330" y="1139882"/>
                    <a:pt x="1827031" y="1139882"/>
                  </a:cubicBezTo>
                  <a:cubicBezTo>
                    <a:pt x="1957811" y="1138420"/>
                    <a:pt x="1947957" y="938337"/>
                    <a:pt x="1817685" y="949650"/>
                  </a:cubicBezTo>
                  <a:close/>
                  <a:moveTo>
                    <a:pt x="1761990" y="2491334"/>
                  </a:moveTo>
                  <a:cubicBezTo>
                    <a:pt x="1892707" y="2489745"/>
                    <a:pt x="1882789" y="2289725"/>
                    <a:pt x="1752580" y="2301102"/>
                  </a:cubicBezTo>
                  <a:cubicBezTo>
                    <a:pt x="1634388" y="2312734"/>
                    <a:pt x="1643289" y="2491334"/>
                    <a:pt x="1761990" y="2491334"/>
                  </a:cubicBezTo>
                  <a:close/>
                  <a:moveTo>
                    <a:pt x="722863" y="4567103"/>
                  </a:moveTo>
                  <a:cubicBezTo>
                    <a:pt x="592591" y="4555789"/>
                    <a:pt x="582990" y="4755682"/>
                    <a:pt x="713453" y="4757334"/>
                  </a:cubicBezTo>
                  <a:cubicBezTo>
                    <a:pt x="832154" y="4757334"/>
                    <a:pt x="841119" y="4578734"/>
                    <a:pt x="722863" y="4567103"/>
                  </a:cubicBezTo>
                  <a:close/>
                  <a:moveTo>
                    <a:pt x="4272069" y="190694"/>
                  </a:moveTo>
                  <a:cubicBezTo>
                    <a:pt x="4402786" y="189105"/>
                    <a:pt x="4392868" y="-10851"/>
                    <a:pt x="4262659" y="463"/>
                  </a:cubicBezTo>
                  <a:cubicBezTo>
                    <a:pt x="4144467" y="12157"/>
                    <a:pt x="4153304" y="190758"/>
                    <a:pt x="4272069" y="190694"/>
                  </a:cubicBezTo>
                  <a:close/>
                  <a:moveTo>
                    <a:pt x="84153" y="3888675"/>
                  </a:moveTo>
                  <a:cubicBezTo>
                    <a:pt x="-33721" y="3900434"/>
                    <a:pt x="-25138" y="4079352"/>
                    <a:pt x="93436" y="4079352"/>
                  </a:cubicBezTo>
                  <a:cubicBezTo>
                    <a:pt x="224280" y="4077445"/>
                    <a:pt x="214235" y="3877425"/>
                    <a:pt x="84153" y="3888675"/>
                  </a:cubicBezTo>
                  <a:close/>
                  <a:moveTo>
                    <a:pt x="489339" y="5693238"/>
                  </a:moveTo>
                  <a:cubicBezTo>
                    <a:pt x="371210" y="5704679"/>
                    <a:pt x="379984" y="5883470"/>
                    <a:pt x="498685" y="5883407"/>
                  </a:cubicBezTo>
                  <a:cubicBezTo>
                    <a:pt x="629403" y="5882135"/>
                    <a:pt x="619611" y="5681925"/>
                    <a:pt x="489339" y="5693366"/>
                  </a:cubicBezTo>
                  <a:close/>
                  <a:moveTo>
                    <a:pt x="2214860" y="5039345"/>
                  </a:moveTo>
                  <a:cubicBezTo>
                    <a:pt x="2096731" y="5050976"/>
                    <a:pt x="2105504" y="5229576"/>
                    <a:pt x="2224206" y="5229576"/>
                  </a:cubicBezTo>
                  <a:cubicBezTo>
                    <a:pt x="2354923" y="5228178"/>
                    <a:pt x="2345132" y="5028222"/>
                    <a:pt x="2214860" y="5039472"/>
                  </a:cubicBezTo>
                  <a:close/>
                  <a:moveTo>
                    <a:pt x="4448054" y="5922813"/>
                  </a:moveTo>
                  <a:cubicBezTo>
                    <a:pt x="4329862" y="5934444"/>
                    <a:pt x="4338763" y="6113108"/>
                    <a:pt x="4457464" y="6113044"/>
                  </a:cubicBezTo>
                  <a:cubicBezTo>
                    <a:pt x="4588435" y="6111774"/>
                    <a:pt x="4578326" y="5911754"/>
                    <a:pt x="4448054" y="5923067"/>
                  </a:cubicBezTo>
                  <a:close/>
                  <a:moveTo>
                    <a:pt x="4267491" y="1896804"/>
                  </a:moveTo>
                  <a:cubicBezTo>
                    <a:pt x="4149299" y="1908372"/>
                    <a:pt x="4158136" y="2086973"/>
                    <a:pt x="4276837" y="2087036"/>
                  </a:cubicBezTo>
                  <a:cubicBezTo>
                    <a:pt x="4407554" y="2085765"/>
                    <a:pt x="4397700" y="1885682"/>
                    <a:pt x="4267491" y="1897059"/>
                  </a:cubicBezTo>
                  <a:close/>
                  <a:moveTo>
                    <a:pt x="4153050" y="722301"/>
                  </a:moveTo>
                  <a:cubicBezTo>
                    <a:pt x="4283831" y="720775"/>
                    <a:pt x="4273849" y="520755"/>
                    <a:pt x="4143704" y="532069"/>
                  </a:cubicBezTo>
                  <a:cubicBezTo>
                    <a:pt x="4025384" y="543954"/>
                    <a:pt x="4034222" y="722491"/>
                    <a:pt x="4152923" y="722555"/>
                  </a:cubicBezTo>
                  <a:close/>
                  <a:moveTo>
                    <a:pt x="4144848" y="4439731"/>
                  </a:moveTo>
                  <a:cubicBezTo>
                    <a:pt x="4026719" y="4451362"/>
                    <a:pt x="4035557" y="4629962"/>
                    <a:pt x="4154258" y="4629962"/>
                  </a:cubicBezTo>
                  <a:cubicBezTo>
                    <a:pt x="4284975" y="4628373"/>
                    <a:pt x="4275184" y="4428417"/>
                    <a:pt x="4144848" y="4439731"/>
                  </a:cubicBezTo>
                  <a:close/>
                  <a:moveTo>
                    <a:pt x="4591233" y="5427499"/>
                  </a:moveTo>
                  <a:cubicBezTo>
                    <a:pt x="4461278" y="5416058"/>
                    <a:pt x="4451042" y="5616269"/>
                    <a:pt x="4582078" y="5617476"/>
                  </a:cubicBezTo>
                  <a:cubicBezTo>
                    <a:pt x="4700524" y="5617858"/>
                    <a:pt x="4709235" y="5439067"/>
                    <a:pt x="4591233" y="5427499"/>
                  </a:cubicBezTo>
                  <a:close/>
                  <a:moveTo>
                    <a:pt x="4806955" y="4171957"/>
                  </a:moveTo>
                  <a:cubicBezTo>
                    <a:pt x="4676746" y="4160580"/>
                    <a:pt x="4667082" y="4360600"/>
                    <a:pt x="4797609" y="4362189"/>
                  </a:cubicBezTo>
                  <a:cubicBezTo>
                    <a:pt x="4916373" y="4362189"/>
                    <a:pt x="4925401" y="4183589"/>
                    <a:pt x="4806955" y="4171957"/>
                  </a:cubicBezTo>
                  <a:close/>
                  <a:moveTo>
                    <a:pt x="3486302" y="1201216"/>
                  </a:moveTo>
                  <a:cubicBezTo>
                    <a:pt x="3605003" y="1201216"/>
                    <a:pt x="3613841" y="1022616"/>
                    <a:pt x="3495648" y="1010985"/>
                  </a:cubicBezTo>
                  <a:cubicBezTo>
                    <a:pt x="3365439" y="999608"/>
                    <a:pt x="3355585" y="1199627"/>
                    <a:pt x="3486302" y="1201216"/>
                  </a:cubicBezTo>
                  <a:close/>
                  <a:moveTo>
                    <a:pt x="2813387" y="534738"/>
                  </a:moveTo>
                  <a:cubicBezTo>
                    <a:pt x="2695259" y="546370"/>
                    <a:pt x="2704032" y="724906"/>
                    <a:pt x="2822734" y="724970"/>
                  </a:cubicBezTo>
                  <a:cubicBezTo>
                    <a:pt x="2953451" y="723445"/>
                    <a:pt x="2943660" y="523425"/>
                    <a:pt x="2813387" y="534738"/>
                  </a:cubicBezTo>
                  <a:close/>
                  <a:moveTo>
                    <a:pt x="3045640" y="3211646"/>
                  </a:moveTo>
                  <a:cubicBezTo>
                    <a:pt x="2927447" y="3223278"/>
                    <a:pt x="2936285" y="3401878"/>
                    <a:pt x="3055049" y="3401878"/>
                  </a:cubicBezTo>
                  <a:cubicBezTo>
                    <a:pt x="3185767" y="3400289"/>
                    <a:pt x="3175848" y="3200333"/>
                    <a:pt x="3045640" y="3211646"/>
                  </a:cubicBezTo>
                  <a:close/>
                  <a:moveTo>
                    <a:pt x="3521080" y="4894812"/>
                  </a:moveTo>
                  <a:cubicBezTo>
                    <a:pt x="3390871" y="4883499"/>
                    <a:pt x="3381207" y="5083518"/>
                    <a:pt x="3511734" y="5085044"/>
                  </a:cubicBezTo>
                  <a:cubicBezTo>
                    <a:pt x="3630498" y="5085044"/>
                    <a:pt x="3639272" y="4906507"/>
                    <a:pt x="3521080" y="4894812"/>
                  </a:cubicBezTo>
                  <a:close/>
                  <a:moveTo>
                    <a:pt x="3706220" y="5642900"/>
                  </a:moveTo>
                  <a:cubicBezTo>
                    <a:pt x="3581606" y="5643599"/>
                    <a:pt x="3581606" y="5832877"/>
                    <a:pt x="3706220" y="5833576"/>
                  </a:cubicBezTo>
                  <a:cubicBezTo>
                    <a:pt x="3830834" y="5832941"/>
                    <a:pt x="3830897" y="5643662"/>
                    <a:pt x="3706220" y="5642900"/>
                  </a:cubicBezTo>
                  <a:close/>
                  <a:moveTo>
                    <a:pt x="2673642" y="3056499"/>
                  </a:moveTo>
                  <a:cubicBezTo>
                    <a:pt x="2555513" y="3068131"/>
                    <a:pt x="2564351" y="3246731"/>
                    <a:pt x="2683051" y="3246731"/>
                  </a:cubicBezTo>
                  <a:cubicBezTo>
                    <a:pt x="2813769" y="3245206"/>
                    <a:pt x="2803914" y="3045186"/>
                    <a:pt x="2673642" y="3056499"/>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62" name="Google Shape;62;p8"/>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63" name="Google Shape;63;p8"/>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64"/>
        <p:cNvGrpSpPr/>
        <p:nvPr/>
      </p:nvGrpSpPr>
      <p:grpSpPr>
        <a:xfrm>
          <a:off x="0" y="0"/>
          <a:ext cx="0" cy="0"/>
          <a:chOff x="0" y="0"/>
          <a:chExt cx="0" cy="0"/>
        </a:xfrm>
      </p:grpSpPr>
      <p:grpSp>
        <p:nvGrpSpPr>
          <p:cNvPr id="65" name="Google Shape;65;p9"/>
          <p:cNvGrpSpPr/>
          <p:nvPr/>
        </p:nvGrpSpPr>
        <p:grpSpPr>
          <a:xfrm>
            <a:off x="5005048" y="0"/>
            <a:ext cx="4138960" cy="5143642"/>
            <a:chOff x="5005048" y="0"/>
            <a:chExt cx="4138960" cy="5143642"/>
          </a:xfrm>
        </p:grpSpPr>
        <p:sp>
          <p:nvSpPr>
            <p:cNvPr id="66" name="Google Shape;66;p9"/>
            <p:cNvSpPr/>
            <p:nvPr/>
          </p:nvSpPr>
          <p:spPr>
            <a:xfrm>
              <a:off x="5005049" y="0"/>
              <a:ext cx="4138960" cy="5143500"/>
            </a:xfrm>
            <a:custGeom>
              <a:avLst/>
              <a:gdLst/>
              <a:ahLst/>
              <a:cxnLst/>
              <a:rect l="l" t="t" r="r" b="b"/>
              <a:pathLst>
                <a:path w="5518613" h="6858000" extrusionOk="0">
                  <a:moveTo>
                    <a:pt x="4347879" y="6858000"/>
                  </a:moveTo>
                  <a:lnTo>
                    <a:pt x="4538614" y="6858000"/>
                  </a:lnTo>
                  <a:cubicBezTo>
                    <a:pt x="4551534" y="5930683"/>
                    <a:pt x="4899626" y="5039346"/>
                    <a:pt x="5518613" y="4348570"/>
                  </a:cubicBezTo>
                  <a:lnTo>
                    <a:pt x="5518613" y="4070500"/>
                  </a:lnTo>
                  <a:cubicBezTo>
                    <a:pt x="4781548" y="4812740"/>
                    <a:pt x="4361771" y="5812222"/>
                    <a:pt x="4347879" y="6858000"/>
                  </a:cubicBezTo>
                  <a:close/>
                  <a:moveTo>
                    <a:pt x="4301085" y="5188627"/>
                  </a:moveTo>
                  <a:cubicBezTo>
                    <a:pt x="4077511" y="5717157"/>
                    <a:pt x="3959147" y="6284191"/>
                    <a:pt x="3952611" y="6858000"/>
                  </a:cubicBezTo>
                  <a:lnTo>
                    <a:pt x="4143347" y="6858000"/>
                  </a:lnTo>
                  <a:cubicBezTo>
                    <a:pt x="4157130" y="5751110"/>
                    <a:pt x="4603757" y="4693586"/>
                    <a:pt x="5387642" y="3911730"/>
                  </a:cubicBezTo>
                  <a:cubicBezTo>
                    <a:pt x="5430449" y="3868935"/>
                    <a:pt x="5474000" y="3827197"/>
                    <a:pt x="5518295" y="3786519"/>
                  </a:cubicBezTo>
                  <a:lnTo>
                    <a:pt x="5518295" y="3532283"/>
                  </a:lnTo>
                  <a:cubicBezTo>
                    <a:pt x="5426952" y="3609615"/>
                    <a:pt x="5338451" y="3691136"/>
                    <a:pt x="5252792" y="3776858"/>
                  </a:cubicBezTo>
                  <a:cubicBezTo>
                    <a:pt x="4847103" y="4181397"/>
                    <a:pt x="4523877" y="4660866"/>
                    <a:pt x="4301085" y="5188627"/>
                  </a:cubicBezTo>
                  <a:close/>
                  <a:moveTo>
                    <a:pt x="4742956" y="6858000"/>
                  </a:moveTo>
                  <a:lnTo>
                    <a:pt x="4933691" y="6858000"/>
                  </a:lnTo>
                  <a:cubicBezTo>
                    <a:pt x="4944296" y="6192253"/>
                    <a:pt x="5147442" y="5543813"/>
                    <a:pt x="5518613" y="4990959"/>
                  </a:cubicBezTo>
                  <a:lnTo>
                    <a:pt x="5518613" y="4666809"/>
                  </a:lnTo>
                  <a:cubicBezTo>
                    <a:pt x="5027419" y="5292807"/>
                    <a:pt x="4754965" y="6062479"/>
                    <a:pt x="4742956" y="6858000"/>
                  </a:cubicBezTo>
                  <a:close/>
                  <a:moveTo>
                    <a:pt x="3936844" y="5034751"/>
                  </a:moveTo>
                  <a:cubicBezTo>
                    <a:pt x="3692690" y="5611967"/>
                    <a:pt x="3563753" y="6231329"/>
                    <a:pt x="3557280" y="6858000"/>
                  </a:cubicBezTo>
                  <a:lnTo>
                    <a:pt x="3748016" y="6858000"/>
                  </a:lnTo>
                  <a:cubicBezTo>
                    <a:pt x="3761742" y="5646276"/>
                    <a:pt x="4250019" y="4488202"/>
                    <a:pt x="5108087" y="3632261"/>
                  </a:cubicBezTo>
                  <a:cubicBezTo>
                    <a:pt x="5237705" y="3502760"/>
                    <a:pt x="5374780" y="3380944"/>
                    <a:pt x="5518613" y="3267434"/>
                  </a:cubicBezTo>
                  <a:lnTo>
                    <a:pt x="5518613" y="3027435"/>
                  </a:lnTo>
                  <a:cubicBezTo>
                    <a:pt x="4821685" y="3543508"/>
                    <a:pt x="4275552" y="4236573"/>
                    <a:pt x="3936844" y="5034751"/>
                  </a:cubicBezTo>
                  <a:close/>
                  <a:moveTo>
                    <a:pt x="1590798" y="2330830"/>
                  </a:moveTo>
                  <a:cubicBezTo>
                    <a:pt x="2180774" y="1457646"/>
                    <a:pt x="2932850" y="705739"/>
                    <a:pt x="3806254" y="115868"/>
                  </a:cubicBezTo>
                  <a:cubicBezTo>
                    <a:pt x="3864619" y="76504"/>
                    <a:pt x="3923511" y="37881"/>
                    <a:pt x="3982938" y="0"/>
                  </a:cubicBezTo>
                  <a:lnTo>
                    <a:pt x="3637961" y="0"/>
                  </a:lnTo>
                  <a:cubicBezTo>
                    <a:pt x="2317309" y="907938"/>
                    <a:pt x="1283739" y="2174291"/>
                    <a:pt x="658991" y="3649867"/>
                  </a:cubicBezTo>
                  <a:cubicBezTo>
                    <a:pt x="229264" y="4666364"/>
                    <a:pt x="7820" y="5745720"/>
                    <a:pt x="0" y="6858000"/>
                  </a:cubicBezTo>
                  <a:lnTo>
                    <a:pt x="190735" y="6858000"/>
                  </a:lnTo>
                  <a:cubicBezTo>
                    <a:pt x="198492" y="5771144"/>
                    <a:pt x="414913" y="4716957"/>
                    <a:pt x="834595" y="3724104"/>
                  </a:cubicBezTo>
                  <a:cubicBezTo>
                    <a:pt x="1041009" y="3236353"/>
                    <a:pt x="1294217" y="2769749"/>
                    <a:pt x="1590670" y="2330830"/>
                  </a:cubicBezTo>
                  <a:close/>
                  <a:moveTo>
                    <a:pt x="5138478" y="6858000"/>
                  </a:moveTo>
                  <a:lnTo>
                    <a:pt x="5329213" y="6858000"/>
                  </a:lnTo>
                  <a:cubicBezTo>
                    <a:pt x="5335393" y="6514973"/>
                    <a:pt x="5399423" y="6175480"/>
                    <a:pt x="5518613" y="5853770"/>
                  </a:cubicBezTo>
                  <a:lnTo>
                    <a:pt x="5518613" y="5388583"/>
                  </a:lnTo>
                  <a:cubicBezTo>
                    <a:pt x="5473428" y="5473625"/>
                    <a:pt x="5431892" y="5560847"/>
                    <a:pt x="5394000" y="5650255"/>
                  </a:cubicBezTo>
                  <a:cubicBezTo>
                    <a:pt x="5232135" y="6032727"/>
                    <a:pt x="5145382" y="6442770"/>
                    <a:pt x="5138478" y="6858000"/>
                  </a:cubicBezTo>
                  <a:close/>
                  <a:moveTo>
                    <a:pt x="1918417" y="2551824"/>
                  </a:moveTo>
                  <a:cubicBezTo>
                    <a:pt x="2643092" y="1478290"/>
                    <a:pt x="3623084" y="601442"/>
                    <a:pt x="4770422" y="0"/>
                  </a:cubicBezTo>
                  <a:lnTo>
                    <a:pt x="4376235" y="0"/>
                  </a:lnTo>
                  <a:cubicBezTo>
                    <a:pt x="4221103" y="90127"/>
                    <a:pt x="4069195" y="185317"/>
                    <a:pt x="3920504" y="285570"/>
                  </a:cubicBezTo>
                  <a:cubicBezTo>
                    <a:pt x="2634426" y="1153193"/>
                    <a:pt x="1627921" y="2375366"/>
                    <a:pt x="1023169" y="3803743"/>
                  </a:cubicBezTo>
                  <a:cubicBezTo>
                    <a:pt x="614105" y="4771490"/>
                    <a:pt x="403024" y="5798792"/>
                    <a:pt x="395331" y="6858000"/>
                  </a:cubicBezTo>
                  <a:lnTo>
                    <a:pt x="586067" y="6858000"/>
                  </a:lnTo>
                  <a:cubicBezTo>
                    <a:pt x="593760" y="5824406"/>
                    <a:pt x="799754" y="4822147"/>
                    <a:pt x="1198836" y="3877980"/>
                  </a:cubicBezTo>
                  <a:cubicBezTo>
                    <a:pt x="1395332" y="3413753"/>
                    <a:pt x="1636313" y="2969629"/>
                    <a:pt x="1918417" y="2551824"/>
                  </a:cubicBezTo>
                  <a:close/>
                  <a:moveTo>
                    <a:pt x="3295909" y="1820898"/>
                  </a:moveTo>
                  <a:cubicBezTo>
                    <a:pt x="2638349" y="2477855"/>
                    <a:pt x="2113960" y="3255643"/>
                    <a:pt x="1751587" y="4111495"/>
                  </a:cubicBezTo>
                  <a:cubicBezTo>
                    <a:pt x="1383722" y="4981807"/>
                    <a:pt x="1193495" y="5905571"/>
                    <a:pt x="1185739" y="6858000"/>
                  </a:cubicBezTo>
                  <a:lnTo>
                    <a:pt x="1376474" y="6858000"/>
                  </a:lnTo>
                  <a:cubicBezTo>
                    <a:pt x="1384167" y="5931185"/>
                    <a:pt x="1569308" y="5032463"/>
                    <a:pt x="1927255" y="4185732"/>
                  </a:cubicBezTo>
                  <a:cubicBezTo>
                    <a:pt x="2618518" y="2553159"/>
                    <a:pt x="3901291" y="1241972"/>
                    <a:pt x="5518613" y="514827"/>
                  </a:cubicBezTo>
                  <a:lnTo>
                    <a:pt x="5518613" y="306544"/>
                  </a:lnTo>
                  <a:cubicBezTo>
                    <a:pt x="4689289" y="667432"/>
                    <a:pt x="3935274" y="1181063"/>
                    <a:pt x="3295909" y="1820643"/>
                  </a:cubicBezTo>
                  <a:close/>
                  <a:moveTo>
                    <a:pt x="3572666" y="4881129"/>
                  </a:moveTo>
                  <a:cubicBezTo>
                    <a:pt x="3307970" y="5506962"/>
                    <a:pt x="3168460" y="6178556"/>
                    <a:pt x="3162013" y="6858000"/>
                  </a:cubicBezTo>
                  <a:lnTo>
                    <a:pt x="3352748" y="6858000"/>
                  </a:lnTo>
                  <a:cubicBezTo>
                    <a:pt x="3372565" y="5227315"/>
                    <a:pt x="4179313" y="3706695"/>
                    <a:pt x="5518613" y="2775615"/>
                  </a:cubicBezTo>
                  <a:lnTo>
                    <a:pt x="5518613" y="2545341"/>
                  </a:lnTo>
                  <a:cubicBezTo>
                    <a:pt x="4654149" y="3115286"/>
                    <a:pt x="3977337" y="3927785"/>
                    <a:pt x="3573111" y="4880875"/>
                  </a:cubicBezTo>
                  <a:close/>
                  <a:moveTo>
                    <a:pt x="5235308" y="0"/>
                  </a:moveTo>
                  <a:cubicBezTo>
                    <a:pt x="3502800" y="791829"/>
                    <a:pt x="2129930" y="2203840"/>
                    <a:pt x="1387410" y="3957619"/>
                  </a:cubicBezTo>
                  <a:cubicBezTo>
                    <a:pt x="998882" y="4876680"/>
                    <a:pt x="798292" y="5852181"/>
                    <a:pt x="790535" y="6858000"/>
                  </a:cubicBezTo>
                  <a:lnTo>
                    <a:pt x="981270" y="6858000"/>
                  </a:lnTo>
                  <a:cubicBezTo>
                    <a:pt x="989027" y="5877796"/>
                    <a:pt x="1184722" y="4927273"/>
                    <a:pt x="1563077" y="4031856"/>
                  </a:cubicBezTo>
                  <a:cubicBezTo>
                    <a:pt x="2315465" y="2254877"/>
                    <a:pt x="3730277" y="840502"/>
                    <a:pt x="5507805" y="88347"/>
                  </a:cubicBezTo>
                  <a:lnTo>
                    <a:pt x="5518295" y="83961"/>
                  </a:lnTo>
                  <a:lnTo>
                    <a:pt x="5518295" y="0"/>
                  </a:lnTo>
                  <a:close/>
                  <a:moveTo>
                    <a:pt x="2115829" y="4265371"/>
                  </a:moveTo>
                  <a:cubicBezTo>
                    <a:pt x="1768499" y="5086996"/>
                    <a:pt x="1588763" y="5958960"/>
                    <a:pt x="1581070" y="6858000"/>
                  </a:cubicBezTo>
                  <a:lnTo>
                    <a:pt x="1771805" y="6858000"/>
                  </a:lnTo>
                  <a:cubicBezTo>
                    <a:pt x="1779499" y="5984575"/>
                    <a:pt x="1954148" y="5137589"/>
                    <a:pt x="2291496" y="4339608"/>
                  </a:cubicBezTo>
                  <a:cubicBezTo>
                    <a:pt x="2920256" y="2855992"/>
                    <a:pt x="4067231" y="1651564"/>
                    <a:pt x="5518613" y="950841"/>
                  </a:cubicBezTo>
                  <a:lnTo>
                    <a:pt x="5518613" y="739889"/>
                  </a:lnTo>
                  <a:cubicBezTo>
                    <a:pt x="3987230" y="1453890"/>
                    <a:pt x="2774896" y="2709940"/>
                    <a:pt x="2115829" y="4265371"/>
                  </a:cubicBezTo>
                  <a:close/>
                  <a:moveTo>
                    <a:pt x="3208425" y="4726999"/>
                  </a:moveTo>
                  <a:cubicBezTo>
                    <a:pt x="2923104" y="5401587"/>
                    <a:pt x="2773059" y="6125618"/>
                    <a:pt x="2766809" y="6858000"/>
                  </a:cubicBezTo>
                  <a:lnTo>
                    <a:pt x="2957544" y="6858000"/>
                  </a:lnTo>
                  <a:cubicBezTo>
                    <a:pt x="2978335" y="5002228"/>
                    <a:pt x="3943723" y="3284988"/>
                    <a:pt x="5518613" y="2302356"/>
                  </a:cubicBezTo>
                  <a:lnTo>
                    <a:pt x="5518613" y="2079201"/>
                  </a:lnTo>
                  <a:cubicBezTo>
                    <a:pt x="4486524" y="2693796"/>
                    <a:pt x="3677291" y="3621298"/>
                    <a:pt x="3208425" y="4726999"/>
                  </a:cubicBezTo>
                  <a:close/>
                  <a:moveTo>
                    <a:pt x="2844247" y="4573123"/>
                  </a:moveTo>
                  <a:cubicBezTo>
                    <a:pt x="2538117" y="5297313"/>
                    <a:pt x="2379234" y="6065676"/>
                    <a:pt x="2371478" y="6858000"/>
                  </a:cubicBezTo>
                  <a:lnTo>
                    <a:pt x="2562213" y="6858000"/>
                  </a:lnTo>
                  <a:cubicBezTo>
                    <a:pt x="2569906" y="6091353"/>
                    <a:pt x="2723703" y="5347905"/>
                    <a:pt x="3019978" y="4647360"/>
                  </a:cubicBezTo>
                  <a:cubicBezTo>
                    <a:pt x="3521924" y="3463366"/>
                    <a:pt x="4400064" y="2477658"/>
                    <a:pt x="5518613" y="1842635"/>
                  </a:cubicBezTo>
                  <a:lnTo>
                    <a:pt x="5518613" y="1624564"/>
                  </a:lnTo>
                  <a:cubicBezTo>
                    <a:pt x="4319580" y="2277199"/>
                    <a:pt x="3376933" y="3316482"/>
                    <a:pt x="2844247" y="4573123"/>
                  </a:cubicBezTo>
                  <a:close/>
                  <a:moveTo>
                    <a:pt x="2480006" y="4419247"/>
                  </a:moveTo>
                  <a:cubicBezTo>
                    <a:pt x="2153276" y="5192123"/>
                    <a:pt x="1984094" y="6012350"/>
                    <a:pt x="1976274" y="6858000"/>
                  </a:cubicBezTo>
                  <a:lnTo>
                    <a:pt x="2167009" y="6858000"/>
                  </a:lnTo>
                  <a:cubicBezTo>
                    <a:pt x="2174702" y="6038091"/>
                    <a:pt x="2338989" y="5242779"/>
                    <a:pt x="2655737" y="4493611"/>
                  </a:cubicBezTo>
                  <a:cubicBezTo>
                    <a:pt x="3221262" y="3159288"/>
                    <a:pt x="4233361" y="2063108"/>
                    <a:pt x="5518613" y="1392892"/>
                  </a:cubicBezTo>
                  <a:lnTo>
                    <a:pt x="5518613" y="1178826"/>
                  </a:lnTo>
                  <a:cubicBezTo>
                    <a:pt x="4153132" y="1864200"/>
                    <a:pt x="3076061" y="3012811"/>
                    <a:pt x="2480006" y="441924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67" name="Google Shape;67;p9"/>
            <p:cNvSpPr/>
            <p:nvPr/>
          </p:nvSpPr>
          <p:spPr>
            <a:xfrm>
              <a:off x="5005048" y="0"/>
              <a:ext cx="4138960" cy="5143642"/>
            </a:xfrm>
            <a:custGeom>
              <a:avLst/>
              <a:gdLst/>
              <a:ahLst/>
              <a:cxnLst/>
              <a:rect l="l" t="t" r="r" b="b"/>
              <a:pathLst>
                <a:path w="5518613" h="6858190" extrusionOk="0">
                  <a:moveTo>
                    <a:pt x="2240760" y="4214715"/>
                  </a:moveTo>
                  <a:cubicBezTo>
                    <a:pt x="2192225" y="4194261"/>
                    <a:pt x="2136295" y="4217016"/>
                    <a:pt x="2115841" y="4265537"/>
                  </a:cubicBezTo>
                  <a:cubicBezTo>
                    <a:pt x="2115835" y="4265543"/>
                    <a:pt x="2115835" y="4265556"/>
                    <a:pt x="2115829" y="4265562"/>
                  </a:cubicBezTo>
                  <a:cubicBezTo>
                    <a:pt x="1768499" y="5087187"/>
                    <a:pt x="1588763" y="5959151"/>
                    <a:pt x="1581070" y="6858191"/>
                  </a:cubicBezTo>
                  <a:lnTo>
                    <a:pt x="1771805" y="6858191"/>
                  </a:lnTo>
                  <a:cubicBezTo>
                    <a:pt x="1779499" y="5984765"/>
                    <a:pt x="1954148" y="5137780"/>
                    <a:pt x="2291496" y="4339799"/>
                  </a:cubicBezTo>
                  <a:cubicBezTo>
                    <a:pt x="2312070" y="4291329"/>
                    <a:pt x="2289436" y="4235359"/>
                    <a:pt x="2240951" y="4214797"/>
                  </a:cubicBezTo>
                  <a:cubicBezTo>
                    <a:pt x="2240888" y="4214766"/>
                    <a:pt x="2240824" y="4214740"/>
                    <a:pt x="2240760" y="4214715"/>
                  </a:cubicBezTo>
                  <a:close/>
                  <a:moveTo>
                    <a:pt x="2250170" y="2598095"/>
                  </a:moveTo>
                  <a:cubicBezTo>
                    <a:pt x="2206714" y="2568350"/>
                    <a:pt x="2147370" y="2579447"/>
                    <a:pt x="2117609" y="2622883"/>
                  </a:cubicBezTo>
                  <a:cubicBezTo>
                    <a:pt x="1637146" y="3322742"/>
                    <a:pt x="1278195" y="4098599"/>
                    <a:pt x="1055848" y="4917803"/>
                  </a:cubicBezTo>
                  <a:cubicBezTo>
                    <a:pt x="1040138" y="4968059"/>
                    <a:pt x="1068151" y="5021531"/>
                    <a:pt x="1118422" y="5037242"/>
                  </a:cubicBezTo>
                  <a:cubicBezTo>
                    <a:pt x="1168694" y="5052948"/>
                    <a:pt x="1222182" y="5024944"/>
                    <a:pt x="1237899" y="4974688"/>
                  </a:cubicBezTo>
                  <a:cubicBezTo>
                    <a:pt x="1238611" y="4972400"/>
                    <a:pt x="1239240" y="4970093"/>
                    <a:pt x="1239781" y="4967760"/>
                  </a:cubicBezTo>
                  <a:cubicBezTo>
                    <a:pt x="1456596" y="4169149"/>
                    <a:pt x="1806538" y="3412786"/>
                    <a:pt x="2274902" y="2730488"/>
                  </a:cubicBezTo>
                  <a:cubicBezTo>
                    <a:pt x="2304581" y="2687090"/>
                    <a:pt x="2293518" y="2627860"/>
                    <a:pt x="2250170" y="2598095"/>
                  </a:cubicBezTo>
                  <a:close/>
                  <a:moveTo>
                    <a:pt x="5289222" y="4471365"/>
                  </a:moveTo>
                  <a:cubicBezTo>
                    <a:pt x="5247089" y="4439770"/>
                    <a:pt x="5187312" y="4448313"/>
                    <a:pt x="5155707" y="4490433"/>
                  </a:cubicBezTo>
                  <a:cubicBezTo>
                    <a:pt x="4642139" y="5174034"/>
                    <a:pt x="4359361" y="6003210"/>
                    <a:pt x="4348260" y="6858064"/>
                  </a:cubicBezTo>
                  <a:lnTo>
                    <a:pt x="4538996" y="6858064"/>
                  </a:lnTo>
                  <a:cubicBezTo>
                    <a:pt x="4550065" y="6044479"/>
                    <a:pt x="4819460" y="5255459"/>
                    <a:pt x="5308296" y="4604903"/>
                  </a:cubicBezTo>
                  <a:cubicBezTo>
                    <a:pt x="5339900" y="4562782"/>
                    <a:pt x="5331375" y="4503024"/>
                    <a:pt x="5289241" y="4471429"/>
                  </a:cubicBezTo>
                  <a:cubicBezTo>
                    <a:pt x="5289216" y="4471403"/>
                    <a:pt x="5289184" y="4471384"/>
                    <a:pt x="5289158" y="4471365"/>
                  </a:cubicBezTo>
                  <a:close/>
                  <a:moveTo>
                    <a:pt x="2682504" y="5323054"/>
                  </a:moveTo>
                  <a:cubicBezTo>
                    <a:pt x="2631558" y="5309764"/>
                    <a:pt x="2579475" y="5340266"/>
                    <a:pt x="2566155" y="5391189"/>
                  </a:cubicBezTo>
                  <a:cubicBezTo>
                    <a:pt x="2441510" y="5870327"/>
                    <a:pt x="2376125" y="6362940"/>
                    <a:pt x="2371478" y="6858000"/>
                  </a:cubicBezTo>
                  <a:lnTo>
                    <a:pt x="2562213" y="6858000"/>
                  </a:lnTo>
                  <a:cubicBezTo>
                    <a:pt x="2566810" y="6379148"/>
                    <a:pt x="2630122" y="5902679"/>
                    <a:pt x="2750724" y="5439240"/>
                  </a:cubicBezTo>
                  <a:cubicBezTo>
                    <a:pt x="2764018" y="5388310"/>
                    <a:pt x="2733513" y="5336243"/>
                    <a:pt x="2682567" y="5322927"/>
                  </a:cubicBezTo>
                  <a:close/>
                  <a:moveTo>
                    <a:pt x="4160068" y="5925910"/>
                  </a:moveTo>
                  <a:cubicBezTo>
                    <a:pt x="4108531" y="5915060"/>
                    <a:pt x="4057948" y="5948028"/>
                    <a:pt x="4047095" y="5999555"/>
                  </a:cubicBezTo>
                  <a:cubicBezTo>
                    <a:pt x="4047089" y="5999562"/>
                    <a:pt x="4047089" y="5999568"/>
                    <a:pt x="4047089" y="5999574"/>
                  </a:cubicBezTo>
                  <a:cubicBezTo>
                    <a:pt x="3988006" y="6282004"/>
                    <a:pt x="3956363" y="6569507"/>
                    <a:pt x="3952611" y="6858000"/>
                  </a:cubicBezTo>
                  <a:lnTo>
                    <a:pt x="4143347" y="6858000"/>
                  </a:lnTo>
                  <a:cubicBezTo>
                    <a:pt x="4147123" y="6582600"/>
                    <a:pt x="4177425" y="6308242"/>
                    <a:pt x="4233819" y="6038663"/>
                  </a:cubicBezTo>
                  <a:cubicBezTo>
                    <a:pt x="4244634" y="5987155"/>
                    <a:pt x="4211649" y="5936626"/>
                    <a:pt x="4160132" y="5925783"/>
                  </a:cubicBezTo>
                  <a:close/>
                  <a:moveTo>
                    <a:pt x="2089189" y="6428024"/>
                  </a:moveTo>
                  <a:cubicBezTo>
                    <a:pt x="2036629" y="6424783"/>
                    <a:pt x="1991399" y="6464762"/>
                    <a:pt x="1988163" y="6517325"/>
                  </a:cubicBezTo>
                  <a:cubicBezTo>
                    <a:pt x="1981233" y="6630015"/>
                    <a:pt x="1977228" y="6744293"/>
                    <a:pt x="1976147" y="6857937"/>
                  </a:cubicBezTo>
                  <a:lnTo>
                    <a:pt x="2166882" y="6857937"/>
                  </a:lnTo>
                  <a:cubicBezTo>
                    <a:pt x="2167900" y="6748170"/>
                    <a:pt x="2171778" y="6637832"/>
                    <a:pt x="2178454" y="6529020"/>
                  </a:cubicBezTo>
                  <a:cubicBezTo>
                    <a:pt x="2181645" y="6476520"/>
                    <a:pt x="2141737" y="6431393"/>
                    <a:pt x="2089253" y="6428088"/>
                  </a:cubicBezTo>
                  <a:close/>
                  <a:moveTo>
                    <a:pt x="3184583" y="972450"/>
                  </a:moveTo>
                  <a:cubicBezTo>
                    <a:pt x="3218833" y="1012264"/>
                    <a:pt x="3278838" y="1016897"/>
                    <a:pt x="3318797" y="982811"/>
                  </a:cubicBezTo>
                  <a:cubicBezTo>
                    <a:pt x="3763936" y="601738"/>
                    <a:pt x="4250629" y="272053"/>
                    <a:pt x="4769659" y="0"/>
                  </a:cubicBezTo>
                  <a:lnTo>
                    <a:pt x="4375472" y="0"/>
                  </a:lnTo>
                  <a:cubicBezTo>
                    <a:pt x="3957475" y="243105"/>
                    <a:pt x="3562373" y="523572"/>
                    <a:pt x="3195010" y="837960"/>
                  </a:cubicBezTo>
                  <a:cubicBezTo>
                    <a:pt x="3154981" y="872186"/>
                    <a:pt x="3150289" y="932364"/>
                    <a:pt x="3184526" y="972381"/>
                  </a:cubicBezTo>
                  <a:cubicBezTo>
                    <a:pt x="3184545" y="972406"/>
                    <a:pt x="3184564" y="972425"/>
                    <a:pt x="3184583" y="972450"/>
                  </a:cubicBezTo>
                  <a:close/>
                  <a:moveTo>
                    <a:pt x="3860550" y="1312617"/>
                  </a:moveTo>
                  <a:cubicBezTo>
                    <a:pt x="2823496" y="2150361"/>
                    <a:pt x="2039217" y="3259260"/>
                    <a:pt x="1594930" y="4515984"/>
                  </a:cubicBezTo>
                  <a:cubicBezTo>
                    <a:pt x="1577376" y="4565636"/>
                    <a:pt x="1603405" y="4620118"/>
                    <a:pt x="1653073" y="4637667"/>
                  </a:cubicBezTo>
                  <a:cubicBezTo>
                    <a:pt x="1702740" y="4655216"/>
                    <a:pt x="1757240" y="4629195"/>
                    <a:pt x="1774794" y="4579543"/>
                  </a:cubicBezTo>
                  <a:cubicBezTo>
                    <a:pt x="2207331" y="3355996"/>
                    <a:pt x="2970909" y="2276380"/>
                    <a:pt x="3980586" y="1460773"/>
                  </a:cubicBezTo>
                  <a:cubicBezTo>
                    <a:pt x="4021531" y="1427634"/>
                    <a:pt x="4027850" y="1367596"/>
                    <a:pt x="3994700" y="1326664"/>
                  </a:cubicBezTo>
                  <a:cubicBezTo>
                    <a:pt x="3961551" y="1285732"/>
                    <a:pt x="3901494" y="1279414"/>
                    <a:pt x="3860550" y="1312554"/>
                  </a:cubicBezTo>
                  <a:close/>
                  <a:moveTo>
                    <a:pt x="1208945" y="3617516"/>
                  </a:moveTo>
                  <a:cubicBezTo>
                    <a:pt x="1160835" y="3596077"/>
                    <a:pt x="1104454" y="3617687"/>
                    <a:pt x="1083015" y="3665782"/>
                  </a:cubicBezTo>
                  <a:cubicBezTo>
                    <a:pt x="1083009" y="3665795"/>
                    <a:pt x="1083002" y="3665808"/>
                    <a:pt x="1082996" y="3665820"/>
                  </a:cubicBezTo>
                  <a:cubicBezTo>
                    <a:pt x="859435" y="4168317"/>
                    <a:pt x="688555" y="4692614"/>
                    <a:pt x="573097" y="5230321"/>
                  </a:cubicBezTo>
                  <a:cubicBezTo>
                    <a:pt x="458636" y="5765430"/>
                    <a:pt x="398987" y="6310803"/>
                    <a:pt x="395077" y="6858000"/>
                  </a:cubicBezTo>
                  <a:lnTo>
                    <a:pt x="585812" y="6858000"/>
                  </a:lnTo>
                  <a:cubicBezTo>
                    <a:pt x="589655" y="6324252"/>
                    <a:pt x="647789" y="5792284"/>
                    <a:pt x="759318" y="5270300"/>
                  </a:cubicBezTo>
                  <a:cubicBezTo>
                    <a:pt x="872119" y="4745584"/>
                    <a:pt x="1038993" y="4233954"/>
                    <a:pt x="1257265" y="3743616"/>
                  </a:cubicBezTo>
                  <a:cubicBezTo>
                    <a:pt x="1278792" y="3695566"/>
                    <a:pt x="1257284" y="3639157"/>
                    <a:pt x="1209212" y="3617637"/>
                  </a:cubicBezTo>
                  <a:cubicBezTo>
                    <a:pt x="1209123" y="3617598"/>
                    <a:pt x="1209034" y="3617554"/>
                    <a:pt x="1208945" y="3617516"/>
                  </a:cubicBezTo>
                  <a:close/>
                  <a:moveTo>
                    <a:pt x="943632" y="5974532"/>
                  </a:moveTo>
                  <a:cubicBezTo>
                    <a:pt x="891294" y="5968659"/>
                    <a:pt x="844106" y="6006305"/>
                    <a:pt x="838219" y="6058620"/>
                  </a:cubicBezTo>
                  <a:cubicBezTo>
                    <a:pt x="808496" y="6324074"/>
                    <a:pt x="792557" y="6590926"/>
                    <a:pt x="790471" y="6858000"/>
                  </a:cubicBezTo>
                  <a:lnTo>
                    <a:pt x="981207" y="6858000"/>
                  </a:lnTo>
                  <a:cubicBezTo>
                    <a:pt x="983267" y="6597917"/>
                    <a:pt x="998799" y="6338127"/>
                    <a:pt x="1027746" y="6079658"/>
                  </a:cubicBezTo>
                  <a:cubicBezTo>
                    <a:pt x="1033475" y="6027432"/>
                    <a:pt x="995855" y="5980418"/>
                    <a:pt x="943632" y="5974532"/>
                  </a:cubicBezTo>
                  <a:close/>
                  <a:moveTo>
                    <a:pt x="2331805" y="1389587"/>
                  </a:moveTo>
                  <a:cubicBezTo>
                    <a:pt x="2707325" y="978292"/>
                    <a:pt x="3123535" y="606057"/>
                    <a:pt x="3574065" y="278578"/>
                  </a:cubicBezTo>
                  <a:cubicBezTo>
                    <a:pt x="3707535" y="181588"/>
                    <a:pt x="3843911" y="88728"/>
                    <a:pt x="3983193" y="0"/>
                  </a:cubicBezTo>
                  <a:lnTo>
                    <a:pt x="3637771" y="0"/>
                  </a:lnTo>
                  <a:cubicBezTo>
                    <a:pt x="3578433" y="40678"/>
                    <a:pt x="3519814" y="82118"/>
                    <a:pt x="3461913" y="124321"/>
                  </a:cubicBezTo>
                  <a:cubicBezTo>
                    <a:pt x="3000969" y="459401"/>
                    <a:pt x="2575133" y="840261"/>
                    <a:pt x="2190915" y="1261071"/>
                  </a:cubicBezTo>
                  <a:cubicBezTo>
                    <a:pt x="2155794" y="1300312"/>
                    <a:pt x="2159145" y="1360585"/>
                    <a:pt x="2198398" y="1395695"/>
                  </a:cubicBezTo>
                  <a:cubicBezTo>
                    <a:pt x="2237111" y="1430316"/>
                    <a:pt x="2296417" y="1427602"/>
                    <a:pt x="2331805" y="1389587"/>
                  </a:cubicBezTo>
                  <a:close/>
                  <a:moveTo>
                    <a:pt x="558283" y="4174100"/>
                  </a:moveTo>
                  <a:cubicBezTo>
                    <a:pt x="508369" y="4157308"/>
                    <a:pt x="454289" y="4184143"/>
                    <a:pt x="437484" y="4234036"/>
                  </a:cubicBezTo>
                  <a:cubicBezTo>
                    <a:pt x="152999" y="5079865"/>
                    <a:pt x="5315" y="5965653"/>
                    <a:pt x="0" y="6858000"/>
                  </a:cubicBezTo>
                  <a:lnTo>
                    <a:pt x="190735" y="6858000"/>
                  </a:lnTo>
                  <a:cubicBezTo>
                    <a:pt x="196021" y="5986354"/>
                    <a:pt x="340335" y="5121127"/>
                    <a:pt x="618237" y="4294926"/>
                  </a:cubicBezTo>
                  <a:cubicBezTo>
                    <a:pt x="635068" y="4245032"/>
                    <a:pt x="608253" y="4190944"/>
                    <a:pt x="558344" y="4174119"/>
                  </a:cubicBezTo>
                  <a:cubicBezTo>
                    <a:pt x="558323" y="4174113"/>
                    <a:pt x="558303" y="4174107"/>
                    <a:pt x="558283" y="4174100"/>
                  </a:cubicBezTo>
                  <a:close/>
                  <a:moveTo>
                    <a:pt x="3037844" y="3379615"/>
                  </a:moveTo>
                  <a:cubicBezTo>
                    <a:pt x="3010054" y="3424341"/>
                    <a:pt x="3023793" y="3483121"/>
                    <a:pt x="3068533" y="3510909"/>
                  </a:cubicBezTo>
                  <a:cubicBezTo>
                    <a:pt x="3111436" y="3537552"/>
                    <a:pt x="3167678" y="3526131"/>
                    <a:pt x="3196790" y="3484868"/>
                  </a:cubicBezTo>
                  <a:cubicBezTo>
                    <a:pt x="3756262" y="2640934"/>
                    <a:pt x="4511937" y="1945073"/>
                    <a:pt x="5399149" y="1456833"/>
                  </a:cubicBezTo>
                  <a:cubicBezTo>
                    <a:pt x="5438612" y="1435178"/>
                    <a:pt x="5478324" y="1413994"/>
                    <a:pt x="5518295" y="1393274"/>
                  </a:cubicBezTo>
                  <a:lnTo>
                    <a:pt x="5518295" y="1179080"/>
                  </a:lnTo>
                  <a:cubicBezTo>
                    <a:pt x="5447342" y="1214673"/>
                    <a:pt x="5377024" y="1251582"/>
                    <a:pt x="5307342" y="1289800"/>
                  </a:cubicBezTo>
                  <a:cubicBezTo>
                    <a:pt x="4393090" y="1792906"/>
                    <a:pt x="3614361" y="2509939"/>
                    <a:pt x="3037780" y="3379551"/>
                  </a:cubicBezTo>
                  <a:close/>
                  <a:moveTo>
                    <a:pt x="4015808" y="3381140"/>
                  </a:moveTo>
                  <a:cubicBezTo>
                    <a:pt x="3403115" y="4138641"/>
                    <a:pt x="2998006" y="5042404"/>
                    <a:pt x="2840242" y="6003706"/>
                  </a:cubicBezTo>
                  <a:cubicBezTo>
                    <a:pt x="2831761" y="6055671"/>
                    <a:pt x="2867028" y="6104675"/>
                    <a:pt x="2919009" y="6113154"/>
                  </a:cubicBezTo>
                  <a:cubicBezTo>
                    <a:pt x="2919009" y="6113154"/>
                    <a:pt x="2919016" y="6113154"/>
                    <a:pt x="2919016" y="6113154"/>
                  </a:cubicBezTo>
                  <a:cubicBezTo>
                    <a:pt x="2924121" y="6114012"/>
                    <a:pt x="2929290" y="6114438"/>
                    <a:pt x="2934465" y="6114425"/>
                  </a:cubicBezTo>
                  <a:cubicBezTo>
                    <a:pt x="2981183" y="6114381"/>
                    <a:pt x="3020989" y="6080504"/>
                    <a:pt x="3028498" y="6034405"/>
                  </a:cubicBezTo>
                  <a:cubicBezTo>
                    <a:pt x="3282755" y="4490388"/>
                    <a:pt x="4190147" y="3130744"/>
                    <a:pt x="5518613" y="2303182"/>
                  </a:cubicBezTo>
                  <a:lnTo>
                    <a:pt x="5518613" y="2080027"/>
                  </a:lnTo>
                  <a:cubicBezTo>
                    <a:pt x="4944729" y="2421681"/>
                    <a:pt x="4435910" y="2862252"/>
                    <a:pt x="4015745" y="3381331"/>
                  </a:cubicBezTo>
                  <a:close/>
                  <a:moveTo>
                    <a:pt x="3489188" y="3682663"/>
                  </a:moveTo>
                  <a:cubicBezTo>
                    <a:pt x="3520805" y="3682689"/>
                    <a:pt x="3550382" y="3667047"/>
                    <a:pt x="3568152" y="3640906"/>
                  </a:cubicBezTo>
                  <a:cubicBezTo>
                    <a:pt x="3901106" y="3151394"/>
                    <a:pt x="4306483" y="2715260"/>
                    <a:pt x="4770422" y="2347419"/>
                  </a:cubicBezTo>
                  <a:cubicBezTo>
                    <a:pt x="4811678" y="2314686"/>
                    <a:pt x="4818582" y="2254712"/>
                    <a:pt x="4785839" y="2213469"/>
                  </a:cubicBezTo>
                  <a:cubicBezTo>
                    <a:pt x="4753096" y="2172225"/>
                    <a:pt x="4693104" y="2165323"/>
                    <a:pt x="4651848" y="2198056"/>
                  </a:cubicBezTo>
                  <a:cubicBezTo>
                    <a:pt x="4172796" y="2577934"/>
                    <a:pt x="3754234" y="3028338"/>
                    <a:pt x="3410477" y="3533872"/>
                  </a:cubicBezTo>
                  <a:cubicBezTo>
                    <a:pt x="3380843" y="3577397"/>
                    <a:pt x="3392116" y="3636704"/>
                    <a:pt x="3435655" y="3666329"/>
                  </a:cubicBezTo>
                  <a:cubicBezTo>
                    <a:pt x="3451441" y="3677071"/>
                    <a:pt x="3470089" y="3682829"/>
                    <a:pt x="3489188" y="3682854"/>
                  </a:cubicBezTo>
                  <a:close/>
                  <a:moveTo>
                    <a:pt x="5235117" y="0"/>
                  </a:moveTo>
                  <a:cubicBezTo>
                    <a:pt x="5039295" y="89448"/>
                    <a:pt x="4847415" y="187160"/>
                    <a:pt x="4659477" y="293133"/>
                  </a:cubicBezTo>
                  <a:cubicBezTo>
                    <a:pt x="4613020" y="317947"/>
                    <a:pt x="4595485" y="375710"/>
                    <a:pt x="4620306" y="422150"/>
                  </a:cubicBezTo>
                  <a:cubicBezTo>
                    <a:pt x="4645127" y="468591"/>
                    <a:pt x="4702908" y="486122"/>
                    <a:pt x="4749364" y="461309"/>
                  </a:cubicBezTo>
                  <a:cubicBezTo>
                    <a:pt x="4750655" y="460619"/>
                    <a:pt x="4751933" y="459899"/>
                    <a:pt x="4753192" y="459149"/>
                  </a:cubicBezTo>
                  <a:cubicBezTo>
                    <a:pt x="5000906" y="319499"/>
                    <a:pt x="5256473" y="194249"/>
                    <a:pt x="5518613" y="84025"/>
                  </a:cubicBezTo>
                  <a:lnTo>
                    <a:pt x="5518613" y="0"/>
                  </a:lnTo>
                  <a:close/>
                  <a:moveTo>
                    <a:pt x="4506698" y="959040"/>
                  </a:moveTo>
                  <a:cubicBezTo>
                    <a:pt x="4534914" y="1003493"/>
                    <a:pt x="4593832" y="1016668"/>
                    <a:pt x="4638305" y="988467"/>
                  </a:cubicBezTo>
                  <a:cubicBezTo>
                    <a:pt x="4920053" y="809892"/>
                    <a:pt x="5214244" y="651732"/>
                    <a:pt x="5518613" y="515208"/>
                  </a:cubicBezTo>
                  <a:lnTo>
                    <a:pt x="5518613" y="306799"/>
                  </a:lnTo>
                  <a:cubicBezTo>
                    <a:pt x="5178233" y="454670"/>
                    <a:pt x="4849857" y="628751"/>
                    <a:pt x="4536453" y="827473"/>
                  </a:cubicBezTo>
                  <a:cubicBezTo>
                    <a:pt x="4491903" y="855559"/>
                    <a:pt x="4478558" y="914434"/>
                    <a:pt x="4506654" y="958970"/>
                  </a:cubicBezTo>
                  <a:cubicBezTo>
                    <a:pt x="4506666" y="958995"/>
                    <a:pt x="4506685" y="959014"/>
                    <a:pt x="4506698" y="959040"/>
                  </a:cubicBezTo>
                  <a:close/>
                  <a:moveTo>
                    <a:pt x="4505109" y="4769266"/>
                  </a:moveTo>
                  <a:cubicBezTo>
                    <a:pt x="4479111" y="4815060"/>
                    <a:pt x="4495178" y="4873248"/>
                    <a:pt x="4540986" y="4899237"/>
                  </a:cubicBezTo>
                  <a:cubicBezTo>
                    <a:pt x="4586794" y="4925227"/>
                    <a:pt x="4645000" y="4909165"/>
                    <a:pt x="4670998" y="4863371"/>
                  </a:cubicBezTo>
                  <a:cubicBezTo>
                    <a:pt x="4671334" y="4862767"/>
                    <a:pt x="4671672" y="4862163"/>
                    <a:pt x="4672002" y="4861553"/>
                  </a:cubicBezTo>
                  <a:cubicBezTo>
                    <a:pt x="4894546" y="4460236"/>
                    <a:pt x="5180426" y="4097461"/>
                    <a:pt x="5518613" y="3787218"/>
                  </a:cubicBezTo>
                  <a:lnTo>
                    <a:pt x="5518613" y="3532982"/>
                  </a:lnTo>
                  <a:cubicBezTo>
                    <a:pt x="5109015" y="3880656"/>
                    <a:pt x="4765659" y="4299483"/>
                    <a:pt x="4505109" y="4769266"/>
                  </a:cubicBezTo>
                  <a:close/>
                  <a:moveTo>
                    <a:pt x="5138541" y="6858000"/>
                  </a:moveTo>
                  <a:lnTo>
                    <a:pt x="5329276" y="6858000"/>
                  </a:lnTo>
                  <a:cubicBezTo>
                    <a:pt x="5336270" y="6515418"/>
                    <a:pt x="5400255" y="6176332"/>
                    <a:pt x="5518613" y="5854724"/>
                  </a:cubicBezTo>
                  <a:lnTo>
                    <a:pt x="5518613" y="5389791"/>
                  </a:lnTo>
                  <a:cubicBezTo>
                    <a:pt x="5516706" y="5392651"/>
                    <a:pt x="5514862" y="5395638"/>
                    <a:pt x="5513146" y="5398816"/>
                  </a:cubicBezTo>
                  <a:cubicBezTo>
                    <a:pt x="5276239" y="5849385"/>
                    <a:pt x="5147964" y="6349072"/>
                    <a:pt x="5138541" y="6858000"/>
                  </a:cubicBezTo>
                  <a:close/>
                  <a:moveTo>
                    <a:pt x="4985952" y="5893686"/>
                  </a:moveTo>
                  <a:cubicBezTo>
                    <a:pt x="5035970" y="5910160"/>
                    <a:pt x="5089878" y="5882988"/>
                    <a:pt x="5106370" y="5832987"/>
                  </a:cubicBezTo>
                  <a:cubicBezTo>
                    <a:pt x="5204847" y="5534978"/>
                    <a:pt x="5343543" y="5251798"/>
                    <a:pt x="5518613" y="4991277"/>
                  </a:cubicBezTo>
                  <a:lnTo>
                    <a:pt x="5518613" y="4667127"/>
                  </a:lnTo>
                  <a:cubicBezTo>
                    <a:pt x="5258469" y="4998866"/>
                    <a:pt x="5057911" y="5373234"/>
                    <a:pt x="4925871" y="5773559"/>
                  </a:cubicBezTo>
                  <a:cubicBezTo>
                    <a:pt x="4909525" y="5823396"/>
                    <a:pt x="4936514" y="5877065"/>
                    <a:pt x="4986271" y="5893686"/>
                  </a:cubicBezTo>
                  <a:close/>
                  <a:moveTo>
                    <a:pt x="4231022" y="3746922"/>
                  </a:moveTo>
                  <a:cubicBezTo>
                    <a:pt x="3547960" y="4641328"/>
                    <a:pt x="3172923" y="5732780"/>
                    <a:pt x="3162013" y="6858000"/>
                  </a:cubicBezTo>
                  <a:lnTo>
                    <a:pt x="3352748" y="6858000"/>
                  </a:lnTo>
                  <a:cubicBezTo>
                    <a:pt x="3371256" y="5227137"/>
                    <a:pt x="4178328" y="3706129"/>
                    <a:pt x="5518613" y="2776187"/>
                  </a:cubicBezTo>
                  <a:lnTo>
                    <a:pt x="5518613" y="2545913"/>
                  </a:lnTo>
                  <a:cubicBezTo>
                    <a:pt x="5487758" y="2566252"/>
                    <a:pt x="5457088" y="2586909"/>
                    <a:pt x="5426615" y="2607883"/>
                  </a:cubicBezTo>
                  <a:cubicBezTo>
                    <a:pt x="4970414" y="2922055"/>
                    <a:pt x="4566875" y="3306503"/>
                    <a:pt x="4231022" y="3746922"/>
                  </a:cubicBezTo>
                  <a:close/>
                  <a:moveTo>
                    <a:pt x="4908260" y="6204806"/>
                  </a:moveTo>
                  <a:cubicBezTo>
                    <a:pt x="4856386" y="6195698"/>
                    <a:pt x="4806947" y="6230357"/>
                    <a:pt x="4797837" y="6282220"/>
                  </a:cubicBezTo>
                  <a:cubicBezTo>
                    <a:pt x="4797830" y="6282240"/>
                    <a:pt x="4797830" y="6282265"/>
                    <a:pt x="4797824" y="6282284"/>
                  </a:cubicBezTo>
                  <a:cubicBezTo>
                    <a:pt x="4764509" y="6472452"/>
                    <a:pt x="4746160" y="6664972"/>
                    <a:pt x="4742956" y="6858000"/>
                  </a:cubicBezTo>
                  <a:lnTo>
                    <a:pt x="4933691" y="6858000"/>
                  </a:lnTo>
                  <a:cubicBezTo>
                    <a:pt x="4936800" y="6676031"/>
                    <a:pt x="4954081" y="6494507"/>
                    <a:pt x="4985380" y="6315208"/>
                  </a:cubicBezTo>
                  <a:cubicBezTo>
                    <a:pt x="4994510" y="6263445"/>
                    <a:pt x="4960013" y="6214067"/>
                    <a:pt x="4908260" y="6204806"/>
                  </a:cubicBezTo>
                  <a:close/>
                  <a:moveTo>
                    <a:pt x="4560803" y="3966517"/>
                  </a:moveTo>
                  <a:cubicBezTo>
                    <a:pt x="4263180" y="4352091"/>
                    <a:pt x="4025727" y="4780535"/>
                    <a:pt x="3856544" y="5237250"/>
                  </a:cubicBezTo>
                  <a:cubicBezTo>
                    <a:pt x="3838253" y="5286641"/>
                    <a:pt x="3863468" y="5341505"/>
                    <a:pt x="3912875" y="5359791"/>
                  </a:cubicBezTo>
                  <a:cubicBezTo>
                    <a:pt x="3962282" y="5378077"/>
                    <a:pt x="4017163" y="5352869"/>
                    <a:pt x="4035454" y="5303478"/>
                  </a:cubicBezTo>
                  <a:cubicBezTo>
                    <a:pt x="4333199" y="4501537"/>
                    <a:pt x="4846398" y="3797203"/>
                    <a:pt x="5518613" y="3267942"/>
                  </a:cubicBezTo>
                  <a:lnTo>
                    <a:pt x="5518613" y="3027944"/>
                  </a:lnTo>
                  <a:cubicBezTo>
                    <a:pt x="5157405" y="3294948"/>
                    <a:pt x="4835056" y="3610823"/>
                    <a:pt x="4560803" y="396651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68" name="Google Shape;68;p9"/>
            <p:cNvSpPr/>
            <p:nvPr/>
          </p:nvSpPr>
          <p:spPr>
            <a:xfrm>
              <a:off x="5330737" y="210583"/>
              <a:ext cx="3668526" cy="4753341"/>
            </a:xfrm>
            <a:custGeom>
              <a:avLst/>
              <a:gdLst/>
              <a:ahLst/>
              <a:cxnLst/>
              <a:rect l="l" t="t" r="r" b="b"/>
              <a:pathLst>
                <a:path w="4891368" h="6337788" extrusionOk="0">
                  <a:moveTo>
                    <a:pt x="745243" y="3328976"/>
                  </a:moveTo>
                  <a:cubicBezTo>
                    <a:pt x="615034" y="3317536"/>
                    <a:pt x="605370" y="3517682"/>
                    <a:pt x="735833" y="3519144"/>
                  </a:cubicBezTo>
                  <a:cubicBezTo>
                    <a:pt x="854598" y="3519335"/>
                    <a:pt x="863499" y="3340544"/>
                    <a:pt x="745243" y="3328976"/>
                  </a:cubicBezTo>
                  <a:close/>
                  <a:moveTo>
                    <a:pt x="1658484" y="6147620"/>
                  </a:moveTo>
                  <a:cubicBezTo>
                    <a:pt x="1528275" y="6136180"/>
                    <a:pt x="1518611" y="6336390"/>
                    <a:pt x="1649138" y="6337788"/>
                  </a:cubicBezTo>
                  <a:cubicBezTo>
                    <a:pt x="1767903" y="6337916"/>
                    <a:pt x="1776676" y="6159125"/>
                    <a:pt x="1658484" y="6147620"/>
                  </a:cubicBezTo>
                  <a:close/>
                  <a:moveTo>
                    <a:pt x="1259974" y="4171957"/>
                  </a:moveTo>
                  <a:cubicBezTo>
                    <a:pt x="1129765" y="4160580"/>
                    <a:pt x="1119783" y="4360664"/>
                    <a:pt x="1250564" y="4362189"/>
                  </a:cubicBezTo>
                  <a:cubicBezTo>
                    <a:pt x="1369329" y="4362253"/>
                    <a:pt x="1378166" y="4183652"/>
                    <a:pt x="1259974" y="4171957"/>
                  </a:cubicBezTo>
                  <a:close/>
                  <a:moveTo>
                    <a:pt x="1778774" y="3926811"/>
                  </a:moveTo>
                  <a:cubicBezTo>
                    <a:pt x="1648566" y="3915307"/>
                    <a:pt x="1638902" y="4115517"/>
                    <a:pt x="1769365" y="4116979"/>
                  </a:cubicBezTo>
                  <a:cubicBezTo>
                    <a:pt x="1888066" y="4117487"/>
                    <a:pt x="1896967" y="3938442"/>
                    <a:pt x="1778774" y="3926811"/>
                  </a:cubicBezTo>
                  <a:close/>
                  <a:moveTo>
                    <a:pt x="2490854" y="5643345"/>
                  </a:moveTo>
                  <a:cubicBezTo>
                    <a:pt x="2372661" y="5654976"/>
                    <a:pt x="2381499" y="5833513"/>
                    <a:pt x="2500200" y="5833576"/>
                  </a:cubicBezTo>
                  <a:cubicBezTo>
                    <a:pt x="2630790" y="5832115"/>
                    <a:pt x="2621062" y="5632095"/>
                    <a:pt x="2490727" y="5643408"/>
                  </a:cubicBezTo>
                  <a:close/>
                  <a:moveTo>
                    <a:pt x="1817685" y="949650"/>
                  </a:moveTo>
                  <a:cubicBezTo>
                    <a:pt x="1699556" y="961282"/>
                    <a:pt x="1708330" y="1139882"/>
                    <a:pt x="1827031" y="1139882"/>
                  </a:cubicBezTo>
                  <a:cubicBezTo>
                    <a:pt x="1957811" y="1138420"/>
                    <a:pt x="1947957" y="938337"/>
                    <a:pt x="1817685" y="949650"/>
                  </a:cubicBezTo>
                  <a:close/>
                  <a:moveTo>
                    <a:pt x="1761990" y="2491334"/>
                  </a:moveTo>
                  <a:cubicBezTo>
                    <a:pt x="1892707" y="2489745"/>
                    <a:pt x="1882789" y="2289725"/>
                    <a:pt x="1752580" y="2301102"/>
                  </a:cubicBezTo>
                  <a:cubicBezTo>
                    <a:pt x="1634388" y="2312734"/>
                    <a:pt x="1643289" y="2491334"/>
                    <a:pt x="1761990" y="2491334"/>
                  </a:cubicBezTo>
                  <a:close/>
                  <a:moveTo>
                    <a:pt x="722863" y="4567103"/>
                  </a:moveTo>
                  <a:cubicBezTo>
                    <a:pt x="592591" y="4555789"/>
                    <a:pt x="582990" y="4755682"/>
                    <a:pt x="713453" y="4757334"/>
                  </a:cubicBezTo>
                  <a:cubicBezTo>
                    <a:pt x="832154" y="4757334"/>
                    <a:pt x="841119" y="4578734"/>
                    <a:pt x="722863" y="4567103"/>
                  </a:cubicBezTo>
                  <a:close/>
                  <a:moveTo>
                    <a:pt x="4272069" y="190694"/>
                  </a:moveTo>
                  <a:cubicBezTo>
                    <a:pt x="4402786" y="189105"/>
                    <a:pt x="4392868" y="-10851"/>
                    <a:pt x="4262659" y="463"/>
                  </a:cubicBezTo>
                  <a:cubicBezTo>
                    <a:pt x="4144467" y="12157"/>
                    <a:pt x="4153304" y="190758"/>
                    <a:pt x="4272069" y="190694"/>
                  </a:cubicBezTo>
                  <a:close/>
                  <a:moveTo>
                    <a:pt x="84153" y="3888675"/>
                  </a:moveTo>
                  <a:cubicBezTo>
                    <a:pt x="-33721" y="3900434"/>
                    <a:pt x="-25138" y="4079352"/>
                    <a:pt x="93436" y="4079352"/>
                  </a:cubicBezTo>
                  <a:cubicBezTo>
                    <a:pt x="224280" y="4077445"/>
                    <a:pt x="214235" y="3877425"/>
                    <a:pt x="84153" y="3888675"/>
                  </a:cubicBezTo>
                  <a:close/>
                  <a:moveTo>
                    <a:pt x="489339" y="5693238"/>
                  </a:moveTo>
                  <a:cubicBezTo>
                    <a:pt x="371210" y="5704679"/>
                    <a:pt x="379984" y="5883470"/>
                    <a:pt x="498685" y="5883407"/>
                  </a:cubicBezTo>
                  <a:cubicBezTo>
                    <a:pt x="629403" y="5882135"/>
                    <a:pt x="619611" y="5681925"/>
                    <a:pt x="489339" y="5693366"/>
                  </a:cubicBezTo>
                  <a:close/>
                  <a:moveTo>
                    <a:pt x="2214860" y="5039345"/>
                  </a:moveTo>
                  <a:cubicBezTo>
                    <a:pt x="2096731" y="5050976"/>
                    <a:pt x="2105504" y="5229576"/>
                    <a:pt x="2224206" y="5229576"/>
                  </a:cubicBezTo>
                  <a:cubicBezTo>
                    <a:pt x="2354923" y="5228178"/>
                    <a:pt x="2345132" y="5028222"/>
                    <a:pt x="2214860" y="5039472"/>
                  </a:cubicBezTo>
                  <a:close/>
                  <a:moveTo>
                    <a:pt x="4448054" y="5922813"/>
                  </a:moveTo>
                  <a:cubicBezTo>
                    <a:pt x="4329862" y="5934444"/>
                    <a:pt x="4338763" y="6113108"/>
                    <a:pt x="4457464" y="6113044"/>
                  </a:cubicBezTo>
                  <a:cubicBezTo>
                    <a:pt x="4588435" y="6111774"/>
                    <a:pt x="4578326" y="5911754"/>
                    <a:pt x="4448054" y="5923067"/>
                  </a:cubicBezTo>
                  <a:close/>
                  <a:moveTo>
                    <a:pt x="4267491" y="1896804"/>
                  </a:moveTo>
                  <a:cubicBezTo>
                    <a:pt x="4149299" y="1908372"/>
                    <a:pt x="4158136" y="2086973"/>
                    <a:pt x="4276837" y="2087036"/>
                  </a:cubicBezTo>
                  <a:cubicBezTo>
                    <a:pt x="4407554" y="2085765"/>
                    <a:pt x="4397700" y="1885682"/>
                    <a:pt x="4267491" y="1897059"/>
                  </a:cubicBezTo>
                  <a:close/>
                  <a:moveTo>
                    <a:pt x="4153050" y="722301"/>
                  </a:moveTo>
                  <a:cubicBezTo>
                    <a:pt x="4283831" y="720775"/>
                    <a:pt x="4273849" y="520755"/>
                    <a:pt x="4143704" y="532069"/>
                  </a:cubicBezTo>
                  <a:cubicBezTo>
                    <a:pt x="4025384" y="543954"/>
                    <a:pt x="4034222" y="722491"/>
                    <a:pt x="4152923" y="722555"/>
                  </a:cubicBezTo>
                  <a:close/>
                  <a:moveTo>
                    <a:pt x="4144848" y="4439731"/>
                  </a:moveTo>
                  <a:cubicBezTo>
                    <a:pt x="4026719" y="4451362"/>
                    <a:pt x="4035557" y="4629962"/>
                    <a:pt x="4154258" y="4629962"/>
                  </a:cubicBezTo>
                  <a:cubicBezTo>
                    <a:pt x="4284975" y="4628373"/>
                    <a:pt x="4275184" y="4428417"/>
                    <a:pt x="4144848" y="4439731"/>
                  </a:cubicBezTo>
                  <a:close/>
                  <a:moveTo>
                    <a:pt x="4591233" y="5427499"/>
                  </a:moveTo>
                  <a:cubicBezTo>
                    <a:pt x="4461278" y="5416058"/>
                    <a:pt x="4451042" y="5616269"/>
                    <a:pt x="4582078" y="5617476"/>
                  </a:cubicBezTo>
                  <a:cubicBezTo>
                    <a:pt x="4700524" y="5617858"/>
                    <a:pt x="4709235" y="5439067"/>
                    <a:pt x="4591233" y="5427499"/>
                  </a:cubicBezTo>
                  <a:close/>
                  <a:moveTo>
                    <a:pt x="4806955" y="4171957"/>
                  </a:moveTo>
                  <a:cubicBezTo>
                    <a:pt x="4676746" y="4160580"/>
                    <a:pt x="4667082" y="4360600"/>
                    <a:pt x="4797609" y="4362189"/>
                  </a:cubicBezTo>
                  <a:cubicBezTo>
                    <a:pt x="4916373" y="4362189"/>
                    <a:pt x="4925401" y="4183589"/>
                    <a:pt x="4806955" y="4171957"/>
                  </a:cubicBezTo>
                  <a:close/>
                  <a:moveTo>
                    <a:pt x="3486302" y="1201216"/>
                  </a:moveTo>
                  <a:cubicBezTo>
                    <a:pt x="3605003" y="1201216"/>
                    <a:pt x="3613841" y="1022616"/>
                    <a:pt x="3495648" y="1010985"/>
                  </a:cubicBezTo>
                  <a:cubicBezTo>
                    <a:pt x="3365439" y="999608"/>
                    <a:pt x="3355585" y="1199627"/>
                    <a:pt x="3486302" y="1201216"/>
                  </a:cubicBezTo>
                  <a:close/>
                  <a:moveTo>
                    <a:pt x="2813387" y="534738"/>
                  </a:moveTo>
                  <a:cubicBezTo>
                    <a:pt x="2695259" y="546370"/>
                    <a:pt x="2704032" y="724906"/>
                    <a:pt x="2822734" y="724970"/>
                  </a:cubicBezTo>
                  <a:cubicBezTo>
                    <a:pt x="2953451" y="723445"/>
                    <a:pt x="2943660" y="523425"/>
                    <a:pt x="2813387" y="534738"/>
                  </a:cubicBezTo>
                  <a:close/>
                  <a:moveTo>
                    <a:pt x="3045640" y="3211646"/>
                  </a:moveTo>
                  <a:cubicBezTo>
                    <a:pt x="2927447" y="3223278"/>
                    <a:pt x="2936285" y="3401878"/>
                    <a:pt x="3055049" y="3401878"/>
                  </a:cubicBezTo>
                  <a:cubicBezTo>
                    <a:pt x="3185767" y="3400289"/>
                    <a:pt x="3175848" y="3200333"/>
                    <a:pt x="3045640" y="3211646"/>
                  </a:cubicBezTo>
                  <a:close/>
                  <a:moveTo>
                    <a:pt x="3521080" y="4894812"/>
                  </a:moveTo>
                  <a:cubicBezTo>
                    <a:pt x="3390871" y="4883499"/>
                    <a:pt x="3381207" y="5083518"/>
                    <a:pt x="3511734" y="5085044"/>
                  </a:cubicBezTo>
                  <a:cubicBezTo>
                    <a:pt x="3630498" y="5085044"/>
                    <a:pt x="3639272" y="4906507"/>
                    <a:pt x="3521080" y="4894812"/>
                  </a:cubicBezTo>
                  <a:close/>
                  <a:moveTo>
                    <a:pt x="3706220" y="5642900"/>
                  </a:moveTo>
                  <a:cubicBezTo>
                    <a:pt x="3581606" y="5643599"/>
                    <a:pt x="3581606" y="5832877"/>
                    <a:pt x="3706220" y="5833576"/>
                  </a:cubicBezTo>
                  <a:cubicBezTo>
                    <a:pt x="3830834" y="5832941"/>
                    <a:pt x="3830897" y="5643662"/>
                    <a:pt x="3706220" y="5642900"/>
                  </a:cubicBezTo>
                  <a:close/>
                  <a:moveTo>
                    <a:pt x="2673642" y="3056499"/>
                  </a:moveTo>
                  <a:cubicBezTo>
                    <a:pt x="2555513" y="3068131"/>
                    <a:pt x="2564351" y="3246731"/>
                    <a:pt x="2683051" y="3246731"/>
                  </a:cubicBezTo>
                  <a:cubicBezTo>
                    <a:pt x="2813769" y="3245206"/>
                    <a:pt x="2803914" y="3045186"/>
                    <a:pt x="2673642" y="3056499"/>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69" name="Google Shape;69;p9"/>
          <p:cNvSpPr txBox="1">
            <a:spLocks noGrp="1"/>
          </p:cNvSpPr>
          <p:nvPr>
            <p:ph type="body" idx="1"/>
          </p:nvPr>
        </p:nvSpPr>
        <p:spPr>
          <a:xfrm>
            <a:off x="855300" y="4406300"/>
            <a:ext cx="7433400" cy="300000"/>
          </a:xfrm>
          <a:prstGeom prst="rect">
            <a:avLst/>
          </a:prstGeom>
        </p:spPr>
        <p:txBody>
          <a:bodyPr spcFirstLastPara="1" wrap="square" lIns="0" tIns="0" rIns="0" bIns="0" anchor="t" anchorCtr="0">
            <a:noAutofit/>
          </a:bodyPr>
          <a:lstStyle>
            <a:lvl1pPr marL="457200" lvl="0" indent="-228600" rtl="0">
              <a:spcBef>
                <a:spcPts val="0"/>
              </a:spcBef>
              <a:spcAft>
                <a:spcPts val="600"/>
              </a:spcAft>
              <a:buClr>
                <a:schemeClr val="accent2"/>
              </a:buClr>
              <a:buSzPts val="1800"/>
              <a:buNone/>
              <a:defRPr sz="1800">
                <a:solidFill>
                  <a:schemeClr val="accent2"/>
                </a:solidFill>
              </a:defRPr>
            </a:lvl1pPr>
          </a:lstStyle>
          <a:p>
            <a:endParaRPr/>
          </a:p>
        </p:txBody>
      </p:sp>
      <p:sp>
        <p:nvSpPr>
          <p:cNvPr id="70" name="Google Shape;70;p9"/>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71"/>
        <p:cNvGrpSpPr/>
        <p:nvPr/>
      </p:nvGrpSpPr>
      <p:grpSpPr>
        <a:xfrm>
          <a:off x="0" y="0"/>
          <a:ext cx="0" cy="0"/>
          <a:chOff x="0" y="0"/>
          <a:chExt cx="0" cy="0"/>
        </a:xfrm>
      </p:grpSpPr>
      <p:grpSp>
        <p:nvGrpSpPr>
          <p:cNvPr id="72" name="Google Shape;72;p10"/>
          <p:cNvGrpSpPr/>
          <p:nvPr/>
        </p:nvGrpSpPr>
        <p:grpSpPr>
          <a:xfrm>
            <a:off x="3078602" y="0"/>
            <a:ext cx="6065389" cy="5143642"/>
            <a:chOff x="2052402" y="0"/>
            <a:chExt cx="6065389" cy="5143642"/>
          </a:xfrm>
        </p:grpSpPr>
        <p:sp>
          <p:nvSpPr>
            <p:cNvPr id="73" name="Google Shape;73;p10"/>
            <p:cNvSpPr/>
            <p:nvPr/>
          </p:nvSpPr>
          <p:spPr>
            <a:xfrm>
              <a:off x="2052402" y="0"/>
              <a:ext cx="6065388" cy="5143500"/>
            </a:xfrm>
            <a:custGeom>
              <a:avLst/>
              <a:gdLst/>
              <a:ahLst/>
              <a:cxnLst/>
              <a:rect l="l" t="t" r="r" b="b"/>
              <a:pathLst>
                <a:path w="8087184" h="6858000" extrusionOk="0">
                  <a:moveTo>
                    <a:pt x="7505580" y="6858000"/>
                  </a:moveTo>
                  <a:lnTo>
                    <a:pt x="7696738" y="6858000"/>
                  </a:lnTo>
                  <a:cubicBezTo>
                    <a:pt x="7718274" y="6613807"/>
                    <a:pt x="7866550" y="6398978"/>
                    <a:pt x="8087184" y="6292327"/>
                  </a:cubicBezTo>
                  <a:lnTo>
                    <a:pt x="8087184" y="6085824"/>
                  </a:lnTo>
                  <a:cubicBezTo>
                    <a:pt x="7757916" y="6205690"/>
                    <a:pt x="7529976" y="6508299"/>
                    <a:pt x="7505580" y="6858000"/>
                  </a:cubicBezTo>
                  <a:close/>
                  <a:moveTo>
                    <a:pt x="7109988" y="6858000"/>
                  </a:moveTo>
                  <a:lnTo>
                    <a:pt x="7300574" y="6858000"/>
                  </a:lnTo>
                  <a:cubicBezTo>
                    <a:pt x="7326176" y="6394974"/>
                    <a:pt x="7641722" y="5998774"/>
                    <a:pt x="8087184" y="5870486"/>
                  </a:cubicBezTo>
                  <a:lnTo>
                    <a:pt x="8087184" y="5673454"/>
                  </a:lnTo>
                  <a:cubicBezTo>
                    <a:pt x="7534740" y="5807487"/>
                    <a:pt x="7136797" y="6289898"/>
                    <a:pt x="7109988" y="6858000"/>
                  </a:cubicBezTo>
                  <a:close/>
                  <a:moveTo>
                    <a:pt x="6319630" y="6858000"/>
                  </a:moveTo>
                  <a:lnTo>
                    <a:pt x="6510215" y="6858000"/>
                  </a:lnTo>
                  <a:cubicBezTo>
                    <a:pt x="6538485" y="5958928"/>
                    <a:pt x="7199691" y="5205998"/>
                    <a:pt x="8087184" y="5062145"/>
                  </a:cubicBezTo>
                  <a:lnTo>
                    <a:pt x="8087184" y="4869180"/>
                  </a:lnTo>
                  <a:cubicBezTo>
                    <a:pt x="7093725" y="5015188"/>
                    <a:pt x="6348402" y="5853783"/>
                    <a:pt x="6319630" y="6858000"/>
                  </a:cubicBezTo>
                  <a:close/>
                  <a:moveTo>
                    <a:pt x="6714777" y="6858000"/>
                  </a:moveTo>
                  <a:lnTo>
                    <a:pt x="6905363" y="6858000"/>
                  </a:lnTo>
                  <a:cubicBezTo>
                    <a:pt x="6932680" y="6177012"/>
                    <a:pt x="7419944" y="5602103"/>
                    <a:pt x="8086993" y="5463773"/>
                  </a:cubicBezTo>
                  <a:lnTo>
                    <a:pt x="8086993" y="5269538"/>
                  </a:lnTo>
                  <a:cubicBezTo>
                    <a:pt x="7313661" y="5411166"/>
                    <a:pt x="6742920" y="6071943"/>
                    <a:pt x="6714968" y="6858000"/>
                  </a:cubicBezTo>
                  <a:close/>
                  <a:moveTo>
                    <a:pt x="7902253" y="6858000"/>
                  </a:moveTo>
                  <a:lnTo>
                    <a:pt x="8087184" y="6858000"/>
                  </a:lnTo>
                  <a:lnTo>
                    <a:pt x="8087184" y="6532261"/>
                  </a:lnTo>
                  <a:cubicBezTo>
                    <a:pt x="7984903" y="6612091"/>
                    <a:pt x="7918389" y="6729230"/>
                    <a:pt x="7902253" y="6858000"/>
                  </a:cubicBezTo>
                  <a:close/>
                  <a:moveTo>
                    <a:pt x="1916910" y="2551824"/>
                  </a:moveTo>
                  <a:cubicBezTo>
                    <a:pt x="2641015" y="1478290"/>
                    <a:pt x="3620238" y="601442"/>
                    <a:pt x="4766674" y="0"/>
                  </a:cubicBezTo>
                  <a:lnTo>
                    <a:pt x="4372797" y="0"/>
                  </a:lnTo>
                  <a:cubicBezTo>
                    <a:pt x="4217787" y="90127"/>
                    <a:pt x="4065999" y="185317"/>
                    <a:pt x="3917425" y="285570"/>
                  </a:cubicBezTo>
                  <a:cubicBezTo>
                    <a:pt x="2632356" y="1153193"/>
                    <a:pt x="1626642" y="2375366"/>
                    <a:pt x="1022365" y="3803743"/>
                  </a:cubicBezTo>
                  <a:cubicBezTo>
                    <a:pt x="613622" y="4771490"/>
                    <a:pt x="402707" y="5798792"/>
                    <a:pt x="395021" y="6858000"/>
                  </a:cubicBezTo>
                  <a:lnTo>
                    <a:pt x="585606" y="6858000"/>
                  </a:lnTo>
                  <a:cubicBezTo>
                    <a:pt x="593293" y="5824406"/>
                    <a:pt x="799126" y="4822147"/>
                    <a:pt x="1197894" y="3877980"/>
                  </a:cubicBezTo>
                  <a:cubicBezTo>
                    <a:pt x="1394236" y="3413753"/>
                    <a:pt x="1635028" y="2969629"/>
                    <a:pt x="1916910" y="2551824"/>
                  </a:cubicBezTo>
                  <a:close/>
                  <a:moveTo>
                    <a:pt x="1589421" y="2330830"/>
                  </a:moveTo>
                  <a:cubicBezTo>
                    <a:pt x="2178972" y="1457633"/>
                    <a:pt x="2930502" y="705726"/>
                    <a:pt x="3803264" y="115868"/>
                  </a:cubicBezTo>
                  <a:cubicBezTo>
                    <a:pt x="3861583" y="76504"/>
                    <a:pt x="3920429" y="37881"/>
                    <a:pt x="3979810" y="0"/>
                  </a:cubicBezTo>
                  <a:lnTo>
                    <a:pt x="3635104" y="0"/>
                  </a:lnTo>
                  <a:cubicBezTo>
                    <a:pt x="2315489" y="907938"/>
                    <a:pt x="1282730" y="2174291"/>
                    <a:pt x="658473" y="3649867"/>
                  </a:cubicBezTo>
                  <a:cubicBezTo>
                    <a:pt x="229084" y="4666364"/>
                    <a:pt x="7814" y="5745720"/>
                    <a:pt x="0" y="6858000"/>
                  </a:cubicBezTo>
                  <a:lnTo>
                    <a:pt x="190586" y="6858000"/>
                  </a:lnTo>
                  <a:cubicBezTo>
                    <a:pt x="198336" y="5771144"/>
                    <a:pt x="414587" y="4716957"/>
                    <a:pt x="833939" y="3724104"/>
                  </a:cubicBezTo>
                  <a:cubicBezTo>
                    <a:pt x="1040191" y="3236353"/>
                    <a:pt x="1293200" y="2769749"/>
                    <a:pt x="1589421" y="2330830"/>
                  </a:cubicBezTo>
                  <a:close/>
                  <a:moveTo>
                    <a:pt x="2572017" y="2993622"/>
                  </a:moveTo>
                  <a:cubicBezTo>
                    <a:pt x="3332930" y="1865656"/>
                    <a:pt x="4404701" y="982881"/>
                    <a:pt x="5657281" y="452412"/>
                  </a:cubicBezTo>
                  <a:cubicBezTo>
                    <a:pt x="6154760" y="241841"/>
                    <a:pt x="6675072" y="90013"/>
                    <a:pt x="7207695" y="0"/>
                  </a:cubicBezTo>
                  <a:lnTo>
                    <a:pt x="6359208" y="0"/>
                  </a:lnTo>
                  <a:cubicBezTo>
                    <a:pt x="4284670" y="610249"/>
                    <a:pt x="2593089" y="2119237"/>
                    <a:pt x="1750212" y="4111495"/>
                  </a:cubicBezTo>
                  <a:cubicBezTo>
                    <a:pt x="1382635" y="4981807"/>
                    <a:pt x="1192558" y="5905571"/>
                    <a:pt x="1184807" y="6858000"/>
                  </a:cubicBezTo>
                  <a:lnTo>
                    <a:pt x="1375393" y="6858000"/>
                  </a:lnTo>
                  <a:cubicBezTo>
                    <a:pt x="1383080" y="5931185"/>
                    <a:pt x="1568075" y="5032463"/>
                    <a:pt x="1925741" y="4185732"/>
                  </a:cubicBezTo>
                  <a:cubicBezTo>
                    <a:pt x="2102147" y="3768398"/>
                    <a:pt x="2318583" y="3369160"/>
                    <a:pt x="2572017" y="2993622"/>
                  </a:cubicBezTo>
                  <a:close/>
                  <a:moveTo>
                    <a:pt x="2244464" y="2772819"/>
                  </a:moveTo>
                  <a:cubicBezTo>
                    <a:pt x="3048163" y="1581236"/>
                    <a:pt x="4180312" y="648682"/>
                    <a:pt x="5503478" y="88347"/>
                  </a:cubicBezTo>
                  <a:cubicBezTo>
                    <a:pt x="5576110" y="57669"/>
                    <a:pt x="5649085" y="28220"/>
                    <a:pt x="5722398" y="0"/>
                  </a:cubicBezTo>
                  <a:lnTo>
                    <a:pt x="5231195" y="0"/>
                  </a:lnTo>
                  <a:cubicBezTo>
                    <a:pt x="3500048" y="791829"/>
                    <a:pt x="2128257" y="2203840"/>
                    <a:pt x="1386320" y="3957619"/>
                  </a:cubicBezTo>
                  <a:cubicBezTo>
                    <a:pt x="998097" y="4876680"/>
                    <a:pt x="797664" y="5852181"/>
                    <a:pt x="789914" y="6858000"/>
                  </a:cubicBezTo>
                  <a:lnTo>
                    <a:pt x="980500" y="6858000"/>
                  </a:lnTo>
                  <a:cubicBezTo>
                    <a:pt x="988250" y="5877796"/>
                    <a:pt x="1183791" y="4927273"/>
                    <a:pt x="1561849" y="4031856"/>
                  </a:cubicBezTo>
                  <a:cubicBezTo>
                    <a:pt x="1748217" y="3591107"/>
                    <a:pt x="1976824" y="3169458"/>
                    <a:pt x="2244464" y="2772819"/>
                  </a:cubicBezTo>
                  <a:close/>
                  <a:moveTo>
                    <a:pt x="6645086" y="5174199"/>
                  </a:moveTo>
                  <a:cubicBezTo>
                    <a:pt x="6196994" y="5621603"/>
                    <a:pt x="5938846" y="6224801"/>
                    <a:pt x="5924482" y="6858000"/>
                  </a:cubicBezTo>
                  <a:lnTo>
                    <a:pt x="6115068" y="6858000"/>
                  </a:lnTo>
                  <a:cubicBezTo>
                    <a:pt x="6144113" y="5740903"/>
                    <a:pt x="6980009" y="4810427"/>
                    <a:pt x="8087184" y="4662805"/>
                  </a:cubicBezTo>
                  <a:lnTo>
                    <a:pt x="8087184" y="4470476"/>
                  </a:lnTo>
                  <a:cubicBezTo>
                    <a:pt x="7541283" y="4536958"/>
                    <a:pt x="7033500" y="4784755"/>
                    <a:pt x="6645086" y="5174199"/>
                  </a:cubicBezTo>
                  <a:close/>
                  <a:moveTo>
                    <a:pt x="5248665" y="3776858"/>
                  </a:moveTo>
                  <a:cubicBezTo>
                    <a:pt x="4429655" y="4594492"/>
                    <a:pt x="3963299" y="5700524"/>
                    <a:pt x="3949506" y="6858000"/>
                  </a:cubicBezTo>
                  <a:lnTo>
                    <a:pt x="4140092" y="6858000"/>
                  </a:lnTo>
                  <a:cubicBezTo>
                    <a:pt x="4168387" y="4649426"/>
                    <a:pt x="5884840" y="2831630"/>
                    <a:pt x="8087184" y="2677862"/>
                  </a:cubicBezTo>
                  <a:lnTo>
                    <a:pt x="8087184" y="2486740"/>
                  </a:lnTo>
                  <a:cubicBezTo>
                    <a:pt x="7015966" y="2558053"/>
                    <a:pt x="6007247" y="3016624"/>
                    <a:pt x="5248983" y="3776985"/>
                  </a:cubicBezTo>
                  <a:close/>
                  <a:moveTo>
                    <a:pt x="4410660" y="2938516"/>
                  </a:moveTo>
                  <a:cubicBezTo>
                    <a:pt x="3369116" y="3978263"/>
                    <a:pt x="2777913" y="5386016"/>
                    <a:pt x="2764635" y="6858000"/>
                  </a:cubicBezTo>
                  <a:lnTo>
                    <a:pt x="2955221" y="6858000"/>
                  </a:lnTo>
                  <a:cubicBezTo>
                    <a:pt x="2982996" y="3994566"/>
                    <a:pt x="5229175" y="1645170"/>
                    <a:pt x="8087184" y="1490201"/>
                  </a:cubicBezTo>
                  <a:lnTo>
                    <a:pt x="8087184" y="1299524"/>
                  </a:lnTo>
                  <a:cubicBezTo>
                    <a:pt x="6701118" y="1371556"/>
                    <a:pt x="5391045" y="1955579"/>
                    <a:pt x="4410660" y="2938516"/>
                  </a:cubicBezTo>
                  <a:close/>
                  <a:moveTo>
                    <a:pt x="4131135" y="2658858"/>
                  </a:moveTo>
                  <a:cubicBezTo>
                    <a:pt x="3581562" y="3207390"/>
                    <a:pt x="3143742" y="3857527"/>
                    <a:pt x="2842013" y="4573123"/>
                  </a:cubicBezTo>
                  <a:cubicBezTo>
                    <a:pt x="2536123" y="5297313"/>
                    <a:pt x="2377365" y="6065676"/>
                    <a:pt x="2369615" y="6858000"/>
                  </a:cubicBezTo>
                  <a:lnTo>
                    <a:pt x="2560201" y="6858000"/>
                  </a:lnTo>
                  <a:cubicBezTo>
                    <a:pt x="2567887" y="6091353"/>
                    <a:pt x="2721563" y="5347905"/>
                    <a:pt x="3017606" y="4647360"/>
                  </a:cubicBezTo>
                  <a:cubicBezTo>
                    <a:pt x="3885813" y="2587735"/>
                    <a:pt x="5855795" y="1207104"/>
                    <a:pt x="8087184" y="1094420"/>
                  </a:cubicBezTo>
                  <a:lnTo>
                    <a:pt x="8087184" y="903743"/>
                  </a:lnTo>
                  <a:cubicBezTo>
                    <a:pt x="6596296" y="976143"/>
                    <a:pt x="5185918" y="1602077"/>
                    <a:pt x="4131643" y="2659239"/>
                  </a:cubicBezTo>
                  <a:close/>
                  <a:moveTo>
                    <a:pt x="3851609" y="2379199"/>
                  </a:moveTo>
                  <a:cubicBezTo>
                    <a:pt x="3266022" y="2963794"/>
                    <a:pt x="2799525" y="3656649"/>
                    <a:pt x="2478058" y="4419247"/>
                  </a:cubicBezTo>
                  <a:cubicBezTo>
                    <a:pt x="2151585" y="5192123"/>
                    <a:pt x="1982535" y="6012350"/>
                    <a:pt x="1974721" y="6858000"/>
                  </a:cubicBezTo>
                  <a:lnTo>
                    <a:pt x="2165307" y="6858000"/>
                  </a:lnTo>
                  <a:cubicBezTo>
                    <a:pt x="2172994" y="6038091"/>
                    <a:pt x="2337152" y="5242779"/>
                    <a:pt x="2653651" y="4493611"/>
                  </a:cubicBezTo>
                  <a:cubicBezTo>
                    <a:pt x="3583550" y="2287642"/>
                    <a:pt x="5696853" y="811831"/>
                    <a:pt x="8087184" y="699147"/>
                  </a:cubicBezTo>
                  <a:lnTo>
                    <a:pt x="8087184" y="508471"/>
                  </a:lnTo>
                  <a:cubicBezTo>
                    <a:pt x="6491347" y="580803"/>
                    <a:pt x="4980435" y="1248328"/>
                    <a:pt x="3851990" y="2379580"/>
                  </a:cubicBezTo>
                  <a:close/>
                  <a:moveTo>
                    <a:pt x="6365561" y="4894350"/>
                  </a:moveTo>
                  <a:cubicBezTo>
                    <a:pt x="5843312" y="5415945"/>
                    <a:pt x="5543596" y="6119847"/>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689995" y="3217985"/>
                  </a:moveTo>
                  <a:cubicBezTo>
                    <a:pt x="3722659" y="4183711"/>
                    <a:pt x="3173060" y="5490862"/>
                    <a:pt x="3159529" y="6858000"/>
                  </a:cubicBezTo>
                  <a:lnTo>
                    <a:pt x="3350115" y="6858000"/>
                  </a:lnTo>
                  <a:cubicBezTo>
                    <a:pt x="3378080" y="4212840"/>
                    <a:pt x="5447656" y="2040614"/>
                    <a:pt x="8087184" y="1885982"/>
                  </a:cubicBezTo>
                  <a:lnTo>
                    <a:pt x="8087184" y="1694988"/>
                  </a:lnTo>
                  <a:cubicBezTo>
                    <a:pt x="6806004" y="1766892"/>
                    <a:pt x="5596357" y="2309182"/>
                    <a:pt x="4689995" y="3217985"/>
                  </a:cubicBezTo>
                  <a:close/>
                  <a:moveTo>
                    <a:pt x="5736946" y="640864"/>
                  </a:moveTo>
                  <a:cubicBezTo>
                    <a:pt x="4104688" y="1332467"/>
                    <a:pt x="2805440" y="2632335"/>
                    <a:pt x="2114167" y="4265371"/>
                  </a:cubicBezTo>
                  <a:cubicBezTo>
                    <a:pt x="1767110" y="5086996"/>
                    <a:pt x="1587515" y="5958960"/>
                    <a:pt x="1579828" y="6858000"/>
                  </a:cubicBezTo>
                  <a:lnTo>
                    <a:pt x="1770414" y="6858000"/>
                  </a:lnTo>
                  <a:cubicBezTo>
                    <a:pt x="1778101" y="5984575"/>
                    <a:pt x="1952613" y="5137589"/>
                    <a:pt x="2289696" y="4339608"/>
                  </a:cubicBezTo>
                  <a:cubicBezTo>
                    <a:pt x="3281262" y="1987231"/>
                    <a:pt x="5537892" y="416179"/>
                    <a:pt x="8087184" y="303430"/>
                  </a:cubicBezTo>
                  <a:lnTo>
                    <a:pt x="8087184" y="112753"/>
                  </a:lnTo>
                  <a:cubicBezTo>
                    <a:pt x="7278466" y="146573"/>
                    <a:pt x="6482453" y="325450"/>
                    <a:pt x="5736946" y="640864"/>
                  </a:cubicBezTo>
                  <a:close/>
                  <a:moveTo>
                    <a:pt x="4969330" y="3497453"/>
                  </a:moveTo>
                  <a:cubicBezTo>
                    <a:pt x="4076132" y="4389101"/>
                    <a:pt x="3568132" y="5595696"/>
                    <a:pt x="3554486" y="6858000"/>
                  </a:cubicBezTo>
                  <a:lnTo>
                    <a:pt x="3745072" y="6858000"/>
                  </a:lnTo>
                  <a:cubicBezTo>
                    <a:pt x="3773202" y="4431107"/>
                    <a:pt x="5666194" y="2436046"/>
                    <a:pt x="8087184" y="2281763"/>
                  </a:cubicBezTo>
                  <a:lnTo>
                    <a:pt x="8087184" y="2091086"/>
                  </a:lnTo>
                  <a:cubicBezTo>
                    <a:pt x="6910953" y="2162571"/>
                    <a:pt x="5801707" y="2662919"/>
                    <a:pt x="4969330" y="3497453"/>
                  </a:cubicBezTo>
                  <a:close/>
                  <a:moveTo>
                    <a:pt x="6086607" y="4615263"/>
                  </a:moveTo>
                  <a:cubicBezTo>
                    <a:pt x="5490118" y="5210739"/>
                    <a:pt x="5148633" y="6015070"/>
                    <a:pt x="5134441" y="6858000"/>
                  </a:cubicBezTo>
                  <a:lnTo>
                    <a:pt x="5325027" y="6858000"/>
                  </a:lnTo>
                  <a:cubicBezTo>
                    <a:pt x="5353570" y="5304190"/>
                    <a:pt x="6541217" y="4018292"/>
                    <a:pt x="8087184" y="3867302"/>
                  </a:cubicBezTo>
                  <a:lnTo>
                    <a:pt x="8087184" y="3675799"/>
                  </a:lnTo>
                  <a:cubicBezTo>
                    <a:pt x="7330940" y="3744977"/>
                    <a:pt x="6622978" y="4077447"/>
                    <a:pt x="6086607" y="4615263"/>
                  </a:cubicBezTo>
                  <a:close/>
                  <a:moveTo>
                    <a:pt x="5807081" y="4335604"/>
                  </a:moveTo>
                  <a:cubicBezTo>
                    <a:pt x="5136353" y="5005171"/>
                    <a:pt x="4753231" y="5910147"/>
                    <a:pt x="4739230" y="6858000"/>
                  </a:cubicBezTo>
                  <a:lnTo>
                    <a:pt x="4929815" y="6858000"/>
                  </a:lnTo>
                  <a:cubicBezTo>
                    <a:pt x="4958327" y="5085840"/>
                    <a:pt x="6322177" y="3622499"/>
                    <a:pt x="8087184" y="3470313"/>
                  </a:cubicBezTo>
                  <a:lnTo>
                    <a:pt x="8087184" y="3279192"/>
                  </a:lnTo>
                  <a:cubicBezTo>
                    <a:pt x="7225928" y="3349227"/>
                    <a:pt x="6417654" y="3723799"/>
                    <a:pt x="5807335" y="4335794"/>
                  </a:cubicBezTo>
                  <a:close/>
                  <a:moveTo>
                    <a:pt x="5527556" y="4055945"/>
                  </a:moveTo>
                  <a:cubicBezTo>
                    <a:pt x="4782753" y="4799672"/>
                    <a:pt x="4358160" y="5805294"/>
                    <a:pt x="4344463" y="6858000"/>
                  </a:cubicBezTo>
                  <a:lnTo>
                    <a:pt x="4535049" y="6858000"/>
                  </a:lnTo>
                  <a:cubicBezTo>
                    <a:pt x="4563415" y="4867661"/>
                    <a:pt x="6103486" y="3227074"/>
                    <a:pt x="8087184" y="3074024"/>
                  </a:cubicBezTo>
                  <a:lnTo>
                    <a:pt x="8087184" y="2882775"/>
                  </a:lnTo>
                  <a:cubicBezTo>
                    <a:pt x="7120852" y="2953516"/>
                    <a:pt x="6212355" y="3370126"/>
                    <a:pt x="5528000" y="4056326"/>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74" name="Google Shape;74;p10"/>
            <p:cNvSpPr/>
            <p:nvPr/>
          </p:nvSpPr>
          <p:spPr>
            <a:xfrm>
              <a:off x="2052402" y="0"/>
              <a:ext cx="6065388" cy="5143642"/>
            </a:xfrm>
            <a:custGeom>
              <a:avLst/>
              <a:gdLst/>
              <a:ahLst/>
              <a:cxnLst/>
              <a:rect l="l" t="t" r="r" b="b"/>
              <a:pathLst>
                <a:path w="8087184" h="6858190" extrusionOk="0">
                  <a:moveTo>
                    <a:pt x="6366259" y="1870219"/>
                  </a:moveTo>
                  <a:cubicBezTo>
                    <a:pt x="6414478" y="1849137"/>
                    <a:pt x="6436522" y="1792932"/>
                    <a:pt x="6415430" y="1744684"/>
                  </a:cubicBezTo>
                  <a:cubicBezTo>
                    <a:pt x="6395292" y="1698629"/>
                    <a:pt x="6342913" y="1676110"/>
                    <a:pt x="6295679" y="1693208"/>
                  </a:cubicBezTo>
                  <a:cubicBezTo>
                    <a:pt x="4468935" y="2426156"/>
                    <a:pt x="3157737" y="4060756"/>
                    <a:pt x="2838011" y="6003706"/>
                  </a:cubicBezTo>
                  <a:cubicBezTo>
                    <a:pt x="2829536" y="6055671"/>
                    <a:pt x="2864769" y="6104675"/>
                    <a:pt x="2916716" y="6113154"/>
                  </a:cubicBezTo>
                  <a:cubicBezTo>
                    <a:pt x="2916716" y="6113154"/>
                    <a:pt x="2916723" y="6113154"/>
                    <a:pt x="2916723" y="6113154"/>
                  </a:cubicBezTo>
                  <a:cubicBezTo>
                    <a:pt x="2921824" y="6114012"/>
                    <a:pt x="2926989" y="6114438"/>
                    <a:pt x="2932160" y="6114425"/>
                  </a:cubicBezTo>
                  <a:cubicBezTo>
                    <a:pt x="2978841" y="6114381"/>
                    <a:pt x="3018616" y="6080504"/>
                    <a:pt x="3026119" y="6034405"/>
                  </a:cubicBezTo>
                  <a:cubicBezTo>
                    <a:pt x="3335065" y="4157486"/>
                    <a:pt x="4601646" y="2578418"/>
                    <a:pt x="6366259" y="1870219"/>
                  </a:cubicBezTo>
                  <a:close/>
                  <a:moveTo>
                    <a:pt x="2680460" y="5322927"/>
                  </a:moveTo>
                  <a:cubicBezTo>
                    <a:pt x="2629555" y="5309637"/>
                    <a:pt x="2577512" y="5340139"/>
                    <a:pt x="2564203" y="5391062"/>
                  </a:cubicBezTo>
                  <a:cubicBezTo>
                    <a:pt x="2439623" y="5870239"/>
                    <a:pt x="2374272" y="6362877"/>
                    <a:pt x="2369615" y="6858000"/>
                  </a:cubicBezTo>
                  <a:lnTo>
                    <a:pt x="2560201" y="6858000"/>
                  </a:lnTo>
                  <a:cubicBezTo>
                    <a:pt x="2564794" y="6379148"/>
                    <a:pt x="2628055" y="5902679"/>
                    <a:pt x="2748563" y="5439240"/>
                  </a:cubicBezTo>
                  <a:cubicBezTo>
                    <a:pt x="2761847" y="5388310"/>
                    <a:pt x="2731365" y="5336243"/>
                    <a:pt x="2680460" y="5322927"/>
                  </a:cubicBezTo>
                  <a:close/>
                  <a:moveTo>
                    <a:pt x="2239000" y="4214715"/>
                  </a:moveTo>
                  <a:cubicBezTo>
                    <a:pt x="2190503" y="4194261"/>
                    <a:pt x="2134617" y="4217016"/>
                    <a:pt x="2114179" y="4265537"/>
                  </a:cubicBezTo>
                  <a:cubicBezTo>
                    <a:pt x="2114173" y="4265543"/>
                    <a:pt x="2114173" y="4265556"/>
                    <a:pt x="2114167" y="4265562"/>
                  </a:cubicBezTo>
                  <a:cubicBezTo>
                    <a:pt x="1767110" y="5087187"/>
                    <a:pt x="1587515" y="5959151"/>
                    <a:pt x="1579828" y="6858191"/>
                  </a:cubicBezTo>
                  <a:lnTo>
                    <a:pt x="1770414" y="6858191"/>
                  </a:lnTo>
                  <a:cubicBezTo>
                    <a:pt x="1778101" y="5984765"/>
                    <a:pt x="1952613" y="5137780"/>
                    <a:pt x="2289696" y="4339799"/>
                  </a:cubicBezTo>
                  <a:cubicBezTo>
                    <a:pt x="2310254" y="4291329"/>
                    <a:pt x="2287638" y="4235359"/>
                    <a:pt x="2239191" y="4214797"/>
                  </a:cubicBezTo>
                  <a:cubicBezTo>
                    <a:pt x="2239127" y="4214766"/>
                    <a:pt x="2239064" y="4214740"/>
                    <a:pt x="2239000" y="4214715"/>
                  </a:cubicBezTo>
                  <a:close/>
                  <a:moveTo>
                    <a:pt x="2087612" y="6428088"/>
                  </a:moveTo>
                  <a:cubicBezTo>
                    <a:pt x="2035093" y="6424847"/>
                    <a:pt x="1989898" y="6464825"/>
                    <a:pt x="1986665" y="6517389"/>
                  </a:cubicBezTo>
                  <a:cubicBezTo>
                    <a:pt x="1979740" y="6630078"/>
                    <a:pt x="1975738" y="6744357"/>
                    <a:pt x="1974658" y="6858000"/>
                  </a:cubicBezTo>
                  <a:lnTo>
                    <a:pt x="2165244" y="6858000"/>
                  </a:lnTo>
                  <a:cubicBezTo>
                    <a:pt x="2166260" y="6748234"/>
                    <a:pt x="2170135" y="6637896"/>
                    <a:pt x="2176806" y="6529083"/>
                  </a:cubicBezTo>
                  <a:cubicBezTo>
                    <a:pt x="2180027" y="6476584"/>
                    <a:pt x="2140105" y="6431330"/>
                    <a:pt x="2087612" y="6428088"/>
                  </a:cubicBezTo>
                  <a:close/>
                  <a:moveTo>
                    <a:pt x="3486447" y="3682663"/>
                  </a:moveTo>
                  <a:cubicBezTo>
                    <a:pt x="3518040" y="3682689"/>
                    <a:pt x="3547593" y="3667047"/>
                    <a:pt x="3565349" y="3640906"/>
                  </a:cubicBezTo>
                  <a:cubicBezTo>
                    <a:pt x="3898042" y="3151394"/>
                    <a:pt x="4303100" y="2715260"/>
                    <a:pt x="4766674" y="2347419"/>
                  </a:cubicBezTo>
                  <a:cubicBezTo>
                    <a:pt x="4807898" y="2314686"/>
                    <a:pt x="4814797" y="2254712"/>
                    <a:pt x="4782080" y="2213469"/>
                  </a:cubicBezTo>
                  <a:cubicBezTo>
                    <a:pt x="4749362" y="2172225"/>
                    <a:pt x="4689417" y="2165323"/>
                    <a:pt x="4648193" y="2198056"/>
                  </a:cubicBezTo>
                  <a:cubicBezTo>
                    <a:pt x="4169519" y="2577934"/>
                    <a:pt x="3751284" y="3028338"/>
                    <a:pt x="3407798" y="3533872"/>
                  </a:cubicBezTo>
                  <a:cubicBezTo>
                    <a:pt x="3378188" y="3577397"/>
                    <a:pt x="3389451" y="3636704"/>
                    <a:pt x="3432956" y="3666329"/>
                  </a:cubicBezTo>
                  <a:cubicBezTo>
                    <a:pt x="3448730" y="3677071"/>
                    <a:pt x="3467363" y="3682829"/>
                    <a:pt x="3486447" y="3682854"/>
                  </a:cubicBezTo>
                  <a:close/>
                  <a:moveTo>
                    <a:pt x="5285003" y="4471365"/>
                  </a:moveTo>
                  <a:cubicBezTo>
                    <a:pt x="5242903" y="4439770"/>
                    <a:pt x="5183174" y="4448313"/>
                    <a:pt x="5151593" y="4490433"/>
                  </a:cubicBezTo>
                  <a:cubicBezTo>
                    <a:pt x="4638429" y="5174034"/>
                    <a:pt x="4355873" y="6003210"/>
                    <a:pt x="4344781" y="6858064"/>
                  </a:cubicBezTo>
                  <a:lnTo>
                    <a:pt x="4535367" y="6858064"/>
                  </a:lnTo>
                  <a:cubicBezTo>
                    <a:pt x="4546427" y="6044479"/>
                    <a:pt x="4815610" y="5255459"/>
                    <a:pt x="5304062" y="4604903"/>
                  </a:cubicBezTo>
                  <a:cubicBezTo>
                    <a:pt x="5335661" y="4562795"/>
                    <a:pt x="5327161" y="4503030"/>
                    <a:pt x="5285074" y="4471416"/>
                  </a:cubicBezTo>
                  <a:cubicBezTo>
                    <a:pt x="5285048" y="4471403"/>
                    <a:pt x="5285029" y="4471384"/>
                    <a:pt x="5285003" y="4471365"/>
                  </a:cubicBezTo>
                  <a:close/>
                  <a:moveTo>
                    <a:pt x="6701690" y="2808030"/>
                  </a:moveTo>
                  <a:cubicBezTo>
                    <a:pt x="5767433" y="3193508"/>
                    <a:pt x="4991743" y="3885022"/>
                    <a:pt x="4501697" y="4769266"/>
                  </a:cubicBezTo>
                  <a:cubicBezTo>
                    <a:pt x="4475720" y="4815060"/>
                    <a:pt x="4491773" y="4873248"/>
                    <a:pt x="4537546" y="4899237"/>
                  </a:cubicBezTo>
                  <a:cubicBezTo>
                    <a:pt x="4583318" y="4925227"/>
                    <a:pt x="4641478" y="4909165"/>
                    <a:pt x="4667455" y="4863371"/>
                  </a:cubicBezTo>
                  <a:cubicBezTo>
                    <a:pt x="4667792" y="4862767"/>
                    <a:pt x="4668129" y="4862164"/>
                    <a:pt x="4668459" y="4861553"/>
                  </a:cubicBezTo>
                  <a:cubicBezTo>
                    <a:pt x="5137446" y="4015222"/>
                    <a:pt x="5879860" y="3353378"/>
                    <a:pt x="6774050" y="2984470"/>
                  </a:cubicBezTo>
                  <a:cubicBezTo>
                    <a:pt x="6822775" y="2964480"/>
                    <a:pt x="6846027" y="2908777"/>
                    <a:pt x="6826079" y="2860053"/>
                  </a:cubicBezTo>
                  <a:cubicBezTo>
                    <a:pt x="6806067" y="2811329"/>
                    <a:pt x="6750416" y="2788041"/>
                    <a:pt x="6701690" y="2808030"/>
                  </a:cubicBezTo>
                  <a:close/>
                  <a:moveTo>
                    <a:pt x="4156864" y="5925783"/>
                  </a:moveTo>
                  <a:cubicBezTo>
                    <a:pt x="4105367" y="5914933"/>
                    <a:pt x="4054824" y="5947901"/>
                    <a:pt x="4043980" y="5999428"/>
                  </a:cubicBezTo>
                  <a:cubicBezTo>
                    <a:pt x="4043973" y="5999435"/>
                    <a:pt x="4043973" y="5999441"/>
                    <a:pt x="4043973" y="5999447"/>
                  </a:cubicBezTo>
                  <a:cubicBezTo>
                    <a:pt x="3984905" y="6281916"/>
                    <a:pt x="3953267" y="6569443"/>
                    <a:pt x="3949506" y="6858000"/>
                  </a:cubicBezTo>
                  <a:lnTo>
                    <a:pt x="4140092" y="6858000"/>
                  </a:lnTo>
                  <a:cubicBezTo>
                    <a:pt x="4143866" y="6582600"/>
                    <a:pt x="4174143" y="6308242"/>
                    <a:pt x="4230493" y="6038663"/>
                  </a:cubicBezTo>
                  <a:cubicBezTo>
                    <a:pt x="4241299" y="5987155"/>
                    <a:pt x="4208341" y="5936626"/>
                    <a:pt x="4156864" y="5925783"/>
                  </a:cubicBezTo>
                  <a:close/>
                  <a:moveTo>
                    <a:pt x="5530160" y="2764810"/>
                  </a:moveTo>
                  <a:cubicBezTo>
                    <a:pt x="5974498" y="2457948"/>
                    <a:pt x="6465491" y="2225005"/>
                    <a:pt x="6984202" y="2075006"/>
                  </a:cubicBezTo>
                  <a:cubicBezTo>
                    <a:pt x="7034770" y="2060368"/>
                    <a:pt x="7063867" y="2007494"/>
                    <a:pt x="7049255" y="1956914"/>
                  </a:cubicBezTo>
                  <a:cubicBezTo>
                    <a:pt x="7034643" y="1906333"/>
                    <a:pt x="6981788" y="1877192"/>
                    <a:pt x="6931219" y="1891829"/>
                  </a:cubicBezTo>
                  <a:cubicBezTo>
                    <a:pt x="4715915" y="2532477"/>
                    <a:pt x="3182876" y="4551024"/>
                    <a:pt x="3159529" y="6858000"/>
                  </a:cubicBezTo>
                  <a:lnTo>
                    <a:pt x="3350115" y="6858000"/>
                  </a:lnTo>
                  <a:cubicBezTo>
                    <a:pt x="3368665" y="5220209"/>
                    <a:pt x="4181729" y="3693627"/>
                    <a:pt x="5530160" y="2764810"/>
                  </a:cubicBezTo>
                  <a:close/>
                  <a:moveTo>
                    <a:pt x="3857517" y="1312554"/>
                  </a:moveTo>
                  <a:cubicBezTo>
                    <a:pt x="2821278" y="2150298"/>
                    <a:pt x="2037615" y="3259196"/>
                    <a:pt x="1593677" y="4515920"/>
                  </a:cubicBezTo>
                  <a:cubicBezTo>
                    <a:pt x="1576137" y="4565572"/>
                    <a:pt x="1602146" y="4620055"/>
                    <a:pt x="1651774" y="4637604"/>
                  </a:cubicBezTo>
                  <a:cubicBezTo>
                    <a:pt x="1701402" y="4655152"/>
                    <a:pt x="1755859" y="4629131"/>
                    <a:pt x="1773399" y="4579479"/>
                  </a:cubicBezTo>
                  <a:cubicBezTo>
                    <a:pt x="2205610" y="3355958"/>
                    <a:pt x="2968581" y="2276360"/>
                    <a:pt x="3977459" y="1460773"/>
                  </a:cubicBezTo>
                  <a:cubicBezTo>
                    <a:pt x="4018371" y="1427634"/>
                    <a:pt x="4024686" y="1367596"/>
                    <a:pt x="3991562" y="1326664"/>
                  </a:cubicBezTo>
                  <a:cubicBezTo>
                    <a:pt x="3958439" y="1285732"/>
                    <a:pt x="3898430" y="1279414"/>
                    <a:pt x="3857517" y="1312554"/>
                  </a:cubicBezTo>
                  <a:close/>
                  <a:moveTo>
                    <a:pt x="2248403" y="2598095"/>
                  </a:moveTo>
                  <a:cubicBezTo>
                    <a:pt x="2204981" y="2568350"/>
                    <a:pt x="2145683" y="2579447"/>
                    <a:pt x="2115945" y="2622883"/>
                  </a:cubicBezTo>
                  <a:cubicBezTo>
                    <a:pt x="1635860" y="3322742"/>
                    <a:pt x="1277191" y="4098599"/>
                    <a:pt x="1055019" y="4917803"/>
                  </a:cubicBezTo>
                  <a:cubicBezTo>
                    <a:pt x="1039321" y="4968059"/>
                    <a:pt x="1067311" y="5021531"/>
                    <a:pt x="1117543" y="5037242"/>
                  </a:cubicBezTo>
                  <a:cubicBezTo>
                    <a:pt x="1167775" y="5052948"/>
                    <a:pt x="1221222" y="5024944"/>
                    <a:pt x="1236926" y="4974688"/>
                  </a:cubicBezTo>
                  <a:cubicBezTo>
                    <a:pt x="1237638" y="4972400"/>
                    <a:pt x="1238267" y="4970093"/>
                    <a:pt x="1238807" y="4967760"/>
                  </a:cubicBezTo>
                  <a:cubicBezTo>
                    <a:pt x="1455452" y="4169149"/>
                    <a:pt x="1805119" y="3412786"/>
                    <a:pt x="2273115" y="2730488"/>
                  </a:cubicBezTo>
                  <a:cubicBezTo>
                    <a:pt x="2302770" y="2687090"/>
                    <a:pt x="2291716" y="2627860"/>
                    <a:pt x="2248403" y="2598095"/>
                  </a:cubicBezTo>
                  <a:close/>
                  <a:moveTo>
                    <a:pt x="3182082" y="972450"/>
                  </a:moveTo>
                  <a:cubicBezTo>
                    <a:pt x="3216304" y="1012264"/>
                    <a:pt x="3276263" y="1016897"/>
                    <a:pt x="3316190" y="982811"/>
                  </a:cubicBezTo>
                  <a:cubicBezTo>
                    <a:pt x="3760979" y="601738"/>
                    <a:pt x="4247290" y="272053"/>
                    <a:pt x="4765912" y="0"/>
                  </a:cubicBezTo>
                  <a:lnTo>
                    <a:pt x="4372035" y="0"/>
                  </a:lnTo>
                  <a:cubicBezTo>
                    <a:pt x="3954366" y="243105"/>
                    <a:pt x="3559574" y="523572"/>
                    <a:pt x="3192500" y="837960"/>
                  </a:cubicBezTo>
                  <a:cubicBezTo>
                    <a:pt x="3152503" y="872186"/>
                    <a:pt x="3147814" y="932364"/>
                    <a:pt x="3182024" y="972381"/>
                  </a:cubicBezTo>
                  <a:cubicBezTo>
                    <a:pt x="3182043" y="972406"/>
                    <a:pt x="3182062" y="972425"/>
                    <a:pt x="3182082" y="972450"/>
                  </a:cubicBezTo>
                  <a:close/>
                  <a:moveTo>
                    <a:pt x="4503476" y="959103"/>
                  </a:moveTo>
                  <a:cubicBezTo>
                    <a:pt x="4531669" y="1003556"/>
                    <a:pt x="4590541" y="1016732"/>
                    <a:pt x="4634980" y="988531"/>
                  </a:cubicBezTo>
                  <a:cubicBezTo>
                    <a:pt x="5419589" y="490690"/>
                    <a:pt x="6295666" y="154609"/>
                    <a:pt x="7211824" y="0"/>
                  </a:cubicBezTo>
                  <a:lnTo>
                    <a:pt x="6361749" y="0"/>
                  </a:lnTo>
                  <a:cubicBezTo>
                    <a:pt x="5716216" y="188538"/>
                    <a:pt x="5100440" y="467098"/>
                    <a:pt x="4532571" y="827473"/>
                  </a:cubicBezTo>
                  <a:cubicBezTo>
                    <a:pt x="4488140" y="855680"/>
                    <a:pt x="4474970" y="914580"/>
                    <a:pt x="4503158" y="959040"/>
                  </a:cubicBezTo>
                  <a:close/>
                  <a:moveTo>
                    <a:pt x="4619923" y="423048"/>
                  </a:moveTo>
                  <a:cubicBezTo>
                    <a:pt x="4645786" y="468905"/>
                    <a:pt x="4703908" y="485105"/>
                    <a:pt x="4749744" y="459231"/>
                  </a:cubicBezTo>
                  <a:cubicBezTo>
                    <a:pt x="4749756" y="459225"/>
                    <a:pt x="4749763" y="459218"/>
                    <a:pt x="4749775" y="459213"/>
                  </a:cubicBezTo>
                  <a:cubicBezTo>
                    <a:pt x="5062406" y="282668"/>
                    <a:pt x="5387494" y="129190"/>
                    <a:pt x="5722461" y="0"/>
                  </a:cubicBezTo>
                  <a:lnTo>
                    <a:pt x="5231004" y="0"/>
                  </a:lnTo>
                  <a:cubicBezTo>
                    <a:pt x="5035419" y="89448"/>
                    <a:pt x="4843690" y="187160"/>
                    <a:pt x="4655817" y="293133"/>
                  </a:cubicBezTo>
                  <a:cubicBezTo>
                    <a:pt x="4609981" y="318991"/>
                    <a:pt x="4593775" y="377121"/>
                    <a:pt x="4619605" y="422984"/>
                  </a:cubicBezTo>
                  <a:close/>
                  <a:moveTo>
                    <a:pt x="1208440" y="3617579"/>
                  </a:moveTo>
                  <a:cubicBezTo>
                    <a:pt x="1160368" y="3596141"/>
                    <a:pt x="1104031" y="3617751"/>
                    <a:pt x="1082609" y="3665846"/>
                  </a:cubicBezTo>
                  <a:cubicBezTo>
                    <a:pt x="1082603" y="3665858"/>
                    <a:pt x="1082596" y="3665871"/>
                    <a:pt x="1082590" y="3665884"/>
                  </a:cubicBezTo>
                  <a:cubicBezTo>
                    <a:pt x="859205" y="4168380"/>
                    <a:pt x="688459" y="4692677"/>
                    <a:pt x="573091" y="5230385"/>
                  </a:cubicBezTo>
                  <a:cubicBezTo>
                    <a:pt x="458720" y="5765494"/>
                    <a:pt x="399119" y="6310867"/>
                    <a:pt x="395211" y="6858064"/>
                  </a:cubicBezTo>
                  <a:lnTo>
                    <a:pt x="585797" y="6858064"/>
                  </a:lnTo>
                  <a:cubicBezTo>
                    <a:pt x="589636" y="6324322"/>
                    <a:pt x="647724" y="5792347"/>
                    <a:pt x="759166" y="5270364"/>
                  </a:cubicBezTo>
                  <a:cubicBezTo>
                    <a:pt x="871732" y="4745641"/>
                    <a:pt x="1038323" y="4233992"/>
                    <a:pt x="1256277" y="3743616"/>
                  </a:cubicBezTo>
                  <a:cubicBezTo>
                    <a:pt x="1277788" y="3695566"/>
                    <a:pt x="1256296" y="3639157"/>
                    <a:pt x="1208262" y="3617637"/>
                  </a:cubicBezTo>
                  <a:cubicBezTo>
                    <a:pt x="1208173" y="3617598"/>
                    <a:pt x="1208084" y="3617554"/>
                    <a:pt x="1207995" y="3617516"/>
                  </a:cubicBezTo>
                  <a:close/>
                  <a:moveTo>
                    <a:pt x="942891" y="5974532"/>
                  </a:moveTo>
                  <a:cubicBezTo>
                    <a:pt x="890594" y="5968659"/>
                    <a:pt x="843443" y="6006305"/>
                    <a:pt x="837560" y="6058620"/>
                  </a:cubicBezTo>
                  <a:cubicBezTo>
                    <a:pt x="807861" y="6324074"/>
                    <a:pt x="791934" y="6590926"/>
                    <a:pt x="789850" y="6858000"/>
                  </a:cubicBezTo>
                  <a:lnTo>
                    <a:pt x="980436" y="6858000"/>
                  </a:lnTo>
                  <a:cubicBezTo>
                    <a:pt x="982494" y="6597917"/>
                    <a:pt x="998014" y="6338127"/>
                    <a:pt x="1026939" y="6079658"/>
                  </a:cubicBezTo>
                  <a:cubicBezTo>
                    <a:pt x="1032663" y="6027432"/>
                    <a:pt x="995073" y="5980418"/>
                    <a:pt x="942891" y="5974532"/>
                  </a:cubicBezTo>
                  <a:close/>
                  <a:moveTo>
                    <a:pt x="2329973" y="1389587"/>
                  </a:moveTo>
                  <a:cubicBezTo>
                    <a:pt x="2705198" y="978292"/>
                    <a:pt x="3121081" y="606057"/>
                    <a:pt x="3571258" y="278578"/>
                  </a:cubicBezTo>
                  <a:cubicBezTo>
                    <a:pt x="3704623" y="181588"/>
                    <a:pt x="3840892" y="88728"/>
                    <a:pt x="3980064" y="0"/>
                  </a:cubicBezTo>
                  <a:lnTo>
                    <a:pt x="3634913" y="0"/>
                  </a:lnTo>
                  <a:cubicBezTo>
                    <a:pt x="3575622" y="40678"/>
                    <a:pt x="3517049" y="82118"/>
                    <a:pt x="3459193" y="124321"/>
                  </a:cubicBezTo>
                  <a:cubicBezTo>
                    <a:pt x="2998611" y="459401"/>
                    <a:pt x="2573110" y="840261"/>
                    <a:pt x="2189194" y="1261071"/>
                  </a:cubicBezTo>
                  <a:cubicBezTo>
                    <a:pt x="2154101" y="1300312"/>
                    <a:pt x="2157449" y="1360585"/>
                    <a:pt x="2196671" y="1395695"/>
                  </a:cubicBezTo>
                  <a:cubicBezTo>
                    <a:pt x="2235354" y="1430316"/>
                    <a:pt x="2294613" y="1427602"/>
                    <a:pt x="2329973" y="1389587"/>
                  </a:cubicBezTo>
                  <a:close/>
                  <a:moveTo>
                    <a:pt x="557844" y="4174100"/>
                  </a:moveTo>
                  <a:cubicBezTo>
                    <a:pt x="507970" y="4157308"/>
                    <a:pt x="453932" y="4184143"/>
                    <a:pt x="437140" y="4234036"/>
                  </a:cubicBezTo>
                  <a:cubicBezTo>
                    <a:pt x="152879" y="5079865"/>
                    <a:pt x="5311" y="5965653"/>
                    <a:pt x="0" y="6858000"/>
                  </a:cubicBezTo>
                  <a:lnTo>
                    <a:pt x="190586" y="6858000"/>
                  </a:lnTo>
                  <a:cubicBezTo>
                    <a:pt x="195867" y="5986354"/>
                    <a:pt x="340068" y="5121127"/>
                    <a:pt x="617752" y="4294926"/>
                  </a:cubicBezTo>
                  <a:cubicBezTo>
                    <a:pt x="634569" y="4245032"/>
                    <a:pt x="607775" y="4190944"/>
                    <a:pt x="557905" y="4174119"/>
                  </a:cubicBezTo>
                  <a:cubicBezTo>
                    <a:pt x="557885" y="4174113"/>
                    <a:pt x="557865" y="4174107"/>
                    <a:pt x="557844" y="4174100"/>
                  </a:cubicBezTo>
                  <a:close/>
                  <a:moveTo>
                    <a:pt x="6996336" y="3748828"/>
                  </a:moveTo>
                  <a:cubicBezTo>
                    <a:pt x="7044554" y="3727644"/>
                    <a:pt x="7066407" y="3671388"/>
                    <a:pt x="7045253" y="3623172"/>
                  </a:cubicBezTo>
                  <a:cubicBezTo>
                    <a:pt x="7024098" y="3574957"/>
                    <a:pt x="6967875" y="3553048"/>
                    <a:pt x="6919656" y="3574232"/>
                  </a:cubicBezTo>
                  <a:cubicBezTo>
                    <a:pt x="5972433" y="3991121"/>
                    <a:pt x="5246340" y="4790323"/>
                    <a:pt x="4921684" y="5773368"/>
                  </a:cubicBezTo>
                  <a:cubicBezTo>
                    <a:pt x="4904569" y="5823161"/>
                    <a:pt x="4931042" y="5877408"/>
                    <a:pt x="4980810" y="5894524"/>
                  </a:cubicBezTo>
                  <a:cubicBezTo>
                    <a:pt x="5030578" y="5911647"/>
                    <a:pt x="5084800" y="5885162"/>
                    <a:pt x="5101914" y="5835370"/>
                  </a:cubicBezTo>
                  <a:cubicBezTo>
                    <a:pt x="5102175" y="5834601"/>
                    <a:pt x="5102429" y="5833826"/>
                    <a:pt x="5102677" y="5833050"/>
                  </a:cubicBezTo>
                  <a:cubicBezTo>
                    <a:pt x="5410415" y="4901366"/>
                    <a:pt x="6098595" y="4143936"/>
                    <a:pt x="6996336" y="3748828"/>
                  </a:cubicBezTo>
                  <a:close/>
                  <a:moveTo>
                    <a:pt x="6881984" y="5085281"/>
                  </a:moveTo>
                  <a:cubicBezTo>
                    <a:pt x="6913749" y="5127178"/>
                    <a:pt x="6973465" y="5135396"/>
                    <a:pt x="7015394" y="5103649"/>
                  </a:cubicBezTo>
                  <a:cubicBezTo>
                    <a:pt x="7328018" y="4865545"/>
                    <a:pt x="7697564" y="4713512"/>
                    <a:pt x="8087184" y="4662677"/>
                  </a:cubicBezTo>
                  <a:lnTo>
                    <a:pt x="8087184" y="4470349"/>
                  </a:lnTo>
                  <a:cubicBezTo>
                    <a:pt x="7655889" y="4522225"/>
                    <a:pt x="7246321" y="4688393"/>
                    <a:pt x="6900725" y="4951680"/>
                  </a:cubicBezTo>
                  <a:cubicBezTo>
                    <a:pt x="6858669" y="4983370"/>
                    <a:pt x="6850284" y="5043153"/>
                    <a:pt x="6881984" y="5085198"/>
                  </a:cubicBezTo>
                  <a:cubicBezTo>
                    <a:pt x="6881984" y="5085223"/>
                    <a:pt x="6882048" y="5085255"/>
                    <a:pt x="6882048" y="5085281"/>
                  </a:cubicBezTo>
                  <a:close/>
                  <a:moveTo>
                    <a:pt x="7499037" y="2661908"/>
                  </a:moveTo>
                  <a:cubicBezTo>
                    <a:pt x="7508693" y="2713633"/>
                    <a:pt x="7558373" y="2747770"/>
                    <a:pt x="7610085" y="2738179"/>
                  </a:cubicBezTo>
                  <a:cubicBezTo>
                    <a:pt x="7767635" y="2709126"/>
                    <a:pt x="7926711" y="2688972"/>
                    <a:pt x="8086549" y="2677798"/>
                  </a:cubicBezTo>
                  <a:lnTo>
                    <a:pt x="8086549" y="2486804"/>
                  </a:lnTo>
                  <a:cubicBezTo>
                    <a:pt x="7915022" y="2498295"/>
                    <a:pt x="7744257" y="2519689"/>
                    <a:pt x="7575208" y="2550871"/>
                  </a:cubicBezTo>
                  <a:cubicBezTo>
                    <a:pt x="7523559" y="2560577"/>
                    <a:pt x="7489572" y="2610235"/>
                    <a:pt x="7499101" y="2661908"/>
                  </a:cubicBezTo>
                  <a:close/>
                  <a:moveTo>
                    <a:pt x="7131080" y="4015712"/>
                  </a:moveTo>
                  <a:cubicBezTo>
                    <a:pt x="7150520" y="4064646"/>
                    <a:pt x="7205916" y="4088550"/>
                    <a:pt x="7254833" y="4069101"/>
                  </a:cubicBezTo>
                  <a:cubicBezTo>
                    <a:pt x="7254833" y="4069101"/>
                    <a:pt x="7254833" y="4069101"/>
                    <a:pt x="7254833" y="4069101"/>
                  </a:cubicBezTo>
                  <a:cubicBezTo>
                    <a:pt x="7521336" y="3962939"/>
                    <a:pt x="7801560" y="3895064"/>
                    <a:pt x="8087057" y="3867493"/>
                  </a:cubicBezTo>
                  <a:lnTo>
                    <a:pt x="8087057" y="3675799"/>
                  </a:lnTo>
                  <a:cubicBezTo>
                    <a:pt x="7777546" y="3704051"/>
                    <a:pt x="7473689" y="3776832"/>
                    <a:pt x="7184952" y="3891899"/>
                  </a:cubicBezTo>
                  <a:cubicBezTo>
                    <a:pt x="7135971" y="3911157"/>
                    <a:pt x="7111894" y="3966492"/>
                    <a:pt x="7131080" y="4015502"/>
                  </a:cubicBezTo>
                  <a:cubicBezTo>
                    <a:pt x="7131143" y="4015528"/>
                    <a:pt x="7131143" y="4015559"/>
                    <a:pt x="7131143" y="4015585"/>
                  </a:cubicBezTo>
                  <a:close/>
                  <a:moveTo>
                    <a:pt x="6365942" y="4894731"/>
                  </a:moveTo>
                  <a:cubicBezTo>
                    <a:pt x="5843642" y="5416174"/>
                    <a:pt x="5543800" y="6119929"/>
                    <a:pt x="5529462" y="6858000"/>
                  </a:cubicBezTo>
                  <a:lnTo>
                    <a:pt x="5720047" y="6858000"/>
                  </a:lnTo>
                  <a:cubicBezTo>
                    <a:pt x="5748705" y="5522515"/>
                    <a:pt x="6760391" y="4414194"/>
                    <a:pt x="8087184" y="4264799"/>
                  </a:cubicBezTo>
                  <a:lnTo>
                    <a:pt x="8087184" y="4072851"/>
                  </a:lnTo>
                  <a:cubicBezTo>
                    <a:pt x="7436207" y="4140993"/>
                    <a:pt x="6828557" y="4431203"/>
                    <a:pt x="6366259" y="4894731"/>
                  </a:cubicBezTo>
                  <a:close/>
                  <a:moveTo>
                    <a:pt x="4557220" y="3966771"/>
                  </a:moveTo>
                  <a:cubicBezTo>
                    <a:pt x="4259850" y="4352269"/>
                    <a:pt x="4022589" y="4780624"/>
                    <a:pt x="3853515" y="5237250"/>
                  </a:cubicBezTo>
                  <a:cubicBezTo>
                    <a:pt x="3835238" y="5286641"/>
                    <a:pt x="3860433" y="5341505"/>
                    <a:pt x="3909801" y="5359791"/>
                  </a:cubicBezTo>
                  <a:cubicBezTo>
                    <a:pt x="3959169" y="5378077"/>
                    <a:pt x="4014007" y="5352869"/>
                    <a:pt x="4032284" y="5303478"/>
                  </a:cubicBezTo>
                  <a:cubicBezTo>
                    <a:pt x="4669044" y="3583607"/>
                    <a:pt x="6257778" y="2399677"/>
                    <a:pt x="8087184" y="2281763"/>
                  </a:cubicBezTo>
                  <a:lnTo>
                    <a:pt x="8087184" y="2091086"/>
                  </a:lnTo>
                  <a:cubicBezTo>
                    <a:pt x="7191432" y="2144743"/>
                    <a:pt x="6328670" y="2448611"/>
                    <a:pt x="5596865" y="2968198"/>
                  </a:cubicBezTo>
                  <a:cubicBezTo>
                    <a:pt x="5202550" y="3247304"/>
                    <a:pt x="4852133" y="3583791"/>
                    <a:pt x="4557220" y="3966517"/>
                  </a:cubicBezTo>
                  <a:close/>
                  <a:moveTo>
                    <a:pt x="6932489" y="261735"/>
                  </a:moveTo>
                  <a:cubicBezTo>
                    <a:pt x="6468922" y="362681"/>
                    <a:pt x="6017234" y="512059"/>
                    <a:pt x="5584858" y="707410"/>
                  </a:cubicBezTo>
                  <a:cubicBezTo>
                    <a:pt x="5536862" y="729014"/>
                    <a:pt x="5515466" y="785454"/>
                    <a:pt x="5537059" y="833473"/>
                  </a:cubicBezTo>
                  <a:cubicBezTo>
                    <a:pt x="5558659" y="881491"/>
                    <a:pt x="5615073" y="902898"/>
                    <a:pt x="5663062" y="881294"/>
                  </a:cubicBezTo>
                  <a:cubicBezTo>
                    <a:pt x="5663151" y="881256"/>
                    <a:pt x="5663234" y="881218"/>
                    <a:pt x="5663316" y="881180"/>
                  </a:cubicBezTo>
                  <a:cubicBezTo>
                    <a:pt x="6083519" y="691317"/>
                    <a:pt x="6522476" y="546157"/>
                    <a:pt x="6973021" y="448090"/>
                  </a:cubicBezTo>
                  <a:cubicBezTo>
                    <a:pt x="7339644" y="368564"/>
                    <a:pt x="7712366" y="320214"/>
                    <a:pt x="8087184" y="303557"/>
                  </a:cubicBezTo>
                  <a:lnTo>
                    <a:pt x="8087184" y="112881"/>
                  </a:lnTo>
                  <a:cubicBezTo>
                    <a:pt x="7698771" y="129641"/>
                    <a:pt x="7312454" y="179439"/>
                    <a:pt x="6932489" y="261735"/>
                  </a:cubicBezTo>
                  <a:close/>
                  <a:moveTo>
                    <a:pt x="7678505" y="1431218"/>
                  </a:moveTo>
                  <a:cubicBezTo>
                    <a:pt x="7684286" y="1483553"/>
                    <a:pt x="7731361" y="1521288"/>
                    <a:pt x="7783708" y="1515497"/>
                  </a:cubicBezTo>
                  <a:cubicBezTo>
                    <a:pt x="7783708" y="1515497"/>
                    <a:pt x="7783708" y="1515497"/>
                    <a:pt x="7783708" y="1515497"/>
                  </a:cubicBezTo>
                  <a:cubicBezTo>
                    <a:pt x="7883957" y="1504438"/>
                    <a:pt x="7985284" y="1496430"/>
                    <a:pt x="8086866" y="1490582"/>
                  </a:cubicBezTo>
                  <a:lnTo>
                    <a:pt x="8086866" y="1299906"/>
                  </a:lnTo>
                  <a:cubicBezTo>
                    <a:pt x="7978233" y="1305689"/>
                    <a:pt x="7869917" y="1314397"/>
                    <a:pt x="7762871" y="1326283"/>
                  </a:cubicBezTo>
                  <a:cubicBezTo>
                    <a:pt x="7710778" y="1332016"/>
                    <a:pt x="7673105" y="1378750"/>
                    <a:pt x="7678505" y="1430901"/>
                  </a:cubicBezTo>
                  <a:close/>
                  <a:moveTo>
                    <a:pt x="5303173" y="1289991"/>
                  </a:moveTo>
                  <a:cubicBezTo>
                    <a:pt x="4389549" y="1793110"/>
                    <a:pt x="3611369" y="2510187"/>
                    <a:pt x="3035203" y="3379869"/>
                  </a:cubicBezTo>
                  <a:cubicBezTo>
                    <a:pt x="3007435" y="3424596"/>
                    <a:pt x="3021164" y="3483375"/>
                    <a:pt x="3065869" y="3511163"/>
                  </a:cubicBezTo>
                  <a:cubicBezTo>
                    <a:pt x="3108738" y="3537807"/>
                    <a:pt x="3164935" y="3526385"/>
                    <a:pt x="3194025" y="3485123"/>
                  </a:cubicBezTo>
                  <a:cubicBezTo>
                    <a:pt x="3753101" y="2641067"/>
                    <a:pt x="4508272" y="1945117"/>
                    <a:pt x="5394908" y="1456833"/>
                  </a:cubicBezTo>
                  <a:cubicBezTo>
                    <a:pt x="6222818" y="1002126"/>
                    <a:pt x="7143722" y="742952"/>
                    <a:pt x="8087184" y="699147"/>
                  </a:cubicBezTo>
                  <a:lnTo>
                    <a:pt x="8087184" y="508471"/>
                  </a:lnTo>
                  <a:cubicBezTo>
                    <a:pt x="7111767" y="552630"/>
                    <a:pt x="6159410" y="820081"/>
                    <a:pt x="5303490" y="1290245"/>
                  </a:cubicBezTo>
                  <a:close/>
                  <a:moveTo>
                    <a:pt x="6957138" y="1164907"/>
                  </a:moveTo>
                  <a:cubicBezTo>
                    <a:pt x="6968955" y="1216211"/>
                    <a:pt x="7020159" y="1248207"/>
                    <a:pt x="7071426" y="1236366"/>
                  </a:cubicBezTo>
                  <a:cubicBezTo>
                    <a:pt x="7071426" y="1236360"/>
                    <a:pt x="7071490" y="1236353"/>
                    <a:pt x="7071490" y="1236347"/>
                  </a:cubicBezTo>
                  <a:cubicBezTo>
                    <a:pt x="7405269" y="1159485"/>
                    <a:pt x="7745147" y="1112083"/>
                    <a:pt x="8087184" y="1094674"/>
                  </a:cubicBezTo>
                  <a:lnTo>
                    <a:pt x="8087184" y="903998"/>
                  </a:lnTo>
                  <a:cubicBezTo>
                    <a:pt x="7730789" y="921355"/>
                    <a:pt x="7376618" y="970277"/>
                    <a:pt x="7028862" y="1050183"/>
                  </a:cubicBezTo>
                  <a:cubicBezTo>
                    <a:pt x="6977531" y="1061859"/>
                    <a:pt x="6945386" y="1112941"/>
                    <a:pt x="6957075" y="1164284"/>
                  </a:cubicBezTo>
                  <a:cubicBezTo>
                    <a:pt x="6957075" y="1164385"/>
                    <a:pt x="6957138" y="1164487"/>
                    <a:pt x="6957138" y="1164589"/>
                  </a:cubicBezTo>
                  <a:close/>
                  <a:moveTo>
                    <a:pt x="7810517" y="5550150"/>
                  </a:moveTo>
                  <a:cubicBezTo>
                    <a:pt x="7858989" y="5529652"/>
                    <a:pt x="7881733" y="5473708"/>
                    <a:pt x="7861214" y="5425193"/>
                  </a:cubicBezTo>
                  <a:cubicBezTo>
                    <a:pt x="7840693" y="5376679"/>
                    <a:pt x="7784789" y="5353975"/>
                    <a:pt x="7736316" y="5374473"/>
                  </a:cubicBezTo>
                  <a:cubicBezTo>
                    <a:pt x="7136099" y="5627692"/>
                    <a:pt x="6737457" y="6206655"/>
                    <a:pt x="6714968" y="6858000"/>
                  </a:cubicBezTo>
                  <a:lnTo>
                    <a:pt x="6905553" y="6858000"/>
                  </a:lnTo>
                  <a:cubicBezTo>
                    <a:pt x="6927979" y="6283212"/>
                    <a:pt x="7280753" y="5773292"/>
                    <a:pt x="7810517" y="5549832"/>
                  </a:cubicBezTo>
                  <a:close/>
                  <a:moveTo>
                    <a:pt x="6090863" y="6328301"/>
                  </a:moveTo>
                  <a:cubicBezTo>
                    <a:pt x="6039456" y="6317477"/>
                    <a:pt x="5988995" y="6350311"/>
                    <a:pt x="5978037" y="6401711"/>
                  </a:cubicBezTo>
                  <a:cubicBezTo>
                    <a:pt x="5946202" y="6551837"/>
                    <a:pt x="5928338" y="6704569"/>
                    <a:pt x="5924672" y="6858000"/>
                  </a:cubicBezTo>
                  <a:lnTo>
                    <a:pt x="6115258" y="6858000"/>
                  </a:lnTo>
                  <a:cubicBezTo>
                    <a:pt x="6118847" y="6717916"/>
                    <a:pt x="6135282" y="6578469"/>
                    <a:pt x="6164366" y="6441372"/>
                  </a:cubicBezTo>
                  <a:cubicBezTo>
                    <a:pt x="6175293" y="6389889"/>
                    <a:pt x="6142417" y="6339252"/>
                    <a:pt x="6090933" y="6328313"/>
                  </a:cubicBezTo>
                  <a:cubicBezTo>
                    <a:pt x="6090914" y="6328313"/>
                    <a:pt x="6090888" y="6328307"/>
                    <a:pt x="6090863" y="6328301"/>
                  </a:cubicBezTo>
                  <a:close/>
                  <a:moveTo>
                    <a:pt x="5637269" y="5359219"/>
                  </a:moveTo>
                  <a:cubicBezTo>
                    <a:pt x="5590722" y="5334641"/>
                    <a:pt x="5533083" y="5352469"/>
                    <a:pt x="5508516" y="5399039"/>
                  </a:cubicBezTo>
                  <a:cubicBezTo>
                    <a:pt x="5508510" y="5399045"/>
                    <a:pt x="5508503" y="5399058"/>
                    <a:pt x="5508497" y="5399071"/>
                  </a:cubicBezTo>
                  <a:cubicBezTo>
                    <a:pt x="5271929" y="5849588"/>
                    <a:pt x="5143862" y="6349180"/>
                    <a:pt x="5134504" y="6858000"/>
                  </a:cubicBezTo>
                  <a:lnTo>
                    <a:pt x="5325090" y="6858000"/>
                  </a:lnTo>
                  <a:cubicBezTo>
                    <a:pt x="5334410" y="6380165"/>
                    <a:pt x="5454936" y="5911126"/>
                    <a:pt x="5677102" y="5488053"/>
                  </a:cubicBezTo>
                  <a:cubicBezTo>
                    <a:pt x="5701668" y="5441483"/>
                    <a:pt x="5683849" y="5383816"/>
                    <a:pt x="5637301" y="5359238"/>
                  </a:cubicBezTo>
                  <a:cubicBezTo>
                    <a:pt x="5637295" y="5359232"/>
                    <a:pt x="5637282" y="5359225"/>
                    <a:pt x="5637269" y="5359219"/>
                  </a:cubicBezTo>
                  <a:close/>
                  <a:moveTo>
                    <a:pt x="6804289" y="5734216"/>
                  </a:moveTo>
                  <a:cubicBezTo>
                    <a:pt x="6760771" y="5704725"/>
                    <a:pt x="6701563" y="5716108"/>
                    <a:pt x="6672022" y="5759640"/>
                  </a:cubicBezTo>
                  <a:cubicBezTo>
                    <a:pt x="6452404" y="6084724"/>
                    <a:pt x="6330169" y="6465778"/>
                    <a:pt x="6319630" y="6858000"/>
                  </a:cubicBezTo>
                  <a:lnTo>
                    <a:pt x="6510215" y="6858000"/>
                  </a:lnTo>
                  <a:cubicBezTo>
                    <a:pt x="6520761" y="6503851"/>
                    <a:pt x="6631618" y="6160023"/>
                    <a:pt x="6829891" y="5866482"/>
                  </a:cubicBezTo>
                  <a:cubicBezTo>
                    <a:pt x="6859177" y="5822913"/>
                    <a:pt x="6847679" y="5763873"/>
                    <a:pt x="6804289" y="5734407"/>
                  </a:cubicBezTo>
                  <a:close/>
                  <a:moveTo>
                    <a:pt x="4904404" y="6204806"/>
                  </a:moveTo>
                  <a:cubicBezTo>
                    <a:pt x="4852571" y="6195698"/>
                    <a:pt x="4803171" y="6230357"/>
                    <a:pt x="4794068" y="6282220"/>
                  </a:cubicBezTo>
                  <a:cubicBezTo>
                    <a:pt x="4794061" y="6282240"/>
                    <a:pt x="4794061" y="6282265"/>
                    <a:pt x="4794055" y="6282284"/>
                  </a:cubicBezTo>
                  <a:cubicBezTo>
                    <a:pt x="4760766" y="6472452"/>
                    <a:pt x="4742432" y="6664972"/>
                    <a:pt x="4739230" y="6858000"/>
                  </a:cubicBezTo>
                  <a:lnTo>
                    <a:pt x="4929815" y="6858000"/>
                  </a:lnTo>
                  <a:cubicBezTo>
                    <a:pt x="4932922" y="6676031"/>
                    <a:pt x="4950189" y="6494507"/>
                    <a:pt x="4981464" y="6315208"/>
                  </a:cubicBezTo>
                  <a:cubicBezTo>
                    <a:pt x="4990587" y="6263445"/>
                    <a:pt x="4956116" y="6214067"/>
                    <a:pt x="4904404" y="6204806"/>
                  </a:cubicBezTo>
                  <a:close/>
                  <a:moveTo>
                    <a:pt x="7902253" y="6858000"/>
                  </a:moveTo>
                  <a:lnTo>
                    <a:pt x="8087184" y="6858000"/>
                  </a:lnTo>
                  <a:lnTo>
                    <a:pt x="8087184" y="6532261"/>
                  </a:lnTo>
                  <a:cubicBezTo>
                    <a:pt x="7984903" y="6612091"/>
                    <a:pt x="7918389" y="6729230"/>
                    <a:pt x="7902253" y="6858000"/>
                  </a:cubicBezTo>
                  <a:close/>
                  <a:moveTo>
                    <a:pt x="7565551" y="6591561"/>
                  </a:moveTo>
                  <a:cubicBezTo>
                    <a:pt x="7546175" y="6640502"/>
                    <a:pt x="7570062" y="6695925"/>
                    <a:pt x="7619043" y="6715311"/>
                  </a:cubicBezTo>
                  <a:cubicBezTo>
                    <a:pt x="7667959" y="6734760"/>
                    <a:pt x="7723356" y="6710798"/>
                    <a:pt x="7742733" y="6661858"/>
                  </a:cubicBezTo>
                  <a:cubicBezTo>
                    <a:pt x="7807341" y="6499910"/>
                    <a:pt x="7930205" y="6368089"/>
                    <a:pt x="8087184" y="6292326"/>
                  </a:cubicBezTo>
                  <a:lnTo>
                    <a:pt x="8087184" y="6085760"/>
                  </a:lnTo>
                  <a:cubicBezTo>
                    <a:pt x="7849270" y="6172245"/>
                    <a:pt x="7659700" y="6356394"/>
                    <a:pt x="7566250" y="6591752"/>
                  </a:cubicBezTo>
                  <a:close/>
                  <a:moveTo>
                    <a:pt x="7109989" y="6858000"/>
                  </a:moveTo>
                  <a:lnTo>
                    <a:pt x="7300574" y="6858000"/>
                  </a:lnTo>
                  <a:cubicBezTo>
                    <a:pt x="7326176" y="6394974"/>
                    <a:pt x="7641722" y="5998774"/>
                    <a:pt x="8087184" y="5870486"/>
                  </a:cubicBezTo>
                  <a:lnTo>
                    <a:pt x="8087184" y="5673454"/>
                  </a:lnTo>
                  <a:cubicBezTo>
                    <a:pt x="7534740" y="5807487"/>
                    <a:pt x="7136797" y="6289898"/>
                    <a:pt x="7109989" y="6858000"/>
                  </a:cubicBezTo>
                  <a:close/>
                  <a:moveTo>
                    <a:pt x="6578000" y="3403894"/>
                  </a:moveTo>
                  <a:cubicBezTo>
                    <a:pt x="6600998" y="3451093"/>
                    <a:pt x="6657792" y="3470809"/>
                    <a:pt x="6705057" y="3448004"/>
                  </a:cubicBezTo>
                  <a:cubicBezTo>
                    <a:pt x="7047794" y="3281442"/>
                    <a:pt x="7413527" y="3167030"/>
                    <a:pt x="7790061" y="3108536"/>
                  </a:cubicBezTo>
                  <a:cubicBezTo>
                    <a:pt x="7841964" y="3099632"/>
                    <a:pt x="7876778" y="3050348"/>
                    <a:pt x="7867884" y="2998453"/>
                  </a:cubicBezTo>
                  <a:cubicBezTo>
                    <a:pt x="7859180" y="2947694"/>
                    <a:pt x="7811725" y="2913029"/>
                    <a:pt x="7760775" y="2920148"/>
                  </a:cubicBezTo>
                  <a:cubicBezTo>
                    <a:pt x="7365500" y="2981527"/>
                    <a:pt x="6981597" y="3101621"/>
                    <a:pt x="6621771" y="3276459"/>
                  </a:cubicBezTo>
                  <a:cubicBezTo>
                    <a:pt x="6574506" y="3299582"/>
                    <a:pt x="6554940" y="3356607"/>
                    <a:pt x="6578000" y="3403894"/>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sp>
          <p:nvSpPr>
            <p:cNvPr id="75" name="Google Shape;75;p10"/>
            <p:cNvSpPr/>
            <p:nvPr/>
          </p:nvSpPr>
          <p:spPr>
            <a:xfrm>
              <a:off x="2377837" y="210583"/>
              <a:ext cx="5576288" cy="4831090"/>
            </a:xfrm>
            <a:custGeom>
              <a:avLst/>
              <a:gdLst/>
              <a:ahLst/>
              <a:cxnLst/>
              <a:rect l="l" t="t" r="r" b="b"/>
              <a:pathLst>
                <a:path w="7435051" h="6441453" extrusionOk="0">
                  <a:moveTo>
                    <a:pt x="2213120" y="5039472"/>
                  </a:moveTo>
                  <a:cubicBezTo>
                    <a:pt x="2095083" y="5051103"/>
                    <a:pt x="2103850" y="5229704"/>
                    <a:pt x="2222458" y="5229704"/>
                  </a:cubicBezTo>
                  <a:cubicBezTo>
                    <a:pt x="2353073" y="5228178"/>
                    <a:pt x="2343290" y="5028222"/>
                    <a:pt x="2213120" y="5039472"/>
                  </a:cubicBezTo>
                  <a:close/>
                  <a:moveTo>
                    <a:pt x="1816257" y="949650"/>
                  </a:moveTo>
                  <a:cubicBezTo>
                    <a:pt x="1698221" y="961282"/>
                    <a:pt x="1706988" y="1139882"/>
                    <a:pt x="1825595" y="1139882"/>
                  </a:cubicBezTo>
                  <a:cubicBezTo>
                    <a:pt x="1956274" y="1138420"/>
                    <a:pt x="1946427" y="938337"/>
                    <a:pt x="1816257" y="949650"/>
                  </a:cubicBezTo>
                  <a:close/>
                  <a:moveTo>
                    <a:pt x="1657435" y="6147620"/>
                  </a:moveTo>
                  <a:cubicBezTo>
                    <a:pt x="1527329" y="6136180"/>
                    <a:pt x="1517673" y="6336390"/>
                    <a:pt x="1648097" y="6337788"/>
                  </a:cubicBezTo>
                  <a:cubicBezTo>
                    <a:pt x="1766514" y="6337916"/>
                    <a:pt x="1775281" y="6159125"/>
                    <a:pt x="1657181" y="6147620"/>
                  </a:cubicBezTo>
                  <a:close/>
                  <a:moveTo>
                    <a:pt x="1777377" y="3926811"/>
                  </a:moveTo>
                  <a:cubicBezTo>
                    <a:pt x="1647271" y="3915307"/>
                    <a:pt x="1637614" y="4115517"/>
                    <a:pt x="1767975" y="4116979"/>
                  </a:cubicBezTo>
                  <a:cubicBezTo>
                    <a:pt x="1886583" y="4117487"/>
                    <a:pt x="1895477" y="3938442"/>
                    <a:pt x="1777377" y="3926811"/>
                  </a:cubicBezTo>
                  <a:close/>
                  <a:moveTo>
                    <a:pt x="2671541" y="3056499"/>
                  </a:moveTo>
                  <a:cubicBezTo>
                    <a:pt x="2553506" y="3068131"/>
                    <a:pt x="2562336" y="3246731"/>
                    <a:pt x="2680944" y="3246731"/>
                  </a:cubicBezTo>
                  <a:cubicBezTo>
                    <a:pt x="2811558" y="3245206"/>
                    <a:pt x="2801712" y="3045186"/>
                    <a:pt x="2671541" y="3056499"/>
                  </a:cubicBezTo>
                  <a:close/>
                  <a:moveTo>
                    <a:pt x="3043247" y="3211646"/>
                  </a:moveTo>
                  <a:cubicBezTo>
                    <a:pt x="2925148" y="3223278"/>
                    <a:pt x="2933978" y="3401878"/>
                    <a:pt x="3052649" y="3401878"/>
                  </a:cubicBezTo>
                  <a:cubicBezTo>
                    <a:pt x="3183264" y="3400289"/>
                    <a:pt x="3173354" y="3200333"/>
                    <a:pt x="3043247" y="3211646"/>
                  </a:cubicBezTo>
                  <a:close/>
                  <a:moveTo>
                    <a:pt x="3483564" y="1201216"/>
                  </a:moveTo>
                  <a:cubicBezTo>
                    <a:pt x="3602171" y="1201216"/>
                    <a:pt x="3611002" y="1022616"/>
                    <a:pt x="3492902" y="1010985"/>
                  </a:cubicBezTo>
                  <a:cubicBezTo>
                    <a:pt x="3362796" y="999608"/>
                    <a:pt x="3352949" y="1199627"/>
                    <a:pt x="3483564" y="1201216"/>
                  </a:cubicBezTo>
                  <a:close/>
                  <a:moveTo>
                    <a:pt x="3518314" y="4894812"/>
                  </a:moveTo>
                  <a:cubicBezTo>
                    <a:pt x="3388207" y="4883499"/>
                    <a:pt x="3378551" y="5083518"/>
                    <a:pt x="3508975" y="5085044"/>
                  </a:cubicBezTo>
                  <a:cubicBezTo>
                    <a:pt x="3627646" y="5085044"/>
                    <a:pt x="3636413" y="4906507"/>
                    <a:pt x="3518314" y="4894812"/>
                  </a:cubicBezTo>
                  <a:close/>
                  <a:moveTo>
                    <a:pt x="2488770" y="5643408"/>
                  </a:moveTo>
                  <a:cubicBezTo>
                    <a:pt x="2370670" y="5655039"/>
                    <a:pt x="2379501" y="5833576"/>
                    <a:pt x="2498109" y="5833640"/>
                  </a:cubicBezTo>
                  <a:cubicBezTo>
                    <a:pt x="2628723" y="5832115"/>
                    <a:pt x="2619003" y="5632095"/>
                    <a:pt x="2488770" y="5643408"/>
                  </a:cubicBezTo>
                  <a:close/>
                  <a:moveTo>
                    <a:pt x="1258984" y="4171957"/>
                  </a:moveTo>
                  <a:cubicBezTo>
                    <a:pt x="1128878" y="4160580"/>
                    <a:pt x="1118904" y="4360664"/>
                    <a:pt x="1249582" y="4362189"/>
                  </a:cubicBezTo>
                  <a:cubicBezTo>
                    <a:pt x="1368253" y="4362253"/>
                    <a:pt x="1377084" y="4183652"/>
                    <a:pt x="1258984" y="4171957"/>
                  </a:cubicBezTo>
                  <a:close/>
                  <a:moveTo>
                    <a:pt x="4268713" y="190694"/>
                  </a:moveTo>
                  <a:cubicBezTo>
                    <a:pt x="4399327" y="189105"/>
                    <a:pt x="4389417" y="-10851"/>
                    <a:pt x="4259311" y="463"/>
                  </a:cubicBezTo>
                  <a:cubicBezTo>
                    <a:pt x="4141211" y="12157"/>
                    <a:pt x="4150041" y="190758"/>
                    <a:pt x="4268713" y="190694"/>
                  </a:cubicBezTo>
                  <a:close/>
                  <a:moveTo>
                    <a:pt x="6303786" y="2710803"/>
                  </a:moveTo>
                  <a:cubicBezTo>
                    <a:pt x="6422394" y="2710803"/>
                    <a:pt x="6431225" y="2532266"/>
                    <a:pt x="6313189" y="2520571"/>
                  </a:cubicBezTo>
                  <a:cubicBezTo>
                    <a:pt x="6183082" y="2509448"/>
                    <a:pt x="6173045" y="2709341"/>
                    <a:pt x="6303786" y="2710803"/>
                  </a:cubicBezTo>
                  <a:close/>
                  <a:moveTo>
                    <a:pt x="2820516" y="724970"/>
                  </a:moveTo>
                  <a:cubicBezTo>
                    <a:pt x="2951131" y="723445"/>
                    <a:pt x="2941220" y="523425"/>
                    <a:pt x="2811177" y="534738"/>
                  </a:cubicBezTo>
                  <a:cubicBezTo>
                    <a:pt x="2693141" y="546370"/>
                    <a:pt x="2701908" y="724906"/>
                    <a:pt x="2820516" y="724970"/>
                  </a:cubicBezTo>
                  <a:close/>
                  <a:moveTo>
                    <a:pt x="7332377" y="2638663"/>
                  </a:moveTo>
                  <a:cubicBezTo>
                    <a:pt x="7214341" y="2650358"/>
                    <a:pt x="7223172" y="2828959"/>
                    <a:pt x="7341779" y="2828895"/>
                  </a:cubicBezTo>
                  <a:cubicBezTo>
                    <a:pt x="7472394" y="2827243"/>
                    <a:pt x="7462674" y="2627414"/>
                    <a:pt x="7332377" y="2638663"/>
                  </a:cubicBezTo>
                  <a:close/>
                  <a:moveTo>
                    <a:pt x="7339301" y="1234966"/>
                  </a:moveTo>
                  <a:cubicBezTo>
                    <a:pt x="7469916" y="1233504"/>
                    <a:pt x="7460006" y="1033421"/>
                    <a:pt x="7329899" y="1044798"/>
                  </a:cubicBezTo>
                  <a:cubicBezTo>
                    <a:pt x="7211864" y="1056302"/>
                    <a:pt x="7220694" y="1235157"/>
                    <a:pt x="7339301" y="1234966"/>
                  </a:cubicBezTo>
                  <a:close/>
                  <a:moveTo>
                    <a:pt x="84087" y="3888675"/>
                  </a:moveTo>
                  <a:cubicBezTo>
                    <a:pt x="-33695" y="3900434"/>
                    <a:pt x="-25118" y="4079352"/>
                    <a:pt x="93362" y="4079352"/>
                  </a:cubicBezTo>
                  <a:cubicBezTo>
                    <a:pt x="224104" y="4077445"/>
                    <a:pt x="214067" y="3877425"/>
                    <a:pt x="84087" y="3888675"/>
                  </a:cubicBezTo>
                  <a:close/>
                  <a:moveTo>
                    <a:pt x="488955" y="5693238"/>
                  </a:moveTo>
                  <a:cubicBezTo>
                    <a:pt x="370919" y="5704679"/>
                    <a:pt x="379686" y="5883470"/>
                    <a:pt x="498293" y="5883407"/>
                  </a:cubicBezTo>
                  <a:cubicBezTo>
                    <a:pt x="628908" y="5882135"/>
                    <a:pt x="619125" y="5681925"/>
                    <a:pt x="488955" y="5693366"/>
                  </a:cubicBezTo>
                  <a:close/>
                  <a:moveTo>
                    <a:pt x="722295" y="4567103"/>
                  </a:moveTo>
                  <a:cubicBezTo>
                    <a:pt x="592125" y="4555789"/>
                    <a:pt x="582532" y="4755682"/>
                    <a:pt x="712893" y="4757334"/>
                  </a:cubicBezTo>
                  <a:cubicBezTo>
                    <a:pt x="831501" y="4757334"/>
                    <a:pt x="840458" y="4578734"/>
                    <a:pt x="722295" y="4567103"/>
                  </a:cubicBezTo>
                  <a:close/>
                  <a:moveTo>
                    <a:pt x="1760606" y="2491334"/>
                  </a:moveTo>
                  <a:cubicBezTo>
                    <a:pt x="1891220" y="2489745"/>
                    <a:pt x="1881310" y="2289725"/>
                    <a:pt x="1751203" y="2301102"/>
                  </a:cubicBezTo>
                  <a:cubicBezTo>
                    <a:pt x="1633104" y="2312734"/>
                    <a:pt x="1641998" y="2491334"/>
                    <a:pt x="1760606" y="2491334"/>
                  </a:cubicBezTo>
                  <a:close/>
                  <a:moveTo>
                    <a:pt x="744657" y="3328976"/>
                  </a:moveTo>
                  <a:cubicBezTo>
                    <a:pt x="614551" y="3317536"/>
                    <a:pt x="604894" y="3517682"/>
                    <a:pt x="735255" y="3519144"/>
                  </a:cubicBezTo>
                  <a:cubicBezTo>
                    <a:pt x="853926" y="3519335"/>
                    <a:pt x="862820" y="3340544"/>
                    <a:pt x="744657" y="3328976"/>
                  </a:cubicBezTo>
                  <a:close/>
                  <a:moveTo>
                    <a:pt x="4587626" y="5427499"/>
                  </a:moveTo>
                  <a:cubicBezTo>
                    <a:pt x="4457774" y="5416058"/>
                    <a:pt x="4447546" y="5616269"/>
                    <a:pt x="4578478" y="5617476"/>
                  </a:cubicBezTo>
                  <a:cubicBezTo>
                    <a:pt x="4696832" y="5617858"/>
                    <a:pt x="4705535" y="5439067"/>
                    <a:pt x="4587626" y="5427499"/>
                  </a:cubicBezTo>
                  <a:close/>
                  <a:moveTo>
                    <a:pt x="6524040" y="3476242"/>
                  </a:moveTo>
                  <a:cubicBezTo>
                    <a:pt x="6654718" y="3474844"/>
                    <a:pt x="6644744" y="3274633"/>
                    <a:pt x="6514638" y="3286074"/>
                  </a:cubicBezTo>
                  <a:cubicBezTo>
                    <a:pt x="6396601" y="3297578"/>
                    <a:pt x="6405432" y="3476242"/>
                    <a:pt x="6524040" y="3476051"/>
                  </a:cubicBezTo>
                  <a:close/>
                  <a:moveTo>
                    <a:pt x="6533125" y="1608057"/>
                  </a:moveTo>
                  <a:cubicBezTo>
                    <a:pt x="6403018" y="1596616"/>
                    <a:pt x="6393362" y="1796826"/>
                    <a:pt x="6523785" y="1798225"/>
                  </a:cubicBezTo>
                  <a:cubicBezTo>
                    <a:pt x="6642394" y="1798161"/>
                    <a:pt x="6651224" y="1619624"/>
                    <a:pt x="6533125" y="1607866"/>
                  </a:cubicBezTo>
                  <a:close/>
                  <a:moveTo>
                    <a:pt x="6625368" y="767682"/>
                  </a:moveTo>
                  <a:cubicBezTo>
                    <a:pt x="6495261" y="756304"/>
                    <a:pt x="6485605" y="956324"/>
                    <a:pt x="6616029" y="957913"/>
                  </a:cubicBezTo>
                  <a:cubicBezTo>
                    <a:pt x="6734701" y="957722"/>
                    <a:pt x="6743531" y="779122"/>
                    <a:pt x="6625368" y="767491"/>
                  </a:cubicBezTo>
                  <a:close/>
                  <a:moveTo>
                    <a:pt x="6239178" y="2986775"/>
                  </a:moveTo>
                  <a:cubicBezTo>
                    <a:pt x="6109072" y="2975398"/>
                    <a:pt x="6099097" y="3175418"/>
                    <a:pt x="6229776" y="3177007"/>
                  </a:cubicBezTo>
                  <a:cubicBezTo>
                    <a:pt x="6348383" y="3176816"/>
                    <a:pt x="6357277" y="2998279"/>
                    <a:pt x="6239178" y="2986585"/>
                  </a:cubicBezTo>
                  <a:close/>
                  <a:moveTo>
                    <a:pt x="6514638" y="4652017"/>
                  </a:moveTo>
                  <a:cubicBezTo>
                    <a:pt x="6396538" y="4663649"/>
                    <a:pt x="6405432" y="4842249"/>
                    <a:pt x="6524040" y="4842249"/>
                  </a:cubicBezTo>
                  <a:cubicBezTo>
                    <a:pt x="6654718" y="4840660"/>
                    <a:pt x="6644808" y="4640640"/>
                    <a:pt x="6514638" y="4652017"/>
                  </a:cubicBezTo>
                  <a:close/>
                  <a:moveTo>
                    <a:pt x="6326403" y="5437732"/>
                  </a:moveTo>
                  <a:cubicBezTo>
                    <a:pt x="6196296" y="5426355"/>
                    <a:pt x="6186640" y="5626375"/>
                    <a:pt x="6317001" y="5627964"/>
                  </a:cubicBezTo>
                  <a:cubicBezTo>
                    <a:pt x="6435671" y="5628027"/>
                    <a:pt x="6444502" y="5449363"/>
                    <a:pt x="6326403" y="5437732"/>
                  </a:cubicBezTo>
                  <a:close/>
                  <a:moveTo>
                    <a:pt x="7229651" y="6251285"/>
                  </a:moveTo>
                  <a:cubicBezTo>
                    <a:pt x="7099545" y="6239781"/>
                    <a:pt x="7089888" y="6440055"/>
                    <a:pt x="7220249" y="6441453"/>
                  </a:cubicBezTo>
                  <a:cubicBezTo>
                    <a:pt x="7338857" y="6441453"/>
                    <a:pt x="7347751" y="6262662"/>
                    <a:pt x="7229651" y="6251094"/>
                  </a:cubicBezTo>
                  <a:close/>
                  <a:moveTo>
                    <a:pt x="6776566" y="3604694"/>
                  </a:moveTo>
                  <a:cubicBezTo>
                    <a:pt x="6658530" y="3616389"/>
                    <a:pt x="6667297" y="3794926"/>
                    <a:pt x="6785968" y="3794926"/>
                  </a:cubicBezTo>
                  <a:cubicBezTo>
                    <a:pt x="6916329" y="3793337"/>
                    <a:pt x="6906481" y="3593381"/>
                    <a:pt x="6776566" y="3604694"/>
                  </a:cubicBezTo>
                  <a:close/>
                  <a:moveTo>
                    <a:pt x="7330281" y="5086315"/>
                  </a:moveTo>
                  <a:cubicBezTo>
                    <a:pt x="7212244" y="5097946"/>
                    <a:pt x="7221075" y="5276610"/>
                    <a:pt x="7339683" y="5276546"/>
                  </a:cubicBezTo>
                  <a:cubicBezTo>
                    <a:pt x="7470107" y="5275021"/>
                    <a:pt x="7460324" y="5074938"/>
                    <a:pt x="7330090" y="5086315"/>
                  </a:cubicBezTo>
                  <a:close/>
                  <a:moveTo>
                    <a:pt x="7149732" y="2268942"/>
                  </a:moveTo>
                  <a:cubicBezTo>
                    <a:pt x="7031697" y="2280573"/>
                    <a:pt x="7040464" y="2459173"/>
                    <a:pt x="7159071" y="2459173"/>
                  </a:cubicBezTo>
                  <a:cubicBezTo>
                    <a:pt x="7289495" y="2457711"/>
                    <a:pt x="7279775" y="2257628"/>
                    <a:pt x="7149542" y="2268942"/>
                  </a:cubicBezTo>
                  <a:close/>
                  <a:moveTo>
                    <a:pt x="4803179" y="4171957"/>
                  </a:moveTo>
                  <a:cubicBezTo>
                    <a:pt x="4673072" y="4160580"/>
                    <a:pt x="4663416" y="4360600"/>
                    <a:pt x="4793840" y="4362189"/>
                  </a:cubicBezTo>
                  <a:cubicBezTo>
                    <a:pt x="4912511" y="4362189"/>
                    <a:pt x="4921532" y="4183589"/>
                    <a:pt x="4803179" y="4171957"/>
                  </a:cubicBezTo>
                  <a:close/>
                  <a:moveTo>
                    <a:pt x="4264139" y="1897059"/>
                  </a:moveTo>
                  <a:cubicBezTo>
                    <a:pt x="4146039" y="1908626"/>
                    <a:pt x="4154870" y="2087227"/>
                    <a:pt x="4273477" y="2087290"/>
                  </a:cubicBezTo>
                  <a:cubicBezTo>
                    <a:pt x="4404092" y="2085765"/>
                    <a:pt x="4394245" y="1885682"/>
                    <a:pt x="4264139" y="1897059"/>
                  </a:cubicBezTo>
                  <a:close/>
                  <a:moveTo>
                    <a:pt x="4141592" y="4439731"/>
                  </a:moveTo>
                  <a:cubicBezTo>
                    <a:pt x="4023556" y="4451362"/>
                    <a:pt x="4032386" y="4629962"/>
                    <a:pt x="4150995" y="4629962"/>
                  </a:cubicBezTo>
                  <a:cubicBezTo>
                    <a:pt x="4281609" y="4628373"/>
                    <a:pt x="4271826" y="4428417"/>
                    <a:pt x="4141592" y="4439731"/>
                  </a:cubicBezTo>
                  <a:close/>
                  <a:moveTo>
                    <a:pt x="4444560" y="5923067"/>
                  </a:moveTo>
                  <a:cubicBezTo>
                    <a:pt x="4326460" y="5934698"/>
                    <a:pt x="4335354" y="6113363"/>
                    <a:pt x="4453962" y="6113299"/>
                  </a:cubicBezTo>
                  <a:cubicBezTo>
                    <a:pt x="4584831" y="6111774"/>
                    <a:pt x="4574730" y="5911754"/>
                    <a:pt x="4444560" y="5923067"/>
                  </a:cubicBezTo>
                  <a:close/>
                  <a:moveTo>
                    <a:pt x="4149660" y="722555"/>
                  </a:moveTo>
                  <a:cubicBezTo>
                    <a:pt x="4280339" y="721029"/>
                    <a:pt x="4270365" y="521010"/>
                    <a:pt x="4140322" y="532323"/>
                  </a:cubicBezTo>
                  <a:cubicBezTo>
                    <a:pt x="4022222" y="543954"/>
                    <a:pt x="4031053" y="722491"/>
                    <a:pt x="4149660" y="722555"/>
                  </a:cubicBezTo>
                  <a:close/>
                  <a:moveTo>
                    <a:pt x="5149473" y="5067883"/>
                  </a:moveTo>
                  <a:cubicBezTo>
                    <a:pt x="5031437" y="5079514"/>
                    <a:pt x="5040267" y="5258178"/>
                    <a:pt x="5158875" y="5258115"/>
                  </a:cubicBezTo>
                  <a:cubicBezTo>
                    <a:pt x="5289489" y="5256589"/>
                    <a:pt x="5279643" y="5056569"/>
                    <a:pt x="5149473" y="5067883"/>
                  </a:cubicBezTo>
                  <a:close/>
                  <a:moveTo>
                    <a:pt x="5180729" y="418362"/>
                  </a:moveTo>
                  <a:cubicBezTo>
                    <a:pt x="5062692" y="430057"/>
                    <a:pt x="5071523" y="608657"/>
                    <a:pt x="5190131" y="608594"/>
                  </a:cubicBezTo>
                  <a:cubicBezTo>
                    <a:pt x="5320746" y="607259"/>
                    <a:pt x="5310962" y="407303"/>
                    <a:pt x="5180729" y="418362"/>
                  </a:cubicBezTo>
                  <a:close/>
                  <a:moveTo>
                    <a:pt x="3703309" y="5642900"/>
                  </a:moveTo>
                  <a:cubicBezTo>
                    <a:pt x="3578793" y="5643599"/>
                    <a:pt x="3578793" y="5832877"/>
                    <a:pt x="3703309" y="5833576"/>
                  </a:cubicBezTo>
                  <a:cubicBezTo>
                    <a:pt x="3827825" y="5832941"/>
                    <a:pt x="3827888" y="5643662"/>
                    <a:pt x="3703309" y="5642900"/>
                  </a:cubicBezTo>
                  <a:close/>
                  <a:moveTo>
                    <a:pt x="5646456" y="6045926"/>
                  </a:moveTo>
                  <a:cubicBezTo>
                    <a:pt x="5516350" y="6034422"/>
                    <a:pt x="5506694" y="6234696"/>
                    <a:pt x="5637118" y="6236094"/>
                  </a:cubicBezTo>
                  <a:cubicBezTo>
                    <a:pt x="5755726" y="6236222"/>
                    <a:pt x="5764556" y="6057430"/>
                    <a:pt x="5646456" y="6045926"/>
                  </a:cubicBezTo>
                  <a:close/>
                  <a:moveTo>
                    <a:pt x="5906225" y="1406067"/>
                  </a:moveTo>
                  <a:cubicBezTo>
                    <a:pt x="5776118" y="1394689"/>
                    <a:pt x="5766462" y="1594773"/>
                    <a:pt x="5896886" y="1596298"/>
                  </a:cubicBezTo>
                  <a:cubicBezTo>
                    <a:pt x="6015494" y="1596298"/>
                    <a:pt x="6024324" y="1417698"/>
                    <a:pt x="5906225" y="1406067"/>
                  </a:cubicBezTo>
                  <a:close/>
                </a:path>
              </a:pathLst>
            </a:custGeom>
            <a:solidFill>
              <a:srgbClr val="004591">
                <a:alpha val="4470"/>
              </a:srgbClr>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rgbClr val="000000"/>
                </a:solidFill>
                <a:latin typeface="Calibri"/>
                <a:ea typeface="Calibri"/>
                <a:cs typeface="Calibri"/>
                <a:sym typeface="Calibri"/>
              </a:endParaRPr>
            </a:p>
          </p:txBody>
        </p:sp>
      </p:grpSp>
      <p:sp>
        <p:nvSpPr>
          <p:cNvPr id="76" name="Google Shape;76;p10"/>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855300" y="836000"/>
            <a:ext cx="7433400" cy="396300"/>
          </a:xfrm>
          <a:prstGeom prst="rect">
            <a:avLst/>
          </a:prstGeom>
          <a:noFill/>
          <a:ln>
            <a:noFill/>
          </a:ln>
        </p:spPr>
        <p:txBody>
          <a:bodyPr spcFirstLastPara="1" wrap="square" lIns="0" tIns="0" rIns="0" bIns="0" anchor="b" anchorCtr="0">
            <a:noAutofit/>
          </a:bodyPr>
          <a:lstStyle>
            <a:lvl1pPr lvl="0"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1pPr>
            <a:lvl2pPr lvl="1"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2pPr>
            <a:lvl3pPr lvl="2"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3pPr>
            <a:lvl4pPr lvl="3"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4pPr>
            <a:lvl5pPr lvl="4"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5pPr>
            <a:lvl6pPr lvl="5"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6pPr>
            <a:lvl7pPr lvl="6"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7pPr>
            <a:lvl8pPr lvl="7"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8pPr>
            <a:lvl9pPr lvl="8" rtl="0">
              <a:lnSpc>
                <a:spcPct val="90000"/>
              </a:lnSpc>
              <a:spcBef>
                <a:spcPts val="0"/>
              </a:spcBef>
              <a:spcAft>
                <a:spcPts val="0"/>
              </a:spcAft>
              <a:buClr>
                <a:schemeClr val="accent1"/>
              </a:buClr>
              <a:buSzPts val="3000"/>
              <a:buFont typeface="Montserrat"/>
              <a:buNone/>
              <a:defRPr sz="3000" b="1">
                <a:solidFill>
                  <a:schemeClr val="accent1"/>
                </a:solidFill>
                <a:latin typeface="Montserrat"/>
                <a:ea typeface="Montserrat"/>
                <a:cs typeface="Montserrat"/>
                <a:sym typeface="Montserrat"/>
              </a:defRPr>
            </a:lvl9pPr>
          </a:lstStyle>
          <a:p>
            <a:endParaRPr/>
          </a:p>
        </p:txBody>
      </p:sp>
      <p:sp>
        <p:nvSpPr>
          <p:cNvPr id="7" name="Google Shape;7;p1"/>
          <p:cNvSpPr txBox="1">
            <a:spLocks noGrp="1"/>
          </p:cNvSpPr>
          <p:nvPr>
            <p:ph type="body" idx="1"/>
          </p:nvPr>
        </p:nvSpPr>
        <p:spPr>
          <a:xfrm>
            <a:off x="855300" y="1430147"/>
            <a:ext cx="7433400" cy="3033900"/>
          </a:xfrm>
          <a:prstGeom prst="rect">
            <a:avLst/>
          </a:prstGeom>
          <a:noFill/>
          <a:ln>
            <a:noFill/>
          </a:ln>
        </p:spPr>
        <p:txBody>
          <a:bodyPr spcFirstLastPara="1" wrap="square" lIns="0" tIns="0" rIns="0" bIns="0" anchor="t" anchorCtr="0">
            <a:noAutofit/>
          </a:bodyPr>
          <a:lstStyle>
            <a:lvl1pPr marL="457200" lvl="0" indent="-381000" rtl="0">
              <a:spcBef>
                <a:spcPts val="0"/>
              </a:spcBef>
              <a:spcAft>
                <a:spcPts val="0"/>
              </a:spcAft>
              <a:buClr>
                <a:schemeClr val="accent1"/>
              </a:buClr>
              <a:buSzPts val="2400"/>
              <a:buFont typeface="Montserrat Light"/>
              <a:buChar char="●"/>
              <a:defRPr sz="2400">
                <a:solidFill>
                  <a:schemeClr val="dk1"/>
                </a:solidFill>
                <a:latin typeface="Montserrat Light"/>
                <a:ea typeface="Montserrat Light"/>
                <a:cs typeface="Montserrat Light"/>
                <a:sym typeface="Montserrat Light"/>
              </a:defRPr>
            </a:lvl1pPr>
            <a:lvl2pPr marL="914400" lvl="1" indent="-381000" rtl="0">
              <a:spcBef>
                <a:spcPts val="600"/>
              </a:spcBef>
              <a:spcAft>
                <a:spcPts val="0"/>
              </a:spcAft>
              <a:buClr>
                <a:schemeClr val="accent1"/>
              </a:buClr>
              <a:buSzPts val="2400"/>
              <a:buFont typeface="Montserrat Light"/>
              <a:buChar char="○"/>
              <a:defRPr sz="2400">
                <a:solidFill>
                  <a:schemeClr val="dk1"/>
                </a:solidFill>
                <a:latin typeface="Montserrat Light"/>
                <a:ea typeface="Montserrat Light"/>
                <a:cs typeface="Montserrat Light"/>
                <a:sym typeface="Montserrat Light"/>
              </a:defRPr>
            </a:lvl2pPr>
            <a:lvl3pPr marL="1371600" lvl="2" indent="-381000" rtl="0">
              <a:spcBef>
                <a:spcPts val="600"/>
              </a:spcBef>
              <a:spcAft>
                <a:spcPts val="0"/>
              </a:spcAft>
              <a:buClr>
                <a:schemeClr val="dk1"/>
              </a:buClr>
              <a:buSzPts val="2400"/>
              <a:buFont typeface="Montserrat Light"/>
              <a:buChar char="■"/>
              <a:defRPr sz="2400">
                <a:solidFill>
                  <a:schemeClr val="dk1"/>
                </a:solidFill>
                <a:latin typeface="Montserrat Light"/>
                <a:ea typeface="Montserrat Light"/>
                <a:cs typeface="Montserrat Light"/>
                <a:sym typeface="Montserrat Light"/>
              </a:defRPr>
            </a:lvl3pPr>
            <a:lvl4pPr marL="1828800" lvl="3" indent="-381000" rtl="0">
              <a:spcBef>
                <a:spcPts val="600"/>
              </a:spcBef>
              <a:spcAft>
                <a:spcPts val="0"/>
              </a:spcAft>
              <a:buClr>
                <a:schemeClr val="dk1"/>
              </a:buClr>
              <a:buSzPts val="2400"/>
              <a:buFont typeface="Montserrat Light"/>
              <a:buChar char="●"/>
              <a:defRPr sz="2400">
                <a:solidFill>
                  <a:schemeClr val="dk1"/>
                </a:solidFill>
                <a:latin typeface="Montserrat Light"/>
                <a:ea typeface="Montserrat Light"/>
                <a:cs typeface="Montserrat Light"/>
                <a:sym typeface="Montserrat Light"/>
              </a:defRPr>
            </a:lvl4pPr>
            <a:lvl5pPr marL="2286000" lvl="4" indent="-381000" rtl="0">
              <a:spcBef>
                <a:spcPts val="600"/>
              </a:spcBef>
              <a:spcAft>
                <a:spcPts val="0"/>
              </a:spcAft>
              <a:buClr>
                <a:schemeClr val="dk1"/>
              </a:buClr>
              <a:buSzPts val="2400"/>
              <a:buFont typeface="Montserrat Light"/>
              <a:buChar char="○"/>
              <a:defRPr sz="2400">
                <a:solidFill>
                  <a:schemeClr val="dk1"/>
                </a:solidFill>
                <a:latin typeface="Montserrat Light"/>
                <a:ea typeface="Montserrat Light"/>
                <a:cs typeface="Montserrat Light"/>
                <a:sym typeface="Montserrat Light"/>
              </a:defRPr>
            </a:lvl5pPr>
            <a:lvl6pPr marL="2743200" lvl="5" indent="-381000" rtl="0">
              <a:spcBef>
                <a:spcPts val="600"/>
              </a:spcBef>
              <a:spcAft>
                <a:spcPts val="0"/>
              </a:spcAft>
              <a:buClr>
                <a:schemeClr val="dk1"/>
              </a:buClr>
              <a:buSzPts val="2400"/>
              <a:buFont typeface="Montserrat Light"/>
              <a:buChar char="■"/>
              <a:defRPr sz="2400">
                <a:solidFill>
                  <a:schemeClr val="dk1"/>
                </a:solidFill>
                <a:latin typeface="Montserrat Light"/>
                <a:ea typeface="Montserrat Light"/>
                <a:cs typeface="Montserrat Light"/>
                <a:sym typeface="Montserrat Light"/>
              </a:defRPr>
            </a:lvl6pPr>
            <a:lvl7pPr marL="3200400" lvl="6" indent="-381000" rtl="0">
              <a:spcBef>
                <a:spcPts val="600"/>
              </a:spcBef>
              <a:spcAft>
                <a:spcPts val="0"/>
              </a:spcAft>
              <a:buClr>
                <a:schemeClr val="dk1"/>
              </a:buClr>
              <a:buSzPts val="2400"/>
              <a:buFont typeface="Montserrat Light"/>
              <a:buChar char="●"/>
              <a:defRPr sz="2400">
                <a:solidFill>
                  <a:schemeClr val="dk1"/>
                </a:solidFill>
                <a:latin typeface="Montserrat Light"/>
                <a:ea typeface="Montserrat Light"/>
                <a:cs typeface="Montserrat Light"/>
                <a:sym typeface="Montserrat Light"/>
              </a:defRPr>
            </a:lvl7pPr>
            <a:lvl8pPr marL="3657600" lvl="7" indent="-381000" rtl="0">
              <a:spcBef>
                <a:spcPts val="600"/>
              </a:spcBef>
              <a:spcAft>
                <a:spcPts val="0"/>
              </a:spcAft>
              <a:buClr>
                <a:schemeClr val="dk1"/>
              </a:buClr>
              <a:buSzPts val="2400"/>
              <a:buFont typeface="Montserrat Light"/>
              <a:buChar char="○"/>
              <a:defRPr sz="2400">
                <a:solidFill>
                  <a:schemeClr val="dk1"/>
                </a:solidFill>
                <a:latin typeface="Montserrat Light"/>
                <a:ea typeface="Montserrat Light"/>
                <a:cs typeface="Montserrat Light"/>
                <a:sym typeface="Montserrat Light"/>
              </a:defRPr>
            </a:lvl8pPr>
            <a:lvl9pPr marL="4114800" lvl="8" indent="-381000" rtl="0">
              <a:spcBef>
                <a:spcPts val="600"/>
              </a:spcBef>
              <a:spcAft>
                <a:spcPts val="600"/>
              </a:spcAft>
              <a:buClr>
                <a:schemeClr val="dk1"/>
              </a:buClr>
              <a:buSzPts val="2400"/>
              <a:buFont typeface="Montserrat Light"/>
              <a:buChar char="■"/>
              <a:defRPr sz="2400">
                <a:solidFill>
                  <a:schemeClr val="dk1"/>
                </a:solidFill>
                <a:latin typeface="Montserrat Light"/>
                <a:ea typeface="Montserrat Light"/>
                <a:cs typeface="Montserrat Light"/>
                <a:sym typeface="Montserrat Light"/>
              </a:defRPr>
            </a:lvl9pPr>
          </a:lstStyle>
          <a:p>
            <a:endParaRPr/>
          </a:p>
        </p:txBody>
      </p:sp>
      <p:sp>
        <p:nvSpPr>
          <p:cNvPr id="8" name="Google Shape;8;p1"/>
          <p:cNvSpPr txBox="1">
            <a:spLocks noGrp="1"/>
          </p:cNvSpPr>
          <p:nvPr>
            <p:ph type="sldNum" idx="12"/>
          </p:nvPr>
        </p:nvSpPr>
        <p:spPr>
          <a:xfrm>
            <a:off x="8480584" y="4749851"/>
            <a:ext cx="548700" cy="393600"/>
          </a:xfrm>
          <a:prstGeom prst="rect">
            <a:avLst/>
          </a:prstGeom>
          <a:noFill/>
          <a:ln>
            <a:noFill/>
          </a:ln>
        </p:spPr>
        <p:txBody>
          <a:bodyPr spcFirstLastPara="1" wrap="square" lIns="0" tIns="0" rIns="0" bIns="0" anchor="ctr" anchorCtr="0">
            <a:noAutofit/>
          </a:bodyPr>
          <a:lstStyle>
            <a:lvl1pPr lvl="0" algn="r" rtl="0">
              <a:buNone/>
              <a:defRPr sz="1300" b="1">
                <a:solidFill>
                  <a:schemeClr val="dk2"/>
                </a:solidFill>
                <a:latin typeface="Montserrat"/>
                <a:ea typeface="Montserrat"/>
                <a:cs typeface="Montserrat"/>
                <a:sym typeface="Montserrat"/>
              </a:defRPr>
            </a:lvl1pPr>
            <a:lvl2pPr lvl="1" algn="r" rtl="0">
              <a:buNone/>
              <a:defRPr sz="1300" b="1">
                <a:solidFill>
                  <a:schemeClr val="dk2"/>
                </a:solidFill>
                <a:latin typeface="Montserrat"/>
                <a:ea typeface="Montserrat"/>
                <a:cs typeface="Montserrat"/>
                <a:sym typeface="Montserrat"/>
              </a:defRPr>
            </a:lvl2pPr>
            <a:lvl3pPr lvl="2" algn="r" rtl="0">
              <a:buNone/>
              <a:defRPr sz="1300" b="1">
                <a:solidFill>
                  <a:schemeClr val="dk2"/>
                </a:solidFill>
                <a:latin typeface="Montserrat"/>
                <a:ea typeface="Montserrat"/>
                <a:cs typeface="Montserrat"/>
                <a:sym typeface="Montserrat"/>
              </a:defRPr>
            </a:lvl3pPr>
            <a:lvl4pPr lvl="3" algn="r" rtl="0">
              <a:buNone/>
              <a:defRPr sz="1300" b="1">
                <a:solidFill>
                  <a:schemeClr val="dk2"/>
                </a:solidFill>
                <a:latin typeface="Montserrat"/>
                <a:ea typeface="Montserrat"/>
                <a:cs typeface="Montserrat"/>
                <a:sym typeface="Montserrat"/>
              </a:defRPr>
            </a:lvl4pPr>
            <a:lvl5pPr lvl="4" algn="r" rtl="0">
              <a:buNone/>
              <a:defRPr sz="1300" b="1">
                <a:solidFill>
                  <a:schemeClr val="dk2"/>
                </a:solidFill>
                <a:latin typeface="Montserrat"/>
                <a:ea typeface="Montserrat"/>
                <a:cs typeface="Montserrat"/>
                <a:sym typeface="Montserrat"/>
              </a:defRPr>
            </a:lvl5pPr>
            <a:lvl6pPr lvl="5" algn="r" rtl="0">
              <a:buNone/>
              <a:defRPr sz="1300" b="1">
                <a:solidFill>
                  <a:schemeClr val="dk2"/>
                </a:solidFill>
                <a:latin typeface="Montserrat"/>
                <a:ea typeface="Montserrat"/>
                <a:cs typeface="Montserrat"/>
                <a:sym typeface="Montserrat"/>
              </a:defRPr>
            </a:lvl6pPr>
            <a:lvl7pPr lvl="6" algn="r" rtl="0">
              <a:buNone/>
              <a:defRPr sz="1300" b="1">
                <a:solidFill>
                  <a:schemeClr val="dk2"/>
                </a:solidFill>
                <a:latin typeface="Montserrat"/>
                <a:ea typeface="Montserrat"/>
                <a:cs typeface="Montserrat"/>
                <a:sym typeface="Montserrat"/>
              </a:defRPr>
            </a:lvl7pPr>
            <a:lvl8pPr lvl="7" algn="r" rtl="0">
              <a:buNone/>
              <a:defRPr sz="1300" b="1">
                <a:solidFill>
                  <a:schemeClr val="dk2"/>
                </a:solidFill>
                <a:latin typeface="Montserrat"/>
                <a:ea typeface="Montserrat"/>
                <a:cs typeface="Montserrat"/>
                <a:sym typeface="Montserrat"/>
              </a:defRPr>
            </a:lvl8pPr>
            <a:lvl9pPr lvl="8" algn="r" rtl="0">
              <a:buNone/>
              <a:defRPr sz="1300" b="1">
                <a:solidFill>
                  <a:schemeClr val="dk2"/>
                </a:solidFill>
                <a:latin typeface="Montserrat"/>
                <a:ea typeface="Montserrat"/>
                <a:cs typeface="Montserrat"/>
                <a:sym typeface="Montserrat"/>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Lst>
  <p:transition>
    <p:fade thruBlk="1"/>
  </p:transition>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drive.google.com/file/d/1smei0eB36Jw0xDlNF7k57ia2gEUAZDmJ/view" TargetMode="External"/><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0.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0.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0.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0.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jpg"/><Relationship Id="rId7" Type="http://schemas.openxmlformats.org/officeDocument/2006/relationships/image" Target="../media/image6.jpg"/><Relationship Id="rId12" Type="http://schemas.openxmlformats.org/officeDocument/2006/relationships/image" Target="../media/image11.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jp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jpg"/><Relationship Id="rId9" Type="http://schemas.openxmlformats.org/officeDocument/2006/relationships/image" Target="../media/image8.pn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5.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4.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4.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4.xml"/></Relationships>
</file>

<file path=ppt/slides/_rels/slide37.xml.rels><?xml version="1.0" encoding="UTF-8" standalone="yes"?>
<Relationships xmlns="http://schemas.openxmlformats.org/package/2006/relationships"><Relationship Id="rId3" Type="http://schemas.openxmlformats.org/officeDocument/2006/relationships/hyperlink" Target="http://drive.google.com/file/d/1smei0eB36Jw0xDlNF7k57ia2gEUAZDmJ/view" TargetMode="External"/><Relationship Id="rId2" Type="http://schemas.openxmlformats.org/officeDocument/2006/relationships/notesSlide" Target="../notesSlides/notesSlide37.xml"/><Relationship Id="rId1" Type="http://schemas.openxmlformats.org/officeDocument/2006/relationships/slideLayout" Target="../slideLayouts/slideLayout2.xml"/><Relationship Id="rId6" Type="http://schemas.openxmlformats.org/officeDocument/2006/relationships/hyperlink" Target="https://qfreeaccountssjc1.az1.qualtrics.com/jfe/form/SV_78aR4nasYGiEyEK" TargetMode="External"/><Relationship Id="rId5" Type="http://schemas.openxmlformats.org/officeDocument/2006/relationships/image" Target="../media/image13.png"/><Relationship Id="rId4" Type="http://schemas.openxmlformats.org/officeDocument/2006/relationships/image" Target="../media/image1.png"/></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4.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40.xml.rels><?xml version="1.0" encoding="UTF-8" standalone="yes"?>
<Relationships xmlns="http://schemas.openxmlformats.org/package/2006/relationships"><Relationship Id="rId3" Type="http://schemas.openxmlformats.org/officeDocument/2006/relationships/hyperlink" Target="https://www.facinghistory.org/reconstruction-era/changing-names" TargetMode="External"/><Relationship Id="rId2" Type="http://schemas.openxmlformats.org/officeDocument/2006/relationships/hyperlink" Target="https://www.newyorker.com/culture/personal-history/america-ruined-my-name-for-me" TargetMode="External"/><Relationship Id="rId1" Type="http://schemas.openxmlformats.org/officeDocument/2006/relationships/slideLayout" Target="../slideLayouts/slideLayout4.xml"/><Relationship Id="rId4" Type="http://schemas.openxmlformats.org/officeDocument/2006/relationships/hyperlink" Target="https://www.kuow.org/stories/a-rose-by-any-other-name-would-not-be-me" TargetMode="External"/></Relationships>
</file>

<file path=ppt/slides/_rels/slide4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p12"/>
          <p:cNvSpPr txBox="1">
            <a:spLocks noGrp="1"/>
          </p:cNvSpPr>
          <p:nvPr>
            <p:ph type="ctrTitle"/>
          </p:nvPr>
        </p:nvSpPr>
        <p:spPr>
          <a:xfrm>
            <a:off x="685800" y="876050"/>
            <a:ext cx="7772400" cy="1098600"/>
          </a:xfrm>
          <a:prstGeom prst="rect">
            <a:avLst/>
          </a:prstGeom>
        </p:spPr>
        <p:txBody>
          <a:bodyPr spcFirstLastPara="1" wrap="square" lIns="0" tIns="0" rIns="0" bIns="0" anchor="ctr" anchorCtr="0">
            <a:noAutofit/>
          </a:bodyPr>
          <a:lstStyle/>
          <a:p>
            <a:pPr marL="0" lvl="0" indent="0" algn="l" rtl="0">
              <a:spcBef>
                <a:spcPts val="0"/>
              </a:spcBef>
              <a:spcAft>
                <a:spcPts val="0"/>
              </a:spcAft>
              <a:buNone/>
            </a:pPr>
            <a:r>
              <a:rPr lang="en"/>
              <a:t>Say my name:</a:t>
            </a:r>
            <a:endParaRPr/>
          </a:p>
          <a:p>
            <a:pPr marL="0" lvl="0" indent="0" algn="l" rtl="0">
              <a:spcBef>
                <a:spcPts val="0"/>
              </a:spcBef>
              <a:spcAft>
                <a:spcPts val="0"/>
              </a:spcAft>
              <a:buNone/>
            </a:pPr>
            <a:endParaRPr/>
          </a:p>
        </p:txBody>
      </p:sp>
      <p:sp>
        <p:nvSpPr>
          <p:cNvPr id="88" name="Google Shape;88;p12"/>
          <p:cNvSpPr txBox="1"/>
          <p:nvPr/>
        </p:nvSpPr>
        <p:spPr>
          <a:xfrm>
            <a:off x="1071075" y="2507025"/>
            <a:ext cx="67794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latin typeface="Montserrat Light"/>
              <a:ea typeface="Montserrat Light"/>
              <a:cs typeface="Montserrat Light"/>
              <a:sym typeface="Montserrat Light"/>
            </a:endParaRPr>
          </a:p>
        </p:txBody>
      </p:sp>
      <p:sp>
        <p:nvSpPr>
          <p:cNvPr id="89" name="Google Shape;89;p12"/>
          <p:cNvSpPr txBox="1"/>
          <p:nvPr/>
        </p:nvSpPr>
        <p:spPr>
          <a:xfrm>
            <a:off x="685800" y="1520250"/>
            <a:ext cx="8012400" cy="822000"/>
          </a:xfrm>
          <a:prstGeom prst="rect">
            <a:avLst/>
          </a:prstGeom>
          <a:noFill/>
          <a:ln>
            <a:noFill/>
          </a:ln>
          <a:effectLst>
            <a:outerShdw blurRad="57150" dist="19050" dir="5400000" algn="bl" rotWithShape="0">
              <a:srgbClr val="000000">
                <a:alpha val="50000"/>
              </a:srgbClr>
            </a:outerShdw>
          </a:effectLst>
        </p:spPr>
        <p:txBody>
          <a:bodyPr spcFirstLastPara="1" wrap="square" lIns="91425" tIns="91425" rIns="91425" bIns="91425" anchor="t" anchorCtr="0">
            <a:spAutoFit/>
          </a:bodyPr>
          <a:lstStyle/>
          <a:p>
            <a:pPr marL="0" lvl="0" indent="0" algn="l" rtl="0">
              <a:lnSpc>
                <a:spcPct val="90000"/>
              </a:lnSpc>
              <a:spcBef>
                <a:spcPts val="0"/>
              </a:spcBef>
              <a:spcAft>
                <a:spcPts val="0"/>
              </a:spcAft>
              <a:buNone/>
            </a:pPr>
            <a:r>
              <a:rPr lang="en" sz="2300" dirty="0">
                <a:solidFill>
                  <a:schemeClr val="lt1"/>
                </a:solidFill>
                <a:latin typeface="Montserrat"/>
                <a:ea typeface="Montserrat"/>
                <a:cs typeface="Montserrat"/>
                <a:sym typeface="Montserrat"/>
              </a:rPr>
              <a:t>Understanding the power of names, correct pronunciation, and personal narratives </a:t>
            </a:r>
            <a:endParaRPr sz="100" dirty="0"/>
          </a:p>
        </p:txBody>
      </p:sp>
      <p:sp>
        <p:nvSpPr>
          <p:cNvPr id="90" name="Google Shape;90;p12"/>
          <p:cNvSpPr txBox="1"/>
          <p:nvPr/>
        </p:nvSpPr>
        <p:spPr>
          <a:xfrm>
            <a:off x="2405975" y="2589425"/>
            <a:ext cx="6238800" cy="849600"/>
          </a:xfrm>
          <a:prstGeom prst="rect">
            <a:avLst/>
          </a:prstGeom>
          <a:noFill/>
          <a:ln>
            <a:noFill/>
          </a:ln>
        </p:spPr>
        <p:txBody>
          <a:bodyPr spcFirstLastPara="1" wrap="square" lIns="91425" tIns="91425" rIns="91425" bIns="91425" anchor="t" anchorCtr="0">
            <a:spAutoFit/>
          </a:bodyPr>
          <a:lstStyle/>
          <a:p>
            <a:pPr marL="0" lvl="0" indent="0" algn="l" rtl="0">
              <a:lnSpc>
                <a:spcPct val="90000"/>
              </a:lnSpc>
              <a:spcBef>
                <a:spcPts val="0"/>
              </a:spcBef>
              <a:spcAft>
                <a:spcPts val="0"/>
              </a:spcAft>
              <a:buNone/>
            </a:pPr>
            <a:r>
              <a:rPr lang="en" sz="1600" b="1" dirty="0">
                <a:solidFill>
                  <a:schemeClr val="lt1"/>
                </a:solidFill>
                <a:latin typeface="Montserrat"/>
                <a:ea typeface="Montserrat"/>
                <a:cs typeface="Montserrat"/>
                <a:sym typeface="Montserrat"/>
              </a:rPr>
              <a:t>Scholars: </a:t>
            </a:r>
            <a:r>
              <a:rPr lang="en" sz="1600" dirty="0">
                <a:solidFill>
                  <a:schemeClr val="lt1"/>
                </a:solidFill>
                <a:latin typeface="Montserrat"/>
                <a:ea typeface="Montserrat"/>
                <a:cs typeface="Montserrat"/>
                <a:sym typeface="Montserrat"/>
              </a:rPr>
              <a:t>Anaid (Aniya) </a:t>
            </a:r>
            <a:r>
              <a:rPr lang="en" sz="1600" dirty="0" err="1">
                <a:solidFill>
                  <a:schemeClr val="lt1"/>
                </a:solidFill>
                <a:latin typeface="Montserrat"/>
                <a:ea typeface="Montserrat"/>
                <a:cs typeface="Montserrat"/>
                <a:sym typeface="Montserrat"/>
              </a:rPr>
              <a:t>Atasuntseva</a:t>
            </a:r>
            <a:r>
              <a:rPr lang="en" sz="1600" dirty="0">
                <a:solidFill>
                  <a:schemeClr val="lt1"/>
                </a:solidFill>
                <a:latin typeface="Montserrat"/>
                <a:ea typeface="Montserrat"/>
                <a:cs typeface="Montserrat"/>
                <a:sym typeface="Montserrat"/>
              </a:rPr>
              <a:t>, Eve </a:t>
            </a:r>
            <a:r>
              <a:rPr lang="en" sz="1600" dirty="0" err="1">
                <a:solidFill>
                  <a:schemeClr val="lt1"/>
                </a:solidFill>
                <a:latin typeface="Montserrat"/>
                <a:ea typeface="Montserrat"/>
                <a:cs typeface="Montserrat"/>
                <a:sym typeface="Montserrat"/>
              </a:rPr>
              <a:t>Ayeroff</a:t>
            </a:r>
            <a:r>
              <a:rPr lang="en" sz="1600" dirty="0">
                <a:solidFill>
                  <a:schemeClr val="lt1"/>
                </a:solidFill>
                <a:latin typeface="Montserrat"/>
                <a:ea typeface="Montserrat"/>
                <a:cs typeface="Montserrat"/>
                <a:sym typeface="Montserrat"/>
              </a:rPr>
              <a:t>, Salma Dali, Malorie Holmes, Christina Johnson, </a:t>
            </a:r>
            <a:r>
              <a:rPr lang="en" sz="1600" dirty="0" err="1">
                <a:solidFill>
                  <a:schemeClr val="lt1"/>
                </a:solidFill>
                <a:latin typeface="Montserrat"/>
                <a:ea typeface="Montserrat"/>
                <a:cs typeface="Montserrat"/>
                <a:sym typeface="Montserrat"/>
              </a:rPr>
              <a:t>Megha</a:t>
            </a:r>
            <a:r>
              <a:rPr lang="en" sz="1600" dirty="0">
                <a:solidFill>
                  <a:schemeClr val="lt1"/>
                </a:solidFill>
                <a:latin typeface="Montserrat"/>
                <a:ea typeface="Montserrat"/>
                <a:cs typeface="Montserrat"/>
                <a:sym typeface="Montserrat"/>
              </a:rPr>
              <a:t> Shankar, Abdullah Sulieman </a:t>
            </a:r>
            <a:r>
              <a:rPr lang="en" sz="1600" dirty="0" err="1">
                <a:solidFill>
                  <a:schemeClr val="lt1"/>
                </a:solidFill>
                <a:latin typeface="Montserrat"/>
                <a:ea typeface="Montserrat"/>
                <a:cs typeface="Montserrat"/>
                <a:sym typeface="Montserrat"/>
              </a:rPr>
              <a:t>Terkawi</a:t>
            </a:r>
            <a:r>
              <a:rPr lang="en" sz="1600" dirty="0">
                <a:solidFill>
                  <a:schemeClr val="lt1"/>
                </a:solidFill>
                <a:latin typeface="Montserrat"/>
                <a:ea typeface="Montserrat"/>
                <a:cs typeface="Montserrat"/>
                <a:sym typeface="Montserrat"/>
              </a:rPr>
              <a:t>.</a:t>
            </a:r>
            <a:endParaRPr sz="1600" dirty="0">
              <a:latin typeface="Montserrat"/>
              <a:ea typeface="Montserrat"/>
              <a:cs typeface="Montserrat"/>
              <a:sym typeface="Montserrat"/>
            </a:endParaRPr>
          </a:p>
        </p:txBody>
      </p:sp>
      <p:sp>
        <p:nvSpPr>
          <p:cNvPr id="91" name="Google Shape;91;p12"/>
          <p:cNvSpPr txBox="1"/>
          <p:nvPr/>
        </p:nvSpPr>
        <p:spPr>
          <a:xfrm>
            <a:off x="2405975" y="3518625"/>
            <a:ext cx="5444400" cy="627900"/>
          </a:xfrm>
          <a:prstGeom prst="rect">
            <a:avLst/>
          </a:prstGeom>
          <a:noFill/>
          <a:ln>
            <a:noFill/>
          </a:ln>
        </p:spPr>
        <p:txBody>
          <a:bodyPr spcFirstLastPara="1" wrap="square" lIns="91425" tIns="91425" rIns="91425" bIns="91425" anchor="t" anchorCtr="0">
            <a:spAutoFit/>
          </a:bodyPr>
          <a:lstStyle/>
          <a:p>
            <a:pPr marL="0" lvl="0" indent="0" algn="l" rtl="0">
              <a:lnSpc>
                <a:spcPct val="90000"/>
              </a:lnSpc>
              <a:spcBef>
                <a:spcPts val="0"/>
              </a:spcBef>
              <a:spcAft>
                <a:spcPts val="0"/>
              </a:spcAft>
              <a:buNone/>
            </a:pPr>
            <a:r>
              <a:rPr lang="en" sz="1600" b="1">
                <a:solidFill>
                  <a:schemeClr val="lt1"/>
                </a:solidFill>
                <a:latin typeface="Montserrat"/>
                <a:ea typeface="Montserrat"/>
                <a:cs typeface="Montserrat"/>
                <a:sym typeface="Montserrat"/>
              </a:rPr>
              <a:t>Mentors: </a:t>
            </a:r>
            <a:r>
              <a:rPr lang="en" sz="1600">
                <a:solidFill>
                  <a:schemeClr val="lt1"/>
                </a:solidFill>
                <a:latin typeface="Montserrat"/>
                <a:ea typeface="Montserrat"/>
                <a:cs typeface="Montserrat"/>
                <a:sym typeface="Montserrat"/>
              </a:rPr>
              <a:t>Beth Beadle, Kathleen Boyd, Joon Chang, Tamara Dunn</a:t>
            </a:r>
            <a:endParaRPr/>
          </a:p>
        </p:txBody>
      </p:sp>
      <p:sp>
        <p:nvSpPr>
          <p:cNvPr id="92" name="Google Shape;92;p12"/>
          <p:cNvSpPr txBox="1"/>
          <p:nvPr/>
        </p:nvSpPr>
        <p:spPr>
          <a:xfrm>
            <a:off x="3976750" y="4600850"/>
            <a:ext cx="4933200" cy="406200"/>
          </a:xfrm>
          <a:prstGeom prst="rect">
            <a:avLst/>
          </a:prstGeom>
          <a:noFill/>
          <a:ln>
            <a:noFill/>
          </a:ln>
        </p:spPr>
        <p:txBody>
          <a:bodyPr spcFirstLastPara="1" wrap="square" lIns="91425" tIns="91425" rIns="91425" bIns="91425" anchor="t" anchorCtr="0">
            <a:spAutoFit/>
          </a:bodyPr>
          <a:lstStyle/>
          <a:p>
            <a:pPr marL="0" lvl="0" indent="0" algn="l" rtl="0">
              <a:lnSpc>
                <a:spcPct val="90000"/>
              </a:lnSpc>
              <a:spcBef>
                <a:spcPts val="0"/>
              </a:spcBef>
              <a:spcAft>
                <a:spcPts val="0"/>
              </a:spcAft>
              <a:buNone/>
            </a:pPr>
            <a:r>
              <a:rPr lang="en" sz="1600" i="1">
                <a:solidFill>
                  <a:schemeClr val="lt1"/>
                </a:solidFill>
                <a:latin typeface="Montserrat"/>
                <a:ea typeface="Montserrat"/>
                <a:cs typeface="Montserrat"/>
                <a:sym typeface="Montserrat"/>
              </a:rPr>
              <a:t>Stanford Diversity and Inclusion Forum 5.21.21</a:t>
            </a:r>
            <a:endParaRPr i="1"/>
          </a:p>
        </p:txBody>
      </p:sp>
      <p:pic>
        <p:nvPicPr>
          <p:cNvPr id="93" name="Google Shape;93;p12" title="12 - Say My Name.mp3">
            <a:hlinkClick r:id="rId3"/>
          </p:cNvPr>
          <p:cNvPicPr preferRelativeResize="0"/>
          <p:nvPr/>
        </p:nvPicPr>
        <p:blipFill>
          <a:blip r:embed="rId4">
            <a:alphaModFix amt="80000"/>
          </a:blip>
          <a:stretch>
            <a:fillRect/>
          </a:stretch>
        </p:blipFill>
        <p:spPr>
          <a:xfrm>
            <a:off x="134250" y="4091400"/>
            <a:ext cx="627900" cy="627900"/>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21"/>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solidFill>
                  <a:schemeClr val="lt1"/>
                </a:solidFill>
              </a:rPr>
              <a:t>10</a:t>
            </a:fld>
            <a:endParaRPr>
              <a:solidFill>
                <a:schemeClr val="lt1"/>
              </a:solidFill>
            </a:endParaRPr>
          </a:p>
        </p:txBody>
      </p:sp>
      <p:grpSp>
        <p:nvGrpSpPr>
          <p:cNvPr id="188" name="Google Shape;188;p21"/>
          <p:cNvGrpSpPr/>
          <p:nvPr/>
        </p:nvGrpSpPr>
        <p:grpSpPr>
          <a:xfrm>
            <a:off x="641479" y="1"/>
            <a:ext cx="7292129" cy="5035487"/>
            <a:chOff x="2547150" y="238125"/>
            <a:chExt cx="2525675" cy="5238750"/>
          </a:xfrm>
        </p:grpSpPr>
        <p:sp>
          <p:nvSpPr>
            <p:cNvPr id="189" name="Google Shape;189;p21"/>
            <p:cNvSpPr/>
            <p:nvPr/>
          </p:nvSpPr>
          <p:spPr>
            <a:xfrm>
              <a:off x="2547150" y="238125"/>
              <a:ext cx="2525675" cy="5238750"/>
            </a:xfrm>
            <a:custGeom>
              <a:avLst/>
              <a:gdLst/>
              <a:ahLst/>
              <a:cxnLst/>
              <a:rect l="l" t="t" r="r" b="b"/>
              <a:pathLst>
                <a:path w="101027" h="209550" extrusionOk="0">
                  <a:moveTo>
                    <a:pt x="98629" y="18886"/>
                  </a:moveTo>
                  <a:lnTo>
                    <a:pt x="98629" y="190364"/>
                  </a:lnTo>
                  <a:lnTo>
                    <a:pt x="2398" y="190364"/>
                  </a:lnTo>
                  <a:lnTo>
                    <a:pt x="2398" y="18886"/>
                  </a:lnTo>
                  <a:close/>
                  <a:moveTo>
                    <a:pt x="10343" y="0"/>
                  </a:moveTo>
                  <a:lnTo>
                    <a:pt x="9293" y="75"/>
                  </a:lnTo>
                  <a:lnTo>
                    <a:pt x="8244" y="225"/>
                  </a:lnTo>
                  <a:lnTo>
                    <a:pt x="7270" y="450"/>
                  </a:lnTo>
                  <a:lnTo>
                    <a:pt x="6295" y="824"/>
                  </a:lnTo>
                  <a:lnTo>
                    <a:pt x="5396" y="1274"/>
                  </a:lnTo>
                  <a:lnTo>
                    <a:pt x="4572" y="1799"/>
                  </a:lnTo>
                  <a:lnTo>
                    <a:pt x="3747" y="2398"/>
                  </a:lnTo>
                  <a:lnTo>
                    <a:pt x="2998" y="3073"/>
                  </a:lnTo>
                  <a:lnTo>
                    <a:pt x="2323" y="3747"/>
                  </a:lnTo>
                  <a:lnTo>
                    <a:pt x="1724" y="4572"/>
                  </a:lnTo>
                  <a:lnTo>
                    <a:pt x="1199" y="5396"/>
                  </a:lnTo>
                  <a:lnTo>
                    <a:pt x="824" y="6370"/>
                  </a:lnTo>
                  <a:lnTo>
                    <a:pt x="450" y="7270"/>
                  </a:lnTo>
                  <a:lnTo>
                    <a:pt x="225" y="8319"/>
                  </a:lnTo>
                  <a:lnTo>
                    <a:pt x="0" y="9293"/>
                  </a:lnTo>
                  <a:lnTo>
                    <a:pt x="0" y="10343"/>
                  </a:lnTo>
                  <a:lnTo>
                    <a:pt x="0" y="199207"/>
                  </a:lnTo>
                  <a:lnTo>
                    <a:pt x="0" y="200257"/>
                  </a:lnTo>
                  <a:lnTo>
                    <a:pt x="225" y="201231"/>
                  </a:lnTo>
                  <a:lnTo>
                    <a:pt x="450" y="202280"/>
                  </a:lnTo>
                  <a:lnTo>
                    <a:pt x="824" y="203180"/>
                  </a:lnTo>
                  <a:lnTo>
                    <a:pt x="1199" y="204154"/>
                  </a:lnTo>
                  <a:lnTo>
                    <a:pt x="1724" y="204978"/>
                  </a:lnTo>
                  <a:lnTo>
                    <a:pt x="2323" y="205803"/>
                  </a:lnTo>
                  <a:lnTo>
                    <a:pt x="2998" y="206477"/>
                  </a:lnTo>
                  <a:lnTo>
                    <a:pt x="3747" y="207152"/>
                  </a:lnTo>
                  <a:lnTo>
                    <a:pt x="4572" y="207751"/>
                  </a:lnTo>
                  <a:lnTo>
                    <a:pt x="5396" y="208276"/>
                  </a:lnTo>
                  <a:lnTo>
                    <a:pt x="6295" y="208726"/>
                  </a:lnTo>
                  <a:lnTo>
                    <a:pt x="7270" y="209100"/>
                  </a:lnTo>
                  <a:lnTo>
                    <a:pt x="8244" y="209325"/>
                  </a:lnTo>
                  <a:lnTo>
                    <a:pt x="9293" y="209475"/>
                  </a:lnTo>
                  <a:lnTo>
                    <a:pt x="10343" y="209550"/>
                  </a:lnTo>
                  <a:lnTo>
                    <a:pt x="90610" y="209550"/>
                  </a:lnTo>
                  <a:lnTo>
                    <a:pt x="91659" y="209475"/>
                  </a:lnTo>
                  <a:lnTo>
                    <a:pt x="92708" y="209325"/>
                  </a:lnTo>
                  <a:lnTo>
                    <a:pt x="93682" y="209100"/>
                  </a:lnTo>
                  <a:lnTo>
                    <a:pt x="94657" y="208726"/>
                  </a:lnTo>
                  <a:lnTo>
                    <a:pt x="95556" y="208276"/>
                  </a:lnTo>
                  <a:lnTo>
                    <a:pt x="96455" y="207751"/>
                  </a:lnTo>
                  <a:lnTo>
                    <a:pt x="97205" y="207152"/>
                  </a:lnTo>
                  <a:lnTo>
                    <a:pt x="97954" y="206477"/>
                  </a:lnTo>
                  <a:lnTo>
                    <a:pt x="98629" y="205803"/>
                  </a:lnTo>
                  <a:lnTo>
                    <a:pt x="99228" y="204978"/>
                  </a:lnTo>
                  <a:lnTo>
                    <a:pt x="99753" y="204154"/>
                  </a:lnTo>
                  <a:lnTo>
                    <a:pt x="100203" y="203180"/>
                  </a:lnTo>
                  <a:lnTo>
                    <a:pt x="100577" y="202280"/>
                  </a:lnTo>
                  <a:lnTo>
                    <a:pt x="100802" y="201231"/>
                  </a:lnTo>
                  <a:lnTo>
                    <a:pt x="100952" y="200257"/>
                  </a:lnTo>
                  <a:lnTo>
                    <a:pt x="101027" y="199207"/>
                  </a:lnTo>
                  <a:lnTo>
                    <a:pt x="101027" y="10343"/>
                  </a:lnTo>
                  <a:lnTo>
                    <a:pt x="100952" y="9293"/>
                  </a:lnTo>
                  <a:lnTo>
                    <a:pt x="100802" y="8319"/>
                  </a:lnTo>
                  <a:lnTo>
                    <a:pt x="100577" y="7270"/>
                  </a:lnTo>
                  <a:lnTo>
                    <a:pt x="100203" y="6370"/>
                  </a:lnTo>
                  <a:lnTo>
                    <a:pt x="99753" y="5396"/>
                  </a:lnTo>
                  <a:lnTo>
                    <a:pt x="99228" y="4572"/>
                  </a:lnTo>
                  <a:lnTo>
                    <a:pt x="98629" y="3747"/>
                  </a:lnTo>
                  <a:lnTo>
                    <a:pt x="97954" y="3073"/>
                  </a:lnTo>
                  <a:lnTo>
                    <a:pt x="97205" y="2398"/>
                  </a:lnTo>
                  <a:lnTo>
                    <a:pt x="96455" y="1799"/>
                  </a:lnTo>
                  <a:lnTo>
                    <a:pt x="95556" y="1274"/>
                  </a:lnTo>
                  <a:lnTo>
                    <a:pt x="94657" y="824"/>
                  </a:lnTo>
                  <a:lnTo>
                    <a:pt x="93682" y="450"/>
                  </a:lnTo>
                  <a:lnTo>
                    <a:pt x="92708" y="225"/>
                  </a:lnTo>
                  <a:lnTo>
                    <a:pt x="91659" y="75"/>
                  </a:lnTo>
                  <a:lnTo>
                    <a:pt x="90610" y="0"/>
                  </a:lnTo>
                  <a:close/>
                </a:path>
              </a:pathLst>
            </a:cu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0" name="Google Shape;190;p21"/>
            <p:cNvSpPr/>
            <p:nvPr/>
          </p:nvSpPr>
          <p:spPr>
            <a:xfrm>
              <a:off x="3557025" y="5147100"/>
              <a:ext cx="504050" cy="179900"/>
            </a:xfrm>
            <a:custGeom>
              <a:avLst/>
              <a:gdLst/>
              <a:ahLst/>
              <a:cxnLst/>
              <a:rect l="l" t="t" r="r" b="b"/>
              <a:pathLst>
                <a:path w="20162" h="7196" extrusionOk="0">
                  <a:moveTo>
                    <a:pt x="3598" y="0"/>
                  </a:moveTo>
                  <a:lnTo>
                    <a:pt x="2849" y="75"/>
                  </a:lnTo>
                  <a:lnTo>
                    <a:pt x="2174" y="300"/>
                  </a:lnTo>
                  <a:lnTo>
                    <a:pt x="1575" y="600"/>
                  </a:lnTo>
                  <a:lnTo>
                    <a:pt x="1050" y="1050"/>
                  </a:lnTo>
                  <a:lnTo>
                    <a:pt x="600" y="1574"/>
                  </a:lnTo>
                  <a:lnTo>
                    <a:pt x="301" y="2174"/>
                  </a:lnTo>
                  <a:lnTo>
                    <a:pt x="76" y="2848"/>
                  </a:lnTo>
                  <a:lnTo>
                    <a:pt x="1" y="3598"/>
                  </a:lnTo>
                  <a:lnTo>
                    <a:pt x="76" y="4347"/>
                  </a:lnTo>
                  <a:lnTo>
                    <a:pt x="301" y="5022"/>
                  </a:lnTo>
                  <a:lnTo>
                    <a:pt x="600" y="5621"/>
                  </a:lnTo>
                  <a:lnTo>
                    <a:pt x="1050" y="6146"/>
                  </a:lnTo>
                  <a:lnTo>
                    <a:pt x="1575" y="6596"/>
                  </a:lnTo>
                  <a:lnTo>
                    <a:pt x="2174" y="6896"/>
                  </a:lnTo>
                  <a:lnTo>
                    <a:pt x="2849" y="7120"/>
                  </a:lnTo>
                  <a:lnTo>
                    <a:pt x="3598" y="7195"/>
                  </a:lnTo>
                  <a:lnTo>
                    <a:pt x="16639" y="7195"/>
                  </a:lnTo>
                  <a:lnTo>
                    <a:pt x="17313" y="7120"/>
                  </a:lnTo>
                  <a:lnTo>
                    <a:pt x="17988" y="6896"/>
                  </a:lnTo>
                  <a:lnTo>
                    <a:pt x="18587" y="6596"/>
                  </a:lnTo>
                  <a:lnTo>
                    <a:pt x="19112" y="6146"/>
                  </a:lnTo>
                  <a:lnTo>
                    <a:pt x="19562" y="5621"/>
                  </a:lnTo>
                  <a:lnTo>
                    <a:pt x="19861" y="5022"/>
                  </a:lnTo>
                  <a:lnTo>
                    <a:pt x="20086" y="4347"/>
                  </a:lnTo>
                  <a:lnTo>
                    <a:pt x="20161" y="3598"/>
                  </a:lnTo>
                  <a:lnTo>
                    <a:pt x="20086" y="2848"/>
                  </a:lnTo>
                  <a:lnTo>
                    <a:pt x="19861" y="2174"/>
                  </a:lnTo>
                  <a:lnTo>
                    <a:pt x="19562" y="1574"/>
                  </a:lnTo>
                  <a:lnTo>
                    <a:pt x="19112" y="1050"/>
                  </a:lnTo>
                  <a:lnTo>
                    <a:pt x="18587" y="600"/>
                  </a:lnTo>
                  <a:lnTo>
                    <a:pt x="17988" y="300"/>
                  </a:lnTo>
                  <a:lnTo>
                    <a:pt x="17313" y="75"/>
                  </a:lnTo>
                  <a:lnTo>
                    <a:pt x="16639" y="0"/>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1" name="Google Shape;191;p21"/>
            <p:cNvSpPr/>
            <p:nvPr/>
          </p:nvSpPr>
          <p:spPr>
            <a:xfrm>
              <a:off x="3008050" y="423600"/>
              <a:ext cx="99325" cy="99325"/>
            </a:xfrm>
            <a:custGeom>
              <a:avLst/>
              <a:gdLst/>
              <a:ahLst/>
              <a:cxnLst/>
              <a:rect l="l" t="t" r="r" b="b"/>
              <a:pathLst>
                <a:path w="3973" h="3973" extrusionOk="0">
                  <a:moveTo>
                    <a:pt x="2024" y="1"/>
                  </a:moveTo>
                  <a:lnTo>
                    <a:pt x="1575" y="76"/>
                  </a:lnTo>
                  <a:lnTo>
                    <a:pt x="1200" y="151"/>
                  </a:lnTo>
                  <a:lnTo>
                    <a:pt x="900" y="375"/>
                  </a:lnTo>
                  <a:lnTo>
                    <a:pt x="600" y="600"/>
                  </a:lnTo>
                  <a:lnTo>
                    <a:pt x="375" y="900"/>
                  </a:lnTo>
                  <a:lnTo>
                    <a:pt x="151" y="1200"/>
                  </a:lnTo>
                  <a:lnTo>
                    <a:pt x="76" y="1575"/>
                  </a:lnTo>
                  <a:lnTo>
                    <a:pt x="1" y="2024"/>
                  </a:lnTo>
                  <a:lnTo>
                    <a:pt x="76" y="2399"/>
                  </a:lnTo>
                  <a:lnTo>
                    <a:pt x="151" y="2774"/>
                  </a:lnTo>
                  <a:lnTo>
                    <a:pt x="375" y="3073"/>
                  </a:lnTo>
                  <a:lnTo>
                    <a:pt x="600" y="3373"/>
                  </a:lnTo>
                  <a:lnTo>
                    <a:pt x="900" y="3673"/>
                  </a:lnTo>
                  <a:lnTo>
                    <a:pt x="1200" y="3823"/>
                  </a:lnTo>
                  <a:lnTo>
                    <a:pt x="1575" y="3973"/>
                  </a:lnTo>
                  <a:lnTo>
                    <a:pt x="2399" y="3973"/>
                  </a:lnTo>
                  <a:lnTo>
                    <a:pt x="2774" y="3823"/>
                  </a:lnTo>
                  <a:lnTo>
                    <a:pt x="3073" y="3673"/>
                  </a:lnTo>
                  <a:lnTo>
                    <a:pt x="3373" y="3373"/>
                  </a:lnTo>
                  <a:lnTo>
                    <a:pt x="3598" y="3073"/>
                  </a:lnTo>
                  <a:lnTo>
                    <a:pt x="3823" y="2774"/>
                  </a:lnTo>
                  <a:lnTo>
                    <a:pt x="3898" y="2399"/>
                  </a:lnTo>
                  <a:lnTo>
                    <a:pt x="3973" y="2024"/>
                  </a:lnTo>
                  <a:lnTo>
                    <a:pt x="3898" y="1575"/>
                  </a:lnTo>
                  <a:lnTo>
                    <a:pt x="3823" y="1200"/>
                  </a:lnTo>
                  <a:lnTo>
                    <a:pt x="3598" y="900"/>
                  </a:lnTo>
                  <a:lnTo>
                    <a:pt x="3373" y="600"/>
                  </a:lnTo>
                  <a:lnTo>
                    <a:pt x="3073" y="375"/>
                  </a:lnTo>
                  <a:lnTo>
                    <a:pt x="2774" y="151"/>
                  </a:lnTo>
                  <a:lnTo>
                    <a:pt x="2399" y="76"/>
                  </a:lnTo>
                  <a:lnTo>
                    <a:pt x="2024" y="1"/>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2" name="Google Shape;192;p21"/>
            <p:cNvSpPr/>
            <p:nvPr/>
          </p:nvSpPr>
          <p:spPr>
            <a:xfrm>
              <a:off x="3566400" y="434850"/>
              <a:ext cx="487175" cy="76850"/>
            </a:xfrm>
            <a:custGeom>
              <a:avLst/>
              <a:gdLst/>
              <a:ahLst/>
              <a:cxnLst/>
              <a:rect l="l" t="t" r="r" b="b"/>
              <a:pathLst>
                <a:path w="19487" h="3074" extrusionOk="0">
                  <a:moveTo>
                    <a:pt x="1275" y="0"/>
                  </a:moveTo>
                  <a:lnTo>
                    <a:pt x="1050" y="75"/>
                  </a:lnTo>
                  <a:lnTo>
                    <a:pt x="750" y="150"/>
                  </a:lnTo>
                  <a:lnTo>
                    <a:pt x="525" y="300"/>
                  </a:lnTo>
                  <a:lnTo>
                    <a:pt x="375" y="450"/>
                  </a:lnTo>
                  <a:lnTo>
                    <a:pt x="225" y="675"/>
                  </a:lnTo>
                  <a:lnTo>
                    <a:pt x="75" y="975"/>
                  </a:lnTo>
                  <a:lnTo>
                    <a:pt x="1" y="1274"/>
                  </a:lnTo>
                  <a:lnTo>
                    <a:pt x="1" y="1574"/>
                  </a:lnTo>
                  <a:lnTo>
                    <a:pt x="1" y="1874"/>
                  </a:lnTo>
                  <a:lnTo>
                    <a:pt x="75" y="2174"/>
                  </a:lnTo>
                  <a:lnTo>
                    <a:pt x="225" y="2399"/>
                  </a:lnTo>
                  <a:lnTo>
                    <a:pt x="375" y="2623"/>
                  </a:lnTo>
                  <a:lnTo>
                    <a:pt x="525" y="2773"/>
                  </a:lnTo>
                  <a:lnTo>
                    <a:pt x="750" y="2923"/>
                  </a:lnTo>
                  <a:lnTo>
                    <a:pt x="1050" y="2998"/>
                  </a:lnTo>
                  <a:lnTo>
                    <a:pt x="1275" y="3073"/>
                  </a:lnTo>
                  <a:lnTo>
                    <a:pt x="18137" y="3073"/>
                  </a:lnTo>
                  <a:lnTo>
                    <a:pt x="18437" y="2998"/>
                  </a:lnTo>
                  <a:lnTo>
                    <a:pt x="18662" y="2923"/>
                  </a:lnTo>
                  <a:lnTo>
                    <a:pt x="18887" y="2773"/>
                  </a:lnTo>
                  <a:lnTo>
                    <a:pt x="19112" y="2623"/>
                  </a:lnTo>
                  <a:lnTo>
                    <a:pt x="19262" y="2399"/>
                  </a:lnTo>
                  <a:lnTo>
                    <a:pt x="19337" y="2174"/>
                  </a:lnTo>
                  <a:lnTo>
                    <a:pt x="19412" y="1874"/>
                  </a:lnTo>
                  <a:lnTo>
                    <a:pt x="19486" y="1574"/>
                  </a:lnTo>
                  <a:lnTo>
                    <a:pt x="19412" y="1274"/>
                  </a:lnTo>
                  <a:lnTo>
                    <a:pt x="19337" y="975"/>
                  </a:lnTo>
                  <a:lnTo>
                    <a:pt x="19262" y="675"/>
                  </a:lnTo>
                  <a:lnTo>
                    <a:pt x="19112" y="450"/>
                  </a:lnTo>
                  <a:lnTo>
                    <a:pt x="18887" y="300"/>
                  </a:lnTo>
                  <a:lnTo>
                    <a:pt x="18662" y="150"/>
                  </a:lnTo>
                  <a:lnTo>
                    <a:pt x="18437" y="75"/>
                  </a:lnTo>
                  <a:lnTo>
                    <a:pt x="18137" y="0"/>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93" name="Google Shape;193;p21"/>
          <p:cNvSpPr txBox="1"/>
          <p:nvPr/>
        </p:nvSpPr>
        <p:spPr>
          <a:xfrm>
            <a:off x="1481550" y="1501800"/>
            <a:ext cx="6080100" cy="1416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4000" dirty="0">
                <a:solidFill>
                  <a:schemeClr val="lt1"/>
                </a:solidFill>
                <a:latin typeface="Montserrat Light"/>
                <a:ea typeface="Montserrat Light"/>
                <a:cs typeface="Montserrat Light"/>
                <a:sym typeface="Montserrat Light"/>
              </a:rPr>
              <a:t>Has your name ever been mispronounced?</a:t>
            </a:r>
            <a:endParaRPr sz="4000" dirty="0">
              <a:solidFill>
                <a:schemeClr val="lt1"/>
              </a:solidFill>
              <a:latin typeface="Montserrat Light"/>
              <a:ea typeface="Montserrat Light"/>
              <a:cs typeface="Montserrat Light"/>
              <a:sym typeface="Montserrat Light"/>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22"/>
          <p:cNvSpPr txBox="1">
            <a:spLocks noGrp="1"/>
          </p:cNvSpPr>
          <p:nvPr>
            <p:ph type="ctrTitle"/>
          </p:nvPr>
        </p:nvSpPr>
        <p:spPr>
          <a:xfrm>
            <a:off x="685800" y="1668151"/>
            <a:ext cx="7772400" cy="1311600"/>
          </a:xfrm>
          <a:prstGeom prst="rect">
            <a:avLst/>
          </a:prstGeom>
        </p:spPr>
        <p:txBody>
          <a:bodyPr spcFirstLastPara="1" wrap="square" lIns="0" tIns="0" rIns="0" bIns="0" anchor="b" anchorCtr="0">
            <a:noAutofit/>
          </a:bodyPr>
          <a:lstStyle/>
          <a:p>
            <a:pPr marL="0" lvl="0" indent="0" algn="l" rtl="0">
              <a:spcBef>
                <a:spcPts val="0"/>
              </a:spcBef>
              <a:spcAft>
                <a:spcPts val="0"/>
              </a:spcAft>
              <a:buNone/>
            </a:pPr>
            <a:endParaRPr>
              <a:solidFill>
                <a:schemeClr val="accent1"/>
              </a:solidFill>
            </a:endParaRPr>
          </a:p>
          <a:p>
            <a:pPr marL="0" lvl="0" indent="0" algn="l" rtl="0">
              <a:spcBef>
                <a:spcPts val="0"/>
              </a:spcBef>
              <a:spcAft>
                <a:spcPts val="0"/>
              </a:spcAft>
              <a:buNone/>
            </a:pPr>
            <a:r>
              <a:rPr lang="en"/>
              <a:t>What do we know about this? </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23"/>
          <p:cNvSpPr txBox="1">
            <a:spLocks noGrp="1"/>
          </p:cNvSpPr>
          <p:nvPr>
            <p:ph type="ctrTitle" idx="4294967295"/>
          </p:nvPr>
        </p:nvSpPr>
        <p:spPr>
          <a:xfrm>
            <a:off x="685800" y="1003113"/>
            <a:ext cx="4644900" cy="19764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sz="3100">
                <a:solidFill>
                  <a:schemeClr val="lt1"/>
                </a:solidFill>
              </a:rPr>
              <a:t>Teachers, please learn our names!: racial microaggressions and the K-12 classroom </a:t>
            </a:r>
            <a:endParaRPr sz="3100">
              <a:solidFill>
                <a:schemeClr val="lt1"/>
              </a:solidFill>
            </a:endParaRPr>
          </a:p>
        </p:txBody>
      </p:sp>
      <p:sp>
        <p:nvSpPr>
          <p:cNvPr id="204" name="Google Shape;204;p23"/>
          <p:cNvSpPr txBox="1">
            <a:spLocks noGrp="1"/>
          </p:cNvSpPr>
          <p:nvPr>
            <p:ph type="subTitle" idx="4294967295"/>
          </p:nvPr>
        </p:nvSpPr>
        <p:spPr>
          <a:xfrm>
            <a:off x="685800" y="2961985"/>
            <a:ext cx="4644900" cy="1178400"/>
          </a:xfrm>
          <a:prstGeom prst="rect">
            <a:avLst/>
          </a:prstGeom>
        </p:spPr>
        <p:txBody>
          <a:bodyPr spcFirstLastPara="1" wrap="square" lIns="0" tIns="0" rIns="0" bIns="0" anchor="t" anchorCtr="0">
            <a:noAutofit/>
          </a:bodyPr>
          <a:lstStyle/>
          <a:p>
            <a:pPr marL="0" lvl="0" indent="0" algn="l" rtl="0">
              <a:spcBef>
                <a:spcPts val="0"/>
              </a:spcBef>
              <a:spcAft>
                <a:spcPts val="600"/>
              </a:spcAft>
              <a:buNone/>
            </a:pPr>
            <a:r>
              <a:rPr lang="en">
                <a:solidFill>
                  <a:schemeClr val="accent2"/>
                </a:solidFill>
              </a:rPr>
              <a:t>2012</a:t>
            </a:r>
            <a:endParaRPr>
              <a:solidFill>
                <a:schemeClr val="accent2"/>
              </a:solidFill>
            </a:endParaRPr>
          </a:p>
        </p:txBody>
      </p:sp>
      <p:sp>
        <p:nvSpPr>
          <p:cNvPr id="205" name="Google Shape;205;p23"/>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solidFill>
                  <a:schemeClr val="lt1"/>
                </a:solidFill>
              </a:rPr>
              <a:t>12</a:t>
            </a:fld>
            <a:endParaRPr>
              <a:solidFill>
                <a:schemeClr val="lt1"/>
              </a:solidFill>
            </a:endParaRPr>
          </a:p>
        </p:txBody>
      </p:sp>
      <p:sp>
        <p:nvSpPr>
          <p:cNvPr id="6" name="TextBox 5">
            <a:extLst>
              <a:ext uri="{FF2B5EF4-FFF2-40B4-BE49-F238E27FC236}">
                <a16:creationId xmlns:a16="http://schemas.microsoft.com/office/drawing/2014/main" id="{B823964E-26A2-3F4D-B126-5C702389D7AD}"/>
              </a:ext>
            </a:extLst>
          </p:cNvPr>
          <p:cNvSpPr txBox="1"/>
          <p:nvPr/>
        </p:nvSpPr>
        <p:spPr>
          <a:xfrm>
            <a:off x="203703" y="4630608"/>
            <a:ext cx="4572000" cy="307777"/>
          </a:xfrm>
          <a:prstGeom prst="rect">
            <a:avLst/>
          </a:prstGeom>
          <a:noFill/>
        </p:spPr>
        <p:txBody>
          <a:bodyPr wrap="square">
            <a:spAutoFit/>
          </a:bodyPr>
          <a:lstStyle/>
          <a:p>
            <a:r>
              <a:rPr lang="en-US" i="1" dirty="0">
                <a:solidFill>
                  <a:schemeClr val="bg2"/>
                </a:solidFill>
              </a:rPr>
              <a:t>Kohli et al, Race Ethnicity and Education, 2012</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24"/>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dirty="0"/>
              <a:t>Teachers, please learn our names! - Findings</a:t>
            </a:r>
            <a:endParaRPr dirty="0"/>
          </a:p>
        </p:txBody>
      </p:sp>
      <p:sp>
        <p:nvSpPr>
          <p:cNvPr id="211" name="Google Shape;211;p24"/>
          <p:cNvSpPr txBox="1">
            <a:spLocks noGrp="1"/>
          </p:cNvSpPr>
          <p:nvPr>
            <p:ph type="body" idx="1"/>
          </p:nvPr>
        </p:nvSpPr>
        <p:spPr>
          <a:xfrm>
            <a:off x="855300" y="1430147"/>
            <a:ext cx="7433400" cy="3033900"/>
          </a:xfrm>
          <a:prstGeom prst="rect">
            <a:avLst/>
          </a:prstGeom>
          <a:ln w="9525" cap="flat" cmpd="sng">
            <a:solidFill>
              <a:schemeClr val="lt1"/>
            </a:solidFill>
            <a:prstDash val="solid"/>
            <a:round/>
            <a:headEnd type="none" w="sm" len="sm"/>
            <a:tailEnd type="none" w="sm" len="sm"/>
          </a:ln>
        </p:spPr>
        <p:txBody>
          <a:bodyPr spcFirstLastPara="1" wrap="square" lIns="0" tIns="0" rIns="0" bIns="0" anchor="t" anchorCtr="0">
            <a:noAutofit/>
          </a:bodyPr>
          <a:lstStyle/>
          <a:p>
            <a:pPr marL="457200" lvl="0" indent="-342900" algn="l" rtl="0">
              <a:lnSpc>
                <a:spcPct val="115000"/>
              </a:lnSpc>
              <a:spcBef>
                <a:spcPts val="0"/>
              </a:spcBef>
              <a:spcAft>
                <a:spcPts val="0"/>
              </a:spcAft>
              <a:buSzPts val="1800"/>
              <a:buFont typeface="Montserrat"/>
              <a:buChar char="●"/>
            </a:pPr>
            <a:r>
              <a:rPr lang="en" sz="1800">
                <a:solidFill>
                  <a:srgbClr val="000000"/>
                </a:solidFill>
                <a:latin typeface="Montserrat"/>
                <a:ea typeface="Montserrat"/>
                <a:cs typeface="Montserrat"/>
                <a:sym typeface="Montserrat"/>
              </a:rPr>
              <a:t>Students recounted instances of being re-named with more traditionally western sounding names, or having names approximated to objects, joked about, etc </a:t>
            </a:r>
            <a:endParaRPr sz="1800">
              <a:solidFill>
                <a:srgbClr val="000000"/>
              </a:solidFill>
              <a:latin typeface="Montserrat"/>
              <a:ea typeface="Montserrat"/>
              <a:cs typeface="Montserrat"/>
              <a:sym typeface="Montserrat"/>
            </a:endParaRPr>
          </a:p>
          <a:p>
            <a:pPr marL="457200" lvl="0" indent="-342900" algn="l" rtl="0">
              <a:lnSpc>
                <a:spcPct val="115000"/>
              </a:lnSpc>
              <a:spcBef>
                <a:spcPts val="1000"/>
              </a:spcBef>
              <a:spcAft>
                <a:spcPts val="0"/>
              </a:spcAft>
              <a:buSzPts val="1800"/>
              <a:buFont typeface="Montserrat"/>
              <a:buChar char="●"/>
            </a:pPr>
            <a:r>
              <a:rPr lang="en" sz="1800">
                <a:solidFill>
                  <a:srgbClr val="000000"/>
                </a:solidFill>
                <a:latin typeface="Montserrat"/>
                <a:ea typeface="Montserrat"/>
                <a:cs typeface="Montserrat"/>
                <a:sym typeface="Montserrat"/>
              </a:rPr>
              <a:t>Identified the experiences children were having in the classroom related to names as racial microaggressions </a:t>
            </a:r>
            <a:endParaRPr sz="1800">
              <a:solidFill>
                <a:srgbClr val="000000"/>
              </a:solidFill>
              <a:latin typeface="Montserrat"/>
              <a:ea typeface="Montserrat"/>
              <a:cs typeface="Montserrat"/>
              <a:sym typeface="Montserrat"/>
            </a:endParaRPr>
          </a:p>
          <a:p>
            <a:pPr marL="457200" lvl="0" indent="-342900" algn="l" rtl="0">
              <a:lnSpc>
                <a:spcPct val="115000"/>
              </a:lnSpc>
              <a:spcBef>
                <a:spcPts val="1000"/>
              </a:spcBef>
              <a:spcAft>
                <a:spcPts val="1000"/>
              </a:spcAft>
              <a:buSzPts val="1800"/>
              <a:buFont typeface="Montserrat"/>
              <a:buChar char="●"/>
            </a:pPr>
            <a:r>
              <a:rPr lang="en" sz="1800">
                <a:solidFill>
                  <a:srgbClr val="000000"/>
                </a:solidFill>
                <a:latin typeface="Montserrat"/>
                <a:ea typeface="Montserrat"/>
                <a:cs typeface="Montserrat"/>
                <a:sym typeface="Montserrat"/>
              </a:rPr>
              <a:t>Examined internalized racial microaggressions that students experienced causing them to feel “anxiety,  shame, or feelings of ‘othering’”</a:t>
            </a:r>
            <a:endParaRPr sz="1200">
              <a:solidFill>
                <a:srgbClr val="000000"/>
              </a:solidFill>
              <a:latin typeface="Montserrat"/>
              <a:ea typeface="Montserrat"/>
              <a:cs typeface="Montserrat"/>
              <a:sym typeface="Montserrat"/>
            </a:endParaRPr>
          </a:p>
        </p:txBody>
      </p:sp>
      <p:sp>
        <p:nvSpPr>
          <p:cNvPr id="212" name="Google Shape;212;p24"/>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13</a:t>
            </a:fld>
            <a:endParaRPr/>
          </a:p>
        </p:txBody>
      </p:sp>
      <p:sp>
        <p:nvSpPr>
          <p:cNvPr id="6" name="TextBox 5">
            <a:extLst>
              <a:ext uri="{FF2B5EF4-FFF2-40B4-BE49-F238E27FC236}">
                <a16:creationId xmlns:a16="http://schemas.microsoft.com/office/drawing/2014/main" id="{5A767E6B-14D7-2B42-9866-D657B4D9755C}"/>
              </a:ext>
            </a:extLst>
          </p:cNvPr>
          <p:cNvSpPr txBox="1"/>
          <p:nvPr/>
        </p:nvSpPr>
        <p:spPr>
          <a:xfrm>
            <a:off x="275878" y="4661894"/>
            <a:ext cx="4572000" cy="307777"/>
          </a:xfrm>
          <a:prstGeom prst="rect">
            <a:avLst/>
          </a:prstGeom>
          <a:noFill/>
        </p:spPr>
        <p:txBody>
          <a:bodyPr wrap="square">
            <a:spAutoFit/>
          </a:bodyPr>
          <a:lstStyle/>
          <a:p>
            <a:r>
              <a:rPr lang="en-US" i="1" dirty="0">
                <a:solidFill>
                  <a:schemeClr val="bg2"/>
                </a:solidFill>
              </a:rPr>
              <a:t>Kohli et al, Race Ethnicity and Education, 2012</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5"/>
          <p:cNvSpPr txBox="1">
            <a:spLocks noGrp="1"/>
          </p:cNvSpPr>
          <p:nvPr>
            <p:ph type="ctrTitle" idx="4294967295"/>
          </p:nvPr>
        </p:nvSpPr>
        <p:spPr>
          <a:xfrm>
            <a:off x="685800" y="1003113"/>
            <a:ext cx="4644900" cy="19764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sz="3100">
                <a:solidFill>
                  <a:schemeClr val="lt1"/>
                </a:solidFill>
              </a:rPr>
              <a:t>America Ruined My Name For Me </a:t>
            </a:r>
            <a:endParaRPr sz="3100">
              <a:solidFill>
                <a:schemeClr val="lt1"/>
              </a:solidFill>
            </a:endParaRPr>
          </a:p>
        </p:txBody>
      </p:sp>
      <p:sp>
        <p:nvSpPr>
          <p:cNvPr id="218" name="Google Shape;218;p25"/>
          <p:cNvSpPr txBox="1">
            <a:spLocks noGrp="1"/>
          </p:cNvSpPr>
          <p:nvPr>
            <p:ph type="subTitle" idx="4294967295"/>
          </p:nvPr>
        </p:nvSpPr>
        <p:spPr>
          <a:xfrm>
            <a:off x="685800" y="2961985"/>
            <a:ext cx="4644900" cy="11784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dirty="0">
                <a:solidFill>
                  <a:schemeClr val="accent2"/>
                </a:solidFill>
              </a:rPr>
              <a:t>April 1st, 2021</a:t>
            </a:r>
            <a:endParaRPr dirty="0">
              <a:solidFill>
                <a:schemeClr val="accent2"/>
              </a:solidFill>
            </a:endParaRPr>
          </a:p>
          <a:p>
            <a:pPr marL="0" lvl="0" indent="0" algn="l" rtl="0">
              <a:spcBef>
                <a:spcPts val="600"/>
              </a:spcBef>
              <a:spcAft>
                <a:spcPts val="600"/>
              </a:spcAft>
              <a:buNone/>
            </a:pPr>
            <a:r>
              <a:rPr lang="en" dirty="0">
                <a:solidFill>
                  <a:schemeClr val="accent2"/>
                </a:solidFill>
              </a:rPr>
              <a:t>The New Yorker magazine </a:t>
            </a:r>
            <a:endParaRPr dirty="0">
              <a:solidFill>
                <a:schemeClr val="accent2"/>
              </a:solidFill>
            </a:endParaRPr>
          </a:p>
        </p:txBody>
      </p:sp>
      <p:sp>
        <p:nvSpPr>
          <p:cNvPr id="219" name="Google Shape;219;p25"/>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solidFill>
                  <a:schemeClr val="lt1"/>
                </a:solidFill>
              </a:rPr>
              <a:t>14</a:t>
            </a:fld>
            <a:endParaRPr>
              <a:solidFill>
                <a:schemeClr val="lt1"/>
              </a:solidFill>
            </a:endParaRPr>
          </a:p>
        </p:txBody>
      </p:sp>
      <p:sp>
        <p:nvSpPr>
          <p:cNvPr id="7" name="TextBox 6">
            <a:extLst>
              <a:ext uri="{FF2B5EF4-FFF2-40B4-BE49-F238E27FC236}">
                <a16:creationId xmlns:a16="http://schemas.microsoft.com/office/drawing/2014/main" id="{158CD6D1-3E15-A54C-9146-665C3E81D810}"/>
              </a:ext>
            </a:extLst>
          </p:cNvPr>
          <p:cNvSpPr txBox="1"/>
          <p:nvPr/>
        </p:nvSpPr>
        <p:spPr>
          <a:xfrm>
            <a:off x="114716" y="4749851"/>
            <a:ext cx="4572000" cy="307777"/>
          </a:xfrm>
          <a:prstGeom prst="rect">
            <a:avLst/>
          </a:prstGeom>
          <a:noFill/>
        </p:spPr>
        <p:txBody>
          <a:bodyPr wrap="square">
            <a:spAutoFit/>
          </a:bodyPr>
          <a:lstStyle/>
          <a:p>
            <a:r>
              <a:rPr lang="en-US" i="1" dirty="0">
                <a:solidFill>
                  <a:schemeClr val="bg2"/>
                </a:solidFill>
              </a:rPr>
              <a:t>Nguyen, The New Yorker Magazine, 2021</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26"/>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dirty="0"/>
              <a:t>America Ruined My Name For Me </a:t>
            </a:r>
            <a:endParaRPr dirty="0"/>
          </a:p>
        </p:txBody>
      </p:sp>
      <p:sp>
        <p:nvSpPr>
          <p:cNvPr id="226" name="Google Shape;226;p26"/>
          <p:cNvSpPr txBox="1">
            <a:spLocks noGrp="1"/>
          </p:cNvSpPr>
          <p:nvPr>
            <p:ph type="body" idx="1"/>
          </p:nvPr>
        </p:nvSpPr>
        <p:spPr>
          <a:xfrm>
            <a:off x="379050" y="1411100"/>
            <a:ext cx="5774100" cy="3033900"/>
          </a:xfrm>
          <a:prstGeom prst="rect">
            <a:avLst/>
          </a:prstGeom>
        </p:spPr>
        <p:txBody>
          <a:bodyPr spcFirstLastPara="1" wrap="square" lIns="0" tIns="0" rIns="0" bIns="0" anchor="t" anchorCtr="0">
            <a:noAutofit/>
          </a:bodyPr>
          <a:lstStyle/>
          <a:p>
            <a:pPr marL="457200" lvl="0" indent="-381000" algn="l" rtl="0">
              <a:spcBef>
                <a:spcPts val="0"/>
              </a:spcBef>
              <a:spcAft>
                <a:spcPts val="0"/>
              </a:spcAft>
              <a:buSzPts val="2400"/>
              <a:buChar char="●"/>
            </a:pPr>
            <a:r>
              <a:rPr lang="en"/>
              <a:t>Autobiographical account by author Beth Nguyen (given name Bich Nguyen, pronounced Bic)</a:t>
            </a:r>
            <a:endParaRPr/>
          </a:p>
          <a:p>
            <a:pPr marL="457200" lvl="0" indent="-381000" algn="l" rtl="0">
              <a:spcBef>
                <a:spcPts val="600"/>
              </a:spcBef>
              <a:spcAft>
                <a:spcPts val="0"/>
              </a:spcAft>
              <a:buSzPts val="2400"/>
              <a:buChar char="●"/>
            </a:pPr>
            <a:r>
              <a:rPr lang="en"/>
              <a:t>Recounts the complexity of living with a name that often draws commentary vs. changing one’s name</a:t>
            </a:r>
            <a:endParaRPr/>
          </a:p>
          <a:p>
            <a:pPr marL="457200" lvl="0" indent="0" algn="l" rtl="0">
              <a:spcBef>
                <a:spcPts val="600"/>
              </a:spcBef>
              <a:spcAft>
                <a:spcPts val="600"/>
              </a:spcAft>
              <a:buNone/>
            </a:pPr>
            <a:endParaRPr/>
          </a:p>
        </p:txBody>
      </p:sp>
      <p:sp>
        <p:nvSpPr>
          <p:cNvPr id="227" name="Google Shape;227;p26"/>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15</a:t>
            </a:fld>
            <a:endParaRPr/>
          </a:p>
        </p:txBody>
      </p:sp>
      <p:sp>
        <p:nvSpPr>
          <p:cNvPr id="228" name="Google Shape;228;p26"/>
          <p:cNvSpPr txBox="1"/>
          <p:nvPr/>
        </p:nvSpPr>
        <p:spPr>
          <a:xfrm>
            <a:off x="6029275" y="1411100"/>
            <a:ext cx="3000000" cy="215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600">
                <a:highlight>
                  <a:srgbClr val="FFFFFF"/>
                </a:highlight>
                <a:latin typeface="Times New Roman"/>
                <a:ea typeface="Times New Roman"/>
                <a:cs typeface="Times New Roman"/>
                <a:sym typeface="Times New Roman"/>
              </a:rPr>
              <a:t>“It was a double bind: the people who made me uncomfortable with my given name also thought that I’d be betraying my heritage by changing it. What I have always wanted is impossible: to be nameless, free from the gaze.”</a:t>
            </a:r>
            <a:endParaRPr sz="1600">
              <a:highlight>
                <a:srgbClr val="FFFFFF"/>
              </a:highlight>
              <a:latin typeface="Times New Roman"/>
              <a:ea typeface="Times New Roman"/>
              <a:cs typeface="Times New Roman"/>
              <a:sym typeface="Times New Roman"/>
            </a:endParaRPr>
          </a:p>
          <a:p>
            <a:pPr marL="457200" lvl="0" indent="-330200" algn="l" rtl="0">
              <a:spcBef>
                <a:spcPts val="0"/>
              </a:spcBef>
              <a:spcAft>
                <a:spcPts val="0"/>
              </a:spcAft>
              <a:buSzPts val="1600"/>
              <a:buFont typeface="Times New Roman"/>
              <a:buChar char="-"/>
            </a:pPr>
            <a:r>
              <a:rPr lang="en" sz="1600">
                <a:highlight>
                  <a:srgbClr val="FFFFFF"/>
                </a:highlight>
                <a:latin typeface="Times New Roman"/>
                <a:ea typeface="Times New Roman"/>
                <a:cs typeface="Times New Roman"/>
                <a:sym typeface="Times New Roman"/>
              </a:rPr>
              <a:t>Beth Nguyen</a:t>
            </a:r>
            <a:endParaRPr sz="1600">
              <a:highlight>
                <a:srgbClr val="FFFFFF"/>
              </a:highlight>
              <a:latin typeface="Times New Roman"/>
              <a:ea typeface="Times New Roman"/>
              <a:cs typeface="Times New Roman"/>
              <a:sym typeface="Times New Roman"/>
            </a:endParaRPr>
          </a:p>
        </p:txBody>
      </p:sp>
      <p:sp>
        <p:nvSpPr>
          <p:cNvPr id="7" name="TextBox 6">
            <a:extLst>
              <a:ext uri="{FF2B5EF4-FFF2-40B4-BE49-F238E27FC236}">
                <a16:creationId xmlns:a16="http://schemas.microsoft.com/office/drawing/2014/main" id="{0B5C5E0B-016E-0143-A2FB-684FBA9BF851}"/>
              </a:ext>
            </a:extLst>
          </p:cNvPr>
          <p:cNvSpPr txBox="1"/>
          <p:nvPr/>
        </p:nvSpPr>
        <p:spPr>
          <a:xfrm>
            <a:off x="114716" y="4746949"/>
            <a:ext cx="4572000" cy="307777"/>
          </a:xfrm>
          <a:prstGeom prst="rect">
            <a:avLst/>
          </a:prstGeom>
          <a:noFill/>
        </p:spPr>
        <p:txBody>
          <a:bodyPr wrap="square">
            <a:spAutoFit/>
          </a:bodyPr>
          <a:lstStyle/>
          <a:p>
            <a:r>
              <a:rPr lang="en-US" i="1" dirty="0">
                <a:solidFill>
                  <a:schemeClr val="bg2"/>
                </a:solidFill>
              </a:rPr>
              <a:t>Nguyen, The New Yorker Magazine, 2021</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27"/>
          <p:cNvSpPr txBox="1">
            <a:spLocks noGrp="1"/>
          </p:cNvSpPr>
          <p:nvPr>
            <p:ph type="ctrTitle" idx="4294967295"/>
          </p:nvPr>
        </p:nvSpPr>
        <p:spPr>
          <a:xfrm>
            <a:off x="685800" y="1003113"/>
            <a:ext cx="4644900" cy="19764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sz="3100">
                <a:solidFill>
                  <a:schemeClr val="lt1"/>
                </a:solidFill>
              </a:rPr>
              <a:t>History of Racism and Name pronunciation</a:t>
            </a:r>
            <a:endParaRPr sz="3100">
              <a:solidFill>
                <a:schemeClr val="lt1"/>
              </a:solidFill>
            </a:endParaRPr>
          </a:p>
        </p:txBody>
      </p:sp>
      <p:sp>
        <p:nvSpPr>
          <p:cNvPr id="234" name="Google Shape;234;p27"/>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solidFill>
                  <a:schemeClr val="lt1"/>
                </a:solidFill>
              </a:rPr>
              <a:t>16</a:t>
            </a:fld>
            <a:endParaRPr>
              <a:solidFill>
                <a:schemeClr val="lt1"/>
              </a:solidFill>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29"/>
          <p:cNvSpPr txBox="1">
            <a:spLocks noGrp="1"/>
          </p:cNvSpPr>
          <p:nvPr>
            <p:ph type="title"/>
          </p:nvPr>
        </p:nvSpPr>
        <p:spPr>
          <a:xfrm>
            <a:off x="855300" y="679453"/>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dirty="0"/>
              <a:t>History of Racism and Name Mispronunciation</a:t>
            </a:r>
            <a:endParaRPr dirty="0"/>
          </a:p>
        </p:txBody>
      </p:sp>
      <p:sp>
        <p:nvSpPr>
          <p:cNvPr id="246" name="Google Shape;246;p29"/>
          <p:cNvSpPr txBox="1">
            <a:spLocks noGrp="1"/>
          </p:cNvSpPr>
          <p:nvPr>
            <p:ph type="body" idx="1"/>
          </p:nvPr>
        </p:nvSpPr>
        <p:spPr>
          <a:xfrm>
            <a:off x="855300" y="1123045"/>
            <a:ext cx="7836027" cy="2897409"/>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sz="2000" b="1" dirty="0">
                <a:solidFill>
                  <a:srgbClr val="000000"/>
                </a:solidFill>
                <a:latin typeface="Montserrat"/>
                <a:ea typeface="Montserrat"/>
                <a:cs typeface="Montserrat"/>
                <a:sym typeface="Montserrat"/>
              </a:rPr>
              <a:t>Names and Slavery</a:t>
            </a:r>
            <a:endParaRPr sz="2000" b="1" dirty="0">
              <a:solidFill>
                <a:srgbClr val="000000"/>
              </a:solidFill>
              <a:latin typeface="Montserrat"/>
              <a:ea typeface="Montserrat"/>
              <a:cs typeface="Montserrat"/>
              <a:sym typeface="Montserrat"/>
            </a:endParaRPr>
          </a:p>
          <a:p>
            <a:pPr marL="914400" lvl="0" indent="-349250" algn="l" rtl="0">
              <a:spcBef>
                <a:spcPts val="600"/>
              </a:spcBef>
              <a:spcAft>
                <a:spcPts val="0"/>
              </a:spcAft>
              <a:buSzPts val="1900"/>
              <a:buFont typeface="Montserrat"/>
              <a:buChar char="●"/>
            </a:pPr>
            <a:r>
              <a:rPr lang="en" sz="1900" dirty="0">
                <a:solidFill>
                  <a:srgbClr val="000000"/>
                </a:solidFill>
                <a:latin typeface="Montserrat"/>
                <a:ea typeface="Montserrat"/>
                <a:cs typeface="Montserrat"/>
                <a:sym typeface="Montserrat"/>
              </a:rPr>
              <a:t>Slaves given European-sounding “slave names” to replace their “African names”</a:t>
            </a:r>
            <a:endParaRPr sz="1900" dirty="0">
              <a:solidFill>
                <a:srgbClr val="000000"/>
              </a:solidFill>
              <a:latin typeface="Montserrat"/>
              <a:ea typeface="Montserrat"/>
              <a:cs typeface="Montserrat"/>
              <a:sym typeface="Montserrat"/>
            </a:endParaRPr>
          </a:p>
          <a:p>
            <a:pPr marL="914400" lvl="0" indent="-349250" algn="l" rtl="0">
              <a:spcBef>
                <a:spcPts val="600"/>
              </a:spcBef>
              <a:spcAft>
                <a:spcPts val="0"/>
              </a:spcAft>
              <a:buSzPts val="1900"/>
              <a:buFont typeface="Montserrat"/>
              <a:buChar char="●"/>
            </a:pPr>
            <a:r>
              <a:rPr lang="en" sz="1900" dirty="0">
                <a:solidFill>
                  <a:srgbClr val="000000"/>
                </a:solidFill>
                <a:latin typeface="Montserrat"/>
                <a:ea typeface="Montserrat"/>
                <a:cs typeface="Montserrat"/>
                <a:sym typeface="Montserrat"/>
              </a:rPr>
              <a:t>Last name was often times the name of the slave owner </a:t>
            </a:r>
            <a:endParaRPr sz="1900" dirty="0">
              <a:solidFill>
                <a:srgbClr val="000000"/>
              </a:solidFill>
              <a:latin typeface="Montserrat"/>
              <a:ea typeface="Montserrat"/>
              <a:cs typeface="Montserrat"/>
              <a:sym typeface="Montserrat"/>
            </a:endParaRPr>
          </a:p>
          <a:p>
            <a:pPr marL="914400" lvl="0" indent="-349250" algn="l" rtl="0">
              <a:spcBef>
                <a:spcPts val="600"/>
              </a:spcBef>
              <a:spcAft>
                <a:spcPts val="0"/>
              </a:spcAft>
              <a:buSzPts val="1900"/>
              <a:buFont typeface="Montserrat"/>
              <a:buChar char="●"/>
            </a:pPr>
            <a:r>
              <a:rPr lang="en" sz="1900" dirty="0">
                <a:solidFill>
                  <a:srgbClr val="000000"/>
                </a:solidFill>
                <a:latin typeface="Montserrat"/>
                <a:ea typeface="Montserrat"/>
                <a:cs typeface="Montserrat"/>
                <a:sym typeface="Montserrat"/>
              </a:rPr>
              <a:t>After emancipation, many former slaves changed their names </a:t>
            </a:r>
            <a:endParaRPr sz="1900" dirty="0">
              <a:solidFill>
                <a:srgbClr val="000000"/>
              </a:solidFill>
              <a:latin typeface="Montserrat"/>
              <a:ea typeface="Montserrat"/>
              <a:cs typeface="Montserrat"/>
              <a:sym typeface="Montserrat"/>
            </a:endParaRPr>
          </a:p>
          <a:p>
            <a:pPr marL="0" lvl="0" indent="0" algn="l" rtl="0">
              <a:spcBef>
                <a:spcPts val="600"/>
              </a:spcBef>
              <a:spcAft>
                <a:spcPts val="0"/>
              </a:spcAft>
              <a:buNone/>
            </a:pPr>
            <a:r>
              <a:rPr lang="en" sz="2000" b="1" dirty="0">
                <a:solidFill>
                  <a:srgbClr val="000000"/>
                </a:solidFill>
                <a:latin typeface="Montserrat"/>
                <a:ea typeface="Montserrat"/>
                <a:cs typeface="Montserrat"/>
                <a:sym typeface="Montserrat"/>
              </a:rPr>
              <a:t>Westernized Names and Racial/Ethnic Identity</a:t>
            </a:r>
            <a:endParaRPr sz="2000" b="1" dirty="0">
              <a:solidFill>
                <a:srgbClr val="000000"/>
              </a:solidFill>
              <a:latin typeface="Montserrat"/>
              <a:ea typeface="Montserrat"/>
              <a:cs typeface="Montserrat"/>
              <a:sym typeface="Montserrat"/>
            </a:endParaRPr>
          </a:p>
          <a:p>
            <a:pPr marL="914400" lvl="0" indent="-355600" algn="l" rtl="0">
              <a:spcBef>
                <a:spcPts val="600"/>
              </a:spcBef>
              <a:spcAft>
                <a:spcPts val="0"/>
              </a:spcAft>
              <a:buSzPts val="2000"/>
              <a:buFont typeface="Montserrat"/>
              <a:buChar char="●"/>
            </a:pPr>
            <a:r>
              <a:rPr lang="en" sz="1900" dirty="0">
                <a:solidFill>
                  <a:srgbClr val="000000"/>
                </a:solidFill>
                <a:latin typeface="Montserrat"/>
                <a:ea typeface="Montserrat"/>
                <a:cs typeface="Montserrat"/>
                <a:sym typeface="Montserrat"/>
              </a:rPr>
              <a:t>Westernizing names to “fit in” </a:t>
            </a:r>
            <a:endParaRPr sz="1900" dirty="0">
              <a:solidFill>
                <a:srgbClr val="000000"/>
              </a:solidFill>
              <a:latin typeface="Montserrat"/>
              <a:ea typeface="Montserrat"/>
              <a:cs typeface="Montserrat"/>
              <a:sym typeface="Montserrat"/>
            </a:endParaRPr>
          </a:p>
          <a:p>
            <a:pPr marL="914400" lvl="0" indent="-355600" algn="l" rtl="0">
              <a:spcBef>
                <a:spcPts val="0"/>
              </a:spcBef>
              <a:spcAft>
                <a:spcPts val="600"/>
              </a:spcAft>
              <a:buSzPts val="2000"/>
              <a:buFont typeface="Montserrat"/>
              <a:buChar char="●"/>
            </a:pPr>
            <a:r>
              <a:rPr lang="en" sz="1900" dirty="0">
                <a:solidFill>
                  <a:srgbClr val="000000"/>
                </a:solidFill>
                <a:latin typeface="Montserrat"/>
                <a:ea typeface="Montserrat"/>
                <a:cs typeface="Montserrat"/>
                <a:sym typeface="Montserrat"/>
              </a:rPr>
              <a:t>Re-claiming names to re-claim identity --- but it’s tricky</a:t>
            </a:r>
            <a:r>
              <a:rPr lang="en" sz="2000" dirty="0">
                <a:solidFill>
                  <a:srgbClr val="000000"/>
                </a:solidFill>
                <a:latin typeface="Montserrat"/>
                <a:ea typeface="Montserrat"/>
                <a:cs typeface="Montserrat"/>
                <a:sym typeface="Montserrat"/>
              </a:rPr>
              <a:t> </a:t>
            </a:r>
            <a:endParaRPr sz="2000" dirty="0">
              <a:solidFill>
                <a:srgbClr val="000000"/>
              </a:solidFill>
              <a:latin typeface="Montserrat"/>
              <a:ea typeface="Montserrat"/>
              <a:cs typeface="Montserrat"/>
              <a:sym typeface="Montserrat"/>
            </a:endParaRPr>
          </a:p>
        </p:txBody>
      </p:sp>
      <p:sp>
        <p:nvSpPr>
          <p:cNvPr id="247" name="Google Shape;247;p29"/>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18</a:t>
            </a:fld>
            <a:endParaRPr/>
          </a:p>
        </p:txBody>
      </p:sp>
      <p:sp>
        <p:nvSpPr>
          <p:cNvPr id="5" name="TextBox 4">
            <a:extLst>
              <a:ext uri="{FF2B5EF4-FFF2-40B4-BE49-F238E27FC236}">
                <a16:creationId xmlns:a16="http://schemas.microsoft.com/office/drawing/2014/main" id="{D9E448AC-4913-634A-A255-1EF6269A708B}"/>
              </a:ext>
            </a:extLst>
          </p:cNvPr>
          <p:cNvSpPr txBox="1"/>
          <p:nvPr/>
        </p:nvSpPr>
        <p:spPr>
          <a:xfrm>
            <a:off x="114716" y="4595962"/>
            <a:ext cx="4572000" cy="307777"/>
          </a:xfrm>
          <a:prstGeom prst="rect">
            <a:avLst/>
          </a:prstGeom>
          <a:noFill/>
        </p:spPr>
        <p:txBody>
          <a:bodyPr wrap="square">
            <a:spAutoFit/>
          </a:bodyPr>
          <a:lstStyle/>
          <a:p>
            <a:r>
              <a:rPr lang="en-US" i="1" dirty="0">
                <a:solidFill>
                  <a:schemeClr val="bg2"/>
                </a:solidFill>
              </a:rPr>
              <a:t>Roy et al, KUOW, 2019</a:t>
            </a:r>
          </a:p>
        </p:txBody>
      </p:sp>
      <p:sp>
        <p:nvSpPr>
          <p:cNvPr id="7" name="TextBox 6">
            <a:extLst>
              <a:ext uri="{FF2B5EF4-FFF2-40B4-BE49-F238E27FC236}">
                <a16:creationId xmlns:a16="http://schemas.microsoft.com/office/drawing/2014/main" id="{4FA5BE1A-FC01-F143-8548-1E5CFEEF68B6}"/>
              </a:ext>
            </a:extLst>
          </p:cNvPr>
          <p:cNvSpPr txBox="1"/>
          <p:nvPr/>
        </p:nvSpPr>
        <p:spPr>
          <a:xfrm>
            <a:off x="114716" y="4835723"/>
            <a:ext cx="4572000" cy="307777"/>
          </a:xfrm>
          <a:prstGeom prst="rect">
            <a:avLst/>
          </a:prstGeom>
          <a:noFill/>
        </p:spPr>
        <p:txBody>
          <a:bodyPr wrap="square">
            <a:spAutoFit/>
          </a:bodyPr>
          <a:lstStyle/>
          <a:p>
            <a:r>
              <a:rPr lang="en-US" i="1" dirty="0">
                <a:solidFill>
                  <a:schemeClr val="bg2"/>
                </a:solidFill>
              </a:rPr>
              <a:t>Changing Names, Facing History and Ourselves</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Google Shape;252;p30"/>
          <p:cNvSpPr txBox="1">
            <a:spLocks noGrp="1"/>
          </p:cNvSpPr>
          <p:nvPr>
            <p:ph type="title"/>
          </p:nvPr>
        </p:nvSpPr>
        <p:spPr>
          <a:xfrm>
            <a:off x="601803" y="386196"/>
            <a:ext cx="7772652" cy="396300"/>
          </a:xfrm>
          <a:prstGeom prst="rect">
            <a:avLst/>
          </a:prstGeom>
        </p:spPr>
        <p:txBody>
          <a:bodyPr spcFirstLastPara="1" vert="horz" wrap="square" lIns="0" tIns="0" rIns="0" bIns="0" rtlCol="0" anchor="b" anchorCtr="0">
            <a:noAutofit/>
          </a:bodyPr>
          <a:lstStyle/>
          <a:p>
            <a:r>
              <a:rPr lang="en" dirty="0"/>
              <a:t>Tangible Effects of Racism and Names</a:t>
            </a:r>
            <a:endParaRPr dirty="0"/>
          </a:p>
        </p:txBody>
      </p:sp>
      <p:sp>
        <p:nvSpPr>
          <p:cNvPr id="253" name="Google Shape;253;p30"/>
          <p:cNvSpPr txBox="1">
            <a:spLocks noGrp="1"/>
          </p:cNvSpPr>
          <p:nvPr>
            <p:ph type="body" idx="1"/>
          </p:nvPr>
        </p:nvSpPr>
        <p:spPr>
          <a:xfrm>
            <a:off x="409705" y="987857"/>
            <a:ext cx="3253800" cy="3391800"/>
          </a:xfrm>
          <a:prstGeom prst="rect">
            <a:avLst/>
          </a:prstGeom>
        </p:spPr>
        <p:txBody>
          <a:bodyPr spcFirstLastPara="1" vert="horz" wrap="square" lIns="0" tIns="0" rIns="0" bIns="0" rtlCol="0" anchor="t" anchorCtr="0">
            <a:noAutofit/>
          </a:bodyPr>
          <a:lstStyle/>
          <a:p>
            <a:pPr marL="0" indent="0">
              <a:buNone/>
            </a:pPr>
            <a:r>
              <a:rPr lang="en" sz="1700" i="1" dirty="0">
                <a:solidFill>
                  <a:srgbClr val="000000"/>
                </a:solidFill>
                <a:latin typeface="Montserrat"/>
                <a:ea typeface="Montserrat"/>
                <a:cs typeface="Montserrat"/>
                <a:sym typeface="Montserrat"/>
              </a:rPr>
              <a:t>“Are Emily and Greg More Employable than Lakisha and Jamal? A Field Experiment on Labor Market Discrimination” </a:t>
            </a:r>
          </a:p>
          <a:p>
            <a:pPr marL="0" indent="0">
              <a:buNone/>
            </a:pPr>
            <a:endParaRPr sz="1700" dirty="0">
              <a:solidFill>
                <a:srgbClr val="000000"/>
              </a:solidFill>
              <a:latin typeface="Montserrat"/>
              <a:ea typeface="Montserrat"/>
              <a:cs typeface="Montserrat"/>
              <a:sym typeface="Montserrat"/>
            </a:endParaRPr>
          </a:p>
          <a:p>
            <a:pPr marL="0" indent="0">
              <a:spcBef>
                <a:spcPts val="600"/>
              </a:spcBef>
              <a:buNone/>
            </a:pPr>
            <a:r>
              <a:rPr lang="en" sz="1700" b="1" dirty="0">
                <a:solidFill>
                  <a:srgbClr val="000000"/>
                </a:solidFill>
                <a:latin typeface="Montserrat"/>
                <a:ea typeface="Montserrat"/>
                <a:cs typeface="Montserrat"/>
                <a:sym typeface="Montserrat"/>
              </a:rPr>
              <a:t>50% gap in callback rates</a:t>
            </a:r>
            <a:r>
              <a:rPr lang="en" sz="1700" dirty="0">
                <a:solidFill>
                  <a:srgbClr val="000000"/>
                </a:solidFill>
                <a:latin typeface="Montserrat"/>
                <a:ea typeface="Montserrat"/>
                <a:cs typeface="Montserrat"/>
                <a:sym typeface="Montserrat"/>
              </a:rPr>
              <a:t> for job applications between Western sounding names and racial/ethnic minority sounding names (Bertrand and Mullainathan, 2003)</a:t>
            </a:r>
            <a:endParaRPr sz="1000" dirty="0">
              <a:solidFill>
                <a:srgbClr val="000000"/>
              </a:solidFill>
              <a:highlight>
                <a:srgbClr val="FFFFFF"/>
              </a:highlight>
              <a:latin typeface="Arial"/>
              <a:ea typeface="Arial"/>
              <a:cs typeface="Arial"/>
              <a:sym typeface="Arial"/>
            </a:endParaRPr>
          </a:p>
          <a:p>
            <a:pPr marL="0" indent="0">
              <a:spcBef>
                <a:spcPts val="600"/>
              </a:spcBef>
              <a:buNone/>
            </a:pPr>
            <a:endParaRPr sz="1300" dirty="0">
              <a:solidFill>
                <a:srgbClr val="050607"/>
              </a:solidFill>
              <a:highlight>
                <a:srgbClr val="FFFFFF"/>
              </a:highlight>
              <a:latin typeface="Georgia"/>
              <a:ea typeface="Georgia"/>
              <a:cs typeface="Georgia"/>
              <a:sym typeface="Georgia"/>
            </a:endParaRPr>
          </a:p>
          <a:p>
            <a:pPr marL="0" indent="0">
              <a:spcBef>
                <a:spcPts val="600"/>
              </a:spcBef>
              <a:spcAft>
                <a:spcPts val="600"/>
              </a:spcAft>
              <a:buNone/>
            </a:pPr>
            <a:endParaRPr sz="1300" dirty="0">
              <a:solidFill>
                <a:srgbClr val="050607"/>
              </a:solidFill>
              <a:highlight>
                <a:srgbClr val="FFFFFF"/>
              </a:highlight>
              <a:latin typeface="Georgia"/>
              <a:ea typeface="Georgia"/>
              <a:cs typeface="Georgia"/>
              <a:sym typeface="Georgia"/>
            </a:endParaRPr>
          </a:p>
        </p:txBody>
      </p:sp>
      <p:sp>
        <p:nvSpPr>
          <p:cNvPr id="254" name="Google Shape;254;p30"/>
          <p:cNvSpPr txBox="1">
            <a:spLocks noGrp="1"/>
          </p:cNvSpPr>
          <p:nvPr>
            <p:ph type="sldNum" idx="12"/>
          </p:nvPr>
        </p:nvSpPr>
        <p:spPr>
          <a:xfrm>
            <a:off x="8480584" y="4749851"/>
            <a:ext cx="548700" cy="393600"/>
          </a:xfrm>
          <a:prstGeom prst="rect">
            <a:avLst/>
          </a:prstGeom>
        </p:spPr>
        <p:txBody>
          <a:bodyPr spcFirstLastPara="1" vert="horz" wrap="square" lIns="0" tIns="0" rIns="0" bIns="0" rtlCol="0" anchor="ctr" anchorCtr="0">
            <a:noAutofit/>
          </a:bodyPr>
          <a:lstStyle/>
          <a:p>
            <a:fld id="{00000000-1234-1234-1234-123412341234}" type="slidenum">
              <a:rPr lang="en"/>
              <a:pPr/>
              <a:t>19</a:t>
            </a:fld>
            <a:endParaRPr/>
          </a:p>
        </p:txBody>
      </p:sp>
      <p:sp>
        <p:nvSpPr>
          <p:cNvPr id="256" name="Google Shape;256;p30"/>
          <p:cNvSpPr txBox="1"/>
          <p:nvPr/>
        </p:nvSpPr>
        <p:spPr>
          <a:xfrm>
            <a:off x="3983478" y="4715833"/>
            <a:ext cx="5160522" cy="461635"/>
          </a:xfrm>
          <a:prstGeom prst="rect">
            <a:avLst/>
          </a:prstGeom>
          <a:noFill/>
          <a:ln>
            <a:noFill/>
          </a:ln>
        </p:spPr>
        <p:txBody>
          <a:bodyPr spcFirstLastPara="1" wrap="square" lIns="91425" tIns="91425" rIns="91425" bIns="91425" anchor="t" anchorCtr="0">
            <a:spAutoFit/>
          </a:bodyPr>
          <a:lstStyle/>
          <a:p>
            <a:pPr lvl="0"/>
            <a:r>
              <a:rPr lang="en" sz="1800" i="1" dirty="0">
                <a:solidFill>
                  <a:schemeClr val="bg2"/>
                </a:solidFill>
                <a:latin typeface=""/>
                <a:ea typeface="Montserrat"/>
                <a:cs typeface="Montserrat"/>
                <a:sym typeface="Montserrat"/>
              </a:rPr>
              <a:t>Kang, </a:t>
            </a:r>
            <a:r>
              <a:rPr lang="en-US" sz="1800" i="1" dirty="0">
                <a:solidFill>
                  <a:schemeClr val="bg2"/>
                </a:solidFill>
                <a:latin typeface=""/>
              </a:rPr>
              <a:t>Administrative Science Quarterly, </a:t>
            </a:r>
            <a:r>
              <a:rPr lang="en" sz="1800" i="1" dirty="0">
                <a:solidFill>
                  <a:schemeClr val="bg2"/>
                </a:solidFill>
                <a:latin typeface=""/>
                <a:ea typeface="Montserrat"/>
                <a:cs typeface="Montserrat"/>
                <a:sym typeface="Montserrat"/>
              </a:rPr>
              <a:t>2016</a:t>
            </a:r>
            <a:endParaRPr sz="1800" i="1" dirty="0">
              <a:solidFill>
                <a:schemeClr val="bg2"/>
              </a:solidFill>
              <a:latin typeface=""/>
              <a:ea typeface="Montserrat"/>
              <a:cs typeface="Montserrat"/>
              <a:sym typeface="Montserrat"/>
            </a:endParaRPr>
          </a:p>
        </p:txBody>
      </p:sp>
      <p:sp>
        <p:nvSpPr>
          <p:cNvPr id="7" name="Google Shape;256;p30">
            <a:extLst>
              <a:ext uri="{FF2B5EF4-FFF2-40B4-BE49-F238E27FC236}">
                <a16:creationId xmlns:a16="http://schemas.microsoft.com/office/drawing/2014/main" id="{8311A265-1766-EA49-9AF9-421BBFE992FF}"/>
              </a:ext>
            </a:extLst>
          </p:cNvPr>
          <p:cNvSpPr txBox="1"/>
          <p:nvPr/>
        </p:nvSpPr>
        <p:spPr>
          <a:xfrm>
            <a:off x="169780" y="4748614"/>
            <a:ext cx="4076495" cy="461635"/>
          </a:xfrm>
          <a:prstGeom prst="rect">
            <a:avLst/>
          </a:prstGeom>
          <a:noFill/>
          <a:ln>
            <a:noFill/>
          </a:ln>
        </p:spPr>
        <p:txBody>
          <a:bodyPr spcFirstLastPara="1" wrap="square" lIns="91425" tIns="91425" rIns="91425" bIns="91425" anchor="t" anchorCtr="0">
            <a:spAutoFit/>
          </a:bodyPr>
          <a:lstStyle/>
          <a:p>
            <a:pPr lvl="0"/>
            <a:r>
              <a:rPr lang="en-US" sz="1800" i="1" dirty="0">
                <a:solidFill>
                  <a:schemeClr val="bg2"/>
                </a:solidFill>
                <a:latin typeface=""/>
                <a:ea typeface="Montserrat"/>
                <a:cs typeface="Montserrat"/>
                <a:sym typeface="Montserrat"/>
              </a:rPr>
              <a:t>Bertrand et al, </a:t>
            </a:r>
            <a:r>
              <a:rPr lang="en-US" sz="1800" i="1" dirty="0">
                <a:solidFill>
                  <a:schemeClr val="bg2"/>
                </a:solidFill>
                <a:latin typeface=""/>
              </a:rPr>
              <a:t>SSRN Journal, </a:t>
            </a:r>
            <a:r>
              <a:rPr lang="en" sz="1800" i="1" dirty="0">
                <a:solidFill>
                  <a:schemeClr val="bg2"/>
                </a:solidFill>
                <a:latin typeface=""/>
                <a:ea typeface="Montserrat"/>
                <a:cs typeface="Montserrat"/>
                <a:sym typeface="Montserrat"/>
              </a:rPr>
              <a:t>2016</a:t>
            </a:r>
            <a:endParaRPr sz="1800" i="1" dirty="0">
              <a:solidFill>
                <a:schemeClr val="bg2"/>
              </a:solidFill>
              <a:latin typeface=""/>
              <a:ea typeface="Montserrat"/>
              <a:cs typeface="Montserrat"/>
              <a:sym typeface="Montserrat"/>
            </a:endParaRPr>
          </a:p>
        </p:txBody>
      </p:sp>
      <p:sp>
        <p:nvSpPr>
          <p:cNvPr id="2" name="Rectangle 1"/>
          <p:cNvSpPr/>
          <p:nvPr/>
        </p:nvSpPr>
        <p:spPr>
          <a:xfrm>
            <a:off x="4383449" y="987857"/>
            <a:ext cx="4146585" cy="3308598"/>
          </a:xfrm>
          <a:prstGeom prst="rect">
            <a:avLst/>
          </a:prstGeom>
        </p:spPr>
        <p:txBody>
          <a:bodyPr wrap="square">
            <a:spAutoFit/>
          </a:bodyPr>
          <a:lstStyle/>
          <a:p>
            <a:pPr lvl="0"/>
            <a:r>
              <a:rPr lang="en-US" sz="1700" i="1" dirty="0">
                <a:latin typeface="Montserrat" panose="020B0604020202020204" charset="0"/>
                <a:ea typeface="Montserrat"/>
                <a:cs typeface="Montserrat"/>
                <a:sym typeface="Montserrat"/>
              </a:rPr>
              <a:t>“Whitened Resumes: Race and Self-Presentation in the Labor Market” </a:t>
            </a:r>
          </a:p>
          <a:p>
            <a:pPr lvl="0"/>
            <a:endParaRPr lang="en-US" sz="1700" dirty="0">
              <a:latin typeface="Montserrat" panose="020B0604020202020204" charset="0"/>
              <a:ea typeface="Montserrat"/>
              <a:cs typeface="Montserrat"/>
              <a:sym typeface="Montserrat"/>
            </a:endParaRPr>
          </a:p>
          <a:p>
            <a:pPr>
              <a:spcBef>
                <a:spcPts val="600"/>
              </a:spcBef>
            </a:pPr>
            <a:r>
              <a:rPr lang="en-US" sz="1700" dirty="0">
                <a:latin typeface="Montserrat" panose="020B0604020202020204" charset="0"/>
              </a:rPr>
              <a:t>25% of black candidates received callbacks from their whitened resumes, while only 10% got calls when they left ethnic details intact. Among Asians, 21% got calls if they used whitened resumes, whereas only 11.5% heard back if they sent resumes with racial references </a:t>
            </a:r>
            <a:r>
              <a:rPr lang="en-US" sz="1700" dirty="0">
                <a:latin typeface="Montserrat" panose="020B0604020202020204" charset="0"/>
                <a:ea typeface="Montserrat"/>
                <a:cs typeface="Montserrat"/>
                <a:sym typeface="Montserrat"/>
              </a:rPr>
              <a:t>(Kang 2016)</a:t>
            </a:r>
            <a:endParaRPr lang="en-US" sz="1700" dirty="0">
              <a:highlight>
                <a:srgbClr val="FFFFFF"/>
              </a:highlight>
              <a:latin typeface="Montserrat" panose="020B0604020202020204" charset="0"/>
            </a:endParaRPr>
          </a:p>
        </p:txBody>
      </p:sp>
    </p:spTree>
    <p:extLst>
      <p:ext uri="{BB962C8B-B14F-4D97-AF65-F5344CB8AC3E}">
        <p14:creationId xmlns:p14="http://schemas.microsoft.com/office/powerpoint/2010/main" val="33536359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sp>
        <p:nvSpPr>
          <p:cNvPr id="98" name="Google Shape;98;p13"/>
          <p:cNvSpPr txBox="1">
            <a:spLocks noGrp="1"/>
          </p:cNvSpPr>
          <p:nvPr>
            <p:ph type="title"/>
          </p:nvPr>
        </p:nvSpPr>
        <p:spPr>
          <a:xfrm>
            <a:off x="136150" y="45225"/>
            <a:ext cx="3964500" cy="3936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Scholars </a:t>
            </a:r>
            <a:endParaRPr/>
          </a:p>
        </p:txBody>
      </p:sp>
      <p:sp>
        <p:nvSpPr>
          <p:cNvPr id="99" name="Google Shape;99;p13"/>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2</a:t>
            </a:fld>
            <a:endParaRPr/>
          </a:p>
        </p:txBody>
      </p:sp>
      <p:sp>
        <p:nvSpPr>
          <p:cNvPr id="100" name="Google Shape;100;p13"/>
          <p:cNvSpPr txBox="1"/>
          <p:nvPr/>
        </p:nvSpPr>
        <p:spPr>
          <a:xfrm>
            <a:off x="1552575" y="3388350"/>
            <a:ext cx="14892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400"/>
              </a:spcAft>
              <a:buNone/>
            </a:pPr>
            <a:r>
              <a:rPr lang="en" sz="1200" b="1">
                <a:solidFill>
                  <a:schemeClr val="dk1"/>
                </a:solidFill>
                <a:latin typeface="Montserrat"/>
                <a:ea typeface="Montserrat"/>
                <a:cs typeface="Montserrat"/>
                <a:sym typeface="Montserrat"/>
              </a:rPr>
              <a:t>Megha Shankar</a:t>
            </a:r>
            <a:endParaRPr>
              <a:latin typeface="Montserrat"/>
              <a:ea typeface="Montserrat"/>
              <a:cs typeface="Montserrat"/>
              <a:sym typeface="Montserrat"/>
            </a:endParaRPr>
          </a:p>
        </p:txBody>
      </p:sp>
      <p:pic>
        <p:nvPicPr>
          <p:cNvPr id="101" name="Google Shape;101;p13"/>
          <p:cNvPicPr preferRelativeResize="0"/>
          <p:nvPr/>
        </p:nvPicPr>
        <p:blipFill rotWithShape="1">
          <a:blip r:embed="rId3">
            <a:alphaModFix/>
          </a:blip>
          <a:srcRect t="5600" b="33723"/>
          <a:stretch/>
        </p:blipFill>
        <p:spPr>
          <a:xfrm>
            <a:off x="1548225" y="2075275"/>
            <a:ext cx="1345500" cy="1230900"/>
          </a:xfrm>
          <a:prstGeom prst="ellipse">
            <a:avLst/>
          </a:prstGeom>
          <a:noFill/>
          <a:ln>
            <a:noFill/>
          </a:ln>
        </p:spPr>
      </p:pic>
      <p:pic>
        <p:nvPicPr>
          <p:cNvPr id="102" name="Google Shape;102;p13"/>
          <p:cNvPicPr preferRelativeResize="0"/>
          <p:nvPr/>
        </p:nvPicPr>
        <p:blipFill rotWithShape="1">
          <a:blip r:embed="rId4">
            <a:alphaModFix/>
          </a:blip>
          <a:srcRect t="13614" r="-1999" b="19253"/>
          <a:stretch/>
        </p:blipFill>
        <p:spPr>
          <a:xfrm>
            <a:off x="52225" y="368600"/>
            <a:ext cx="1344300" cy="1230900"/>
          </a:xfrm>
          <a:prstGeom prst="ellipse">
            <a:avLst/>
          </a:prstGeom>
          <a:noFill/>
          <a:ln>
            <a:noFill/>
          </a:ln>
        </p:spPr>
      </p:pic>
      <p:sp>
        <p:nvSpPr>
          <p:cNvPr id="103" name="Google Shape;103;p13"/>
          <p:cNvSpPr txBox="1"/>
          <p:nvPr/>
        </p:nvSpPr>
        <p:spPr>
          <a:xfrm>
            <a:off x="97975" y="1605475"/>
            <a:ext cx="11976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200" b="1">
                <a:solidFill>
                  <a:schemeClr val="dk1"/>
                </a:solidFill>
                <a:latin typeface="Montserrat"/>
                <a:ea typeface="Montserrat"/>
                <a:cs typeface="Montserrat"/>
                <a:sym typeface="Montserrat"/>
              </a:rPr>
              <a:t>Anaid (Aniya) </a:t>
            </a:r>
            <a:endParaRPr sz="1200" b="1">
              <a:solidFill>
                <a:schemeClr val="dk1"/>
              </a:solidFill>
              <a:latin typeface="Montserrat"/>
              <a:ea typeface="Montserrat"/>
              <a:cs typeface="Montserrat"/>
              <a:sym typeface="Montserrat"/>
            </a:endParaRPr>
          </a:p>
          <a:p>
            <a:pPr marL="0" lvl="0" indent="0" algn="ctr" rtl="0">
              <a:spcBef>
                <a:spcPts val="400"/>
              </a:spcBef>
              <a:spcAft>
                <a:spcPts val="400"/>
              </a:spcAft>
              <a:buNone/>
            </a:pPr>
            <a:r>
              <a:rPr lang="en" sz="1200" b="1">
                <a:solidFill>
                  <a:schemeClr val="dk1"/>
                </a:solidFill>
                <a:latin typeface="Montserrat"/>
                <a:ea typeface="Montserrat"/>
                <a:cs typeface="Montserrat"/>
                <a:sym typeface="Montserrat"/>
              </a:rPr>
              <a:t>Atasuntseva </a:t>
            </a:r>
            <a:endParaRPr sz="1200">
              <a:latin typeface="Montserrat"/>
              <a:ea typeface="Montserrat"/>
              <a:cs typeface="Montserrat"/>
              <a:sym typeface="Montserrat"/>
            </a:endParaRPr>
          </a:p>
        </p:txBody>
      </p:sp>
      <p:sp>
        <p:nvSpPr>
          <p:cNvPr id="104" name="Google Shape;104;p13"/>
          <p:cNvSpPr txBox="1"/>
          <p:nvPr/>
        </p:nvSpPr>
        <p:spPr>
          <a:xfrm>
            <a:off x="1572200" y="1757875"/>
            <a:ext cx="11976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400"/>
              </a:spcAft>
              <a:buNone/>
            </a:pPr>
            <a:r>
              <a:rPr lang="en" sz="1200" b="1">
                <a:solidFill>
                  <a:schemeClr val="dk1"/>
                </a:solidFill>
                <a:latin typeface="Montserrat"/>
                <a:ea typeface="Montserrat"/>
                <a:cs typeface="Montserrat"/>
                <a:sym typeface="Montserrat"/>
              </a:rPr>
              <a:t>Eve Ayeroff</a:t>
            </a:r>
            <a:endParaRPr sz="1200">
              <a:latin typeface="Montserrat"/>
              <a:ea typeface="Montserrat"/>
              <a:cs typeface="Montserrat"/>
              <a:sym typeface="Montserrat"/>
            </a:endParaRPr>
          </a:p>
        </p:txBody>
      </p:sp>
      <p:sp>
        <p:nvSpPr>
          <p:cNvPr id="105" name="Google Shape;105;p13"/>
          <p:cNvSpPr txBox="1"/>
          <p:nvPr/>
        </p:nvSpPr>
        <p:spPr>
          <a:xfrm>
            <a:off x="2922175" y="1757875"/>
            <a:ext cx="14892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400"/>
              </a:spcAft>
              <a:buNone/>
            </a:pPr>
            <a:r>
              <a:rPr lang="en" sz="1200" b="1">
                <a:solidFill>
                  <a:schemeClr val="dk1"/>
                </a:solidFill>
                <a:latin typeface="Montserrat"/>
                <a:ea typeface="Montserrat"/>
                <a:cs typeface="Montserrat"/>
                <a:sym typeface="Montserrat"/>
              </a:rPr>
              <a:t>Salma Dali</a:t>
            </a:r>
            <a:endParaRPr>
              <a:latin typeface="Montserrat"/>
              <a:ea typeface="Montserrat"/>
              <a:cs typeface="Montserrat"/>
              <a:sym typeface="Montserrat"/>
            </a:endParaRPr>
          </a:p>
        </p:txBody>
      </p:sp>
      <p:sp>
        <p:nvSpPr>
          <p:cNvPr id="106" name="Google Shape;106;p13"/>
          <p:cNvSpPr txBox="1"/>
          <p:nvPr/>
        </p:nvSpPr>
        <p:spPr>
          <a:xfrm>
            <a:off x="3041850" y="3394325"/>
            <a:ext cx="14892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400"/>
              </a:spcAft>
              <a:buNone/>
            </a:pPr>
            <a:r>
              <a:rPr lang="en" sz="1200" b="1">
                <a:solidFill>
                  <a:schemeClr val="dk1"/>
                </a:solidFill>
                <a:latin typeface="Montserrat"/>
                <a:ea typeface="Montserrat"/>
                <a:cs typeface="Montserrat"/>
                <a:sym typeface="Montserrat"/>
              </a:rPr>
              <a:t>Malorie Holmes </a:t>
            </a:r>
            <a:endParaRPr>
              <a:latin typeface="Montserrat"/>
              <a:ea typeface="Montserrat"/>
              <a:cs typeface="Montserrat"/>
              <a:sym typeface="Montserrat"/>
            </a:endParaRPr>
          </a:p>
        </p:txBody>
      </p:sp>
      <p:pic>
        <p:nvPicPr>
          <p:cNvPr id="107" name="Google Shape;107;p13"/>
          <p:cNvPicPr preferRelativeResize="0"/>
          <p:nvPr/>
        </p:nvPicPr>
        <p:blipFill rotWithShape="1">
          <a:blip r:embed="rId5">
            <a:alphaModFix/>
          </a:blip>
          <a:srcRect t="8734" b="17800"/>
          <a:stretch/>
        </p:blipFill>
        <p:spPr>
          <a:xfrm>
            <a:off x="3028950" y="2041350"/>
            <a:ext cx="1344300" cy="1234500"/>
          </a:xfrm>
          <a:prstGeom prst="ellipse">
            <a:avLst/>
          </a:prstGeom>
          <a:noFill/>
          <a:ln>
            <a:noFill/>
          </a:ln>
        </p:spPr>
      </p:pic>
      <p:pic>
        <p:nvPicPr>
          <p:cNvPr id="108" name="Google Shape;108;p13"/>
          <p:cNvPicPr preferRelativeResize="0"/>
          <p:nvPr/>
        </p:nvPicPr>
        <p:blipFill rotWithShape="1">
          <a:blip r:embed="rId6">
            <a:alphaModFix/>
          </a:blip>
          <a:srcRect t="1439" r="2143" b="22002"/>
          <a:stretch/>
        </p:blipFill>
        <p:spPr>
          <a:xfrm>
            <a:off x="29475" y="2075275"/>
            <a:ext cx="1344300" cy="1234500"/>
          </a:xfrm>
          <a:prstGeom prst="ellipse">
            <a:avLst/>
          </a:prstGeom>
          <a:noFill/>
          <a:ln>
            <a:noFill/>
          </a:ln>
        </p:spPr>
      </p:pic>
      <p:sp>
        <p:nvSpPr>
          <p:cNvPr id="109" name="Google Shape;109;p13"/>
          <p:cNvSpPr txBox="1"/>
          <p:nvPr/>
        </p:nvSpPr>
        <p:spPr>
          <a:xfrm>
            <a:off x="0" y="3352050"/>
            <a:ext cx="14892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200" b="1">
                <a:solidFill>
                  <a:schemeClr val="dk1"/>
                </a:solidFill>
                <a:latin typeface="Montserrat"/>
                <a:ea typeface="Montserrat"/>
                <a:cs typeface="Montserrat"/>
                <a:sym typeface="Montserrat"/>
              </a:rPr>
              <a:t>Christina Johnson</a:t>
            </a:r>
            <a:endParaRPr sz="1200" b="1">
              <a:solidFill>
                <a:schemeClr val="dk1"/>
              </a:solidFill>
              <a:latin typeface="Montserrat"/>
              <a:ea typeface="Montserrat"/>
              <a:cs typeface="Montserrat"/>
              <a:sym typeface="Montserrat"/>
            </a:endParaRPr>
          </a:p>
          <a:p>
            <a:pPr marL="0" lvl="0" indent="0" algn="ctr" rtl="0">
              <a:spcBef>
                <a:spcPts val="400"/>
              </a:spcBef>
              <a:spcAft>
                <a:spcPts val="400"/>
              </a:spcAft>
              <a:buNone/>
            </a:pPr>
            <a:endParaRPr sz="1200" b="1">
              <a:solidFill>
                <a:schemeClr val="dk1"/>
              </a:solidFill>
              <a:latin typeface="Montserrat"/>
              <a:ea typeface="Montserrat"/>
              <a:cs typeface="Montserrat"/>
              <a:sym typeface="Montserrat"/>
            </a:endParaRPr>
          </a:p>
        </p:txBody>
      </p:sp>
      <p:pic>
        <p:nvPicPr>
          <p:cNvPr id="110" name="Google Shape;110;p13"/>
          <p:cNvPicPr preferRelativeResize="0"/>
          <p:nvPr/>
        </p:nvPicPr>
        <p:blipFill rotWithShape="1">
          <a:blip r:embed="rId7">
            <a:alphaModFix/>
          </a:blip>
          <a:srcRect t="4086" b="4077"/>
          <a:stretch/>
        </p:blipFill>
        <p:spPr>
          <a:xfrm>
            <a:off x="2922200" y="404900"/>
            <a:ext cx="1344300" cy="1234500"/>
          </a:xfrm>
          <a:prstGeom prst="ellipse">
            <a:avLst/>
          </a:prstGeom>
          <a:noFill/>
          <a:ln>
            <a:noFill/>
          </a:ln>
        </p:spPr>
      </p:pic>
      <p:sp>
        <p:nvSpPr>
          <p:cNvPr id="111" name="Google Shape;111;p13"/>
          <p:cNvSpPr txBox="1"/>
          <p:nvPr/>
        </p:nvSpPr>
        <p:spPr>
          <a:xfrm>
            <a:off x="1161050" y="4902250"/>
            <a:ext cx="23916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400"/>
              </a:spcAft>
              <a:buNone/>
            </a:pPr>
            <a:r>
              <a:rPr lang="en" sz="1200" b="1">
                <a:solidFill>
                  <a:schemeClr val="dk1"/>
                </a:solidFill>
                <a:latin typeface="Montserrat"/>
                <a:ea typeface="Montserrat"/>
                <a:cs typeface="Montserrat"/>
                <a:sym typeface="Montserrat"/>
              </a:rPr>
              <a:t>Abdullah Sulieman Terkawi</a:t>
            </a:r>
            <a:endParaRPr>
              <a:latin typeface="Montserrat"/>
              <a:ea typeface="Montserrat"/>
              <a:cs typeface="Montserrat"/>
              <a:sym typeface="Montserrat"/>
            </a:endParaRPr>
          </a:p>
        </p:txBody>
      </p:sp>
      <p:sp>
        <p:nvSpPr>
          <p:cNvPr id="112" name="Google Shape;112;p13"/>
          <p:cNvSpPr txBox="1">
            <a:spLocks noGrp="1"/>
          </p:cNvSpPr>
          <p:nvPr>
            <p:ph type="title"/>
          </p:nvPr>
        </p:nvSpPr>
        <p:spPr>
          <a:xfrm>
            <a:off x="5154825" y="45225"/>
            <a:ext cx="3964500" cy="393600"/>
          </a:xfrm>
          <a:prstGeom prst="rect">
            <a:avLst/>
          </a:prstGeom>
        </p:spPr>
        <p:txBody>
          <a:bodyPr spcFirstLastPara="1" wrap="square" lIns="0" tIns="0" rIns="0" bIns="0" anchor="b" anchorCtr="0">
            <a:noAutofit/>
          </a:bodyPr>
          <a:lstStyle/>
          <a:p>
            <a:pPr marL="0" lvl="0" indent="0" algn="ctr" rtl="0">
              <a:spcBef>
                <a:spcPts val="0"/>
              </a:spcBef>
              <a:spcAft>
                <a:spcPts val="0"/>
              </a:spcAft>
              <a:buNone/>
            </a:pPr>
            <a:r>
              <a:rPr lang="en"/>
              <a:t>Mentors</a:t>
            </a:r>
            <a:endParaRPr/>
          </a:p>
        </p:txBody>
      </p:sp>
      <p:pic>
        <p:nvPicPr>
          <p:cNvPr id="113" name="Google Shape;113;p13"/>
          <p:cNvPicPr preferRelativeResize="0"/>
          <p:nvPr/>
        </p:nvPicPr>
        <p:blipFill rotWithShape="1">
          <a:blip r:embed="rId8">
            <a:alphaModFix/>
          </a:blip>
          <a:srcRect t="2290" b="-2289"/>
          <a:stretch/>
        </p:blipFill>
        <p:spPr>
          <a:xfrm>
            <a:off x="5293050" y="591225"/>
            <a:ext cx="1344300" cy="1234500"/>
          </a:xfrm>
          <a:prstGeom prst="ellipse">
            <a:avLst/>
          </a:prstGeom>
          <a:noFill/>
          <a:ln>
            <a:noFill/>
          </a:ln>
        </p:spPr>
      </p:pic>
      <p:sp>
        <p:nvSpPr>
          <p:cNvPr id="114" name="Google Shape;114;p13"/>
          <p:cNvSpPr txBox="1"/>
          <p:nvPr/>
        </p:nvSpPr>
        <p:spPr>
          <a:xfrm>
            <a:off x="5293050" y="1986475"/>
            <a:ext cx="14892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200" b="1">
                <a:solidFill>
                  <a:schemeClr val="dk1"/>
                </a:solidFill>
                <a:latin typeface="Montserrat"/>
                <a:ea typeface="Montserrat"/>
                <a:cs typeface="Montserrat"/>
                <a:sym typeface="Montserrat"/>
              </a:rPr>
              <a:t>Beth Beadle</a:t>
            </a:r>
            <a:endParaRPr sz="1200" b="1">
              <a:solidFill>
                <a:schemeClr val="dk1"/>
              </a:solidFill>
              <a:latin typeface="Montserrat"/>
              <a:ea typeface="Montserrat"/>
              <a:cs typeface="Montserrat"/>
              <a:sym typeface="Montserrat"/>
            </a:endParaRPr>
          </a:p>
          <a:p>
            <a:pPr marL="0" lvl="0" indent="0" algn="ctr" rtl="0">
              <a:spcBef>
                <a:spcPts val="400"/>
              </a:spcBef>
              <a:spcAft>
                <a:spcPts val="400"/>
              </a:spcAft>
              <a:buNone/>
            </a:pPr>
            <a:endParaRPr sz="1200" b="1">
              <a:solidFill>
                <a:schemeClr val="dk1"/>
              </a:solidFill>
              <a:latin typeface="Montserrat"/>
              <a:ea typeface="Montserrat"/>
              <a:cs typeface="Montserrat"/>
              <a:sym typeface="Montserrat"/>
            </a:endParaRPr>
          </a:p>
        </p:txBody>
      </p:sp>
      <p:sp>
        <p:nvSpPr>
          <p:cNvPr id="115" name="Google Shape;115;p13"/>
          <p:cNvSpPr txBox="1"/>
          <p:nvPr/>
        </p:nvSpPr>
        <p:spPr>
          <a:xfrm>
            <a:off x="7018350" y="1999075"/>
            <a:ext cx="20247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200" b="1">
                <a:solidFill>
                  <a:schemeClr val="dk1"/>
                </a:solidFill>
                <a:latin typeface="Montserrat"/>
                <a:ea typeface="Montserrat"/>
                <a:cs typeface="Montserrat"/>
                <a:sym typeface="Montserrat"/>
              </a:rPr>
              <a:t>Kathleen (Kiki) Boyd</a:t>
            </a:r>
            <a:endParaRPr sz="1200" b="1">
              <a:solidFill>
                <a:schemeClr val="dk1"/>
              </a:solidFill>
              <a:latin typeface="Montserrat"/>
              <a:ea typeface="Montserrat"/>
              <a:cs typeface="Montserrat"/>
              <a:sym typeface="Montserrat"/>
            </a:endParaRPr>
          </a:p>
          <a:p>
            <a:pPr marL="0" lvl="0" indent="0" algn="ctr" rtl="0">
              <a:spcBef>
                <a:spcPts val="400"/>
              </a:spcBef>
              <a:spcAft>
                <a:spcPts val="0"/>
              </a:spcAft>
              <a:buNone/>
            </a:pPr>
            <a:endParaRPr sz="1200" b="1">
              <a:solidFill>
                <a:schemeClr val="dk1"/>
              </a:solidFill>
              <a:latin typeface="Montserrat"/>
              <a:ea typeface="Montserrat"/>
              <a:cs typeface="Montserrat"/>
              <a:sym typeface="Montserrat"/>
            </a:endParaRPr>
          </a:p>
          <a:p>
            <a:pPr marL="0" lvl="0" indent="0" algn="ctr" rtl="0">
              <a:spcBef>
                <a:spcPts val="400"/>
              </a:spcBef>
              <a:spcAft>
                <a:spcPts val="400"/>
              </a:spcAft>
              <a:buNone/>
            </a:pPr>
            <a:endParaRPr sz="1200" b="1">
              <a:solidFill>
                <a:schemeClr val="dk1"/>
              </a:solidFill>
              <a:latin typeface="Montserrat"/>
              <a:ea typeface="Montserrat"/>
              <a:cs typeface="Montserrat"/>
              <a:sym typeface="Montserrat"/>
            </a:endParaRPr>
          </a:p>
        </p:txBody>
      </p:sp>
      <p:pic>
        <p:nvPicPr>
          <p:cNvPr id="116" name="Google Shape;116;p13"/>
          <p:cNvPicPr preferRelativeResize="0"/>
          <p:nvPr/>
        </p:nvPicPr>
        <p:blipFill rotWithShape="1">
          <a:blip r:embed="rId9">
            <a:alphaModFix/>
          </a:blip>
          <a:srcRect t="11260" r="7621"/>
          <a:stretch/>
        </p:blipFill>
        <p:spPr>
          <a:xfrm>
            <a:off x="5293050" y="2395175"/>
            <a:ext cx="1344300" cy="1234500"/>
          </a:xfrm>
          <a:prstGeom prst="ellipse">
            <a:avLst/>
          </a:prstGeom>
          <a:noFill/>
          <a:ln>
            <a:noFill/>
          </a:ln>
        </p:spPr>
      </p:pic>
      <p:sp>
        <p:nvSpPr>
          <p:cNvPr id="117" name="Google Shape;117;p13"/>
          <p:cNvSpPr txBox="1"/>
          <p:nvPr/>
        </p:nvSpPr>
        <p:spPr>
          <a:xfrm>
            <a:off x="4952850" y="3644775"/>
            <a:ext cx="20247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200" b="1">
                <a:solidFill>
                  <a:schemeClr val="dk1"/>
                </a:solidFill>
                <a:latin typeface="Montserrat"/>
                <a:ea typeface="Montserrat"/>
                <a:cs typeface="Montserrat"/>
                <a:sym typeface="Montserrat"/>
              </a:rPr>
              <a:t>Joon Chang</a:t>
            </a:r>
            <a:endParaRPr sz="1200" b="1">
              <a:solidFill>
                <a:schemeClr val="dk1"/>
              </a:solidFill>
              <a:latin typeface="Montserrat"/>
              <a:ea typeface="Montserrat"/>
              <a:cs typeface="Montserrat"/>
              <a:sym typeface="Montserrat"/>
            </a:endParaRPr>
          </a:p>
          <a:p>
            <a:pPr marL="0" lvl="0" indent="0" algn="ctr" rtl="0">
              <a:spcBef>
                <a:spcPts val="400"/>
              </a:spcBef>
              <a:spcAft>
                <a:spcPts val="0"/>
              </a:spcAft>
              <a:buNone/>
            </a:pPr>
            <a:endParaRPr sz="1200" b="1">
              <a:solidFill>
                <a:schemeClr val="dk1"/>
              </a:solidFill>
              <a:latin typeface="Montserrat"/>
              <a:ea typeface="Montserrat"/>
              <a:cs typeface="Montserrat"/>
              <a:sym typeface="Montserrat"/>
            </a:endParaRPr>
          </a:p>
          <a:p>
            <a:pPr marL="0" lvl="0" indent="0" algn="ctr" rtl="0">
              <a:spcBef>
                <a:spcPts val="400"/>
              </a:spcBef>
              <a:spcAft>
                <a:spcPts val="400"/>
              </a:spcAft>
              <a:buNone/>
            </a:pPr>
            <a:endParaRPr sz="1200" b="1">
              <a:solidFill>
                <a:schemeClr val="dk1"/>
              </a:solidFill>
              <a:latin typeface="Montserrat"/>
              <a:ea typeface="Montserrat"/>
              <a:cs typeface="Montserrat"/>
              <a:sym typeface="Montserrat"/>
            </a:endParaRPr>
          </a:p>
        </p:txBody>
      </p:sp>
      <p:pic>
        <p:nvPicPr>
          <p:cNvPr id="118" name="Google Shape;118;p13"/>
          <p:cNvPicPr preferRelativeResize="0"/>
          <p:nvPr/>
        </p:nvPicPr>
        <p:blipFill rotWithShape="1">
          <a:blip r:embed="rId10">
            <a:alphaModFix/>
          </a:blip>
          <a:srcRect l="11546" t="21956" r="2925" b="-4098"/>
          <a:stretch/>
        </p:blipFill>
        <p:spPr>
          <a:xfrm>
            <a:off x="7246950" y="2344175"/>
            <a:ext cx="1344300" cy="1234500"/>
          </a:xfrm>
          <a:prstGeom prst="ellipse">
            <a:avLst/>
          </a:prstGeom>
          <a:noFill/>
          <a:ln>
            <a:noFill/>
          </a:ln>
        </p:spPr>
      </p:pic>
      <p:sp>
        <p:nvSpPr>
          <p:cNvPr id="119" name="Google Shape;119;p13"/>
          <p:cNvSpPr txBox="1"/>
          <p:nvPr/>
        </p:nvSpPr>
        <p:spPr>
          <a:xfrm>
            <a:off x="6942150" y="3644775"/>
            <a:ext cx="2024700" cy="393600"/>
          </a:xfrm>
          <a:prstGeom prst="rect">
            <a:avLst/>
          </a:prstGeom>
          <a:noFill/>
          <a:ln>
            <a:noFill/>
          </a:ln>
        </p:spPr>
        <p:txBody>
          <a:bodyPr spcFirstLastPara="1" wrap="square" lIns="0" tIns="0" rIns="0" bIns="0" anchor="t" anchorCtr="0">
            <a:noAutofit/>
          </a:bodyPr>
          <a:lstStyle/>
          <a:p>
            <a:pPr marL="0" lvl="0" indent="0" algn="ctr" rtl="0">
              <a:spcBef>
                <a:spcPts val="0"/>
              </a:spcBef>
              <a:spcAft>
                <a:spcPts val="0"/>
              </a:spcAft>
              <a:buNone/>
            </a:pPr>
            <a:r>
              <a:rPr lang="en" sz="1200" b="1">
                <a:solidFill>
                  <a:schemeClr val="dk1"/>
                </a:solidFill>
                <a:latin typeface="Montserrat"/>
                <a:ea typeface="Montserrat"/>
                <a:cs typeface="Montserrat"/>
                <a:sym typeface="Montserrat"/>
              </a:rPr>
              <a:t>Tamara Dunn</a:t>
            </a:r>
            <a:endParaRPr sz="1200" b="1">
              <a:solidFill>
                <a:schemeClr val="dk1"/>
              </a:solidFill>
              <a:latin typeface="Montserrat"/>
              <a:ea typeface="Montserrat"/>
              <a:cs typeface="Montserrat"/>
              <a:sym typeface="Montserrat"/>
            </a:endParaRPr>
          </a:p>
          <a:p>
            <a:pPr marL="0" lvl="0" indent="0" algn="ctr" rtl="0">
              <a:spcBef>
                <a:spcPts val="400"/>
              </a:spcBef>
              <a:spcAft>
                <a:spcPts val="0"/>
              </a:spcAft>
              <a:buNone/>
            </a:pPr>
            <a:endParaRPr sz="1200" b="1">
              <a:solidFill>
                <a:schemeClr val="dk1"/>
              </a:solidFill>
              <a:latin typeface="Montserrat"/>
              <a:ea typeface="Montserrat"/>
              <a:cs typeface="Montserrat"/>
              <a:sym typeface="Montserrat"/>
            </a:endParaRPr>
          </a:p>
          <a:p>
            <a:pPr marL="0" lvl="0" indent="0" algn="ctr" rtl="0">
              <a:spcBef>
                <a:spcPts val="400"/>
              </a:spcBef>
              <a:spcAft>
                <a:spcPts val="400"/>
              </a:spcAft>
              <a:buNone/>
            </a:pPr>
            <a:endParaRPr sz="1200" b="1">
              <a:solidFill>
                <a:schemeClr val="dk1"/>
              </a:solidFill>
              <a:latin typeface="Montserrat"/>
              <a:ea typeface="Montserrat"/>
              <a:cs typeface="Montserrat"/>
              <a:sym typeface="Montserrat"/>
            </a:endParaRPr>
          </a:p>
        </p:txBody>
      </p:sp>
      <p:pic>
        <p:nvPicPr>
          <p:cNvPr id="120" name="Google Shape;120;p13"/>
          <p:cNvPicPr preferRelativeResize="0"/>
          <p:nvPr/>
        </p:nvPicPr>
        <p:blipFill rotWithShape="1">
          <a:blip r:embed="rId11">
            <a:alphaModFix/>
          </a:blip>
          <a:srcRect t="9468" b="16501"/>
          <a:stretch/>
        </p:blipFill>
        <p:spPr>
          <a:xfrm>
            <a:off x="1472625" y="404900"/>
            <a:ext cx="1344300" cy="1234500"/>
          </a:xfrm>
          <a:prstGeom prst="ellipse">
            <a:avLst/>
          </a:prstGeom>
          <a:noFill/>
          <a:ln>
            <a:noFill/>
          </a:ln>
        </p:spPr>
      </p:pic>
      <p:pic>
        <p:nvPicPr>
          <p:cNvPr id="121" name="Google Shape;121;p13"/>
          <p:cNvPicPr preferRelativeResize="0"/>
          <p:nvPr/>
        </p:nvPicPr>
        <p:blipFill rotWithShape="1">
          <a:blip r:embed="rId12">
            <a:alphaModFix/>
          </a:blip>
          <a:srcRect l="18539" t="8122" r="13723"/>
          <a:stretch/>
        </p:blipFill>
        <p:spPr>
          <a:xfrm>
            <a:off x="1745775" y="3667750"/>
            <a:ext cx="1197600" cy="1234500"/>
          </a:xfrm>
          <a:prstGeom prst="ellipse">
            <a:avLst/>
          </a:prstGeom>
          <a:noFill/>
          <a:ln>
            <a:noFill/>
          </a:ln>
        </p:spPr>
      </p:pic>
      <p:pic>
        <p:nvPicPr>
          <p:cNvPr id="122" name="Google Shape;122;p13"/>
          <p:cNvPicPr preferRelativeResize="0"/>
          <p:nvPr/>
        </p:nvPicPr>
        <p:blipFill rotWithShape="1">
          <a:blip r:embed="rId13">
            <a:alphaModFix/>
          </a:blip>
          <a:srcRect l="3220" r="-3219" b="28269"/>
          <a:stretch/>
        </p:blipFill>
        <p:spPr>
          <a:xfrm>
            <a:off x="7358550" y="677675"/>
            <a:ext cx="1344300" cy="1234500"/>
          </a:xfrm>
          <a:prstGeom prst="ellipse">
            <a:avLst/>
          </a:prstGeom>
          <a:noFill/>
          <a:ln>
            <a:noFill/>
          </a:ln>
        </p:spPr>
      </p:pic>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sp>
        <p:nvSpPr>
          <p:cNvPr id="266" name="Google Shape;266;p32"/>
          <p:cNvSpPr txBox="1">
            <a:spLocks noGrp="1"/>
          </p:cNvSpPr>
          <p:nvPr>
            <p:ph type="ctrTitle"/>
          </p:nvPr>
        </p:nvSpPr>
        <p:spPr>
          <a:xfrm>
            <a:off x="381000" y="1466750"/>
            <a:ext cx="7772400" cy="1600500"/>
          </a:xfrm>
          <a:prstGeom prst="rect">
            <a:avLst/>
          </a:prstGeom>
        </p:spPr>
        <p:txBody>
          <a:bodyPr spcFirstLastPara="1" wrap="square" lIns="0" tIns="0" rIns="0" bIns="0" anchor="ctr" anchorCtr="0">
            <a:noAutofit/>
          </a:bodyPr>
          <a:lstStyle/>
          <a:p>
            <a:pPr marL="0" lvl="0" indent="0" algn="l" rtl="0">
              <a:spcBef>
                <a:spcPts val="0"/>
              </a:spcBef>
              <a:spcAft>
                <a:spcPts val="0"/>
              </a:spcAft>
              <a:buNone/>
            </a:pPr>
            <a:r>
              <a:rPr lang="en" dirty="0"/>
              <a:t>Tools for name pronunciation</a:t>
            </a:r>
            <a:endParaRPr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sp>
        <p:nvSpPr>
          <p:cNvPr id="272" name="Google Shape;272;p33"/>
          <p:cNvSpPr txBox="1">
            <a:spLocks noGrp="1"/>
          </p:cNvSpPr>
          <p:nvPr>
            <p:ph type="title"/>
          </p:nvPr>
        </p:nvSpPr>
        <p:spPr>
          <a:xfrm>
            <a:off x="524208" y="421693"/>
            <a:ext cx="82998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dirty="0"/>
              <a:t>Asking people how to pronounce names</a:t>
            </a:r>
            <a:endParaRPr dirty="0"/>
          </a:p>
        </p:txBody>
      </p:sp>
      <p:sp>
        <p:nvSpPr>
          <p:cNvPr id="273" name="Google Shape;273;p33"/>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22</a:t>
            </a:fld>
            <a:endParaRPr/>
          </a:p>
        </p:txBody>
      </p:sp>
      <p:sp>
        <p:nvSpPr>
          <p:cNvPr id="274" name="Google Shape;274;p33"/>
          <p:cNvSpPr/>
          <p:nvPr/>
        </p:nvSpPr>
        <p:spPr>
          <a:xfrm rot="-6597333">
            <a:off x="1252959" y="4317920"/>
            <a:ext cx="586303" cy="586303"/>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5" name="Google Shape;275;p33"/>
          <p:cNvSpPr/>
          <p:nvPr/>
        </p:nvSpPr>
        <p:spPr>
          <a:xfrm rot="-6599386">
            <a:off x="62029" y="3972476"/>
            <a:ext cx="440541" cy="440541"/>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6" name="Google Shape;276;p33"/>
          <p:cNvSpPr/>
          <p:nvPr/>
        </p:nvSpPr>
        <p:spPr>
          <a:xfrm rot="-6598620">
            <a:off x="3872574" y="1784081"/>
            <a:ext cx="1681581" cy="1681581"/>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7" name="Google Shape;277;p33"/>
          <p:cNvSpPr/>
          <p:nvPr/>
        </p:nvSpPr>
        <p:spPr>
          <a:xfrm rot="-6597701">
            <a:off x="857783" y="2035236"/>
            <a:ext cx="274172" cy="274172"/>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78" name="Google Shape;278;p33"/>
          <p:cNvGrpSpPr/>
          <p:nvPr/>
        </p:nvGrpSpPr>
        <p:grpSpPr>
          <a:xfrm>
            <a:off x="524210" y="1096486"/>
            <a:ext cx="2755474" cy="2713990"/>
            <a:chOff x="4447194" y="1815766"/>
            <a:chExt cx="2440200" cy="2440200"/>
          </a:xfrm>
        </p:grpSpPr>
        <p:sp>
          <p:nvSpPr>
            <p:cNvPr id="279" name="Google Shape;279;p33"/>
            <p:cNvSpPr/>
            <p:nvPr/>
          </p:nvSpPr>
          <p:spPr>
            <a:xfrm>
              <a:off x="4447194" y="1815766"/>
              <a:ext cx="2440200" cy="2440200"/>
            </a:xfrm>
            <a:prstGeom prst="ellipse">
              <a:avLst/>
            </a:prstGeom>
            <a:solidFill>
              <a:schemeClr val="accent2"/>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latin typeface="Montserrat Light"/>
                <a:ea typeface="Montserrat Light"/>
                <a:cs typeface="Montserrat Light"/>
                <a:sym typeface="Montserrat Light"/>
              </a:endParaRPr>
            </a:p>
          </p:txBody>
        </p:sp>
        <p:sp>
          <p:nvSpPr>
            <p:cNvPr id="280" name="Google Shape;280;p33"/>
            <p:cNvSpPr txBox="1"/>
            <p:nvPr/>
          </p:nvSpPr>
          <p:spPr>
            <a:xfrm>
              <a:off x="4735950" y="2504275"/>
              <a:ext cx="1862700" cy="11634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600"/>
                </a:spcAft>
                <a:buNone/>
              </a:pPr>
              <a:r>
                <a:rPr lang="en" sz="1700" dirty="0">
                  <a:solidFill>
                    <a:schemeClr val="lt1"/>
                  </a:solidFill>
                  <a:latin typeface="Calibri"/>
                  <a:ea typeface="Calibri"/>
                  <a:cs typeface="Calibri"/>
                  <a:sym typeface="Calibri"/>
                </a:rPr>
                <a:t>Just ask! “What do you prefer that I call you? What do you prefer to be called in front of others?”</a:t>
              </a:r>
              <a:endParaRPr sz="1200" dirty="0">
                <a:solidFill>
                  <a:schemeClr val="lt1"/>
                </a:solidFill>
                <a:latin typeface="Montserrat Light"/>
                <a:ea typeface="Montserrat Light"/>
                <a:cs typeface="Montserrat Light"/>
                <a:sym typeface="Montserrat Light"/>
              </a:endParaRPr>
            </a:p>
          </p:txBody>
        </p:sp>
      </p:grpSp>
      <p:grpSp>
        <p:nvGrpSpPr>
          <p:cNvPr id="281" name="Google Shape;281;p33"/>
          <p:cNvGrpSpPr/>
          <p:nvPr/>
        </p:nvGrpSpPr>
        <p:grpSpPr>
          <a:xfrm>
            <a:off x="1373420" y="2048413"/>
            <a:ext cx="2755480" cy="2713905"/>
            <a:chOff x="3490737" y="1374053"/>
            <a:chExt cx="1423800" cy="1423800"/>
          </a:xfrm>
        </p:grpSpPr>
        <p:sp>
          <p:nvSpPr>
            <p:cNvPr id="282" name="Google Shape;282;p33"/>
            <p:cNvSpPr/>
            <p:nvPr/>
          </p:nvSpPr>
          <p:spPr>
            <a:xfrm>
              <a:off x="3490737" y="1374053"/>
              <a:ext cx="1423800" cy="1423800"/>
            </a:xfrm>
            <a:prstGeom prst="ellipse">
              <a:avLst/>
            </a:prstGeom>
            <a:solidFill>
              <a:schemeClr val="accent1"/>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sz="1500">
                <a:solidFill>
                  <a:schemeClr val="lt1"/>
                </a:solidFill>
                <a:latin typeface="Montserrat Light"/>
                <a:ea typeface="Montserrat Light"/>
                <a:cs typeface="Montserrat Light"/>
                <a:sym typeface="Montserrat Light"/>
              </a:endParaRPr>
            </a:p>
          </p:txBody>
        </p:sp>
        <p:sp>
          <p:nvSpPr>
            <p:cNvPr id="283" name="Google Shape;283;p33"/>
            <p:cNvSpPr txBox="1"/>
            <p:nvPr/>
          </p:nvSpPr>
          <p:spPr>
            <a:xfrm>
              <a:off x="3718754" y="1613603"/>
              <a:ext cx="967800" cy="9447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600"/>
                </a:spcAft>
                <a:buNone/>
              </a:pPr>
              <a:r>
                <a:rPr lang="en" sz="1700">
                  <a:solidFill>
                    <a:schemeClr val="lt1"/>
                  </a:solidFill>
                  <a:latin typeface="Calibri"/>
                  <a:ea typeface="Calibri"/>
                  <a:cs typeface="Calibri"/>
                  <a:sym typeface="Calibri"/>
                </a:rPr>
                <a:t>Listen carefully to where the person puts emphasis and inflections</a:t>
              </a:r>
              <a:endParaRPr sz="1100">
                <a:solidFill>
                  <a:schemeClr val="lt1"/>
                </a:solidFill>
                <a:latin typeface="Montserrat Light"/>
                <a:ea typeface="Montserrat Light"/>
                <a:cs typeface="Montserrat Light"/>
                <a:sym typeface="Montserrat Light"/>
              </a:endParaRPr>
            </a:p>
          </p:txBody>
        </p:sp>
      </p:grpSp>
      <p:grpSp>
        <p:nvGrpSpPr>
          <p:cNvPr id="284" name="Google Shape;284;p33"/>
          <p:cNvGrpSpPr/>
          <p:nvPr/>
        </p:nvGrpSpPr>
        <p:grpSpPr>
          <a:xfrm>
            <a:off x="2511323" y="1096486"/>
            <a:ext cx="2825607" cy="2713990"/>
            <a:chOff x="4447194" y="1815766"/>
            <a:chExt cx="2502309" cy="2440200"/>
          </a:xfrm>
        </p:grpSpPr>
        <p:sp>
          <p:nvSpPr>
            <p:cNvPr id="285" name="Google Shape;285;p33"/>
            <p:cNvSpPr/>
            <p:nvPr/>
          </p:nvSpPr>
          <p:spPr>
            <a:xfrm>
              <a:off x="4447194" y="1815766"/>
              <a:ext cx="2440200" cy="2440200"/>
            </a:xfrm>
            <a:prstGeom prst="ellipse">
              <a:avLst/>
            </a:prstGeom>
            <a:solidFill>
              <a:schemeClr val="accent2"/>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solidFill>
                  <a:schemeClr val="lt1"/>
                </a:solidFill>
                <a:latin typeface="Montserrat Light"/>
                <a:ea typeface="Montserrat Light"/>
                <a:cs typeface="Montserrat Light"/>
                <a:sym typeface="Montserrat Light"/>
              </a:endParaRPr>
            </a:p>
          </p:txBody>
        </p:sp>
        <p:sp>
          <p:nvSpPr>
            <p:cNvPr id="286" name="Google Shape;286;p33"/>
            <p:cNvSpPr txBox="1"/>
            <p:nvPr/>
          </p:nvSpPr>
          <p:spPr>
            <a:xfrm>
              <a:off x="4447203" y="2399525"/>
              <a:ext cx="2502300" cy="1381800"/>
            </a:xfrm>
            <a:prstGeom prst="rect">
              <a:avLst/>
            </a:prstGeom>
            <a:noFill/>
            <a:ln>
              <a:noFill/>
            </a:ln>
          </p:spPr>
          <p:txBody>
            <a:bodyPr spcFirstLastPara="1" wrap="square" lIns="91425" tIns="91425" rIns="91425" bIns="91425" anchor="ctr" anchorCtr="0">
              <a:noAutofit/>
            </a:bodyPr>
            <a:lstStyle/>
            <a:p>
              <a:pPr marL="342900" lvl="0" indent="0" algn="l" rtl="0">
                <a:spcBef>
                  <a:spcPts val="0"/>
                </a:spcBef>
                <a:spcAft>
                  <a:spcPts val="0"/>
                </a:spcAft>
                <a:buNone/>
              </a:pPr>
              <a:r>
                <a:rPr lang="en" sz="1700">
                  <a:solidFill>
                    <a:schemeClr val="lt1"/>
                  </a:solidFill>
                  <a:latin typeface="Calibri"/>
                  <a:ea typeface="Calibri"/>
                  <a:cs typeface="Calibri"/>
                  <a:sym typeface="Calibri"/>
                </a:rPr>
                <a:t>Repeat after them once or twice, not more</a:t>
              </a:r>
              <a:endParaRPr sz="1700">
                <a:solidFill>
                  <a:schemeClr val="lt1"/>
                </a:solidFill>
                <a:latin typeface="Calibri"/>
                <a:ea typeface="Calibri"/>
                <a:cs typeface="Calibri"/>
                <a:sym typeface="Calibri"/>
              </a:endParaRPr>
            </a:p>
            <a:p>
              <a:pPr marL="342900" lvl="0" indent="0" algn="l" rtl="0">
                <a:spcBef>
                  <a:spcPts val="600"/>
                </a:spcBef>
                <a:spcAft>
                  <a:spcPts val="600"/>
                </a:spcAft>
                <a:buNone/>
              </a:pPr>
              <a:r>
                <a:rPr lang="en" sz="1700">
                  <a:solidFill>
                    <a:schemeClr val="lt1"/>
                  </a:solidFill>
                  <a:latin typeface="Calibri"/>
                  <a:ea typeface="Calibri"/>
                  <a:cs typeface="Calibri"/>
                  <a:sym typeface="Calibri"/>
                </a:rPr>
                <a:t>Thank them for sharing then move on, avoid dwelling </a:t>
              </a:r>
              <a:endParaRPr sz="1500">
                <a:solidFill>
                  <a:schemeClr val="lt1"/>
                </a:solidFill>
                <a:latin typeface="Montserrat Light"/>
                <a:ea typeface="Montserrat Light"/>
                <a:cs typeface="Montserrat Light"/>
                <a:sym typeface="Montserrat Light"/>
              </a:endParaRPr>
            </a:p>
          </p:txBody>
        </p:sp>
      </p:grpSp>
      <p:grpSp>
        <p:nvGrpSpPr>
          <p:cNvPr id="287" name="Google Shape;287;p33"/>
          <p:cNvGrpSpPr/>
          <p:nvPr/>
        </p:nvGrpSpPr>
        <p:grpSpPr>
          <a:xfrm>
            <a:off x="3447808" y="2048413"/>
            <a:ext cx="2755480" cy="2713905"/>
            <a:chOff x="3490737" y="1374053"/>
            <a:chExt cx="1423800" cy="1423800"/>
          </a:xfrm>
        </p:grpSpPr>
        <p:sp>
          <p:nvSpPr>
            <p:cNvPr id="288" name="Google Shape;288;p33"/>
            <p:cNvSpPr/>
            <p:nvPr/>
          </p:nvSpPr>
          <p:spPr>
            <a:xfrm>
              <a:off x="3490737" y="1374053"/>
              <a:ext cx="1423800" cy="1423800"/>
            </a:xfrm>
            <a:prstGeom prst="ellipse">
              <a:avLst/>
            </a:prstGeom>
            <a:solidFill>
              <a:schemeClr val="accent1"/>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sz="1500">
                <a:solidFill>
                  <a:schemeClr val="lt1"/>
                </a:solidFill>
                <a:latin typeface="Montserrat Light"/>
                <a:ea typeface="Montserrat Light"/>
                <a:cs typeface="Montserrat Light"/>
                <a:sym typeface="Montserrat Light"/>
              </a:endParaRPr>
            </a:p>
          </p:txBody>
        </p:sp>
        <p:sp>
          <p:nvSpPr>
            <p:cNvPr id="289" name="Google Shape;289;p33"/>
            <p:cNvSpPr txBox="1"/>
            <p:nvPr/>
          </p:nvSpPr>
          <p:spPr>
            <a:xfrm>
              <a:off x="3763036" y="1613603"/>
              <a:ext cx="967800" cy="944700"/>
            </a:xfrm>
            <a:prstGeom prst="rect">
              <a:avLst/>
            </a:prstGeom>
            <a:noFill/>
            <a:ln>
              <a:noFill/>
            </a:ln>
          </p:spPr>
          <p:txBody>
            <a:bodyPr spcFirstLastPara="1" wrap="square" lIns="91425" tIns="91425" rIns="91425" bIns="91425" anchor="ctr" anchorCtr="0">
              <a:noAutofit/>
            </a:bodyPr>
            <a:lstStyle/>
            <a:p>
              <a:pPr marL="342900" lvl="0" indent="0" algn="l" rtl="0">
                <a:spcBef>
                  <a:spcPts val="0"/>
                </a:spcBef>
                <a:spcAft>
                  <a:spcPts val="600"/>
                </a:spcAft>
                <a:buNone/>
              </a:pPr>
              <a:r>
                <a:rPr lang="en" sz="1700">
                  <a:solidFill>
                    <a:schemeClr val="lt1"/>
                  </a:solidFill>
                  <a:latin typeface="Calibri"/>
                  <a:ea typeface="Calibri"/>
                  <a:cs typeface="Calibri"/>
                  <a:sym typeface="Calibri"/>
                </a:rPr>
                <a:t>Practice, practice, practice</a:t>
              </a:r>
              <a:endParaRPr sz="1100">
                <a:solidFill>
                  <a:schemeClr val="lt1"/>
                </a:solidFill>
                <a:latin typeface="Montserrat Light"/>
                <a:ea typeface="Montserrat Light"/>
                <a:cs typeface="Montserrat Light"/>
                <a:sym typeface="Montserrat Light"/>
              </a:endParaRPr>
            </a:p>
          </p:txBody>
        </p:sp>
      </p:grpSp>
      <p:grpSp>
        <p:nvGrpSpPr>
          <p:cNvPr id="290" name="Google Shape;290;p33"/>
          <p:cNvGrpSpPr/>
          <p:nvPr/>
        </p:nvGrpSpPr>
        <p:grpSpPr>
          <a:xfrm>
            <a:off x="4807410" y="977111"/>
            <a:ext cx="2755474" cy="2713990"/>
            <a:chOff x="4317102" y="1815766"/>
            <a:chExt cx="2440200" cy="2440200"/>
          </a:xfrm>
        </p:grpSpPr>
        <p:sp>
          <p:nvSpPr>
            <p:cNvPr id="291" name="Google Shape;291;p33"/>
            <p:cNvSpPr/>
            <p:nvPr/>
          </p:nvSpPr>
          <p:spPr>
            <a:xfrm>
              <a:off x="4317102" y="1815766"/>
              <a:ext cx="2440200" cy="2440200"/>
            </a:xfrm>
            <a:prstGeom prst="ellipse">
              <a:avLst/>
            </a:prstGeom>
            <a:solidFill>
              <a:schemeClr val="accent2"/>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solidFill>
                  <a:schemeClr val="lt1"/>
                </a:solidFill>
                <a:latin typeface="Montserrat Light"/>
                <a:ea typeface="Montserrat Light"/>
                <a:cs typeface="Montserrat Light"/>
                <a:sym typeface="Montserrat Light"/>
              </a:endParaRPr>
            </a:p>
          </p:txBody>
        </p:sp>
        <p:sp>
          <p:nvSpPr>
            <p:cNvPr id="292" name="Google Shape;292;p33"/>
            <p:cNvSpPr txBox="1"/>
            <p:nvPr/>
          </p:nvSpPr>
          <p:spPr>
            <a:xfrm>
              <a:off x="4735950" y="2504275"/>
              <a:ext cx="1862700" cy="11634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600"/>
                </a:spcAft>
                <a:buNone/>
              </a:pPr>
              <a:r>
                <a:rPr lang="en" sz="1700">
                  <a:solidFill>
                    <a:schemeClr val="lt1"/>
                  </a:solidFill>
                  <a:latin typeface="Calibri"/>
                  <a:ea typeface="Calibri"/>
                  <a:cs typeface="Calibri"/>
                  <a:sym typeface="Calibri"/>
                </a:rPr>
                <a:t>Clarify “Remind me how to pronounce your name again”</a:t>
              </a:r>
              <a:endParaRPr sz="1600">
                <a:solidFill>
                  <a:schemeClr val="lt1"/>
                </a:solidFill>
                <a:latin typeface="Montserrat Light"/>
                <a:ea typeface="Montserrat Light"/>
                <a:cs typeface="Montserrat Light"/>
                <a:sym typeface="Montserrat Light"/>
              </a:endParaRPr>
            </a:p>
          </p:txBody>
        </p:sp>
      </p:grpSp>
      <p:grpSp>
        <p:nvGrpSpPr>
          <p:cNvPr id="293" name="Google Shape;293;p33"/>
          <p:cNvGrpSpPr/>
          <p:nvPr/>
        </p:nvGrpSpPr>
        <p:grpSpPr>
          <a:xfrm>
            <a:off x="6147033" y="1996676"/>
            <a:ext cx="2755500" cy="2713800"/>
            <a:chOff x="6273775" y="2251858"/>
            <a:chExt cx="2755500" cy="2713800"/>
          </a:xfrm>
        </p:grpSpPr>
        <p:sp>
          <p:nvSpPr>
            <p:cNvPr id="294" name="Google Shape;294;p33"/>
            <p:cNvSpPr/>
            <p:nvPr/>
          </p:nvSpPr>
          <p:spPr>
            <a:xfrm>
              <a:off x="6273775" y="2251858"/>
              <a:ext cx="2755500" cy="2713800"/>
            </a:xfrm>
            <a:prstGeom prst="ellipse">
              <a:avLst/>
            </a:prstGeom>
            <a:solidFill>
              <a:schemeClr val="accent1"/>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sz="1500">
                <a:solidFill>
                  <a:schemeClr val="lt1"/>
                </a:solidFill>
                <a:latin typeface="Montserrat Light"/>
                <a:ea typeface="Montserrat Light"/>
                <a:cs typeface="Montserrat Light"/>
                <a:sym typeface="Montserrat Light"/>
              </a:endParaRPr>
            </a:p>
          </p:txBody>
        </p:sp>
        <p:sp>
          <p:nvSpPr>
            <p:cNvPr id="295" name="Google Shape;295;p33"/>
            <p:cNvSpPr txBox="1"/>
            <p:nvPr/>
          </p:nvSpPr>
          <p:spPr>
            <a:xfrm>
              <a:off x="6273775" y="2913350"/>
              <a:ext cx="2676900" cy="1394100"/>
            </a:xfrm>
            <a:prstGeom prst="rect">
              <a:avLst/>
            </a:prstGeom>
            <a:noFill/>
            <a:ln>
              <a:noFill/>
            </a:ln>
          </p:spPr>
          <p:txBody>
            <a:bodyPr spcFirstLastPara="1" wrap="square" lIns="91425" tIns="91425" rIns="91425" bIns="91425" anchor="ctr" anchorCtr="0">
              <a:noAutofit/>
            </a:bodyPr>
            <a:lstStyle/>
            <a:p>
              <a:pPr marL="342900" lvl="0" indent="0" algn="l" rtl="0">
                <a:spcBef>
                  <a:spcPts val="0"/>
                </a:spcBef>
                <a:spcAft>
                  <a:spcPts val="600"/>
                </a:spcAft>
                <a:buNone/>
              </a:pPr>
              <a:r>
                <a:rPr lang="en" sz="1700">
                  <a:solidFill>
                    <a:schemeClr val="lt1"/>
                  </a:solidFill>
                  <a:latin typeface="Calibri"/>
                  <a:ea typeface="Calibri"/>
                  <a:cs typeface="Calibri"/>
                  <a:sym typeface="Calibri"/>
                </a:rPr>
                <a:t>Own mistakes and correct. “I realize I’ve been saying your name wrong, sorry.” OR “It’s really important to me that I learn how to say your name correctly”</a:t>
              </a:r>
              <a:endParaRPr sz="1600">
                <a:solidFill>
                  <a:schemeClr val="lt1"/>
                </a:solidFill>
                <a:latin typeface="Montserrat Light"/>
                <a:ea typeface="Montserrat Light"/>
                <a:cs typeface="Montserrat Light"/>
                <a:sym typeface="Montserrat Light"/>
              </a:endParaRPr>
            </a:p>
          </p:txBody>
        </p:sp>
      </p:grpSp>
      <p:sp>
        <p:nvSpPr>
          <p:cNvPr id="26" name="TextBox 25">
            <a:extLst>
              <a:ext uri="{FF2B5EF4-FFF2-40B4-BE49-F238E27FC236}">
                <a16:creationId xmlns:a16="http://schemas.microsoft.com/office/drawing/2014/main" id="{CD23D682-C2B8-964C-A8F3-7097816C9AC5}"/>
              </a:ext>
            </a:extLst>
          </p:cNvPr>
          <p:cNvSpPr txBox="1"/>
          <p:nvPr/>
        </p:nvSpPr>
        <p:spPr>
          <a:xfrm>
            <a:off x="114716" y="4482777"/>
            <a:ext cx="1646605" cy="307777"/>
          </a:xfrm>
          <a:prstGeom prst="rect">
            <a:avLst/>
          </a:prstGeom>
          <a:noFill/>
        </p:spPr>
        <p:txBody>
          <a:bodyPr wrap="none" rtlCol="0">
            <a:spAutoFit/>
          </a:bodyPr>
          <a:lstStyle/>
          <a:p>
            <a:r>
              <a:rPr lang="en-US" i="1" dirty="0">
                <a:solidFill>
                  <a:schemeClr val="bg2"/>
                </a:solidFill>
              </a:rPr>
              <a:t>Lee, Idealist, 2020</a:t>
            </a:r>
          </a:p>
        </p:txBody>
      </p:sp>
      <p:sp>
        <p:nvSpPr>
          <p:cNvPr id="28" name="TextBox 27">
            <a:extLst>
              <a:ext uri="{FF2B5EF4-FFF2-40B4-BE49-F238E27FC236}">
                <a16:creationId xmlns:a16="http://schemas.microsoft.com/office/drawing/2014/main" id="{570C267E-7C69-7D4B-BB35-7E566FEF0CDF}"/>
              </a:ext>
            </a:extLst>
          </p:cNvPr>
          <p:cNvSpPr txBox="1"/>
          <p:nvPr/>
        </p:nvSpPr>
        <p:spPr>
          <a:xfrm>
            <a:off x="97838" y="4702673"/>
            <a:ext cx="4572000" cy="307777"/>
          </a:xfrm>
          <a:prstGeom prst="rect">
            <a:avLst/>
          </a:prstGeom>
          <a:noFill/>
        </p:spPr>
        <p:txBody>
          <a:bodyPr wrap="square">
            <a:spAutoFit/>
          </a:bodyPr>
          <a:lstStyle/>
          <a:p>
            <a:pPr marL="0" marR="0">
              <a:spcBef>
                <a:spcPts val="0"/>
              </a:spcBef>
              <a:spcAft>
                <a:spcPts val="0"/>
              </a:spcAft>
            </a:pPr>
            <a:r>
              <a:rPr lang="en-US" i="1" dirty="0" err="1">
                <a:solidFill>
                  <a:schemeClr val="bg2"/>
                </a:solidFill>
                <a:effectLst/>
                <a:latin typeface="Arial" panose="020B0604020202020204" pitchFamily="34" charset="0"/>
                <a:ea typeface="Times New Roman" panose="02020603050405020304" pitchFamily="18" charset="0"/>
                <a:cs typeface="Arial" panose="020B0604020202020204" pitchFamily="34" charset="0"/>
              </a:rPr>
              <a:t>Tulshyan</a:t>
            </a:r>
            <a:r>
              <a:rPr lang="en-US" i="1" dirty="0">
                <a:solidFill>
                  <a:schemeClr val="bg2"/>
                </a:solidFill>
                <a:effectLst/>
                <a:latin typeface="Arial" panose="020B0604020202020204" pitchFamily="34" charset="0"/>
                <a:ea typeface="Times New Roman" panose="02020603050405020304" pitchFamily="18" charset="0"/>
                <a:cs typeface="Arial" panose="020B0604020202020204" pitchFamily="34" charset="0"/>
              </a:rPr>
              <a:t>, Harvard Business Review, 2020</a:t>
            </a:r>
            <a:endParaRPr lang="en-US" i="1" dirty="0">
              <a:solidFill>
                <a:schemeClr val="bg2"/>
              </a:solidFill>
              <a:effectLst/>
              <a:latin typeface="Arial" panose="020B0604020202020204" pitchFamily="34" charset="0"/>
              <a:ea typeface="Calibri" panose="020F0502020204030204" pitchFamily="34" charset="0"/>
              <a:cs typeface="Arial" panose="020B0604020202020204" pitchFamily="34"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78"/>
                                        </p:tgtEl>
                                        <p:attrNameLst>
                                          <p:attrName>style.visibility</p:attrName>
                                        </p:attrNameLst>
                                      </p:cBhvr>
                                      <p:to>
                                        <p:strVal val="visible"/>
                                      </p:to>
                                    </p:set>
                                    <p:animEffect transition="in" filter="fade">
                                      <p:cBhvr>
                                        <p:cTn id="7" dur="1000"/>
                                        <p:tgtEl>
                                          <p:spTgt spid="278"/>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81"/>
                                        </p:tgtEl>
                                        <p:attrNameLst>
                                          <p:attrName>style.visibility</p:attrName>
                                        </p:attrNameLst>
                                      </p:cBhvr>
                                      <p:to>
                                        <p:strVal val="visible"/>
                                      </p:to>
                                    </p:set>
                                    <p:animEffect transition="in" filter="fade">
                                      <p:cBhvr>
                                        <p:cTn id="12" dur="1000"/>
                                        <p:tgtEl>
                                          <p:spTgt spid="281"/>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84"/>
                                        </p:tgtEl>
                                        <p:attrNameLst>
                                          <p:attrName>style.visibility</p:attrName>
                                        </p:attrNameLst>
                                      </p:cBhvr>
                                      <p:to>
                                        <p:strVal val="visible"/>
                                      </p:to>
                                    </p:set>
                                    <p:animEffect transition="in" filter="fade">
                                      <p:cBhvr>
                                        <p:cTn id="17" dur="1000"/>
                                        <p:tgtEl>
                                          <p:spTgt spid="284"/>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87"/>
                                        </p:tgtEl>
                                        <p:attrNameLst>
                                          <p:attrName>style.visibility</p:attrName>
                                        </p:attrNameLst>
                                      </p:cBhvr>
                                      <p:to>
                                        <p:strVal val="visible"/>
                                      </p:to>
                                    </p:set>
                                    <p:animEffect transition="in" filter="fade">
                                      <p:cBhvr>
                                        <p:cTn id="22" dur="1000"/>
                                        <p:tgtEl>
                                          <p:spTgt spid="287"/>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90"/>
                                        </p:tgtEl>
                                        <p:attrNameLst>
                                          <p:attrName>style.visibility</p:attrName>
                                        </p:attrNameLst>
                                      </p:cBhvr>
                                      <p:to>
                                        <p:strVal val="visible"/>
                                      </p:to>
                                    </p:set>
                                    <p:animEffect transition="in" filter="fade">
                                      <p:cBhvr>
                                        <p:cTn id="27" dur="1000"/>
                                        <p:tgtEl>
                                          <p:spTgt spid="290"/>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93"/>
                                        </p:tgtEl>
                                        <p:attrNameLst>
                                          <p:attrName>style.visibility</p:attrName>
                                        </p:attrNameLst>
                                      </p:cBhvr>
                                      <p:to>
                                        <p:strVal val="visible"/>
                                      </p:to>
                                    </p:set>
                                    <p:animEffect transition="in" filter="fade">
                                      <p:cBhvr>
                                        <p:cTn id="32" dur="1000"/>
                                        <p:tgtEl>
                                          <p:spTgt spid="29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385534-27CC-2340-BED2-09FB87BEC6DD}"/>
              </a:ext>
            </a:extLst>
          </p:cNvPr>
          <p:cNvSpPr>
            <a:spLocks noGrp="1"/>
          </p:cNvSpPr>
          <p:nvPr>
            <p:ph type="title"/>
          </p:nvPr>
        </p:nvSpPr>
        <p:spPr/>
        <p:txBody>
          <a:bodyPr/>
          <a:lstStyle/>
          <a:p>
            <a:r>
              <a:rPr lang="en-US" dirty="0"/>
              <a:t>Online resources </a:t>
            </a:r>
          </a:p>
        </p:txBody>
      </p:sp>
      <p:sp>
        <p:nvSpPr>
          <p:cNvPr id="3" name="Text Placeholder 2">
            <a:extLst>
              <a:ext uri="{FF2B5EF4-FFF2-40B4-BE49-F238E27FC236}">
                <a16:creationId xmlns:a16="http://schemas.microsoft.com/office/drawing/2014/main" id="{5F6C0F18-9416-7B49-8F86-287949B67D2A}"/>
              </a:ext>
            </a:extLst>
          </p:cNvPr>
          <p:cNvSpPr>
            <a:spLocks noGrp="1"/>
          </p:cNvSpPr>
          <p:nvPr>
            <p:ph type="body" idx="1"/>
          </p:nvPr>
        </p:nvSpPr>
        <p:spPr/>
        <p:txBody>
          <a:bodyPr/>
          <a:lstStyle/>
          <a:p>
            <a:r>
              <a:rPr lang="en-US" dirty="0" err="1"/>
              <a:t>pronouncenames.com</a:t>
            </a:r>
            <a:endParaRPr lang="en-US" dirty="0"/>
          </a:p>
          <a:p>
            <a:r>
              <a:rPr lang="en-US" dirty="0" err="1"/>
              <a:t>nameshouts.com</a:t>
            </a:r>
            <a:endParaRPr lang="en-US" dirty="0"/>
          </a:p>
          <a:p>
            <a:r>
              <a:rPr lang="en-US" dirty="0" err="1"/>
              <a:t>namecoach.com</a:t>
            </a:r>
            <a:endParaRPr lang="en-US" dirty="0"/>
          </a:p>
          <a:p>
            <a:r>
              <a:rPr lang="en-US" dirty="0" err="1"/>
              <a:t>namez.com</a:t>
            </a:r>
            <a:endParaRPr lang="en-US" dirty="0"/>
          </a:p>
        </p:txBody>
      </p:sp>
      <p:sp>
        <p:nvSpPr>
          <p:cNvPr id="4" name="Slide Number Placeholder 3">
            <a:extLst>
              <a:ext uri="{FF2B5EF4-FFF2-40B4-BE49-F238E27FC236}">
                <a16:creationId xmlns:a16="http://schemas.microsoft.com/office/drawing/2014/main" id="{86B7D549-D6F2-9645-A966-7F0463109BF4}"/>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 smtClean="0"/>
              <a:t>23</a:t>
            </a:fld>
            <a:endParaRPr lang="en"/>
          </a:p>
        </p:txBody>
      </p:sp>
    </p:spTree>
    <p:extLst>
      <p:ext uri="{BB962C8B-B14F-4D97-AF65-F5344CB8AC3E}">
        <p14:creationId xmlns:p14="http://schemas.microsoft.com/office/powerpoint/2010/main" val="71404985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13"/>
        <p:cNvGrpSpPr/>
        <p:nvPr/>
      </p:nvGrpSpPr>
      <p:grpSpPr>
        <a:xfrm>
          <a:off x="0" y="0"/>
          <a:ext cx="0" cy="0"/>
          <a:chOff x="0" y="0"/>
          <a:chExt cx="0" cy="0"/>
        </a:xfrm>
      </p:grpSpPr>
      <p:sp>
        <p:nvSpPr>
          <p:cNvPr id="314" name="Google Shape;314;p36"/>
          <p:cNvSpPr txBox="1">
            <a:spLocks noGrp="1"/>
          </p:cNvSpPr>
          <p:nvPr>
            <p:ph type="title"/>
          </p:nvPr>
        </p:nvSpPr>
        <p:spPr>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Phonetic pronunciation tools</a:t>
            </a:r>
            <a:endParaRPr/>
          </a:p>
        </p:txBody>
      </p:sp>
      <p:sp>
        <p:nvSpPr>
          <p:cNvPr id="2" name="Text Placeholder 1">
            <a:extLst>
              <a:ext uri="{FF2B5EF4-FFF2-40B4-BE49-F238E27FC236}">
                <a16:creationId xmlns:a16="http://schemas.microsoft.com/office/drawing/2014/main" id="{F2AB03E3-0C03-2246-945A-458BA69BCBF1}"/>
              </a:ext>
            </a:extLst>
          </p:cNvPr>
          <p:cNvSpPr>
            <a:spLocks noGrp="1"/>
          </p:cNvSpPr>
          <p:nvPr>
            <p:ph type="body" idx="1"/>
          </p:nvPr>
        </p:nvSpPr>
        <p:spPr/>
        <p:txBody>
          <a:bodyPr/>
          <a:lstStyle/>
          <a:p>
            <a:pPr marL="101600" indent="0">
              <a:buNone/>
            </a:pPr>
            <a:r>
              <a:rPr lang="en-US" dirty="0"/>
              <a:t>Sounds like</a:t>
            </a:r>
          </a:p>
          <a:p>
            <a:r>
              <a:rPr lang="en-US" dirty="0"/>
              <a:t>Use a word that sounds like or rhymes with your name</a:t>
            </a:r>
          </a:p>
          <a:p>
            <a:r>
              <a:rPr lang="en-US" dirty="0"/>
              <a:t>Example: Tamara rhymes with camera </a:t>
            </a:r>
          </a:p>
        </p:txBody>
      </p:sp>
      <p:sp>
        <p:nvSpPr>
          <p:cNvPr id="3" name="Text Placeholder 2">
            <a:extLst>
              <a:ext uri="{FF2B5EF4-FFF2-40B4-BE49-F238E27FC236}">
                <a16:creationId xmlns:a16="http://schemas.microsoft.com/office/drawing/2014/main" id="{1E9020AB-460C-794C-B0BC-886210429ADF}"/>
              </a:ext>
            </a:extLst>
          </p:cNvPr>
          <p:cNvSpPr>
            <a:spLocks noGrp="1"/>
          </p:cNvSpPr>
          <p:nvPr>
            <p:ph type="body" idx="2"/>
          </p:nvPr>
        </p:nvSpPr>
        <p:spPr/>
        <p:txBody>
          <a:bodyPr/>
          <a:lstStyle/>
          <a:p>
            <a:pPr marL="101600" indent="0">
              <a:buNone/>
            </a:pPr>
            <a:r>
              <a:rPr lang="en-US" dirty="0"/>
              <a:t>Phonetic writing</a:t>
            </a:r>
          </a:p>
          <a:p>
            <a:r>
              <a:rPr lang="en-US" dirty="0"/>
              <a:t>Break up the name into syllables</a:t>
            </a:r>
          </a:p>
          <a:p>
            <a:r>
              <a:rPr lang="en-US" dirty="0"/>
              <a:t>Separate each syllable with a hyphen ( - )</a:t>
            </a:r>
          </a:p>
          <a:p>
            <a:r>
              <a:rPr lang="en-US" dirty="0"/>
              <a:t>Capitalize the syllable that is emphasized</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20"/>
        <p:cNvGrpSpPr/>
        <p:nvPr/>
      </p:nvGrpSpPr>
      <p:grpSpPr>
        <a:xfrm>
          <a:off x="0" y="0"/>
          <a:ext cx="0" cy="0"/>
          <a:chOff x="0" y="0"/>
          <a:chExt cx="0" cy="0"/>
        </a:xfrm>
      </p:grpSpPr>
      <p:sp>
        <p:nvSpPr>
          <p:cNvPr id="321" name="Google Shape;321;p37"/>
          <p:cNvSpPr txBox="1">
            <a:spLocks noGrp="1"/>
          </p:cNvSpPr>
          <p:nvPr>
            <p:ph type="title"/>
          </p:nvPr>
        </p:nvSpPr>
        <p:spPr>
          <a:xfrm>
            <a:off x="855300" y="455594"/>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dirty="0"/>
              <a:t>Correcting Mispronunciation</a:t>
            </a:r>
            <a:endParaRPr dirty="0"/>
          </a:p>
        </p:txBody>
      </p:sp>
      <p:sp>
        <p:nvSpPr>
          <p:cNvPr id="322" name="Google Shape;322;p37"/>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25</a:t>
            </a:fld>
            <a:endParaRPr/>
          </a:p>
        </p:txBody>
      </p:sp>
      <p:sp>
        <p:nvSpPr>
          <p:cNvPr id="323" name="Google Shape;323;p37"/>
          <p:cNvSpPr/>
          <p:nvPr/>
        </p:nvSpPr>
        <p:spPr>
          <a:xfrm rot="-6597333">
            <a:off x="1252959" y="4286023"/>
            <a:ext cx="586303" cy="586303"/>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4" name="Google Shape;324;p37"/>
          <p:cNvSpPr/>
          <p:nvPr/>
        </p:nvSpPr>
        <p:spPr>
          <a:xfrm rot="-6599386">
            <a:off x="62029" y="3940579"/>
            <a:ext cx="440541" cy="440541"/>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5" name="Google Shape;325;p37"/>
          <p:cNvSpPr/>
          <p:nvPr/>
        </p:nvSpPr>
        <p:spPr>
          <a:xfrm rot="-6598620">
            <a:off x="3872574" y="1752184"/>
            <a:ext cx="1681581" cy="1681581"/>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6" name="Google Shape;326;p37"/>
          <p:cNvSpPr/>
          <p:nvPr/>
        </p:nvSpPr>
        <p:spPr>
          <a:xfrm rot="-6597701">
            <a:off x="857783" y="2003339"/>
            <a:ext cx="274172" cy="274172"/>
          </a:xfrm>
          <a:prstGeom prst="ellipse">
            <a:avLst/>
          </a:prstGeom>
          <a:gradFill>
            <a:gsLst>
              <a:gs pos="0">
                <a:schemeClr val="accent1"/>
              </a:gs>
              <a:gs pos="100000">
                <a:srgbClr val="00D0FF">
                  <a:alpha val="11764"/>
                </a:srgbClr>
              </a:gs>
            </a:gsLst>
            <a:path path="circle">
              <a:fillToRect l="100000" t="100000"/>
            </a:path>
            <a:tileRect r="-100000" b="-10000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327" name="Google Shape;327;p37"/>
          <p:cNvGrpSpPr/>
          <p:nvPr/>
        </p:nvGrpSpPr>
        <p:grpSpPr>
          <a:xfrm>
            <a:off x="524210" y="1064589"/>
            <a:ext cx="2755474" cy="2713990"/>
            <a:chOff x="4447194" y="1815766"/>
            <a:chExt cx="2440200" cy="2440200"/>
          </a:xfrm>
        </p:grpSpPr>
        <p:sp>
          <p:nvSpPr>
            <p:cNvPr id="328" name="Google Shape;328;p37"/>
            <p:cNvSpPr/>
            <p:nvPr/>
          </p:nvSpPr>
          <p:spPr>
            <a:xfrm>
              <a:off x="4447194" y="1815766"/>
              <a:ext cx="2440200" cy="2440200"/>
            </a:xfrm>
            <a:prstGeom prst="ellipse">
              <a:avLst/>
            </a:prstGeom>
            <a:solidFill>
              <a:schemeClr val="accent2"/>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latin typeface="Montserrat Light"/>
                <a:ea typeface="Montserrat Light"/>
                <a:cs typeface="Montserrat Light"/>
                <a:sym typeface="Montserrat Light"/>
              </a:endParaRPr>
            </a:p>
          </p:txBody>
        </p:sp>
        <p:sp>
          <p:nvSpPr>
            <p:cNvPr id="329" name="Google Shape;329;p37"/>
            <p:cNvSpPr txBox="1"/>
            <p:nvPr/>
          </p:nvSpPr>
          <p:spPr>
            <a:xfrm>
              <a:off x="4735950" y="2504275"/>
              <a:ext cx="1862700" cy="11634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600"/>
                </a:spcAft>
                <a:buNone/>
              </a:pPr>
              <a:r>
                <a:rPr lang="en" sz="1600">
                  <a:solidFill>
                    <a:schemeClr val="lt1"/>
                  </a:solidFill>
                  <a:latin typeface="Montserrat Light"/>
                  <a:ea typeface="Montserrat Light"/>
                  <a:cs typeface="Montserrat Light"/>
                  <a:sym typeface="Montserrat Light"/>
                </a:rPr>
                <a:t>“Hey, it’s not a big deal, but you’ve said my name three times and you’re still getting it wrong. It’s actually...”</a:t>
              </a:r>
              <a:endParaRPr sz="1200">
                <a:solidFill>
                  <a:schemeClr val="lt1"/>
                </a:solidFill>
                <a:latin typeface="Montserrat Light"/>
                <a:ea typeface="Montserrat Light"/>
                <a:cs typeface="Montserrat Light"/>
                <a:sym typeface="Montserrat Light"/>
              </a:endParaRPr>
            </a:p>
          </p:txBody>
        </p:sp>
      </p:grpSp>
      <p:grpSp>
        <p:nvGrpSpPr>
          <p:cNvPr id="330" name="Google Shape;330;p37"/>
          <p:cNvGrpSpPr/>
          <p:nvPr/>
        </p:nvGrpSpPr>
        <p:grpSpPr>
          <a:xfrm>
            <a:off x="1373420" y="2016516"/>
            <a:ext cx="2755480" cy="2713905"/>
            <a:chOff x="3490737" y="1374053"/>
            <a:chExt cx="1423800" cy="1423800"/>
          </a:xfrm>
        </p:grpSpPr>
        <p:sp>
          <p:nvSpPr>
            <p:cNvPr id="331" name="Google Shape;331;p37"/>
            <p:cNvSpPr/>
            <p:nvPr/>
          </p:nvSpPr>
          <p:spPr>
            <a:xfrm>
              <a:off x="3490737" y="1374053"/>
              <a:ext cx="1423800" cy="1423800"/>
            </a:xfrm>
            <a:prstGeom prst="ellipse">
              <a:avLst/>
            </a:prstGeom>
            <a:solidFill>
              <a:schemeClr val="accent1"/>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sz="1500">
                <a:solidFill>
                  <a:schemeClr val="accent2"/>
                </a:solidFill>
                <a:latin typeface="Montserrat Light"/>
                <a:ea typeface="Montserrat Light"/>
                <a:cs typeface="Montserrat Light"/>
                <a:sym typeface="Montserrat Light"/>
              </a:endParaRPr>
            </a:p>
          </p:txBody>
        </p:sp>
        <p:sp>
          <p:nvSpPr>
            <p:cNvPr id="332" name="Google Shape;332;p37"/>
            <p:cNvSpPr txBox="1"/>
            <p:nvPr/>
          </p:nvSpPr>
          <p:spPr>
            <a:xfrm>
              <a:off x="3718754" y="1613603"/>
              <a:ext cx="967800" cy="9447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600"/>
                </a:spcAft>
                <a:buNone/>
              </a:pPr>
              <a:r>
                <a:rPr lang="en" sz="1600">
                  <a:solidFill>
                    <a:schemeClr val="lt1"/>
                  </a:solidFill>
                  <a:latin typeface="Montserrat Light"/>
                  <a:ea typeface="Montserrat Light"/>
                  <a:cs typeface="Montserrat Light"/>
                  <a:sym typeface="Montserrat Light"/>
                </a:rPr>
                <a:t>“I noticed that you’ve been calling me Valerie. In fact, it’s Malorie you say it with an M in front, Malorie.”</a:t>
              </a:r>
              <a:endParaRPr sz="1100">
                <a:solidFill>
                  <a:schemeClr val="lt1"/>
                </a:solidFill>
                <a:latin typeface="Montserrat Light"/>
                <a:ea typeface="Montserrat Light"/>
                <a:cs typeface="Montserrat Light"/>
                <a:sym typeface="Montserrat Light"/>
              </a:endParaRPr>
            </a:p>
          </p:txBody>
        </p:sp>
      </p:grpSp>
      <p:grpSp>
        <p:nvGrpSpPr>
          <p:cNvPr id="333" name="Google Shape;333;p37"/>
          <p:cNvGrpSpPr/>
          <p:nvPr/>
        </p:nvGrpSpPr>
        <p:grpSpPr>
          <a:xfrm>
            <a:off x="2511323" y="1064589"/>
            <a:ext cx="2825607" cy="2713990"/>
            <a:chOff x="4447194" y="1815766"/>
            <a:chExt cx="2502309" cy="2440200"/>
          </a:xfrm>
        </p:grpSpPr>
        <p:sp>
          <p:nvSpPr>
            <p:cNvPr id="334" name="Google Shape;334;p37"/>
            <p:cNvSpPr/>
            <p:nvPr/>
          </p:nvSpPr>
          <p:spPr>
            <a:xfrm>
              <a:off x="4447194" y="1815766"/>
              <a:ext cx="2440200" cy="2440200"/>
            </a:xfrm>
            <a:prstGeom prst="ellipse">
              <a:avLst/>
            </a:prstGeom>
            <a:solidFill>
              <a:schemeClr val="accent2"/>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latin typeface="Montserrat Light"/>
                <a:ea typeface="Montserrat Light"/>
                <a:cs typeface="Montserrat Light"/>
                <a:sym typeface="Montserrat Light"/>
              </a:endParaRPr>
            </a:p>
          </p:txBody>
        </p:sp>
        <p:sp>
          <p:nvSpPr>
            <p:cNvPr id="335" name="Google Shape;335;p37"/>
            <p:cNvSpPr txBox="1"/>
            <p:nvPr/>
          </p:nvSpPr>
          <p:spPr>
            <a:xfrm>
              <a:off x="4447203" y="2399525"/>
              <a:ext cx="2502300" cy="13818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1500">
                  <a:solidFill>
                    <a:schemeClr val="lt1"/>
                  </a:solidFill>
                  <a:latin typeface="Montserrat Light"/>
                  <a:ea typeface="Montserrat Light"/>
                  <a:cs typeface="Montserrat Light"/>
                  <a:sym typeface="Montserrat Light"/>
                </a:rPr>
                <a:t>#1: "It's great to meet </a:t>
              </a:r>
              <a:endParaRPr sz="1500">
                <a:solidFill>
                  <a:schemeClr val="lt1"/>
                </a:solidFill>
                <a:latin typeface="Montserrat Light"/>
                <a:ea typeface="Montserrat Light"/>
                <a:cs typeface="Montserrat Light"/>
                <a:sym typeface="Montserrat Light"/>
              </a:endParaRPr>
            </a:p>
            <a:p>
              <a:pPr marL="0" lvl="0" indent="0" algn="ctr" rtl="0">
                <a:spcBef>
                  <a:spcPts val="600"/>
                </a:spcBef>
                <a:spcAft>
                  <a:spcPts val="0"/>
                </a:spcAft>
                <a:buNone/>
              </a:pPr>
              <a:r>
                <a:rPr lang="en" sz="1500">
                  <a:solidFill>
                    <a:schemeClr val="lt1"/>
                  </a:solidFill>
                  <a:latin typeface="Montserrat Light"/>
                  <a:ea typeface="Montserrat Light"/>
                  <a:cs typeface="Montserrat Light"/>
                  <a:sym typeface="Montserrat Light"/>
                </a:rPr>
                <a:t>you, Christine" </a:t>
              </a:r>
              <a:endParaRPr sz="1500">
                <a:solidFill>
                  <a:schemeClr val="lt1"/>
                </a:solidFill>
                <a:latin typeface="Montserrat Light"/>
                <a:ea typeface="Montserrat Light"/>
                <a:cs typeface="Montserrat Light"/>
                <a:sym typeface="Montserrat Light"/>
              </a:endParaRPr>
            </a:p>
            <a:p>
              <a:pPr marL="0" lvl="0" indent="0" algn="ctr" rtl="0">
                <a:spcBef>
                  <a:spcPts val="600"/>
                </a:spcBef>
                <a:spcAft>
                  <a:spcPts val="600"/>
                </a:spcAft>
                <a:buNone/>
              </a:pPr>
              <a:r>
                <a:rPr lang="en" sz="1500">
                  <a:solidFill>
                    <a:schemeClr val="lt1"/>
                  </a:solidFill>
                  <a:latin typeface="Montserrat Light"/>
                  <a:ea typeface="Montserrat Light"/>
                  <a:cs typeface="Montserrat Light"/>
                  <a:sym typeface="Montserrat Light"/>
                </a:rPr>
                <a:t>#2: "Thank you! Actually, my name is Christina with an 'a.' People confuse it all the time! It's so nice meeting you as well!"</a:t>
              </a:r>
              <a:endParaRPr sz="1100">
                <a:solidFill>
                  <a:schemeClr val="lt1"/>
                </a:solidFill>
                <a:latin typeface="Montserrat Light"/>
                <a:ea typeface="Montserrat Light"/>
                <a:cs typeface="Montserrat Light"/>
                <a:sym typeface="Montserrat Light"/>
              </a:endParaRPr>
            </a:p>
          </p:txBody>
        </p:sp>
      </p:grpSp>
      <p:grpSp>
        <p:nvGrpSpPr>
          <p:cNvPr id="336" name="Google Shape;336;p37"/>
          <p:cNvGrpSpPr/>
          <p:nvPr/>
        </p:nvGrpSpPr>
        <p:grpSpPr>
          <a:xfrm>
            <a:off x="3447808" y="2016516"/>
            <a:ext cx="2755480" cy="2713905"/>
            <a:chOff x="3490737" y="1374053"/>
            <a:chExt cx="1423800" cy="1423800"/>
          </a:xfrm>
        </p:grpSpPr>
        <p:sp>
          <p:nvSpPr>
            <p:cNvPr id="337" name="Google Shape;337;p37"/>
            <p:cNvSpPr/>
            <p:nvPr/>
          </p:nvSpPr>
          <p:spPr>
            <a:xfrm>
              <a:off x="3490737" y="1374053"/>
              <a:ext cx="1423800" cy="1423800"/>
            </a:xfrm>
            <a:prstGeom prst="ellipse">
              <a:avLst/>
            </a:prstGeom>
            <a:solidFill>
              <a:schemeClr val="accent1"/>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sz="1500">
                <a:solidFill>
                  <a:schemeClr val="accent2"/>
                </a:solidFill>
                <a:latin typeface="Montserrat Light"/>
                <a:ea typeface="Montserrat Light"/>
                <a:cs typeface="Montserrat Light"/>
                <a:sym typeface="Montserrat Light"/>
              </a:endParaRPr>
            </a:p>
          </p:txBody>
        </p:sp>
        <p:sp>
          <p:nvSpPr>
            <p:cNvPr id="338" name="Google Shape;338;p37"/>
            <p:cNvSpPr txBox="1"/>
            <p:nvPr/>
          </p:nvSpPr>
          <p:spPr>
            <a:xfrm>
              <a:off x="3763036" y="1613603"/>
              <a:ext cx="967800" cy="9447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600"/>
                </a:spcAft>
                <a:buNone/>
              </a:pPr>
              <a:r>
                <a:rPr lang="en" sz="1600">
                  <a:solidFill>
                    <a:schemeClr val="lt1"/>
                  </a:solidFill>
                  <a:latin typeface="Montserrat Light"/>
                  <a:ea typeface="Montserrat Light"/>
                  <a:cs typeface="Montserrat Light"/>
                  <a:sym typeface="Montserrat Light"/>
                </a:rPr>
                <a:t>“My name is actually JB, but don’t worry I’ve been called much worse.”</a:t>
              </a:r>
              <a:endParaRPr sz="1100">
                <a:solidFill>
                  <a:schemeClr val="lt1"/>
                </a:solidFill>
                <a:latin typeface="Montserrat Light"/>
                <a:ea typeface="Montserrat Light"/>
                <a:cs typeface="Montserrat Light"/>
                <a:sym typeface="Montserrat Light"/>
              </a:endParaRPr>
            </a:p>
          </p:txBody>
        </p:sp>
      </p:grpSp>
      <p:grpSp>
        <p:nvGrpSpPr>
          <p:cNvPr id="339" name="Google Shape;339;p37"/>
          <p:cNvGrpSpPr/>
          <p:nvPr/>
        </p:nvGrpSpPr>
        <p:grpSpPr>
          <a:xfrm>
            <a:off x="4807410" y="945214"/>
            <a:ext cx="2755474" cy="2713990"/>
            <a:chOff x="4317102" y="1815766"/>
            <a:chExt cx="2440200" cy="2440200"/>
          </a:xfrm>
        </p:grpSpPr>
        <p:sp>
          <p:nvSpPr>
            <p:cNvPr id="340" name="Google Shape;340;p37"/>
            <p:cNvSpPr/>
            <p:nvPr/>
          </p:nvSpPr>
          <p:spPr>
            <a:xfrm>
              <a:off x="4317102" y="1815766"/>
              <a:ext cx="2440200" cy="2440200"/>
            </a:xfrm>
            <a:prstGeom prst="ellipse">
              <a:avLst/>
            </a:prstGeom>
            <a:solidFill>
              <a:schemeClr val="accent2"/>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latin typeface="Montserrat Light"/>
                <a:ea typeface="Montserrat Light"/>
                <a:cs typeface="Montserrat Light"/>
                <a:sym typeface="Montserrat Light"/>
              </a:endParaRPr>
            </a:p>
          </p:txBody>
        </p:sp>
        <p:sp>
          <p:nvSpPr>
            <p:cNvPr id="341" name="Google Shape;341;p37"/>
            <p:cNvSpPr txBox="1"/>
            <p:nvPr/>
          </p:nvSpPr>
          <p:spPr>
            <a:xfrm>
              <a:off x="4735950" y="2504275"/>
              <a:ext cx="1862700" cy="11634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600">
                  <a:solidFill>
                    <a:schemeClr val="lt1"/>
                  </a:solidFill>
                  <a:latin typeface="Montserrat Light"/>
                  <a:ea typeface="Montserrat Light"/>
                  <a:cs typeface="Montserrat Light"/>
                  <a:sym typeface="Montserrat Light"/>
                </a:rPr>
                <a:t>“Oh gosh, you know, I haven’t taken the time to tell you that in fact my name is pronounced Aniya, like Tanya”</a:t>
              </a:r>
              <a:endParaRPr sz="1600">
                <a:solidFill>
                  <a:schemeClr val="lt1"/>
                </a:solidFill>
                <a:latin typeface="Montserrat Light"/>
                <a:ea typeface="Montserrat Light"/>
                <a:cs typeface="Montserrat Light"/>
                <a:sym typeface="Montserrat Light"/>
              </a:endParaRPr>
            </a:p>
            <a:p>
              <a:pPr marL="0" lvl="0" indent="0" algn="l" rtl="0">
                <a:spcBef>
                  <a:spcPts val="600"/>
                </a:spcBef>
                <a:spcAft>
                  <a:spcPts val="600"/>
                </a:spcAft>
                <a:buNone/>
              </a:pPr>
              <a:endParaRPr sz="1600">
                <a:solidFill>
                  <a:schemeClr val="lt1"/>
                </a:solidFill>
                <a:latin typeface="Montserrat Light"/>
                <a:ea typeface="Montserrat Light"/>
                <a:cs typeface="Montserrat Light"/>
                <a:sym typeface="Montserrat Light"/>
              </a:endParaRPr>
            </a:p>
          </p:txBody>
        </p:sp>
      </p:grpSp>
      <p:grpSp>
        <p:nvGrpSpPr>
          <p:cNvPr id="342" name="Google Shape;342;p37"/>
          <p:cNvGrpSpPr/>
          <p:nvPr/>
        </p:nvGrpSpPr>
        <p:grpSpPr>
          <a:xfrm>
            <a:off x="6147033" y="1964779"/>
            <a:ext cx="2755500" cy="2713800"/>
            <a:chOff x="6273775" y="2251858"/>
            <a:chExt cx="2755500" cy="2713800"/>
          </a:xfrm>
        </p:grpSpPr>
        <p:sp>
          <p:nvSpPr>
            <p:cNvPr id="343" name="Google Shape;343;p37"/>
            <p:cNvSpPr/>
            <p:nvPr/>
          </p:nvSpPr>
          <p:spPr>
            <a:xfrm>
              <a:off x="6273775" y="2251858"/>
              <a:ext cx="2755500" cy="2713800"/>
            </a:xfrm>
            <a:prstGeom prst="ellipse">
              <a:avLst/>
            </a:prstGeom>
            <a:solidFill>
              <a:schemeClr val="accent1"/>
            </a:solidFill>
            <a:ln>
              <a:noFill/>
            </a:ln>
            <a:effectLst>
              <a:outerShdw blurRad="228600" dist="50800" dir="5400000" algn="tl" rotWithShape="0">
                <a:srgbClr val="000000">
                  <a:alpha val="549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sz="1500">
                <a:solidFill>
                  <a:schemeClr val="accent2"/>
                </a:solidFill>
                <a:latin typeface="Montserrat Light"/>
                <a:ea typeface="Montserrat Light"/>
                <a:cs typeface="Montserrat Light"/>
                <a:sym typeface="Montserrat Light"/>
              </a:endParaRPr>
            </a:p>
          </p:txBody>
        </p:sp>
        <p:sp>
          <p:nvSpPr>
            <p:cNvPr id="344" name="Google Shape;344;p37"/>
            <p:cNvSpPr txBox="1"/>
            <p:nvPr/>
          </p:nvSpPr>
          <p:spPr>
            <a:xfrm>
              <a:off x="6646100" y="2913350"/>
              <a:ext cx="2057100" cy="13941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600">
                  <a:solidFill>
                    <a:schemeClr val="lt1"/>
                  </a:solidFill>
                  <a:latin typeface="Montserrat Light"/>
                  <a:ea typeface="Montserrat Light"/>
                  <a:cs typeface="Montserrat Light"/>
                  <a:sym typeface="Montserrat Light"/>
                </a:rPr>
                <a:t>Refer to yourself in third person: </a:t>
              </a:r>
              <a:endParaRPr sz="1600">
                <a:solidFill>
                  <a:schemeClr val="lt1"/>
                </a:solidFill>
                <a:latin typeface="Montserrat Light"/>
                <a:ea typeface="Montserrat Light"/>
                <a:cs typeface="Montserrat Light"/>
                <a:sym typeface="Montserrat Light"/>
              </a:endParaRPr>
            </a:p>
            <a:p>
              <a:pPr marL="0" lvl="0" indent="0" algn="l" rtl="0">
                <a:spcBef>
                  <a:spcPts val="600"/>
                </a:spcBef>
                <a:spcAft>
                  <a:spcPts val="600"/>
                </a:spcAft>
                <a:buNone/>
              </a:pPr>
              <a:r>
                <a:rPr lang="en" sz="1600">
                  <a:solidFill>
                    <a:schemeClr val="lt1"/>
                  </a:solidFill>
                  <a:latin typeface="Montserrat Light"/>
                  <a:ea typeface="Montserrat Light"/>
                  <a:cs typeface="Montserrat Light"/>
                  <a:sym typeface="Montserrat Light"/>
                </a:rPr>
                <a:t>“My friend said to me ‘Abdullah I can’t believe you did that’”</a:t>
              </a:r>
              <a:endParaRPr sz="1600">
                <a:solidFill>
                  <a:schemeClr val="lt1"/>
                </a:solidFill>
                <a:latin typeface="Montserrat Light"/>
                <a:ea typeface="Montserrat Light"/>
                <a:cs typeface="Montserrat Light"/>
                <a:sym typeface="Montserrat Light"/>
              </a:endParaRPr>
            </a:p>
          </p:txBody>
        </p:sp>
      </p:grpSp>
      <p:sp>
        <p:nvSpPr>
          <p:cNvPr id="345" name="Google Shape;345;p37"/>
          <p:cNvSpPr txBox="1"/>
          <p:nvPr/>
        </p:nvSpPr>
        <p:spPr>
          <a:xfrm>
            <a:off x="7323425" y="1895900"/>
            <a:ext cx="1862700" cy="11634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200">
              <a:solidFill>
                <a:srgbClr val="FFFFFF"/>
              </a:solidFill>
              <a:latin typeface="Montserrat Light"/>
              <a:ea typeface="Montserrat Light"/>
              <a:cs typeface="Montserrat Light"/>
              <a:sym typeface="Montserrat Light"/>
            </a:endParaRPr>
          </a:p>
        </p:txBody>
      </p:sp>
      <p:sp>
        <p:nvSpPr>
          <p:cNvPr id="27" name="TextBox 26">
            <a:extLst>
              <a:ext uri="{FF2B5EF4-FFF2-40B4-BE49-F238E27FC236}">
                <a16:creationId xmlns:a16="http://schemas.microsoft.com/office/drawing/2014/main" id="{4FCB6697-BE66-F346-8C7D-01D8CD12D580}"/>
              </a:ext>
            </a:extLst>
          </p:cNvPr>
          <p:cNvSpPr txBox="1"/>
          <p:nvPr/>
        </p:nvSpPr>
        <p:spPr>
          <a:xfrm>
            <a:off x="135279" y="4749851"/>
            <a:ext cx="1686680" cy="307777"/>
          </a:xfrm>
          <a:prstGeom prst="rect">
            <a:avLst/>
          </a:prstGeom>
          <a:noFill/>
        </p:spPr>
        <p:txBody>
          <a:bodyPr wrap="none" rtlCol="0">
            <a:spAutoFit/>
          </a:bodyPr>
          <a:lstStyle/>
          <a:p>
            <a:r>
              <a:rPr lang="en-US" i="1" dirty="0">
                <a:solidFill>
                  <a:schemeClr val="bg2"/>
                </a:solidFill>
              </a:rPr>
              <a:t>Cain, Insider, 2017</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27"/>
                                        </p:tgtEl>
                                        <p:attrNameLst>
                                          <p:attrName>style.visibility</p:attrName>
                                        </p:attrNameLst>
                                      </p:cBhvr>
                                      <p:to>
                                        <p:strVal val="visible"/>
                                      </p:to>
                                    </p:set>
                                    <p:animEffect transition="in" filter="fade">
                                      <p:cBhvr>
                                        <p:cTn id="7" dur="1000"/>
                                        <p:tgtEl>
                                          <p:spTgt spid="327"/>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30"/>
                                        </p:tgtEl>
                                        <p:attrNameLst>
                                          <p:attrName>style.visibility</p:attrName>
                                        </p:attrNameLst>
                                      </p:cBhvr>
                                      <p:to>
                                        <p:strVal val="visible"/>
                                      </p:to>
                                    </p:set>
                                    <p:animEffect transition="in" filter="fade">
                                      <p:cBhvr>
                                        <p:cTn id="12" dur="1000"/>
                                        <p:tgtEl>
                                          <p:spTgt spid="330"/>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33"/>
                                        </p:tgtEl>
                                        <p:attrNameLst>
                                          <p:attrName>style.visibility</p:attrName>
                                        </p:attrNameLst>
                                      </p:cBhvr>
                                      <p:to>
                                        <p:strVal val="visible"/>
                                      </p:to>
                                    </p:set>
                                    <p:animEffect transition="in" filter="fade">
                                      <p:cBhvr>
                                        <p:cTn id="17" dur="1000"/>
                                        <p:tgtEl>
                                          <p:spTgt spid="333"/>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36"/>
                                        </p:tgtEl>
                                        <p:attrNameLst>
                                          <p:attrName>style.visibility</p:attrName>
                                        </p:attrNameLst>
                                      </p:cBhvr>
                                      <p:to>
                                        <p:strVal val="visible"/>
                                      </p:to>
                                    </p:set>
                                    <p:animEffect transition="in" filter="fade">
                                      <p:cBhvr>
                                        <p:cTn id="22" dur="1000"/>
                                        <p:tgtEl>
                                          <p:spTgt spid="336"/>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39"/>
                                        </p:tgtEl>
                                        <p:attrNameLst>
                                          <p:attrName>style.visibility</p:attrName>
                                        </p:attrNameLst>
                                      </p:cBhvr>
                                      <p:to>
                                        <p:strVal val="visible"/>
                                      </p:to>
                                    </p:set>
                                    <p:animEffect transition="in" filter="fade">
                                      <p:cBhvr>
                                        <p:cTn id="27" dur="1000"/>
                                        <p:tgtEl>
                                          <p:spTgt spid="339"/>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42"/>
                                        </p:tgtEl>
                                        <p:attrNameLst>
                                          <p:attrName>style.visibility</p:attrName>
                                        </p:attrNameLst>
                                      </p:cBhvr>
                                      <p:to>
                                        <p:strVal val="visible"/>
                                      </p:to>
                                    </p:set>
                                    <p:animEffect transition="in" filter="fade">
                                      <p:cBhvr>
                                        <p:cTn id="32" dur="1000"/>
                                        <p:tgtEl>
                                          <p:spTgt spid="34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49"/>
        <p:cNvGrpSpPr/>
        <p:nvPr/>
      </p:nvGrpSpPr>
      <p:grpSpPr>
        <a:xfrm>
          <a:off x="0" y="0"/>
          <a:ext cx="0" cy="0"/>
          <a:chOff x="0" y="0"/>
          <a:chExt cx="0" cy="0"/>
        </a:xfrm>
      </p:grpSpPr>
      <p:sp>
        <p:nvSpPr>
          <p:cNvPr id="350" name="Google Shape;350;p38"/>
          <p:cNvSpPr txBox="1">
            <a:spLocks noGrp="1"/>
          </p:cNvSpPr>
          <p:nvPr>
            <p:ph type="ctrTitle"/>
          </p:nvPr>
        </p:nvSpPr>
        <p:spPr>
          <a:xfrm>
            <a:off x="610825" y="1173276"/>
            <a:ext cx="7772400" cy="13116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Apply your knowledge!</a:t>
            </a:r>
            <a:endParaRPr/>
          </a:p>
        </p:txBody>
      </p:sp>
      <p:sp>
        <p:nvSpPr>
          <p:cNvPr id="351" name="Google Shape;351;p38"/>
          <p:cNvSpPr txBox="1">
            <a:spLocks noGrp="1"/>
          </p:cNvSpPr>
          <p:nvPr>
            <p:ph type="subTitle" idx="1"/>
          </p:nvPr>
        </p:nvSpPr>
        <p:spPr>
          <a:xfrm>
            <a:off x="685800" y="2686777"/>
            <a:ext cx="7772400" cy="398700"/>
          </a:xfrm>
          <a:prstGeom prst="rect">
            <a:avLst/>
          </a:prstGeom>
        </p:spPr>
        <p:txBody>
          <a:bodyPr spcFirstLastPara="1" wrap="square" lIns="0" tIns="0" rIns="0" bIns="0" anchor="t" anchorCtr="0">
            <a:noAutofit/>
          </a:bodyPr>
          <a:lstStyle/>
          <a:p>
            <a:pPr marL="0" lvl="0" indent="0" algn="l" rtl="0">
              <a:spcBef>
                <a:spcPts val="0"/>
              </a:spcBef>
              <a:spcAft>
                <a:spcPts val="600"/>
              </a:spcAft>
              <a:buNone/>
            </a:pPr>
            <a:r>
              <a:rPr lang="en"/>
              <a:t>Change your name on zoom to phonetic pronunciation or “sounds like” pronunciation tip</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55"/>
        <p:cNvGrpSpPr/>
        <p:nvPr/>
      </p:nvGrpSpPr>
      <p:grpSpPr>
        <a:xfrm>
          <a:off x="0" y="0"/>
          <a:ext cx="0" cy="0"/>
          <a:chOff x="0" y="0"/>
          <a:chExt cx="0" cy="0"/>
        </a:xfrm>
      </p:grpSpPr>
      <p:sp>
        <p:nvSpPr>
          <p:cNvPr id="356" name="Google Shape;356;p39"/>
          <p:cNvSpPr txBox="1">
            <a:spLocks noGrp="1"/>
          </p:cNvSpPr>
          <p:nvPr>
            <p:ph type="ctrTitle"/>
          </p:nvPr>
        </p:nvSpPr>
        <p:spPr>
          <a:xfrm>
            <a:off x="685800" y="1668151"/>
            <a:ext cx="7772400" cy="13116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Tools for Application to Healthcare</a:t>
            </a:r>
            <a:endParaRPr/>
          </a:p>
        </p:txBody>
      </p:sp>
      <p:sp>
        <p:nvSpPr>
          <p:cNvPr id="357" name="Google Shape;357;p39"/>
          <p:cNvSpPr txBox="1">
            <a:spLocks noGrp="1"/>
          </p:cNvSpPr>
          <p:nvPr>
            <p:ph type="subTitle" idx="1"/>
          </p:nvPr>
        </p:nvSpPr>
        <p:spPr>
          <a:xfrm>
            <a:off x="685800" y="3076652"/>
            <a:ext cx="7772400" cy="398700"/>
          </a:xfrm>
          <a:prstGeom prst="rect">
            <a:avLst/>
          </a:prstGeom>
        </p:spPr>
        <p:txBody>
          <a:bodyPr spcFirstLastPara="1" wrap="square" lIns="0" tIns="0" rIns="0" bIns="0" anchor="t" anchorCtr="0">
            <a:noAutofit/>
          </a:bodyPr>
          <a:lstStyle/>
          <a:p>
            <a:pPr marL="0" lvl="0" indent="0" algn="l" rtl="0">
              <a:spcBef>
                <a:spcPts val="0"/>
              </a:spcBef>
              <a:spcAft>
                <a:spcPts val="600"/>
              </a:spcAft>
              <a:buNone/>
            </a:pP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61"/>
        <p:cNvGrpSpPr/>
        <p:nvPr/>
      </p:nvGrpSpPr>
      <p:grpSpPr>
        <a:xfrm>
          <a:off x="0" y="0"/>
          <a:ext cx="0" cy="0"/>
          <a:chOff x="0" y="0"/>
          <a:chExt cx="0" cy="0"/>
        </a:xfrm>
      </p:grpSpPr>
      <p:sp>
        <p:nvSpPr>
          <p:cNvPr id="362" name="Google Shape;362;p40"/>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Clr>
                <a:schemeClr val="dk2"/>
              </a:buClr>
              <a:buSzPts val="1100"/>
              <a:buFont typeface="Arial"/>
              <a:buNone/>
            </a:pPr>
            <a:r>
              <a:rPr lang="en"/>
              <a:t>Application to Healthcare</a:t>
            </a:r>
            <a:endParaRPr/>
          </a:p>
          <a:p>
            <a:pPr marL="0" lvl="0" indent="0" algn="l" rtl="0">
              <a:spcBef>
                <a:spcPts val="0"/>
              </a:spcBef>
              <a:spcAft>
                <a:spcPts val="0"/>
              </a:spcAft>
              <a:buNone/>
            </a:pPr>
            <a:endParaRPr/>
          </a:p>
        </p:txBody>
      </p:sp>
      <p:sp>
        <p:nvSpPr>
          <p:cNvPr id="363" name="Google Shape;363;p40"/>
          <p:cNvSpPr txBox="1">
            <a:spLocks noGrp="1"/>
          </p:cNvSpPr>
          <p:nvPr>
            <p:ph type="body" idx="1"/>
          </p:nvPr>
        </p:nvSpPr>
        <p:spPr>
          <a:xfrm>
            <a:off x="855300" y="1168200"/>
            <a:ext cx="7303800" cy="3741000"/>
          </a:xfrm>
          <a:prstGeom prst="rect">
            <a:avLst/>
          </a:prstGeom>
        </p:spPr>
        <p:txBody>
          <a:bodyPr spcFirstLastPara="1" wrap="square" lIns="0" tIns="0" rIns="0" bIns="0" anchor="t" anchorCtr="0">
            <a:noAutofit/>
          </a:bodyPr>
          <a:lstStyle/>
          <a:p>
            <a:pPr marL="457200" lvl="0" indent="-355600" algn="l" rtl="0">
              <a:spcBef>
                <a:spcPts val="0"/>
              </a:spcBef>
              <a:spcAft>
                <a:spcPts val="0"/>
              </a:spcAft>
              <a:buSzPts val="2000"/>
              <a:buFont typeface="Montserrat"/>
              <a:buChar char="●"/>
            </a:pPr>
            <a:r>
              <a:rPr lang="en" sz="2000" b="1">
                <a:latin typeface="Montserrat"/>
                <a:ea typeface="Montserrat"/>
                <a:cs typeface="Montserrat"/>
                <a:sym typeface="Montserrat"/>
              </a:rPr>
              <a:t>Ask how people prefer to be addressed! </a:t>
            </a:r>
            <a:endParaRPr sz="2000" b="1">
              <a:latin typeface="Montserrat"/>
              <a:ea typeface="Montserrat"/>
              <a:cs typeface="Montserrat"/>
              <a:sym typeface="Montserrat"/>
            </a:endParaRPr>
          </a:p>
          <a:p>
            <a:pPr marL="914400" lvl="1" indent="-355600" algn="l" rtl="0">
              <a:spcBef>
                <a:spcPts val="1000"/>
              </a:spcBef>
              <a:spcAft>
                <a:spcPts val="0"/>
              </a:spcAft>
              <a:buSzPts val="2000"/>
              <a:buFont typeface="Montserrat"/>
              <a:buChar char="○"/>
            </a:pPr>
            <a:r>
              <a:rPr lang="en" sz="1800"/>
              <a:t>Ask patients and family how they prefer to be addressed (e.g., “Mrs. Wang instead of “Mom”) </a:t>
            </a:r>
            <a:endParaRPr sz="1800"/>
          </a:p>
          <a:p>
            <a:pPr marL="914400" lvl="1" indent="-355600" algn="l" rtl="0">
              <a:spcBef>
                <a:spcPts val="1000"/>
              </a:spcBef>
              <a:spcAft>
                <a:spcPts val="1000"/>
              </a:spcAft>
              <a:buSzPts val="2000"/>
              <a:buFont typeface="Montserrat"/>
              <a:buChar char="○"/>
            </a:pPr>
            <a:r>
              <a:rPr lang="en" sz="1800"/>
              <a:t>Ask colleagues how they prefer to be addressed in various contexts (with the clinical team AND with patients)</a:t>
            </a:r>
            <a:endParaRPr sz="2150">
              <a:solidFill>
                <a:srgbClr val="333333"/>
              </a:solidFill>
              <a:highlight>
                <a:srgbClr val="FFFFFF"/>
              </a:highlight>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67"/>
        <p:cNvGrpSpPr/>
        <p:nvPr/>
      </p:nvGrpSpPr>
      <p:grpSpPr>
        <a:xfrm>
          <a:off x="0" y="0"/>
          <a:ext cx="0" cy="0"/>
          <a:chOff x="0" y="0"/>
          <a:chExt cx="0" cy="0"/>
        </a:xfrm>
      </p:grpSpPr>
      <p:sp>
        <p:nvSpPr>
          <p:cNvPr id="368" name="Google Shape;368;p41"/>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Clr>
                <a:schemeClr val="dk2"/>
              </a:buClr>
              <a:buSzPts val="1100"/>
              <a:buFont typeface="Arial"/>
              <a:buNone/>
            </a:pPr>
            <a:r>
              <a:rPr lang="en"/>
              <a:t>Application to Healthcare</a:t>
            </a:r>
            <a:endParaRPr/>
          </a:p>
          <a:p>
            <a:pPr marL="0" lvl="0" indent="0" algn="l" rtl="0">
              <a:spcBef>
                <a:spcPts val="0"/>
              </a:spcBef>
              <a:spcAft>
                <a:spcPts val="0"/>
              </a:spcAft>
              <a:buNone/>
            </a:pPr>
            <a:endParaRPr/>
          </a:p>
        </p:txBody>
      </p:sp>
      <p:sp>
        <p:nvSpPr>
          <p:cNvPr id="369" name="Google Shape;369;p41"/>
          <p:cNvSpPr txBox="1">
            <a:spLocks noGrp="1"/>
          </p:cNvSpPr>
          <p:nvPr>
            <p:ph type="body" idx="1"/>
          </p:nvPr>
        </p:nvSpPr>
        <p:spPr>
          <a:xfrm>
            <a:off x="855300" y="1102325"/>
            <a:ext cx="7941000" cy="3741000"/>
          </a:xfrm>
          <a:prstGeom prst="rect">
            <a:avLst/>
          </a:prstGeom>
        </p:spPr>
        <p:txBody>
          <a:bodyPr spcFirstLastPara="1" wrap="square" lIns="0" tIns="0" rIns="0" bIns="0" anchor="t" anchorCtr="0">
            <a:noAutofit/>
          </a:bodyPr>
          <a:lstStyle/>
          <a:p>
            <a:pPr marL="457200" lvl="0" indent="-358775" algn="l" rtl="0">
              <a:spcBef>
                <a:spcPts val="0"/>
              </a:spcBef>
              <a:spcAft>
                <a:spcPts val="0"/>
              </a:spcAft>
              <a:buSzPts val="2050"/>
              <a:buFont typeface="Montserrat"/>
              <a:buChar char="●"/>
            </a:pPr>
            <a:r>
              <a:rPr lang="en" sz="2050" b="1" dirty="0">
                <a:solidFill>
                  <a:srgbClr val="333333"/>
                </a:solidFill>
                <a:highlight>
                  <a:srgbClr val="FFFFFF"/>
                </a:highlight>
                <a:latin typeface="Montserrat"/>
                <a:ea typeface="Montserrat"/>
                <a:cs typeface="Montserrat"/>
                <a:sym typeface="Montserrat"/>
              </a:rPr>
              <a:t>Patient-Facing Tips</a:t>
            </a:r>
            <a:endParaRPr sz="2050" b="1" dirty="0">
              <a:solidFill>
                <a:srgbClr val="333333"/>
              </a:solidFill>
              <a:highlight>
                <a:srgbClr val="FFFFFF"/>
              </a:highlight>
              <a:latin typeface="Montserrat"/>
              <a:ea typeface="Montserrat"/>
              <a:cs typeface="Montserrat"/>
              <a:sym typeface="Montserrat"/>
            </a:endParaRPr>
          </a:p>
          <a:p>
            <a:pPr marL="914400" lvl="1" indent="-358775" algn="l" rtl="0">
              <a:spcBef>
                <a:spcPts val="0"/>
              </a:spcBef>
              <a:spcAft>
                <a:spcPts val="0"/>
              </a:spcAft>
              <a:buSzPts val="2050"/>
              <a:buFont typeface="Montserrat"/>
              <a:buChar char="○"/>
            </a:pPr>
            <a:r>
              <a:rPr lang="en" sz="1800" dirty="0">
                <a:solidFill>
                  <a:srgbClr val="333333"/>
                </a:solidFill>
                <a:highlight>
                  <a:srgbClr val="FFFFFF"/>
                </a:highlight>
              </a:rPr>
              <a:t>When in doubt, go formal: “Mr. Smith, it’s nice to meet you” </a:t>
            </a:r>
            <a:endParaRPr sz="1800" dirty="0">
              <a:solidFill>
                <a:srgbClr val="333333"/>
              </a:solidFill>
              <a:highlight>
                <a:srgbClr val="FFFFFF"/>
              </a:highlight>
            </a:endParaRPr>
          </a:p>
          <a:p>
            <a:pPr marL="914400" lvl="1" indent="-358775" algn="l" rtl="0">
              <a:spcBef>
                <a:spcPts val="0"/>
              </a:spcBef>
              <a:spcAft>
                <a:spcPts val="0"/>
              </a:spcAft>
              <a:buSzPts val="2050"/>
              <a:buFont typeface="Montserrat"/>
              <a:buChar char="○"/>
            </a:pPr>
            <a:r>
              <a:rPr lang="en" sz="1800" dirty="0">
                <a:solidFill>
                  <a:srgbClr val="333333"/>
                </a:solidFill>
                <a:highlight>
                  <a:srgbClr val="FFFFFF"/>
                </a:highlight>
              </a:rPr>
              <a:t>Check Titles: Carefully check to see if the patient has a title based on factors such as degree (e.g., </a:t>
            </a:r>
            <a:r>
              <a:rPr lang="en" sz="1800" dirty="0" err="1">
                <a:solidFill>
                  <a:srgbClr val="333333"/>
                </a:solidFill>
                <a:highlight>
                  <a:srgbClr val="FFFFFF"/>
                </a:highlight>
              </a:rPr>
              <a:t>Ph.D</a:t>
            </a:r>
            <a:r>
              <a:rPr lang="en" sz="1800" dirty="0">
                <a:solidFill>
                  <a:srgbClr val="333333"/>
                </a:solidFill>
                <a:highlight>
                  <a:srgbClr val="FFFFFF"/>
                </a:highlight>
              </a:rPr>
              <a:t> = “Dr”) or religious affiliation (e.g., “Sister”)</a:t>
            </a:r>
            <a:endParaRPr lang="en-US" sz="1800" dirty="0">
              <a:solidFill>
                <a:srgbClr val="333333"/>
              </a:solidFill>
              <a:highlight>
                <a:srgbClr val="FFFFFF"/>
              </a:highlight>
            </a:endParaRPr>
          </a:p>
          <a:p>
            <a:pPr marL="457200" lvl="0" indent="0" algn="l" rtl="0">
              <a:spcBef>
                <a:spcPts val="600"/>
              </a:spcBef>
              <a:spcAft>
                <a:spcPts val="0"/>
              </a:spcAft>
              <a:buNone/>
            </a:pPr>
            <a:endParaRPr lang="en-US" sz="1800" dirty="0">
              <a:solidFill>
                <a:srgbClr val="333333"/>
              </a:solidFill>
              <a:highlight>
                <a:srgbClr val="FFFFFF"/>
              </a:highlight>
            </a:endParaRPr>
          </a:p>
          <a:p>
            <a:pPr marL="457200" lvl="0" indent="-358775" algn="l" rtl="0">
              <a:spcBef>
                <a:spcPts val="600"/>
              </a:spcBef>
              <a:spcAft>
                <a:spcPts val="0"/>
              </a:spcAft>
              <a:buSzPts val="2050"/>
              <a:buFont typeface="Montserrat"/>
              <a:buChar char="●"/>
            </a:pPr>
            <a:r>
              <a:rPr lang="en" sz="2050" b="1" dirty="0">
                <a:solidFill>
                  <a:srgbClr val="333333"/>
                </a:solidFill>
                <a:highlight>
                  <a:srgbClr val="FFFFFF"/>
                </a:highlight>
                <a:latin typeface="Montserrat"/>
                <a:ea typeface="Montserrat"/>
                <a:cs typeface="Montserrat"/>
                <a:sym typeface="Montserrat"/>
              </a:rPr>
              <a:t>Electronic Medical Record Tips </a:t>
            </a:r>
            <a:endParaRPr sz="2050" b="1" dirty="0">
              <a:solidFill>
                <a:srgbClr val="333333"/>
              </a:solidFill>
              <a:highlight>
                <a:srgbClr val="FFFFFF"/>
              </a:highlight>
              <a:latin typeface="Montserrat"/>
              <a:ea typeface="Montserrat"/>
              <a:cs typeface="Montserrat"/>
              <a:sym typeface="Montserrat"/>
            </a:endParaRPr>
          </a:p>
          <a:p>
            <a:pPr marL="914400" lvl="1" indent="-358775" algn="l" rtl="0">
              <a:spcBef>
                <a:spcPts val="0"/>
              </a:spcBef>
              <a:spcAft>
                <a:spcPts val="0"/>
              </a:spcAft>
              <a:buSzPts val="2050"/>
              <a:buFont typeface="Montserrat"/>
              <a:buChar char="○"/>
            </a:pPr>
            <a:r>
              <a:rPr lang="en" sz="1800" dirty="0">
                <a:solidFill>
                  <a:srgbClr val="333333"/>
                </a:solidFill>
                <a:highlight>
                  <a:srgbClr val="FFFFFF"/>
                </a:highlight>
              </a:rPr>
              <a:t>Use “nicknames” in the electronic medical record </a:t>
            </a:r>
            <a:endParaRPr sz="1800" dirty="0">
              <a:solidFill>
                <a:srgbClr val="333333"/>
              </a:solidFill>
              <a:highlight>
                <a:srgbClr val="FFFFFF"/>
              </a:highlight>
            </a:endParaRPr>
          </a:p>
          <a:p>
            <a:pPr marL="914400" lvl="1" indent="-358775" algn="l" rtl="0">
              <a:spcBef>
                <a:spcPts val="0"/>
              </a:spcBef>
              <a:spcAft>
                <a:spcPts val="0"/>
              </a:spcAft>
              <a:buSzPts val="2050"/>
              <a:buFont typeface="Montserrat"/>
              <a:buChar char="○"/>
            </a:pPr>
            <a:r>
              <a:rPr lang="en" sz="1800" dirty="0">
                <a:solidFill>
                  <a:srgbClr val="333333"/>
                </a:solidFill>
                <a:highlight>
                  <a:srgbClr val="FFFFFF"/>
                </a:highlight>
              </a:rPr>
              <a:t>Use the social history to document stories around a patient’s name</a:t>
            </a:r>
            <a:endParaRPr sz="1800" dirty="0">
              <a:solidFill>
                <a:srgbClr val="333333"/>
              </a:solidFill>
              <a:highlight>
                <a:srgbClr val="FFFFFF"/>
              </a:highlight>
            </a:endParaRPr>
          </a:p>
          <a:p>
            <a:pPr marL="914400" lvl="1" indent="-358775" algn="l" rtl="0">
              <a:spcBef>
                <a:spcPts val="0"/>
              </a:spcBef>
              <a:spcAft>
                <a:spcPts val="0"/>
              </a:spcAft>
              <a:buSzPts val="2050"/>
              <a:buFont typeface="Montserrat"/>
              <a:buChar char="○"/>
            </a:pPr>
            <a:r>
              <a:rPr lang="en" sz="1800" dirty="0">
                <a:solidFill>
                  <a:srgbClr val="333333"/>
                </a:solidFill>
                <a:highlight>
                  <a:srgbClr val="FFFFFF"/>
                </a:highlight>
              </a:rPr>
              <a:t>Write in the note the phonetic spelling</a:t>
            </a:r>
            <a:endParaRPr sz="1800" dirty="0">
              <a:solidFill>
                <a:srgbClr val="333333"/>
              </a:solidFill>
              <a:highlight>
                <a:srgbClr val="FFFFFF"/>
              </a:highlight>
            </a:endParaRPr>
          </a:p>
          <a:p>
            <a:pPr marL="1371600" lvl="1" indent="-342900" algn="l" rtl="0">
              <a:spcBef>
                <a:spcPts val="0"/>
              </a:spcBef>
              <a:spcAft>
                <a:spcPts val="0"/>
              </a:spcAft>
              <a:buSzPts val="1800"/>
              <a:buChar char="○"/>
            </a:pPr>
            <a:r>
              <a:rPr lang="en" sz="1800" dirty="0">
                <a:solidFill>
                  <a:srgbClr val="333333"/>
                </a:solidFill>
                <a:highlight>
                  <a:schemeClr val="lt1"/>
                </a:highlight>
              </a:rPr>
              <a:t>E.g., “Mr. Juarez (HWA-</a:t>
            </a:r>
            <a:r>
              <a:rPr lang="en" sz="1800" dirty="0" err="1">
                <a:solidFill>
                  <a:srgbClr val="333333"/>
                </a:solidFill>
                <a:highlight>
                  <a:schemeClr val="lt1"/>
                </a:highlight>
              </a:rPr>
              <a:t>rez</a:t>
            </a:r>
            <a:r>
              <a:rPr lang="en" sz="1800" dirty="0">
                <a:solidFill>
                  <a:srgbClr val="333333"/>
                </a:solidFill>
                <a:highlight>
                  <a:schemeClr val="lt1"/>
                </a:highlight>
              </a:rPr>
              <a:t>) is a 28 year old man</a:t>
            </a:r>
            <a:r>
              <a:rPr lang="en" sz="1800" dirty="0"/>
              <a:t>.” </a:t>
            </a:r>
            <a:endParaRPr sz="1800" dirty="0">
              <a:solidFill>
                <a:srgbClr val="333333"/>
              </a:solidFill>
              <a:highlight>
                <a:srgbClr val="FFFFFF"/>
              </a:highlight>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6"/>
        <p:cNvGrpSpPr/>
        <p:nvPr/>
      </p:nvGrpSpPr>
      <p:grpSpPr>
        <a:xfrm>
          <a:off x="0" y="0"/>
          <a:ext cx="0" cy="0"/>
          <a:chOff x="0" y="0"/>
          <a:chExt cx="0" cy="0"/>
        </a:xfrm>
      </p:grpSpPr>
      <p:sp>
        <p:nvSpPr>
          <p:cNvPr id="127" name="Google Shape;127;p14"/>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dirty="0"/>
              <a:t>Learning Objectives </a:t>
            </a:r>
            <a:endParaRPr dirty="0"/>
          </a:p>
        </p:txBody>
      </p:sp>
      <p:sp>
        <p:nvSpPr>
          <p:cNvPr id="128" name="Google Shape;128;p14"/>
          <p:cNvSpPr txBox="1">
            <a:spLocks noGrp="1"/>
          </p:cNvSpPr>
          <p:nvPr>
            <p:ph type="body" idx="1"/>
          </p:nvPr>
        </p:nvSpPr>
        <p:spPr>
          <a:xfrm>
            <a:off x="855300" y="1277751"/>
            <a:ext cx="7433400" cy="3656100"/>
          </a:xfrm>
          <a:prstGeom prst="rect">
            <a:avLst/>
          </a:prstGeom>
        </p:spPr>
        <p:txBody>
          <a:bodyPr spcFirstLastPara="1" wrap="square" lIns="0" tIns="0" rIns="0" bIns="0" anchor="t" anchorCtr="0">
            <a:noAutofit/>
          </a:bodyPr>
          <a:lstStyle/>
          <a:p>
            <a:pPr marL="457200" lvl="0" indent="-361950" algn="l" rtl="0">
              <a:lnSpc>
                <a:spcPct val="115000"/>
              </a:lnSpc>
              <a:spcBef>
                <a:spcPts val="1000"/>
              </a:spcBef>
              <a:spcAft>
                <a:spcPts val="0"/>
              </a:spcAft>
              <a:buSzPts val="2100"/>
              <a:buChar char="●"/>
            </a:pPr>
            <a:r>
              <a:rPr lang="en" sz="2100" b="1" dirty="0">
                <a:solidFill>
                  <a:srgbClr val="000000"/>
                </a:solidFill>
                <a:latin typeface="Montserrat"/>
                <a:ea typeface="Montserrat"/>
                <a:cs typeface="Montserrat"/>
                <a:sym typeface="Montserrat"/>
              </a:rPr>
              <a:t>Examine </a:t>
            </a:r>
            <a:r>
              <a:rPr lang="en" sz="2100" dirty="0">
                <a:solidFill>
                  <a:srgbClr val="000000"/>
                </a:solidFill>
                <a:latin typeface="Montserrat"/>
                <a:ea typeface="Montserrat"/>
                <a:cs typeface="Montserrat"/>
                <a:sym typeface="Montserrat"/>
              </a:rPr>
              <a:t>the importance of name pronunciation in identity affirmation</a:t>
            </a:r>
            <a:endParaRPr sz="2100" dirty="0"/>
          </a:p>
          <a:p>
            <a:pPr marL="457200" lvl="0" indent="-361950" algn="l" rtl="0">
              <a:lnSpc>
                <a:spcPct val="115000"/>
              </a:lnSpc>
              <a:spcBef>
                <a:spcPts val="1000"/>
              </a:spcBef>
              <a:spcAft>
                <a:spcPts val="0"/>
              </a:spcAft>
              <a:buSzPts val="2100"/>
              <a:buChar char="●"/>
            </a:pPr>
            <a:r>
              <a:rPr lang="en" sz="2100" b="1" dirty="0">
                <a:solidFill>
                  <a:srgbClr val="000000"/>
                </a:solidFill>
                <a:latin typeface="Montserrat"/>
                <a:ea typeface="Montserrat"/>
                <a:cs typeface="Montserrat"/>
                <a:sym typeface="Montserrat"/>
              </a:rPr>
              <a:t>Illustrate </a:t>
            </a:r>
            <a:r>
              <a:rPr lang="en" sz="2100" dirty="0">
                <a:solidFill>
                  <a:srgbClr val="000000"/>
                </a:solidFill>
                <a:latin typeface="Montserrat"/>
                <a:ea typeface="Montserrat"/>
                <a:cs typeface="Montserrat"/>
                <a:sym typeface="Montserrat"/>
              </a:rPr>
              <a:t>the historical instances of racism that contribute to name mispronunciation</a:t>
            </a:r>
            <a:endParaRPr sz="2100" dirty="0">
              <a:solidFill>
                <a:srgbClr val="000000"/>
              </a:solidFill>
              <a:latin typeface="Montserrat"/>
              <a:ea typeface="Montserrat"/>
              <a:cs typeface="Montserrat"/>
              <a:sym typeface="Montserrat"/>
            </a:endParaRPr>
          </a:p>
          <a:p>
            <a:pPr marL="457200" lvl="0" indent="-361950" algn="l" rtl="0">
              <a:lnSpc>
                <a:spcPct val="115000"/>
              </a:lnSpc>
              <a:spcBef>
                <a:spcPts val="1000"/>
              </a:spcBef>
              <a:spcAft>
                <a:spcPts val="0"/>
              </a:spcAft>
              <a:buSzPts val="2100"/>
              <a:buChar char="●"/>
            </a:pPr>
            <a:r>
              <a:rPr lang="en" sz="2100" b="1" dirty="0">
                <a:solidFill>
                  <a:srgbClr val="000000"/>
                </a:solidFill>
                <a:latin typeface="Montserrat"/>
                <a:ea typeface="Montserrat"/>
                <a:cs typeface="Montserrat"/>
                <a:sym typeface="Montserrat"/>
              </a:rPr>
              <a:t>Employ </a:t>
            </a:r>
            <a:r>
              <a:rPr lang="en" sz="2100" dirty="0">
                <a:solidFill>
                  <a:srgbClr val="000000"/>
                </a:solidFill>
                <a:latin typeface="Montserrat"/>
                <a:ea typeface="Montserrat"/>
                <a:cs typeface="Montserrat"/>
                <a:sym typeface="Montserrat"/>
              </a:rPr>
              <a:t>tools to engage in productive conversation around name pronunciation</a:t>
            </a:r>
            <a:endParaRPr sz="2100" b="1" dirty="0">
              <a:solidFill>
                <a:srgbClr val="000000"/>
              </a:solidFill>
              <a:latin typeface="Montserrat"/>
              <a:ea typeface="Montserrat"/>
              <a:cs typeface="Montserrat"/>
              <a:sym typeface="Montserrat"/>
            </a:endParaRPr>
          </a:p>
          <a:p>
            <a:pPr marL="457200" lvl="0" indent="-361950" algn="l" rtl="0">
              <a:lnSpc>
                <a:spcPct val="115000"/>
              </a:lnSpc>
              <a:spcBef>
                <a:spcPts val="1000"/>
              </a:spcBef>
              <a:spcAft>
                <a:spcPts val="0"/>
              </a:spcAft>
              <a:buSzPts val="2100"/>
              <a:buChar char="●"/>
            </a:pPr>
            <a:r>
              <a:rPr lang="en" sz="2100" b="1" dirty="0">
                <a:solidFill>
                  <a:srgbClr val="000000"/>
                </a:solidFill>
                <a:latin typeface="Montserrat"/>
                <a:ea typeface="Montserrat"/>
                <a:cs typeface="Montserrat"/>
                <a:sym typeface="Montserrat"/>
              </a:rPr>
              <a:t>Apply </a:t>
            </a:r>
            <a:r>
              <a:rPr lang="en" sz="2100" dirty="0">
                <a:solidFill>
                  <a:srgbClr val="000000"/>
                </a:solidFill>
                <a:latin typeface="Montserrat"/>
                <a:ea typeface="Montserrat"/>
                <a:cs typeface="Montserrat"/>
                <a:sym typeface="Montserrat"/>
              </a:rPr>
              <a:t>name affirmation tools to case scenarios in a clinical and medical education setting </a:t>
            </a:r>
            <a:endParaRPr sz="2100" dirty="0">
              <a:solidFill>
                <a:srgbClr val="000000"/>
              </a:solidFill>
              <a:latin typeface="Montserrat"/>
              <a:ea typeface="Montserrat"/>
              <a:cs typeface="Montserrat"/>
              <a:sym typeface="Montserrat"/>
            </a:endParaRPr>
          </a:p>
          <a:p>
            <a:pPr marL="457200" lvl="0" indent="0" algn="l" rtl="0">
              <a:lnSpc>
                <a:spcPct val="115000"/>
              </a:lnSpc>
              <a:spcBef>
                <a:spcPts val="100"/>
              </a:spcBef>
              <a:spcAft>
                <a:spcPts val="0"/>
              </a:spcAft>
              <a:buNone/>
            </a:pPr>
            <a:endParaRPr sz="1800" dirty="0">
              <a:solidFill>
                <a:srgbClr val="000000"/>
              </a:solidFill>
              <a:latin typeface="Playfair Display"/>
              <a:ea typeface="Playfair Display"/>
              <a:cs typeface="Playfair Display"/>
              <a:sym typeface="Playfair Display"/>
            </a:endParaRPr>
          </a:p>
          <a:p>
            <a:pPr marL="0" lvl="0" indent="0" algn="l" rtl="0">
              <a:spcBef>
                <a:spcPts val="1200"/>
              </a:spcBef>
              <a:spcAft>
                <a:spcPts val="600"/>
              </a:spcAft>
              <a:buNone/>
            </a:pPr>
            <a:r>
              <a:rPr lang="en" dirty="0"/>
              <a:t> </a:t>
            </a:r>
            <a:endParaRPr dirty="0"/>
          </a:p>
        </p:txBody>
      </p:sp>
      <p:sp>
        <p:nvSpPr>
          <p:cNvPr id="129" name="Google Shape;129;p14"/>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3</a:t>
            </a:fld>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73"/>
        <p:cNvGrpSpPr/>
        <p:nvPr/>
      </p:nvGrpSpPr>
      <p:grpSpPr>
        <a:xfrm>
          <a:off x="0" y="0"/>
          <a:ext cx="0" cy="0"/>
          <a:chOff x="0" y="0"/>
          <a:chExt cx="0" cy="0"/>
        </a:xfrm>
      </p:grpSpPr>
      <p:sp>
        <p:nvSpPr>
          <p:cNvPr id="374" name="Google Shape;374;p42"/>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Application to Healthcare</a:t>
            </a:r>
            <a:endParaRPr/>
          </a:p>
        </p:txBody>
      </p:sp>
      <p:sp>
        <p:nvSpPr>
          <p:cNvPr id="375" name="Google Shape;375;p42"/>
          <p:cNvSpPr txBox="1">
            <a:spLocks noGrp="1"/>
          </p:cNvSpPr>
          <p:nvPr>
            <p:ph type="body" idx="1"/>
          </p:nvPr>
        </p:nvSpPr>
        <p:spPr>
          <a:xfrm>
            <a:off x="855300" y="1430147"/>
            <a:ext cx="7433400" cy="3033900"/>
          </a:xfrm>
          <a:prstGeom prst="rect">
            <a:avLst/>
          </a:prstGeom>
        </p:spPr>
        <p:txBody>
          <a:bodyPr spcFirstLastPara="1" wrap="square" lIns="0" tIns="0" rIns="0" bIns="0" anchor="t" anchorCtr="0">
            <a:noAutofit/>
          </a:bodyPr>
          <a:lstStyle/>
          <a:p>
            <a:pPr marL="457200" lvl="0" indent="-358775" algn="l" rtl="0">
              <a:lnSpc>
                <a:spcPct val="100000"/>
              </a:lnSpc>
              <a:spcBef>
                <a:spcPts val="1200"/>
              </a:spcBef>
              <a:spcAft>
                <a:spcPts val="0"/>
              </a:spcAft>
              <a:buSzPts val="2050"/>
              <a:buFont typeface="Montserrat"/>
              <a:buChar char="●"/>
            </a:pPr>
            <a:r>
              <a:rPr lang="en" sz="2050" b="1">
                <a:latin typeface="Montserrat"/>
                <a:ea typeface="Montserrat"/>
                <a:cs typeface="Montserrat"/>
                <a:sym typeface="Montserrat"/>
              </a:rPr>
              <a:t>Healthcare System Facing Tips</a:t>
            </a:r>
            <a:endParaRPr sz="2050" b="1">
              <a:latin typeface="Montserrat"/>
              <a:ea typeface="Montserrat"/>
              <a:cs typeface="Montserrat"/>
              <a:sym typeface="Montserrat"/>
            </a:endParaRPr>
          </a:p>
          <a:p>
            <a:pPr marL="914400" lvl="1" indent="-358775" algn="l" rtl="0">
              <a:lnSpc>
                <a:spcPct val="100000"/>
              </a:lnSpc>
              <a:spcBef>
                <a:spcPts val="1000"/>
              </a:spcBef>
              <a:spcAft>
                <a:spcPts val="0"/>
              </a:spcAft>
              <a:buSzPts val="2050"/>
              <a:buFont typeface="Montserrat"/>
              <a:buChar char="○"/>
            </a:pPr>
            <a:r>
              <a:rPr lang="en" sz="1850"/>
              <a:t>Clinicians can have name badges with phonetic spelling</a:t>
            </a:r>
            <a:endParaRPr sz="1850"/>
          </a:p>
          <a:p>
            <a:pPr marL="914400" lvl="1" indent="-358775" algn="l" rtl="0">
              <a:lnSpc>
                <a:spcPct val="100000"/>
              </a:lnSpc>
              <a:spcBef>
                <a:spcPts val="1200"/>
              </a:spcBef>
              <a:spcAft>
                <a:spcPts val="1000"/>
              </a:spcAft>
              <a:buSzPts val="2050"/>
              <a:buFont typeface="Montserrat"/>
              <a:buChar char="○"/>
            </a:pPr>
            <a:r>
              <a:rPr lang="en" sz="1850"/>
              <a:t>Promote each other by calling a fellow physician by formal titles, e.g., “Dr. Garcia” </a:t>
            </a:r>
            <a:endParaRPr sz="185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79"/>
        <p:cNvGrpSpPr/>
        <p:nvPr/>
      </p:nvGrpSpPr>
      <p:grpSpPr>
        <a:xfrm>
          <a:off x="0" y="0"/>
          <a:ext cx="0" cy="0"/>
          <a:chOff x="0" y="0"/>
          <a:chExt cx="0" cy="0"/>
        </a:xfrm>
      </p:grpSpPr>
      <p:sp>
        <p:nvSpPr>
          <p:cNvPr id="380" name="Google Shape;380;p43"/>
          <p:cNvSpPr txBox="1">
            <a:spLocks noGrp="1"/>
          </p:cNvSpPr>
          <p:nvPr>
            <p:ph type="ctrTitle"/>
          </p:nvPr>
        </p:nvSpPr>
        <p:spPr>
          <a:xfrm>
            <a:off x="685800" y="1668151"/>
            <a:ext cx="7772400" cy="13116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solidFill>
                  <a:schemeClr val="accent1"/>
                </a:solidFill>
              </a:rPr>
              <a:t>2.</a:t>
            </a:r>
            <a:endParaRPr>
              <a:solidFill>
                <a:schemeClr val="accent1"/>
              </a:solidFill>
            </a:endParaRPr>
          </a:p>
          <a:p>
            <a:pPr marL="0" lvl="0" indent="0" algn="l" rtl="0">
              <a:spcBef>
                <a:spcPts val="0"/>
              </a:spcBef>
              <a:spcAft>
                <a:spcPts val="0"/>
              </a:spcAft>
              <a:buNone/>
            </a:pPr>
            <a:r>
              <a:rPr lang="en"/>
              <a:t>Breakout room </a:t>
            </a:r>
            <a:endParaRPr/>
          </a:p>
        </p:txBody>
      </p:sp>
      <p:sp>
        <p:nvSpPr>
          <p:cNvPr id="381" name="Google Shape;381;p43"/>
          <p:cNvSpPr txBox="1">
            <a:spLocks noGrp="1"/>
          </p:cNvSpPr>
          <p:nvPr>
            <p:ph type="subTitle" idx="1"/>
          </p:nvPr>
        </p:nvSpPr>
        <p:spPr>
          <a:xfrm>
            <a:off x="685800" y="3076652"/>
            <a:ext cx="7772400" cy="398700"/>
          </a:xfrm>
          <a:prstGeom prst="rect">
            <a:avLst/>
          </a:prstGeom>
        </p:spPr>
        <p:txBody>
          <a:bodyPr spcFirstLastPara="1" wrap="square" lIns="0" tIns="0" rIns="0" bIns="0" anchor="t" anchorCtr="0">
            <a:noAutofit/>
          </a:bodyPr>
          <a:lstStyle/>
          <a:p>
            <a:pPr marL="0" lvl="0" indent="0" algn="l" rtl="0">
              <a:spcBef>
                <a:spcPts val="0"/>
              </a:spcBef>
              <a:spcAft>
                <a:spcPts val="0"/>
              </a:spcAft>
              <a:buNone/>
            </a:pPr>
            <a:endParaRPr/>
          </a:p>
          <a:p>
            <a:pPr marL="0" lvl="0" indent="0" algn="l" rtl="0">
              <a:spcBef>
                <a:spcPts val="600"/>
              </a:spcBef>
              <a:spcAft>
                <a:spcPts val="600"/>
              </a:spcAft>
              <a:buNone/>
            </a:pPr>
            <a:endParaRPr sz="1800" i="1"/>
          </a:p>
        </p:txBody>
      </p:sp>
      <p:sp>
        <p:nvSpPr>
          <p:cNvPr id="382" name="Google Shape;382;p43"/>
          <p:cNvSpPr txBox="1"/>
          <p:nvPr/>
        </p:nvSpPr>
        <p:spPr>
          <a:xfrm>
            <a:off x="1318225" y="3572250"/>
            <a:ext cx="7772400" cy="9234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600"/>
              </a:spcAft>
              <a:buNone/>
            </a:pPr>
            <a:r>
              <a:rPr lang="en" sz="2400">
                <a:solidFill>
                  <a:schemeClr val="dk1"/>
                </a:solidFill>
                <a:latin typeface="Montserrat Light"/>
                <a:ea typeface="Montserrat Light"/>
                <a:cs typeface="Montserrat Light"/>
                <a:sym typeface="Montserrat Light"/>
              </a:rPr>
              <a:t>Case-based discussion of how to apply these concepts and tools to real-life scenarios. </a:t>
            </a:r>
            <a:endParaRPr>
              <a:solidFill>
                <a:schemeClr val="dk1"/>
              </a:solidFill>
              <a:latin typeface="Montserrat Light"/>
              <a:ea typeface="Montserrat Light"/>
              <a:cs typeface="Montserrat Light"/>
              <a:sym typeface="Montserrat Light"/>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44"/>
          <p:cNvSpPr txBox="1">
            <a:spLocks noGrp="1"/>
          </p:cNvSpPr>
          <p:nvPr>
            <p:ph type="title"/>
          </p:nvPr>
        </p:nvSpPr>
        <p:spPr>
          <a:xfrm>
            <a:off x="855300" y="836000"/>
            <a:ext cx="8167800" cy="396300"/>
          </a:xfrm>
          <a:prstGeom prst="rect">
            <a:avLst/>
          </a:prstGeom>
          <a:ln w="9525" cap="flat" cmpd="sng">
            <a:solidFill>
              <a:schemeClr val="lt1"/>
            </a:solidFill>
            <a:prstDash val="solid"/>
            <a:round/>
            <a:headEnd type="none" w="sm" len="sm"/>
            <a:tailEnd type="none" w="sm" len="sm"/>
          </a:ln>
        </p:spPr>
        <p:txBody>
          <a:bodyPr spcFirstLastPara="1" wrap="square" lIns="0" tIns="0" rIns="0" bIns="0" anchor="b" anchorCtr="0">
            <a:noAutofit/>
          </a:bodyPr>
          <a:lstStyle/>
          <a:p>
            <a:pPr marL="0" lvl="0" indent="0" algn="l" rtl="0">
              <a:spcBef>
                <a:spcPts val="0"/>
              </a:spcBef>
              <a:spcAft>
                <a:spcPts val="0"/>
              </a:spcAft>
              <a:buClr>
                <a:schemeClr val="dk2"/>
              </a:buClr>
              <a:buSzPts val="1100"/>
              <a:buFont typeface="Arial"/>
              <a:buNone/>
            </a:pPr>
            <a:r>
              <a:rPr lang="en"/>
              <a:t>Case #1 </a:t>
            </a:r>
            <a:r>
              <a:rPr lang="en" b="0"/>
              <a:t>Resident/Intern/Patient </a:t>
            </a:r>
            <a:endParaRPr/>
          </a:p>
        </p:txBody>
      </p:sp>
      <p:sp>
        <p:nvSpPr>
          <p:cNvPr id="388" name="Google Shape;388;p44"/>
          <p:cNvSpPr txBox="1">
            <a:spLocks noGrp="1"/>
          </p:cNvSpPr>
          <p:nvPr>
            <p:ph type="body" idx="1"/>
          </p:nvPr>
        </p:nvSpPr>
        <p:spPr>
          <a:xfrm>
            <a:off x="855300" y="1430151"/>
            <a:ext cx="7433400" cy="37134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sz="2200"/>
              <a:t>Dr. Miller (resident): Hello Ms. Jones, I’m Dr. Miller and this is my colleague Kris.</a:t>
            </a:r>
            <a:br>
              <a:rPr lang="en" sz="2200"/>
            </a:br>
            <a:endParaRPr sz="1000"/>
          </a:p>
          <a:p>
            <a:pPr marL="0" lvl="0" indent="0" algn="l" rtl="0">
              <a:spcBef>
                <a:spcPts val="600"/>
              </a:spcBef>
              <a:spcAft>
                <a:spcPts val="0"/>
              </a:spcAft>
              <a:buNone/>
            </a:pPr>
            <a:r>
              <a:rPr lang="en" sz="2200"/>
              <a:t>Dr. Patel (intern): Hi Ms. Jones, my name is Dr. Krishna Patel. Lovely to meet you.</a:t>
            </a:r>
            <a:br>
              <a:rPr lang="en" sz="2200"/>
            </a:br>
            <a:endParaRPr sz="1000"/>
          </a:p>
          <a:p>
            <a:pPr marL="0" lvl="0" indent="0" algn="l" rtl="0">
              <a:spcBef>
                <a:spcPts val="600"/>
              </a:spcBef>
              <a:spcAft>
                <a:spcPts val="0"/>
              </a:spcAft>
              <a:buNone/>
            </a:pPr>
            <a:r>
              <a:rPr lang="en" sz="2200"/>
              <a:t>Ms. Jones: Nice to meet you both.</a:t>
            </a:r>
            <a:endParaRPr sz="2200"/>
          </a:p>
          <a:p>
            <a:pPr marL="0" lvl="0" indent="0" algn="l" rtl="0">
              <a:spcBef>
                <a:spcPts val="600"/>
              </a:spcBef>
              <a:spcAft>
                <a:spcPts val="0"/>
              </a:spcAft>
              <a:buNone/>
            </a:pPr>
            <a:endParaRPr sz="1000"/>
          </a:p>
          <a:p>
            <a:pPr marL="0" lvl="0" indent="0" algn="l" rtl="0">
              <a:spcBef>
                <a:spcPts val="600"/>
              </a:spcBef>
              <a:spcAft>
                <a:spcPts val="0"/>
              </a:spcAft>
              <a:buNone/>
            </a:pPr>
            <a:r>
              <a:rPr lang="en" sz="2200"/>
              <a:t>Dr. Miller: Ms. Jones, today we will be reviewing the results of your recent lab work and biopsy, which Kris here will now begin reviewing.</a:t>
            </a:r>
            <a:endParaRPr sz="2200"/>
          </a:p>
          <a:p>
            <a:pPr marL="0" lvl="0" indent="0" algn="l" rtl="0">
              <a:spcBef>
                <a:spcPts val="600"/>
              </a:spcBef>
              <a:spcAft>
                <a:spcPts val="600"/>
              </a:spcAft>
              <a:buNone/>
            </a:pPr>
            <a:endParaRPr sz="2200"/>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92"/>
        <p:cNvGrpSpPr/>
        <p:nvPr/>
      </p:nvGrpSpPr>
      <p:grpSpPr>
        <a:xfrm>
          <a:off x="0" y="0"/>
          <a:ext cx="0" cy="0"/>
          <a:chOff x="0" y="0"/>
          <a:chExt cx="0" cy="0"/>
        </a:xfrm>
      </p:grpSpPr>
      <p:sp>
        <p:nvSpPr>
          <p:cNvPr id="393" name="Google Shape;393;p45"/>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Case #1 Discussion Questions</a:t>
            </a:r>
            <a:endParaRPr/>
          </a:p>
        </p:txBody>
      </p:sp>
      <p:sp>
        <p:nvSpPr>
          <p:cNvPr id="394" name="Google Shape;394;p45"/>
          <p:cNvSpPr txBox="1">
            <a:spLocks noGrp="1"/>
          </p:cNvSpPr>
          <p:nvPr>
            <p:ph type="body" idx="1"/>
          </p:nvPr>
        </p:nvSpPr>
        <p:spPr>
          <a:xfrm>
            <a:off x="855300" y="1430150"/>
            <a:ext cx="7433400" cy="3541500"/>
          </a:xfrm>
          <a:prstGeom prst="rect">
            <a:avLst/>
          </a:prstGeom>
        </p:spPr>
        <p:txBody>
          <a:bodyPr spcFirstLastPara="1" wrap="square" lIns="0" tIns="0" rIns="0" bIns="0" anchor="t" anchorCtr="0">
            <a:noAutofit/>
          </a:bodyPr>
          <a:lstStyle/>
          <a:p>
            <a:pPr marL="457200" lvl="0" indent="-368300" algn="l" rtl="0">
              <a:spcBef>
                <a:spcPts val="0"/>
              </a:spcBef>
              <a:spcAft>
                <a:spcPts val="0"/>
              </a:spcAft>
              <a:buSzPts val="2200"/>
              <a:buChar char="●"/>
            </a:pPr>
            <a:r>
              <a:rPr lang="en" sz="2200"/>
              <a:t>What happened in this scenario? What kinds of power dynamics are at play here?</a:t>
            </a:r>
            <a:endParaRPr sz="600"/>
          </a:p>
          <a:p>
            <a:pPr marL="457200" lvl="0" indent="-368300" algn="l" rtl="0">
              <a:spcBef>
                <a:spcPts val="600"/>
              </a:spcBef>
              <a:spcAft>
                <a:spcPts val="0"/>
              </a:spcAft>
              <a:buSzPts val="2200"/>
              <a:buChar char="●"/>
            </a:pPr>
            <a:r>
              <a:rPr lang="en" sz="2200"/>
              <a:t>How might this affect the relationship between the resident and intern? </a:t>
            </a:r>
            <a:endParaRPr sz="2200"/>
          </a:p>
          <a:p>
            <a:pPr marL="457200" lvl="0" indent="-368300" algn="l" rtl="0">
              <a:spcBef>
                <a:spcPts val="600"/>
              </a:spcBef>
              <a:spcAft>
                <a:spcPts val="0"/>
              </a:spcAft>
              <a:buSzPts val="2200"/>
              <a:buChar char="●"/>
            </a:pPr>
            <a:r>
              <a:rPr lang="en" sz="2200"/>
              <a:t>How would you address this situation?</a:t>
            </a:r>
            <a:endParaRPr sz="600"/>
          </a:p>
          <a:p>
            <a:pPr marL="457200" lvl="0" indent="-368300" algn="l" rtl="0">
              <a:spcBef>
                <a:spcPts val="600"/>
              </a:spcBef>
              <a:spcAft>
                <a:spcPts val="0"/>
              </a:spcAft>
              <a:buSzPts val="2200"/>
              <a:buChar char="●"/>
            </a:pPr>
            <a:r>
              <a:rPr lang="en" sz="2200"/>
              <a:t>Have you ever had a time where you were addressed incorrectly in a workplace setting? How did that make you feel? What did you do about it?</a:t>
            </a:r>
            <a:endParaRPr sz="2200"/>
          </a:p>
          <a:p>
            <a:pPr marL="0" lvl="0" indent="0" algn="l" rtl="0">
              <a:spcBef>
                <a:spcPts val="600"/>
              </a:spcBef>
              <a:spcAft>
                <a:spcPts val="600"/>
              </a:spcAft>
              <a:buNone/>
            </a:pPr>
            <a:endParaRPr/>
          </a:p>
        </p:txBody>
      </p:sp>
      <p:sp>
        <p:nvSpPr>
          <p:cNvPr id="395" name="Google Shape;395;p45"/>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33</a:t>
            </a:fld>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99"/>
        <p:cNvGrpSpPr/>
        <p:nvPr/>
      </p:nvGrpSpPr>
      <p:grpSpPr>
        <a:xfrm>
          <a:off x="0" y="0"/>
          <a:ext cx="0" cy="0"/>
          <a:chOff x="0" y="0"/>
          <a:chExt cx="0" cy="0"/>
        </a:xfrm>
      </p:grpSpPr>
      <p:sp>
        <p:nvSpPr>
          <p:cNvPr id="400" name="Google Shape;400;p46"/>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Case #2 </a:t>
            </a:r>
            <a:r>
              <a:rPr lang="en" b="0"/>
              <a:t>Physician/Patient </a:t>
            </a:r>
            <a:endParaRPr b="0"/>
          </a:p>
        </p:txBody>
      </p:sp>
      <p:sp>
        <p:nvSpPr>
          <p:cNvPr id="401" name="Google Shape;401;p46"/>
          <p:cNvSpPr txBox="1">
            <a:spLocks noGrp="1"/>
          </p:cNvSpPr>
          <p:nvPr>
            <p:ph type="body" idx="1"/>
          </p:nvPr>
        </p:nvSpPr>
        <p:spPr>
          <a:xfrm>
            <a:off x="855300" y="1430151"/>
            <a:ext cx="7433400" cy="37134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sz="2200"/>
              <a:t>After a busy morning of rounds, Dr. Dole heads to his afternoon clinic. He walks in, to greet his first patient who is a 65 year old woman and new patient. He says “Hi Mary, how are you?” </a:t>
            </a:r>
            <a:endParaRPr sz="2200"/>
          </a:p>
          <a:p>
            <a:pPr marL="0" lvl="0" indent="0" algn="l" rtl="0">
              <a:spcBef>
                <a:spcPts val="600"/>
              </a:spcBef>
              <a:spcAft>
                <a:spcPts val="0"/>
              </a:spcAft>
              <a:buNone/>
            </a:pPr>
            <a:endParaRPr sz="2200"/>
          </a:p>
          <a:p>
            <a:pPr marL="0" lvl="0" indent="0" algn="l" rtl="0">
              <a:spcBef>
                <a:spcPts val="600"/>
              </a:spcBef>
              <a:spcAft>
                <a:spcPts val="0"/>
              </a:spcAft>
              <a:buNone/>
            </a:pPr>
            <a:r>
              <a:rPr lang="en" sz="2200"/>
              <a:t>She responds and says, “Oh, my name is Maria.”</a:t>
            </a:r>
            <a:endParaRPr sz="2200"/>
          </a:p>
          <a:p>
            <a:pPr marL="0" lvl="0" indent="0" algn="l" rtl="0">
              <a:spcBef>
                <a:spcPts val="600"/>
              </a:spcBef>
              <a:spcAft>
                <a:spcPts val="0"/>
              </a:spcAft>
              <a:buNone/>
            </a:pPr>
            <a:endParaRPr sz="2200"/>
          </a:p>
          <a:p>
            <a:pPr marL="0" lvl="0" indent="0" algn="l" rtl="0">
              <a:spcBef>
                <a:spcPts val="600"/>
              </a:spcBef>
              <a:spcAft>
                <a:spcPts val="600"/>
              </a:spcAft>
              <a:buNone/>
            </a:pPr>
            <a:r>
              <a:rPr lang="en" sz="2200"/>
              <a:t>Dr. Dole responds and says “Oh I apologize Maria.”</a:t>
            </a:r>
            <a:endParaRPr sz="2200"/>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05"/>
        <p:cNvGrpSpPr/>
        <p:nvPr/>
      </p:nvGrpSpPr>
      <p:grpSpPr>
        <a:xfrm>
          <a:off x="0" y="0"/>
          <a:ext cx="0" cy="0"/>
          <a:chOff x="0" y="0"/>
          <a:chExt cx="0" cy="0"/>
        </a:xfrm>
      </p:grpSpPr>
      <p:sp>
        <p:nvSpPr>
          <p:cNvPr id="406" name="Google Shape;406;p47"/>
          <p:cNvSpPr txBox="1">
            <a:spLocks noGrp="1"/>
          </p:cNvSpPr>
          <p:nvPr>
            <p:ph type="title"/>
          </p:nvPr>
        </p:nvSpPr>
        <p:spPr>
          <a:xfrm>
            <a:off x="855300" y="533725"/>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Case #2 Discussion Questions</a:t>
            </a:r>
            <a:endParaRPr/>
          </a:p>
        </p:txBody>
      </p:sp>
      <p:sp>
        <p:nvSpPr>
          <p:cNvPr id="407" name="Google Shape;407;p47"/>
          <p:cNvSpPr txBox="1">
            <a:spLocks noGrp="1"/>
          </p:cNvSpPr>
          <p:nvPr>
            <p:ph type="body" idx="1"/>
          </p:nvPr>
        </p:nvSpPr>
        <p:spPr>
          <a:xfrm>
            <a:off x="855300" y="1127875"/>
            <a:ext cx="8288700" cy="4015500"/>
          </a:xfrm>
          <a:prstGeom prst="rect">
            <a:avLst/>
          </a:prstGeom>
        </p:spPr>
        <p:txBody>
          <a:bodyPr spcFirstLastPara="1" wrap="square" lIns="0" tIns="0" rIns="0" bIns="0" anchor="t" anchorCtr="0">
            <a:noAutofit/>
          </a:bodyPr>
          <a:lstStyle/>
          <a:p>
            <a:pPr marL="457200" lvl="0" indent="-368300" algn="l" rtl="0">
              <a:spcBef>
                <a:spcPts val="0"/>
              </a:spcBef>
              <a:spcAft>
                <a:spcPts val="0"/>
              </a:spcAft>
              <a:buSzPts val="2200"/>
              <a:buChar char="●"/>
            </a:pPr>
            <a:r>
              <a:rPr lang="en" sz="2200"/>
              <a:t>What mistakes did Dr. Dole make? What could he have done differently?</a:t>
            </a:r>
            <a:endParaRPr sz="2200"/>
          </a:p>
          <a:p>
            <a:pPr marL="342900" lvl="0" indent="0" algn="l" rtl="0">
              <a:spcBef>
                <a:spcPts val="600"/>
              </a:spcBef>
              <a:spcAft>
                <a:spcPts val="0"/>
              </a:spcAft>
              <a:buNone/>
            </a:pPr>
            <a:endParaRPr sz="600"/>
          </a:p>
          <a:p>
            <a:pPr marL="457200" lvl="0" indent="-368300" algn="l" rtl="0">
              <a:spcBef>
                <a:spcPts val="600"/>
              </a:spcBef>
              <a:spcAft>
                <a:spcPts val="0"/>
              </a:spcAft>
              <a:buSzPts val="2200"/>
              <a:buChar char="●"/>
            </a:pPr>
            <a:r>
              <a:rPr lang="en" sz="2200"/>
              <a:t>How might this mistake affect the doctor-patient relationship going forward?</a:t>
            </a:r>
            <a:br>
              <a:rPr lang="en" sz="2200"/>
            </a:br>
            <a:endParaRPr sz="600"/>
          </a:p>
          <a:p>
            <a:pPr marL="457200" lvl="0" indent="-368300" algn="l" rtl="0">
              <a:spcBef>
                <a:spcPts val="600"/>
              </a:spcBef>
              <a:spcAft>
                <a:spcPts val="0"/>
              </a:spcAft>
              <a:buSzPts val="2200"/>
              <a:buChar char="●"/>
            </a:pPr>
            <a:r>
              <a:rPr lang="en" sz="2200"/>
              <a:t>What could Dr. Dole say next, to further address this situation and continue with the visit?</a:t>
            </a:r>
            <a:br>
              <a:rPr lang="en" sz="2200"/>
            </a:br>
            <a:endParaRPr sz="600"/>
          </a:p>
          <a:p>
            <a:pPr marL="457200" lvl="0" indent="-368300" algn="l" rtl="0">
              <a:spcBef>
                <a:spcPts val="600"/>
              </a:spcBef>
              <a:spcAft>
                <a:spcPts val="600"/>
              </a:spcAft>
              <a:buSzPts val="2200"/>
              <a:buChar char="●"/>
            </a:pPr>
            <a:r>
              <a:rPr lang="en" sz="2200"/>
              <a:t>Have you ever had a time where you were addressed incorrectly in the workplace? How did that make you feel? What did you do about it?</a:t>
            </a:r>
            <a:endParaRPr sz="2200"/>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11"/>
        <p:cNvGrpSpPr/>
        <p:nvPr/>
      </p:nvGrpSpPr>
      <p:grpSpPr>
        <a:xfrm>
          <a:off x="0" y="0"/>
          <a:ext cx="0" cy="0"/>
          <a:chOff x="0" y="0"/>
          <a:chExt cx="0" cy="0"/>
        </a:xfrm>
      </p:grpSpPr>
      <p:sp>
        <p:nvSpPr>
          <p:cNvPr id="412" name="Google Shape;412;p48"/>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Large Group Debrief</a:t>
            </a:r>
            <a:endParaRPr/>
          </a:p>
        </p:txBody>
      </p:sp>
      <p:sp>
        <p:nvSpPr>
          <p:cNvPr id="413" name="Google Shape;413;p48"/>
          <p:cNvSpPr txBox="1">
            <a:spLocks noGrp="1"/>
          </p:cNvSpPr>
          <p:nvPr>
            <p:ph type="body" idx="1"/>
          </p:nvPr>
        </p:nvSpPr>
        <p:spPr>
          <a:xfrm>
            <a:off x="855300" y="1430147"/>
            <a:ext cx="7433400" cy="30339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dirty="0"/>
              <a:t>One person from each group shares one new strategy they will use for name pronunciation. </a:t>
            </a:r>
            <a:endParaRPr dirty="0"/>
          </a:p>
          <a:p>
            <a:pPr marL="0" lvl="0" indent="0" algn="l" rtl="0">
              <a:spcBef>
                <a:spcPts val="600"/>
              </a:spcBef>
              <a:spcAft>
                <a:spcPts val="0"/>
              </a:spcAft>
              <a:buNone/>
            </a:pPr>
            <a:endParaRPr dirty="0"/>
          </a:p>
          <a:p>
            <a:pPr marL="0" lvl="0" indent="0" algn="l" rtl="0">
              <a:spcBef>
                <a:spcPts val="600"/>
              </a:spcBef>
              <a:spcAft>
                <a:spcPts val="600"/>
              </a:spcAft>
              <a:buNone/>
            </a:pPr>
            <a:r>
              <a:rPr lang="en"/>
              <a:t>Share in the chat any take away points from your group discussion. </a:t>
            </a:r>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17"/>
        <p:cNvGrpSpPr/>
        <p:nvPr/>
      </p:nvGrpSpPr>
      <p:grpSpPr>
        <a:xfrm>
          <a:off x="0" y="0"/>
          <a:ext cx="0" cy="0"/>
          <a:chOff x="0" y="0"/>
          <a:chExt cx="0" cy="0"/>
        </a:xfrm>
      </p:grpSpPr>
      <p:sp>
        <p:nvSpPr>
          <p:cNvPr id="418" name="Google Shape;418;p49"/>
          <p:cNvSpPr txBox="1">
            <a:spLocks noGrp="1"/>
          </p:cNvSpPr>
          <p:nvPr>
            <p:ph type="ctrTitle"/>
          </p:nvPr>
        </p:nvSpPr>
        <p:spPr>
          <a:xfrm>
            <a:off x="762150" y="-55674"/>
            <a:ext cx="7772400" cy="13116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Workshop Evaluation</a:t>
            </a:r>
            <a:endParaRPr/>
          </a:p>
        </p:txBody>
      </p:sp>
      <p:sp>
        <p:nvSpPr>
          <p:cNvPr id="419" name="Google Shape;419;p49"/>
          <p:cNvSpPr txBox="1">
            <a:spLocks noGrp="1"/>
          </p:cNvSpPr>
          <p:nvPr>
            <p:ph type="subTitle" idx="1"/>
          </p:nvPr>
        </p:nvSpPr>
        <p:spPr>
          <a:xfrm>
            <a:off x="685800" y="1263723"/>
            <a:ext cx="7772400" cy="920700"/>
          </a:xfrm>
          <a:prstGeom prst="rect">
            <a:avLst/>
          </a:prstGeom>
        </p:spPr>
        <p:txBody>
          <a:bodyPr spcFirstLastPara="1" wrap="square" lIns="0" tIns="0" rIns="0" bIns="0" anchor="t" anchorCtr="0">
            <a:noAutofit/>
          </a:bodyPr>
          <a:lstStyle/>
          <a:p>
            <a:pPr marL="0" lvl="0" indent="0" algn="l" rtl="0">
              <a:spcBef>
                <a:spcPts val="0"/>
              </a:spcBef>
              <a:spcAft>
                <a:spcPts val="600"/>
              </a:spcAft>
              <a:buNone/>
            </a:pPr>
            <a:r>
              <a:rPr lang="en" b="1" i="1">
                <a:latin typeface="Montserrat"/>
                <a:ea typeface="Montserrat"/>
                <a:cs typeface="Montserrat"/>
                <a:sym typeface="Montserrat"/>
              </a:rPr>
              <a:t>Once you have completed the survey, you may exit the workshop. Thank you for your participation!</a:t>
            </a:r>
            <a:endParaRPr b="1" i="1">
              <a:latin typeface="Montserrat"/>
              <a:ea typeface="Montserrat"/>
              <a:cs typeface="Montserrat"/>
              <a:sym typeface="Montserrat"/>
            </a:endParaRPr>
          </a:p>
        </p:txBody>
      </p:sp>
      <p:pic>
        <p:nvPicPr>
          <p:cNvPr id="420" name="Google Shape;420;p49" title="12 - Say My Name.mp3">
            <a:hlinkClick r:id="rId3"/>
          </p:cNvPr>
          <p:cNvPicPr preferRelativeResize="0"/>
          <p:nvPr/>
        </p:nvPicPr>
        <p:blipFill>
          <a:blip r:embed="rId4">
            <a:alphaModFix amt="80000"/>
          </a:blip>
          <a:stretch>
            <a:fillRect/>
          </a:stretch>
        </p:blipFill>
        <p:spPr>
          <a:xfrm>
            <a:off x="134250" y="4091400"/>
            <a:ext cx="627900" cy="627900"/>
          </a:xfrm>
          <a:prstGeom prst="rect">
            <a:avLst/>
          </a:prstGeom>
          <a:noFill/>
          <a:ln>
            <a:noFill/>
          </a:ln>
        </p:spPr>
      </p:pic>
      <p:pic>
        <p:nvPicPr>
          <p:cNvPr id="421" name="Google Shape;421;p49"/>
          <p:cNvPicPr preferRelativeResize="0"/>
          <p:nvPr/>
        </p:nvPicPr>
        <p:blipFill>
          <a:blip r:embed="rId5">
            <a:alphaModFix/>
          </a:blip>
          <a:stretch>
            <a:fillRect/>
          </a:stretch>
        </p:blipFill>
        <p:spPr>
          <a:xfrm>
            <a:off x="3541400" y="2200626"/>
            <a:ext cx="1858949" cy="1858949"/>
          </a:xfrm>
          <a:prstGeom prst="rect">
            <a:avLst/>
          </a:prstGeom>
          <a:noFill/>
          <a:ln>
            <a:noFill/>
          </a:ln>
        </p:spPr>
      </p:pic>
      <p:sp>
        <p:nvSpPr>
          <p:cNvPr id="422" name="Google Shape;422;p49"/>
          <p:cNvSpPr txBox="1"/>
          <p:nvPr/>
        </p:nvSpPr>
        <p:spPr>
          <a:xfrm>
            <a:off x="1440550" y="4484950"/>
            <a:ext cx="68307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u="sng">
                <a:solidFill>
                  <a:schemeClr val="hlink"/>
                </a:solidFill>
                <a:latin typeface="Montserrat Light"/>
                <a:ea typeface="Montserrat Light"/>
                <a:cs typeface="Montserrat Light"/>
                <a:sym typeface="Montserrat Light"/>
                <a:hlinkClick r:id="rId6"/>
              </a:rPr>
              <a:t>https://qfreeaccountssjc1.az1.qualtrics.com/jfe/form/SV_78aR4nasYGiEyEK</a:t>
            </a:r>
            <a:r>
              <a:rPr lang="en">
                <a:latin typeface="Montserrat Light"/>
                <a:ea typeface="Montserrat Light"/>
                <a:cs typeface="Montserrat Light"/>
                <a:sym typeface="Montserrat Light"/>
              </a:rPr>
              <a:t> </a:t>
            </a:r>
            <a:endParaRPr>
              <a:latin typeface="Montserrat Light"/>
              <a:ea typeface="Montserrat Light"/>
              <a:cs typeface="Montserrat Light"/>
              <a:sym typeface="Montserrat Light"/>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26"/>
        <p:cNvGrpSpPr/>
        <p:nvPr/>
      </p:nvGrpSpPr>
      <p:grpSpPr>
        <a:xfrm>
          <a:off x="0" y="0"/>
          <a:ext cx="0" cy="0"/>
          <a:chOff x="0" y="0"/>
          <a:chExt cx="0" cy="0"/>
        </a:xfrm>
      </p:grpSpPr>
      <p:sp>
        <p:nvSpPr>
          <p:cNvPr id="427" name="Google Shape;427;p50"/>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Recap &amp; Resources</a:t>
            </a:r>
            <a:endParaRPr/>
          </a:p>
        </p:txBody>
      </p:sp>
      <p:sp>
        <p:nvSpPr>
          <p:cNvPr id="428" name="Google Shape;428;p50"/>
          <p:cNvSpPr txBox="1">
            <a:spLocks noGrp="1"/>
          </p:cNvSpPr>
          <p:nvPr>
            <p:ph type="body" idx="1"/>
          </p:nvPr>
        </p:nvSpPr>
        <p:spPr>
          <a:xfrm>
            <a:off x="855300" y="1430147"/>
            <a:ext cx="7433400" cy="3033900"/>
          </a:xfrm>
          <a:prstGeom prst="rect">
            <a:avLst/>
          </a:prstGeom>
        </p:spPr>
        <p:txBody>
          <a:bodyPr spcFirstLastPara="1" wrap="square" lIns="0" tIns="0" rIns="0" bIns="0" anchor="t" anchorCtr="0">
            <a:noAutofit/>
          </a:bodyPr>
          <a:lstStyle/>
          <a:p>
            <a:pPr marL="457200" lvl="0" indent="-361950" algn="l" rtl="0">
              <a:lnSpc>
                <a:spcPct val="115000"/>
              </a:lnSpc>
              <a:spcBef>
                <a:spcPts val="1000"/>
              </a:spcBef>
              <a:spcAft>
                <a:spcPts val="0"/>
              </a:spcAft>
              <a:buSzPts val="2100"/>
              <a:buChar char="●"/>
            </a:pPr>
            <a:r>
              <a:rPr lang="en" sz="2100" b="1" dirty="0">
                <a:solidFill>
                  <a:srgbClr val="000000"/>
                </a:solidFill>
                <a:latin typeface="Montserrat"/>
                <a:ea typeface="Montserrat"/>
                <a:cs typeface="Montserrat"/>
                <a:sym typeface="Montserrat"/>
              </a:rPr>
              <a:t>Examined </a:t>
            </a:r>
            <a:r>
              <a:rPr lang="en" sz="2100" dirty="0">
                <a:solidFill>
                  <a:srgbClr val="000000"/>
                </a:solidFill>
                <a:latin typeface="Montserrat"/>
                <a:ea typeface="Montserrat"/>
                <a:cs typeface="Montserrat"/>
                <a:sym typeface="Montserrat"/>
              </a:rPr>
              <a:t>the importance of name pronunciation in identity affirmation</a:t>
            </a:r>
            <a:endParaRPr sz="2100" dirty="0"/>
          </a:p>
          <a:p>
            <a:pPr marL="457200" lvl="0" indent="-361950" algn="l" rtl="0">
              <a:lnSpc>
                <a:spcPct val="115000"/>
              </a:lnSpc>
              <a:spcBef>
                <a:spcPts val="1000"/>
              </a:spcBef>
              <a:spcAft>
                <a:spcPts val="0"/>
              </a:spcAft>
              <a:buSzPts val="2100"/>
              <a:buChar char="●"/>
            </a:pPr>
            <a:r>
              <a:rPr lang="en" sz="2100" b="1" dirty="0">
                <a:solidFill>
                  <a:srgbClr val="000000"/>
                </a:solidFill>
                <a:latin typeface="Montserrat"/>
                <a:ea typeface="Montserrat"/>
                <a:cs typeface="Montserrat"/>
                <a:sym typeface="Montserrat"/>
              </a:rPr>
              <a:t>Illustrated </a:t>
            </a:r>
            <a:r>
              <a:rPr lang="en" sz="2100" dirty="0">
                <a:solidFill>
                  <a:srgbClr val="000000"/>
                </a:solidFill>
                <a:latin typeface="Montserrat"/>
                <a:ea typeface="Montserrat"/>
                <a:cs typeface="Montserrat"/>
                <a:sym typeface="Montserrat"/>
              </a:rPr>
              <a:t>the historical instances of racism that contribute to name mispronunciation</a:t>
            </a:r>
            <a:endParaRPr sz="2100" dirty="0">
              <a:solidFill>
                <a:srgbClr val="000000"/>
              </a:solidFill>
              <a:latin typeface="Montserrat"/>
              <a:ea typeface="Montserrat"/>
              <a:cs typeface="Montserrat"/>
              <a:sym typeface="Montserrat"/>
            </a:endParaRPr>
          </a:p>
          <a:p>
            <a:pPr marL="457200" lvl="0" indent="-361950" algn="l" rtl="0">
              <a:lnSpc>
                <a:spcPct val="115000"/>
              </a:lnSpc>
              <a:spcBef>
                <a:spcPts val="1000"/>
              </a:spcBef>
              <a:spcAft>
                <a:spcPts val="0"/>
              </a:spcAft>
              <a:buSzPts val="2100"/>
              <a:buChar char="●"/>
            </a:pPr>
            <a:r>
              <a:rPr lang="en" sz="2100" b="1" dirty="0">
                <a:solidFill>
                  <a:srgbClr val="000000"/>
                </a:solidFill>
                <a:latin typeface="Montserrat"/>
                <a:ea typeface="Montserrat"/>
                <a:cs typeface="Montserrat"/>
                <a:sym typeface="Montserrat"/>
              </a:rPr>
              <a:t>Employed </a:t>
            </a:r>
            <a:r>
              <a:rPr lang="en" sz="2100" dirty="0">
                <a:solidFill>
                  <a:srgbClr val="000000"/>
                </a:solidFill>
                <a:latin typeface="Montserrat"/>
                <a:ea typeface="Montserrat"/>
                <a:cs typeface="Montserrat"/>
                <a:sym typeface="Montserrat"/>
              </a:rPr>
              <a:t>tools to engage in productive conversation around name pronunciation</a:t>
            </a:r>
            <a:endParaRPr sz="2100" b="1" dirty="0">
              <a:solidFill>
                <a:srgbClr val="000000"/>
              </a:solidFill>
              <a:latin typeface="Montserrat"/>
              <a:ea typeface="Montserrat"/>
              <a:cs typeface="Montserrat"/>
              <a:sym typeface="Montserrat"/>
            </a:endParaRPr>
          </a:p>
          <a:p>
            <a:pPr marL="457200" lvl="0" indent="-361950" algn="l" rtl="0">
              <a:lnSpc>
                <a:spcPct val="115000"/>
              </a:lnSpc>
              <a:spcBef>
                <a:spcPts val="1000"/>
              </a:spcBef>
              <a:spcAft>
                <a:spcPts val="100"/>
              </a:spcAft>
              <a:buSzPts val="2100"/>
              <a:buChar char="●"/>
            </a:pPr>
            <a:r>
              <a:rPr lang="en" sz="2100" b="1" dirty="0">
                <a:solidFill>
                  <a:srgbClr val="000000"/>
                </a:solidFill>
                <a:latin typeface="Montserrat"/>
                <a:ea typeface="Montserrat"/>
                <a:cs typeface="Montserrat"/>
                <a:sym typeface="Montserrat"/>
              </a:rPr>
              <a:t>Applied </a:t>
            </a:r>
            <a:r>
              <a:rPr lang="en" sz="2100" dirty="0">
                <a:solidFill>
                  <a:srgbClr val="000000"/>
                </a:solidFill>
                <a:latin typeface="Montserrat"/>
                <a:ea typeface="Montserrat"/>
                <a:cs typeface="Montserrat"/>
                <a:sym typeface="Montserrat"/>
              </a:rPr>
              <a:t>name affirmation tools to case scenarios in a clinical and medical education setting </a:t>
            </a:r>
            <a:endParaRPr dirty="0"/>
          </a:p>
        </p:txBody>
      </p:sp>
      <p:sp>
        <p:nvSpPr>
          <p:cNvPr id="429" name="Google Shape;429;p50"/>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38</a:t>
            </a:fld>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433"/>
        <p:cNvGrpSpPr/>
        <p:nvPr/>
      </p:nvGrpSpPr>
      <p:grpSpPr>
        <a:xfrm>
          <a:off x="0" y="0"/>
          <a:ext cx="0" cy="0"/>
          <a:chOff x="0" y="0"/>
          <a:chExt cx="0" cy="0"/>
        </a:xfrm>
      </p:grpSpPr>
      <p:sp>
        <p:nvSpPr>
          <p:cNvPr id="434" name="Google Shape;434;p51"/>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Take-home points</a:t>
            </a:r>
            <a:endParaRPr dirty="0"/>
          </a:p>
        </p:txBody>
      </p:sp>
      <p:sp>
        <p:nvSpPr>
          <p:cNvPr id="435" name="Google Shape;435;p51"/>
          <p:cNvSpPr txBox="1">
            <a:spLocks noGrp="1"/>
          </p:cNvSpPr>
          <p:nvPr>
            <p:ph type="body" idx="1"/>
          </p:nvPr>
        </p:nvSpPr>
        <p:spPr>
          <a:xfrm>
            <a:off x="855300" y="1310197"/>
            <a:ext cx="7433400" cy="3033900"/>
          </a:xfrm>
          <a:prstGeom prst="rect">
            <a:avLst/>
          </a:prstGeom>
        </p:spPr>
        <p:txBody>
          <a:bodyPr spcFirstLastPara="1" wrap="square" lIns="0" tIns="0" rIns="0" bIns="0" anchor="t" anchorCtr="0">
            <a:noAutofit/>
          </a:bodyPr>
          <a:lstStyle/>
          <a:p>
            <a:pPr marL="457200" lvl="0" indent="-361950" algn="l" rtl="0">
              <a:lnSpc>
                <a:spcPct val="115000"/>
              </a:lnSpc>
              <a:spcBef>
                <a:spcPts val="1000"/>
              </a:spcBef>
              <a:spcAft>
                <a:spcPts val="0"/>
              </a:spcAft>
              <a:buSzPts val="2100"/>
              <a:buChar char="●"/>
            </a:pPr>
            <a:r>
              <a:rPr lang="en" dirty="0"/>
              <a:t>Names are deeply personal and have complex ties to identity and racial microaggressions</a:t>
            </a:r>
            <a:endParaRPr dirty="0"/>
          </a:p>
          <a:p>
            <a:pPr marL="457200" lvl="0" indent="-381000" algn="l" rtl="0">
              <a:spcBef>
                <a:spcPts val="100"/>
              </a:spcBef>
              <a:spcAft>
                <a:spcPts val="0"/>
              </a:spcAft>
              <a:buSzPts val="2400"/>
              <a:buChar char="●"/>
            </a:pPr>
            <a:r>
              <a:rPr lang="en" dirty="0"/>
              <a:t>Pronunciation:  </a:t>
            </a:r>
            <a:endParaRPr dirty="0"/>
          </a:p>
          <a:p>
            <a:pPr marL="914400" lvl="1" indent="-381000" algn="l" rtl="0">
              <a:spcBef>
                <a:spcPts val="600"/>
              </a:spcBef>
              <a:spcAft>
                <a:spcPts val="0"/>
              </a:spcAft>
              <a:buSzPts val="2400"/>
              <a:buChar char="○"/>
            </a:pPr>
            <a:r>
              <a:rPr lang="en" dirty="0"/>
              <a:t>1. Just ask! </a:t>
            </a:r>
            <a:endParaRPr dirty="0"/>
          </a:p>
          <a:p>
            <a:pPr marL="914400" lvl="1" indent="-381000" algn="l" rtl="0">
              <a:spcBef>
                <a:spcPts val="600"/>
              </a:spcBef>
              <a:spcAft>
                <a:spcPts val="0"/>
              </a:spcAft>
              <a:buSzPts val="2400"/>
              <a:buChar char="○"/>
            </a:pPr>
            <a:r>
              <a:rPr lang="en" dirty="0"/>
              <a:t>2. Practice, practice, practice </a:t>
            </a:r>
            <a:endParaRPr dirty="0"/>
          </a:p>
          <a:p>
            <a:pPr marL="914400" lvl="1" indent="-381000" algn="l" rtl="0">
              <a:spcBef>
                <a:spcPts val="600"/>
              </a:spcBef>
              <a:spcAft>
                <a:spcPts val="0"/>
              </a:spcAft>
              <a:buSzPts val="2400"/>
              <a:buChar char="○"/>
            </a:pPr>
            <a:r>
              <a:rPr lang="en" dirty="0"/>
              <a:t>3. Own mistakes and correct</a:t>
            </a:r>
            <a:endParaRPr dirty="0"/>
          </a:p>
          <a:p>
            <a:pPr marL="457200" lvl="0" indent="-381000" algn="l" rtl="0">
              <a:spcBef>
                <a:spcPts val="600"/>
              </a:spcBef>
              <a:spcAft>
                <a:spcPts val="0"/>
              </a:spcAft>
              <a:buSzPts val="2400"/>
              <a:buChar char="●"/>
            </a:pPr>
            <a:r>
              <a:rPr lang="en" dirty="0"/>
              <a:t>Incorporate tools into EHR, professional settings, and personal life</a:t>
            </a:r>
            <a:endParaRPr sz="900" dirty="0">
              <a:solidFill>
                <a:srgbClr val="000000"/>
              </a:solidFill>
              <a:latin typeface="Arial"/>
              <a:ea typeface="Arial"/>
              <a:cs typeface="Arial"/>
              <a:sym typeface="Arial"/>
            </a:endParaRPr>
          </a:p>
          <a:p>
            <a:pPr marL="0" lvl="0" indent="0" algn="l" rtl="0">
              <a:lnSpc>
                <a:spcPct val="115000"/>
              </a:lnSpc>
              <a:spcBef>
                <a:spcPts val="1000"/>
              </a:spcBef>
              <a:spcAft>
                <a:spcPts val="0"/>
              </a:spcAft>
              <a:buNone/>
            </a:pPr>
            <a:endParaRPr dirty="0"/>
          </a:p>
          <a:p>
            <a:pPr marL="457200" lvl="0" indent="-361950" algn="l" rtl="0">
              <a:lnSpc>
                <a:spcPct val="115000"/>
              </a:lnSpc>
              <a:spcBef>
                <a:spcPts val="1000"/>
              </a:spcBef>
              <a:spcAft>
                <a:spcPts val="100"/>
              </a:spcAft>
              <a:buClr>
                <a:srgbClr val="000000"/>
              </a:buClr>
              <a:buSzPts val="2100"/>
              <a:buFont typeface="Montserrat"/>
              <a:buChar char="●"/>
            </a:pPr>
            <a:endParaRPr sz="2100" dirty="0">
              <a:solidFill>
                <a:srgbClr val="000000"/>
              </a:solidFill>
              <a:latin typeface="Montserrat"/>
              <a:ea typeface="Montserrat"/>
              <a:cs typeface="Montserrat"/>
              <a:sym typeface="Montserrat"/>
            </a:endParaRPr>
          </a:p>
        </p:txBody>
      </p:sp>
      <p:sp>
        <p:nvSpPr>
          <p:cNvPr id="436" name="Google Shape;436;p51"/>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39</a:t>
            </a:fld>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gradFill>
          <a:gsLst>
            <a:gs pos="0">
              <a:schemeClr val="accent1"/>
            </a:gs>
            <a:gs pos="100000">
              <a:srgbClr val="D1F6FF"/>
            </a:gs>
          </a:gsLst>
          <a:path path="circle">
            <a:fillToRect l="100000" t="100000"/>
          </a:path>
          <a:tileRect r="-100000" b="-100000"/>
        </a:gradFill>
        <a:effectLst/>
      </p:bgPr>
    </p:bg>
    <p:spTree>
      <p:nvGrpSpPr>
        <p:cNvPr id="1" name="Shape 133"/>
        <p:cNvGrpSpPr/>
        <p:nvPr/>
      </p:nvGrpSpPr>
      <p:grpSpPr>
        <a:xfrm>
          <a:off x="0" y="0"/>
          <a:ext cx="0" cy="0"/>
          <a:chOff x="0" y="0"/>
          <a:chExt cx="0" cy="0"/>
        </a:xfrm>
      </p:grpSpPr>
      <p:sp>
        <p:nvSpPr>
          <p:cNvPr id="134" name="Google Shape;134;p15"/>
          <p:cNvSpPr txBox="1">
            <a:spLocks noGrp="1"/>
          </p:cNvSpPr>
          <p:nvPr>
            <p:ph type="title"/>
          </p:nvPr>
        </p:nvSpPr>
        <p:spPr>
          <a:xfrm>
            <a:off x="855300" y="576809"/>
            <a:ext cx="4594200" cy="3963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dirty="0">
                <a:solidFill>
                  <a:schemeClr val="accent2"/>
                </a:solidFill>
              </a:rPr>
              <a:t>What’s in a name?</a:t>
            </a:r>
            <a:endParaRPr dirty="0">
              <a:solidFill>
                <a:schemeClr val="accent2"/>
              </a:solidFill>
            </a:endParaRPr>
          </a:p>
        </p:txBody>
      </p:sp>
      <p:sp>
        <p:nvSpPr>
          <p:cNvPr id="135" name="Google Shape;135;p15"/>
          <p:cNvSpPr txBox="1">
            <a:spLocks noGrp="1"/>
          </p:cNvSpPr>
          <p:nvPr>
            <p:ph type="body" idx="1"/>
          </p:nvPr>
        </p:nvSpPr>
        <p:spPr>
          <a:xfrm>
            <a:off x="855300" y="1524897"/>
            <a:ext cx="3278700" cy="1732200"/>
          </a:xfrm>
          <a:prstGeom prst="rect">
            <a:avLst/>
          </a:prstGeom>
        </p:spPr>
        <p:txBody>
          <a:bodyPr spcFirstLastPara="1" wrap="square" lIns="0" tIns="0" rIns="0" bIns="0" anchor="t" anchorCtr="0">
            <a:noAutofit/>
          </a:bodyPr>
          <a:lstStyle/>
          <a:p>
            <a:pPr marL="457200" lvl="0" indent="-355600" algn="l" rtl="0">
              <a:lnSpc>
                <a:spcPct val="115000"/>
              </a:lnSpc>
              <a:spcBef>
                <a:spcPts val="0"/>
              </a:spcBef>
              <a:spcAft>
                <a:spcPts val="0"/>
              </a:spcAft>
              <a:buSzPts val="2000"/>
              <a:buFont typeface="Montserrat"/>
              <a:buChar char="●"/>
            </a:pPr>
            <a:r>
              <a:rPr lang="en" sz="2000" dirty="0">
                <a:solidFill>
                  <a:srgbClr val="000000"/>
                </a:solidFill>
                <a:latin typeface="Montserrat"/>
                <a:ea typeface="Montserrat"/>
                <a:cs typeface="Montserrat"/>
                <a:sym typeface="Montserrat"/>
              </a:rPr>
              <a:t>Reflection of identity</a:t>
            </a:r>
            <a:endParaRPr sz="2000" dirty="0">
              <a:solidFill>
                <a:srgbClr val="000000"/>
              </a:solidFill>
              <a:latin typeface="Montserrat"/>
              <a:ea typeface="Montserrat"/>
              <a:cs typeface="Montserrat"/>
              <a:sym typeface="Montserrat"/>
            </a:endParaRPr>
          </a:p>
          <a:p>
            <a:pPr marL="457200" lvl="0" indent="-355600" algn="l" rtl="0">
              <a:lnSpc>
                <a:spcPct val="115000"/>
              </a:lnSpc>
              <a:spcBef>
                <a:spcPts val="1000"/>
              </a:spcBef>
              <a:spcAft>
                <a:spcPts val="0"/>
              </a:spcAft>
              <a:buSzPts val="2000"/>
              <a:buFont typeface="Montserrat"/>
              <a:buChar char="●"/>
            </a:pPr>
            <a:r>
              <a:rPr lang="en" sz="2000" dirty="0">
                <a:solidFill>
                  <a:srgbClr val="000000"/>
                </a:solidFill>
                <a:latin typeface="Montserrat"/>
                <a:ea typeface="Montserrat"/>
                <a:cs typeface="Montserrat"/>
                <a:sym typeface="Montserrat"/>
              </a:rPr>
              <a:t>Often have meaning to an individual and tie them to a racial, ethnic, cultural, or religious group </a:t>
            </a:r>
            <a:endParaRPr sz="2000" dirty="0">
              <a:solidFill>
                <a:srgbClr val="000000"/>
              </a:solidFill>
              <a:latin typeface="Montserrat"/>
              <a:ea typeface="Montserrat"/>
              <a:cs typeface="Montserrat"/>
              <a:sym typeface="Montserrat"/>
            </a:endParaRPr>
          </a:p>
          <a:p>
            <a:pPr marL="457200" lvl="0" indent="0" algn="l" rtl="0">
              <a:lnSpc>
                <a:spcPct val="115000"/>
              </a:lnSpc>
              <a:spcBef>
                <a:spcPts val="1200"/>
              </a:spcBef>
              <a:spcAft>
                <a:spcPts val="0"/>
              </a:spcAft>
              <a:buNone/>
            </a:pPr>
            <a:endParaRPr sz="2000" dirty="0">
              <a:solidFill>
                <a:srgbClr val="000000"/>
              </a:solidFill>
              <a:latin typeface="Montserrat"/>
              <a:ea typeface="Montserrat"/>
              <a:cs typeface="Montserrat"/>
              <a:sym typeface="Montserrat"/>
            </a:endParaRPr>
          </a:p>
          <a:p>
            <a:pPr marL="457200" lvl="0" indent="0" algn="l" rtl="0">
              <a:spcBef>
                <a:spcPts val="1200"/>
              </a:spcBef>
              <a:spcAft>
                <a:spcPts val="600"/>
              </a:spcAft>
              <a:buNone/>
            </a:pPr>
            <a:endParaRPr sz="2000" dirty="0"/>
          </a:p>
        </p:txBody>
      </p:sp>
      <p:sp>
        <p:nvSpPr>
          <p:cNvPr id="136" name="Google Shape;136;p15"/>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solidFill>
                  <a:schemeClr val="lt1"/>
                </a:solidFill>
              </a:rPr>
              <a:t>4</a:t>
            </a:fld>
            <a:endParaRPr>
              <a:solidFill>
                <a:schemeClr val="lt1"/>
              </a:solidFill>
            </a:endParaRPr>
          </a:p>
        </p:txBody>
      </p:sp>
      <p:sp>
        <p:nvSpPr>
          <p:cNvPr id="137" name="Google Shape;137;p15"/>
          <p:cNvSpPr txBox="1"/>
          <p:nvPr/>
        </p:nvSpPr>
        <p:spPr>
          <a:xfrm>
            <a:off x="4808050" y="836000"/>
            <a:ext cx="3969300" cy="36480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4500" b="1" dirty="0">
                <a:latin typeface="Montserrat"/>
                <a:ea typeface="Montserrat"/>
                <a:cs typeface="Montserrat"/>
                <a:sym typeface="Montserrat"/>
              </a:rPr>
              <a:t>“Names are deeply personal and deeply public”</a:t>
            </a:r>
            <a:endParaRPr sz="4500" b="1" dirty="0">
              <a:latin typeface="Montserrat"/>
              <a:ea typeface="Montserrat"/>
              <a:cs typeface="Montserrat"/>
              <a:sym typeface="Montserrat"/>
            </a:endParaRPr>
          </a:p>
        </p:txBody>
      </p:sp>
      <p:sp>
        <p:nvSpPr>
          <p:cNvPr id="138" name="Google Shape;138;p15"/>
          <p:cNvSpPr txBox="1"/>
          <p:nvPr/>
        </p:nvSpPr>
        <p:spPr>
          <a:xfrm>
            <a:off x="5783900" y="4339942"/>
            <a:ext cx="7335000" cy="553968"/>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600"/>
              </a:spcAft>
              <a:buNone/>
            </a:pPr>
            <a:r>
              <a:rPr lang="en" sz="1900" dirty="0">
                <a:solidFill>
                  <a:schemeClr val="dk1"/>
                </a:solidFill>
                <a:latin typeface="Montserrat Light"/>
                <a:ea typeface="Montserrat Light"/>
                <a:cs typeface="Montserrat Light"/>
                <a:sym typeface="Montserrat Light"/>
              </a:rPr>
              <a:t>-Beth Nguyen</a:t>
            </a:r>
            <a:endParaRPr sz="900" dirty="0">
              <a:latin typeface="Montserrat Light"/>
              <a:ea typeface="Montserrat Light"/>
              <a:cs typeface="Montserrat Light"/>
              <a:sym typeface="Montserrat Light"/>
            </a:endParaRPr>
          </a:p>
        </p:txBody>
      </p:sp>
      <p:sp>
        <p:nvSpPr>
          <p:cNvPr id="2" name="TextBox 1">
            <a:extLst>
              <a:ext uri="{FF2B5EF4-FFF2-40B4-BE49-F238E27FC236}">
                <a16:creationId xmlns:a16="http://schemas.microsoft.com/office/drawing/2014/main" id="{AF2BF8F0-DEE1-AA40-BF8D-6944C3A22ACC}"/>
              </a:ext>
            </a:extLst>
          </p:cNvPr>
          <p:cNvSpPr txBox="1"/>
          <p:nvPr/>
        </p:nvSpPr>
        <p:spPr>
          <a:xfrm>
            <a:off x="220329" y="4739836"/>
            <a:ext cx="4312023" cy="307777"/>
          </a:xfrm>
          <a:prstGeom prst="rect">
            <a:avLst/>
          </a:prstGeom>
          <a:noFill/>
        </p:spPr>
        <p:txBody>
          <a:bodyPr wrap="square" rtlCol="0">
            <a:spAutoFit/>
          </a:bodyPr>
          <a:lstStyle/>
          <a:p>
            <a:r>
              <a:rPr lang="en-US" i="1" dirty="0">
                <a:solidFill>
                  <a:schemeClr val="bg2"/>
                </a:solidFill>
              </a:rPr>
              <a:t>Nguyen, The New Yorker Magazine, 2021</a:t>
            </a: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D39BEA-C8C1-484A-B29B-DED893588BFE}"/>
              </a:ext>
            </a:extLst>
          </p:cNvPr>
          <p:cNvSpPr>
            <a:spLocks noGrp="1"/>
          </p:cNvSpPr>
          <p:nvPr>
            <p:ph type="title"/>
          </p:nvPr>
        </p:nvSpPr>
        <p:spPr>
          <a:xfrm>
            <a:off x="855300" y="315051"/>
            <a:ext cx="7433400" cy="396300"/>
          </a:xfrm>
        </p:spPr>
        <p:txBody>
          <a:bodyPr/>
          <a:lstStyle/>
          <a:p>
            <a:r>
              <a:rPr lang="en-US" dirty="0"/>
              <a:t>Sources</a:t>
            </a:r>
          </a:p>
        </p:txBody>
      </p:sp>
      <p:sp>
        <p:nvSpPr>
          <p:cNvPr id="3" name="Text Placeholder 2">
            <a:extLst>
              <a:ext uri="{FF2B5EF4-FFF2-40B4-BE49-F238E27FC236}">
                <a16:creationId xmlns:a16="http://schemas.microsoft.com/office/drawing/2014/main" id="{CEF7A7DB-5CE6-E74E-94A7-8AA0029E3B55}"/>
              </a:ext>
            </a:extLst>
          </p:cNvPr>
          <p:cNvSpPr>
            <a:spLocks noGrp="1"/>
          </p:cNvSpPr>
          <p:nvPr>
            <p:ph type="body" idx="1"/>
          </p:nvPr>
        </p:nvSpPr>
        <p:spPr>
          <a:xfrm>
            <a:off x="780872" y="817676"/>
            <a:ext cx="7784773" cy="3033900"/>
          </a:xfrm>
        </p:spPr>
        <p:txBody>
          <a:bodyPr/>
          <a:lstStyle/>
          <a:p>
            <a:pPr marL="76200" indent="0">
              <a:buNone/>
            </a:pPr>
            <a:r>
              <a:rPr lang="en-US" sz="1100" dirty="0"/>
              <a:t>America Ruined My Name for Me | The New Yorker. Accessed February 11, 2022. </a:t>
            </a:r>
            <a:r>
              <a:rPr lang="en-US" sz="1100" dirty="0">
                <a:hlinkClick r:id="rId2"/>
              </a:rPr>
              <a:t>https://www.newyorker.com/culture/personal-history/america-ruined-my-name-for-me</a:t>
            </a:r>
            <a:endParaRPr lang="en-US" sz="1100" dirty="0"/>
          </a:p>
          <a:p>
            <a:pPr marL="76200" indent="0">
              <a:buNone/>
            </a:pPr>
            <a:endParaRPr lang="en-US" sz="1100" dirty="0"/>
          </a:p>
          <a:p>
            <a:pPr marL="76200" indent="0">
              <a:buNone/>
            </a:pPr>
            <a:r>
              <a:rPr lang="en-US" sz="1100" dirty="0"/>
              <a:t>Kohli R, Solórzano DG. Teachers, please learn our names!: racial </a:t>
            </a:r>
            <a:r>
              <a:rPr lang="en-US" sz="1100" dirty="0" err="1"/>
              <a:t>microagressions</a:t>
            </a:r>
            <a:r>
              <a:rPr lang="en-US" sz="1100" dirty="0"/>
              <a:t> and the K-12 classroom. </a:t>
            </a:r>
            <a:r>
              <a:rPr lang="en-US" sz="1100" i="1" dirty="0"/>
              <a:t>Race </a:t>
            </a:r>
            <a:r>
              <a:rPr lang="en-US" sz="1100" i="1" dirty="0" err="1"/>
              <a:t>Ethn</a:t>
            </a:r>
            <a:r>
              <a:rPr lang="en-US" sz="1100" i="1" dirty="0"/>
              <a:t> Educ</a:t>
            </a:r>
            <a:r>
              <a:rPr lang="en-US" sz="1100" dirty="0"/>
              <a:t>. 2012;15(4):441-462. doi:10.1080/13613324.2012.674026</a:t>
            </a:r>
          </a:p>
          <a:p>
            <a:pPr marL="76200" indent="0">
              <a:buNone/>
            </a:pPr>
            <a:endParaRPr lang="en-US" sz="1100" dirty="0"/>
          </a:p>
          <a:p>
            <a:pPr marL="76200" indent="0">
              <a:buNone/>
            </a:pPr>
            <a:r>
              <a:rPr lang="en-US" sz="1100" dirty="0"/>
              <a:t>Changing Names | Facing History and Ourselves. Accessed February 11, 2022. </a:t>
            </a:r>
            <a:r>
              <a:rPr lang="en-US" sz="1100" dirty="0">
                <a:hlinkClick r:id="rId3"/>
              </a:rPr>
              <a:t>https://www.facinghistory.org/reconstruction-era/changing-names</a:t>
            </a:r>
            <a:endParaRPr lang="en-US" sz="1100" dirty="0"/>
          </a:p>
          <a:p>
            <a:pPr marL="76200" indent="0">
              <a:buNone/>
            </a:pPr>
            <a:endParaRPr lang="en-US" sz="1100" dirty="0"/>
          </a:p>
          <a:p>
            <a:pPr marL="76200" indent="0">
              <a:buNone/>
            </a:pPr>
            <a:r>
              <a:rPr lang="en-US" sz="1100" dirty="0"/>
              <a:t>The racist practice of mispronouncing names. Published March 21, 2019. Accessed February 14, 2022. </a:t>
            </a:r>
            <a:r>
              <a:rPr lang="en-US" sz="1100" dirty="0">
                <a:hlinkClick r:id="rId4"/>
              </a:rPr>
              <a:t>https://www.kuow.org/stories/a-rose-by-any-other-name-would-not-be-me</a:t>
            </a:r>
            <a:endParaRPr lang="en-US" sz="1100" dirty="0"/>
          </a:p>
          <a:p>
            <a:pPr marL="76200" indent="0">
              <a:buNone/>
            </a:pPr>
            <a:endParaRPr lang="en-US" sz="1100" dirty="0"/>
          </a:p>
          <a:p>
            <a:pPr marL="76200" indent="0">
              <a:buNone/>
            </a:pPr>
            <a:r>
              <a:rPr lang="en-US" sz="1100" dirty="0"/>
              <a:t>Bertrand M, Mullainathan S. </a:t>
            </a:r>
            <a:r>
              <a:rPr lang="en-US" sz="1100" i="1" dirty="0"/>
              <a:t>Are Emily and Greg More Employable than Lakisha and Jamal? A Field Experiment on Labor Market Discrimination</a:t>
            </a:r>
            <a:r>
              <a:rPr lang="en-US" sz="1100" dirty="0"/>
              <a:t>. National Bureau of Economic Research; 2003. doi:10.3386/w9873</a:t>
            </a:r>
          </a:p>
          <a:p>
            <a:pPr marL="76200" indent="0">
              <a:buNone/>
            </a:pPr>
            <a:endParaRPr lang="en-US" sz="1100" dirty="0"/>
          </a:p>
          <a:p>
            <a:pPr marL="76200" indent="0">
              <a:buNone/>
            </a:pPr>
            <a:r>
              <a:rPr lang="en-US" sz="1100" dirty="0"/>
              <a:t>Kang SK, </a:t>
            </a:r>
            <a:r>
              <a:rPr lang="en-US" sz="1100" dirty="0" err="1"/>
              <a:t>DeCelles</a:t>
            </a:r>
            <a:r>
              <a:rPr lang="en-US" sz="1100" dirty="0"/>
              <a:t> KA, </a:t>
            </a:r>
            <a:r>
              <a:rPr lang="en-US" sz="1100" dirty="0" err="1"/>
              <a:t>Tilcsik</a:t>
            </a:r>
            <a:r>
              <a:rPr lang="en-US" sz="1100" dirty="0"/>
              <a:t> A, Jun S. Whitened Résumés: Race and Self-Presentation in the Labor Market. </a:t>
            </a:r>
            <a:r>
              <a:rPr lang="en-US" sz="1100" i="1" dirty="0"/>
              <a:t>Adm Sci Q</a:t>
            </a:r>
            <a:r>
              <a:rPr lang="en-US" sz="1100" dirty="0"/>
              <a:t>. 2016;61(3):469-502. doi:10.1177/0001839216639577</a:t>
            </a:r>
          </a:p>
          <a:p>
            <a:pPr marL="76200" indent="0">
              <a:buNone/>
            </a:pPr>
            <a:endParaRPr lang="en-US" sz="1100" dirty="0"/>
          </a:p>
          <a:p>
            <a:pPr marL="76200" indent="0">
              <a:buNone/>
            </a:pPr>
            <a:r>
              <a:rPr lang="en-US" sz="1100" dirty="0" err="1"/>
              <a:t>Tulshyan</a:t>
            </a:r>
            <a:r>
              <a:rPr lang="en-US" sz="1100" dirty="0"/>
              <a:t> R. If You Don’t Know How to Say Someone’s Name, Just Ask. </a:t>
            </a:r>
            <a:r>
              <a:rPr lang="en-US" sz="1100" i="1" dirty="0"/>
              <a:t>Harv Bus Rev</a:t>
            </a:r>
            <a:r>
              <a:rPr lang="en-US" sz="1100" dirty="0"/>
              <a:t>. Published online January 9, 2020. Accessed February 14, 2022. https://</a:t>
            </a:r>
            <a:r>
              <a:rPr lang="en-US" sz="1100" dirty="0" err="1"/>
              <a:t>hbr.org</a:t>
            </a:r>
            <a:r>
              <a:rPr lang="en-US" sz="1100" dirty="0"/>
              <a:t>/2020/01/if-you-</a:t>
            </a:r>
            <a:r>
              <a:rPr lang="en-US" sz="1100" dirty="0" err="1"/>
              <a:t>dont</a:t>
            </a:r>
            <a:r>
              <a:rPr lang="en-US" sz="1100" dirty="0"/>
              <a:t>-know-how-to-say-</a:t>
            </a:r>
            <a:r>
              <a:rPr lang="en-US" sz="1100" dirty="0" err="1"/>
              <a:t>someones</a:t>
            </a:r>
            <a:r>
              <a:rPr lang="en-US" sz="1100" dirty="0"/>
              <a:t>-name-just-ask </a:t>
            </a:r>
          </a:p>
          <a:p>
            <a:pPr marL="76200" indent="0">
              <a:buNone/>
            </a:pPr>
            <a:endParaRPr lang="en-US" sz="1100" dirty="0"/>
          </a:p>
          <a:p>
            <a:pPr marL="76200" indent="0">
              <a:buNone/>
            </a:pPr>
            <a:r>
              <a:rPr lang="en-US" sz="1100" dirty="0"/>
              <a:t> Cain </a:t>
            </a:r>
            <a:r>
              <a:rPr lang="en-US" sz="1100" dirty="0" err="1"/>
              <a:t>Á</a:t>
            </a:r>
            <a:r>
              <a:rPr lang="en-US" sz="1100" dirty="0"/>
              <a:t>. What to do when someone keeps saying your name wrong, without making it awkward. Business Insider. Accessed February 14, 2022. https://</a:t>
            </a:r>
            <a:r>
              <a:rPr lang="en-US" sz="1100" dirty="0" err="1"/>
              <a:t>www.businessinsider.com</a:t>
            </a:r>
            <a:r>
              <a:rPr lang="en-US" sz="1100" dirty="0"/>
              <a:t>/how-to-correct-mispronouncing-name-2017-1</a:t>
            </a:r>
          </a:p>
          <a:p>
            <a:pPr marL="76200" indent="0">
              <a:buNone/>
            </a:pPr>
            <a:endParaRPr lang="en-US" sz="1100" dirty="0"/>
          </a:p>
        </p:txBody>
      </p:sp>
      <p:sp>
        <p:nvSpPr>
          <p:cNvPr id="4" name="Slide Number Placeholder 3">
            <a:extLst>
              <a:ext uri="{FF2B5EF4-FFF2-40B4-BE49-F238E27FC236}">
                <a16:creationId xmlns:a16="http://schemas.microsoft.com/office/drawing/2014/main" id="{1955C585-983B-7040-90FC-FE79BEB02A9B}"/>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 smtClean="0"/>
              <a:t>40</a:t>
            </a:fld>
            <a:endParaRPr lang="en"/>
          </a:p>
        </p:txBody>
      </p:sp>
    </p:spTree>
    <p:extLst>
      <p:ext uri="{BB962C8B-B14F-4D97-AF65-F5344CB8AC3E}">
        <p14:creationId xmlns:p14="http://schemas.microsoft.com/office/powerpoint/2010/main" val="1361475391"/>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40"/>
        <p:cNvGrpSpPr/>
        <p:nvPr/>
      </p:nvGrpSpPr>
      <p:grpSpPr>
        <a:xfrm>
          <a:off x="0" y="0"/>
          <a:ext cx="0" cy="0"/>
          <a:chOff x="0" y="0"/>
          <a:chExt cx="0" cy="0"/>
        </a:xfrm>
      </p:grpSpPr>
      <p:sp>
        <p:nvSpPr>
          <p:cNvPr id="441" name="Google Shape;441;p52"/>
          <p:cNvSpPr txBox="1">
            <a:spLocks noGrp="1"/>
          </p:cNvSpPr>
          <p:nvPr>
            <p:ph type="ctrTitle"/>
          </p:nvPr>
        </p:nvSpPr>
        <p:spPr>
          <a:xfrm>
            <a:off x="685800" y="1668151"/>
            <a:ext cx="7772400" cy="13116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t>Thank you!</a:t>
            </a:r>
            <a:endParaRPr/>
          </a:p>
          <a:p>
            <a:pPr marL="0" lvl="0" indent="0" algn="l" rtl="0">
              <a:spcBef>
                <a:spcPts val="0"/>
              </a:spcBef>
              <a:spcAft>
                <a:spcPts val="0"/>
              </a:spcAft>
              <a:buNone/>
            </a:pPr>
            <a:endParaRPr/>
          </a:p>
          <a:p>
            <a:pPr marL="0" lvl="0" indent="0" algn="l" rtl="0">
              <a:lnSpc>
                <a:spcPct val="100000"/>
              </a:lnSpc>
              <a:spcBef>
                <a:spcPts val="0"/>
              </a:spcBef>
              <a:spcAft>
                <a:spcPts val="600"/>
              </a:spcAft>
              <a:buNone/>
            </a:pPr>
            <a:r>
              <a:rPr lang="en" sz="2400" i="1">
                <a:solidFill>
                  <a:schemeClr val="dk1"/>
                </a:solidFill>
              </a:rPr>
              <a:t>Please take 5 minutes to complete survey (copied into the chat) at this time. </a:t>
            </a:r>
            <a:endParaRPr i="1"/>
          </a:p>
        </p:txBody>
      </p:sp>
      <p:pic>
        <p:nvPicPr>
          <p:cNvPr id="442" name="Google Shape;442;p52"/>
          <p:cNvPicPr preferRelativeResize="0"/>
          <p:nvPr/>
        </p:nvPicPr>
        <p:blipFill>
          <a:blip r:embed="rId3">
            <a:alphaModFix/>
          </a:blip>
          <a:stretch>
            <a:fillRect/>
          </a:stretch>
        </p:blipFill>
        <p:spPr>
          <a:xfrm>
            <a:off x="3552850" y="2979751"/>
            <a:ext cx="1858949" cy="1858949"/>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16"/>
          <p:cNvSpPr txBox="1">
            <a:spLocks noGrp="1"/>
          </p:cNvSpPr>
          <p:nvPr>
            <p:ph type="ctrTitle"/>
          </p:nvPr>
        </p:nvSpPr>
        <p:spPr>
          <a:xfrm>
            <a:off x="685800" y="1668151"/>
            <a:ext cx="7772400" cy="13116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a:solidFill>
                  <a:schemeClr val="accent1"/>
                </a:solidFill>
              </a:rPr>
              <a:t>1.</a:t>
            </a:r>
            <a:endParaRPr>
              <a:solidFill>
                <a:schemeClr val="accent1"/>
              </a:solidFill>
            </a:endParaRPr>
          </a:p>
          <a:p>
            <a:pPr marL="0" lvl="0" indent="0" algn="l" rtl="0">
              <a:spcBef>
                <a:spcPts val="0"/>
              </a:spcBef>
              <a:spcAft>
                <a:spcPts val="0"/>
              </a:spcAft>
              <a:buNone/>
            </a:pPr>
            <a:r>
              <a:rPr lang="en"/>
              <a:t>Breakout room </a:t>
            </a:r>
            <a:endParaRPr/>
          </a:p>
        </p:txBody>
      </p:sp>
      <p:sp>
        <p:nvSpPr>
          <p:cNvPr id="144" name="Google Shape;144;p16"/>
          <p:cNvSpPr txBox="1">
            <a:spLocks noGrp="1"/>
          </p:cNvSpPr>
          <p:nvPr>
            <p:ph type="subTitle" idx="1"/>
          </p:nvPr>
        </p:nvSpPr>
        <p:spPr>
          <a:xfrm>
            <a:off x="685800" y="3076652"/>
            <a:ext cx="7772400" cy="3987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a:t>What do our names mean to us? </a:t>
            </a:r>
            <a:endParaRPr/>
          </a:p>
          <a:p>
            <a:pPr marL="0" lvl="0" indent="0" algn="l" rtl="0">
              <a:spcBef>
                <a:spcPts val="600"/>
              </a:spcBef>
              <a:spcAft>
                <a:spcPts val="600"/>
              </a:spcAft>
              <a:buNone/>
            </a:pPr>
            <a:endParaRPr sz="1800" i="1"/>
          </a:p>
        </p:txBody>
      </p:sp>
      <p:sp>
        <p:nvSpPr>
          <p:cNvPr id="145" name="Google Shape;145;p16"/>
          <p:cNvSpPr txBox="1"/>
          <p:nvPr/>
        </p:nvSpPr>
        <p:spPr>
          <a:xfrm>
            <a:off x="1318225" y="3572250"/>
            <a:ext cx="7772400" cy="1015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600"/>
              </a:spcAft>
              <a:buNone/>
            </a:pPr>
            <a:r>
              <a:rPr lang="en" sz="1800" i="1">
                <a:latin typeface="Montserrat"/>
                <a:ea typeface="Montserrat"/>
                <a:cs typeface="Montserrat"/>
                <a:sym typeface="Montserrat"/>
              </a:rPr>
              <a:t>Please introduce yourself with your name and an accompanying story, meaning of your name, or some aspect of how your name adds to your identity</a:t>
            </a:r>
            <a:r>
              <a:rPr lang="en" sz="1800" i="1">
                <a:solidFill>
                  <a:schemeClr val="dk1"/>
                </a:solidFill>
                <a:latin typeface="Montserrat Light"/>
                <a:ea typeface="Montserrat Light"/>
                <a:cs typeface="Montserrat Light"/>
                <a:sym typeface="Montserrat Light"/>
              </a:rPr>
              <a:t> </a:t>
            </a:r>
            <a:endParaRPr>
              <a:latin typeface="Montserrat Light"/>
              <a:ea typeface="Montserrat Light"/>
              <a:cs typeface="Montserrat Light"/>
              <a:sym typeface="Montserrat Light"/>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17"/>
          <p:cNvSpPr txBox="1">
            <a:spLocks noGrp="1"/>
          </p:cNvSpPr>
          <p:nvPr>
            <p:ph type="body" idx="1"/>
          </p:nvPr>
        </p:nvSpPr>
        <p:spPr>
          <a:xfrm>
            <a:off x="855300" y="1430150"/>
            <a:ext cx="3473100" cy="3319800"/>
          </a:xfrm>
          <a:prstGeom prst="rect">
            <a:avLst/>
          </a:prstGeom>
        </p:spPr>
        <p:txBody>
          <a:bodyPr spcFirstLastPara="1" wrap="square" lIns="0" tIns="0" rIns="0" bIns="0" anchor="t" anchorCtr="0">
            <a:noAutofit/>
          </a:bodyPr>
          <a:lstStyle/>
          <a:p>
            <a:pPr marL="457200" lvl="0" indent="-342900" algn="l" rtl="0">
              <a:lnSpc>
                <a:spcPct val="115000"/>
              </a:lnSpc>
              <a:spcBef>
                <a:spcPts val="0"/>
              </a:spcBef>
              <a:spcAft>
                <a:spcPts val="0"/>
              </a:spcAft>
              <a:buSzPts val="1800"/>
              <a:buFont typeface="Montserrat"/>
              <a:buChar char="●"/>
            </a:pPr>
            <a:r>
              <a:rPr lang="en" sz="1800" dirty="0">
                <a:solidFill>
                  <a:srgbClr val="000000"/>
                </a:solidFill>
                <a:latin typeface="Montserrat"/>
                <a:ea typeface="Montserrat"/>
                <a:cs typeface="Montserrat"/>
                <a:sym typeface="Montserrat"/>
              </a:rPr>
              <a:t>Mispronunciation of names can undermine one’s identity, similar to not using pronouns </a:t>
            </a:r>
            <a:endParaRPr sz="1800" dirty="0"/>
          </a:p>
        </p:txBody>
      </p:sp>
      <p:sp>
        <p:nvSpPr>
          <p:cNvPr id="151" name="Google Shape;151;p17"/>
          <p:cNvSpPr txBox="1">
            <a:spLocks noGrp="1"/>
          </p:cNvSpPr>
          <p:nvPr>
            <p:ph type="title"/>
          </p:nvPr>
        </p:nvSpPr>
        <p:spPr>
          <a:xfrm>
            <a:off x="855300" y="836000"/>
            <a:ext cx="7433400" cy="396300"/>
          </a:xfrm>
          <a:prstGeom prst="rect">
            <a:avLst/>
          </a:prstGeom>
        </p:spPr>
        <p:txBody>
          <a:bodyPr spcFirstLastPara="1" wrap="square" lIns="0" tIns="0" rIns="0" bIns="0" anchor="b" anchorCtr="0">
            <a:noAutofit/>
          </a:bodyPr>
          <a:lstStyle/>
          <a:p>
            <a:pPr marL="0" lvl="0" indent="0" algn="l" rtl="0">
              <a:spcBef>
                <a:spcPts val="0"/>
              </a:spcBef>
              <a:spcAft>
                <a:spcPts val="0"/>
              </a:spcAft>
              <a:buNone/>
            </a:pPr>
            <a:r>
              <a:rPr lang="en" dirty="0"/>
              <a:t>Name (mis)pronunciation as an inclusivity issue </a:t>
            </a:r>
            <a:endParaRPr dirty="0"/>
          </a:p>
        </p:txBody>
      </p:sp>
      <p:sp>
        <p:nvSpPr>
          <p:cNvPr id="152" name="Google Shape;152;p17"/>
          <p:cNvSpPr txBox="1">
            <a:spLocks noGrp="1"/>
          </p:cNvSpPr>
          <p:nvPr>
            <p:ph type="body" idx="2"/>
          </p:nvPr>
        </p:nvSpPr>
        <p:spPr>
          <a:xfrm>
            <a:off x="4815605" y="1430150"/>
            <a:ext cx="3473100" cy="3319800"/>
          </a:xfrm>
          <a:prstGeom prst="rect">
            <a:avLst/>
          </a:prstGeom>
        </p:spPr>
        <p:txBody>
          <a:bodyPr spcFirstLastPara="1" wrap="square" lIns="0" tIns="0" rIns="0" bIns="0" anchor="t" anchorCtr="0">
            <a:noAutofit/>
          </a:bodyPr>
          <a:lstStyle/>
          <a:p>
            <a:pPr marL="457200" lvl="0" indent="-342900" algn="l" rtl="0">
              <a:lnSpc>
                <a:spcPct val="115000"/>
              </a:lnSpc>
              <a:spcBef>
                <a:spcPts val="0"/>
              </a:spcBef>
              <a:spcAft>
                <a:spcPts val="0"/>
              </a:spcAft>
              <a:buSzPts val="1800"/>
              <a:buFont typeface="Montserrat"/>
              <a:buChar char="●"/>
            </a:pPr>
            <a:r>
              <a:rPr lang="en" sz="1800">
                <a:solidFill>
                  <a:srgbClr val="000000"/>
                </a:solidFill>
                <a:latin typeface="Montserrat"/>
                <a:ea typeface="Montserrat"/>
                <a:cs typeface="Montserrat"/>
                <a:sym typeface="Montserrat"/>
              </a:rPr>
              <a:t>Chronic mispronunciation can lead to feeling marginalized, not accepted or included, unvalued, and can be experienced as a microaggression</a:t>
            </a:r>
            <a:endParaRPr/>
          </a:p>
        </p:txBody>
      </p:sp>
      <p:sp>
        <p:nvSpPr>
          <p:cNvPr id="153" name="Google Shape;153;p17"/>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6</a:t>
            </a:fld>
            <a:endParaRPr/>
          </a:p>
        </p:txBody>
      </p:sp>
      <p:sp>
        <p:nvSpPr>
          <p:cNvPr id="8" name="TextBox 7">
            <a:extLst>
              <a:ext uri="{FF2B5EF4-FFF2-40B4-BE49-F238E27FC236}">
                <a16:creationId xmlns:a16="http://schemas.microsoft.com/office/drawing/2014/main" id="{B19C369F-6C0B-C542-9152-27A12399020B}"/>
              </a:ext>
            </a:extLst>
          </p:cNvPr>
          <p:cNvSpPr txBox="1"/>
          <p:nvPr/>
        </p:nvSpPr>
        <p:spPr>
          <a:xfrm>
            <a:off x="0" y="4595962"/>
            <a:ext cx="4572000" cy="307777"/>
          </a:xfrm>
          <a:prstGeom prst="rect">
            <a:avLst/>
          </a:prstGeom>
          <a:noFill/>
        </p:spPr>
        <p:txBody>
          <a:bodyPr wrap="square">
            <a:spAutoFit/>
          </a:bodyPr>
          <a:lstStyle/>
          <a:p>
            <a:r>
              <a:rPr lang="en-US" i="1" dirty="0">
                <a:solidFill>
                  <a:schemeClr val="bg2"/>
                </a:solidFill>
              </a:rPr>
              <a:t>Nguyen, The New Yorker Magazine, 2021</a:t>
            </a:r>
          </a:p>
        </p:txBody>
      </p:sp>
      <p:sp>
        <p:nvSpPr>
          <p:cNvPr id="9" name="TextBox 8">
            <a:extLst>
              <a:ext uri="{FF2B5EF4-FFF2-40B4-BE49-F238E27FC236}">
                <a16:creationId xmlns:a16="http://schemas.microsoft.com/office/drawing/2014/main" id="{00E0CDBD-06D6-1740-8505-86C52349FD3F}"/>
              </a:ext>
            </a:extLst>
          </p:cNvPr>
          <p:cNvSpPr txBox="1"/>
          <p:nvPr/>
        </p:nvSpPr>
        <p:spPr>
          <a:xfrm>
            <a:off x="0" y="4835723"/>
            <a:ext cx="4572000" cy="307777"/>
          </a:xfrm>
          <a:prstGeom prst="rect">
            <a:avLst/>
          </a:prstGeom>
          <a:noFill/>
        </p:spPr>
        <p:txBody>
          <a:bodyPr wrap="square">
            <a:spAutoFit/>
          </a:bodyPr>
          <a:lstStyle/>
          <a:p>
            <a:r>
              <a:rPr lang="en-US" i="1" dirty="0">
                <a:solidFill>
                  <a:schemeClr val="bg2"/>
                </a:solidFill>
              </a:rPr>
              <a:t>Kohli et al, Race Ethnicity and Education, 2012</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18"/>
          <p:cNvSpPr txBox="1">
            <a:spLocks noGrp="1"/>
          </p:cNvSpPr>
          <p:nvPr>
            <p:ph type="body" idx="1"/>
          </p:nvPr>
        </p:nvSpPr>
        <p:spPr>
          <a:xfrm>
            <a:off x="1562284" y="857235"/>
            <a:ext cx="6918300" cy="2736900"/>
          </a:xfrm>
          <a:prstGeom prst="rect">
            <a:avLst/>
          </a:prstGeom>
        </p:spPr>
        <p:txBody>
          <a:bodyPr spcFirstLastPara="1" wrap="square" lIns="0" tIns="0" rIns="0" bIns="0" anchor="t" anchorCtr="0">
            <a:noAutofit/>
          </a:bodyPr>
          <a:lstStyle/>
          <a:p>
            <a:pPr marL="0" lvl="0" indent="0" algn="l" rtl="0">
              <a:spcBef>
                <a:spcPts val="0"/>
              </a:spcBef>
              <a:spcAft>
                <a:spcPts val="0"/>
              </a:spcAft>
              <a:buNone/>
            </a:pPr>
            <a:r>
              <a:rPr lang="en" sz="2800" i="1" dirty="0">
                <a:latin typeface="Montserrat"/>
                <a:ea typeface="Montserrat"/>
                <a:cs typeface="Montserrat"/>
                <a:sym typeface="Montserrat"/>
              </a:rPr>
              <a:t>When my colleagues don’t bother putting in the work of pronouncing my name correctly, I sense that I am not worth the effort. And whether it’s right or wrong, this makes me remember the times in my life when I was made to feel different and most unwelcome.</a:t>
            </a:r>
            <a:endParaRPr sz="2800" i="1" dirty="0">
              <a:latin typeface="Montserrat"/>
              <a:ea typeface="Montserrat"/>
              <a:cs typeface="Montserrat"/>
              <a:sym typeface="Montserrat"/>
            </a:endParaRPr>
          </a:p>
          <a:p>
            <a:pPr marL="914400" lvl="0" indent="457200" algn="l" rtl="0">
              <a:spcBef>
                <a:spcPts val="0"/>
              </a:spcBef>
              <a:spcAft>
                <a:spcPts val="0"/>
              </a:spcAft>
              <a:buNone/>
            </a:pPr>
            <a:r>
              <a:rPr lang="en" sz="2800" i="1" dirty="0">
                <a:latin typeface="Montserrat"/>
                <a:ea typeface="Montserrat"/>
                <a:cs typeface="Montserrat"/>
                <a:sym typeface="Montserrat"/>
              </a:rPr>
              <a:t>			-</a:t>
            </a:r>
            <a:r>
              <a:rPr lang="en" sz="2800" i="1" dirty="0" err="1">
                <a:latin typeface="Montserrat"/>
                <a:ea typeface="Montserrat"/>
                <a:cs typeface="Montserrat"/>
                <a:sym typeface="Montserrat"/>
              </a:rPr>
              <a:t>Yejin</a:t>
            </a:r>
            <a:r>
              <a:rPr lang="en" sz="2800" i="1" dirty="0">
                <a:latin typeface="Montserrat"/>
                <a:ea typeface="Montserrat"/>
                <a:cs typeface="Montserrat"/>
                <a:sym typeface="Montserrat"/>
              </a:rPr>
              <a:t> Lee</a:t>
            </a:r>
            <a:endParaRPr sz="2800" dirty="0"/>
          </a:p>
        </p:txBody>
      </p:sp>
      <p:sp>
        <p:nvSpPr>
          <p:cNvPr id="159" name="Google Shape;159;p18"/>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t>7</a:t>
            </a:fld>
            <a:endParaRPr/>
          </a:p>
        </p:txBody>
      </p:sp>
      <p:sp>
        <p:nvSpPr>
          <p:cNvPr id="5" name="TextBox 4">
            <a:extLst>
              <a:ext uri="{FF2B5EF4-FFF2-40B4-BE49-F238E27FC236}">
                <a16:creationId xmlns:a16="http://schemas.microsoft.com/office/drawing/2014/main" id="{101C4DBD-4606-864A-9919-6DA88ECFC314}"/>
              </a:ext>
            </a:extLst>
          </p:cNvPr>
          <p:cNvSpPr txBox="1"/>
          <p:nvPr/>
        </p:nvSpPr>
        <p:spPr>
          <a:xfrm>
            <a:off x="135279" y="4749851"/>
            <a:ext cx="1646605" cy="307777"/>
          </a:xfrm>
          <a:prstGeom prst="rect">
            <a:avLst/>
          </a:prstGeom>
          <a:noFill/>
        </p:spPr>
        <p:txBody>
          <a:bodyPr wrap="none" rtlCol="0">
            <a:spAutoFit/>
          </a:bodyPr>
          <a:lstStyle/>
          <a:p>
            <a:r>
              <a:rPr lang="en-US" i="1" dirty="0">
                <a:solidFill>
                  <a:schemeClr val="bg2"/>
                </a:solidFill>
              </a:rPr>
              <a:t>Lee, Idealist, 2020</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E9B1AE63-E7CC-6046-BD33-14228A27097E}"/>
              </a:ext>
            </a:extLst>
          </p:cNvPr>
          <p:cNvSpPr>
            <a:spLocks noGrp="1"/>
          </p:cNvSpPr>
          <p:nvPr>
            <p:ph type="title"/>
          </p:nvPr>
        </p:nvSpPr>
        <p:spPr>
          <a:xfrm>
            <a:off x="583696" y="256579"/>
            <a:ext cx="7433400" cy="396300"/>
          </a:xfrm>
        </p:spPr>
        <p:txBody>
          <a:bodyPr/>
          <a:lstStyle/>
          <a:p>
            <a:r>
              <a:rPr lang="en-US" dirty="0"/>
              <a:t>Media Representations </a:t>
            </a:r>
          </a:p>
        </p:txBody>
      </p:sp>
      <p:sp>
        <p:nvSpPr>
          <p:cNvPr id="4" name="Text Placeholder 3">
            <a:extLst>
              <a:ext uri="{FF2B5EF4-FFF2-40B4-BE49-F238E27FC236}">
                <a16:creationId xmlns:a16="http://schemas.microsoft.com/office/drawing/2014/main" id="{09A24F9A-4338-F943-9B22-18F62A3144DE}"/>
              </a:ext>
            </a:extLst>
          </p:cNvPr>
          <p:cNvSpPr>
            <a:spLocks noGrp="1"/>
          </p:cNvSpPr>
          <p:nvPr>
            <p:ph type="body" idx="1"/>
          </p:nvPr>
        </p:nvSpPr>
        <p:spPr>
          <a:xfrm>
            <a:off x="583696" y="850726"/>
            <a:ext cx="7433400" cy="3033900"/>
          </a:xfrm>
        </p:spPr>
        <p:txBody>
          <a:bodyPr/>
          <a:lstStyle/>
          <a:p>
            <a:r>
              <a:rPr lang="en-US" sz="2200" dirty="0"/>
              <a:t>“America Ruined My Name for Me” Nguyen</a:t>
            </a:r>
          </a:p>
          <a:p>
            <a:r>
              <a:rPr lang="en-US" sz="2200" dirty="0"/>
              <a:t>“Say My Name: Why Pronouncing Names Correctly is Important” Lee</a:t>
            </a:r>
          </a:p>
          <a:p>
            <a:r>
              <a:rPr lang="en-US" sz="2200" dirty="0"/>
              <a:t>“It’s Well Past Time White People Learn How To Say Everyone’s Names Correctly” McPhillips</a:t>
            </a:r>
          </a:p>
          <a:p>
            <a:r>
              <a:rPr lang="en" sz="2200" dirty="0"/>
              <a:t>“Pronouncing Students’ Names Correctly Should Be a Big Deal” Rice</a:t>
            </a:r>
          </a:p>
          <a:p>
            <a:r>
              <a:rPr lang="en" sz="2200" dirty="0"/>
              <a:t>“The Lasting Impact of Mispronouncing Students’ Names” McLaughlin</a:t>
            </a:r>
          </a:p>
          <a:p>
            <a:endParaRPr lang="en-US" dirty="0"/>
          </a:p>
          <a:p>
            <a:endParaRPr lang="en-US" dirty="0"/>
          </a:p>
          <a:p>
            <a:endParaRPr lang="en-US" dirty="0"/>
          </a:p>
        </p:txBody>
      </p:sp>
      <p:sp>
        <p:nvSpPr>
          <p:cNvPr id="2" name="Slide Number Placeholder 1">
            <a:extLst>
              <a:ext uri="{FF2B5EF4-FFF2-40B4-BE49-F238E27FC236}">
                <a16:creationId xmlns:a16="http://schemas.microsoft.com/office/drawing/2014/main" id="{DA778106-C76E-CE42-B2DD-035B7AD45368}"/>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 smtClean="0"/>
              <a:t>8</a:t>
            </a:fld>
            <a:endParaRPr lang="en"/>
          </a:p>
        </p:txBody>
      </p:sp>
      <p:sp>
        <p:nvSpPr>
          <p:cNvPr id="5" name="TextBox 4">
            <a:extLst>
              <a:ext uri="{FF2B5EF4-FFF2-40B4-BE49-F238E27FC236}">
                <a16:creationId xmlns:a16="http://schemas.microsoft.com/office/drawing/2014/main" id="{8CD8C4E1-97E4-D148-B0A8-ADEAAE1D6E38}"/>
              </a:ext>
            </a:extLst>
          </p:cNvPr>
          <p:cNvSpPr txBox="1"/>
          <p:nvPr/>
        </p:nvSpPr>
        <p:spPr>
          <a:xfrm>
            <a:off x="114716" y="3991416"/>
            <a:ext cx="3567002" cy="1169551"/>
          </a:xfrm>
          <a:prstGeom prst="rect">
            <a:avLst/>
          </a:prstGeom>
          <a:noFill/>
        </p:spPr>
        <p:txBody>
          <a:bodyPr wrap="none" rtlCol="0">
            <a:spAutoFit/>
          </a:bodyPr>
          <a:lstStyle/>
          <a:p>
            <a:r>
              <a:rPr lang="en-US" i="1" dirty="0">
                <a:solidFill>
                  <a:schemeClr val="bg2"/>
                </a:solidFill>
              </a:rPr>
              <a:t>Nguyen, The New Yorker Magazine, 2021 </a:t>
            </a:r>
          </a:p>
          <a:p>
            <a:r>
              <a:rPr lang="en-US" i="1" dirty="0">
                <a:solidFill>
                  <a:schemeClr val="bg2"/>
                </a:solidFill>
              </a:rPr>
              <a:t>Lee, Idealist, 2020</a:t>
            </a:r>
          </a:p>
          <a:p>
            <a:r>
              <a:rPr lang="en-US" i="1" dirty="0">
                <a:solidFill>
                  <a:schemeClr val="bg2"/>
                </a:solidFill>
              </a:rPr>
              <a:t>McPhillips, Well and Good, 2020</a:t>
            </a:r>
          </a:p>
          <a:p>
            <a:r>
              <a:rPr lang="en-US" i="1" dirty="0">
                <a:solidFill>
                  <a:schemeClr val="bg2"/>
                </a:solidFill>
              </a:rPr>
              <a:t>Rice, Education Week, 2017</a:t>
            </a:r>
          </a:p>
          <a:p>
            <a:r>
              <a:rPr lang="en-US" i="1" dirty="0">
                <a:solidFill>
                  <a:schemeClr val="bg2"/>
                </a:solidFill>
              </a:rPr>
              <a:t>McLaughlin, NEA, 2016</a:t>
            </a:r>
          </a:p>
        </p:txBody>
      </p:sp>
    </p:spTree>
    <p:extLst>
      <p:ext uri="{BB962C8B-B14F-4D97-AF65-F5344CB8AC3E}">
        <p14:creationId xmlns:p14="http://schemas.microsoft.com/office/powerpoint/2010/main" val="19155141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20"/>
          <p:cNvSpPr txBox="1">
            <a:spLocks noGrp="1"/>
          </p:cNvSpPr>
          <p:nvPr>
            <p:ph type="sldNum" idx="12"/>
          </p:nvPr>
        </p:nvSpPr>
        <p:spPr>
          <a:xfrm>
            <a:off x="8480584" y="4749851"/>
            <a:ext cx="548700" cy="393600"/>
          </a:xfrm>
          <a:prstGeom prst="rect">
            <a:avLst/>
          </a:prstGeom>
        </p:spPr>
        <p:txBody>
          <a:bodyPr spcFirstLastPara="1" wrap="square" lIns="0" tIns="0" rIns="0" bIns="0" anchor="ctr" anchorCtr="0">
            <a:noAutofit/>
          </a:bodyPr>
          <a:lstStyle/>
          <a:p>
            <a:pPr marL="0" lvl="0" indent="0" algn="r" rtl="0">
              <a:spcBef>
                <a:spcPts val="0"/>
              </a:spcBef>
              <a:spcAft>
                <a:spcPts val="0"/>
              </a:spcAft>
              <a:buNone/>
            </a:pPr>
            <a:fld id="{00000000-1234-1234-1234-123412341234}" type="slidenum">
              <a:rPr lang="en">
                <a:solidFill>
                  <a:schemeClr val="lt1"/>
                </a:solidFill>
              </a:rPr>
              <a:t>9</a:t>
            </a:fld>
            <a:endParaRPr>
              <a:solidFill>
                <a:schemeClr val="lt1"/>
              </a:solidFill>
            </a:endParaRPr>
          </a:p>
        </p:txBody>
      </p:sp>
      <p:grpSp>
        <p:nvGrpSpPr>
          <p:cNvPr id="177" name="Google Shape;177;p20"/>
          <p:cNvGrpSpPr/>
          <p:nvPr/>
        </p:nvGrpSpPr>
        <p:grpSpPr>
          <a:xfrm>
            <a:off x="641479" y="1"/>
            <a:ext cx="7292129" cy="5035487"/>
            <a:chOff x="2547150" y="238125"/>
            <a:chExt cx="2525675" cy="5238750"/>
          </a:xfrm>
        </p:grpSpPr>
        <p:sp>
          <p:nvSpPr>
            <p:cNvPr id="178" name="Google Shape;178;p20"/>
            <p:cNvSpPr/>
            <p:nvPr/>
          </p:nvSpPr>
          <p:spPr>
            <a:xfrm>
              <a:off x="2547150" y="238125"/>
              <a:ext cx="2525675" cy="5238750"/>
            </a:xfrm>
            <a:custGeom>
              <a:avLst/>
              <a:gdLst/>
              <a:ahLst/>
              <a:cxnLst/>
              <a:rect l="l" t="t" r="r" b="b"/>
              <a:pathLst>
                <a:path w="101027" h="209550" extrusionOk="0">
                  <a:moveTo>
                    <a:pt x="98629" y="18886"/>
                  </a:moveTo>
                  <a:lnTo>
                    <a:pt x="98629" y="190364"/>
                  </a:lnTo>
                  <a:lnTo>
                    <a:pt x="2398" y="190364"/>
                  </a:lnTo>
                  <a:lnTo>
                    <a:pt x="2398" y="18886"/>
                  </a:lnTo>
                  <a:close/>
                  <a:moveTo>
                    <a:pt x="10343" y="0"/>
                  </a:moveTo>
                  <a:lnTo>
                    <a:pt x="9293" y="75"/>
                  </a:lnTo>
                  <a:lnTo>
                    <a:pt x="8244" y="225"/>
                  </a:lnTo>
                  <a:lnTo>
                    <a:pt x="7270" y="450"/>
                  </a:lnTo>
                  <a:lnTo>
                    <a:pt x="6295" y="824"/>
                  </a:lnTo>
                  <a:lnTo>
                    <a:pt x="5396" y="1274"/>
                  </a:lnTo>
                  <a:lnTo>
                    <a:pt x="4572" y="1799"/>
                  </a:lnTo>
                  <a:lnTo>
                    <a:pt x="3747" y="2398"/>
                  </a:lnTo>
                  <a:lnTo>
                    <a:pt x="2998" y="3073"/>
                  </a:lnTo>
                  <a:lnTo>
                    <a:pt x="2323" y="3747"/>
                  </a:lnTo>
                  <a:lnTo>
                    <a:pt x="1724" y="4572"/>
                  </a:lnTo>
                  <a:lnTo>
                    <a:pt x="1199" y="5396"/>
                  </a:lnTo>
                  <a:lnTo>
                    <a:pt x="824" y="6370"/>
                  </a:lnTo>
                  <a:lnTo>
                    <a:pt x="450" y="7270"/>
                  </a:lnTo>
                  <a:lnTo>
                    <a:pt x="225" y="8319"/>
                  </a:lnTo>
                  <a:lnTo>
                    <a:pt x="0" y="9293"/>
                  </a:lnTo>
                  <a:lnTo>
                    <a:pt x="0" y="10343"/>
                  </a:lnTo>
                  <a:lnTo>
                    <a:pt x="0" y="199207"/>
                  </a:lnTo>
                  <a:lnTo>
                    <a:pt x="0" y="200257"/>
                  </a:lnTo>
                  <a:lnTo>
                    <a:pt x="225" y="201231"/>
                  </a:lnTo>
                  <a:lnTo>
                    <a:pt x="450" y="202280"/>
                  </a:lnTo>
                  <a:lnTo>
                    <a:pt x="824" y="203180"/>
                  </a:lnTo>
                  <a:lnTo>
                    <a:pt x="1199" y="204154"/>
                  </a:lnTo>
                  <a:lnTo>
                    <a:pt x="1724" y="204978"/>
                  </a:lnTo>
                  <a:lnTo>
                    <a:pt x="2323" y="205803"/>
                  </a:lnTo>
                  <a:lnTo>
                    <a:pt x="2998" y="206477"/>
                  </a:lnTo>
                  <a:lnTo>
                    <a:pt x="3747" y="207152"/>
                  </a:lnTo>
                  <a:lnTo>
                    <a:pt x="4572" y="207751"/>
                  </a:lnTo>
                  <a:lnTo>
                    <a:pt x="5396" y="208276"/>
                  </a:lnTo>
                  <a:lnTo>
                    <a:pt x="6295" y="208726"/>
                  </a:lnTo>
                  <a:lnTo>
                    <a:pt x="7270" y="209100"/>
                  </a:lnTo>
                  <a:lnTo>
                    <a:pt x="8244" y="209325"/>
                  </a:lnTo>
                  <a:lnTo>
                    <a:pt x="9293" y="209475"/>
                  </a:lnTo>
                  <a:lnTo>
                    <a:pt x="10343" y="209550"/>
                  </a:lnTo>
                  <a:lnTo>
                    <a:pt x="90610" y="209550"/>
                  </a:lnTo>
                  <a:lnTo>
                    <a:pt x="91659" y="209475"/>
                  </a:lnTo>
                  <a:lnTo>
                    <a:pt x="92708" y="209325"/>
                  </a:lnTo>
                  <a:lnTo>
                    <a:pt x="93682" y="209100"/>
                  </a:lnTo>
                  <a:lnTo>
                    <a:pt x="94657" y="208726"/>
                  </a:lnTo>
                  <a:lnTo>
                    <a:pt x="95556" y="208276"/>
                  </a:lnTo>
                  <a:lnTo>
                    <a:pt x="96455" y="207751"/>
                  </a:lnTo>
                  <a:lnTo>
                    <a:pt x="97205" y="207152"/>
                  </a:lnTo>
                  <a:lnTo>
                    <a:pt x="97954" y="206477"/>
                  </a:lnTo>
                  <a:lnTo>
                    <a:pt x="98629" y="205803"/>
                  </a:lnTo>
                  <a:lnTo>
                    <a:pt x="99228" y="204978"/>
                  </a:lnTo>
                  <a:lnTo>
                    <a:pt x="99753" y="204154"/>
                  </a:lnTo>
                  <a:lnTo>
                    <a:pt x="100203" y="203180"/>
                  </a:lnTo>
                  <a:lnTo>
                    <a:pt x="100577" y="202280"/>
                  </a:lnTo>
                  <a:lnTo>
                    <a:pt x="100802" y="201231"/>
                  </a:lnTo>
                  <a:lnTo>
                    <a:pt x="100952" y="200257"/>
                  </a:lnTo>
                  <a:lnTo>
                    <a:pt x="101027" y="199207"/>
                  </a:lnTo>
                  <a:lnTo>
                    <a:pt x="101027" y="10343"/>
                  </a:lnTo>
                  <a:lnTo>
                    <a:pt x="100952" y="9293"/>
                  </a:lnTo>
                  <a:lnTo>
                    <a:pt x="100802" y="8319"/>
                  </a:lnTo>
                  <a:lnTo>
                    <a:pt x="100577" y="7270"/>
                  </a:lnTo>
                  <a:lnTo>
                    <a:pt x="100203" y="6370"/>
                  </a:lnTo>
                  <a:lnTo>
                    <a:pt x="99753" y="5396"/>
                  </a:lnTo>
                  <a:lnTo>
                    <a:pt x="99228" y="4572"/>
                  </a:lnTo>
                  <a:lnTo>
                    <a:pt x="98629" y="3747"/>
                  </a:lnTo>
                  <a:lnTo>
                    <a:pt x="97954" y="3073"/>
                  </a:lnTo>
                  <a:lnTo>
                    <a:pt x="97205" y="2398"/>
                  </a:lnTo>
                  <a:lnTo>
                    <a:pt x="96455" y="1799"/>
                  </a:lnTo>
                  <a:lnTo>
                    <a:pt x="95556" y="1274"/>
                  </a:lnTo>
                  <a:lnTo>
                    <a:pt x="94657" y="824"/>
                  </a:lnTo>
                  <a:lnTo>
                    <a:pt x="93682" y="450"/>
                  </a:lnTo>
                  <a:lnTo>
                    <a:pt x="92708" y="225"/>
                  </a:lnTo>
                  <a:lnTo>
                    <a:pt x="91659" y="75"/>
                  </a:lnTo>
                  <a:lnTo>
                    <a:pt x="90610" y="0"/>
                  </a:lnTo>
                  <a:close/>
                </a:path>
              </a:pathLst>
            </a:cu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9" name="Google Shape;179;p20"/>
            <p:cNvSpPr/>
            <p:nvPr/>
          </p:nvSpPr>
          <p:spPr>
            <a:xfrm>
              <a:off x="3557025" y="5147100"/>
              <a:ext cx="504050" cy="179900"/>
            </a:xfrm>
            <a:custGeom>
              <a:avLst/>
              <a:gdLst/>
              <a:ahLst/>
              <a:cxnLst/>
              <a:rect l="l" t="t" r="r" b="b"/>
              <a:pathLst>
                <a:path w="20162" h="7196" extrusionOk="0">
                  <a:moveTo>
                    <a:pt x="3598" y="0"/>
                  </a:moveTo>
                  <a:lnTo>
                    <a:pt x="2849" y="75"/>
                  </a:lnTo>
                  <a:lnTo>
                    <a:pt x="2174" y="300"/>
                  </a:lnTo>
                  <a:lnTo>
                    <a:pt x="1575" y="600"/>
                  </a:lnTo>
                  <a:lnTo>
                    <a:pt x="1050" y="1050"/>
                  </a:lnTo>
                  <a:lnTo>
                    <a:pt x="600" y="1574"/>
                  </a:lnTo>
                  <a:lnTo>
                    <a:pt x="301" y="2174"/>
                  </a:lnTo>
                  <a:lnTo>
                    <a:pt x="76" y="2848"/>
                  </a:lnTo>
                  <a:lnTo>
                    <a:pt x="1" y="3598"/>
                  </a:lnTo>
                  <a:lnTo>
                    <a:pt x="76" y="4347"/>
                  </a:lnTo>
                  <a:lnTo>
                    <a:pt x="301" y="5022"/>
                  </a:lnTo>
                  <a:lnTo>
                    <a:pt x="600" y="5621"/>
                  </a:lnTo>
                  <a:lnTo>
                    <a:pt x="1050" y="6146"/>
                  </a:lnTo>
                  <a:lnTo>
                    <a:pt x="1575" y="6596"/>
                  </a:lnTo>
                  <a:lnTo>
                    <a:pt x="2174" y="6896"/>
                  </a:lnTo>
                  <a:lnTo>
                    <a:pt x="2849" y="7120"/>
                  </a:lnTo>
                  <a:lnTo>
                    <a:pt x="3598" y="7195"/>
                  </a:lnTo>
                  <a:lnTo>
                    <a:pt x="16639" y="7195"/>
                  </a:lnTo>
                  <a:lnTo>
                    <a:pt x="17313" y="7120"/>
                  </a:lnTo>
                  <a:lnTo>
                    <a:pt x="17988" y="6896"/>
                  </a:lnTo>
                  <a:lnTo>
                    <a:pt x="18587" y="6596"/>
                  </a:lnTo>
                  <a:lnTo>
                    <a:pt x="19112" y="6146"/>
                  </a:lnTo>
                  <a:lnTo>
                    <a:pt x="19562" y="5621"/>
                  </a:lnTo>
                  <a:lnTo>
                    <a:pt x="19861" y="5022"/>
                  </a:lnTo>
                  <a:lnTo>
                    <a:pt x="20086" y="4347"/>
                  </a:lnTo>
                  <a:lnTo>
                    <a:pt x="20161" y="3598"/>
                  </a:lnTo>
                  <a:lnTo>
                    <a:pt x="20086" y="2848"/>
                  </a:lnTo>
                  <a:lnTo>
                    <a:pt x="19861" y="2174"/>
                  </a:lnTo>
                  <a:lnTo>
                    <a:pt x="19562" y="1574"/>
                  </a:lnTo>
                  <a:lnTo>
                    <a:pt x="19112" y="1050"/>
                  </a:lnTo>
                  <a:lnTo>
                    <a:pt x="18587" y="600"/>
                  </a:lnTo>
                  <a:lnTo>
                    <a:pt x="17988" y="300"/>
                  </a:lnTo>
                  <a:lnTo>
                    <a:pt x="17313" y="75"/>
                  </a:lnTo>
                  <a:lnTo>
                    <a:pt x="16639" y="0"/>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0" name="Google Shape;180;p20"/>
            <p:cNvSpPr/>
            <p:nvPr/>
          </p:nvSpPr>
          <p:spPr>
            <a:xfrm>
              <a:off x="3008050" y="423600"/>
              <a:ext cx="99325" cy="99325"/>
            </a:xfrm>
            <a:custGeom>
              <a:avLst/>
              <a:gdLst/>
              <a:ahLst/>
              <a:cxnLst/>
              <a:rect l="l" t="t" r="r" b="b"/>
              <a:pathLst>
                <a:path w="3973" h="3973" extrusionOk="0">
                  <a:moveTo>
                    <a:pt x="2024" y="1"/>
                  </a:moveTo>
                  <a:lnTo>
                    <a:pt x="1575" y="76"/>
                  </a:lnTo>
                  <a:lnTo>
                    <a:pt x="1200" y="151"/>
                  </a:lnTo>
                  <a:lnTo>
                    <a:pt x="900" y="375"/>
                  </a:lnTo>
                  <a:lnTo>
                    <a:pt x="600" y="600"/>
                  </a:lnTo>
                  <a:lnTo>
                    <a:pt x="375" y="900"/>
                  </a:lnTo>
                  <a:lnTo>
                    <a:pt x="151" y="1200"/>
                  </a:lnTo>
                  <a:lnTo>
                    <a:pt x="76" y="1575"/>
                  </a:lnTo>
                  <a:lnTo>
                    <a:pt x="1" y="2024"/>
                  </a:lnTo>
                  <a:lnTo>
                    <a:pt x="76" y="2399"/>
                  </a:lnTo>
                  <a:lnTo>
                    <a:pt x="151" y="2774"/>
                  </a:lnTo>
                  <a:lnTo>
                    <a:pt x="375" y="3073"/>
                  </a:lnTo>
                  <a:lnTo>
                    <a:pt x="600" y="3373"/>
                  </a:lnTo>
                  <a:lnTo>
                    <a:pt x="900" y="3673"/>
                  </a:lnTo>
                  <a:lnTo>
                    <a:pt x="1200" y="3823"/>
                  </a:lnTo>
                  <a:lnTo>
                    <a:pt x="1575" y="3973"/>
                  </a:lnTo>
                  <a:lnTo>
                    <a:pt x="2399" y="3973"/>
                  </a:lnTo>
                  <a:lnTo>
                    <a:pt x="2774" y="3823"/>
                  </a:lnTo>
                  <a:lnTo>
                    <a:pt x="3073" y="3673"/>
                  </a:lnTo>
                  <a:lnTo>
                    <a:pt x="3373" y="3373"/>
                  </a:lnTo>
                  <a:lnTo>
                    <a:pt x="3598" y="3073"/>
                  </a:lnTo>
                  <a:lnTo>
                    <a:pt x="3823" y="2774"/>
                  </a:lnTo>
                  <a:lnTo>
                    <a:pt x="3898" y="2399"/>
                  </a:lnTo>
                  <a:lnTo>
                    <a:pt x="3973" y="2024"/>
                  </a:lnTo>
                  <a:lnTo>
                    <a:pt x="3898" y="1575"/>
                  </a:lnTo>
                  <a:lnTo>
                    <a:pt x="3823" y="1200"/>
                  </a:lnTo>
                  <a:lnTo>
                    <a:pt x="3598" y="900"/>
                  </a:lnTo>
                  <a:lnTo>
                    <a:pt x="3373" y="600"/>
                  </a:lnTo>
                  <a:lnTo>
                    <a:pt x="3073" y="375"/>
                  </a:lnTo>
                  <a:lnTo>
                    <a:pt x="2774" y="151"/>
                  </a:lnTo>
                  <a:lnTo>
                    <a:pt x="2399" y="76"/>
                  </a:lnTo>
                  <a:lnTo>
                    <a:pt x="2024" y="1"/>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1" name="Google Shape;181;p20"/>
            <p:cNvSpPr/>
            <p:nvPr/>
          </p:nvSpPr>
          <p:spPr>
            <a:xfrm>
              <a:off x="3566400" y="434850"/>
              <a:ext cx="487175" cy="76850"/>
            </a:xfrm>
            <a:custGeom>
              <a:avLst/>
              <a:gdLst/>
              <a:ahLst/>
              <a:cxnLst/>
              <a:rect l="l" t="t" r="r" b="b"/>
              <a:pathLst>
                <a:path w="19487" h="3074" extrusionOk="0">
                  <a:moveTo>
                    <a:pt x="1275" y="0"/>
                  </a:moveTo>
                  <a:lnTo>
                    <a:pt x="1050" y="75"/>
                  </a:lnTo>
                  <a:lnTo>
                    <a:pt x="750" y="150"/>
                  </a:lnTo>
                  <a:lnTo>
                    <a:pt x="525" y="300"/>
                  </a:lnTo>
                  <a:lnTo>
                    <a:pt x="375" y="450"/>
                  </a:lnTo>
                  <a:lnTo>
                    <a:pt x="225" y="675"/>
                  </a:lnTo>
                  <a:lnTo>
                    <a:pt x="75" y="975"/>
                  </a:lnTo>
                  <a:lnTo>
                    <a:pt x="1" y="1274"/>
                  </a:lnTo>
                  <a:lnTo>
                    <a:pt x="1" y="1574"/>
                  </a:lnTo>
                  <a:lnTo>
                    <a:pt x="1" y="1874"/>
                  </a:lnTo>
                  <a:lnTo>
                    <a:pt x="75" y="2174"/>
                  </a:lnTo>
                  <a:lnTo>
                    <a:pt x="225" y="2399"/>
                  </a:lnTo>
                  <a:lnTo>
                    <a:pt x="375" y="2623"/>
                  </a:lnTo>
                  <a:lnTo>
                    <a:pt x="525" y="2773"/>
                  </a:lnTo>
                  <a:lnTo>
                    <a:pt x="750" y="2923"/>
                  </a:lnTo>
                  <a:lnTo>
                    <a:pt x="1050" y="2998"/>
                  </a:lnTo>
                  <a:lnTo>
                    <a:pt x="1275" y="3073"/>
                  </a:lnTo>
                  <a:lnTo>
                    <a:pt x="18137" y="3073"/>
                  </a:lnTo>
                  <a:lnTo>
                    <a:pt x="18437" y="2998"/>
                  </a:lnTo>
                  <a:lnTo>
                    <a:pt x="18662" y="2923"/>
                  </a:lnTo>
                  <a:lnTo>
                    <a:pt x="18887" y="2773"/>
                  </a:lnTo>
                  <a:lnTo>
                    <a:pt x="19112" y="2623"/>
                  </a:lnTo>
                  <a:lnTo>
                    <a:pt x="19262" y="2399"/>
                  </a:lnTo>
                  <a:lnTo>
                    <a:pt x="19337" y="2174"/>
                  </a:lnTo>
                  <a:lnTo>
                    <a:pt x="19412" y="1874"/>
                  </a:lnTo>
                  <a:lnTo>
                    <a:pt x="19486" y="1574"/>
                  </a:lnTo>
                  <a:lnTo>
                    <a:pt x="19412" y="1274"/>
                  </a:lnTo>
                  <a:lnTo>
                    <a:pt x="19337" y="975"/>
                  </a:lnTo>
                  <a:lnTo>
                    <a:pt x="19262" y="675"/>
                  </a:lnTo>
                  <a:lnTo>
                    <a:pt x="19112" y="450"/>
                  </a:lnTo>
                  <a:lnTo>
                    <a:pt x="18887" y="300"/>
                  </a:lnTo>
                  <a:lnTo>
                    <a:pt x="18662" y="150"/>
                  </a:lnTo>
                  <a:lnTo>
                    <a:pt x="18437" y="75"/>
                  </a:lnTo>
                  <a:lnTo>
                    <a:pt x="18137" y="0"/>
                  </a:lnTo>
                  <a:close/>
                </a:path>
              </a:pathLst>
            </a:cu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82" name="Google Shape;182;p20"/>
          <p:cNvSpPr txBox="1"/>
          <p:nvPr/>
        </p:nvSpPr>
        <p:spPr>
          <a:xfrm>
            <a:off x="1481550" y="1501788"/>
            <a:ext cx="5730600" cy="20319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4000" dirty="0">
                <a:solidFill>
                  <a:schemeClr val="lt1"/>
                </a:solidFill>
                <a:latin typeface="Montserrat Light"/>
                <a:ea typeface="Montserrat Light"/>
                <a:cs typeface="Montserrat Light"/>
                <a:sym typeface="Montserrat Light"/>
              </a:rPr>
              <a:t>Have you ever mispronounced someone’s name?</a:t>
            </a:r>
            <a:endParaRPr sz="4000" dirty="0">
              <a:solidFill>
                <a:schemeClr val="lt1"/>
              </a:solidFill>
              <a:latin typeface="Montserrat Light"/>
              <a:ea typeface="Montserrat Light"/>
              <a:cs typeface="Montserrat Light"/>
              <a:sym typeface="Montserrat Light"/>
            </a:endParaRPr>
          </a:p>
        </p:txBody>
      </p:sp>
    </p:spTree>
  </p:cSld>
  <p:clrMapOvr>
    <a:masterClrMapping/>
  </p:clrMapOvr>
</p:sld>
</file>

<file path=ppt/theme/theme1.xml><?xml version="1.0" encoding="utf-8"?>
<a:theme xmlns:a="http://schemas.openxmlformats.org/drawingml/2006/main" name="Nicholas template">
  <a:themeElements>
    <a:clrScheme name="Custom 347">
      <a:dk1>
        <a:srgbClr val="1E2124"/>
      </a:dk1>
      <a:lt1>
        <a:srgbClr val="FFFFFF"/>
      </a:lt1>
      <a:dk2>
        <a:srgbClr val="7C8894"/>
      </a:dk2>
      <a:lt2>
        <a:srgbClr val="E6ECEE"/>
      </a:lt2>
      <a:accent1>
        <a:srgbClr val="2AC3F3"/>
      </a:accent1>
      <a:accent2>
        <a:srgbClr val="004591"/>
      </a:accent2>
      <a:accent3>
        <a:srgbClr val="6BD8B6"/>
      </a:accent3>
      <a:accent4>
        <a:srgbClr val="A9E04B"/>
      </a:accent4>
      <a:accent5>
        <a:srgbClr val="F3C744"/>
      </a:accent5>
      <a:accent6>
        <a:srgbClr val="F37768"/>
      </a:accent6>
      <a:hlink>
        <a:srgbClr val="003C7E"/>
      </a:hlink>
      <a:folHlink>
        <a:srgbClr val="6611C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372</TotalTime>
  <Words>4531</Words>
  <Application>Microsoft Macintosh PowerPoint</Application>
  <PresentationFormat>On-screen Show (16:9)</PresentationFormat>
  <Paragraphs>319</Paragraphs>
  <Slides>41</Slides>
  <Notes>4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41</vt:i4>
      </vt:variant>
    </vt:vector>
  </HeadingPairs>
  <TitlesOfParts>
    <vt:vector size="49" baseType="lpstr">
      <vt:lpstr>Calibri</vt:lpstr>
      <vt:lpstr>Arial</vt:lpstr>
      <vt:lpstr>Playfair Display</vt:lpstr>
      <vt:lpstr>Montserrat</vt:lpstr>
      <vt:lpstr>Georgia</vt:lpstr>
      <vt:lpstr>Montserrat Light</vt:lpstr>
      <vt:lpstr>Times New Roman</vt:lpstr>
      <vt:lpstr>Nicholas template</vt:lpstr>
      <vt:lpstr>Say my name: </vt:lpstr>
      <vt:lpstr>Scholars </vt:lpstr>
      <vt:lpstr>Learning Objectives </vt:lpstr>
      <vt:lpstr>What’s in a name?</vt:lpstr>
      <vt:lpstr>1. Breakout room </vt:lpstr>
      <vt:lpstr>Name (mis)pronunciation as an inclusivity issue </vt:lpstr>
      <vt:lpstr>PowerPoint Presentation</vt:lpstr>
      <vt:lpstr>Media Representations </vt:lpstr>
      <vt:lpstr>PowerPoint Presentation</vt:lpstr>
      <vt:lpstr>PowerPoint Presentation</vt:lpstr>
      <vt:lpstr> What do we know about this? </vt:lpstr>
      <vt:lpstr>Teachers, please learn our names!: racial microaggressions and the K-12 classroom </vt:lpstr>
      <vt:lpstr>Teachers, please learn our names! - Findings</vt:lpstr>
      <vt:lpstr>America Ruined My Name For Me </vt:lpstr>
      <vt:lpstr>America Ruined My Name For Me </vt:lpstr>
      <vt:lpstr>History of Racism and Name pronunciation</vt:lpstr>
      <vt:lpstr>PowerPoint Presentation</vt:lpstr>
      <vt:lpstr>History of Racism and Name Mispronunciation</vt:lpstr>
      <vt:lpstr>Tangible Effects of Racism and Names</vt:lpstr>
      <vt:lpstr>PowerPoint Presentation</vt:lpstr>
      <vt:lpstr>Tools for name pronunciation</vt:lpstr>
      <vt:lpstr>Asking people how to pronounce names</vt:lpstr>
      <vt:lpstr>Online resources </vt:lpstr>
      <vt:lpstr>Phonetic pronunciation tools</vt:lpstr>
      <vt:lpstr>Correcting Mispronunciation</vt:lpstr>
      <vt:lpstr>Apply your knowledge!</vt:lpstr>
      <vt:lpstr>Tools for Application to Healthcare</vt:lpstr>
      <vt:lpstr>Application to Healthcare </vt:lpstr>
      <vt:lpstr>Application to Healthcare </vt:lpstr>
      <vt:lpstr>Application to Healthcare</vt:lpstr>
      <vt:lpstr>2. Breakout room </vt:lpstr>
      <vt:lpstr>Case #1 Resident/Intern/Patient </vt:lpstr>
      <vt:lpstr>Case #1 Discussion Questions</vt:lpstr>
      <vt:lpstr>Case #2 Physician/Patient </vt:lpstr>
      <vt:lpstr>Case #2 Discussion Questions</vt:lpstr>
      <vt:lpstr>Large Group Debrief</vt:lpstr>
      <vt:lpstr>Workshop Evaluation</vt:lpstr>
      <vt:lpstr>Recap &amp; Resources</vt:lpstr>
      <vt:lpstr>Take-home points</vt:lpstr>
      <vt:lpstr>Sources</vt:lpstr>
      <vt:lpstr>Thank you!  Please take 5 minutes to complete survey (copied into the chat) at this time.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ay my name: </dc:title>
  <cp:lastModifiedBy>Salma Dali</cp:lastModifiedBy>
  <cp:revision>24</cp:revision>
  <dcterms:modified xsi:type="dcterms:W3CDTF">2022-07-28T00:24:53Z</dcterms:modified>
</cp:coreProperties>
</file>